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0" r:id="rId3"/>
    <p:sldId id="257" r:id="rId4"/>
    <p:sldId id="264" r:id="rId5"/>
    <p:sldId id="258" r:id="rId6"/>
    <p:sldId id="259" r:id="rId7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0" userDrawn="1">
          <p15:clr>
            <a:srgbClr val="A4A3A4"/>
          </p15:clr>
        </p15:guide>
        <p15:guide id="2" pos="3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695" autoAdjust="0"/>
    <p:restoredTop sz="94660"/>
  </p:normalViewPr>
  <p:slideViewPr>
    <p:cSldViewPr snapToGrid="0">
      <p:cViewPr varScale="1">
        <p:scale>
          <a:sx n="149" d="100"/>
          <a:sy n="149" d="100"/>
        </p:scale>
        <p:origin x="1180" y="84"/>
      </p:cViewPr>
      <p:guideLst>
        <p:guide orient="horz" pos="210"/>
        <p:guide pos="3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1\Desktop\2018_05_21_WIKIM30_PCoA_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208434282253179"/>
          <c:y val="0.15250000000000002"/>
          <c:w val="0.64608873410054513"/>
          <c:h val="0.71299561403508771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003CE6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003CE6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J$1:$J$15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6</c:v>
                </c:pt>
                <c:pt idx="6">
                  <c:v>9</c:v>
                </c:pt>
                <c:pt idx="7">
                  <c:v>13</c:v>
                </c:pt>
                <c:pt idx="8">
                  <c:v>13</c:v>
                </c:pt>
                <c:pt idx="9">
                  <c:v>6</c:v>
                </c:pt>
                <c:pt idx="10">
                  <c:v>6</c:v>
                </c:pt>
                <c:pt idx="11">
                  <c:v>4</c:v>
                </c:pt>
                <c:pt idx="12">
                  <c:v>9</c:v>
                </c:pt>
                <c:pt idx="13">
                  <c:v>6</c:v>
                </c:pt>
                <c:pt idx="14">
                  <c:v>8</c:v>
                </c:pt>
              </c:numCache>
            </c:numRef>
          </c:xVal>
          <c:yVal>
            <c:numRef>
              <c:f>'Covariance   Correlation3_HID4'!$K$1:$K$15</c:f>
              <c:numCache>
                <c:formatCode>General</c:formatCode>
                <c:ptCount val="15"/>
                <c:pt idx="0">
                  <c:v>1.0531999999999999</c:v>
                </c:pt>
                <c:pt idx="1">
                  <c:v>1.6315999999999999</c:v>
                </c:pt>
                <c:pt idx="2">
                  <c:v>1.4011</c:v>
                </c:pt>
                <c:pt idx="3">
                  <c:v>5.6500000000000002E-2</c:v>
                </c:pt>
                <c:pt idx="4">
                  <c:v>0.2228999999999999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E-3</c:v>
                </c:pt>
                <c:pt idx="9">
                  <c:v>0</c:v>
                </c:pt>
                <c:pt idx="10">
                  <c:v>0.48499999999999999</c:v>
                </c:pt>
                <c:pt idx="11">
                  <c:v>0.84172000000000002</c:v>
                </c:pt>
                <c:pt idx="12">
                  <c:v>3.6700000000000003E-2</c:v>
                </c:pt>
                <c:pt idx="13">
                  <c:v>0.17710000000000001</c:v>
                </c:pt>
                <c:pt idx="14">
                  <c:v>0.1247999999999999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6</c:f>
              <c:numCache>
                <c:formatCode>General</c:formatCode>
                <c:ptCount val="300"/>
                <c:pt idx="0">
                  <c:v>-8.3236984376742704</c:v>
                </c:pt>
                <c:pt idx="1">
                  <c:v>-8.3206831572897997</c:v>
                </c:pt>
                <c:pt idx="2">
                  <c:v>-8.311638647599322</c:v>
                </c:pt>
                <c:pt idx="3">
                  <c:v>-8.2965689024037044</c:v>
                </c:pt>
                <c:pt idx="4">
                  <c:v>-8.2754805760781931</c:v>
                </c:pt>
                <c:pt idx="5">
                  <c:v>-8.2483829806340339</c:v>
                </c:pt>
                <c:pt idx="6">
                  <c:v>-8.2152880816065466</c:v>
                </c:pt>
                <c:pt idx="7">
                  <c:v>-8.1762104927714834</c:v>
                </c:pt>
                <c:pt idx="8">
                  <c:v>-8.1311674696919916</c:v>
                </c:pt>
                <c:pt idx="9">
                  <c:v>-8.0801789020990551</c:v>
                </c:pt>
                <c:pt idx="10">
                  <c:v>-8.02326730510873</c:v>
                </c:pt>
                <c:pt idx="11">
                  <c:v>-7.9604578092801255</c:v>
                </c:pt>
                <c:pt idx="12">
                  <c:v>-7.8917781495184389</c:v>
                </c:pt>
                <c:pt idx="13">
                  <c:v>-7.8172586528280075</c:v>
                </c:pt>
                <c:pt idx="14">
                  <c:v>-7.7369322249207624</c:v>
                </c:pt>
                <c:pt idx="15">
                  <c:v>-7.6508343356859836</c:v>
                </c:pt>
                <c:pt idx="16">
                  <c:v>-7.5590030035278062</c:v>
                </c:pt>
                <c:pt idx="17">
                  <c:v>-7.4614787785773533</c:v>
                </c:pt>
                <c:pt idx="18">
                  <c:v>-7.3583047247869402</c:v>
                </c:pt>
                <c:pt idx="19">
                  <c:v>-7.2495264009142577</c:v>
                </c:pt>
                <c:pt idx="20">
                  <c:v>-7.1351918404048895</c:v>
                </c:pt>
                <c:pt idx="21">
                  <c:v>-7.0153515301821088</c:v>
                </c:pt>
                <c:pt idx="22">
                  <c:v>-6.8900583883532676</c:v>
                </c:pt>
                <c:pt idx="23">
                  <c:v>-6.759367740842654</c:v>
                </c:pt>
                <c:pt idx="24">
                  <c:v>-6.6233372969611128</c:v>
                </c:pt>
                <c:pt idx="25">
                  <c:v>-6.482027123923249</c:v>
                </c:pt>
                <c:pt idx="26">
                  <c:v>-6.3354996203234322</c:v>
                </c:pt>
                <c:pt idx="27">
                  <c:v>-6.183819488582337</c:v>
                </c:pt>
                <c:pt idx="28">
                  <c:v>-6.0270537063761687</c:v>
                </c:pt>
                <c:pt idx="29">
                  <c:v>-5.8652714970612134</c:v>
                </c:pt>
                <c:pt idx="30">
                  <c:v>-5.6985442991067501</c:v>
                </c:pt>
                <c:pt idx="31">
                  <c:v>-5.5269457345498285</c:v>
                </c:pt>
                <c:pt idx="32">
                  <c:v>-5.3505515764858682</c:v>
                </c:pt>
                <c:pt idx="33">
                  <c:v>-5.1694397156093661</c:v>
                </c:pt>
                <c:pt idx="34">
                  <c:v>-4.9836901258195834</c:v>
                </c:pt>
                <c:pt idx="35">
                  <c:v>-4.7933848289062997</c:v>
                </c:pt>
                <c:pt idx="36">
                  <c:v>-4.5986078583313237</c:v>
                </c:pt>
                <c:pt idx="37">
                  <c:v>-4.3994452221216651</c:v>
                </c:pt>
                <c:pt idx="38">
                  <c:v>-4.195984864890816</c:v>
                </c:pt>
                <c:pt idx="39">
                  <c:v>-3.9883166290048884</c:v>
                </c:pt>
                <c:pt idx="40">
                  <c:v>-3.7765322149107483</c:v>
                </c:pt>
                <c:pt idx="41">
                  <c:v>-3.5607251406436866</c:v>
                </c:pt>
                <c:pt idx="42">
                  <c:v>-3.3409907005324833</c:v>
                </c:pt>
                <c:pt idx="43">
                  <c:v>-3.1174259231201109</c:v>
                </c:pt>
                <c:pt idx="44">
                  <c:v>-2.8901295283186723</c:v>
                </c:pt>
                <c:pt idx="45">
                  <c:v>-2.6592018838174587</c:v>
                </c:pt>
                <c:pt idx="46">
                  <c:v>-2.4247449607633991</c:v>
                </c:pt>
                <c:pt idx="47">
                  <c:v>-2.1868622887334848</c:v>
                </c:pt>
                <c:pt idx="48">
                  <c:v>-1.9456589100190129</c:v>
                </c:pt>
                <c:pt idx="49">
                  <c:v>-1.7012413332418719</c:v>
                </c:pt>
                <c:pt idx="50">
                  <c:v>-1.453717486323332</c:v>
                </c:pt>
                <c:pt idx="51">
                  <c:v>-1.2031966688261102</c:v>
                </c:pt>
                <c:pt idx="52">
                  <c:v>-0.94978950369076465</c:v>
                </c:pt>
                <c:pt idx="53">
                  <c:v>-0.69360788838771636</c:v>
                </c:pt>
                <c:pt idx="54">
                  <c:v>-0.43476494550648237</c:v>
                </c:pt>
                <c:pt idx="55">
                  <c:v>-0.17337497280390135</c:v>
                </c:pt>
                <c:pt idx="56">
                  <c:v>9.0446607266503776E-2</c:v>
                </c:pt>
                <c:pt idx="57">
                  <c:v>0.35658329852185577</c:v>
                </c:pt>
                <c:pt idx="58">
                  <c:v>0.62491758249134755</c:v>
                </c:pt>
                <c:pt idx="59">
                  <c:v>0.89533097030909747</c:v>
                </c:pt>
                <c:pt idx="60">
                  <c:v>1.167704055035494</c:v>
                </c:pt>
                <c:pt idx="61">
                  <c:v>1.4419165643839329</c:v>
                </c:pt>
                <c:pt idx="62">
                  <c:v>1.7178474138296895</c:v>
                </c:pt>
                <c:pt idx="63">
                  <c:v>1.9953747600774161</c:v>
                </c:pt>
                <c:pt idx="64">
                  <c:v>2.2743760548637235</c:v>
                </c:pt>
                <c:pt idx="65">
                  <c:v>2.554728099071041</c:v>
                </c:pt>
                <c:pt idx="66">
                  <c:v>2.8363070971288789</c:v>
                </c:pt>
                <c:pt idx="67">
                  <c:v>3.1189887116784663</c:v>
                </c:pt>
                <c:pt idx="68">
                  <c:v>3.4026481184766286</c:v>
                </c:pt>
                <c:pt idx="69">
                  <c:v>3.6871600615146676</c:v>
                </c:pt>
                <c:pt idx="70">
                  <c:v>3.9723989083278721</c:v>
                </c:pt>
                <c:pt idx="71">
                  <c:v>4.2582387054712916</c:v>
                </c:pt>
                <c:pt idx="72">
                  <c:v>4.5445532341372257</c:v>
                </c:pt>
                <c:pt idx="73">
                  <c:v>4.8312160658898993</c:v>
                </c:pt>
                <c:pt idx="74">
                  <c:v>5.1181006184926972</c:v>
                </c:pt>
                <c:pt idx="75">
                  <c:v>5.4050802118033179</c:v>
                </c:pt>
                <c:pt idx="76">
                  <c:v>5.6920281237121664</c:v>
                </c:pt>
                <c:pt idx="77">
                  <c:v>5.9788176460992535</c:v>
                </c:pt>
                <c:pt idx="78">
                  <c:v>6.2653221407849484</c:v>
                </c:pt>
                <c:pt idx="79">
                  <c:v>6.5514150954498289</c:v>
                </c:pt>
                <c:pt idx="80">
                  <c:v>6.8369701794989597</c:v>
                </c:pt>
                <c:pt idx="81">
                  <c:v>7.1218612998459285</c:v>
                </c:pt>
                <c:pt idx="82">
                  <c:v>7.405962656592</c:v>
                </c:pt>
                <c:pt idx="83">
                  <c:v>7.68914879857582</c:v>
                </c:pt>
                <c:pt idx="84">
                  <c:v>7.9712946787691017</c:v>
                </c:pt>
                <c:pt idx="85">
                  <c:v>8.2522757094938815</c:v>
                </c:pt>
                <c:pt idx="86">
                  <c:v>8.5319678174369304</c:v>
                </c:pt>
                <c:pt idx="87">
                  <c:v>8.810247498437036</c:v>
                </c:pt>
                <c:pt idx="88">
                  <c:v>9.0869918720209597</c:v>
                </c:pt>
                <c:pt idx="89">
                  <c:v>9.3620787356639958</c:v>
                </c:pt>
                <c:pt idx="90">
                  <c:v>9.6353866187511805</c:v>
                </c:pt>
                <c:pt idx="91">
                  <c:v>9.9067948362152656</c:v>
                </c:pt>
                <c:pt idx="92">
                  <c:v>10.176183541827875</c:v>
                </c:pt>
                <c:pt idx="93">
                  <c:v>10.443433781120209</c:v>
                </c:pt>
                <c:pt idx="94">
                  <c:v>10.708427543910002</c:v>
                </c:pt>
                <c:pt idx="95">
                  <c:v>10.971047816411481</c:v>
                </c:pt>
                <c:pt idx="96">
                  <c:v>11.231178632905372</c:v>
                </c:pt>
                <c:pt idx="97">
                  <c:v>11.488705126946096</c:v>
                </c:pt>
                <c:pt idx="98">
                  <c:v>11.743513582083548</c:v>
                </c:pt>
                <c:pt idx="99">
                  <c:v>11.995491482077092</c:v>
                </c:pt>
                <c:pt idx="100">
                  <c:v>12.244527560579559</c:v>
                </c:pt>
                <c:pt idx="101">
                  <c:v>12.49051185026933</c:v>
                </c:pt>
                <c:pt idx="102">
                  <c:v>12.733335731408822</c:v>
                </c:pt>
                <c:pt idx="103">
                  <c:v>12.972891979807894</c:v>
                </c:pt>
                <c:pt idx="104">
                  <c:v>13.209074814171037</c:v>
                </c:pt>
                <c:pt idx="105">
                  <c:v>13.441779942807415</c:v>
                </c:pt>
                <c:pt idx="106">
                  <c:v>13.670904609683134</c:v>
                </c:pt>
                <c:pt idx="107">
                  <c:v>13.896347639795428</c:v>
                </c:pt>
                <c:pt idx="108">
                  <c:v>14.118009483848683</c:v>
                </c:pt>
                <c:pt idx="109">
                  <c:v>14.335792262212598</c:v>
                </c:pt>
                <c:pt idx="110">
                  <c:v>14.549599808143082</c:v>
                </c:pt>
                <c:pt idx="111">
                  <c:v>14.759337710246781</c:v>
                </c:pt>
                <c:pt idx="112">
                  <c:v>14.96491335417049</c:v>
                </c:pt>
                <c:pt idx="113">
                  <c:v>15.166235963497041</c:v>
                </c:pt>
                <c:pt idx="114">
                  <c:v>15.363216639829616</c:v>
                </c:pt>
                <c:pt idx="115">
                  <c:v>15.555768402046786</c:v>
                </c:pt>
                <c:pt idx="116">
                  <c:v>15.743806224710902</c:v>
                </c:pt>
                <c:pt idx="117">
                  <c:v>15.927247075612961</c:v>
                </c:pt>
                <c:pt idx="118">
                  <c:v>16.106009952437276</c:v>
                </c:pt>
                <c:pt idx="119">
                  <c:v>16.280015918529813</c:v>
                </c:pt>
                <c:pt idx="120">
                  <c:v>16.449188137754426</c:v>
                </c:pt>
                <c:pt idx="121">
                  <c:v>16.613451908421482</c:v>
                </c:pt>
                <c:pt idx="122">
                  <c:v>16.772734696274085</c:v>
                </c:pt>
                <c:pt idx="123">
                  <c:v>16.926966166517104</c:v>
                </c:pt>
                <c:pt idx="124">
                  <c:v>17.076078214875075</c:v>
                </c:pt>
                <c:pt idx="125">
                  <c:v>17.220004997665121</c:v>
                </c:pt>
                <c:pt idx="126">
                  <c:v>17.358682960871661</c:v>
                </c:pt>
                <c:pt idx="127">
                  <c:v>17.492050868210089</c:v>
                </c:pt>
                <c:pt idx="128">
                  <c:v>17.620049828166984</c:v>
                </c:pt>
                <c:pt idx="129">
                  <c:v>17.742623320004949</c:v>
                </c:pt>
                <c:pt idx="130">
                  <c:v>17.859717218720569</c:v>
                </c:pt>
                <c:pt idx="131">
                  <c:v>17.971279818944502</c:v>
                </c:pt>
                <c:pt idx="132">
                  <c:v>18.077261857773109</c:v>
                </c:pt>
                <c:pt idx="133">
                  <c:v>18.177616536521548</c:v>
                </c:pt>
                <c:pt idx="134">
                  <c:v>18.27229954138879</c:v>
                </c:pt>
                <c:pt idx="135">
                  <c:v>18.361269063025325</c:v>
                </c:pt>
                <c:pt idx="136">
                  <c:v>18.44448581499498</c:v>
                </c:pt>
                <c:pt idx="137">
                  <c:v>18.521913051122745</c:v>
                </c:pt>
                <c:pt idx="138">
                  <c:v>18.593516581720806</c:v>
                </c:pt>
                <c:pt idx="139">
                  <c:v>18.659264788685775</c:v>
                </c:pt>
                <c:pt idx="140">
                  <c:v>18.719128639460344</c:v>
                </c:pt>
                <c:pt idx="141">
                  <c:v>18.773081699853243</c:v>
                </c:pt>
                <c:pt idx="142">
                  <c:v>18.821100145711846</c:v>
                </c:pt>
                <c:pt idx="143">
                  <c:v>18.863162773442234</c:v>
                </c:pt>
                <c:pt idx="144">
                  <c:v>18.899251009372115</c:v>
                </c:pt>
                <c:pt idx="145">
                  <c:v>18.929348917952431</c:v>
                </c:pt>
                <c:pt idx="146">
                  <c:v>18.953443208794035</c:v>
                </c:pt>
                <c:pt idx="147">
                  <c:v>18.971523242536382</c:v>
                </c:pt>
                <c:pt idx="148">
                  <c:v>18.983581035545541</c:v>
                </c:pt>
                <c:pt idx="149">
                  <c:v>18.989611263439556</c:v>
                </c:pt>
                <c:pt idx="150">
                  <c:v>18.989611263439556</c:v>
                </c:pt>
                <c:pt idx="151">
                  <c:v>18.983581035545534</c:v>
                </c:pt>
                <c:pt idx="152">
                  <c:v>18.971523242536371</c:v>
                </c:pt>
                <c:pt idx="153">
                  <c:v>18.95344320879402</c:v>
                </c:pt>
                <c:pt idx="154">
                  <c:v>18.92934891795241</c:v>
                </c:pt>
                <c:pt idx="155">
                  <c:v>18.899251009372094</c:v>
                </c:pt>
                <c:pt idx="156">
                  <c:v>18.863162773442205</c:v>
                </c:pt>
                <c:pt idx="157">
                  <c:v>18.82110014571181</c:v>
                </c:pt>
                <c:pt idx="158">
                  <c:v>18.773081699853208</c:v>
                </c:pt>
                <c:pt idx="159">
                  <c:v>18.719128639460301</c:v>
                </c:pt>
                <c:pt idx="160">
                  <c:v>18.659264788685732</c:v>
                </c:pt>
                <c:pt idx="161">
                  <c:v>18.593516581720756</c:v>
                </c:pt>
                <c:pt idx="162">
                  <c:v>18.521913051122691</c:v>
                </c:pt>
                <c:pt idx="163">
                  <c:v>18.444485814994923</c:v>
                </c:pt>
                <c:pt idx="164">
                  <c:v>18.361269063025262</c:v>
                </c:pt>
                <c:pt idx="165">
                  <c:v>18.272299541388726</c:v>
                </c:pt>
                <c:pt idx="166">
                  <c:v>18.17761653652148</c:v>
                </c:pt>
                <c:pt idx="167">
                  <c:v>18.077261857773035</c:v>
                </c:pt>
                <c:pt idx="168">
                  <c:v>17.971279818944428</c:v>
                </c:pt>
                <c:pt idx="169">
                  <c:v>17.85971721872049</c:v>
                </c:pt>
                <c:pt idx="170">
                  <c:v>17.742623320004867</c:v>
                </c:pt>
                <c:pt idx="171">
                  <c:v>17.620049828166898</c:v>
                </c:pt>
                <c:pt idx="172">
                  <c:v>17.492050868210001</c:v>
                </c:pt>
                <c:pt idx="173">
                  <c:v>17.358682960871565</c:v>
                </c:pt>
                <c:pt idx="174">
                  <c:v>17.220004997665022</c:v>
                </c:pt>
                <c:pt idx="175">
                  <c:v>17.076078214874975</c:v>
                </c:pt>
                <c:pt idx="176">
                  <c:v>16.926966166516998</c:v>
                </c:pt>
                <c:pt idx="177">
                  <c:v>16.772734696273975</c:v>
                </c:pt>
                <c:pt idx="178">
                  <c:v>16.613451908421375</c:v>
                </c:pt>
                <c:pt idx="179">
                  <c:v>16.449188137754305</c:v>
                </c:pt>
                <c:pt idx="180">
                  <c:v>16.280015918529692</c:v>
                </c:pt>
                <c:pt idx="181">
                  <c:v>16.106009952437148</c:v>
                </c:pt>
                <c:pt idx="182">
                  <c:v>15.927247075612835</c:v>
                </c:pt>
                <c:pt idx="183">
                  <c:v>15.743806224710774</c:v>
                </c:pt>
                <c:pt idx="184">
                  <c:v>15.555768402046652</c:v>
                </c:pt>
                <c:pt idx="185">
                  <c:v>15.363216639829481</c:v>
                </c:pt>
                <c:pt idx="186">
                  <c:v>15.1662359634969</c:v>
                </c:pt>
                <c:pt idx="187">
                  <c:v>14.964913354170349</c:v>
                </c:pt>
                <c:pt idx="188">
                  <c:v>14.759337710246637</c:v>
                </c:pt>
                <c:pt idx="189">
                  <c:v>14.549599808142935</c:v>
                </c:pt>
                <c:pt idx="190">
                  <c:v>14.335792262212447</c:v>
                </c:pt>
                <c:pt idx="191">
                  <c:v>14.118009483848535</c:v>
                </c:pt>
                <c:pt idx="192">
                  <c:v>13.896347639795277</c:v>
                </c:pt>
                <c:pt idx="193">
                  <c:v>13.670904609682978</c:v>
                </c:pt>
                <c:pt idx="194">
                  <c:v>13.441779942807253</c:v>
                </c:pt>
                <c:pt idx="195">
                  <c:v>13.209074814170872</c:v>
                </c:pt>
                <c:pt idx="196">
                  <c:v>12.972891979807729</c:v>
                </c:pt>
                <c:pt idx="197">
                  <c:v>12.733335731408655</c:v>
                </c:pt>
                <c:pt idx="198">
                  <c:v>12.490511850269161</c:v>
                </c:pt>
                <c:pt idx="199">
                  <c:v>12.244527560579385</c:v>
                </c:pt>
                <c:pt idx="200">
                  <c:v>11.995491482076918</c:v>
                </c:pt>
                <c:pt idx="201">
                  <c:v>11.743513582083372</c:v>
                </c:pt>
                <c:pt idx="202">
                  <c:v>11.488705126945916</c:v>
                </c:pt>
                <c:pt idx="203">
                  <c:v>11.231178632905191</c:v>
                </c:pt>
                <c:pt idx="204">
                  <c:v>10.971047816411296</c:v>
                </c:pt>
                <c:pt idx="205">
                  <c:v>10.708427543909815</c:v>
                </c:pt>
                <c:pt idx="206">
                  <c:v>10.443433781120021</c:v>
                </c:pt>
                <c:pt idx="207">
                  <c:v>10.176183541827683</c:v>
                </c:pt>
                <c:pt idx="208">
                  <c:v>9.9067948362150737</c:v>
                </c:pt>
                <c:pt idx="209">
                  <c:v>9.6353866187509851</c:v>
                </c:pt>
                <c:pt idx="210">
                  <c:v>9.3620787356638022</c:v>
                </c:pt>
                <c:pt idx="211">
                  <c:v>9.0869918720207608</c:v>
                </c:pt>
                <c:pt idx="212">
                  <c:v>8.8102474984368353</c:v>
                </c:pt>
                <c:pt idx="213">
                  <c:v>8.5319678174367297</c:v>
                </c:pt>
                <c:pt idx="214">
                  <c:v>8.2522757094936914</c:v>
                </c:pt>
                <c:pt idx="215">
                  <c:v>7.9712946787689107</c:v>
                </c:pt>
                <c:pt idx="216">
                  <c:v>7.6891487985756291</c:v>
                </c:pt>
                <c:pt idx="217">
                  <c:v>7.4059626565918082</c:v>
                </c:pt>
                <c:pt idx="218">
                  <c:v>7.1218612998457331</c:v>
                </c:pt>
                <c:pt idx="219">
                  <c:v>6.8369701794987634</c:v>
                </c:pt>
                <c:pt idx="220">
                  <c:v>6.5514150954496326</c:v>
                </c:pt>
                <c:pt idx="221">
                  <c:v>6.2653221407847521</c:v>
                </c:pt>
                <c:pt idx="222">
                  <c:v>5.9788176460990563</c:v>
                </c:pt>
                <c:pt idx="223">
                  <c:v>5.6920281237119692</c:v>
                </c:pt>
                <c:pt idx="224">
                  <c:v>5.4050802118031207</c:v>
                </c:pt>
                <c:pt idx="225">
                  <c:v>5.1181006184924973</c:v>
                </c:pt>
                <c:pt idx="226">
                  <c:v>4.8312160658896994</c:v>
                </c:pt>
                <c:pt idx="227">
                  <c:v>4.5445532341370258</c:v>
                </c:pt>
                <c:pt idx="228">
                  <c:v>4.2582387054710917</c:v>
                </c:pt>
                <c:pt idx="229">
                  <c:v>3.9723989083276732</c:v>
                </c:pt>
                <c:pt idx="230">
                  <c:v>3.6871600615144686</c:v>
                </c:pt>
                <c:pt idx="231">
                  <c:v>3.4026481184764306</c:v>
                </c:pt>
                <c:pt idx="232">
                  <c:v>3.118988711678266</c:v>
                </c:pt>
                <c:pt idx="233">
                  <c:v>2.836307097128679</c:v>
                </c:pt>
                <c:pt idx="234">
                  <c:v>2.5547280990708421</c:v>
                </c:pt>
                <c:pt idx="235">
                  <c:v>2.2743760548635255</c:v>
                </c:pt>
                <c:pt idx="236">
                  <c:v>1.9953747600772194</c:v>
                </c:pt>
                <c:pt idx="237">
                  <c:v>1.7178474138294937</c:v>
                </c:pt>
                <c:pt idx="238">
                  <c:v>1.4419165643837384</c:v>
                </c:pt>
                <c:pt idx="239">
                  <c:v>1.1677040550352977</c:v>
                </c:pt>
                <c:pt idx="240">
                  <c:v>0.89533097030890296</c:v>
                </c:pt>
                <c:pt idx="241">
                  <c:v>0.62491758249115392</c:v>
                </c:pt>
                <c:pt idx="242">
                  <c:v>0.35658329852167459</c:v>
                </c:pt>
                <c:pt idx="243">
                  <c:v>9.0446607266325252E-2</c:v>
                </c:pt>
                <c:pt idx="244">
                  <c:v>-0.17337497280407899</c:v>
                </c:pt>
                <c:pt idx="245">
                  <c:v>-0.43476494550665823</c:v>
                </c:pt>
                <c:pt idx="246">
                  <c:v>-0.69360788838789578</c:v>
                </c:pt>
                <c:pt idx="247">
                  <c:v>-0.94978950369094228</c:v>
                </c:pt>
                <c:pt idx="248">
                  <c:v>-1.2031966688262861</c:v>
                </c:pt>
                <c:pt idx="249">
                  <c:v>-1.4537174863235061</c:v>
                </c:pt>
                <c:pt idx="250">
                  <c:v>-1.7012413332420451</c:v>
                </c:pt>
                <c:pt idx="251">
                  <c:v>-1.9456589100191835</c:v>
                </c:pt>
                <c:pt idx="252">
                  <c:v>-2.1868622887336517</c:v>
                </c:pt>
                <c:pt idx="253">
                  <c:v>-2.4247449607635625</c:v>
                </c:pt>
                <c:pt idx="254">
                  <c:v>-2.6592018838176203</c:v>
                </c:pt>
                <c:pt idx="255">
                  <c:v>-2.890129528318834</c:v>
                </c:pt>
                <c:pt idx="256">
                  <c:v>-3.117425923120269</c:v>
                </c:pt>
                <c:pt idx="257">
                  <c:v>-3.3409907005326378</c:v>
                </c:pt>
                <c:pt idx="258">
                  <c:v>-3.5607251406438376</c:v>
                </c:pt>
                <c:pt idx="259">
                  <c:v>-3.7765322149108975</c:v>
                </c:pt>
                <c:pt idx="260">
                  <c:v>-3.988316629005034</c:v>
                </c:pt>
                <c:pt idx="261">
                  <c:v>-4.1959848648909599</c:v>
                </c:pt>
                <c:pt idx="262">
                  <c:v>-4.3994452221218054</c:v>
                </c:pt>
                <c:pt idx="263">
                  <c:v>-4.5986078583314605</c:v>
                </c:pt>
                <c:pt idx="264">
                  <c:v>-4.7933848289064347</c:v>
                </c:pt>
                <c:pt idx="265">
                  <c:v>-4.9836901258197148</c:v>
                </c:pt>
                <c:pt idx="266">
                  <c:v>-5.1694397156094976</c:v>
                </c:pt>
                <c:pt idx="267">
                  <c:v>-5.3505515764859961</c:v>
                </c:pt>
                <c:pt idx="268">
                  <c:v>-5.5269457345499546</c:v>
                </c:pt>
                <c:pt idx="269">
                  <c:v>-5.6985442991068709</c:v>
                </c:pt>
                <c:pt idx="270">
                  <c:v>-5.8652714970613307</c:v>
                </c:pt>
                <c:pt idx="271">
                  <c:v>-6.027053706376277</c:v>
                </c:pt>
                <c:pt idx="272">
                  <c:v>-6.18381948858244</c:v>
                </c:pt>
                <c:pt idx="273">
                  <c:v>-6.3354996203235334</c:v>
                </c:pt>
                <c:pt idx="274">
                  <c:v>-6.4820271239233449</c:v>
                </c:pt>
                <c:pt idx="275">
                  <c:v>-6.623337296961207</c:v>
                </c:pt>
                <c:pt idx="276">
                  <c:v>-6.7593677408427446</c:v>
                </c:pt>
                <c:pt idx="277">
                  <c:v>-6.8900583883533582</c:v>
                </c:pt>
                <c:pt idx="278">
                  <c:v>-7.0153515301821958</c:v>
                </c:pt>
                <c:pt idx="279">
                  <c:v>-7.135191840404973</c:v>
                </c:pt>
                <c:pt idx="280">
                  <c:v>-7.2495264009143359</c:v>
                </c:pt>
                <c:pt idx="281">
                  <c:v>-7.3583047247870148</c:v>
                </c:pt>
                <c:pt idx="282">
                  <c:v>-7.4614787785774226</c:v>
                </c:pt>
                <c:pt idx="283">
                  <c:v>-7.5590030035278737</c:v>
                </c:pt>
                <c:pt idx="284">
                  <c:v>-7.6508343356860458</c:v>
                </c:pt>
                <c:pt idx="285">
                  <c:v>-7.7369322249208192</c:v>
                </c:pt>
                <c:pt idx="286">
                  <c:v>-7.8172586528280608</c:v>
                </c:pt>
                <c:pt idx="287">
                  <c:v>-7.8917781495184887</c:v>
                </c:pt>
                <c:pt idx="288">
                  <c:v>-7.9604578092801717</c:v>
                </c:pt>
                <c:pt idx="289">
                  <c:v>-8.0232673051087726</c:v>
                </c:pt>
                <c:pt idx="290">
                  <c:v>-8.0801789020990924</c:v>
                </c:pt>
                <c:pt idx="291">
                  <c:v>-8.1311674696920253</c:v>
                </c:pt>
                <c:pt idx="292">
                  <c:v>-8.1762104927715118</c:v>
                </c:pt>
                <c:pt idx="293">
                  <c:v>-8.2152880816065732</c:v>
                </c:pt>
                <c:pt idx="294">
                  <c:v>-8.2483829806340552</c:v>
                </c:pt>
                <c:pt idx="295">
                  <c:v>-8.2754805760782091</c:v>
                </c:pt>
                <c:pt idx="296">
                  <c:v>-8.2965689024037168</c:v>
                </c:pt>
                <c:pt idx="297">
                  <c:v>-8.3116386475993291</c:v>
                </c:pt>
                <c:pt idx="298">
                  <c:v>-8.320683157289805</c:v>
                </c:pt>
                <c:pt idx="299">
                  <c:v>-8.3236984376742704</c:v>
                </c:pt>
              </c:numCache>
            </c:numRef>
          </c:xVal>
          <c:yVal>
            <c:numRef>
              <c:f>'Covariance   Correlation3'!yycir7</c:f>
              <c:numCache>
                <c:formatCode>General</c:formatCode>
                <c:ptCount val="300"/>
                <c:pt idx="0">
                  <c:v>1.4806419879559831</c:v>
                </c:pt>
                <c:pt idx="1">
                  <c:v>1.4540954960686951</c:v>
                </c:pt>
                <c:pt idx="2">
                  <c:v>1.4270845055559234</c:v>
                </c:pt>
                <c:pt idx="3">
                  <c:v>1.3996209437106875</c:v>
                </c:pt>
                <c:pt idx="4">
                  <c:v>1.3717169376687677</c:v>
                </c:pt>
                <c:pt idx="5">
                  <c:v>1.3433848090537026</c:v>
                </c:pt>
                <c:pt idx="6">
                  <c:v>1.3146370685359061</c:v>
                </c:pt>
                <c:pt idx="7">
                  <c:v>1.2854864103083099</c:v>
                </c:pt>
                <c:pt idx="8">
                  <c:v>1.2559457064809616</c:v>
                </c:pt>
                <c:pt idx="9">
                  <c:v>1.2260280013970668</c:v>
                </c:pt>
                <c:pt idx="10">
                  <c:v>1.1957465058729733</c:v>
                </c:pt>
                <c:pt idx="11">
                  <c:v>1.165114591364645</c:v>
                </c:pt>
                <c:pt idx="12">
                  <c:v>1.1341457840632061</c:v>
                </c:pt>
                <c:pt idx="13">
                  <c:v>1.1028537589221523</c:v>
                </c:pt>
                <c:pt idx="14">
                  <c:v>1.0712523336188804</c:v>
                </c:pt>
                <c:pt idx="15">
                  <c:v>1.0393554624531873</c:v>
                </c:pt>
                <c:pt idx="16">
                  <c:v>1.0071772301854467</c:v>
                </c:pt>
                <c:pt idx="17">
                  <c:v>0.97473184581717343</c:v>
                </c:pt>
                <c:pt idx="18">
                  <c:v>0.94203363631672954</c:v>
                </c:pt>
                <c:pt idx="19">
                  <c:v>0.90909704029293859</c:v>
                </c:pt>
                <c:pt idx="20">
                  <c:v>0.87593660161940157</c:v>
                </c:pt>
                <c:pt idx="21">
                  <c:v>0.84256696301233214</c:v>
                </c:pt>
                <c:pt idx="22">
                  <c:v>0.80900285956474582</c:v>
                </c:pt>
                <c:pt idx="23">
                  <c:v>0.77525911223985733</c:v>
                </c:pt>
                <c:pt idx="24">
                  <c:v>0.74135062132655904</c:v>
                </c:pt>
                <c:pt idx="25">
                  <c:v>0.70729235985987549</c:v>
                </c:pt>
                <c:pt idx="26">
                  <c:v>0.67309936700929163</c:v>
                </c:pt>
                <c:pt idx="27">
                  <c:v>0.63878674143787817</c:v>
                </c:pt>
                <c:pt idx="28">
                  <c:v>0.60436963463514726</c:v>
                </c:pt>
                <c:pt idx="29">
                  <c:v>0.56986324422658241</c:v>
                </c:pt>
                <c:pt idx="30">
                  <c:v>0.53528280726279309</c:v>
                </c:pt>
                <c:pt idx="31">
                  <c:v>0.50064359349126364</c:v>
                </c:pt>
                <c:pt idx="32">
                  <c:v>0.46596089861366186</c:v>
                </c:pt>
                <c:pt idx="33">
                  <c:v>0.43125003753168811</c:v>
                </c:pt>
                <c:pt idx="34">
                  <c:v>0.396526337584446</c:v>
                </c:pt>
                <c:pt idx="35">
                  <c:v>0.36180513178031914</c:v>
                </c:pt>
                <c:pt idx="36">
                  <c:v>0.32710175202634917</c:v>
                </c:pt>
                <c:pt idx="37">
                  <c:v>0.29243152235809544</c:v>
                </c:pt>
                <c:pt idx="38">
                  <c:v>0.25780975217297297</c:v>
                </c:pt>
                <c:pt idx="39">
                  <c:v>0.22325172947005267</c:v>
                </c:pt>
                <c:pt idx="40">
                  <c:v>0.18877271409931207</c:v>
                </c:pt>
                <c:pt idx="41">
                  <c:v>0.15438793102331494</c:v>
                </c:pt>
                <c:pt idx="42">
                  <c:v>0.12011256359429678</c:v>
                </c:pt>
                <c:pt idx="43">
                  <c:v>8.59617468496231E-2</c:v>
                </c:pt>
                <c:pt idx="44">
                  <c:v>5.1950560828583514E-2</c:v>
                </c:pt>
                <c:pt idx="45">
                  <c:v>1.8094023913471147E-2</c:v>
                </c:pt>
                <c:pt idx="46">
                  <c:v>-1.559291380211314E-2</c:v>
                </c:pt>
                <c:pt idx="47">
                  <c:v>-4.9095377114799388E-2</c:v>
                </c:pt>
                <c:pt idx="48">
                  <c:v>-8.2398572279922089E-2</c:v>
                </c:pt>
                <c:pt idx="49">
                  <c:v>-0.11548779354401983</c:v>
                </c:pt>
                <c:pt idx="50">
                  <c:v>-0.14834842963848116</c:v>
                </c:pt>
                <c:pt idx="51">
                  <c:v>-0.18096597023147198</c:v>
                </c:pt>
                <c:pt idx="52">
                  <c:v>-0.21332601233528753</c:v>
                </c:pt>
                <c:pt idx="53">
                  <c:v>-0.24541426666630706</c:v>
                </c:pt>
                <c:pt idx="54">
                  <c:v>-0.27721656395473887</c:v>
                </c:pt>
                <c:pt idx="55">
                  <c:v>-0.30871886120137243</c:v>
                </c:pt>
                <c:pt idx="56">
                  <c:v>-0.33990724787856935</c:v>
                </c:pt>
                <c:pt idx="57">
                  <c:v>-0.37076795207276136</c:v>
                </c:pt>
                <c:pt idx="58">
                  <c:v>-0.40128734656574117</c:v>
                </c:pt>
                <c:pt idx="59">
                  <c:v>-0.43145195485205612</c:v>
                </c:pt>
                <c:pt idx="60">
                  <c:v>-0.46124845708985573</c:v>
                </c:pt>
                <c:pt idx="61">
                  <c:v>-0.49066369598255727</c:v>
                </c:pt>
                <c:pt idx="62">
                  <c:v>-0.5196846825887389</c:v>
                </c:pt>
                <c:pt idx="63">
                  <c:v>-0.54829860205768943</c:v>
                </c:pt>
                <c:pt idx="64">
                  <c:v>-0.57649281928808571</c:v>
                </c:pt>
                <c:pt idx="65">
                  <c:v>-0.6042548845072987</c:v>
                </c:pt>
                <c:pt idx="66">
                  <c:v>-0.63157253876886144</c:v>
                </c:pt>
                <c:pt idx="67">
                  <c:v>-0.65843371936567552</c:v>
                </c:pt>
                <c:pt idx="68">
                  <c:v>-0.68482656515656226</c:v>
                </c:pt>
                <c:pt idx="69">
                  <c:v>-0.71073942180380945</c:v>
                </c:pt>
                <c:pt idx="70">
                  <c:v>-0.73616084691939854</c:v>
                </c:pt>
                <c:pt idx="71">
                  <c:v>-0.76107961511764088</c:v>
                </c:pt>
                <c:pt idx="72">
                  <c:v>-0.78548472297199179</c:v>
                </c:pt>
                <c:pt idx="73">
                  <c:v>-0.80936539387385464</c:v>
                </c:pt>
                <c:pt idx="74">
                  <c:v>-0.83271108279122774</c:v>
                </c:pt>
                <c:pt idx="75">
                  <c:v>-0.85551148092509244</c:v>
                </c:pt>
                <c:pt idx="76">
                  <c:v>-0.87775652026149131</c:v>
                </c:pt>
                <c:pt idx="77">
                  <c:v>-0.89943637801727616</c:v>
                </c:pt>
                <c:pt idx="78">
                  <c:v>-0.92054148097757504</c:v>
                </c:pt>
                <c:pt idx="79">
                  <c:v>-0.9410625097230535</c:v>
                </c:pt>
                <c:pt idx="80">
                  <c:v>-0.96099040274510827</c:v>
                </c:pt>
                <c:pt idx="81">
                  <c:v>-0.98031636044717374</c:v>
                </c:pt>
                <c:pt idx="82">
                  <c:v>-0.99903184903037645</c:v>
                </c:pt>
                <c:pt idx="83">
                  <c:v>-1.0171286042618211</c:v>
                </c:pt>
                <c:pt idx="84">
                  <c:v>-1.0345986351238414</c:v>
                </c:pt>
                <c:pt idx="85">
                  <c:v>-1.0514342273426103</c:v>
                </c:pt>
                <c:pt idx="86">
                  <c:v>-1.0676279467945455</c:v>
                </c:pt>
                <c:pt idx="87">
                  <c:v>-1.0831726427890083</c:v>
                </c:pt>
                <c:pt idx="88">
                  <c:v>-1.0980614512258491</c:v>
                </c:pt>
                <c:pt idx="89">
                  <c:v>-1.1122877976263987</c:v>
                </c:pt>
                <c:pt idx="90">
                  <c:v>-1.1258454000365754</c:v>
                </c:pt>
                <c:pt idx="91">
                  <c:v>-1.1387282718008165</c:v>
                </c:pt>
                <c:pt idx="92">
                  <c:v>-1.1509307242056188</c:v>
                </c:pt>
                <c:pt idx="93">
                  <c:v>-1.1624473689915127</c:v>
                </c:pt>
                <c:pt idx="94">
                  <c:v>-1.1732731207323681</c:v>
                </c:pt>
                <c:pt idx="95">
                  <c:v>-1.1834031990809737</c:v>
                </c:pt>
                <c:pt idx="96">
                  <c:v>-1.1928331308799038</c:v>
                </c:pt>
                <c:pt idx="97">
                  <c:v>-1.2015587521367392</c:v>
                </c:pt>
                <c:pt idx="98">
                  <c:v>-1.20957620986277</c:v>
                </c:pt>
                <c:pt idx="99">
                  <c:v>-1.2168819637743642</c:v>
                </c:pt>
                <c:pt idx="100">
                  <c:v>-1.2234727878562603</c:v>
                </c:pt>
                <c:pt idx="101">
                  <c:v>-1.2293457717860825</c:v>
                </c:pt>
                <c:pt idx="102">
                  <c:v>-1.234498322219459</c:v>
                </c:pt>
                <c:pt idx="103">
                  <c:v>-1.2389281639351688</c:v>
                </c:pt>
                <c:pt idx="104">
                  <c:v>-1.2426333408398151</c:v>
                </c:pt>
                <c:pt idx="105">
                  <c:v>-1.2456122168315815</c:v>
                </c:pt>
                <c:pt idx="106">
                  <c:v>-1.2478634765226895</c:v>
                </c:pt>
                <c:pt idx="107">
                  <c:v>-1.2493861258202346</c:v>
                </c:pt>
                <c:pt idx="108">
                  <c:v>-1.2501794923651517</c:v>
                </c:pt>
                <c:pt idx="109">
                  <c:v>-1.2502432258291081</c:v>
                </c:pt>
                <c:pt idx="110">
                  <c:v>-1.2495772980692008</c:v>
                </c:pt>
                <c:pt idx="111">
                  <c:v>-1.2481820031403816</c:v>
                </c:pt>
                <c:pt idx="112">
                  <c:v>-1.2460579571656125</c:v>
                </c:pt>
                <c:pt idx="113">
                  <c:v>-1.2432060980638013</c:v>
                </c:pt>
                <c:pt idx="114">
                  <c:v>-1.239627685135644</c:v>
                </c:pt>
                <c:pt idx="115">
                  <c:v>-1.2353242985075537</c:v>
                </c:pt>
                <c:pt idx="116">
                  <c:v>-1.2302978384339194</c:v>
                </c:pt>
                <c:pt idx="117">
                  <c:v>-1.2245505244580097</c:v>
                </c:pt>
                <c:pt idx="118">
                  <c:v>-1.2180848944318825</c:v>
                </c:pt>
                <c:pt idx="119">
                  <c:v>-1.2109038033957424</c:v>
                </c:pt>
                <c:pt idx="120">
                  <c:v>-1.2030104223172355</c:v>
                </c:pt>
                <c:pt idx="121">
                  <c:v>-1.1944082366912379</c:v>
                </c:pt>
                <c:pt idx="122">
                  <c:v>-1.1851010450007604</c:v>
                </c:pt>
                <c:pt idx="123">
                  <c:v>-1.1750929570396458</c:v>
                </c:pt>
                <c:pt idx="124">
                  <c:v>-1.1643883920977982</c:v>
                </c:pt>
                <c:pt idx="125">
                  <c:v>-1.1529920770097504</c:v>
                </c:pt>
                <c:pt idx="126">
                  <c:v>-1.1409090440674259</c:v>
                </c:pt>
                <c:pt idx="127">
                  <c:v>-1.1281446287980206</c:v>
                </c:pt>
                <c:pt idx="128">
                  <c:v>-1.1147044676079845</c:v>
                </c:pt>
                <c:pt idx="129">
                  <c:v>-1.1005944952941433</c:v>
                </c:pt>
                <c:pt idx="130">
                  <c:v>-1.0858209424230589</c:v>
                </c:pt>
                <c:pt idx="131">
                  <c:v>-1.0703903325797866</c:v>
                </c:pt>
                <c:pt idx="132">
                  <c:v>-1.0543094794872439</c:v>
                </c:pt>
                <c:pt idx="133">
                  <c:v>-1.0375854839974616</c:v>
                </c:pt>
                <c:pt idx="134">
                  <c:v>-1.0202257309560485</c:v>
                </c:pt>
                <c:pt idx="135">
                  <c:v>-1.0022378859412511</c:v>
                </c:pt>
                <c:pt idx="136">
                  <c:v>-0.98362989187904915</c:v>
                </c:pt>
                <c:pt idx="137">
                  <c:v>-0.96440996553578362</c:v>
                </c:pt>
                <c:pt idx="138">
                  <c:v>-0.94458659388986521</c:v>
                </c:pt>
                <c:pt idx="139">
                  <c:v>-0.92416853038416202</c:v>
                </c:pt>
                <c:pt idx="140">
                  <c:v>-0.90316479106072611</c:v>
                </c:pt>
                <c:pt idx="141">
                  <c:v>-0.88158465057956348</c:v>
                </c:pt>
                <c:pt idx="142">
                  <c:v>-0.85943763812320462</c:v>
                </c:pt>
                <c:pt idx="143">
                  <c:v>-0.83673353318888655</c:v>
                </c:pt>
                <c:pt idx="144">
                  <c:v>-0.81348236127020157</c:v>
                </c:pt>
                <c:pt idx="145">
                  <c:v>-0.78969438943012182</c:v>
                </c:pt>
                <c:pt idx="146">
                  <c:v>-0.76538012176735315</c:v>
                </c:pt>
                <c:pt idx="147">
                  <c:v>-0.74055029477802092</c:v>
                </c:pt>
                <c:pt idx="148">
                  <c:v>-0.71521587261473507</c:v>
                </c:pt>
                <c:pt idx="149">
                  <c:v>-0.68938804224513039</c:v>
                </c:pt>
                <c:pt idx="150">
                  <c:v>-0.66307820851201515</c:v>
                </c:pt>
                <c:pt idx="151">
                  <c:v>-0.63629798909731294</c:v>
                </c:pt>
                <c:pt idx="152">
                  <c:v>-0.60905920939202396</c:v>
                </c:pt>
                <c:pt idx="153">
                  <c:v>-0.58137389727446265</c:v>
                </c:pt>
                <c:pt idx="154">
                  <c:v>-0.55325427779908765</c:v>
                </c:pt>
                <c:pt idx="155">
                  <c:v>-0.52471276779825859</c:v>
                </c:pt>
                <c:pt idx="156">
                  <c:v>-0.49576197039931635</c:v>
                </c:pt>
                <c:pt idx="157">
                  <c:v>-0.46641466945939369</c:v>
                </c:pt>
                <c:pt idx="158">
                  <c:v>-0.43668382392042582</c:v>
                </c:pt>
                <c:pt idx="159">
                  <c:v>-0.40658256208684507</c:v>
                </c:pt>
                <c:pt idx="160">
                  <c:v>-0.37612417582849167</c:v>
                </c:pt>
                <c:pt idx="161">
                  <c:v>-0.34532211471129948</c:v>
                </c:pt>
                <c:pt idx="162">
                  <c:v>-0.31418998005834387</c:v>
                </c:pt>
                <c:pt idx="163">
                  <c:v>-0.28274151894388255</c:v>
                </c:pt>
                <c:pt idx="164">
                  <c:v>-0.25099061812303369</c:v>
                </c:pt>
                <c:pt idx="165">
                  <c:v>-0.21895129789977441</c:v>
                </c:pt>
                <c:pt idx="166">
                  <c:v>-0.18663770593597206</c:v>
                </c:pt>
                <c:pt idx="167">
                  <c:v>-0.15406411100417339</c:v>
                </c:pt>
                <c:pt idx="168">
                  <c:v>-0.12124489668691585</c:v>
                </c:pt>
                <c:pt idx="169">
                  <c:v>-8.8194555025343568E-2</c:v>
                </c:pt>
                <c:pt idx="170">
                  <c:v>-5.492768011992899E-2</c:v>
                </c:pt>
                <c:pt idx="171">
                  <c:v>-2.1458961686129929E-2</c:v>
                </c:pt>
                <c:pt idx="172">
                  <c:v>1.2196821432176486E-2</c:v>
                </c:pt>
                <c:pt idx="173">
                  <c:v>4.6024807788614175E-2</c:v>
                </c:pt>
                <c:pt idx="174">
                  <c:v>8.0010059896704289E-2</c:v>
                </c:pt>
                <c:pt idx="175">
                  <c:v>0.11413757082584042</c:v>
                </c:pt>
                <c:pt idx="176">
                  <c:v>0.14839227082792461</c:v>
                </c:pt>
                <c:pt idx="177">
                  <c:v>0.18275903399174509</c:v>
                </c:pt>
                <c:pt idx="178">
                  <c:v>0.2172226849221518</c:v>
                </c:pt>
                <c:pt idx="179">
                  <c:v>0.25176800544108691</c:v>
                </c:pt>
                <c:pt idx="180">
                  <c:v>0.2863797413074991</c:v>
                </c:pt>
                <c:pt idx="181">
                  <c:v>0.32104260895318959</c:v>
                </c:pt>
                <c:pt idx="182">
                  <c:v>0.35574130223160572</c:v>
                </c:pt>
                <c:pt idx="183">
                  <c:v>0.39046049917660375</c:v>
                </c:pt>
                <c:pt idx="184">
                  <c:v>0.42518486876819805</c:v>
                </c:pt>
                <c:pt idx="185">
                  <c:v>0.45989907770230798</c:v>
                </c:pt>
                <c:pt idx="186">
                  <c:v>0.49458779716151335</c:v>
                </c:pt>
                <c:pt idx="187">
                  <c:v>0.52923570958382771</c:v>
                </c:pt>
                <c:pt idx="188">
                  <c:v>0.56382751542650422</c:v>
                </c:pt>
                <c:pt idx="189">
                  <c:v>0.59834793992188184</c:v>
                </c:pt>
                <c:pt idx="190">
                  <c:v>0.63278173982229302</c:v>
                </c:pt>
                <c:pt idx="191">
                  <c:v>0.66711371013105203</c:v>
                </c:pt>
                <c:pt idx="192">
                  <c:v>0.70132869081655647</c:v>
                </c:pt>
                <c:pt idx="193">
                  <c:v>0.73541157350652575</c:v>
                </c:pt>
                <c:pt idx="194">
                  <c:v>0.7693473081594363</c:v>
                </c:pt>
                <c:pt idx="195">
                  <c:v>0.80312090971019545</c:v>
                </c:pt>
                <c:pt idx="196">
                  <c:v>0.83671746468712405</c:v>
                </c:pt>
                <c:pt idx="197">
                  <c:v>0.87012213779732595</c:v>
                </c:pt>
                <c:pt idx="198">
                  <c:v>0.90332017847753521</c:v>
                </c:pt>
                <c:pt idx="199">
                  <c:v>0.93629692740755111</c:v>
                </c:pt>
                <c:pt idx="200">
                  <c:v>0.96903782298337893</c:v>
                </c:pt>
                <c:pt idx="201">
                  <c:v>1.0015284077472266</c:v>
                </c:pt>
                <c:pt idx="202">
                  <c:v>1.0337543347715097</c:v>
                </c:pt>
                <c:pt idx="203">
                  <c:v>1.0657013739940511</c:v>
                </c:pt>
                <c:pt idx="204">
                  <c:v>1.0973554185016756</c:v>
                </c:pt>
                <c:pt idx="205">
                  <c:v>1.1287024907594267</c:v>
                </c:pt>
                <c:pt idx="206">
                  <c:v>1.1597287487826518</c:v>
                </c:pt>
                <c:pt idx="207">
                  <c:v>1.1904204922492319</c:v>
                </c:pt>
                <c:pt idx="208">
                  <c:v>1.2207641685492607</c:v>
                </c:pt>
                <c:pt idx="209">
                  <c:v>1.250746378769493</c:v>
                </c:pt>
                <c:pt idx="210">
                  <c:v>1.2803538836099297</c:v>
                </c:pt>
                <c:pt idx="211">
                  <c:v>1.3095736092299182</c:v>
                </c:pt>
                <c:pt idx="212">
                  <c:v>1.3383926530211934</c:v>
                </c:pt>
                <c:pt idx="213">
                  <c:v>1.3667982893053066</c:v>
                </c:pt>
                <c:pt idx="214">
                  <c:v>1.3947779749529248</c:v>
                </c:pt>
                <c:pt idx="215">
                  <c:v>1.4223193549225284</c:v>
                </c:pt>
                <c:pt idx="216">
                  <c:v>1.4494102677160432</c:v>
                </c:pt>
                <c:pt idx="217">
                  <c:v>1.4760387507490205</c:v>
                </c:pt>
                <c:pt idx="218">
                  <c:v>1.5021930456329746</c:v>
                </c:pt>
                <c:pt idx="219">
                  <c:v>1.5278616033675587</c:v>
                </c:pt>
                <c:pt idx="220">
                  <c:v>1.5530330894402762</c:v>
                </c:pt>
                <c:pt idx="221">
                  <c:v>1.5776963888314837</c:v>
                </c:pt>
                <c:pt idx="222">
                  <c:v>1.6018406109224708</c:v>
                </c:pt>
                <c:pt idx="223">
                  <c:v>1.6254550943044488</c:v>
                </c:pt>
                <c:pt idx="224">
                  <c:v>1.6485294114863318</c:v>
                </c:pt>
                <c:pt idx="225">
                  <c:v>1.6710533734992206</c:v>
                </c:pt>
                <c:pt idx="226">
                  <c:v>1.6930170343955655</c:v>
                </c:pt>
                <c:pt idx="227">
                  <c:v>1.7144106956410174</c:v>
                </c:pt>
                <c:pt idx="228">
                  <c:v>1.7352249103970261</c:v>
                </c:pt>
                <c:pt idx="229">
                  <c:v>1.7554504876922994</c:v>
                </c:pt>
                <c:pt idx="230">
                  <c:v>1.7750784964812771</c:v>
                </c:pt>
                <c:pt idx="231">
                  <c:v>1.7941002695878292</c:v>
                </c:pt>
                <c:pt idx="232">
                  <c:v>1.8125074075324361</c:v>
                </c:pt>
                <c:pt idx="233">
                  <c:v>1.830291782241164</c:v>
                </c:pt>
                <c:pt idx="234">
                  <c:v>1.8474455406347918</c:v>
                </c:pt>
                <c:pt idx="235">
                  <c:v>1.8639611080965111</c:v>
                </c:pt>
                <c:pt idx="236">
                  <c:v>1.8798311918166628</c:v>
                </c:pt>
                <c:pt idx="237">
                  <c:v>1.8950487840130372</c:v>
                </c:pt>
                <c:pt idx="238">
                  <c:v>1.9096071650253132</c:v>
                </c:pt>
                <c:pt idx="239">
                  <c:v>1.9234999062822711</c:v>
                </c:pt>
                <c:pt idx="240">
                  <c:v>1.9367208731404679</c:v>
                </c:pt>
                <c:pt idx="241">
                  <c:v>1.9492642275931253</c:v>
                </c:pt>
                <c:pt idx="242">
                  <c:v>1.9611244308480256</c:v>
                </c:pt>
                <c:pt idx="243">
                  <c:v>1.9722962457732909</c:v>
                </c:pt>
                <c:pt idx="244">
                  <c:v>1.9827747392099493</c:v>
                </c:pt>
                <c:pt idx="245">
                  <c:v>1.9925552841502807</c:v>
                </c:pt>
                <c:pt idx="246">
                  <c:v>2.0016335617809733</c:v>
                </c:pt>
                <c:pt idx="247">
                  <c:v>2.0100055633901888</c:v>
                </c:pt>
                <c:pt idx="248">
                  <c:v>2.0176675921376983</c:v>
                </c:pt>
                <c:pt idx="249">
                  <c:v>2.0246162646873023</c:v>
                </c:pt>
                <c:pt idx="250">
                  <c:v>2.0308485127008153</c:v>
                </c:pt>
                <c:pt idx="251">
                  <c:v>2.0363615841929597</c:v>
                </c:pt>
                <c:pt idx="252">
                  <c:v>2.0411530447465638</c:v>
                </c:pt>
                <c:pt idx="253">
                  <c:v>2.0452207785875327</c:v>
                </c:pt>
                <c:pt idx="254">
                  <c:v>2.0485629895191133</c:v>
                </c:pt>
                <c:pt idx="255">
                  <c:v>2.0511782017150448</c:v>
                </c:pt>
                <c:pt idx="256">
                  <c:v>2.0530652603712434</c:v>
                </c:pt>
                <c:pt idx="257">
                  <c:v>2.0542233322157295</c:v>
                </c:pt>
                <c:pt idx="258">
                  <c:v>2.0546519058765766</c:v>
                </c:pt>
                <c:pt idx="259">
                  <c:v>2.054350792107722</c:v>
                </c:pt>
                <c:pt idx="260">
                  <c:v>2.0533201238725289</c:v>
                </c:pt>
                <c:pt idx="261">
                  <c:v>2.0515603562850755</c:v>
                </c:pt>
                <c:pt idx="262">
                  <c:v>2.0490722664091887</c:v>
                </c:pt>
                <c:pt idx="263">
                  <c:v>2.0458569529153157</c:v>
                </c:pt>
                <c:pt idx="264">
                  <c:v>2.0419158355953799</c:v>
                </c:pt>
                <c:pt idx="265">
                  <c:v>2.0372506547358435</c:v>
                </c:pt>
                <c:pt idx="266">
                  <c:v>2.0318634703492431</c:v>
                </c:pt>
                <c:pt idx="267">
                  <c:v>2.0257566612645492</c:v>
                </c:pt>
                <c:pt idx="268">
                  <c:v>2.0189329240767391</c:v>
                </c:pt>
                <c:pt idx="269">
                  <c:v>2.0113952719560602</c:v>
                </c:pt>
                <c:pt idx="270">
                  <c:v>2.0031470333174939</c:v>
                </c:pt>
                <c:pt idx="271">
                  <c:v>1.9941918503510265</c:v>
                </c:pt>
                <c:pt idx="272">
                  <c:v>1.9845336774133564</c:v>
                </c:pt>
                <c:pt idx="273">
                  <c:v>1.9741767792817657</c:v>
                </c:pt>
                <c:pt idx="274">
                  <c:v>1.9631257292709092</c:v>
                </c:pt>
                <c:pt idx="275">
                  <c:v>1.9513854072133732</c:v>
                </c:pt>
                <c:pt idx="276">
                  <c:v>1.938960997304874</c:v>
                </c:pt>
                <c:pt idx="277">
                  <c:v>1.9258579858150657</c:v>
                </c:pt>
                <c:pt idx="278">
                  <c:v>1.9120821586649579</c:v>
                </c:pt>
                <c:pt idx="279">
                  <c:v>1.8976395988720141</c:v>
                </c:pt>
                <c:pt idx="280">
                  <c:v>1.8825366838640649</c:v>
                </c:pt>
                <c:pt idx="281">
                  <c:v>1.8667800826632128</c:v>
                </c:pt>
                <c:pt idx="282">
                  <c:v>1.8503767529409823</c:v>
                </c:pt>
                <c:pt idx="283">
                  <c:v>1.8333339379460054</c:v>
                </c:pt>
                <c:pt idx="284">
                  <c:v>1.8156591633056096</c:v>
                </c:pt>
                <c:pt idx="285">
                  <c:v>1.7973602337027104</c:v>
                </c:pt>
                <c:pt idx="286">
                  <c:v>1.7784452294294852</c:v>
                </c:pt>
                <c:pt idx="287">
                  <c:v>1.7589225028193418</c:v>
                </c:pt>
                <c:pt idx="288">
                  <c:v>1.7388006745587639</c:v>
                </c:pt>
                <c:pt idx="289">
                  <c:v>1.7180886298806584</c:v>
                </c:pt>
                <c:pt idx="290">
                  <c:v>1.6967955146408877</c:v>
                </c:pt>
                <c:pt idx="291">
                  <c:v>1.6749307312797159</c:v>
                </c:pt>
                <c:pt idx="292">
                  <c:v>1.6525039346699568</c:v>
                </c:pt>
                <c:pt idx="293">
                  <c:v>1.6295250278536528</c:v>
                </c:pt>
                <c:pt idx="294">
                  <c:v>1.6060041576691719</c:v>
                </c:pt>
                <c:pt idx="295">
                  <c:v>1.5819517102706473</c:v>
                </c:pt>
                <c:pt idx="296">
                  <c:v>1.5573783065417468</c:v>
                </c:pt>
                <c:pt idx="297">
                  <c:v>1.532294797405787</c:v>
                </c:pt>
                <c:pt idx="298">
                  <c:v>1.5067122590342734</c:v>
                </c:pt>
                <c:pt idx="299">
                  <c:v>1.480641987955973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4044272"/>
        <c:axId val="484041920"/>
      </c:scatterChart>
      <c:valAx>
        <c:axId val="484044272"/>
        <c:scaling>
          <c:orientation val="minMax"/>
          <c:max val="15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484041920"/>
        <c:crosses val="autoZero"/>
        <c:crossBetween val="midCat"/>
      </c:valAx>
      <c:valAx>
        <c:axId val="484041920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484044272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980012113870381"/>
          <c:y val="0.10679611650485436"/>
          <c:w val="0.6542383403997577"/>
          <c:h val="0.7039966363427872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003CE6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003CE6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BL$1:$BL$15</c:f>
              <c:numCache>
                <c:formatCode>General</c:formatCode>
                <c:ptCount val="15"/>
                <c:pt idx="0">
                  <c:v>1248.77</c:v>
                </c:pt>
                <c:pt idx="1">
                  <c:v>2456.31</c:v>
                </c:pt>
                <c:pt idx="2">
                  <c:v>1500</c:v>
                </c:pt>
                <c:pt idx="3">
                  <c:v>2422.6</c:v>
                </c:pt>
                <c:pt idx="4">
                  <c:v>2067.77</c:v>
                </c:pt>
                <c:pt idx="5">
                  <c:v>1348.43</c:v>
                </c:pt>
                <c:pt idx="6">
                  <c:v>1409.69</c:v>
                </c:pt>
                <c:pt idx="7">
                  <c:v>2011.43</c:v>
                </c:pt>
                <c:pt idx="8">
                  <c:v>1302.08</c:v>
                </c:pt>
                <c:pt idx="9">
                  <c:v>1328.58</c:v>
                </c:pt>
                <c:pt idx="10">
                  <c:v>1299.6099999999999</c:v>
                </c:pt>
                <c:pt idx="11">
                  <c:v>1766.94</c:v>
                </c:pt>
                <c:pt idx="12">
                  <c:v>1844.76</c:v>
                </c:pt>
                <c:pt idx="13">
                  <c:v>1863.16</c:v>
                </c:pt>
                <c:pt idx="14">
                  <c:v>2044.99</c:v>
                </c:pt>
              </c:numCache>
            </c:numRef>
          </c:xVal>
          <c:yVal>
            <c:numRef>
              <c:f>'Covariance   Correlation3_HID4'!$BM$1:$BM$15</c:f>
              <c:numCache>
                <c:formatCode>General</c:formatCode>
                <c:ptCount val="15"/>
                <c:pt idx="0">
                  <c:v>9.1300000000000006E-2</c:v>
                </c:pt>
                <c:pt idx="1">
                  <c:v>0.44719999999999999</c:v>
                </c:pt>
                <c:pt idx="2">
                  <c:v>0.40560000000000002</c:v>
                </c:pt>
                <c:pt idx="3">
                  <c:v>0.29530000000000001</c:v>
                </c:pt>
                <c:pt idx="4">
                  <c:v>0.10879999999999999</c:v>
                </c:pt>
                <c:pt idx="5">
                  <c:v>1.6014999999999999</c:v>
                </c:pt>
                <c:pt idx="6">
                  <c:v>1.0639000000000001</c:v>
                </c:pt>
                <c:pt idx="7">
                  <c:v>1.5142</c:v>
                </c:pt>
                <c:pt idx="8">
                  <c:v>1.4415</c:v>
                </c:pt>
                <c:pt idx="9">
                  <c:v>1.0116000000000001</c:v>
                </c:pt>
                <c:pt idx="10">
                  <c:v>0.59709999999999996</c:v>
                </c:pt>
                <c:pt idx="11">
                  <c:v>0.1628</c:v>
                </c:pt>
                <c:pt idx="12">
                  <c:v>0.2384</c:v>
                </c:pt>
                <c:pt idx="13">
                  <c:v>2.1299999999999999E-2</c:v>
                </c:pt>
                <c:pt idx="14">
                  <c:v>0.614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40</c:f>
              <c:numCache>
                <c:formatCode>General</c:formatCode>
                <c:ptCount val="300"/>
                <c:pt idx="0">
                  <c:v>502.20097903698002</c:v>
                </c:pt>
                <c:pt idx="1">
                  <c:v>502.47154637796257</c:v>
                </c:pt>
                <c:pt idx="2">
                  <c:v>503.28312892598888</c:v>
                </c:pt>
                <c:pt idx="3">
                  <c:v>504.63536830905309</c:v>
                </c:pt>
                <c:pt idx="4">
                  <c:v>506.52766741631035</c:v>
                </c:pt>
                <c:pt idx="5">
                  <c:v>508.95919066174542</c:v>
                </c:pt>
                <c:pt idx="6">
                  <c:v>511.92886435314335</c:v>
                </c:pt>
                <c:pt idx="7">
                  <c:v>515.43537716620153</c:v>
                </c:pt>
                <c:pt idx="8">
                  <c:v>519.47718072357452</c:v>
                </c:pt>
                <c:pt idx="9">
                  <c:v>524.05249027859236</c:v>
                </c:pt>
                <c:pt idx="10">
                  <c:v>529.15928550335593</c:v>
                </c:pt>
                <c:pt idx="11">
                  <c:v>534.79531138085622</c:v>
                </c:pt>
                <c:pt idx="12">
                  <c:v>540.95807920072616</c:v>
                </c:pt>
                <c:pt idx="13">
                  <c:v>547.64486765818583</c:v>
                </c:pt>
                <c:pt idx="14">
                  <c:v>554.85272405569276</c:v>
                </c:pt>
                <c:pt idx="15">
                  <c:v>562.57846560677126</c:v>
                </c:pt>
                <c:pt idx="16">
                  <c:v>570.81868084144139</c:v>
                </c:pt>
                <c:pt idx="17">
                  <c:v>579.56973111262641</c:v>
                </c:pt>
                <c:pt idx="18">
                  <c:v>588.82775220287908</c:v>
                </c:pt>
                <c:pt idx="19">
                  <c:v>598.5886560307099</c:v>
                </c:pt>
                <c:pt idx="20">
                  <c:v>608.84813245576902</c:v>
                </c:pt>
                <c:pt idx="21">
                  <c:v>619.60165118208306</c:v>
                </c:pt>
                <c:pt idx="22">
                  <c:v>630.84446375850666</c:v>
                </c:pt>
                <c:pt idx="23">
                  <c:v>642.57160567550363</c:v>
                </c:pt>
                <c:pt idx="24">
                  <c:v>654.77789855733658</c:v>
                </c:pt>
                <c:pt idx="25">
                  <c:v>667.45795244868987</c:v>
                </c:pt>
                <c:pt idx="26">
                  <c:v>680.6061681947233</c:v>
                </c:pt>
                <c:pt idx="27">
                  <c:v>694.21673991350031</c:v>
                </c:pt>
                <c:pt idx="28">
                  <c:v>708.28365755970367</c:v>
                </c:pt>
                <c:pt idx="29">
                  <c:v>722.80070957850035</c:v>
                </c:pt>
                <c:pt idx="30">
                  <c:v>737.7614856483907</c:v>
                </c:pt>
                <c:pt idx="31">
                  <c:v>753.15937951182548</c:v>
                </c:pt>
                <c:pt idx="32">
                  <c:v>768.98759189234249</c:v>
                </c:pt>
                <c:pt idx="33">
                  <c:v>785.23913349693726</c:v>
                </c:pt>
                <c:pt idx="34">
                  <c:v>801.90682810233625</c:v>
                </c:pt>
                <c:pt idx="35">
                  <c:v>818.98331572381733</c:v>
                </c:pt>
                <c:pt idx="36">
                  <c:v>836.46105586516899</c:v>
                </c:pt>
                <c:pt idx="37">
                  <c:v>854.33233084836354</c:v>
                </c:pt>
                <c:pt idx="38">
                  <c:v>872.58924922146537</c:v>
                </c:pt>
                <c:pt idx="39">
                  <c:v>891.2237492432738</c:v>
                </c:pt>
                <c:pt idx="40">
                  <c:v>910.22760244316203</c:v>
                </c:pt>
                <c:pt idx="41">
                  <c:v>929.59241725453728</c:v>
                </c:pt>
                <c:pt idx="42">
                  <c:v>949.30964272032054</c:v>
                </c:pt>
                <c:pt idx="43">
                  <c:v>969.37057226880893</c:v>
                </c:pt>
                <c:pt idx="44">
                  <c:v>989.76634755825171</c:v>
                </c:pt>
                <c:pt idx="45">
                  <c:v>1010.4879623884457</c:v>
                </c:pt>
                <c:pt idx="46">
                  <c:v>1031.5262666776193</c:v>
                </c:pt>
                <c:pt idx="47">
                  <c:v>1052.8719705028507</c:v>
                </c:pt>
                <c:pt idx="48">
                  <c:v>1074.5156482022367</c:v>
                </c:pt>
                <c:pt idx="49">
                  <c:v>1096.4477425369996</c:v>
                </c:pt>
                <c:pt idx="50">
                  <c:v>1118.6585689116953</c:v>
                </c:pt>
                <c:pt idx="51">
                  <c:v>1141.1383196506565</c:v>
                </c:pt>
                <c:pt idx="52">
                  <c:v>1163.877068328788</c:v>
                </c:pt>
                <c:pt idx="53">
                  <c:v>1186.8647741547952</c:v>
                </c:pt>
                <c:pt idx="54">
                  <c:v>1210.0912864049151</c:v>
                </c:pt>
                <c:pt idx="55">
                  <c:v>1233.5463489051924</c:v>
                </c:pt>
                <c:pt idx="56">
                  <c:v>1257.2196045603134</c:v>
                </c:pt>
                <c:pt idx="57">
                  <c:v>1281.1005999270099</c:v>
                </c:pt>
                <c:pt idx="58">
                  <c:v>1305.1787898300056</c:v>
                </c:pt>
                <c:pt idx="59">
                  <c:v>1329.4435420184677</c:v>
                </c:pt>
                <c:pt idx="60">
                  <c:v>1353.8841418609111</c:v>
                </c:pt>
                <c:pt idx="61">
                  <c:v>1378.4897970764755</c:v>
                </c:pt>
                <c:pt idx="62">
                  <c:v>1403.2496425004961</c:v>
                </c:pt>
                <c:pt idx="63">
                  <c:v>1428.152744882251</c:v>
                </c:pt>
                <c:pt idx="64">
                  <c:v>1453.1881077127798</c:v>
                </c:pt>
                <c:pt idx="65">
                  <c:v>1478.3446760806305</c:v>
                </c:pt>
                <c:pt idx="66">
                  <c:v>1503.6113415533985</c:v>
                </c:pt>
                <c:pt idx="67">
                  <c:v>1528.9769470828962</c:v>
                </c:pt>
                <c:pt idx="68">
                  <c:v>1554.4302919317929</c:v>
                </c:pt>
                <c:pt idx="69">
                  <c:v>1579.9601366195445</c:v>
                </c:pt>
                <c:pt idx="70">
                  <c:v>1605.5552078854312</c:v>
                </c:pt>
                <c:pt idx="71">
                  <c:v>1631.2042036665127</c:v>
                </c:pt>
                <c:pt idx="72">
                  <c:v>1656.8957980883006</c:v>
                </c:pt>
                <c:pt idx="73">
                  <c:v>1682.6186464659461</c:v>
                </c:pt>
                <c:pt idx="74">
                  <c:v>1708.3613903137336</c:v>
                </c:pt>
                <c:pt idx="75">
                  <c:v>1734.1126623606674</c:v>
                </c:pt>
                <c:pt idx="76">
                  <c:v>1759.8610915699401</c:v>
                </c:pt>
                <c:pt idx="77">
                  <c:v>1785.5953081600603</c:v>
                </c:pt>
                <c:pt idx="78">
                  <c:v>1811.3039486254295</c:v>
                </c:pt>
                <c:pt idx="79">
                  <c:v>1836.9756607541462</c:v>
                </c:pt>
                <c:pt idx="80">
                  <c:v>1862.5991086408224</c:v>
                </c:pt>
                <c:pt idx="81">
                  <c:v>1888.1629776922009</c:v>
                </c:pt>
                <c:pt idx="82">
                  <c:v>1913.6559796233605</c:v>
                </c:pt>
                <c:pt idx="83">
                  <c:v>1939.0668574423064</c:v>
                </c:pt>
                <c:pt idx="84">
                  <c:v>1964.384390420739</c:v>
                </c:pt>
                <c:pt idx="85">
                  <c:v>1989.5973990488123</c:v>
                </c:pt>
                <c:pt idx="86">
                  <c:v>2014.6947499716916</c:v>
                </c:pt>
                <c:pt idx="87">
                  <c:v>2039.6653609057287</c:v>
                </c:pt>
                <c:pt idx="88">
                  <c:v>2064.4982055320861</c:v>
                </c:pt>
                <c:pt idx="89">
                  <c:v>2089.1823183656497</c:v>
                </c:pt>
                <c:pt idx="90">
                  <c:v>2113.7067995970797</c:v>
                </c:pt>
                <c:pt idx="91">
                  <c:v>2138.0608199058552</c:v>
                </c:pt>
                <c:pt idx="92">
                  <c:v>2162.2336252422024</c:v>
                </c:pt>
                <c:pt idx="93">
                  <c:v>2186.2145415757764</c:v>
                </c:pt>
                <c:pt idx="94">
                  <c:v>2209.992979609015</c:v>
                </c:pt>
                <c:pt idx="95">
                  <c:v>2233.5584394530729</c:v>
                </c:pt>
                <c:pt idx="96">
                  <c:v>2256.9005152642776</c:v>
                </c:pt>
                <c:pt idx="97">
                  <c:v>2280.0088998390574</c:v>
                </c:pt>
                <c:pt idx="98">
                  <c:v>2302.8733891653114</c:v>
                </c:pt>
                <c:pt idx="99">
                  <c:v>2325.4838869282153</c:v>
                </c:pt>
                <c:pt idx="100">
                  <c:v>2347.830408968468</c:v>
                </c:pt>
                <c:pt idx="101">
                  <c:v>2369.9030876910174</c:v>
                </c:pt>
                <c:pt idx="102">
                  <c:v>2391.6921764223098</c:v>
                </c:pt>
                <c:pt idx="103">
                  <c:v>2413.1880537141501</c:v>
                </c:pt>
                <c:pt idx="104">
                  <c:v>2434.3812275922601</c:v>
                </c:pt>
                <c:pt idx="105">
                  <c:v>2455.2623397476664</c:v>
                </c:pt>
                <c:pt idx="106">
                  <c:v>2475.8221696690698</c:v>
                </c:pt>
                <c:pt idx="107">
                  <c:v>2496.0516387143584</c:v>
                </c:pt>
                <c:pt idx="108">
                  <c:v>2515.9418141194856</c:v>
                </c:pt>
                <c:pt idx="109">
                  <c:v>2535.4839129429238</c:v>
                </c:pt>
                <c:pt idx="110">
                  <c:v>2554.6693059439649</c:v>
                </c:pt>
                <c:pt idx="111">
                  <c:v>2573.4895213931504</c:v>
                </c:pt>
                <c:pt idx="112">
                  <c:v>2591.9362488131492</c:v>
                </c:pt>
                <c:pt idx="113">
                  <c:v>2610.0013426484279</c:v>
                </c:pt>
                <c:pt idx="114">
                  <c:v>2627.6768258621032</c:v>
                </c:pt>
                <c:pt idx="115">
                  <c:v>2644.9548934583727</c:v>
                </c:pt>
                <c:pt idx="116">
                  <c:v>2661.8279159289832</c:v>
                </c:pt>
                <c:pt idx="117">
                  <c:v>2678.2884426222067</c:v>
                </c:pt>
                <c:pt idx="118">
                  <c:v>2694.3292050328387</c:v>
                </c:pt>
                <c:pt idx="119">
                  <c:v>2709.9431200117633</c:v>
                </c:pt>
                <c:pt idx="120">
                  <c:v>2725.123292893677</c:v>
                </c:pt>
                <c:pt idx="121">
                  <c:v>2739.8630205415734</c:v>
                </c:pt>
                <c:pt idx="122">
                  <c:v>2754.1557943066641</c:v>
                </c:pt>
                <c:pt idx="123">
                  <c:v>2767.9953029024118</c:v>
                </c:pt>
                <c:pt idx="124">
                  <c:v>2781.3754351914195</c:v>
                </c:pt>
                <c:pt idx="125">
                  <c:v>2794.2902828839342</c:v>
                </c:pt>
                <c:pt idx="126">
                  <c:v>2806.7341431467821</c:v>
                </c:pt>
                <c:pt idx="127">
                  <c:v>2818.7015211215803</c:v>
                </c:pt>
                <c:pt idx="128">
                  <c:v>2830.1871323511109</c:v>
                </c:pt>
                <c:pt idx="129">
                  <c:v>2841.1859051127881</c:v>
                </c:pt>
                <c:pt idx="130">
                  <c:v>2851.6929826581882</c:v>
                </c:pt>
                <c:pt idx="131">
                  <c:v>2861.7037253576536</c:v>
                </c:pt>
                <c:pt idx="132">
                  <c:v>2871.2137127490223</c:v>
                </c:pt>
                <c:pt idx="133">
                  <c:v>2880.2187454895784</c:v>
                </c:pt>
                <c:pt idx="134">
                  <c:v>2888.7148472103672</c:v>
                </c:pt>
                <c:pt idx="135">
                  <c:v>2896.6982662720425</c:v>
                </c:pt>
                <c:pt idx="136">
                  <c:v>2904.1654774214894</c:v>
                </c:pt>
                <c:pt idx="137">
                  <c:v>2911.113183348476</c:v>
                </c:pt>
                <c:pt idx="138">
                  <c:v>2917.5383161416494</c:v>
                </c:pt>
                <c:pt idx="139">
                  <c:v>2923.4380386432431</c:v>
                </c:pt>
                <c:pt idx="140">
                  <c:v>2928.8097457018857</c:v>
                </c:pt>
                <c:pt idx="141">
                  <c:v>2933.6510653229579</c:v>
                </c:pt>
                <c:pt idx="142">
                  <c:v>2937.9598597160057</c:v>
                </c:pt>
                <c:pt idx="143">
                  <c:v>2941.7342262387215</c:v>
                </c:pt>
                <c:pt idx="144">
                  <c:v>2944.9724982371017</c:v>
                </c:pt>
                <c:pt idx="145">
                  <c:v>2947.6732457813932</c:v>
                </c:pt>
                <c:pt idx="146">
                  <c:v>2949.8352762975092</c:v>
                </c:pt>
                <c:pt idx="147">
                  <c:v>2951.4576350936377</c:v>
                </c:pt>
                <c:pt idx="148">
                  <c:v>2952.5396057818057</c:v>
                </c:pt>
                <c:pt idx="149">
                  <c:v>2953.0807105942158</c:v>
                </c:pt>
                <c:pt idx="150">
                  <c:v>2953.0807105942158</c:v>
                </c:pt>
                <c:pt idx="151">
                  <c:v>2952.5396057818052</c:v>
                </c:pt>
                <c:pt idx="152">
                  <c:v>2951.4576350936368</c:v>
                </c:pt>
                <c:pt idx="153">
                  <c:v>2949.8352762975078</c:v>
                </c:pt>
                <c:pt idx="154">
                  <c:v>2947.6732457813914</c:v>
                </c:pt>
                <c:pt idx="155">
                  <c:v>2944.9724982370999</c:v>
                </c:pt>
                <c:pt idx="156">
                  <c:v>2941.7342262387192</c:v>
                </c:pt>
                <c:pt idx="157">
                  <c:v>2937.9598597160029</c:v>
                </c:pt>
                <c:pt idx="158">
                  <c:v>2933.6510653229552</c:v>
                </c:pt>
                <c:pt idx="159">
                  <c:v>2928.8097457018821</c:v>
                </c:pt>
                <c:pt idx="160">
                  <c:v>2923.4380386432395</c:v>
                </c:pt>
                <c:pt idx="161">
                  <c:v>2917.5383161416448</c:v>
                </c:pt>
                <c:pt idx="162">
                  <c:v>2911.113183348471</c:v>
                </c:pt>
                <c:pt idx="163">
                  <c:v>2904.1654774214849</c:v>
                </c:pt>
                <c:pt idx="164">
                  <c:v>2896.698266272037</c:v>
                </c:pt>
                <c:pt idx="165">
                  <c:v>2888.7148472103613</c:v>
                </c:pt>
                <c:pt idx="166">
                  <c:v>2880.2187454895725</c:v>
                </c:pt>
                <c:pt idx="167">
                  <c:v>2871.2137127490155</c:v>
                </c:pt>
                <c:pt idx="168">
                  <c:v>2861.7037253576464</c:v>
                </c:pt>
                <c:pt idx="169">
                  <c:v>2851.6929826581809</c:v>
                </c:pt>
                <c:pt idx="170">
                  <c:v>2841.1859051127803</c:v>
                </c:pt>
                <c:pt idx="171">
                  <c:v>2830.1871323511032</c:v>
                </c:pt>
                <c:pt idx="172">
                  <c:v>2818.7015211215721</c:v>
                </c:pt>
                <c:pt idx="173">
                  <c:v>2806.734143146773</c:v>
                </c:pt>
                <c:pt idx="174">
                  <c:v>2794.2902828839251</c:v>
                </c:pt>
                <c:pt idx="175">
                  <c:v>2781.3754351914104</c:v>
                </c:pt>
                <c:pt idx="176">
                  <c:v>2767.9953029024027</c:v>
                </c:pt>
                <c:pt idx="177">
                  <c:v>2754.1557943066546</c:v>
                </c:pt>
                <c:pt idx="178">
                  <c:v>2739.8630205415639</c:v>
                </c:pt>
                <c:pt idx="179">
                  <c:v>2725.1232928936665</c:v>
                </c:pt>
                <c:pt idx="180">
                  <c:v>2709.9431200117529</c:v>
                </c:pt>
                <c:pt idx="181">
                  <c:v>2694.3292050328273</c:v>
                </c:pt>
                <c:pt idx="182">
                  <c:v>2678.2884426221954</c:v>
                </c:pt>
                <c:pt idx="183">
                  <c:v>2661.8279159289714</c:v>
                </c:pt>
                <c:pt idx="184">
                  <c:v>2644.9548934583609</c:v>
                </c:pt>
                <c:pt idx="185">
                  <c:v>2627.6768258620909</c:v>
                </c:pt>
                <c:pt idx="186">
                  <c:v>2610.0013426484156</c:v>
                </c:pt>
                <c:pt idx="187">
                  <c:v>2591.9362488131364</c:v>
                </c:pt>
                <c:pt idx="188">
                  <c:v>2573.4895213931377</c:v>
                </c:pt>
                <c:pt idx="189">
                  <c:v>2554.6693059439517</c:v>
                </c:pt>
                <c:pt idx="190">
                  <c:v>2535.4839129429106</c:v>
                </c:pt>
                <c:pt idx="191">
                  <c:v>2515.9418141194724</c:v>
                </c:pt>
                <c:pt idx="192">
                  <c:v>2496.0516387143448</c:v>
                </c:pt>
                <c:pt idx="193">
                  <c:v>2475.8221696690553</c:v>
                </c:pt>
                <c:pt idx="194">
                  <c:v>2455.2623397476523</c:v>
                </c:pt>
                <c:pt idx="195">
                  <c:v>2434.3812275922451</c:v>
                </c:pt>
                <c:pt idx="196">
                  <c:v>2413.1880537141351</c:v>
                </c:pt>
                <c:pt idx="197">
                  <c:v>2391.6921764222948</c:v>
                </c:pt>
                <c:pt idx="198">
                  <c:v>2369.9030876910019</c:v>
                </c:pt>
                <c:pt idx="199">
                  <c:v>2347.8304089684525</c:v>
                </c:pt>
                <c:pt idx="200">
                  <c:v>2325.4838869281998</c:v>
                </c:pt>
                <c:pt idx="201">
                  <c:v>2302.8733891652955</c:v>
                </c:pt>
                <c:pt idx="202">
                  <c:v>2280.0088998390411</c:v>
                </c:pt>
                <c:pt idx="203">
                  <c:v>2256.9005152642612</c:v>
                </c:pt>
                <c:pt idx="204">
                  <c:v>2233.5584394530561</c:v>
                </c:pt>
                <c:pt idx="205">
                  <c:v>2209.9929796089982</c:v>
                </c:pt>
                <c:pt idx="206">
                  <c:v>2186.2145415757595</c:v>
                </c:pt>
                <c:pt idx="207">
                  <c:v>2162.2336252421851</c:v>
                </c:pt>
                <c:pt idx="208">
                  <c:v>2138.0608199058383</c:v>
                </c:pt>
                <c:pt idx="209">
                  <c:v>2113.7067995970624</c:v>
                </c:pt>
                <c:pt idx="210">
                  <c:v>2089.1823183656325</c:v>
                </c:pt>
                <c:pt idx="211">
                  <c:v>2064.4982055320684</c:v>
                </c:pt>
                <c:pt idx="212">
                  <c:v>2039.6653609057107</c:v>
                </c:pt>
                <c:pt idx="213">
                  <c:v>2014.6947499716737</c:v>
                </c:pt>
                <c:pt idx="214">
                  <c:v>1989.5973990487953</c:v>
                </c:pt>
                <c:pt idx="215">
                  <c:v>1964.384390420722</c:v>
                </c:pt>
                <c:pt idx="216">
                  <c:v>1939.0668574422893</c:v>
                </c:pt>
                <c:pt idx="217">
                  <c:v>1913.6559796233432</c:v>
                </c:pt>
                <c:pt idx="218">
                  <c:v>1888.1629776921832</c:v>
                </c:pt>
                <c:pt idx="219">
                  <c:v>1862.5991086408048</c:v>
                </c:pt>
                <c:pt idx="220">
                  <c:v>1836.9756607541285</c:v>
                </c:pt>
                <c:pt idx="221">
                  <c:v>1811.3039486254117</c:v>
                </c:pt>
                <c:pt idx="222">
                  <c:v>1785.5953081600426</c:v>
                </c:pt>
                <c:pt idx="223">
                  <c:v>1759.8610915699223</c:v>
                </c:pt>
                <c:pt idx="224">
                  <c:v>1734.1126623606499</c:v>
                </c:pt>
                <c:pt idx="225">
                  <c:v>1708.3613903137157</c:v>
                </c:pt>
                <c:pt idx="226">
                  <c:v>1682.6186464659281</c:v>
                </c:pt>
                <c:pt idx="227">
                  <c:v>1656.8957980882826</c:v>
                </c:pt>
                <c:pt idx="228">
                  <c:v>1631.2042036664948</c:v>
                </c:pt>
                <c:pt idx="229">
                  <c:v>1605.5552078854134</c:v>
                </c:pt>
                <c:pt idx="230">
                  <c:v>1579.9601366195268</c:v>
                </c:pt>
                <c:pt idx="231">
                  <c:v>1554.4302919317752</c:v>
                </c:pt>
                <c:pt idx="232">
                  <c:v>1528.9769470828783</c:v>
                </c:pt>
                <c:pt idx="233">
                  <c:v>1503.6113415533805</c:v>
                </c:pt>
                <c:pt idx="234">
                  <c:v>1478.3446760806128</c:v>
                </c:pt>
                <c:pt idx="235">
                  <c:v>1453.1881077127621</c:v>
                </c:pt>
                <c:pt idx="236">
                  <c:v>1428.1527448822333</c:v>
                </c:pt>
                <c:pt idx="237">
                  <c:v>1403.2496425004783</c:v>
                </c:pt>
                <c:pt idx="238">
                  <c:v>1378.489797076458</c:v>
                </c:pt>
                <c:pt idx="239">
                  <c:v>1353.8841418608936</c:v>
                </c:pt>
                <c:pt idx="240">
                  <c:v>1329.4435420184504</c:v>
                </c:pt>
                <c:pt idx="241">
                  <c:v>1305.1787898299881</c:v>
                </c:pt>
                <c:pt idx="242">
                  <c:v>1281.1005999269937</c:v>
                </c:pt>
                <c:pt idx="243">
                  <c:v>1257.2196045602973</c:v>
                </c:pt>
                <c:pt idx="244">
                  <c:v>1233.5463489051765</c:v>
                </c:pt>
                <c:pt idx="245">
                  <c:v>1210.0912864048994</c:v>
                </c:pt>
                <c:pt idx="246">
                  <c:v>1186.8647741547791</c:v>
                </c:pt>
                <c:pt idx="247">
                  <c:v>1163.8770683287721</c:v>
                </c:pt>
                <c:pt idx="248">
                  <c:v>1141.1383196506408</c:v>
                </c:pt>
                <c:pt idx="249">
                  <c:v>1118.6585689116796</c:v>
                </c:pt>
                <c:pt idx="250">
                  <c:v>1096.4477425369842</c:v>
                </c:pt>
                <c:pt idx="251">
                  <c:v>1074.5156482022214</c:v>
                </c:pt>
                <c:pt idx="252">
                  <c:v>1052.8719705028357</c:v>
                </c:pt>
                <c:pt idx="253">
                  <c:v>1031.5262666776046</c:v>
                </c:pt>
                <c:pt idx="254">
                  <c:v>1010.4879623884311</c:v>
                </c:pt>
                <c:pt idx="255">
                  <c:v>989.76634755823727</c:v>
                </c:pt>
                <c:pt idx="256">
                  <c:v>969.37057226879472</c:v>
                </c:pt>
                <c:pt idx="257">
                  <c:v>949.30964272030667</c:v>
                </c:pt>
                <c:pt idx="258">
                  <c:v>929.59241725452375</c:v>
                </c:pt>
                <c:pt idx="259">
                  <c:v>910.22760244314861</c:v>
                </c:pt>
                <c:pt idx="260">
                  <c:v>891.22374924326061</c:v>
                </c:pt>
                <c:pt idx="261">
                  <c:v>872.58924922145241</c:v>
                </c:pt>
                <c:pt idx="262">
                  <c:v>854.33233084835092</c:v>
                </c:pt>
                <c:pt idx="263">
                  <c:v>836.46105586515671</c:v>
                </c:pt>
                <c:pt idx="264">
                  <c:v>818.98331572380516</c:v>
                </c:pt>
                <c:pt idx="265">
                  <c:v>801.90682810232443</c:v>
                </c:pt>
                <c:pt idx="266">
                  <c:v>785.23913349692543</c:v>
                </c:pt>
                <c:pt idx="267">
                  <c:v>768.9875918923309</c:v>
                </c:pt>
                <c:pt idx="268">
                  <c:v>753.15937951181411</c:v>
                </c:pt>
                <c:pt idx="269">
                  <c:v>737.7614856483799</c:v>
                </c:pt>
                <c:pt idx="270">
                  <c:v>722.80070957848989</c:v>
                </c:pt>
                <c:pt idx="271">
                  <c:v>708.28365755969401</c:v>
                </c:pt>
                <c:pt idx="272">
                  <c:v>694.21673991349098</c:v>
                </c:pt>
                <c:pt idx="273">
                  <c:v>680.6061681947142</c:v>
                </c:pt>
                <c:pt idx="274">
                  <c:v>667.45795244868123</c:v>
                </c:pt>
                <c:pt idx="275">
                  <c:v>654.77789855732817</c:v>
                </c:pt>
                <c:pt idx="276">
                  <c:v>642.57160567549545</c:v>
                </c:pt>
                <c:pt idx="277">
                  <c:v>630.84446375849848</c:v>
                </c:pt>
                <c:pt idx="278">
                  <c:v>619.60165118207533</c:v>
                </c:pt>
                <c:pt idx="279">
                  <c:v>608.84813245576152</c:v>
                </c:pt>
                <c:pt idx="280">
                  <c:v>598.58865603070285</c:v>
                </c:pt>
                <c:pt idx="281">
                  <c:v>588.82775220287249</c:v>
                </c:pt>
                <c:pt idx="282">
                  <c:v>579.56973111262027</c:v>
                </c:pt>
                <c:pt idx="283">
                  <c:v>570.81868084143525</c:v>
                </c:pt>
                <c:pt idx="284">
                  <c:v>562.5784656067658</c:v>
                </c:pt>
                <c:pt idx="285">
                  <c:v>554.85272405568753</c:v>
                </c:pt>
                <c:pt idx="286">
                  <c:v>547.64486765818106</c:v>
                </c:pt>
                <c:pt idx="287">
                  <c:v>540.95807920072161</c:v>
                </c:pt>
                <c:pt idx="288">
                  <c:v>534.79531138085213</c:v>
                </c:pt>
                <c:pt idx="289">
                  <c:v>529.15928550335229</c:v>
                </c:pt>
                <c:pt idx="290">
                  <c:v>524.05249027858895</c:v>
                </c:pt>
                <c:pt idx="291">
                  <c:v>519.47718072357156</c:v>
                </c:pt>
                <c:pt idx="292">
                  <c:v>515.43537716619903</c:v>
                </c:pt>
                <c:pt idx="293">
                  <c:v>511.92886435314108</c:v>
                </c:pt>
                <c:pt idx="294">
                  <c:v>508.95919066174338</c:v>
                </c:pt>
                <c:pt idx="295">
                  <c:v>506.52766741630876</c:v>
                </c:pt>
                <c:pt idx="296">
                  <c:v>504.63536830905196</c:v>
                </c:pt>
                <c:pt idx="297">
                  <c:v>503.28312892598819</c:v>
                </c:pt>
                <c:pt idx="298">
                  <c:v>502.47154637796211</c:v>
                </c:pt>
                <c:pt idx="299">
                  <c:v>502.20097903698002</c:v>
                </c:pt>
              </c:numCache>
            </c:numRef>
          </c:xVal>
          <c:yVal>
            <c:numRef>
              <c:f>'Covariance   Correlation3'!yycir41</c:f>
              <c:numCache>
                <c:formatCode>General</c:formatCode>
                <c:ptCount val="300"/>
                <c:pt idx="0">
                  <c:v>1.2166412785683471</c:v>
                </c:pt>
                <c:pt idx="1">
                  <c:v>1.1845493542476362</c:v>
                </c:pt>
                <c:pt idx="2">
                  <c:v>1.1522174256088773</c:v>
                </c:pt>
                <c:pt idx="3">
                  <c:v>1.1196597695215771</c:v>
                </c:pt>
                <c:pt idx="4">
                  <c:v>1.0868907625301281</c:v>
                </c:pt>
                <c:pt idx="5">
                  <c:v>1.0539248745055323</c:v>
                </c:pt>
                <c:pt idx="6">
                  <c:v>1.0207766622559136</c:v>
                </c:pt>
                <c:pt idx="7">
                  <c:v>0.98746076309864217</c:v>
                </c:pt>
                <c:pt idx="8">
                  <c:v>0.95399188839690374</c:v>
                </c:pt>
                <c:pt idx="9">
                  <c:v>0.92038481706357966</c:v>
                </c:pt>
                <c:pt idx="10">
                  <c:v>0.88665438903529326</c:v>
                </c:pt>
                <c:pt idx="11">
                  <c:v>0.85281549871951157</c:v>
                </c:pt>
                <c:pt idx="12">
                  <c:v>0.81888308841759427</c:v>
                </c:pt>
                <c:pt idx="13">
                  <c:v>0.78487214172669417</c:v>
                </c:pt>
                <c:pt idx="14">
                  <c:v>0.75079767692342325</c:v>
                </c:pt>
                <c:pt idx="15">
                  <c:v>0.71667474033220291</c:v>
                </c:pt>
                <c:pt idx="16">
                  <c:v>0.68251839968123207</c:v>
                </c:pt>
                <c:pt idx="17">
                  <c:v>0.64834373744900209</c:v>
                </c:pt>
                <c:pt idx="18">
                  <c:v>0.61416584420429843</c:v>
                </c:pt>
                <c:pt idx="19">
                  <c:v>0.57999981194263117</c:v>
                </c:pt>
                <c:pt idx="20">
                  <c:v>0.54586072742203406</c:v>
                </c:pt>
                <c:pt idx="21">
                  <c:v>0.51176366550117658</c:v>
                </c:pt>
                <c:pt idx="22">
                  <c:v>0.477723682482732</c:v>
                </c:pt>
                <c:pt idx="23">
                  <c:v>0.44375580946493698</c:v>
                </c:pt>
                <c:pt idx="24">
                  <c:v>0.40987504570428035</c:v>
                </c:pt>
                <c:pt idx="25">
                  <c:v>0.37609635199225694</c:v>
                </c:pt>
                <c:pt idx="26">
                  <c:v>0.34243464404910096</c:v>
                </c:pt>
                <c:pt idx="27">
                  <c:v>0.30890478593742449</c:v>
                </c:pt>
                <c:pt idx="28">
                  <c:v>0.27552158349866523</c:v>
                </c:pt>
                <c:pt idx="29">
                  <c:v>0.24229977781524531</c:v>
                </c:pt>
                <c:pt idx="30">
                  <c:v>0.20925403870132187</c:v>
                </c:pt>
                <c:pt idx="31">
                  <c:v>0.17639895822501228</c:v>
                </c:pt>
                <c:pt idx="32">
                  <c:v>0.14374904426494678</c:v>
                </c:pt>
                <c:pt idx="33">
                  <c:v>0.11131871410399752</c:v>
                </c:pt>
                <c:pt idx="34">
                  <c:v>7.9122288063012802E-2</c:v>
                </c:pt>
                <c:pt idx="35">
                  <c:v>4.7173983177365153E-2</c:v>
                </c:pt>
                <c:pt idx="36">
                  <c:v>1.5487906919110894E-2</c:v>
                </c:pt>
                <c:pt idx="37">
                  <c:v>-1.5921949032473626E-2</c:v>
                </c:pt>
                <c:pt idx="38">
                  <c:v>-4.7041714969223714E-2</c:v>
                </c:pt>
                <c:pt idx="39">
                  <c:v>-7.7857649278558927E-2</c:v>
                </c:pt>
                <c:pt idx="40">
                  <c:v>-0.10835614451139242</c:v>
                </c:pt>
                <c:pt idx="41">
                  <c:v>-0.13852373339079671</c:v>
                </c:pt>
                <c:pt idx="42">
                  <c:v>-0.16834709475877507</c:v>
                </c:pt>
                <c:pt idx="43">
                  <c:v>-0.19781305945850941</c:v>
                </c:pt>
                <c:pt idx="44">
                  <c:v>-0.22690861614948887</c:v>
                </c:pt>
                <c:pt idx="45">
                  <c:v>-0.25562091705295237</c:v>
                </c:pt>
                <c:pt idx="46">
                  <c:v>-0.28393728362510495</c:v>
                </c:pt>
                <c:pt idx="47">
                  <c:v>-0.31184521215560657</c:v>
                </c:pt>
                <c:pt idx="48">
                  <c:v>-0.33933237928885857</c:v>
                </c:pt>
                <c:pt idx="49">
                  <c:v>-0.36638664746565042</c:v>
                </c:pt>
                <c:pt idx="50">
                  <c:v>-0.39299607028276345</c:v>
                </c:pt>
                <c:pt idx="51">
                  <c:v>-0.41914889776816783</c:v>
                </c:pt>
                <c:pt idx="52">
                  <c:v>-0.44483358156947828</c:v>
                </c:pt>
                <c:pt idx="53">
                  <c:v>-0.47003878005338096</c:v>
                </c:pt>
                <c:pt idx="54">
                  <c:v>-0.49475336331378067</c:v>
                </c:pt>
                <c:pt idx="55">
                  <c:v>-0.51896641808645438</c:v>
                </c:pt>
                <c:pt idx="56">
                  <c:v>-0.54266725256803938</c:v>
                </c:pt>
                <c:pt idx="57">
                  <c:v>-0.56584540113723403</c:v>
                </c:pt>
                <c:pt idx="58">
                  <c:v>-0.58849062897612203</c:v>
                </c:pt>
                <c:pt idx="59">
                  <c:v>-0.61059293658957869</c:v>
                </c:pt>
                <c:pt idx="60">
                  <c:v>-0.63214256422076742</c:v>
                </c:pt>
                <c:pt idx="61">
                  <c:v>-0.65312999616077272</c:v>
                </c:pt>
                <c:pt idx="62">
                  <c:v>-0.67354596495047048</c:v>
                </c:pt>
                <c:pt idx="63">
                  <c:v>-0.69338145547277652</c:v>
                </c:pt>
                <c:pt idx="64">
                  <c:v>-0.7126277089334675</c:v>
                </c:pt>
                <c:pt idx="65">
                  <c:v>-0.73127622672881953</c:v>
                </c:pt>
                <c:pt idx="66">
                  <c:v>-0.74931877419835125</c:v>
                </c:pt>
                <c:pt idx="67">
                  <c:v>-0.76674738426101885</c:v>
                </c:pt>
                <c:pt idx="68">
                  <c:v>-0.78355436093325359</c:v>
                </c:pt>
                <c:pt idx="69">
                  <c:v>-0.79973228272729324</c:v>
                </c:pt>
                <c:pt idx="70">
                  <c:v>-0.81527400592829991</c:v>
                </c:pt>
                <c:pt idx="71">
                  <c:v>-0.83017266774882637</c:v>
                </c:pt>
                <c:pt idx="72">
                  <c:v>-0.84442168935922657</c:v>
                </c:pt>
                <c:pt idx="73">
                  <c:v>-0.85801477879268362</c:v>
                </c:pt>
                <c:pt idx="74">
                  <c:v>-0.87094593372356488</c:v>
                </c:pt>
                <c:pt idx="75">
                  <c:v>-0.88320944411787994</c:v>
                </c:pt>
                <c:pt idx="76">
                  <c:v>-0.89479989475467048</c:v>
                </c:pt>
                <c:pt idx="77">
                  <c:v>-0.90571216761721929</c:v>
                </c:pt>
                <c:pt idx="78">
                  <c:v>-0.91594144415302403</c:v>
                </c:pt>
                <c:pt idx="79">
                  <c:v>-0.92548320740153223</c:v>
                </c:pt>
                <c:pt idx="80">
                  <c:v>-0.93433324398870465</c:v>
                </c:pt>
                <c:pt idx="81">
                  <c:v>-0.94248764598752333</c:v>
                </c:pt>
                <c:pt idx="82">
                  <c:v>-0.94994281264362102</c:v>
                </c:pt>
                <c:pt idx="83">
                  <c:v>-0.95669545196527428</c:v>
                </c:pt>
                <c:pt idx="84">
                  <c:v>-0.96274258217705344</c:v>
                </c:pt>
                <c:pt idx="85">
                  <c:v>-0.96808153303648992</c:v>
                </c:pt>
                <c:pt idx="86">
                  <c:v>-0.97270994701318236</c:v>
                </c:pt>
                <c:pt idx="87">
                  <c:v>-0.97662578032981373</c:v>
                </c:pt>
                <c:pt idx="88">
                  <c:v>-0.97982730386462624</c:v>
                </c:pt>
                <c:pt idx="89">
                  <c:v>-0.98231310391495386</c:v>
                </c:pt>
                <c:pt idx="90">
                  <c:v>-0.98408208282147258</c:v>
                </c:pt>
                <c:pt idx="91">
                  <c:v>-0.98513345945289577</c:v>
                </c:pt>
                <c:pt idx="92">
                  <c:v>-0.98546676955090062</c:v>
                </c:pt>
                <c:pt idx="93">
                  <c:v>-0.98508186593513081</c:v>
                </c:pt>
                <c:pt idx="94">
                  <c:v>-0.98397891856818775</c:v>
                </c:pt>
                <c:pt idx="95">
                  <c:v>-0.98215841448057906</c:v>
                </c:pt>
                <c:pt idx="96">
                  <c:v>-0.97962115755566126</c:v>
                </c:pt>
                <c:pt idx="97">
                  <c:v>-0.97636826817466482</c:v>
                </c:pt>
                <c:pt idx="98">
                  <c:v>-0.97240118272196874</c:v>
                </c:pt>
                <c:pt idx="99">
                  <c:v>-0.96772165295083012</c:v>
                </c:pt>
                <c:pt idx="100">
                  <c:v>-0.96233174520986231</c:v>
                </c:pt>
                <c:pt idx="101">
                  <c:v>-0.95623383953059116</c:v>
                </c:pt>
                <c:pt idx="102">
                  <c:v>-0.94943062857650196</c:v>
                </c:pt>
                <c:pt idx="103">
                  <c:v>-0.94192511645403365</c:v>
                </c:pt>
                <c:pt idx="104">
                  <c:v>-0.93372061738605039</c:v>
                </c:pt>
                <c:pt idx="105">
                  <c:v>-0.9248207542483754</c:v>
                </c:pt>
                <c:pt idx="106">
                  <c:v>-0.91522945697002811</c:v>
                </c:pt>
                <c:pt idx="107">
                  <c:v>-0.90495096079788129</c:v>
                </c:pt>
                <c:pt idx="108">
                  <c:v>-0.89398980442649245</c:v>
                </c:pt>
                <c:pt idx="109">
                  <c:v>-0.88235082799394604</c:v>
                </c:pt>
                <c:pt idx="110">
                  <c:v>-0.87003917094458449</c:v>
                </c:pt>
                <c:pt idx="111">
                  <c:v>-0.85706026975957328</c:v>
                </c:pt>
                <c:pt idx="112">
                  <c:v>-0.84341985555630494</c:v>
                </c:pt>
                <c:pt idx="113">
                  <c:v>-0.82912395155769825</c:v>
                </c:pt>
                <c:pt idx="114">
                  <c:v>-0.81417887043251247</c:v>
                </c:pt>
                <c:pt idx="115">
                  <c:v>-0.79859121150785195</c:v>
                </c:pt>
                <c:pt idx="116">
                  <c:v>-0.78236785785508678</c:v>
                </c:pt>
                <c:pt idx="117">
                  <c:v>-0.76551597325048426</c:v>
                </c:pt>
                <c:pt idx="118">
                  <c:v>-0.74804299901188576</c:v>
                </c:pt>
                <c:pt idx="119">
                  <c:v>-0.72995665071283056</c:v>
                </c:pt>
                <c:pt idx="120">
                  <c:v>-0.71126491477557652</c:v>
                </c:pt>
                <c:pt idx="121">
                  <c:v>-0.69197604494451959</c:v>
                </c:pt>
                <c:pt idx="122">
                  <c:v>-0.67209855864157275</c:v>
                </c:pt>
                <c:pt idx="123">
                  <c:v>-0.65164123320511369</c:v>
                </c:pt>
                <c:pt idx="124">
                  <c:v>-0.63061310201415777</c:v>
                </c:pt>
                <c:pt idx="125">
                  <c:v>-0.60902345049947326</c:v>
                </c:pt>
                <c:pt idx="126">
                  <c:v>-0.58688181204339518</c:v>
                </c:pt>
                <c:pt idx="127">
                  <c:v>-0.5641979637701533</c:v>
                </c:pt>
                <c:pt idx="128">
                  <c:v>-0.54098192222856867</c:v>
                </c:pt>
                <c:pt idx="129">
                  <c:v>-0.51724393896902787</c:v>
                </c:pt>
                <c:pt idx="130">
                  <c:v>-0.49299449601668666</c:v>
                </c:pt>
                <c:pt idx="131">
                  <c:v>-0.46824430124290317</c:v>
                </c:pt>
                <c:pt idx="132">
                  <c:v>-0.44300428363694333</c:v>
                </c:pt>
                <c:pt idx="133">
                  <c:v>-0.41728558848004593</c:v>
                </c:pt>
                <c:pt idx="134">
                  <c:v>-0.39109957242398197</c:v>
                </c:pt>
                <c:pt idx="135">
                  <c:v>-0.36445779847627507</c:v>
                </c:pt>
                <c:pt idx="136">
                  <c:v>-0.33737203089430462</c:v>
                </c:pt>
                <c:pt idx="137">
                  <c:v>-0.30985422999053813</c:v>
                </c:pt>
                <c:pt idx="138">
                  <c:v>-0.28191654685119771</c:v>
                </c:pt>
                <c:pt idx="139">
                  <c:v>-0.25357131797067967</c:v>
                </c:pt>
                <c:pt idx="140">
                  <c:v>-0.224831059804107</c:v>
                </c:pt>
                <c:pt idx="141">
                  <c:v>-0.19570846324041469</c:v>
                </c:pt>
                <c:pt idx="142">
                  <c:v>-0.16621638799841065</c:v>
                </c:pt>
                <c:pt idx="143">
                  <c:v>-0.13636785694828624</c:v>
                </c:pt>
                <c:pt idx="144">
                  <c:v>-0.1061760503610823</c:v>
                </c:pt>
                <c:pt idx="145">
                  <c:v>-7.5654300088654036E-2</c:v>
                </c:pt>
                <c:pt idx="146">
                  <c:v>-4.4816083676699314E-2</c:v>
                </c:pt>
                <c:pt idx="147">
                  <c:v>-1.3675018413454421E-2</c:v>
                </c:pt>
                <c:pt idx="148">
                  <c:v>1.7755144683317181E-2</c:v>
                </c:pt>
                <c:pt idx="149">
                  <c:v>4.9460526938387095E-2</c:v>
                </c:pt>
                <c:pt idx="150">
                  <c:v>8.1427128147493866E-2</c:v>
                </c:pt>
                <c:pt idx="151">
                  <c:v>0.11364083275944137</c:v>
                </c:pt>
                <c:pt idx="152">
                  <c:v>0.14608741610912512</c:v>
                </c:pt>
                <c:pt idx="153">
                  <c:v>0.17875255069874652</c:v>
                </c:pt>
                <c:pt idx="154">
                  <c:v>0.21162181252443168</c:v>
                </c:pt>
                <c:pt idx="155">
                  <c:v>0.24468068744546623</c:v>
                </c:pt>
                <c:pt idx="156">
                  <c:v>0.27791457759333005</c:v>
                </c:pt>
                <c:pt idx="157">
                  <c:v>0.31130880781770609</c:v>
                </c:pt>
                <c:pt idx="158">
                  <c:v>0.34484863216661332</c:v>
                </c:pt>
                <c:pt idx="159">
                  <c:v>0.37851924039780371</c:v>
                </c:pt>
                <c:pt idx="160">
                  <c:v>0.41230576451854872</c:v>
                </c:pt>
                <c:pt idx="161">
                  <c:v>0.44619328535092617</c:v>
                </c:pt>
                <c:pt idx="162">
                  <c:v>0.48016683911970937</c:v>
                </c:pt>
                <c:pt idx="163">
                  <c:v>0.51421142405994791</c:v>
                </c:pt>
                <c:pt idx="164">
                  <c:v>0.54831200704132643</c:v>
                </c:pt>
                <c:pt idx="165">
                  <c:v>0.58245353020637181</c:v>
                </c:pt>
                <c:pt idx="166">
                  <c:v>0.61662091761957705</c:v>
                </c:pt>
                <c:pt idx="167">
                  <c:v>0.65079908192451164</c:v>
                </c:pt>
                <c:pt idx="168">
                  <c:v>0.6849729310059729</c:v>
                </c:pt>
                <c:pt idx="169">
                  <c:v>0.71912737465423993</c:v>
                </c:pt>
                <c:pt idx="170">
                  <c:v>0.75324733122848431</c:v>
                </c:pt>
                <c:pt idx="171">
                  <c:v>0.78731773431639873</c:v>
                </c:pt>
                <c:pt idx="172">
                  <c:v>0.82132353938710079</c:v>
                </c:pt>
                <c:pt idx="173">
                  <c:v>0.85524973043437347</c:v>
                </c:pt>
                <c:pt idx="174">
                  <c:v>0.88908132660731198</c:v>
                </c:pt>
                <c:pt idx="175">
                  <c:v>0.92280338882544433</c:v>
                </c:pt>
                <c:pt idx="176">
                  <c:v>0.95640102637540947</c:v>
                </c:pt>
                <c:pt idx="177">
                  <c:v>0.98985940348627843</c:v>
                </c:pt>
                <c:pt idx="178">
                  <c:v>1.0231637458806091</c:v>
                </c:pt>
                <c:pt idx="179">
                  <c:v>1.0562993472983577</c:v>
                </c:pt>
                <c:pt idx="180">
                  <c:v>1.0892515759907422</c:v>
                </c:pt>
                <c:pt idx="181">
                  <c:v>1.1220058811812155</c:v>
                </c:pt>
                <c:pt idx="182">
                  <c:v>1.1545477994906768</c:v>
                </c:pt>
                <c:pt idx="183">
                  <c:v>1.1868629613240926</c:v>
                </c:pt>
                <c:pt idx="184">
                  <c:v>1.2189370972157072</c:v>
                </c:pt>
                <c:pt idx="185">
                  <c:v>1.2507560441300329</c:v>
                </c:pt>
                <c:pt idx="186">
                  <c:v>1.2823057517158545</c:v>
                </c:pt>
                <c:pt idx="187">
                  <c:v>1.313572288510461</c:v>
                </c:pt>
                <c:pt idx="188">
                  <c:v>1.3445418480913933</c:v>
                </c:pt>
                <c:pt idx="189">
                  <c:v>1.3752007551729692</c:v>
                </c:pt>
                <c:pt idx="190">
                  <c:v>1.4055354716449044</c:v>
                </c:pt>
                <c:pt idx="191">
                  <c:v>1.4355326025503625</c:v>
                </c:pt>
                <c:pt idx="192">
                  <c:v>1.4651789020007897</c:v>
                </c:pt>
                <c:pt idx="193">
                  <c:v>1.4944612790249259</c:v>
                </c:pt>
                <c:pt idx="194">
                  <c:v>1.5233668033494094</c:v>
                </c:pt>
                <c:pt idx="195">
                  <c:v>1.5518827111084224</c:v>
                </c:pt>
                <c:pt idx="196">
                  <c:v>1.5799964104798545</c:v>
                </c:pt>
                <c:pt idx="197">
                  <c:v>1.6076954872454958</c:v>
                </c:pt>
                <c:pt idx="198">
                  <c:v>1.6349677102728071</c:v>
                </c:pt>
                <c:pt idx="199">
                  <c:v>1.6618010369158447</c:v>
                </c:pt>
                <c:pt idx="200">
                  <c:v>1.6881836183329515</c:v>
                </c:pt>
                <c:pt idx="201">
                  <c:v>1.7141038047188739</c:v>
                </c:pt>
                <c:pt idx="202">
                  <c:v>1.7395501504489872</c:v>
                </c:pt>
                <c:pt idx="203">
                  <c:v>1.7645114191333604</c:v>
                </c:pt>
                <c:pt idx="204">
                  <c:v>1.7889765885784308</c:v>
                </c:pt>
                <c:pt idx="205">
                  <c:v>1.8129348556540938</c:v>
                </c:pt>
                <c:pt idx="206">
                  <c:v>1.8363756410640626</c:v>
                </c:pt>
                <c:pt idx="207">
                  <c:v>1.8592885940173842</c:v>
                </c:pt>
                <c:pt idx="208">
                  <c:v>1.8816635967990614</c:v>
                </c:pt>
                <c:pt idx="209">
                  <c:v>1.9034907692377465</c:v>
                </c:pt>
                <c:pt idx="210">
                  <c:v>1.9247604730685521</c:v>
                </c:pt>
                <c:pt idx="211">
                  <c:v>1.9454633161890316</c:v>
                </c:pt>
                <c:pt idx="212">
                  <c:v>1.9655901568064729</c:v>
                </c:pt>
                <c:pt idx="213">
                  <c:v>1.985132107474652</c:v>
                </c:pt>
                <c:pt idx="214">
                  <c:v>2.0040805390182825</c:v>
                </c:pt>
                <c:pt idx="215">
                  <c:v>2.0224270843434162</c:v>
                </c:pt>
                <c:pt idx="216">
                  <c:v>2.0401636421321125</c:v>
                </c:pt>
                <c:pt idx="217">
                  <c:v>2.0572823804197569</c:v>
                </c:pt>
                <c:pt idx="218">
                  <c:v>2.0737757400534336</c:v>
                </c:pt>
                <c:pt idx="219">
                  <c:v>2.0896364380298351</c:v>
                </c:pt>
                <c:pt idx="220">
                  <c:v>2.1048574707112326</c:v>
                </c:pt>
                <c:pt idx="221">
                  <c:v>2.119432116918083</c:v>
                </c:pt>
                <c:pt idx="222">
                  <c:v>2.1333539408969142</c:v>
                </c:pt>
                <c:pt idx="223">
                  <c:v>2.1466167951621729</c:v>
                </c:pt>
                <c:pt idx="224">
                  <c:v>2.15921482321078</c:v>
                </c:pt>
                <c:pt idx="225">
                  <c:v>2.1711424621081985</c:v>
                </c:pt>
                <c:pt idx="226">
                  <c:v>2.1823944449448671</c:v>
                </c:pt>
                <c:pt idx="227">
                  <c:v>2.1929658031619228</c:v>
                </c:pt>
                <c:pt idx="228">
                  <c:v>2.2028518687451717</c:v>
                </c:pt>
                <c:pt idx="229">
                  <c:v>2.2120482762863571</c:v>
                </c:pt>
                <c:pt idx="230">
                  <c:v>2.2205509649107977</c:v>
                </c:pt>
                <c:pt idx="231">
                  <c:v>2.2283561800705574</c:v>
                </c:pt>
                <c:pt idx="232">
                  <c:v>2.2354604752023475</c:v>
                </c:pt>
                <c:pt idx="233">
                  <c:v>2.2418607132494319</c:v>
                </c:pt>
                <c:pt idx="234">
                  <c:v>2.2475540680468638</c:v>
                </c:pt>
                <c:pt idx="235">
                  <c:v>2.2525380255694376</c:v>
                </c:pt>
                <c:pt idx="236">
                  <c:v>2.2568103850418169</c:v>
                </c:pt>
                <c:pt idx="237">
                  <c:v>2.26036925991033</c:v>
                </c:pt>
                <c:pt idx="238">
                  <c:v>2.2632130786760207</c:v>
                </c:pt>
                <c:pt idx="239">
                  <c:v>2.26534058558858</c:v>
                </c:pt>
                <c:pt idx="240">
                  <c:v>2.2667508412008464</c:v>
                </c:pt>
                <c:pt idx="241">
                  <c:v>2.2674432227836423</c:v>
                </c:pt>
                <c:pt idx="242">
                  <c:v>2.267417424600751</c:v>
                </c:pt>
                <c:pt idx="243">
                  <c:v>2.2666734580439249</c:v>
                </c:pt>
                <c:pt idx="244">
                  <c:v>2.265211651627852</c:v>
                </c:pt>
                <c:pt idx="245">
                  <c:v>2.2630326508450938</c:v>
                </c:pt>
                <c:pt idx="246">
                  <c:v>2.2601374178810545</c:v>
                </c:pt>
                <c:pt idx="247">
                  <c:v>2.2565272311891067</c:v>
                </c:pt>
                <c:pt idx="248">
                  <c:v>2.2522036849260627</c:v>
                </c:pt>
                <c:pt idx="249">
                  <c:v>2.24716868824824</c:v>
                </c:pt>
                <c:pt idx="250">
                  <c:v>2.2414244644684302</c:v>
                </c:pt>
                <c:pt idx="251">
                  <c:v>2.2349735500741481</c:v>
                </c:pt>
                <c:pt idx="252">
                  <c:v>2.2278187936075895</c:v>
                </c:pt>
                <c:pt idx="253">
                  <c:v>2.219963354407795</c:v>
                </c:pt>
                <c:pt idx="254">
                  <c:v>2.2114107012155766</c:v>
                </c:pt>
                <c:pt idx="255">
                  <c:v>2.202164610641816</c:v>
                </c:pt>
                <c:pt idx="256">
                  <c:v>2.1922291654998225</c:v>
                </c:pt>
                <c:pt idx="257">
                  <c:v>2.1816087530024775</c:v>
                </c:pt>
                <c:pt idx="258">
                  <c:v>2.1703080628249625</c:v>
                </c:pt>
                <c:pt idx="259">
                  <c:v>2.1583320850339325</c:v>
                </c:pt>
                <c:pt idx="260">
                  <c:v>2.1456861078840421</c:v>
                </c:pt>
                <c:pt idx="261">
                  <c:v>2.132375715482802</c:v>
                </c:pt>
                <c:pt idx="262">
                  <c:v>2.1184067853247943</c:v>
                </c:pt>
                <c:pt idx="263">
                  <c:v>2.1037854856963349</c:v>
                </c:pt>
                <c:pt idx="264">
                  <c:v>2.0885182729517338</c:v>
                </c:pt>
                <c:pt idx="265">
                  <c:v>2.0726118886623492</c:v>
                </c:pt>
                <c:pt idx="266">
                  <c:v>2.0560733566396996</c:v>
                </c:pt>
                <c:pt idx="267">
                  <c:v>2.0389099798339485</c:v>
                </c:pt>
                <c:pt idx="268">
                  <c:v>2.0211293371091243</c:v>
                </c:pt>
                <c:pt idx="269">
                  <c:v>2.0027392798965087</c:v>
                </c:pt>
                <c:pt idx="270">
                  <c:v>1.9837479287276651</c:v>
                </c:pt>
                <c:pt idx="271">
                  <c:v>1.9641636696486426</c:v>
                </c:pt>
                <c:pt idx="272">
                  <c:v>1.9439951505169293</c:v>
                </c:pt>
                <c:pt idx="273">
                  <c:v>1.9232512771828079</c:v>
                </c:pt>
                <c:pt idx="274">
                  <c:v>1.9019412095567785</c:v>
                </c:pt>
                <c:pt idx="275">
                  <c:v>1.8800743575648022</c:v>
                </c:pt>
                <c:pt idx="276">
                  <c:v>1.8576603769931412</c:v>
                </c:pt>
                <c:pt idx="277">
                  <c:v>1.8347091652246368</c:v>
                </c:pt>
                <c:pt idx="278">
                  <c:v>1.8112308568683035</c:v>
                </c:pt>
                <c:pt idx="279">
                  <c:v>1.7872358192841693</c:v>
                </c:pt>
                <c:pt idx="280">
                  <c:v>1.7627346480053441</c:v>
                </c:pt>
                <c:pt idx="281">
                  <c:v>1.7377381620593282</c:v>
                </c:pt>
                <c:pt idx="282">
                  <c:v>1.7122573991906356</c:v>
                </c:pt>
                <c:pt idx="283">
                  <c:v>1.6863036109868363</c:v>
                </c:pt>
                <c:pt idx="284">
                  <c:v>1.6598882579101724</c:v>
                </c:pt>
                <c:pt idx="285">
                  <c:v>1.6330230042369398</c:v>
                </c:pt>
                <c:pt idx="286">
                  <c:v>1.6057197129068728</c:v>
                </c:pt>
                <c:pt idx="287">
                  <c:v>1.577990440284804</c:v>
                </c:pt>
                <c:pt idx="288">
                  <c:v>1.5498474308369119</c:v>
                </c:pt>
                <c:pt idx="289">
                  <c:v>1.5213031117239111</c:v>
                </c:pt>
                <c:pt idx="290">
                  <c:v>1.4923700873135664</c:v>
                </c:pt>
                <c:pt idx="291">
                  <c:v>1.4630611336149597</c:v>
                </c:pt>
                <c:pt idx="292">
                  <c:v>1.4333891926369633</c:v>
                </c:pt>
                <c:pt idx="293">
                  <c:v>1.4033673666734139</c:v>
                </c:pt>
                <c:pt idx="294">
                  <c:v>1.3730089125175082</c:v>
                </c:pt>
                <c:pt idx="295">
                  <c:v>1.3423272356079758</c:v>
                </c:pt>
                <c:pt idx="296">
                  <c:v>1.3113358841096161</c:v>
                </c:pt>
                <c:pt idx="297">
                  <c:v>1.2800485429308082</c:v>
                </c:pt>
                <c:pt idx="298">
                  <c:v>1.2484790276806419</c:v>
                </c:pt>
                <c:pt idx="299">
                  <c:v>1.216641278568335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382488"/>
        <c:axId val="283384448"/>
      </c:scatterChart>
      <c:valAx>
        <c:axId val="283382488"/>
        <c:scaling>
          <c:orientation val="minMax"/>
          <c:max val="30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384448"/>
        <c:crosses val="autoZero"/>
        <c:crossBetween val="midCat"/>
      </c:valAx>
      <c:valAx>
        <c:axId val="283384448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382488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826165960024233"/>
          <c:y val="0.10679611650485436"/>
          <c:w val="0.64991141732283464"/>
          <c:h val="0.7039966363427872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003CE6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003CE6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BO$1:$BO$15</c:f>
              <c:numCache>
                <c:formatCode>General</c:formatCode>
                <c:ptCount val="15"/>
                <c:pt idx="0">
                  <c:v>12.6</c:v>
                </c:pt>
                <c:pt idx="1">
                  <c:v>15.8</c:v>
                </c:pt>
                <c:pt idx="2">
                  <c:v>13.1</c:v>
                </c:pt>
                <c:pt idx="3">
                  <c:v>10</c:v>
                </c:pt>
                <c:pt idx="4">
                  <c:v>10.6</c:v>
                </c:pt>
                <c:pt idx="5">
                  <c:v>13.07</c:v>
                </c:pt>
                <c:pt idx="6">
                  <c:v>15.5</c:v>
                </c:pt>
                <c:pt idx="7">
                  <c:v>9.99</c:v>
                </c:pt>
                <c:pt idx="8">
                  <c:v>14.3</c:v>
                </c:pt>
                <c:pt idx="9">
                  <c:v>18</c:v>
                </c:pt>
                <c:pt idx="10">
                  <c:v>22.2</c:v>
                </c:pt>
                <c:pt idx="11">
                  <c:v>25</c:v>
                </c:pt>
                <c:pt idx="12">
                  <c:v>18.5</c:v>
                </c:pt>
                <c:pt idx="13">
                  <c:v>20.5</c:v>
                </c:pt>
                <c:pt idx="14">
                  <c:v>19.7</c:v>
                </c:pt>
              </c:numCache>
            </c:numRef>
          </c:xVal>
          <c:yVal>
            <c:numRef>
              <c:f>'Covariance   Correlation3_HID4'!$BP$1:$BP$15</c:f>
              <c:numCache>
                <c:formatCode>General</c:formatCode>
                <c:ptCount val="15"/>
                <c:pt idx="0">
                  <c:v>9.1300000000000006E-2</c:v>
                </c:pt>
                <c:pt idx="1">
                  <c:v>0.44719999999999999</c:v>
                </c:pt>
                <c:pt idx="2">
                  <c:v>0.40560000000000002</c:v>
                </c:pt>
                <c:pt idx="3">
                  <c:v>0.29530000000000001</c:v>
                </c:pt>
                <c:pt idx="4">
                  <c:v>0.10879999999999999</c:v>
                </c:pt>
                <c:pt idx="5">
                  <c:v>1.6014999999999999</c:v>
                </c:pt>
                <c:pt idx="6">
                  <c:v>1.0639000000000001</c:v>
                </c:pt>
                <c:pt idx="7">
                  <c:v>1.5142</c:v>
                </c:pt>
                <c:pt idx="8">
                  <c:v>1.4415</c:v>
                </c:pt>
                <c:pt idx="9">
                  <c:v>1.0116000000000001</c:v>
                </c:pt>
                <c:pt idx="10">
                  <c:v>0.59709999999999996</c:v>
                </c:pt>
                <c:pt idx="11">
                  <c:v>0.1628</c:v>
                </c:pt>
                <c:pt idx="12">
                  <c:v>0.2384</c:v>
                </c:pt>
                <c:pt idx="13">
                  <c:v>2.1299999999999999E-2</c:v>
                </c:pt>
                <c:pt idx="14">
                  <c:v>0.614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42</c:f>
              <c:numCache>
                <c:formatCode>General</c:formatCode>
                <c:ptCount val="300"/>
                <c:pt idx="0">
                  <c:v>2.2847777708606003</c:v>
                </c:pt>
                <c:pt idx="1">
                  <c:v>2.2877891191489059</c:v>
                </c:pt>
                <c:pt idx="2">
                  <c:v>2.2968218342871918</c:v>
                </c:pt>
                <c:pt idx="3">
                  <c:v>2.3118719276827324</c:v>
                </c:pt>
                <c:pt idx="4">
                  <c:v>2.332932753637964</c:v>
                </c:pt>
                <c:pt idx="5">
                  <c:v>2.3599950122850295</c:v>
                </c:pt>
                <c:pt idx="6">
                  <c:v>2.3930467536923459</c:v>
                </c:pt>
                <c:pt idx="7">
                  <c:v>2.432073383141347</c:v>
                </c:pt>
                <c:pt idx="8">
                  <c:v>2.4770576675711187</c:v>
                </c:pt>
                <c:pt idx="9">
                  <c:v>2.5279797431880127</c:v>
                </c:pt>
                <c:pt idx="10">
                  <c:v>2.5848171242369542</c:v>
                </c:pt>
                <c:pt idx="11">
                  <c:v>2.6475447129305056</c:v>
                </c:pt>
                <c:pt idx="12">
                  <c:v>2.7161348105313579</c:v>
                </c:pt>
                <c:pt idx="13">
                  <c:v>2.7905571295832985</c:v>
                </c:pt>
                <c:pt idx="14">
                  <c:v>2.8707788072853067</c:v>
                </c:pt>
                <c:pt idx="15">
                  <c:v>2.9567644200028429</c:v>
                </c:pt>
                <c:pt idx="16">
                  <c:v>3.0484759989099253</c:v>
                </c:pt>
                <c:pt idx="17">
                  <c:v>3.1458730467550957</c:v>
                </c:pt>
                <c:pt idx="18">
                  <c:v>3.2489125557438623</c:v>
                </c:pt>
                <c:pt idx="19">
                  <c:v>3.3575490265297372</c:v>
                </c:pt>
                <c:pt idx="20">
                  <c:v>3.4717344883054615</c:v>
                </c:pt>
                <c:pt idx="21">
                  <c:v>3.5914185199855702</c:v>
                </c:pt>
                <c:pt idx="22">
                  <c:v>3.7165482724709129</c:v>
                </c:pt>
                <c:pt idx="23">
                  <c:v>3.8470684919853362</c:v>
                </c:pt>
                <c:pt idx="24">
                  <c:v>3.9829215444742037</c:v>
                </c:pt>
                <c:pt idx="25">
                  <c:v>4.1240474410539534</c:v>
                </c:pt>
                <c:pt idx="26">
                  <c:v>4.2703838645015111</c:v>
                </c:pt>
                <c:pt idx="27">
                  <c:v>4.4218661967718198</c:v>
                </c:pt>
                <c:pt idx="28">
                  <c:v>4.5784275475313532</c:v>
                </c:pt>
                <c:pt idx="29">
                  <c:v>4.7399987836949933</c:v>
                </c:pt>
                <c:pt idx="30">
                  <c:v>4.9065085599532701</c:v>
                </c:pt>
                <c:pt idx="31">
                  <c:v>5.07788335027643</c:v>
                </c:pt>
                <c:pt idx="32">
                  <c:v>5.2540474803814607</c:v>
                </c:pt>
                <c:pt idx="33">
                  <c:v>5.4349231611477311</c:v>
                </c:pt>
                <c:pt idx="34">
                  <c:v>5.6204305229664708</c:v>
                </c:pt>
                <c:pt idx="35">
                  <c:v>5.8104876510089518</c:v>
                </c:pt>
                <c:pt idx="36">
                  <c:v>6.0050106213977532</c:v>
                </c:pt>
                <c:pt idx="37">
                  <c:v>6.2039135382651995</c:v>
                </c:pt>
                <c:pt idx="38">
                  <c:v>6.4071085716825458</c:v>
                </c:pt>
                <c:pt idx="39">
                  <c:v>6.6145059964432065</c:v>
                </c:pt>
                <c:pt idx="40">
                  <c:v>6.8260142316828851</c:v>
                </c:pt>
                <c:pt idx="41">
                  <c:v>7.0415398813191015</c:v>
                </c:pt>
                <c:pt idx="42">
                  <c:v>7.260987775292266</c:v>
                </c:pt>
                <c:pt idx="43">
                  <c:v>7.4842610115901174</c:v>
                </c:pt>
                <c:pt idx="44">
                  <c:v>7.7112609990368988</c:v>
                </c:pt>
                <c:pt idx="45">
                  <c:v>7.9418875008284644</c:v>
                </c:pt>
                <c:pt idx="46">
                  <c:v>8.1760386787940273</c:v>
                </c:pt>
                <c:pt idx="47">
                  <c:v>8.4136111383650221</c:v>
                </c:pt>
                <c:pt idx="48">
                  <c:v>8.6544999742312392</c:v>
                </c:pt>
                <c:pt idx="49">
                  <c:v>8.8985988166640553</c:v>
                </c:pt>
                <c:pt idx="50">
                  <c:v>9.1457998784863186</c:v>
                </c:pt>
                <c:pt idx="51">
                  <c:v>9.3959940026681199</c:v>
                </c:pt>
                <c:pt idx="52">
                  <c:v>9.6490707105274733</c:v>
                </c:pt>
                <c:pt idx="53">
                  <c:v>9.9049182505145872</c:v>
                </c:pt>
                <c:pt idx="54">
                  <c:v>10.163423647558204</c:v>
                </c:pt>
                <c:pt idx="55">
                  <c:v>10.424472752952219</c:v>
                </c:pt>
                <c:pt idx="56">
                  <c:v>10.687950294760521</c:v>
                </c:pt>
                <c:pt idx="57">
                  <c:v>10.953739928717841</c:v>
                </c:pt>
                <c:pt idx="58">
                  <c:v>11.221724289604106</c:v>
                </c:pt>
                <c:pt idx="59">
                  <c:v>11.491785043069619</c:v>
                </c:pt>
                <c:pt idx="60">
                  <c:v>11.763802937888169</c:v>
                </c:pt>
                <c:pt idx="61">
                  <c:v>12.037657858615017</c:v>
                </c:pt>
                <c:pt idx="62">
                  <c:v>12.313228878626504</c:v>
                </c:pt>
                <c:pt idx="63">
                  <c:v>12.590394313517837</c:v>
                </c:pt>
                <c:pt idx="64">
                  <c:v>12.86903177483549</c:v>
                </c:pt>
                <c:pt idx="65">
                  <c:v>13.149018224120509</c:v>
                </c:pt>
                <c:pt idx="66">
                  <c:v>13.43023002723883</c:v>
                </c:pt>
                <c:pt idx="67">
                  <c:v>13.712543008974635</c:v>
                </c:pt>
                <c:pt idx="68">
                  <c:v>13.995832507862616</c:v>
                </c:pt>
                <c:pt idx="69">
                  <c:v>14.279973431234998</c:v>
                </c:pt>
                <c:pt idx="70">
                  <c:v>14.564840310458909</c:v>
                </c:pt>
                <c:pt idx="71">
                  <c:v>14.850307356339815</c:v>
                </c:pt>
                <c:pt idx="72">
                  <c:v>15.13624851466648</c:v>
                </c:pt>
                <c:pt idx="73">
                  <c:v>15.422537521872961</c:v>
                </c:pt>
                <c:pt idx="74">
                  <c:v>15.709047960793034</c:v>
                </c:pt>
                <c:pt idx="75">
                  <c:v>15.995653316482473</c:v>
                </c:pt>
                <c:pt idx="76">
                  <c:v>16.282227032084482</c:v>
                </c:pt>
                <c:pt idx="77">
                  <c:v>16.56864256471362</c:v>
                </c:pt>
                <c:pt idx="78">
                  <c:v>16.854773441333613</c:v>
                </c:pt>
                <c:pt idx="79">
                  <c:v>17.140493314604253</c:v>
                </c:pt>
                <c:pt idx="80">
                  <c:v>17.425676018672849</c:v>
                </c:pt>
                <c:pt idx="81">
                  <c:v>17.710195624885504</c:v>
                </c:pt>
                <c:pt idx="82">
                  <c:v>17.993926497393666</c:v>
                </c:pt>
                <c:pt idx="83">
                  <c:v>18.276743348631392</c:v>
                </c:pt>
                <c:pt idx="84">
                  <c:v>18.558521294638791</c:v>
                </c:pt>
                <c:pt idx="85">
                  <c:v>18.839135910207279</c:v>
                </c:pt>
                <c:pt idx="86">
                  <c:v>19.118463283822244</c:v>
                </c:pt>
                <c:pt idx="87">
                  <c:v>19.396380072378886</c:v>
                </c:pt>
                <c:pt idx="88">
                  <c:v>19.672763555647052</c:v>
                </c:pt>
                <c:pt idx="89">
                  <c:v>19.947491690461042</c:v>
                </c:pt>
                <c:pt idx="90">
                  <c:v>20.220443164610447</c:v>
                </c:pt>
                <c:pt idx="91">
                  <c:v>20.491497450408168</c:v>
                </c:pt>
                <c:pt idx="92">
                  <c:v>20.760534857912091</c:v>
                </c:pt>
                <c:pt idx="93">
                  <c:v>21.027436587776773</c:v>
                </c:pt>
                <c:pt idx="94">
                  <c:v>21.292084783711896</c:v>
                </c:pt>
                <c:pt idx="95">
                  <c:v>21.554362584524288</c:v>
                </c:pt>
                <c:pt idx="96">
                  <c:v>21.814154175720525</c:v>
                </c:pt>
                <c:pt idx="97">
                  <c:v>22.071344840647377</c:v>
                </c:pt>
                <c:pt idx="98">
                  <c:v>22.325821011147418</c:v>
                </c:pt>
                <c:pt idx="99">
                  <c:v>22.577470317707554</c:v>
                </c:pt>
                <c:pt idx="100">
                  <c:v>22.826181639078225</c:v>
                </c:pt>
                <c:pt idx="101">
                  <c:v>23.071845151341421</c:v>
                </c:pt>
                <c:pt idx="102">
                  <c:v>23.314352376405843</c:v>
                </c:pt>
                <c:pt idx="103">
                  <c:v>23.55359622990775</c:v>
                </c:pt>
                <c:pt idx="104">
                  <c:v>23.789471068496432</c:v>
                </c:pt>
                <c:pt idx="105">
                  <c:v>24.021872736483317</c:v>
                </c:pt>
                <c:pt idx="106">
                  <c:v>24.250698611834189</c:v>
                </c:pt>
                <c:pt idx="107">
                  <c:v>24.475847651484205</c:v>
                </c:pt>
                <c:pt idx="108">
                  <c:v>24.697220435955671</c:v>
                </c:pt>
                <c:pt idx="109">
                  <c:v>24.914719213258849</c:v>
                </c:pt>
                <c:pt idx="110">
                  <c:v>25.128247942056532</c:v>
                </c:pt>
                <c:pt idx="111">
                  <c:v>25.337712334073153</c:v>
                </c:pt>
                <c:pt idx="112">
                  <c:v>25.54301989572987</c:v>
                </c:pt>
                <c:pt idx="113">
                  <c:v>25.744079968987098</c:v>
                </c:pt>
                <c:pt idx="114">
                  <c:v>25.940803771376551</c:v>
                </c:pt>
                <c:pt idx="115">
                  <c:v>26.133104435205102</c:v>
                </c:pt>
                <c:pt idx="116">
                  <c:v>26.320897045913085</c:v>
                </c:pt>
                <c:pt idx="117">
                  <c:v>26.504098679570191</c:v>
                </c:pt>
                <c:pt idx="118">
                  <c:v>26.682628439492337</c:v>
                </c:pt>
                <c:pt idx="119">
                  <c:v>26.856407491963353</c:v>
                </c:pt>
                <c:pt idx="120">
                  <c:v>27.025359101045748</c:v>
                </c:pt>
                <c:pt idx="121">
                  <c:v>27.189408662465134</c:v>
                </c:pt>
                <c:pt idx="122">
                  <c:v>27.348483736553376</c:v>
                </c:pt>
                <c:pt idx="123">
                  <c:v>27.502514080235898</c:v>
                </c:pt>
                <c:pt idx="124">
                  <c:v>27.651431678049065</c:v>
                </c:pt>
                <c:pt idx="125">
                  <c:v>27.795170772173883</c:v>
                </c:pt>
                <c:pt idx="126">
                  <c:v>27.933667891472808</c:v>
                </c:pt>
                <c:pt idx="127">
                  <c:v>28.066861879516807</c:v>
                </c:pt>
                <c:pt idx="128">
                  <c:v>28.194693921590321</c:v>
                </c:pt>
                <c:pt idx="129">
                  <c:v>28.317107570662202</c:v>
                </c:pt>
                <c:pt idx="130">
                  <c:v>28.43404877231109</c:v>
                </c:pt>
                <c:pt idx="131">
                  <c:v>28.545465888594375</c:v>
                </c:pt>
                <c:pt idx="132">
                  <c:v>28.651309720850023</c:v>
                </c:pt>
                <c:pt idx="133">
                  <c:v>28.751533531421337</c:v>
                </c:pt>
                <c:pt idx="134">
                  <c:v>28.846093064294983</c:v>
                </c:pt>
                <c:pt idx="135">
                  <c:v>28.934946564643205</c:v>
                </c:pt>
                <c:pt idx="136">
                  <c:v>29.01805479726157</c:v>
                </c:pt>
                <c:pt idx="137">
                  <c:v>29.095381063894159</c:v>
                </c:pt>
                <c:pt idx="138">
                  <c:v>29.16689121943844</c:v>
                </c:pt>
                <c:pt idx="139">
                  <c:v>29.232553687022822</c:v>
                </c:pt>
                <c:pt idx="140">
                  <c:v>29.292339471950093</c:v>
                </c:pt>
                <c:pt idx="141">
                  <c:v>29.346222174500664</c:v>
                </c:pt>
                <c:pt idx="142">
                  <c:v>29.394178001589957</c:v>
                </c:pt>
                <c:pt idx="143">
                  <c:v>29.43618577727473</c:v>
                </c:pt>
                <c:pt idx="144">
                  <c:v>29.472226952103817</c:v>
                </c:pt>
                <c:pt idx="145">
                  <c:v>29.502285611309013</c:v>
                </c:pt>
                <c:pt idx="146">
                  <c:v>29.526348481832592</c:v>
                </c:pt>
                <c:pt idx="147">
                  <c:v>29.544404938188336</c:v>
                </c:pt>
                <c:pt idx="148">
                  <c:v>29.556447007153423</c:v>
                </c:pt>
                <c:pt idx="149">
                  <c:v>29.562469371289197</c:v>
                </c:pt>
                <c:pt idx="150">
                  <c:v>29.562469371289197</c:v>
                </c:pt>
                <c:pt idx="151">
                  <c:v>29.556447007153416</c:v>
                </c:pt>
                <c:pt idx="152">
                  <c:v>29.544404938188322</c:v>
                </c:pt>
                <c:pt idx="153">
                  <c:v>29.526348481832578</c:v>
                </c:pt>
                <c:pt idx="154">
                  <c:v>29.502285611308992</c:v>
                </c:pt>
                <c:pt idx="155">
                  <c:v>29.472226952103796</c:v>
                </c:pt>
                <c:pt idx="156">
                  <c:v>29.436185777274702</c:v>
                </c:pt>
                <c:pt idx="157">
                  <c:v>29.394178001589921</c:v>
                </c:pt>
                <c:pt idx="158">
                  <c:v>29.346222174500628</c:v>
                </c:pt>
                <c:pt idx="159">
                  <c:v>29.292339471950051</c:v>
                </c:pt>
                <c:pt idx="160">
                  <c:v>29.232553687022776</c:v>
                </c:pt>
                <c:pt idx="161">
                  <c:v>29.166891219438391</c:v>
                </c:pt>
                <c:pt idx="162">
                  <c:v>29.095381063894102</c:v>
                </c:pt>
                <c:pt idx="163">
                  <c:v>29.018054797261513</c:v>
                </c:pt>
                <c:pt idx="164">
                  <c:v>28.934946564643141</c:v>
                </c:pt>
                <c:pt idx="165">
                  <c:v>28.846093064294919</c:v>
                </c:pt>
                <c:pt idx="166">
                  <c:v>28.75153353142127</c:v>
                </c:pt>
                <c:pt idx="167">
                  <c:v>28.651309720849952</c:v>
                </c:pt>
                <c:pt idx="168">
                  <c:v>28.5454658885943</c:v>
                </c:pt>
                <c:pt idx="169">
                  <c:v>28.434048772311012</c:v>
                </c:pt>
                <c:pt idx="170">
                  <c:v>28.317107570662117</c:v>
                </c:pt>
                <c:pt idx="171">
                  <c:v>28.194693921590236</c:v>
                </c:pt>
                <c:pt idx="172">
                  <c:v>28.066861879516715</c:v>
                </c:pt>
                <c:pt idx="173">
                  <c:v>27.933667891472712</c:v>
                </c:pt>
                <c:pt idx="174">
                  <c:v>27.795170772173787</c:v>
                </c:pt>
                <c:pt idx="175">
                  <c:v>27.651431678048965</c:v>
                </c:pt>
                <c:pt idx="176">
                  <c:v>27.502514080235795</c:v>
                </c:pt>
                <c:pt idx="177">
                  <c:v>27.348483736553266</c:v>
                </c:pt>
                <c:pt idx="178">
                  <c:v>27.189408662465024</c:v>
                </c:pt>
                <c:pt idx="179">
                  <c:v>27.02535910104563</c:v>
                </c:pt>
                <c:pt idx="180">
                  <c:v>26.856407491963232</c:v>
                </c:pt>
                <c:pt idx="181">
                  <c:v>26.682628439492213</c:v>
                </c:pt>
                <c:pt idx="182">
                  <c:v>26.504098679570067</c:v>
                </c:pt>
                <c:pt idx="183">
                  <c:v>26.320897045912957</c:v>
                </c:pt>
                <c:pt idx="184">
                  <c:v>26.13310443520497</c:v>
                </c:pt>
                <c:pt idx="185">
                  <c:v>25.940803771376416</c:v>
                </c:pt>
                <c:pt idx="186">
                  <c:v>25.744079968986959</c:v>
                </c:pt>
                <c:pt idx="187">
                  <c:v>25.543019895729731</c:v>
                </c:pt>
                <c:pt idx="188">
                  <c:v>25.337712334073011</c:v>
                </c:pt>
                <c:pt idx="189">
                  <c:v>25.128247942056383</c:v>
                </c:pt>
                <c:pt idx="190">
                  <c:v>24.914719213258699</c:v>
                </c:pt>
                <c:pt idx="191">
                  <c:v>24.697220435955522</c:v>
                </c:pt>
                <c:pt idx="192">
                  <c:v>24.475847651484052</c:v>
                </c:pt>
                <c:pt idx="193">
                  <c:v>24.250698611834032</c:v>
                </c:pt>
                <c:pt idx="194">
                  <c:v>24.021872736483154</c:v>
                </c:pt>
                <c:pt idx="195">
                  <c:v>23.789471068496269</c:v>
                </c:pt>
                <c:pt idx="196">
                  <c:v>23.553596229907587</c:v>
                </c:pt>
                <c:pt idx="197">
                  <c:v>23.314352376405672</c:v>
                </c:pt>
                <c:pt idx="198">
                  <c:v>23.071845151341254</c:v>
                </c:pt>
                <c:pt idx="199">
                  <c:v>22.826181639078051</c:v>
                </c:pt>
                <c:pt idx="200">
                  <c:v>22.57747031770738</c:v>
                </c:pt>
                <c:pt idx="201">
                  <c:v>22.325821011147241</c:v>
                </c:pt>
                <c:pt idx="202">
                  <c:v>22.0713448406472</c:v>
                </c:pt>
                <c:pt idx="203">
                  <c:v>21.814154175720347</c:v>
                </c:pt>
                <c:pt idx="204">
                  <c:v>21.554362584524103</c:v>
                </c:pt>
                <c:pt idx="205">
                  <c:v>21.292084783711708</c:v>
                </c:pt>
                <c:pt idx="206">
                  <c:v>21.027436587776585</c:v>
                </c:pt>
                <c:pt idx="207">
                  <c:v>20.7605348579119</c:v>
                </c:pt>
                <c:pt idx="208">
                  <c:v>20.491497450407977</c:v>
                </c:pt>
                <c:pt idx="209">
                  <c:v>20.220443164610252</c:v>
                </c:pt>
                <c:pt idx="210">
                  <c:v>19.947491690460851</c:v>
                </c:pt>
                <c:pt idx="211">
                  <c:v>19.672763555646853</c:v>
                </c:pt>
                <c:pt idx="212">
                  <c:v>19.396380072378687</c:v>
                </c:pt>
                <c:pt idx="213">
                  <c:v>19.118463283822042</c:v>
                </c:pt>
                <c:pt idx="214">
                  <c:v>18.839135910207087</c:v>
                </c:pt>
                <c:pt idx="215">
                  <c:v>18.558521294638602</c:v>
                </c:pt>
                <c:pt idx="216">
                  <c:v>18.2767433486312</c:v>
                </c:pt>
                <c:pt idx="217">
                  <c:v>17.993926497393474</c:v>
                </c:pt>
                <c:pt idx="218">
                  <c:v>17.710195624885309</c:v>
                </c:pt>
                <c:pt idx="219">
                  <c:v>17.425676018672654</c:v>
                </c:pt>
                <c:pt idx="220">
                  <c:v>17.140493314604058</c:v>
                </c:pt>
                <c:pt idx="221">
                  <c:v>16.854773441333418</c:v>
                </c:pt>
                <c:pt idx="222">
                  <c:v>16.568642564713425</c:v>
                </c:pt>
                <c:pt idx="223">
                  <c:v>16.282227032084283</c:v>
                </c:pt>
                <c:pt idx="224">
                  <c:v>15.995653316482278</c:v>
                </c:pt>
                <c:pt idx="225">
                  <c:v>15.709047960792835</c:v>
                </c:pt>
                <c:pt idx="226">
                  <c:v>15.42253752187276</c:v>
                </c:pt>
                <c:pt idx="227">
                  <c:v>15.136248514666281</c:v>
                </c:pt>
                <c:pt idx="228">
                  <c:v>14.850307356339616</c:v>
                </c:pt>
                <c:pt idx="229">
                  <c:v>14.564840310458711</c:v>
                </c:pt>
                <c:pt idx="230">
                  <c:v>14.279973431234799</c:v>
                </c:pt>
                <c:pt idx="231">
                  <c:v>13.995832507862417</c:v>
                </c:pt>
                <c:pt idx="232">
                  <c:v>13.712543008974434</c:v>
                </c:pt>
                <c:pt idx="233">
                  <c:v>13.430230027238631</c:v>
                </c:pt>
                <c:pt idx="234">
                  <c:v>13.14901822412031</c:v>
                </c:pt>
                <c:pt idx="235">
                  <c:v>12.869031774835292</c:v>
                </c:pt>
                <c:pt idx="236">
                  <c:v>12.59039431351764</c:v>
                </c:pt>
                <c:pt idx="237">
                  <c:v>12.31322887862631</c:v>
                </c:pt>
                <c:pt idx="238">
                  <c:v>12.037657858614821</c:v>
                </c:pt>
                <c:pt idx="239">
                  <c:v>11.763802937887972</c:v>
                </c:pt>
                <c:pt idx="240">
                  <c:v>11.491785043069424</c:v>
                </c:pt>
                <c:pt idx="241">
                  <c:v>11.221724289603912</c:v>
                </c:pt>
                <c:pt idx="242">
                  <c:v>10.95373992871766</c:v>
                </c:pt>
                <c:pt idx="243">
                  <c:v>10.687950294760341</c:v>
                </c:pt>
                <c:pt idx="244">
                  <c:v>10.424472752952042</c:v>
                </c:pt>
                <c:pt idx="245">
                  <c:v>10.163423647558028</c:v>
                </c:pt>
                <c:pt idx="246">
                  <c:v>9.9049182505144096</c:v>
                </c:pt>
                <c:pt idx="247">
                  <c:v>9.6490707105272957</c:v>
                </c:pt>
                <c:pt idx="248">
                  <c:v>9.395994002667944</c:v>
                </c:pt>
                <c:pt idx="249">
                  <c:v>9.1457998784861445</c:v>
                </c:pt>
                <c:pt idx="250">
                  <c:v>8.898598816663883</c:v>
                </c:pt>
                <c:pt idx="251">
                  <c:v>8.6544999742310686</c:v>
                </c:pt>
                <c:pt idx="252">
                  <c:v>8.4136111383648551</c:v>
                </c:pt>
                <c:pt idx="253">
                  <c:v>8.1760386787938639</c:v>
                </c:pt>
                <c:pt idx="254">
                  <c:v>7.9418875008283027</c:v>
                </c:pt>
                <c:pt idx="255">
                  <c:v>7.7112609990367371</c:v>
                </c:pt>
                <c:pt idx="256">
                  <c:v>7.4842610115899593</c:v>
                </c:pt>
                <c:pt idx="257">
                  <c:v>7.2609877752921115</c:v>
                </c:pt>
                <c:pt idx="258">
                  <c:v>7.0415398813189505</c:v>
                </c:pt>
                <c:pt idx="259">
                  <c:v>6.8260142316827377</c:v>
                </c:pt>
                <c:pt idx="260">
                  <c:v>6.614505996443059</c:v>
                </c:pt>
                <c:pt idx="261">
                  <c:v>6.4071085716824019</c:v>
                </c:pt>
                <c:pt idx="262">
                  <c:v>6.2039135382650592</c:v>
                </c:pt>
                <c:pt idx="263">
                  <c:v>6.0050106213976182</c:v>
                </c:pt>
                <c:pt idx="264">
                  <c:v>5.8104876510088168</c:v>
                </c:pt>
                <c:pt idx="265">
                  <c:v>5.6204305229663394</c:v>
                </c:pt>
                <c:pt idx="266">
                  <c:v>5.4349231611475997</c:v>
                </c:pt>
                <c:pt idx="267">
                  <c:v>5.2540474803813311</c:v>
                </c:pt>
                <c:pt idx="268">
                  <c:v>5.0778833502763039</c:v>
                </c:pt>
                <c:pt idx="269">
                  <c:v>4.9065085599531493</c:v>
                </c:pt>
                <c:pt idx="270">
                  <c:v>4.739998783694876</c:v>
                </c:pt>
                <c:pt idx="271">
                  <c:v>4.5784275475312448</c:v>
                </c:pt>
                <c:pt idx="272">
                  <c:v>4.4218661967717168</c:v>
                </c:pt>
                <c:pt idx="273">
                  <c:v>4.2703838645014116</c:v>
                </c:pt>
                <c:pt idx="274">
                  <c:v>4.1240474410538575</c:v>
                </c:pt>
                <c:pt idx="275">
                  <c:v>3.9829215444741095</c:v>
                </c:pt>
                <c:pt idx="276">
                  <c:v>3.8470684919852456</c:v>
                </c:pt>
                <c:pt idx="277">
                  <c:v>3.7165482724708223</c:v>
                </c:pt>
                <c:pt idx="278">
                  <c:v>3.5914185199854831</c:v>
                </c:pt>
                <c:pt idx="279">
                  <c:v>3.4717344883053798</c:v>
                </c:pt>
                <c:pt idx="280">
                  <c:v>3.3575490265296573</c:v>
                </c:pt>
                <c:pt idx="281">
                  <c:v>3.2489125557437877</c:v>
                </c:pt>
                <c:pt idx="282">
                  <c:v>3.1458730467550247</c:v>
                </c:pt>
                <c:pt idx="283">
                  <c:v>3.0484759989098595</c:v>
                </c:pt>
                <c:pt idx="284">
                  <c:v>2.9567644200027807</c:v>
                </c:pt>
                <c:pt idx="285">
                  <c:v>2.8707788072852498</c:v>
                </c:pt>
                <c:pt idx="286">
                  <c:v>2.7905571295832452</c:v>
                </c:pt>
                <c:pt idx="287">
                  <c:v>2.7161348105313081</c:v>
                </c:pt>
                <c:pt idx="288">
                  <c:v>2.6475447129304612</c:v>
                </c:pt>
                <c:pt idx="289">
                  <c:v>2.5848171242369116</c:v>
                </c:pt>
                <c:pt idx="290">
                  <c:v>2.5279797431879754</c:v>
                </c:pt>
                <c:pt idx="291">
                  <c:v>2.4770576675710867</c:v>
                </c:pt>
                <c:pt idx="292">
                  <c:v>2.4320733831413186</c:v>
                </c:pt>
                <c:pt idx="293">
                  <c:v>2.3930467536923192</c:v>
                </c:pt>
                <c:pt idx="294">
                  <c:v>2.3599950122850082</c:v>
                </c:pt>
                <c:pt idx="295">
                  <c:v>2.3329327536379481</c:v>
                </c:pt>
                <c:pt idx="296">
                  <c:v>2.3118719276827218</c:v>
                </c:pt>
                <c:pt idx="297">
                  <c:v>2.2968218342871847</c:v>
                </c:pt>
                <c:pt idx="298">
                  <c:v>2.2877891191489024</c:v>
                </c:pt>
                <c:pt idx="299">
                  <c:v>2.2847777708606003</c:v>
                </c:pt>
              </c:numCache>
            </c:numRef>
          </c:xVal>
          <c:yVal>
            <c:numRef>
              <c:f>'Covariance   Correlation3'!yycir43</c:f>
              <c:numCache>
                <c:formatCode>General</c:formatCode>
                <c:ptCount val="300"/>
                <c:pt idx="0">
                  <c:v>1.092779493935278</c:v>
                </c:pt>
                <c:pt idx="1">
                  <c:v>1.0598478283816384</c:v>
                </c:pt>
                <c:pt idx="2">
                  <c:v>1.0267312231932824</c:v>
                </c:pt>
                <c:pt idx="3">
                  <c:v>0.99344430173079079</c:v>
                </c:pt>
                <c:pt idx="4">
                  <c:v>0.96000176256161618</c:v>
                </c:pt>
                <c:pt idx="5">
                  <c:v>0.92641837296960983</c:v>
                </c:pt>
                <c:pt idx="6">
                  <c:v>0.8927089624342045</c:v>
                </c:pt>
                <c:pt idx="7">
                  <c:v>0.85888841608213473</c:v>
                </c:pt>
                <c:pt idx="8">
                  <c:v>0.82497166811458111</c:v>
                </c:pt>
                <c:pt idx="9">
                  <c:v>0.79097369521265104</c:v>
                </c:pt>
                <c:pt idx="10">
                  <c:v>0.75690950992409634</c:v>
                </c:pt>
                <c:pt idx="11">
                  <c:v>0.72279415403419423</c:v>
                </c:pt>
                <c:pt idx="12">
                  <c:v>0.68864269192371941</c:v>
                </c:pt>
                <c:pt idx="13">
                  <c:v>0.65447020391693689</c:v>
                </c:pt>
                <c:pt idx="14">
                  <c:v>0.62029177962255577</c:v>
                </c:pt>
                <c:pt idx="15">
                  <c:v>0.58612251127058235</c:v>
                </c:pt>
                <c:pt idx="16">
                  <c:v>0.55197748704801664</c:v>
                </c:pt>
                <c:pt idx="17">
                  <c:v>0.51787178443633408</c:v>
                </c:pt>
                <c:pt idx="18">
                  <c:v>0.48382046355369274</c:v>
                </c:pt>
                <c:pt idx="19">
                  <c:v>0.44983856050481108</c:v>
                </c:pt>
                <c:pt idx="20">
                  <c:v>0.41594108074144542</c:v>
                </c:pt>
                <c:pt idx="21">
                  <c:v>0.38214299243640654</c:v>
                </c:pt>
                <c:pt idx="22">
                  <c:v>0.34845921987403478</c:v>
                </c:pt>
                <c:pt idx="23">
                  <c:v>0.31490463686005771</c:v>
                </c:pt>
                <c:pt idx="24">
                  <c:v>0.28149406015373268</c:v>
                </c:pt>
                <c:pt idx="25">
                  <c:v>0.24824224292518771</c:v>
                </c:pt>
                <c:pt idx="26">
                  <c:v>0.21516386824083411</c:v>
                </c:pt>
                <c:pt idx="27">
                  <c:v>0.18227354257973838</c:v>
                </c:pt>
                <c:pt idx="28">
                  <c:v>0.14958578938381173</c:v>
                </c:pt>
                <c:pt idx="29">
                  <c:v>0.11711504264466804</c:v>
                </c:pt>
                <c:pt idx="30">
                  <c:v>8.4875640529978091E-2</c:v>
                </c:pt>
                <c:pt idx="31">
                  <c:v>5.2881819052139623E-2</c:v>
                </c:pt>
                <c:pt idx="32">
                  <c:v>2.114770578205466E-2</c:v>
                </c:pt>
                <c:pt idx="33">
                  <c:v>-1.0312686389208681E-2</c:v>
                </c:pt>
                <c:pt idx="34">
                  <c:v>-4.1485465438113267E-2</c:v>
                </c:pt>
                <c:pt idx="35">
                  <c:v>-7.2356866342981385E-2</c:v>
                </c:pt>
                <c:pt idx="36">
                  <c:v>-0.10291325716223887</c:v>
                </c:pt>
                <c:pt idx="37">
                  <c:v>-0.13314114505389713</c:v>
                </c:pt>
                <c:pt idx="38">
                  <c:v>-0.16302718223361301</c:v>
                </c:pt>
                <c:pt idx="39">
                  <c:v>-0.19255817186869401</c:v>
                </c:pt>
                <c:pt idx="40">
                  <c:v>-0.22172107390544904</c:v>
                </c:pt>
                <c:pt idx="41">
                  <c:v>-0.25050301082730753</c:v>
                </c:pt>
                <c:pt idx="42">
                  <c:v>-0.2788912733411697</c:v>
                </c:pt>
                <c:pt idx="43">
                  <c:v>-0.3068733259894712</c:v>
                </c:pt>
                <c:pt idx="44">
                  <c:v>-0.33443681268548958</c:v>
                </c:pt>
                <c:pt idx="45">
                  <c:v>-0.36156956216944391</c:v>
                </c:pt>
                <c:pt idx="46">
                  <c:v>-0.38825959338298011</c:v>
                </c:pt>
                <c:pt idx="47">
                  <c:v>-0.41449512075966921</c:v>
                </c:pt>
                <c:pt idx="48">
                  <c:v>-0.44026455942918197</c:v>
                </c:pt>
                <c:pt idx="49">
                  <c:v>-0.46555653033284117</c:v>
                </c:pt>
                <c:pt idx="50">
                  <c:v>-0.49035986524829389</c:v>
                </c:pt>
                <c:pt idx="51">
                  <c:v>-0.51466361172108388</c:v>
                </c:pt>
                <c:pt idx="52">
                  <c:v>-0.53845703790094712</c:v>
                </c:pt>
                <c:pt idx="53">
                  <c:v>-0.56172963728069458</c:v>
                </c:pt>
                <c:pt idx="54">
                  <c:v>-0.58447113333559042</c:v>
                </c:pt>
                <c:pt idx="55">
                  <c:v>-0.60667148406117699</c:v>
                </c:pt>
                <c:pt idx="56">
                  <c:v>-0.62832088640753869</c:v>
                </c:pt>
                <c:pt idx="57">
                  <c:v>-0.64940978060805488</c:v>
                </c:pt>
                <c:pt idx="58">
                  <c:v>-0.66992885440072314</c:v>
                </c:pt>
                <c:pt idx="59">
                  <c:v>-0.68986904714019248</c:v>
                </c:pt>
                <c:pt idx="60">
                  <c:v>-0.70922155379868812</c:v>
                </c:pt>
                <c:pt idx="61">
                  <c:v>-0.72797782885406503</c:v>
                </c:pt>
                <c:pt idx="62">
                  <c:v>-0.74612959006326962</c:v>
                </c:pt>
                <c:pt idx="63">
                  <c:v>-0.76366882211954468</c:v>
                </c:pt>
                <c:pt idx="64">
                  <c:v>-0.780587780191764</c:v>
                </c:pt>
                <c:pt idx="65">
                  <c:v>-0.79687899334433077</c:v>
                </c:pt>
                <c:pt idx="66">
                  <c:v>-0.81253526783613284</c:v>
                </c:pt>
                <c:pt idx="67">
                  <c:v>-0.82754969029709757</c:v>
                </c:pt>
                <c:pt idx="68">
                  <c:v>-0.84191563078093834</c:v>
                </c:pt>
                <c:pt idx="69">
                  <c:v>-0.8556267456927561</c:v>
                </c:pt>
                <c:pt idx="70">
                  <c:v>-0.86867698059018916</c:v>
                </c:pt>
                <c:pt idx="71">
                  <c:v>-0.88106057285688599</c:v>
                </c:pt>
                <c:pt idx="72">
                  <c:v>-0.89277205424711403</c:v>
                </c:pt>
                <c:pt idx="73">
                  <c:v>-0.90380625330038278</c:v>
                </c:pt>
                <c:pt idx="74">
                  <c:v>-0.91415829762501566</c:v>
                </c:pt>
                <c:pt idx="75">
                  <c:v>-0.9238236160496609</c:v>
                </c:pt>
                <c:pt idx="76">
                  <c:v>-0.93279794064179244</c:v>
                </c:pt>
                <c:pt idx="77">
                  <c:v>-0.9410773085923072</c:v>
                </c:pt>
                <c:pt idx="78">
                  <c:v>-0.94865806396539287</c:v>
                </c:pt>
                <c:pt idx="79">
                  <c:v>-0.95553685931288279</c:v>
                </c:pt>
                <c:pt idx="80">
                  <c:v>-0.9617106571523979</c:v>
                </c:pt>
                <c:pt idx="81">
                  <c:v>-0.96717673130861181</c:v>
                </c:pt>
                <c:pt idx="82">
                  <c:v>-0.97193266811705314</c:v>
                </c:pt>
                <c:pt idx="83">
                  <c:v>-0.97597636748991268</c:v>
                </c:pt>
                <c:pt idx="84">
                  <c:v>-0.97930604384338216</c:v>
                </c:pt>
                <c:pt idx="85">
                  <c:v>-0.9819202268861178</c:v>
                </c:pt>
                <c:pt idx="86">
                  <c:v>-0.9838177622684805</c:v>
                </c:pt>
                <c:pt idx="87">
                  <c:v>-0.98499781209226311</c:v>
                </c:pt>
                <c:pt idx="88">
                  <c:v>-0.98545985528068292</c:v>
                </c:pt>
                <c:pt idx="89">
                  <c:v>-0.98520368780847523</c:v>
                </c:pt>
                <c:pt idx="90">
                  <c:v>-0.98422942279198455</c:v>
                </c:pt>
                <c:pt idx="91">
                  <c:v>-0.98253749043921512</c:v>
                </c:pt>
                <c:pt idx="92">
                  <c:v>-0.98012863785986448</c:v>
                </c:pt>
                <c:pt idx="93">
                  <c:v>-0.9770039287354193</c:v>
                </c:pt>
                <c:pt idx="94">
                  <c:v>-0.97316474284946486</c:v>
                </c:pt>
                <c:pt idx="95">
                  <c:v>-0.96861277547841096</c:v>
                </c:pt>
                <c:pt idx="96">
                  <c:v>-0.96335003664290575</c:v>
                </c:pt>
                <c:pt idx="97">
                  <c:v>-0.95737885022026648</c:v>
                </c:pt>
                <c:pt idx="98">
                  <c:v>-0.95070185291832199</c:v>
                </c:pt>
                <c:pt idx="99">
                  <c:v>-0.94332199311111542</c:v>
                </c:pt>
                <c:pt idx="100">
                  <c:v>-0.93524252953698617</c:v>
                </c:pt>
                <c:pt idx="101">
                  <c:v>-0.9264670298596025</c:v>
                </c:pt>
                <c:pt idx="102">
                  <c:v>-0.91699936909258128</c:v>
                </c:pt>
                <c:pt idx="103">
                  <c:v>-0.90684372788839207</c:v>
                </c:pt>
                <c:pt idx="104">
                  <c:v>-0.89600459069229732</c:v>
                </c:pt>
                <c:pt idx="105">
                  <c:v>-0.88448674376214864</c:v>
                </c:pt>
                <c:pt idx="106">
                  <c:v>-0.87229527305491028</c:v>
                </c:pt>
                <c:pt idx="107">
                  <c:v>-0.85943556198084248</c:v>
                </c:pt>
                <c:pt idx="108">
                  <c:v>-0.84591328902633944</c:v>
                </c:pt>
                <c:pt idx="109">
                  <c:v>-0.83173442524647034</c:v>
                </c:pt>
                <c:pt idx="110">
                  <c:v>-0.81690523162832962</c:v>
                </c:pt>
                <c:pt idx="111">
                  <c:v>-0.80143225632635995</c:v>
                </c:pt>
                <c:pt idx="112">
                  <c:v>-0.78532233177087274</c:v>
                </c:pt>
                <c:pt idx="113">
                  <c:v>-0.76858257165103838</c:v>
                </c:pt>
                <c:pt idx="114">
                  <c:v>-0.75122036777368273</c:v>
                </c:pt>
                <c:pt idx="115">
                  <c:v>-0.73324338679927203</c:v>
                </c:pt>
                <c:pt idx="116">
                  <c:v>-0.71465956685653187</c:v>
                </c:pt>
                <c:pt idx="117">
                  <c:v>-0.69547711403719292</c:v>
                </c:pt>
                <c:pt idx="118">
                  <c:v>-0.67570449877241223</c:v>
                </c:pt>
                <c:pt idx="119">
                  <c:v>-0.65535045209246889</c:v>
                </c:pt>
                <c:pt idx="120">
                  <c:v>-0.63442396177138694</c:v>
                </c:pt>
                <c:pt idx="121">
                  <c:v>-0.61293426835818798</c:v>
                </c:pt>
                <c:pt idx="122">
                  <c:v>-0.59089086109652256</c:v>
                </c:pt>
                <c:pt idx="123">
                  <c:v>-0.56830347373449097</c:v>
                </c:pt>
                <c:pt idx="124">
                  <c:v>-0.54518208022649106</c:v>
                </c:pt>
                <c:pt idx="125">
                  <c:v>-0.52153689032900241</c:v>
                </c:pt>
                <c:pt idx="126">
                  <c:v>-0.49737834509224438</c:v>
                </c:pt>
                <c:pt idx="127">
                  <c:v>-0.47271711224970264</c:v>
                </c:pt>
                <c:pt idx="128">
                  <c:v>-0.44756408150755866</c:v>
                </c:pt>
                <c:pt idx="129">
                  <c:v>-0.42193035973610127</c:v>
                </c:pt>
                <c:pt idx="130">
                  <c:v>-0.39582726606524599</c:v>
                </c:pt>
                <c:pt idx="131">
                  <c:v>-0.36926632688632588</c:v>
                </c:pt>
                <c:pt idx="132">
                  <c:v>-0.34225927076236135</c:v>
                </c:pt>
                <c:pt idx="133">
                  <c:v>-0.31481802324905706</c:v>
                </c:pt>
                <c:pt idx="134">
                  <c:v>-0.28695470162881237</c:v>
                </c:pt>
                <c:pt idx="135">
                  <c:v>-0.25868160956007014</c:v>
                </c:pt>
                <c:pt idx="136">
                  <c:v>-0.23001123164436849</c:v>
                </c:pt>
                <c:pt idx="137">
                  <c:v>-0.20095622791348983</c:v>
                </c:pt>
                <c:pt idx="138">
                  <c:v>-0.17152942823915046</c:v>
                </c:pt>
                <c:pt idx="139">
                  <c:v>-0.14174382666768837</c:v>
                </c:pt>
                <c:pt idx="140">
                  <c:v>-0.11161257568225863</c:v>
                </c:pt>
                <c:pt idx="141">
                  <c:v>-8.1148980395067072E-2</c:v>
                </c:pt>
                <c:pt idx="142">
                  <c:v>-5.036649267220733E-2</c:v>
                </c:pt>
                <c:pt idx="143">
                  <c:v>-1.9278705193695345E-2</c:v>
                </c:pt>
                <c:pt idx="144">
                  <c:v>1.210065454867526E-2</c:v>
                </c:pt>
                <c:pt idx="145">
                  <c:v>4.3757730313007281E-2</c:v>
                </c:pt>
                <c:pt idx="146">
                  <c:v>7.5678543225826234E-2</c:v>
                </c:pt>
                <c:pt idx="147">
                  <c:v>0.10784899795475744</c:v>
                </c:pt>
                <c:pt idx="148">
                  <c:v>0.14025488893262783</c:v>
                </c:pt>
                <c:pt idx="149">
                  <c:v>0.17288190663024461</c:v>
                </c:pt>
                <c:pt idx="150">
                  <c:v>0.20571564387507985</c:v>
                </c:pt>
                <c:pt idx="151">
                  <c:v>0.23874160221307517</c:v>
                </c:pt>
                <c:pt idx="152">
                  <c:v>0.27194519831074632</c:v>
                </c:pt>
                <c:pt idx="153">
                  <c:v>0.30531177039477603</c:v>
                </c:pt>
                <c:pt idx="154">
                  <c:v>0.33882658472623933</c:v>
                </c:pt>
                <c:pt idx="155">
                  <c:v>0.37247484210660814</c:v>
                </c:pt>
                <c:pt idx="156">
                  <c:v>0.40624168441266012</c:v>
                </c:pt>
                <c:pt idx="157">
                  <c:v>0.4401122011574084</c:v>
                </c:pt>
                <c:pt idx="158">
                  <c:v>0.47407143607415253</c:v>
                </c:pt>
                <c:pt idx="159">
                  <c:v>0.50810439372074478</c:v>
                </c:pt>
                <c:pt idx="160">
                  <c:v>0.54219604610115535</c:v>
                </c:pt>
                <c:pt idx="161">
                  <c:v>0.576331339301412</c:v>
                </c:pt>
                <c:pt idx="162">
                  <c:v>0.61049520013698544</c:v>
                </c:pt>
                <c:pt idx="163">
                  <c:v>0.64467254280868258</c:v>
                </c:pt>
                <c:pt idx="164">
                  <c:v>0.67884827556410998</c:v>
                </c:pt>
                <c:pt idx="165">
                  <c:v>0.71300730736177087</c:v>
                </c:pt>
                <c:pt idx="166">
                  <c:v>0.74713455453483857</c:v>
                </c:pt>
                <c:pt idx="167">
                  <c:v>0.78121494745168263</c:v>
                </c:pt>
                <c:pt idx="168">
                  <c:v>0.81523343717019325</c:v>
                </c:pt>
                <c:pt idx="169">
                  <c:v>0.84917500208297025</c:v>
                </c:pt>
                <c:pt idx="170">
                  <c:v>0.88302465455044232</c:v>
                </c:pt>
                <c:pt idx="171">
                  <c:v>0.9167674475189862</c:v>
                </c:pt>
                <c:pt idx="172">
                  <c:v>0.95038848112112562</c:v>
                </c:pt>
                <c:pt idx="173">
                  <c:v>0.98387290925489257</c:v>
                </c:pt>
                <c:pt idx="174">
                  <c:v>1.0172059461394478</c:v>
                </c:pt>
                <c:pt idx="175">
                  <c:v>1.0503728728440671</c:v>
                </c:pt>
                <c:pt idx="176">
                  <c:v>1.0833590437876044</c:v>
                </c:pt>
                <c:pt idx="177">
                  <c:v>1.11614989320557</c:v>
                </c:pt>
                <c:pt idx="178">
                  <c:v>1.1487309415819595</c:v>
                </c:pt>
                <c:pt idx="179">
                  <c:v>1.1810878020430062</c:v>
                </c:pt>
                <c:pt idx="180">
                  <c:v>1.2132061867100126</c:v>
                </c:pt>
                <c:pt idx="181">
                  <c:v>1.2450719130084782</c:v>
                </c:pt>
                <c:pt idx="182">
                  <c:v>1.2766709099307274</c:v>
                </c:pt>
                <c:pt idx="183">
                  <c:v>1.3079892242492663</c:v>
                </c:pt>
                <c:pt idx="184">
                  <c:v>1.3390130266781399</c:v>
                </c:pt>
                <c:pt idx="185">
                  <c:v>1.36972861797955</c:v>
                </c:pt>
                <c:pt idx="186">
                  <c:v>1.4001224350130577</c:v>
                </c:pt>
                <c:pt idx="187">
                  <c:v>1.4301810567246813</c:v>
                </c:pt>
                <c:pt idx="188">
                  <c:v>1.4598912100732586</c:v>
                </c:pt>
                <c:pt idx="189">
                  <c:v>1.4892397758914453</c:v>
                </c:pt>
                <c:pt idx="190">
                  <c:v>1.5182137946787717</c:v>
                </c:pt>
                <c:pt idx="191">
                  <c:v>1.5468004723241933</c:v>
                </c:pt>
                <c:pt idx="192">
                  <c:v>1.5749871857556101</c:v>
                </c:pt>
                <c:pt idx="193">
                  <c:v>1.602761488513859</c:v>
                </c:pt>
                <c:pt idx="194">
                  <c:v>1.6301111162487205</c:v>
                </c:pt>
                <c:pt idx="195">
                  <c:v>1.6570239921345102</c:v>
                </c:pt>
                <c:pt idx="196">
                  <c:v>1.6834882322028657</c:v>
                </c:pt>
                <c:pt idx="197">
                  <c:v>1.7094921505903711</c:v>
                </c:pt>
                <c:pt idx="198">
                  <c:v>1.7350242646987071</c:v>
                </c:pt>
                <c:pt idx="199">
                  <c:v>1.7600733002650415</c:v>
                </c:pt>
                <c:pt idx="200">
                  <c:v>1.7846281963404267</c:v>
                </c:pt>
                <c:pt idx="201">
                  <c:v>1.8086781101740059</c:v>
                </c:pt>
                <c:pt idx="202">
                  <c:v>1.8322124220008613</c:v>
                </c:pt>
                <c:pt idx="203">
                  <c:v>1.8552207397314096</c:v>
                </c:pt>
                <c:pt idx="204">
                  <c:v>1.8776929035402505</c:v>
                </c:pt>
                <c:pt idx="205">
                  <c:v>1.8996189903524632</c:v>
                </c:pt>
                <c:pt idx="206">
                  <c:v>1.9209893182253566</c:v>
                </c:pt>
                <c:pt idx="207">
                  <c:v>1.9417944506237403</c:v>
                </c:pt>
                <c:pt idx="208">
                  <c:v>1.9620252005868375</c:v>
                </c:pt>
                <c:pt idx="209">
                  <c:v>1.9816726347849811</c:v>
                </c:pt>
                <c:pt idx="210">
                  <c:v>2.0007280774643283</c:v>
                </c:pt>
                <c:pt idx="211">
                  <c:v>2.0191831142778245</c:v>
                </c:pt>
                <c:pt idx="212">
                  <c:v>2.037029596000743</c:v>
                </c:pt>
                <c:pt idx="213">
                  <c:v>2.0542596421291544</c:v>
                </c:pt>
                <c:pt idx="214">
                  <c:v>2.0708656443597322</c:v>
                </c:pt>
                <c:pt idx="215">
                  <c:v>2.0868402699493722</c:v>
                </c:pt>
                <c:pt idx="216">
                  <c:v>2.1021764649531165</c:v>
                </c:pt>
                <c:pt idx="217">
                  <c:v>2.1168674573389832</c:v>
                </c:pt>
                <c:pt idx="218">
                  <c:v>2.1309067599783029</c:v>
                </c:pt>
                <c:pt idx="219">
                  <c:v>2.1442881735102528</c:v>
                </c:pt>
                <c:pt idx="220">
                  <c:v>2.1570057890793195</c:v>
                </c:pt>
                <c:pt idx="221">
                  <c:v>2.1690539909444824</c:v>
                </c:pt>
                <c:pt idx="222">
                  <c:v>2.1804274589589698</c:v>
                </c:pt>
                <c:pt idx="223">
                  <c:v>2.1911211709194811</c:v>
                </c:pt>
                <c:pt idx="224">
                  <c:v>2.2011304047838567</c:v>
                </c:pt>
                <c:pt idx="225">
                  <c:v>2.2104507407561917</c:v>
                </c:pt>
                <c:pt idx="226">
                  <c:v>2.2190780632385003</c:v>
                </c:pt>
                <c:pt idx="227">
                  <c:v>2.2270085626480425</c:v>
                </c:pt>
                <c:pt idx="228">
                  <c:v>2.234238737099532</c:v>
                </c:pt>
                <c:pt idx="229">
                  <c:v>2.2407653939514689</c:v>
                </c:pt>
                <c:pt idx="230">
                  <c:v>2.2465856512159204</c:v>
                </c:pt>
                <c:pt idx="231">
                  <c:v>2.2516969388311243</c:v>
                </c:pt>
                <c:pt idx="232">
                  <c:v>2.2560969997963598</c:v>
                </c:pt>
                <c:pt idx="233">
                  <c:v>2.259783891168571</c:v>
                </c:pt>
                <c:pt idx="234">
                  <c:v>2.2627559849203176</c:v>
                </c:pt>
                <c:pt idx="235">
                  <c:v>2.2650119686586674</c:v>
                </c:pt>
                <c:pt idx="236">
                  <c:v>2.266550846204709</c:v>
                </c:pt>
                <c:pt idx="237">
                  <c:v>2.2673719380334405</c:v>
                </c:pt>
                <c:pt idx="238">
                  <c:v>2.2674748815738246</c:v>
                </c:pt>
                <c:pt idx="239">
                  <c:v>2.2668596313688916</c:v>
                </c:pt>
                <c:pt idx="240">
                  <c:v>2.2655264590958124</c:v>
                </c:pt>
                <c:pt idx="241">
                  <c:v>2.2634759534459326</c:v>
                </c:pt>
                <c:pt idx="242">
                  <c:v>2.2607090198648221</c:v>
                </c:pt>
                <c:pt idx="243">
                  <c:v>2.2572268801524582</c:v>
                </c:pt>
                <c:pt idx="244">
                  <c:v>2.2530310719237123</c:v>
                </c:pt>
                <c:pt idx="245">
                  <c:v>2.2481234479293817</c:v>
                </c:pt>
                <c:pt idx="246">
                  <c:v>2.2425061752380655</c:v>
                </c:pt>
                <c:pt idx="247">
                  <c:v>2.2361817342792532</c:v>
                </c:pt>
                <c:pt idx="248">
                  <c:v>2.2291529177480309</c:v>
                </c:pt>
                <c:pt idx="249">
                  <c:v>2.2214228293719098</c:v>
                </c:pt>
                <c:pt idx="250">
                  <c:v>2.2129948825403059</c:v>
                </c:pt>
                <c:pt idx="251">
                  <c:v>2.2038727987972839</c:v>
                </c:pt>
                <c:pt idx="252">
                  <c:v>2.1940606061982266</c:v>
                </c:pt>
                <c:pt idx="253">
                  <c:v>2.1835626375311628</c:v>
                </c:pt>
                <c:pt idx="254">
                  <c:v>2.1723835284035249</c:v>
                </c:pt>
                <c:pt idx="255">
                  <c:v>2.1605282151951992</c:v>
                </c:pt>
                <c:pt idx="256">
                  <c:v>2.1480019328787581</c:v>
                </c:pt>
                <c:pt idx="257">
                  <c:v>2.1348102127078428</c:v>
                </c:pt>
                <c:pt idx="258">
                  <c:v>2.1209588797747188</c:v>
                </c:pt>
                <c:pt idx="259">
                  <c:v>2.1064540504380789</c:v>
                </c:pt>
                <c:pt idx="260">
                  <c:v>2.0913021296222296</c:v>
                </c:pt>
                <c:pt idx="261">
                  <c:v>2.0755098079888601</c:v>
                </c:pt>
                <c:pt idx="262">
                  <c:v>2.0590840589826311</c:v>
                </c:pt>
                <c:pt idx="263">
                  <c:v>2.0420321357519007</c:v>
                </c:pt>
                <c:pt idx="264">
                  <c:v>2.0243615679459359</c:v>
                </c:pt>
                <c:pt idx="265">
                  <c:v>2.006080158390033</c:v>
                </c:pt>
                <c:pt idx="266">
                  <c:v>1.9871959796400096</c:v>
                </c:pt>
                <c:pt idx="267">
                  <c:v>1.9677173704175894</c:v>
                </c:pt>
                <c:pt idx="268">
                  <c:v>1.9476529319282614</c:v>
                </c:pt>
                <c:pt idx="269">
                  <c:v>1.9270115240632242</c:v>
                </c:pt>
                <c:pt idx="270">
                  <c:v>1.9058022614871117</c:v>
                </c:pt>
                <c:pt idx="271">
                  <c:v>1.8840345096132136</c:v>
                </c:pt>
                <c:pt idx="272">
                  <c:v>1.8617178804679686</c:v>
                </c:pt>
                <c:pt idx="273">
                  <c:v>1.8388622284465694</c:v>
                </c:pt>
                <c:pt idx="274">
                  <c:v>1.8154776459615354</c:v>
                </c:pt>
                <c:pt idx="275">
                  <c:v>1.7915744589861895</c:v>
                </c:pt>
                <c:pt idx="276">
                  <c:v>1.7671632224949974</c:v>
                </c:pt>
                <c:pt idx="277">
                  <c:v>1.7422547158027895</c:v>
                </c:pt>
                <c:pt idx="278">
                  <c:v>1.7168599378049181</c:v>
                </c:pt>
                <c:pt idx="279">
                  <c:v>1.6909901021204548</c:v>
                </c:pt>
                <c:pt idx="280">
                  <c:v>1.664656632140572</c:v>
                </c:pt>
                <c:pt idx="281">
                  <c:v>1.6378711559842958</c:v>
                </c:pt>
                <c:pt idx="282">
                  <c:v>1.6106455013638548</c:v>
                </c:pt>
                <c:pt idx="283">
                  <c:v>1.5829916903618957</c:v>
                </c:pt>
                <c:pt idx="284">
                  <c:v>1.5549219341228704</c:v>
                </c:pt>
                <c:pt idx="285">
                  <c:v>1.5264486274609381</c:v>
                </c:pt>
                <c:pt idx="286">
                  <c:v>1.497584343386765</c:v>
                </c:pt>
                <c:pt idx="287">
                  <c:v>1.468341827555635</c:v>
                </c:pt>
                <c:pt idx="288">
                  <c:v>1.438733992639329</c:v>
                </c:pt>
                <c:pt idx="289">
                  <c:v>1.4087739126242509</c:v>
                </c:pt>
                <c:pt idx="290">
                  <c:v>1.3784748170383252</c:v>
                </c:pt>
                <c:pt idx="291">
                  <c:v>1.3478500851092081</c:v>
                </c:pt>
                <c:pt idx="292">
                  <c:v>1.3169132398563983</c:v>
                </c:pt>
                <c:pt idx="293">
                  <c:v>1.2856779421198514</c:v>
                </c:pt>
                <c:pt idx="294">
                  <c:v>1.2541579845277386</c:v>
                </c:pt>
                <c:pt idx="295">
                  <c:v>1.2223672854060093</c:v>
                </c:pt>
                <c:pt idx="296">
                  <c:v>1.190319882632451</c:v>
                </c:pt>
                <c:pt idx="297">
                  <c:v>1.1580299274379575</c:v>
                </c:pt>
                <c:pt idx="298">
                  <c:v>1.1255116781577434</c:v>
                </c:pt>
                <c:pt idx="299">
                  <c:v>1.092779493935265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386016"/>
        <c:axId val="283386408"/>
      </c:scatterChart>
      <c:valAx>
        <c:axId val="283386016"/>
        <c:scaling>
          <c:orientation val="minMax"/>
          <c:max val="3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386408"/>
        <c:crosses val="autoZero"/>
        <c:crossBetween val="midCat"/>
      </c:valAx>
      <c:valAx>
        <c:axId val="283386408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386016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338582677165359"/>
          <c:y val="0.10679611650485436"/>
          <c:w val="0.60549845331833529"/>
          <c:h val="0.7039966363427872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003CE6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003CE6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BR$1:$BR$15</c:f>
              <c:numCache>
                <c:formatCode>General</c:formatCode>
                <c:ptCount val="15"/>
                <c:pt idx="0">
                  <c:v>138.99886778491901</c:v>
                </c:pt>
                <c:pt idx="1">
                  <c:v>162.91424412457732</c:v>
                </c:pt>
                <c:pt idx="2">
                  <c:v>161.81378103847999</c:v>
                </c:pt>
                <c:pt idx="3">
                  <c:v>71.559135701775006</c:v>
                </c:pt>
                <c:pt idx="4">
                  <c:v>46.166237429095098</c:v>
                </c:pt>
                <c:pt idx="5">
                  <c:v>69.021716759589793</c:v>
                </c:pt>
                <c:pt idx="6">
                  <c:v>89.470748764987405</c:v>
                </c:pt>
                <c:pt idx="7">
                  <c:v>148.91475822535801</c:v>
                </c:pt>
                <c:pt idx="8">
                  <c:v>155.77808522817401</c:v>
                </c:pt>
                <c:pt idx="9">
                  <c:v>200.41766017548801</c:v>
                </c:pt>
                <c:pt idx="10">
                  <c:v>362.51397650410098</c:v>
                </c:pt>
                <c:pt idx="11">
                  <c:v>376.12746722204901</c:v>
                </c:pt>
                <c:pt idx="12">
                  <c:v>172.90809699088169</c:v>
                </c:pt>
                <c:pt idx="13">
                  <c:v>316.49362074445901</c:v>
                </c:pt>
                <c:pt idx="14">
                  <c:v>206.08254805910366</c:v>
                </c:pt>
              </c:numCache>
            </c:numRef>
          </c:xVal>
          <c:yVal>
            <c:numRef>
              <c:f>'Covariance   Correlation3_HID4'!$BS$1:$BS$15</c:f>
              <c:numCache>
                <c:formatCode>General</c:formatCode>
                <c:ptCount val="15"/>
                <c:pt idx="0">
                  <c:v>9.1300000000000006E-2</c:v>
                </c:pt>
                <c:pt idx="1">
                  <c:v>0.44719999999999999</c:v>
                </c:pt>
                <c:pt idx="2">
                  <c:v>0.40560000000000002</c:v>
                </c:pt>
                <c:pt idx="3">
                  <c:v>0.29530000000000001</c:v>
                </c:pt>
                <c:pt idx="4">
                  <c:v>0.10879999999999999</c:v>
                </c:pt>
                <c:pt idx="5">
                  <c:v>1.6014999999999999</c:v>
                </c:pt>
                <c:pt idx="6">
                  <c:v>1.0639000000000001</c:v>
                </c:pt>
                <c:pt idx="7">
                  <c:v>1.5142</c:v>
                </c:pt>
                <c:pt idx="8">
                  <c:v>1.4415</c:v>
                </c:pt>
                <c:pt idx="9">
                  <c:v>1.0116000000000001</c:v>
                </c:pt>
                <c:pt idx="10">
                  <c:v>0.59709999999999996</c:v>
                </c:pt>
                <c:pt idx="11">
                  <c:v>0.1628</c:v>
                </c:pt>
                <c:pt idx="12">
                  <c:v>0.2384</c:v>
                </c:pt>
                <c:pt idx="13">
                  <c:v>2.1299999999999999E-2</c:v>
                </c:pt>
                <c:pt idx="14">
                  <c:v>0.614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44</c:f>
              <c:numCache>
                <c:formatCode>General</c:formatCode>
                <c:ptCount val="300"/>
                <c:pt idx="0">
                  <c:v>-123.56687113635698</c:v>
                </c:pt>
                <c:pt idx="1">
                  <c:v>-123.50015428104538</c:v>
                </c:pt>
                <c:pt idx="2">
                  <c:v>-123.30003317539578</c:v>
                </c:pt>
                <c:pt idx="3">
                  <c:v>-122.96659618725485</c:v>
                </c:pt>
                <c:pt idx="4">
                  <c:v>-122.49999055300984</c:v>
                </c:pt>
                <c:pt idx="5">
                  <c:v>-121.90042231257334</c:v>
                </c:pt>
                <c:pt idx="6">
                  <c:v>-121.16815621840189</c:v>
                </c:pt>
                <c:pt idx="7">
                  <c:v>-120.30351561858848</c:v>
                </c:pt>
                <c:pt idx="8">
                  <c:v>-119.30688231408132</c:v>
                </c:pt>
                <c:pt idx="9">
                  <c:v>-118.1786963900914</c:v>
                </c:pt>
                <c:pt idx="10">
                  <c:v>-116.91945602176295</c:v>
                </c:pt>
                <c:pt idx="11">
                  <c:v>-115.52971725419357</c:v>
                </c:pt>
                <c:pt idx="12">
                  <c:v>-114.01009375690032</c:v>
                </c:pt>
                <c:pt idx="13">
                  <c:v>-112.36125655284044</c:v>
                </c:pt>
                <c:pt idx="14">
                  <c:v>-110.58393372210654</c:v>
                </c:pt>
                <c:pt idx="15">
                  <c:v>-108.67891008042702</c:v>
                </c:pt>
                <c:pt idx="16">
                  <c:v>-106.64702683261348</c:v>
                </c:pt>
                <c:pt idx="17">
                  <c:v>-104.48918120110827</c:v>
                </c:pt>
                <c:pt idx="18">
                  <c:v>-102.20632602979637</c:v>
                </c:pt>
                <c:pt idx="19">
                  <c:v>-99.79946936325652</c:v>
                </c:pt>
                <c:pt idx="20">
                  <c:v>-97.269674001636901</c:v>
                </c:pt>
                <c:pt idx="21">
                  <c:v>-94.618057031352492</c:v>
                </c:pt>
                <c:pt idx="22">
                  <c:v>-91.845789331811289</c:v>
                </c:pt>
                <c:pt idx="23">
                  <c:v>-88.954095058387026</c:v>
                </c:pt>
                <c:pt idx="24">
                  <c:v>-85.944251101866229</c:v>
                </c:pt>
                <c:pt idx="25">
                  <c:v>-82.817586524609482</c:v>
                </c:pt>
                <c:pt idx="26">
                  <c:v>-79.575481973674954</c:v>
                </c:pt>
                <c:pt idx="27">
                  <c:v>-76.219369071163385</c:v>
                </c:pt>
                <c:pt idx="28">
                  <c:v>-72.750729782054037</c:v>
                </c:pt>
                <c:pt idx="29">
                  <c:v>-69.171095759810896</c:v>
                </c:pt>
                <c:pt idx="30">
                  <c:v>-65.48204767004728</c:v>
                </c:pt>
                <c:pt idx="31">
                  <c:v>-61.68521449254871</c:v>
                </c:pt>
                <c:pt idx="32">
                  <c:v>-57.782272801961199</c:v>
                </c:pt>
                <c:pt idx="33">
                  <c:v>-53.77494602746296</c:v>
                </c:pt>
                <c:pt idx="34">
                  <c:v>-49.665003691746875</c:v>
                </c:pt>
                <c:pt idx="35">
                  <c:v>-45.454260629648616</c:v>
                </c:pt>
                <c:pt idx="36">
                  <c:v>-41.144576186767267</c:v>
                </c:pt>
                <c:pt idx="37">
                  <c:v>-36.737853398430161</c:v>
                </c:pt>
                <c:pt idx="38">
                  <c:v>-32.236038149366379</c:v>
                </c:pt>
                <c:pt idx="39">
                  <c:v>-27.641118314458623</c:v>
                </c:pt>
                <c:pt idx="40">
                  <c:v>-22.955122880953724</c:v>
                </c:pt>
                <c:pt idx="41">
                  <c:v>-18.180121052518928</c:v>
                </c:pt>
                <c:pt idx="42">
                  <c:v>-13.318221335539931</c:v>
                </c:pt>
                <c:pt idx="43">
                  <c:v>-8.3715706080636494</c:v>
                </c:pt>
                <c:pt idx="44">
                  <c:v>-3.3423531717974129</c:v>
                </c:pt>
                <c:pt idx="45">
                  <c:v>1.7672102124170692</c:v>
                </c:pt>
                <c:pt idx="46">
                  <c:v>6.9548633052295088</c:v>
                </c:pt>
                <c:pt idx="47">
                  <c:v>12.218315385072486</c:v>
                </c:pt>
                <c:pt idx="48">
                  <c:v>17.555242259679773</c:v>
                </c:pt>
                <c:pt idx="49">
                  <c:v>22.963287292384166</c:v>
                </c:pt>
                <c:pt idx="50">
                  <c:v>28.440062442741834</c:v>
                </c:pt>
                <c:pt idx="51">
                  <c:v>33.983149321024001</c:v>
                </c:pt>
                <c:pt idx="52">
                  <c:v>39.590100256109423</c:v>
                </c:pt>
                <c:pt idx="53">
                  <c:v>45.258439376307308</c:v>
                </c:pt>
                <c:pt idx="54">
                  <c:v>50.985663702632266</c:v>
                </c:pt>
                <c:pt idx="55">
                  <c:v>56.769244254050008</c:v>
                </c:pt>
                <c:pt idx="56">
                  <c:v>62.60662716420336</c:v>
                </c:pt>
                <c:pt idx="57">
                  <c:v>68.495234809128235</c:v>
                </c:pt>
                <c:pt idx="58">
                  <c:v>74.432466945459666</c:v>
                </c:pt>
                <c:pt idx="59">
                  <c:v>80.415701858626193</c:v>
                </c:pt>
                <c:pt idx="60">
                  <c:v>86.442297520525074</c:v>
                </c:pt>
                <c:pt idx="61">
                  <c:v>92.509592756167564</c:v>
                </c:pt>
                <c:pt idx="62">
                  <c:v>98.614908418779038</c:v>
                </c:pt>
                <c:pt idx="63">
                  <c:v>104.75554857283451</c:v>
                </c:pt>
                <c:pt idx="64">
                  <c:v>110.928801684508</c:v>
                </c:pt>
                <c:pt idx="65">
                  <c:v>117.13194181900957</c:v>
                </c:pt>
                <c:pt idx="66">
                  <c:v>123.36222984428134</c:v>
                </c:pt>
                <c:pt idx="67">
                  <c:v>129.61691464052112</c:v>
                </c:pt>
                <c:pt idx="68">
                  <c:v>135.8932343149994</c:v>
                </c:pt>
                <c:pt idx="69">
                  <c:v>142.18841742163363</c:v>
                </c:pt>
                <c:pt idx="70">
                  <c:v>148.49968418478056</c:v>
                </c:pt>
                <c:pt idx="71">
                  <c:v>154.82424772670691</c:v>
                </c:pt>
                <c:pt idx="72">
                  <c:v>161.15931529819639</c:v>
                </c:pt>
                <c:pt idx="73">
                  <c:v>167.50208951174881</c:v>
                </c:pt>
                <c:pt idx="74">
                  <c:v>173.84976957682784</c:v>
                </c:pt>
                <c:pt idx="75">
                  <c:v>180.19955253661115</c:v>
                </c:pt>
                <c:pt idx="76">
                  <c:v>186.54863450569758</c:v>
                </c:pt>
                <c:pt idx="77">
                  <c:v>192.89421190822341</c:v>
                </c:pt>
                <c:pt idx="78">
                  <c:v>199.23348271584302</c:v>
                </c:pt>
                <c:pt idx="79">
                  <c:v>205.5636476850255</c:v>
                </c:pt>
                <c:pt idx="80">
                  <c:v>211.88191159312186</c:v>
                </c:pt>
                <c:pt idx="81">
                  <c:v>218.1854844726567</c:v>
                </c:pt>
                <c:pt idx="82">
                  <c:v>224.47158284329919</c:v>
                </c:pt>
                <c:pt idx="83">
                  <c:v>230.73743094096983</c:v>
                </c:pt>
                <c:pt idx="84">
                  <c:v>236.98026194353946</c:v>
                </c:pt>
                <c:pt idx="85">
                  <c:v>243.19731919258021</c:v>
                </c:pt>
                <c:pt idx="86">
                  <c:v>249.38585741062826</c:v>
                </c:pt>
                <c:pt idx="87">
                  <c:v>255.54314391342089</c:v>
                </c:pt>
                <c:pt idx="88">
                  <c:v>261.66645981657325</c:v>
                </c:pt>
                <c:pt idx="89">
                  <c:v>267.75310123616072</c:v>
                </c:pt>
                <c:pt idx="90">
                  <c:v>273.80038048267863</c:v>
                </c:pt>
                <c:pt idx="91">
                  <c:v>279.80562724784932</c:v>
                </c:pt>
                <c:pt idx="92">
                  <c:v>285.76618978375609</c:v>
                </c:pt>
                <c:pt idx="93">
                  <c:v>291.67943607377964</c:v>
                </c:pt>
                <c:pt idx="94">
                  <c:v>297.54275499482299</c:v>
                </c:pt>
                <c:pt idx="95">
                  <c:v>303.3535574703098</c:v>
                </c:pt>
                <c:pt idx="96">
                  <c:v>309.1092776134476</c:v>
                </c:pt>
                <c:pt idx="97">
                  <c:v>314.80737386025135</c:v>
                </c:pt>
                <c:pt idx="98">
                  <c:v>320.44533009182652</c:v>
                </c:pt>
                <c:pt idx="99">
                  <c:v>326.02065674541609</c:v>
                </c:pt>
                <c:pt idx="100">
                  <c:v>331.53089191372169</c:v>
                </c:pt>
                <c:pt idx="101">
                  <c:v>336.97360243201246</c:v>
                </c:pt>
                <c:pt idx="102">
                  <c:v>342.34638495254205</c:v>
                </c:pt>
                <c:pt idx="103">
                  <c:v>347.64686700579949</c:v>
                </c:pt>
                <c:pt idx="104">
                  <c:v>352.87270804812465</c:v>
                </c:pt>
                <c:pt idx="105">
                  <c:v>358.02160049522661</c:v>
                </c:pt>
                <c:pt idx="106">
                  <c:v>363.09127074114804</c:v>
                </c:pt>
                <c:pt idx="107">
                  <c:v>368.07948016222531</c:v>
                </c:pt>
                <c:pt idx="108">
                  <c:v>372.98402610560208</c:v>
                </c:pt>
                <c:pt idx="109">
                  <c:v>377.80274286185818</c:v>
                </c:pt>
                <c:pt idx="110">
                  <c:v>382.53350262132653</c:v>
                </c:pt>
                <c:pt idx="111">
                  <c:v>387.17421641367366</c:v>
                </c:pt>
                <c:pt idx="112">
                  <c:v>391.72283503033037</c:v>
                </c:pt>
                <c:pt idx="113">
                  <c:v>396.17734992936425</c:v>
                </c:pt>
                <c:pt idx="114">
                  <c:v>400.53579412239571</c:v>
                </c:pt>
                <c:pt idx="115">
                  <c:v>404.79624304316422</c:v>
                </c:pt>
                <c:pt idx="116">
                  <c:v>408.95681539736302</c:v>
                </c:pt>
                <c:pt idx="117">
                  <c:v>413.01567399336523</c:v>
                </c:pt>
                <c:pt idx="118">
                  <c:v>416.97102655347658</c:v>
                </c:pt>
                <c:pt idx="119">
                  <c:v>420.82112650535407</c:v>
                </c:pt>
                <c:pt idx="120">
                  <c:v>424.56427375324381</c:v>
                </c:pt>
                <c:pt idx="121">
                  <c:v>428.19881542869484</c:v>
                </c:pt>
                <c:pt idx="122">
                  <c:v>431.7231466204201</c:v>
                </c:pt>
                <c:pt idx="123">
                  <c:v>435.13571108297913</c:v>
                </c:pt>
                <c:pt idx="124">
                  <c:v>438.43500192397278</c:v>
                </c:pt>
                <c:pt idx="125">
                  <c:v>441.61956226944471</c:v>
                </c:pt>
                <c:pt idx="126">
                  <c:v>444.6879859071953</c:v>
                </c:pt>
                <c:pt idx="127">
                  <c:v>447.63891790772573</c:v>
                </c:pt>
                <c:pt idx="128">
                  <c:v>450.47105522253673</c:v>
                </c:pt>
                <c:pt idx="129">
                  <c:v>453.18314725951791</c:v>
                </c:pt>
                <c:pt idx="130">
                  <c:v>455.77399643517435</c:v>
                </c:pt>
                <c:pt idx="131">
                  <c:v>458.24245870344544</c:v>
                </c:pt>
                <c:pt idx="132">
                  <c:v>460.58744406088363</c:v>
                </c:pt>
                <c:pt idx="133">
                  <c:v>462.80791702796898</c:v>
                </c:pt>
                <c:pt idx="134">
                  <c:v>464.90289710634818</c:v>
                </c:pt>
                <c:pt idx="135">
                  <c:v>466.87145921179456</c:v>
                </c:pt>
                <c:pt idx="136">
                  <c:v>468.71273408269985</c:v>
                </c:pt>
                <c:pt idx="137">
                  <c:v>470.42590866391492</c:v>
                </c:pt>
                <c:pt idx="138">
                  <c:v>472.01022646577258</c:v>
                </c:pt>
                <c:pt idx="139">
                  <c:v>473.46498789813199</c:v>
                </c:pt>
                <c:pt idx="140">
                  <c:v>474.78955057929772</c:v>
                </c:pt>
                <c:pt idx="141">
                  <c:v>475.98332961967765</c:v>
                </c:pt>
                <c:pt idx="142">
                  <c:v>477.04579788005401</c:v>
                </c:pt>
                <c:pt idx="143">
                  <c:v>477.97648620435257</c:v>
                </c:pt>
                <c:pt idx="144">
                  <c:v>478.77498362680922</c:v>
                </c:pt>
                <c:pt idx="145">
                  <c:v>479.44093755344102</c:v>
                </c:pt>
                <c:pt idx="146">
                  <c:v>479.97405391774112</c:v>
                </c:pt>
                <c:pt idx="147">
                  <c:v>480.37409731053106</c:v>
                </c:pt>
                <c:pt idx="148">
                  <c:v>480.64089108391022</c:v>
                </c:pt>
                <c:pt idx="149">
                  <c:v>480.77431742925876</c:v>
                </c:pt>
                <c:pt idx="150">
                  <c:v>480.77431742925864</c:v>
                </c:pt>
                <c:pt idx="151">
                  <c:v>480.64089108391011</c:v>
                </c:pt>
                <c:pt idx="152">
                  <c:v>480.37409731053083</c:v>
                </c:pt>
                <c:pt idx="153">
                  <c:v>479.97405391774078</c:v>
                </c:pt>
                <c:pt idx="154">
                  <c:v>479.44093755344056</c:v>
                </c:pt>
                <c:pt idx="155">
                  <c:v>478.77498362680876</c:v>
                </c:pt>
                <c:pt idx="156">
                  <c:v>477.97648620435189</c:v>
                </c:pt>
                <c:pt idx="157">
                  <c:v>477.04579788005321</c:v>
                </c:pt>
                <c:pt idx="158">
                  <c:v>475.98332961967685</c:v>
                </c:pt>
                <c:pt idx="159">
                  <c:v>474.78955057929682</c:v>
                </c:pt>
                <c:pt idx="160">
                  <c:v>473.46498789813097</c:v>
                </c:pt>
                <c:pt idx="161">
                  <c:v>472.01022646577155</c:v>
                </c:pt>
                <c:pt idx="162">
                  <c:v>470.42590866391379</c:v>
                </c:pt>
                <c:pt idx="163">
                  <c:v>468.7127340826986</c:v>
                </c:pt>
                <c:pt idx="164">
                  <c:v>466.87145921179331</c:v>
                </c:pt>
                <c:pt idx="165">
                  <c:v>464.9028971063467</c:v>
                </c:pt>
                <c:pt idx="166">
                  <c:v>462.80791702796751</c:v>
                </c:pt>
                <c:pt idx="167">
                  <c:v>460.58744406088204</c:v>
                </c:pt>
                <c:pt idx="168">
                  <c:v>458.24245870344384</c:v>
                </c:pt>
                <c:pt idx="169">
                  <c:v>455.77399643517265</c:v>
                </c:pt>
                <c:pt idx="170">
                  <c:v>453.18314725951609</c:v>
                </c:pt>
                <c:pt idx="171">
                  <c:v>450.4710552225348</c:v>
                </c:pt>
                <c:pt idx="172">
                  <c:v>447.63891790772368</c:v>
                </c:pt>
                <c:pt idx="173">
                  <c:v>444.68798590719314</c:v>
                </c:pt>
                <c:pt idx="174">
                  <c:v>441.61956226944255</c:v>
                </c:pt>
                <c:pt idx="175">
                  <c:v>438.43500192397062</c:v>
                </c:pt>
                <c:pt idx="176">
                  <c:v>435.13571108297674</c:v>
                </c:pt>
                <c:pt idx="177">
                  <c:v>431.72314662041765</c:v>
                </c:pt>
                <c:pt idx="178">
                  <c:v>428.19881542869246</c:v>
                </c:pt>
                <c:pt idx="179">
                  <c:v>424.5642737532412</c:v>
                </c:pt>
                <c:pt idx="180">
                  <c:v>420.8211265053514</c:v>
                </c:pt>
                <c:pt idx="181">
                  <c:v>416.97102655347385</c:v>
                </c:pt>
                <c:pt idx="182">
                  <c:v>413.0156739933625</c:v>
                </c:pt>
                <c:pt idx="183">
                  <c:v>408.95681539736017</c:v>
                </c:pt>
                <c:pt idx="184">
                  <c:v>404.79624304316133</c:v>
                </c:pt>
                <c:pt idx="185">
                  <c:v>400.5357941223927</c:v>
                </c:pt>
                <c:pt idx="186">
                  <c:v>396.17734992936118</c:v>
                </c:pt>
                <c:pt idx="187">
                  <c:v>391.72283503032725</c:v>
                </c:pt>
                <c:pt idx="188">
                  <c:v>387.17421641367048</c:v>
                </c:pt>
                <c:pt idx="189">
                  <c:v>382.53350262132324</c:v>
                </c:pt>
                <c:pt idx="190">
                  <c:v>377.80274286185482</c:v>
                </c:pt>
                <c:pt idx="191">
                  <c:v>372.98402610559879</c:v>
                </c:pt>
                <c:pt idx="192">
                  <c:v>368.07948016222196</c:v>
                </c:pt>
                <c:pt idx="193">
                  <c:v>363.09127074114451</c:v>
                </c:pt>
                <c:pt idx="194">
                  <c:v>358.02160049522308</c:v>
                </c:pt>
                <c:pt idx="195">
                  <c:v>352.87270804812101</c:v>
                </c:pt>
                <c:pt idx="196">
                  <c:v>347.6468670057958</c:v>
                </c:pt>
                <c:pt idx="197">
                  <c:v>342.34638495253836</c:v>
                </c:pt>
                <c:pt idx="198">
                  <c:v>336.9736024320087</c:v>
                </c:pt>
                <c:pt idx="199">
                  <c:v>331.53089191371788</c:v>
                </c:pt>
                <c:pt idx="200">
                  <c:v>326.02065674541223</c:v>
                </c:pt>
                <c:pt idx="201">
                  <c:v>320.4453300918226</c:v>
                </c:pt>
                <c:pt idx="202">
                  <c:v>314.80737386024748</c:v>
                </c:pt>
                <c:pt idx="203">
                  <c:v>309.10927761344362</c:v>
                </c:pt>
                <c:pt idx="204">
                  <c:v>303.3535574703057</c:v>
                </c:pt>
                <c:pt idx="205">
                  <c:v>297.54275499481884</c:v>
                </c:pt>
                <c:pt idx="206">
                  <c:v>291.67943607377543</c:v>
                </c:pt>
                <c:pt idx="207">
                  <c:v>285.76618978375188</c:v>
                </c:pt>
                <c:pt idx="208">
                  <c:v>279.80562724784511</c:v>
                </c:pt>
                <c:pt idx="209">
                  <c:v>273.80038048267431</c:v>
                </c:pt>
                <c:pt idx="210">
                  <c:v>267.75310123615645</c:v>
                </c:pt>
                <c:pt idx="211">
                  <c:v>261.66645981656882</c:v>
                </c:pt>
                <c:pt idx="212">
                  <c:v>255.54314391341649</c:v>
                </c:pt>
                <c:pt idx="213">
                  <c:v>249.38585741062383</c:v>
                </c:pt>
                <c:pt idx="214">
                  <c:v>243.197319192576</c:v>
                </c:pt>
                <c:pt idx="215">
                  <c:v>236.98026194353525</c:v>
                </c:pt>
                <c:pt idx="216">
                  <c:v>230.7374309409656</c:v>
                </c:pt>
                <c:pt idx="217">
                  <c:v>224.47158284329493</c:v>
                </c:pt>
                <c:pt idx="218">
                  <c:v>218.18548447265238</c:v>
                </c:pt>
                <c:pt idx="219">
                  <c:v>211.88191159311754</c:v>
                </c:pt>
                <c:pt idx="220">
                  <c:v>205.56364768502115</c:v>
                </c:pt>
                <c:pt idx="221">
                  <c:v>199.23348271583868</c:v>
                </c:pt>
                <c:pt idx="222">
                  <c:v>192.89421190821906</c:v>
                </c:pt>
                <c:pt idx="223">
                  <c:v>186.54863450569323</c:v>
                </c:pt>
                <c:pt idx="224">
                  <c:v>180.1995525366068</c:v>
                </c:pt>
                <c:pt idx="225">
                  <c:v>173.84976957682341</c:v>
                </c:pt>
                <c:pt idx="226">
                  <c:v>167.50208951174437</c:v>
                </c:pt>
                <c:pt idx="227">
                  <c:v>161.15931529819198</c:v>
                </c:pt>
                <c:pt idx="228">
                  <c:v>154.82424772670251</c:v>
                </c:pt>
                <c:pt idx="229">
                  <c:v>148.49968418477613</c:v>
                </c:pt>
                <c:pt idx="230">
                  <c:v>142.18841742162925</c:v>
                </c:pt>
                <c:pt idx="231">
                  <c:v>135.893234314995</c:v>
                </c:pt>
                <c:pt idx="232">
                  <c:v>129.61691464051668</c:v>
                </c:pt>
                <c:pt idx="233">
                  <c:v>123.36222984427692</c:v>
                </c:pt>
                <c:pt idx="234">
                  <c:v>117.13194181900518</c:v>
                </c:pt>
                <c:pt idx="235">
                  <c:v>110.92880168450363</c:v>
                </c:pt>
                <c:pt idx="236">
                  <c:v>104.75554857283016</c:v>
                </c:pt>
                <c:pt idx="237">
                  <c:v>98.614908418774718</c:v>
                </c:pt>
                <c:pt idx="238">
                  <c:v>92.509592756163258</c:v>
                </c:pt>
                <c:pt idx="239">
                  <c:v>86.442297520520739</c:v>
                </c:pt>
                <c:pt idx="240">
                  <c:v>80.415701858621873</c:v>
                </c:pt>
                <c:pt idx="241">
                  <c:v>74.432466945455374</c:v>
                </c:pt>
                <c:pt idx="242">
                  <c:v>68.495234809124227</c:v>
                </c:pt>
                <c:pt idx="243">
                  <c:v>62.606627164199409</c:v>
                </c:pt>
                <c:pt idx="244">
                  <c:v>56.769244254046086</c:v>
                </c:pt>
                <c:pt idx="245">
                  <c:v>50.985663702628372</c:v>
                </c:pt>
                <c:pt idx="246">
                  <c:v>45.258439376303329</c:v>
                </c:pt>
                <c:pt idx="247">
                  <c:v>39.590100256105501</c:v>
                </c:pt>
                <c:pt idx="248">
                  <c:v>33.983149321020107</c:v>
                </c:pt>
                <c:pt idx="249">
                  <c:v>28.440062442737997</c:v>
                </c:pt>
                <c:pt idx="250">
                  <c:v>22.963287292380329</c:v>
                </c:pt>
                <c:pt idx="251">
                  <c:v>17.555242259676021</c:v>
                </c:pt>
                <c:pt idx="252">
                  <c:v>12.218315385068792</c:v>
                </c:pt>
                <c:pt idx="253">
                  <c:v>6.9548633052258992</c:v>
                </c:pt>
                <c:pt idx="254">
                  <c:v>1.7672102124134881</c:v>
                </c:pt>
                <c:pt idx="255">
                  <c:v>-3.3423531718009656</c:v>
                </c:pt>
                <c:pt idx="256">
                  <c:v>-8.3715706080671168</c:v>
                </c:pt>
                <c:pt idx="257">
                  <c:v>-13.318221335543342</c:v>
                </c:pt>
                <c:pt idx="258">
                  <c:v>-18.180121052522281</c:v>
                </c:pt>
                <c:pt idx="259">
                  <c:v>-22.95512288095702</c:v>
                </c:pt>
                <c:pt idx="260">
                  <c:v>-27.641118314461892</c:v>
                </c:pt>
                <c:pt idx="261">
                  <c:v>-32.236038149369563</c:v>
                </c:pt>
                <c:pt idx="262">
                  <c:v>-36.737853398433288</c:v>
                </c:pt>
                <c:pt idx="263">
                  <c:v>-41.14457618677028</c:v>
                </c:pt>
                <c:pt idx="264">
                  <c:v>-45.4542606296516</c:v>
                </c:pt>
                <c:pt idx="265">
                  <c:v>-49.665003691749803</c:v>
                </c:pt>
                <c:pt idx="266">
                  <c:v>-53.774946027465887</c:v>
                </c:pt>
                <c:pt idx="267">
                  <c:v>-57.782272801964041</c:v>
                </c:pt>
                <c:pt idx="268">
                  <c:v>-61.685214492551495</c:v>
                </c:pt>
                <c:pt idx="269">
                  <c:v>-65.48204767004998</c:v>
                </c:pt>
                <c:pt idx="270">
                  <c:v>-69.171095759813483</c:v>
                </c:pt>
                <c:pt idx="271">
                  <c:v>-72.750729782056425</c:v>
                </c:pt>
                <c:pt idx="272">
                  <c:v>-76.219369071165659</c:v>
                </c:pt>
                <c:pt idx="273">
                  <c:v>-79.575481973677171</c:v>
                </c:pt>
                <c:pt idx="274">
                  <c:v>-82.817586524611642</c:v>
                </c:pt>
                <c:pt idx="275">
                  <c:v>-85.944251101868332</c:v>
                </c:pt>
                <c:pt idx="276">
                  <c:v>-88.954095058389072</c:v>
                </c:pt>
                <c:pt idx="277">
                  <c:v>-91.845789331813279</c:v>
                </c:pt>
                <c:pt idx="278">
                  <c:v>-94.618057031354368</c:v>
                </c:pt>
                <c:pt idx="279">
                  <c:v>-97.26967400163872</c:v>
                </c:pt>
                <c:pt idx="280">
                  <c:v>-99.799469363258282</c:v>
                </c:pt>
                <c:pt idx="281">
                  <c:v>-102.20632602979802</c:v>
                </c:pt>
                <c:pt idx="282">
                  <c:v>-104.4891812011098</c:v>
                </c:pt>
                <c:pt idx="283">
                  <c:v>-106.64702683261496</c:v>
                </c:pt>
                <c:pt idx="284">
                  <c:v>-108.67891008042838</c:v>
                </c:pt>
                <c:pt idx="285">
                  <c:v>-110.58393372210779</c:v>
                </c:pt>
                <c:pt idx="286">
                  <c:v>-112.36125655284158</c:v>
                </c:pt>
                <c:pt idx="287">
                  <c:v>-114.01009375690145</c:v>
                </c:pt>
                <c:pt idx="288">
                  <c:v>-115.52971725419459</c:v>
                </c:pt>
                <c:pt idx="289">
                  <c:v>-116.91945602176386</c:v>
                </c:pt>
                <c:pt idx="290">
                  <c:v>-118.1786963900922</c:v>
                </c:pt>
                <c:pt idx="291">
                  <c:v>-119.30688231408206</c:v>
                </c:pt>
                <c:pt idx="292">
                  <c:v>-120.3035156185891</c:v>
                </c:pt>
                <c:pt idx="293">
                  <c:v>-121.16815621840246</c:v>
                </c:pt>
                <c:pt idx="294">
                  <c:v>-121.90042231257385</c:v>
                </c:pt>
                <c:pt idx="295">
                  <c:v>-122.49999055301018</c:v>
                </c:pt>
                <c:pt idx="296">
                  <c:v>-122.96659618725513</c:v>
                </c:pt>
                <c:pt idx="297">
                  <c:v>-123.30003317539595</c:v>
                </c:pt>
                <c:pt idx="298">
                  <c:v>-123.5001542810455</c:v>
                </c:pt>
                <c:pt idx="299">
                  <c:v>-123.56687113635698</c:v>
                </c:pt>
              </c:numCache>
            </c:numRef>
          </c:xVal>
          <c:yVal>
            <c:numRef>
              <c:f>'Covariance   Correlation3'!yycir45</c:f>
              <c:numCache>
                <c:formatCode>General</c:formatCode>
                <c:ptCount val="300"/>
                <c:pt idx="0">
                  <c:v>1.1168454140918951</c:v>
                </c:pt>
                <c:pt idx="1">
                  <c:v>1.0840588785268352</c:v>
                </c:pt>
                <c:pt idx="2">
                  <c:v>1.0510767124088838</c:v>
                </c:pt>
                <c:pt idx="3">
                  <c:v>1.0179134797341125</c:v>
                </c:pt>
                <c:pt idx="4">
                  <c:v>0.98458382445248749</c:v>
                </c:pt>
                <c:pt idx="5">
                  <c:v>0.95110246400151299</c:v>
                </c:pt>
                <c:pt idx="6">
                  <c:v>0.91748418280742539</c:v>
                </c:pt>
                <c:pt idx="7">
                  <c:v>0.88374382575680754</c:v>
                </c:pt>
                <c:pt idx="8">
                  <c:v>0.8498962916415016</c:v>
                </c:pt>
                <c:pt idx="9">
                  <c:v>0.81595652657972673</c:v>
                </c:pt>
                <c:pt idx="10">
                  <c:v>0.78193951741629086</c:v>
                </c:pt>
                <c:pt idx="11">
                  <c:v>0.74786028510482261</c:v>
                </c:pt>
                <c:pt idx="12">
                  <c:v>0.71373387807494104</c:v>
                </c:pt>
                <c:pt idx="13">
                  <c:v>0.67957536558729326</c:v>
                </c:pt>
                <c:pt idx="14">
                  <c:v>0.64539983107939225</c:v>
                </c:pt>
                <c:pt idx="15">
                  <c:v>0.61122236550519626</c:v>
                </c:pt>
                <c:pt idx="16">
                  <c:v>0.57705806067136778</c:v>
                </c:pt>
                <c:pt idx="17">
                  <c:v>0.54292200257315704</c:v>
                </c:pt>
                <c:pt idx="18">
                  <c:v>0.50882926473285095</c:v>
                </c:pt>
                <c:pt idx="19">
                  <c:v>0.47479490154373016</c:v>
                </c:pt>
                <c:pt idx="20">
                  <c:v>0.44083394162247252</c:v>
                </c:pt>
                <c:pt idx="21">
                  <c:v>0.40696138117293901</c:v>
                </c:pt>
                <c:pt idx="22">
                  <c:v>0.37319217736427285</c:v>
                </c:pt>
                <c:pt idx="23">
                  <c:v>0.33954124172623484</c:v>
                </c:pt>
                <c:pt idx="24">
                  <c:v>0.30602343356468859</c:v>
                </c:pt>
                <c:pt idx="25">
                  <c:v>0.27265355340015429</c:v>
                </c:pt>
                <c:pt idx="26">
                  <c:v>0.239446336432312</c:v>
                </c:pt>
                <c:pt idx="27">
                  <c:v>0.20641644603335363</c:v>
                </c:pt>
                <c:pt idx="28">
                  <c:v>0.17357846727304954</c:v>
                </c:pt>
                <c:pt idx="29">
                  <c:v>0.14094690047839425</c:v>
                </c:pt>
                <c:pt idx="30">
                  <c:v>0.10853615483066736</c:v>
                </c:pt>
                <c:pt idx="31">
                  <c:v>7.63605420027475E-2</c:v>
                </c:pt>
                <c:pt idx="32">
                  <c:v>4.4434269839479013E-2</c:v>
                </c:pt>
                <c:pt idx="33">
                  <c:v>1.2771436083888088E-2</c:v>
                </c:pt>
                <c:pt idx="34">
                  <c:v>-1.8613977847983687E-2</c:v>
                </c:pt>
                <c:pt idx="35">
                  <c:v>-4.9708113040880242E-2</c:v>
                </c:pt>
                <c:pt idx="36">
                  <c:v>-8.0497239200035764E-2</c:v>
                </c:pt>
                <c:pt idx="37">
                  <c:v>-0.11096776071408748</c:v>
                </c:pt>
                <c:pt idx="38">
                  <c:v>-0.14110622265851513</c:v>
                </c:pt>
                <c:pt idx="39">
                  <c:v>-0.17089931673695619</c:v>
                </c:pt>
                <c:pt idx="40">
                  <c:v>-0.20033388715777578</c:v>
                </c:pt>
                <c:pt idx="41">
                  <c:v>-0.22939693644329257</c:v>
                </c:pt>
                <c:pt idx="42">
                  <c:v>-0.25807563116910054</c:v>
                </c:pt>
                <c:pt idx="43">
                  <c:v>-0.28635730763094702</c:v>
                </c:pt>
                <c:pt idx="44">
                  <c:v>-0.31422947743666818</c:v>
                </c:pt>
                <c:pt idx="45">
                  <c:v>-0.34167983302071153</c:v>
                </c:pt>
                <c:pt idx="46">
                  <c:v>-0.36869625307880988</c:v>
                </c:pt>
                <c:pt idx="47">
                  <c:v>-0.39526680792040891</c:v>
                </c:pt>
                <c:pt idx="48">
                  <c:v>-0.4213797647364822</c:v>
                </c:pt>
                <c:pt idx="49">
                  <c:v>-0.44702359278040982</c:v>
                </c:pt>
                <c:pt idx="50">
                  <c:v>-0.47218696845963049</c:v>
                </c:pt>
                <c:pt idx="51">
                  <c:v>-0.49685878033582259</c:v>
                </c:pt>
                <c:pt idx="52">
                  <c:v>-0.5210281340314008</c:v>
                </c:pt>
                <c:pt idx="53">
                  <c:v>-0.5446843570401686</c:v>
                </c:pt>
                <c:pt idx="54">
                  <c:v>-0.56781700343999497</c:v>
                </c:pt>
                <c:pt idx="55">
                  <c:v>-0.59041585850544087</c:v>
                </c:pt>
                <c:pt idx="56">
                  <c:v>-0.61247094321829276</c:v>
                </c:pt>
                <c:pt idx="57">
                  <c:v>-0.63397251867401749</c:v>
                </c:pt>
                <c:pt idx="58">
                  <c:v>-0.65491109038218787</c:v>
                </c:pt>
                <c:pt idx="59">
                  <c:v>-0.67527741245898232</c:v>
                </c:pt>
                <c:pt idx="60">
                  <c:v>-0.69506249170990675</c:v>
                </c:pt>
                <c:pt idx="61">
                  <c:v>-0.71425759160093749</c:v>
                </c:pt>
                <c:pt idx="62">
                  <c:v>-0.73285423611632605</c:v>
                </c:pt>
                <c:pt idx="63">
                  <c:v>-0.75084421350137198</c:v>
                </c:pt>
                <c:pt idx="64">
                  <c:v>-0.76821957988850031</c:v>
                </c:pt>
                <c:pt idx="65">
                  <c:v>-0.78497266280505062</c:v>
                </c:pt>
                <c:pt idx="66">
                  <c:v>-0.80109606456122606</c:v>
                </c:pt>
                <c:pt idx="67">
                  <c:v>-0.81658266551670322</c:v>
                </c:pt>
                <c:pt idx="68">
                  <c:v>-0.83142562722446556</c:v>
                </c:pt>
                <c:pt idx="69">
                  <c:v>-0.84561839545046935</c:v>
                </c:pt>
                <c:pt idx="70">
                  <c:v>-0.85915470306780906</c:v>
                </c:pt>
                <c:pt idx="71">
                  <c:v>-0.87202857282410329</c:v>
                </c:pt>
                <c:pt idx="72">
                  <c:v>-0.88423431998088209</c:v>
                </c:pt>
                <c:pt idx="73">
                  <c:v>-0.8957665548238064</c:v>
                </c:pt>
                <c:pt idx="74">
                  <c:v>-0.90662018504261543</c:v>
                </c:pt>
                <c:pt idx="75">
                  <c:v>-0.91679041797974692</c:v>
                </c:pt>
                <c:pt idx="76">
                  <c:v>-0.92627276274663961</c:v>
                </c:pt>
                <c:pt idx="77">
                  <c:v>-0.93506303220678255</c:v>
                </c:pt>
                <c:pt idx="78">
                  <c:v>-0.94315734482463942</c:v>
                </c:pt>
                <c:pt idx="79">
                  <c:v>-0.95055212637962183</c:v>
                </c:pt>
                <c:pt idx="80">
                  <c:v>-0.95724411154436695</c:v>
                </c:pt>
                <c:pt idx="81">
                  <c:v>-0.96323034532661245</c:v>
                </c:pt>
                <c:pt idx="82">
                  <c:v>-0.96850818437404007</c:v>
                </c:pt>
                <c:pt idx="83">
                  <c:v>-0.97307529814150384</c:v>
                </c:pt>
                <c:pt idx="84">
                  <c:v>-0.97692966992013297</c:v>
                </c:pt>
                <c:pt idx="85">
                  <c:v>-0.98006959772785518</c:v>
                </c:pt>
                <c:pt idx="86">
                  <c:v>-0.98249369506094353</c:v>
                </c:pt>
                <c:pt idx="87">
                  <c:v>-0.98420089150625656</c:v>
                </c:pt>
                <c:pt idx="88">
                  <c:v>-0.98519043321390332</c:v>
                </c:pt>
                <c:pt idx="89">
                  <c:v>-0.98546188323012296</c:v>
                </c:pt>
                <c:pt idx="90">
                  <c:v>-0.98501512169022976</c:v>
                </c:pt>
                <c:pt idx="91">
                  <c:v>-0.98385034587154252</c:v>
                </c:pt>
                <c:pt idx="92">
                  <c:v>-0.98196807010627352</c:v>
                </c:pt>
                <c:pt idx="93">
                  <c:v>-0.97936912555441236</c:v>
                </c:pt>
                <c:pt idx="94">
                  <c:v>-0.97605465983670947</c:v>
                </c:pt>
                <c:pt idx="95">
                  <c:v>-0.97202613652792025</c:v>
                </c:pt>
                <c:pt idx="96">
                  <c:v>-0.96728533451053023</c:v>
                </c:pt>
                <c:pt idx="97">
                  <c:v>-0.96183434718925098</c:v>
                </c:pt>
                <c:pt idx="98">
                  <c:v>-0.95567558156663224</c:v>
                </c:pt>
                <c:pt idx="99">
                  <c:v>-0.94881175718019661</c:v>
                </c:pt>
                <c:pt idx="100">
                  <c:v>-0.94124590490156845</c:v>
                </c:pt>
                <c:pt idx="101">
                  <c:v>-0.93298136559812694</c:v>
                </c:pt>
                <c:pt idx="102">
                  <c:v>-0.92402178865777151</c:v>
                </c:pt>
                <c:pt idx="103">
                  <c:v>-0.91437113037745754</c:v>
                </c:pt>
                <c:pt idx="104">
                  <c:v>-0.9040336522162038</c:v>
                </c:pt>
                <c:pt idx="105">
                  <c:v>-0.89301391891335458</c:v>
                </c:pt>
                <c:pt idx="106">
                  <c:v>-0.8813167964729185</c:v>
                </c:pt>
                <c:pt idx="107">
                  <c:v>-0.86894745001487772</c:v>
                </c:pt>
                <c:pt idx="108">
                  <c:v>-0.85591134149441683</c:v>
                </c:pt>
                <c:pt idx="109">
                  <c:v>-0.84221422729007656</c:v>
                </c:pt>
                <c:pt idx="110">
                  <c:v>-0.82786215566190058</c:v>
                </c:pt>
                <c:pt idx="111">
                  <c:v>-0.81286146408069226</c:v>
                </c:pt>
                <c:pt idx="112">
                  <c:v>-0.7972187764295674</c:v>
                </c:pt>
                <c:pt idx="113">
                  <c:v>-0.78094100007903289</c:v>
                </c:pt>
                <c:pt idx="114">
                  <c:v>-0.76403532283688735</c:v>
                </c:pt>
                <c:pt idx="115">
                  <c:v>-0.74650920977428648</c:v>
                </c:pt>
                <c:pt idx="116">
                  <c:v>-0.72837039992937846</c:v>
                </c:pt>
                <c:pt idx="117">
                  <c:v>-0.70962690288996255</c:v>
                </c:pt>
                <c:pt idx="118">
                  <c:v>-0.69028699525668014</c:v>
                </c:pt>
                <c:pt idx="119">
                  <c:v>-0.6703592169883017</c:v>
                </c:pt>
                <c:pt idx="120">
                  <c:v>-0.64985236763072085</c:v>
                </c:pt>
                <c:pt idx="121">
                  <c:v>-0.62877550243132252</c:v>
                </c:pt>
                <c:pt idx="122">
                  <c:v>-0.60713792834044011</c:v>
                </c:pt>
                <c:pt idx="123">
                  <c:v>-0.58494919990167027</c:v>
                </c:pt>
                <c:pt idx="124">
                  <c:v>-0.56221911503285305</c:v>
                </c:pt>
                <c:pt idx="125">
                  <c:v>-0.53895771069958864</c:v>
                </c:pt>
                <c:pt idx="126">
                  <c:v>-0.51517525848319523</c:v>
                </c:pt>
                <c:pt idx="127">
                  <c:v>-0.49088226004506835</c:v>
                </c:pt>
                <c:pt idx="128">
                  <c:v>-0.46608944248944245</c:v>
                </c:pt>
                <c:pt idx="129">
                  <c:v>-0.4408077536266039</c:v>
                </c:pt>
                <c:pt idx="130">
                  <c:v>-0.41504835713864563</c:v>
                </c:pt>
                <c:pt idx="131">
                  <c:v>-0.38882262764990039</c:v>
                </c:pt>
                <c:pt idx="132">
                  <c:v>-0.36214214570422582</c:v>
                </c:pt>
                <c:pt idx="133">
                  <c:v>-0.33501869265136303</c:v>
                </c:pt>
                <c:pt idx="134">
                  <c:v>-0.30746424544462364</c:v>
                </c:pt>
                <c:pt idx="135">
                  <c:v>-0.27949097135220502</c:v>
                </c:pt>
                <c:pt idx="136">
                  <c:v>-0.25111122258446694</c:v>
                </c:pt>
                <c:pt idx="137">
                  <c:v>-0.22233753083954172</c:v>
                </c:pt>
                <c:pt idx="138">
                  <c:v>-0.19318260176969188</c:v>
                </c:pt>
                <c:pt idx="139">
                  <c:v>-0.16365930937085005</c:v>
                </c:pt>
                <c:pt idx="140">
                  <c:v>-0.1337806902978248</c:v>
                </c:pt>
                <c:pt idx="141">
                  <c:v>-0.10355993810768133</c:v>
                </c:pt>
                <c:pt idx="142">
                  <c:v>-7.3010397433838081E-2</c:v>
                </c:pt>
                <c:pt idx="143">
                  <c:v>-4.2145558093451774E-2</c:v>
                </c:pt>
                <c:pt idx="144">
                  <c:v>-1.0979049130694418E-2</c:v>
                </c:pt>
                <c:pt idx="145">
                  <c:v>2.047536720144888E-2</c:v>
                </c:pt>
                <c:pt idx="146">
                  <c:v>5.2203801518203863E-2</c:v>
                </c:pt>
                <c:pt idx="147">
                  <c:v>8.4192243436168379E-2</c:v>
                </c:pt>
                <c:pt idx="148">
                  <c:v>0.11642656775990257</c:v>
                </c:pt>
                <c:pt idx="149">
                  <c:v>0.14889254071921842</c:v>
                </c:pt>
                <c:pt idx="150">
                  <c:v>0.18157582625441088</c:v>
                </c:pt>
                <c:pt idx="151">
                  <c:v>0.21446199234666097</c:v>
                </c:pt>
                <c:pt idx="152">
                  <c:v>0.24753651739080512</c:v>
                </c:pt>
                <c:pt idx="153">
                  <c:v>0.2807847966076697</c:v>
                </c:pt>
                <c:pt idx="154">
                  <c:v>0.31419214849312971</c:v>
                </c:pt>
                <c:pt idx="155">
                  <c:v>0.34774382130104792</c:v>
                </c:pt>
                <c:pt idx="156">
                  <c:v>0.38142499955723047</c:v>
                </c:pt>
                <c:pt idx="157">
                  <c:v>0.41522081060152349</c:v>
                </c:pt>
                <c:pt idx="158">
                  <c:v>0.44911633115516048</c:v>
                </c:pt>
                <c:pt idx="159">
                  <c:v>0.48309659391046295</c:v>
                </c:pt>
                <c:pt idx="160">
                  <c:v>0.51714659413998132</c:v>
                </c:pt>
                <c:pt idx="161">
                  <c:v>0.55125129632216141</c:v>
                </c:pt>
                <c:pt idx="162">
                  <c:v>0.58539564078060558</c:v>
                </c:pt>
                <c:pt idx="163">
                  <c:v>0.61956455033400404</c:v>
                </c:pt>
                <c:pt idx="164">
                  <c:v>0.65374293695379082</c:v>
                </c:pt>
                <c:pt idx="165">
                  <c:v>0.68791570842659711</c:v>
                </c:pt>
                <c:pt idx="166">
                  <c:v>0.72206777501854269</c:v>
                </c:pt>
                <c:pt idx="167">
                  <c:v>0.75618405613844031</c:v>
                </c:pt>
                <c:pt idx="168">
                  <c:v>0.79024948699696018</c:v>
                </c:pt>
                <c:pt idx="169">
                  <c:v>0.82424902525881572</c:v>
                </c:pt>
                <c:pt idx="170">
                  <c:v>0.85816765768503722</c:v>
                </c:pt>
                <c:pt idx="171">
                  <c:v>0.89199040676239338</c:v>
                </c:pt>
                <c:pt idx="172">
                  <c:v>0.92570233731704066</c:v>
                </c:pt>
                <c:pt idx="173">
                  <c:v>0.9592885631094763</c:v>
                </c:pt>
                <c:pt idx="174">
                  <c:v>0.99273425340788057</c:v>
                </c:pt>
                <c:pt idx="175">
                  <c:v>1.0260246395369528</c:v>
                </c:pt>
                <c:pt idx="176">
                  <c:v>1.059145021399341</c:v>
                </c:pt>
                <c:pt idx="177">
                  <c:v>1.0920807739667908</c:v>
                </c:pt>
                <c:pt idx="178">
                  <c:v>1.1248173537381478</c:v>
                </c:pt>
                <c:pt idx="179">
                  <c:v>1.1573403051613584</c:v>
                </c:pt>
                <c:pt idx="180">
                  <c:v>1.1896352670166324</c:v>
                </c:pt>
                <c:pt idx="181">
                  <c:v>1.2216879787579535</c:v>
                </c:pt>
                <c:pt idx="182">
                  <c:v>1.2534842868101388</c:v>
                </c:pt>
                <c:pt idx="183">
                  <c:v>1.2850101508186544</c:v>
                </c:pt>
                <c:pt idx="184">
                  <c:v>1.3162516498494434</c:v>
                </c:pt>
                <c:pt idx="185">
                  <c:v>1.3471949885360179</c:v>
                </c:pt>
                <c:pt idx="186">
                  <c:v>1.3778265031711046</c:v>
                </c:pt>
                <c:pt idx="187">
                  <c:v>1.4081326677401529</c:v>
                </c:pt>
                <c:pt idx="188">
                  <c:v>1.438100099894043</c:v>
                </c:pt>
                <c:pt idx="189">
                  <c:v>1.4677155668583521</c:v>
                </c:pt>
                <c:pt idx="190">
                  <c:v>1.4969659912765794</c:v>
                </c:pt>
                <c:pt idx="191">
                  <c:v>1.5258384569847336</c:v>
                </c:pt>
                <c:pt idx="192">
                  <c:v>1.5543202147147528</c:v>
                </c:pt>
                <c:pt idx="193">
                  <c:v>1.5823986877242164</c:v>
                </c:pt>
                <c:pt idx="194">
                  <c:v>1.6100614773498851</c:v>
                </c:pt>
                <c:pt idx="195">
                  <c:v>1.6372963684825996</c:v>
                </c:pt>
                <c:pt idx="196">
                  <c:v>1.664091334961129</c:v>
                </c:pt>
                <c:pt idx="197">
                  <c:v>1.6904345448825855</c:v>
                </c:pt>
                <c:pt idx="198">
                  <c:v>1.716314365827059</c:v>
                </c:pt>
                <c:pt idx="199">
                  <c:v>1.741719369994168</c:v>
                </c:pt>
                <c:pt idx="200">
                  <c:v>1.7666383392492517</c:v>
                </c:pt>
                <c:pt idx="201">
                  <c:v>1.7910602700769847</c:v>
                </c:pt>
                <c:pt idx="202">
                  <c:v>1.8149743784402195</c:v>
                </c:pt>
                <c:pt idx="203">
                  <c:v>1.8383701045419116</c:v>
                </c:pt>
                <c:pt idx="204">
                  <c:v>1.8612371174880318</c:v>
                </c:pt>
                <c:pt idx="205">
                  <c:v>1.8835653198493953</c:v>
                </c:pt>
                <c:pt idx="206">
                  <c:v>1.9053448521204042</c:v>
                </c:pt>
                <c:pt idx="207">
                  <c:v>1.9265660970727263</c:v>
                </c:pt>
                <c:pt idx="208">
                  <c:v>1.9472196840019929</c:v>
                </c:pt>
                <c:pt idx="209">
                  <c:v>1.9672964928656387</c:v>
                </c:pt>
                <c:pt idx="210">
                  <c:v>1.9867876583100545</c:v>
                </c:pt>
                <c:pt idx="211">
                  <c:v>2.0056845735852793</c:v>
                </c:pt>
                <c:pt idx="212">
                  <c:v>2.0239788943454959</c:v>
                </c:pt>
                <c:pt idx="213">
                  <c:v>2.0416625423336643</c:v>
                </c:pt>
                <c:pt idx="214">
                  <c:v>2.0587277089486471</c:v>
                </c:pt>
                <c:pt idx="215">
                  <c:v>2.0751668586932714</c:v>
                </c:pt>
                <c:pt idx="216">
                  <c:v>2.0909727325017915</c:v>
                </c:pt>
                <c:pt idx="217">
                  <c:v>2.1061383509452867</c:v>
                </c:pt>
                <c:pt idx="218">
                  <c:v>2.1206570173135817</c:v>
                </c:pt>
                <c:pt idx="219">
                  <c:v>2.1345223205723247</c:v>
                </c:pt>
                <c:pt idx="220">
                  <c:v>2.1477281381939224</c:v>
                </c:pt>
                <c:pt idx="221">
                  <c:v>2.1602686388610715</c:v>
                </c:pt>
                <c:pt idx="222">
                  <c:v>2.1721382850417061</c:v>
                </c:pt>
                <c:pt idx="223">
                  <c:v>2.1833318354342182</c:v>
                </c:pt>
                <c:pt idx="224">
                  <c:v>2.1938443472818649</c:v>
                </c:pt>
                <c:pt idx="225">
                  <c:v>2.2036711785553531</c:v>
                </c:pt>
                <c:pt idx="226">
                  <c:v>2.2128079900026307</c:v>
                </c:pt>
                <c:pt idx="227">
                  <c:v>2.2212507470649729</c:v>
                </c:pt>
                <c:pt idx="228">
                  <c:v>2.228995721658535</c:v>
                </c:pt>
                <c:pt idx="229">
                  <c:v>2.2360394938205661</c:v>
                </c:pt>
                <c:pt idx="230">
                  <c:v>2.2423789532195704</c:v>
                </c:pt>
                <c:pt idx="231">
                  <c:v>2.2480113005287388</c:v>
                </c:pt>
                <c:pt idx="232">
                  <c:v>2.2529340486620582</c:v>
                </c:pt>
                <c:pt idx="233">
                  <c:v>2.2571450238725328</c:v>
                </c:pt>
                <c:pt idx="234">
                  <c:v>2.2606423667120543</c:v>
                </c:pt>
                <c:pt idx="235">
                  <c:v>2.2634245328524787</c:v>
                </c:pt>
                <c:pt idx="236">
                  <c:v>2.2654902937675594</c:v>
                </c:pt>
                <c:pt idx="237">
                  <c:v>2.2668387372754299</c:v>
                </c:pt>
                <c:pt idx="238">
                  <c:v>2.2674692679413977</c:v>
                </c:pt>
                <c:pt idx="239">
                  <c:v>2.2673816073408704</c:v>
                </c:pt>
                <c:pt idx="240">
                  <c:v>2.2665757941823017</c:v>
                </c:pt>
                <c:pt idx="241">
                  <c:v>2.2650521842900977</c:v>
                </c:pt>
                <c:pt idx="242">
                  <c:v>2.2628114504474954</c:v>
                </c:pt>
                <c:pt idx="243">
                  <c:v>2.2598545820994813</c:v>
                </c:pt>
                <c:pt idx="244">
                  <c:v>2.2561828849158774</c:v>
                </c:pt>
                <c:pt idx="245">
                  <c:v>2.251797980214798</c:v>
                </c:pt>
                <c:pt idx="246">
                  <c:v>2.2467018042467193</c:v>
                </c:pt>
                <c:pt idx="247">
                  <c:v>2.2408966073394847</c:v>
                </c:pt>
                <c:pt idx="248">
                  <c:v>2.2343849529046271</c:v>
                </c:pt>
                <c:pt idx="249">
                  <c:v>2.2271697163054323</c:v>
                </c:pt>
                <c:pt idx="250">
                  <c:v>2.2192540835872672</c:v>
                </c:pt>
                <c:pt idx="251">
                  <c:v>2.2106415500707044</c:v>
                </c:pt>
                <c:pt idx="252">
                  <c:v>2.201335918808093</c:v>
                </c:pt>
                <c:pt idx="253">
                  <c:v>2.1913412989042342</c:v>
                </c:pt>
                <c:pt idx="254">
                  <c:v>2.180662103701918</c:v>
                </c:pt>
                <c:pt idx="255">
                  <c:v>2.1693030488331133</c:v>
                </c:pt>
                <c:pt idx="256">
                  <c:v>2.1572691501366799</c:v>
                </c:pt>
                <c:pt idx="257">
                  <c:v>2.1445657214435143</c:v>
                </c:pt>
                <c:pt idx="258">
                  <c:v>2.1311983722301111</c:v>
                </c:pt>
                <c:pt idx="259">
                  <c:v>2.1171730051415771</c:v>
                </c:pt>
                <c:pt idx="260">
                  <c:v>2.1024958133851879</c:v>
                </c:pt>
                <c:pt idx="261">
                  <c:v>2.0871732779956438</c:v>
                </c:pt>
                <c:pt idx="262">
                  <c:v>2.0712121649732254</c:v>
                </c:pt>
                <c:pt idx="263">
                  <c:v>2.0546195222961199</c:v>
                </c:pt>
                <c:pt idx="264">
                  <c:v>2.0374026768082314</c:v>
                </c:pt>
                <c:pt idx="265">
                  <c:v>2.019569230983854</c:v>
                </c:pt>
                <c:pt idx="266">
                  <c:v>2.0011270595706305</c:v>
                </c:pt>
                <c:pt idx="267">
                  <c:v>1.9820843061122897</c:v>
                </c:pt>
                <c:pt idx="268">
                  <c:v>1.9624493793526834</c:v>
                </c:pt>
                <c:pt idx="269">
                  <c:v>1.9422309495227226</c:v>
                </c:pt>
                <c:pt idx="270">
                  <c:v>1.9214379445118479</c:v>
                </c:pt>
                <c:pt idx="271">
                  <c:v>1.9000795459257267</c:v>
                </c:pt>
                <c:pt idx="272">
                  <c:v>1.878165185031909</c:v>
                </c:pt>
                <c:pt idx="273">
                  <c:v>1.8557045385952518</c:v>
                </c:pt>
                <c:pt idx="274">
                  <c:v>1.8327075246049287</c:v>
                </c:pt>
                <c:pt idx="275">
                  <c:v>1.8091842978949257</c:v>
                </c:pt>
                <c:pt idx="276">
                  <c:v>1.7851452456599519</c:v>
                </c:pt>
                <c:pt idx="277">
                  <c:v>1.7606009828687468</c:v>
                </c:pt>
                <c:pt idx="278">
                  <c:v>1.7355623475768107</c:v>
                </c:pt>
                <c:pt idx="279">
                  <c:v>1.7100403961406214</c:v>
                </c:pt>
                <c:pt idx="280">
                  <c:v>1.6840463983354612</c:v>
                </c:pt>
                <c:pt idx="281">
                  <c:v>1.657591832379</c:v>
                </c:pt>
                <c:pt idx="282">
                  <c:v>1.630688379862838</c:v>
                </c:pt>
                <c:pt idx="283">
                  <c:v>1.6033479205942427</c:v>
                </c:pt>
                <c:pt idx="284">
                  <c:v>1.5755825273503619</c:v>
                </c:pt>
                <c:pt idx="285">
                  <c:v>1.5474044605472244</c:v>
                </c:pt>
                <c:pt idx="286">
                  <c:v>1.5188261628258857</c:v>
                </c:pt>
                <c:pt idx="287">
                  <c:v>1.4898602535581076</c:v>
                </c:pt>
                <c:pt idx="288">
                  <c:v>1.4605195232739989</c:v>
                </c:pt>
                <c:pt idx="289">
                  <c:v>1.4308169280140779</c:v>
                </c:pt>
                <c:pt idx="290">
                  <c:v>1.4007655836082493</c:v>
                </c:pt>
                <c:pt idx="291">
                  <c:v>1.3703787598842228</c:v>
                </c:pt>
                <c:pt idx="292">
                  <c:v>1.3396698748079308</c:v>
                </c:pt>
                <c:pt idx="293">
                  <c:v>1.3086524885585327</c:v>
                </c:pt>
                <c:pt idx="294">
                  <c:v>1.277340297540621</c:v>
                </c:pt>
                <c:pt idx="295">
                  <c:v>1.2457471283362753</c:v>
                </c:pt>
                <c:pt idx="296">
                  <c:v>1.2138869315996321</c:v>
                </c:pt>
                <c:pt idx="297">
                  <c:v>1.1817737758966693</c:v>
                </c:pt>
                <c:pt idx="298">
                  <c:v>1.1494218414929229</c:v>
                </c:pt>
                <c:pt idx="299">
                  <c:v>1.1168454140918829</c:v>
                </c:pt>
              </c:numCache>
            </c:numRef>
          </c:yVal>
          <c:smooth val="0"/>
        </c:ser>
        <c:ser>
          <c:idx val="2"/>
          <c:order val="2"/>
          <c:spPr>
            <a:ln w="19050">
              <a:noFill/>
            </a:ln>
          </c:spPr>
          <c:marker>
            <c:symbol val="none"/>
          </c:marker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388368"/>
        <c:axId val="283387584"/>
      </c:scatterChart>
      <c:valAx>
        <c:axId val="283388368"/>
        <c:scaling>
          <c:orientation val="minMax"/>
          <c:max val="4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387584"/>
        <c:crosses val="autoZero"/>
        <c:crossBetween val="midCat"/>
      </c:valAx>
      <c:valAx>
        <c:axId val="283387584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388368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922319806178074"/>
          <c:y val="0.10679611650485436"/>
          <c:w val="0.64894987886129618"/>
          <c:h val="0.71327997076023386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FF0000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FF0000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CD$1:$CD$15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6</c:v>
                </c:pt>
                <c:pt idx="6">
                  <c:v>9</c:v>
                </c:pt>
                <c:pt idx="7">
                  <c:v>13</c:v>
                </c:pt>
                <c:pt idx="8">
                  <c:v>13</c:v>
                </c:pt>
                <c:pt idx="9">
                  <c:v>6</c:v>
                </c:pt>
                <c:pt idx="10">
                  <c:v>6</c:v>
                </c:pt>
                <c:pt idx="11">
                  <c:v>4</c:v>
                </c:pt>
                <c:pt idx="12">
                  <c:v>9</c:v>
                </c:pt>
                <c:pt idx="13">
                  <c:v>6</c:v>
                </c:pt>
                <c:pt idx="14">
                  <c:v>8</c:v>
                </c:pt>
              </c:numCache>
            </c:numRef>
          </c:xVal>
          <c:yVal>
            <c:numRef>
              <c:f>'Covariance   Correlation3_HID4'!$CE$1:$CE$15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3999999999999998E-3</c:v>
                </c:pt>
                <c:pt idx="6">
                  <c:v>2.3E-3</c:v>
                </c:pt>
                <c:pt idx="7">
                  <c:v>2.8E-3</c:v>
                </c:pt>
                <c:pt idx="8">
                  <c:v>6.0000000000000001E-3</c:v>
                </c:pt>
                <c:pt idx="9">
                  <c:v>4.3E-3</c:v>
                </c:pt>
                <c:pt idx="10">
                  <c:v>3.5999999999999999E-3</c:v>
                </c:pt>
                <c:pt idx="11">
                  <c:v>0</c:v>
                </c:pt>
                <c:pt idx="12">
                  <c:v>1.8E-3</c:v>
                </c:pt>
                <c:pt idx="13">
                  <c:v>0</c:v>
                </c:pt>
                <c:pt idx="14">
                  <c:v>0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50</c:f>
              <c:numCache>
                <c:formatCode>General</c:formatCode>
                <c:ptCount val="300"/>
                <c:pt idx="0">
                  <c:v>-8.3236984376742704</c:v>
                </c:pt>
                <c:pt idx="1">
                  <c:v>-8.3206831572897997</c:v>
                </c:pt>
                <c:pt idx="2">
                  <c:v>-8.311638647599322</c:v>
                </c:pt>
                <c:pt idx="3">
                  <c:v>-8.2965689024037044</c:v>
                </c:pt>
                <c:pt idx="4">
                  <c:v>-8.2754805760781931</c:v>
                </c:pt>
                <c:pt idx="5">
                  <c:v>-8.2483829806340339</c:v>
                </c:pt>
                <c:pt idx="6">
                  <c:v>-8.2152880816065466</c:v>
                </c:pt>
                <c:pt idx="7">
                  <c:v>-8.1762104927714834</c:v>
                </c:pt>
                <c:pt idx="8">
                  <c:v>-8.1311674696919916</c:v>
                </c:pt>
                <c:pt idx="9">
                  <c:v>-8.0801789020990551</c:v>
                </c:pt>
                <c:pt idx="10">
                  <c:v>-8.02326730510873</c:v>
                </c:pt>
                <c:pt idx="11">
                  <c:v>-7.9604578092801255</c:v>
                </c:pt>
                <c:pt idx="12">
                  <c:v>-7.8917781495184389</c:v>
                </c:pt>
                <c:pt idx="13">
                  <c:v>-7.8172586528280075</c:v>
                </c:pt>
                <c:pt idx="14">
                  <c:v>-7.7369322249207624</c:v>
                </c:pt>
                <c:pt idx="15">
                  <c:v>-7.6508343356859836</c:v>
                </c:pt>
                <c:pt idx="16">
                  <c:v>-7.5590030035278062</c:v>
                </c:pt>
                <c:pt idx="17">
                  <c:v>-7.4614787785773533</c:v>
                </c:pt>
                <c:pt idx="18">
                  <c:v>-7.3583047247869402</c:v>
                </c:pt>
                <c:pt idx="19">
                  <c:v>-7.2495264009142577</c:v>
                </c:pt>
                <c:pt idx="20">
                  <c:v>-7.1351918404048895</c:v>
                </c:pt>
                <c:pt idx="21">
                  <c:v>-7.0153515301821088</c:v>
                </c:pt>
                <c:pt idx="22">
                  <c:v>-6.8900583883532676</c:v>
                </c:pt>
                <c:pt idx="23">
                  <c:v>-6.759367740842654</c:v>
                </c:pt>
                <c:pt idx="24">
                  <c:v>-6.6233372969611128</c:v>
                </c:pt>
                <c:pt idx="25">
                  <c:v>-6.482027123923249</c:v>
                </c:pt>
                <c:pt idx="26">
                  <c:v>-6.3354996203234322</c:v>
                </c:pt>
                <c:pt idx="27">
                  <c:v>-6.183819488582337</c:v>
                </c:pt>
                <c:pt idx="28">
                  <c:v>-6.0270537063761687</c:v>
                </c:pt>
                <c:pt idx="29">
                  <c:v>-5.8652714970612134</c:v>
                </c:pt>
                <c:pt idx="30">
                  <c:v>-5.6985442991067501</c:v>
                </c:pt>
                <c:pt idx="31">
                  <c:v>-5.5269457345498285</c:v>
                </c:pt>
                <c:pt idx="32">
                  <c:v>-5.3505515764858682</c:v>
                </c:pt>
                <c:pt idx="33">
                  <c:v>-5.1694397156093661</c:v>
                </c:pt>
                <c:pt idx="34">
                  <c:v>-4.9836901258195834</c:v>
                </c:pt>
                <c:pt idx="35">
                  <c:v>-4.7933848289062997</c:v>
                </c:pt>
                <c:pt idx="36">
                  <c:v>-4.5986078583313237</c:v>
                </c:pt>
                <c:pt idx="37">
                  <c:v>-4.3994452221216651</c:v>
                </c:pt>
                <c:pt idx="38">
                  <c:v>-4.195984864890816</c:v>
                </c:pt>
                <c:pt idx="39">
                  <c:v>-3.9883166290048884</c:v>
                </c:pt>
                <c:pt idx="40">
                  <c:v>-3.7765322149107483</c:v>
                </c:pt>
                <c:pt idx="41">
                  <c:v>-3.5607251406436866</c:v>
                </c:pt>
                <c:pt idx="42">
                  <c:v>-3.3409907005324833</c:v>
                </c:pt>
                <c:pt idx="43">
                  <c:v>-3.1174259231201109</c:v>
                </c:pt>
                <c:pt idx="44">
                  <c:v>-2.8901295283186723</c:v>
                </c:pt>
                <c:pt idx="45">
                  <c:v>-2.6592018838174587</c:v>
                </c:pt>
                <c:pt idx="46">
                  <c:v>-2.4247449607633991</c:v>
                </c:pt>
                <c:pt idx="47">
                  <c:v>-2.1868622887334848</c:v>
                </c:pt>
                <c:pt idx="48">
                  <c:v>-1.9456589100190129</c:v>
                </c:pt>
                <c:pt idx="49">
                  <c:v>-1.7012413332418719</c:v>
                </c:pt>
                <c:pt idx="50">
                  <c:v>-1.453717486323332</c:v>
                </c:pt>
                <c:pt idx="51">
                  <c:v>-1.2031966688261102</c:v>
                </c:pt>
                <c:pt idx="52">
                  <c:v>-0.94978950369076465</c:v>
                </c:pt>
                <c:pt idx="53">
                  <c:v>-0.69360788838771636</c:v>
                </c:pt>
                <c:pt idx="54">
                  <c:v>-0.43476494550648237</c:v>
                </c:pt>
                <c:pt idx="55">
                  <c:v>-0.17337497280390135</c:v>
                </c:pt>
                <c:pt idx="56">
                  <c:v>9.0446607266503776E-2</c:v>
                </c:pt>
                <c:pt idx="57">
                  <c:v>0.35658329852185577</c:v>
                </c:pt>
                <c:pt idx="58">
                  <c:v>0.62491758249134755</c:v>
                </c:pt>
                <c:pt idx="59">
                  <c:v>0.89533097030909747</c:v>
                </c:pt>
                <c:pt idx="60">
                  <c:v>1.167704055035494</c:v>
                </c:pt>
                <c:pt idx="61">
                  <c:v>1.4419165643839329</c:v>
                </c:pt>
                <c:pt idx="62">
                  <c:v>1.7178474138296895</c:v>
                </c:pt>
                <c:pt idx="63">
                  <c:v>1.9953747600774161</c:v>
                </c:pt>
                <c:pt idx="64">
                  <c:v>2.2743760548637235</c:v>
                </c:pt>
                <c:pt idx="65">
                  <c:v>2.554728099071041</c:v>
                </c:pt>
                <c:pt idx="66">
                  <c:v>2.8363070971288789</c:v>
                </c:pt>
                <c:pt idx="67">
                  <c:v>3.1189887116784663</c:v>
                </c:pt>
                <c:pt idx="68">
                  <c:v>3.4026481184766286</c:v>
                </c:pt>
                <c:pt idx="69">
                  <c:v>3.6871600615146676</c:v>
                </c:pt>
                <c:pt idx="70">
                  <c:v>3.9723989083278721</c:v>
                </c:pt>
                <c:pt idx="71">
                  <c:v>4.2582387054712916</c:v>
                </c:pt>
                <c:pt idx="72">
                  <c:v>4.5445532341372257</c:v>
                </c:pt>
                <c:pt idx="73">
                  <c:v>4.8312160658898993</c:v>
                </c:pt>
                <c:pt idx="74">
                  <c:v>5.1181006184926972</c:v>
                </c:pt>
                <c:pt idx="75">
                  <c:v>5.4050802118033179</c:v>
                </c:pt>
                <c:pt idx="76">
                  <c:v>5.6920281237121664</c:v>
                </c:pt>
                <c:pt idx="77">
                  <c:v>5.9788176460992535</c:v>
                </c:pt>
                <c:pt idx="78">
                  <c:v>6.2653221407849484</c:v>
                </c:pt>
                <c:pt idx="79">
                  <c:v>6.5514150954498289</c:v>
                </c:pt>
                <c:pt idx="80">
                  <c:v>6.8369701794989597</c:v>
                </c:pt>
                <c:pt idx="81">
                  <c:v>7.1218612998459285</c:v>
                </c:pt>
                <c:pt idx="82">
                  <c:v>7.405962656592</c:v>
                </c:pt>
                <c:pt idx="83">
                  <c:v>7.68914879857582</c:v>
                </c:pt>
                <c:pt idx="84">
                  <c:v>7.9712946787691017</c:v>
                </c:pt>
                <c:pt idx="85">
                  <c:v>8.2522757094938815</c:v>
                </c:pt>
                <c:pt idx="86">
                  <c:v>8.5319678174369304</c:v>
                </c:pt>
                <c:pt idx="87">
                  <c:v>8.810247498437036</c:v>
                </c:pt>
                <c:pt idx="88">
                  <c:v>9.0869918720209597</c:v>
                </c:pt>
                <c:pt idx="89">
                  <c:v>9.3620787356639958</c:v>
                </c:pt>
                <c:pt idx="90">
                  <c:v>9.6353866187511805</c:v>
                </c:pt>
                <c:pt idx="91">
                  <c:v>9.9067948362152656</c:v>
                </c:pt>
                <c:pt idx="92">
                  <c:v>10.176183541827875</c:v>
                </c:pt>
                <c:pt idx="93">
                  <c:v>10.443433781120209</c:v>
                </c:pt>
                <c:pt idx="94">
                  <c:v>10.708427543910002</c:v>
                </c:pt>
                <c:pt idx="95">
                  <c:v>10.971047816411481</c:v>
                </c:pt>
                <c:pt idx="96">
                  <c:v>11.231178632905372</c:v>
                </c:pt>
                <c:pt idx="97">
                  <c:v>11.488705126946096</c:v>
                </c:pt>
                <c:pt idx="98">
                  <c:v>11.743513582083548</c:v>
                </c:pt>
                <c:pt idx="99">
                  <c:v>11.995491482077092</c:v>
                </c:pt>
                <c:pt idx="100">
                  <c:v>12.244527560579559</c:v>
                </c:pt>
                <c:pt idx="101">
                  <c:v>12.49051185026933</c:v>
                </c:pt>
                <c:pt idx="102">
                  <c:v>12.733335731408822</c:v>
                </c:pt>
                <c:pt idx="103">
                  <c:v>12.972891979807894</c:v>
                </c:pt>
                <c:pt idx="104">
                  <c:v>13.209074814171037</c:v>
                </c:pt>
                <c:pt idx="105">
                  <c:v>13.441779942807415</c:v>
                </c:pt>
                <c:pt idx="106">
                  <c:v>13.670904609683134</c:v>
                </c:pt>
                <c:pt idx="107">
                  <c:v>13.896347639795428</c:v>
                </c:pt>
                <c:pt idx="108">
                  <c:v>14.118009483848683</c:v>
                </c:pt>
                <c:pt idx="109">
                  <c:v>14.335792262212598</c:v>
                </c:pt>
                <c:pt idx="110">
                  <c:v>14.549599808143082</c:v>
                </c:pt>
                <c:pt idx="111">
                  <c:v>14.759337710246781</c:v>
                </c:pt>
                <c:pt idx="112">
                  <c:v>14.96491335417049</c:v>
                </c:pt>
                <c:pt idx="113">
                  <c:v>15.166235963497041</c:v>
                </c:pt>
                <c:pt idx="114">
                  <c:v>15.363216639829616</c:v>
                </c:pt>
                <c:pt idx="115">
                  <c:v>15.555768402046786</c:v>
                </c:pt>
                <c:pt idx="116">
                  <c:v>15.743806224710902</c:v>
                </c:pt>
                <c:pt idx="117">
                  <c:v>15.927247075612961</c:v>
                </c:pt>
                <c:pt idx="118">
                  <c:v>16.106009952437276</c:v>
                </c:pt>
                <c:pt idx="119">
                  <c:v>16.280015918529813</c:v>
                </c:pt>
                <c:pt idx="120">
                  <c:v>16.449188137754426</c:v>
                </c:pt>
                <c:pt idx="121">
                  <c:v>16.613451908421482</c:v>
                </c:pt>
                <c:pt idx="122">
                  <c:v>16.772734696274085</c:v>
                </c:pt>
                <c:pt idx="123">
                  <c:v>16.926966166517104</c:v>
                </c:pt>
                <c:pt idx="124">
                  <c:v>17.076078214875075</c:v>
                </c:pt>
                <c:pt idx="125">
                  <c:v>17.220004997665121</c:v>
                </c:pt>
                <c:pt idx="126">
                  <c:v>17.358682960871661</c:v>
                </c:pt>
                <c:pt idx="127">
                  <c:v>17.492050868210089</c:v>
                </c:pt>
                <c:pt idx="128">
                  <c:v>17.620049828166984</c:v>
                </c:pt>
                <c:pt idx="129">
                  <c:v>17.742623320004949</c:v>
                </c:pt>
                <c:pt idx="130">
                  <c:v>17.859717218720569</c:v>
                </c:pt>
                <c:pt idx="131">
                  <c:v>17.971279818944502</c:v>
                </c:pt>
                <c:pt idx="132">
                  <c:v>18.077261857773109</c:v>
                </c:pt>
                <c:pt idx="133">
                  <c:v>18.177616536521548</c:v>
                </c:pt>
                <c:pt idx="134">
                  <c:v>18.27229954138879</c:v>
                </c:pt>
                <c:pt idx="135">
                  <c:v>18.361269063025325</c:v>
                </c:pt>
                <c:pt idx="136">
                  <c:v>18.44448581499498</c:v>
                </c:pt>
                <c:pt idx="137">
                  <c:v>18.521913051122745</c:v>
                </c:pt>
                <c:pt idx="138">
                  <c:v>18.593516581720806</c:v>
                </c:pt>
                <c:pt idx="139">
                  <c:v>18.659264788685775</c:v>
                </c:pt>
                <c:pt idx="140">
                  <c:v>18.719128639460344</c:v>
                </c:pt>
                <c:pt idx="141">
                  <c:v>18.773081699853243</c:v>
                </c:pt>
                <c:pt idx="142">
                  <c:v>18.821100145711846</c:v>
                </c:pt>
                <c:pt idx="143">
                  <c:v>18.863162773442234</c:v>
                </c:pt>
                <c:pt idx="144">
                  <c:v>18.899251009372115</c:v>
                </c:pt>
                <c:pt idx="145">
                  <c:v>18.929348917952431</c:v>
                </c:pt>
                <c:pt idx="146">
                  <c:v>18.953443208794035</c:v>
                </c:pt>
                <c:pt idx="147">
                  <c:v>18.971523242536382</c:v>
                </c:pt>
                <c:pt idx="148">
                  <c:v>18.983581035545541</c:v>
                </c:pt>
                <c:pt idx="149">
                  <c:v>18.989611263439556</c:v>
                </c:pt>
                <c:pt idx="150">
                  <c:v>18.989611263439556</c:v>
                </c:pt>
                <c:pt idx="151">
                  <c:v>18.983581035545534</c:v>
                </c:pt>
                <c:pt idx="152">
                  <c:v>18.971523242536371</c:v>
                </c:pt>
                <c:pt idx="153">
                  <c:v>18.95344320879402</c:v>
                </c:pt>
                <c:pt idx="154">
                  <c:v>18.92934891795241</c:v>
                </c:pt>
                <c:pt idx="155">
                  <c:v>18.899251009372094</c:v>
                </c:pt>
                <c:pt idx="156">
                  <c:v>18.863162773442205</c:v>
                </c:pt>
                <c:pt idx="157">
                  <c:v>18.82110014571181</c:v>
                </c:pt>
                <c:pt idx="158">
                  <c:v>18.773081699853208</c:v>
                </c:pt>
                <c:pt idx="159">
                  <c:v>18.719128639460301</c:v>
                </c:pt>
                <c:pt idx="160">
                  <c:v>18.659264788685732</c:v>
                </c:pt>
                <c:pt idx="161">
                  <c:v>18.593516581720756</c:v>
                </c:pt>
                <c:pt idx="162">
                  <c:v>18.521913051122691</c:v>
                </c:pt>
                <c:pt idx="163">
                  <c:v>18.444485814994923</c:v>
                </c:pt>
                <c:pt idx="164">
                  <c:v>18.361269063025262</c:v>
                </c:pt>
                <c:pt idx="165">
                  <c:v>18.272299541388726</c:v>
                </c:pt>
                <c:pt idx="166">
                  <c:v>18.17761653652148</c:v>
                </c:pt>
                <c:pt idx="167">
                  <c:v>18.077261857773035</c:v>
                </c:pt>
                <c:pt idx="168">
                  <c:v>17.971279818944428</c:v>
                </c:pt>
                <c:pt idx="169">
                  <c:v>17.85971721872049</c:v>
                </c:pt>
                <c:pt idx="170">
                  <c:v>17.742623320004867</c:v>
                </c:pt>
                <c:pt idx="171">
                  <c:v>17.620049828166898</c:v>
                </c:pt>
                <c:pt idx="172">
                  <c:v>17.492050868210001</c:v>
                </c:pt>
                <c:pt idx="173">
                  <c:v>17.358682960871565</c:v>
                </c:pt>
                <c:pt idx="174">
                  <c:v>17.220004997665022</c:v>
                </c:pt>
                <c:pt idx="175">
                  <c:v>17.076078214874975</c:v>
                </c:pt>
                <c:pt idx="176">
                  <c:v>16.926966166516998</c:v>
                </c:pt>
                <c:pt idx="177">
                  <c:v>16.772734696273975</c:v>
                </c:pt>
                <c:pt idx="178">
                  <c:v>16.613451908421375</c:v>
                </c:pt>
                <c:pt idx="179">
                  <c:v>16.449188137754305</c:v>
                </c:pt>
                <c:pt idx="180">
                  <c:v>16.280015918529692</c:v>
                </c:pt>
                <c:pt idx="181">
                  <c:v>16.106009952437148</c:v>
                </c:pt>
                <c:pt idx="182">
                  <c:v>15.927247075612835</c:v>
                </c:pt>
                <c:pt idx="183">
                  <c:v>15.743806224710774</c:v>
                </c:pt>
                <c:pt idx="184">
                  <c:v>15.555768402046652</c:v>
                </c:pt>
                <c:pt idx="185">
                  <c:v>15.363216639829481</c:v>
                </c:pt>
                <c:pt idx="186">
                  <c:v>15.1662359634969</c:v>
                </c:pt>
                <c:pt idx="187">
                  <c:v>14.964913354170349</c:v>
                </c:pt>
                <c:pt idx="188">
                  <c:v>14.759337710246637</c:v>
                </c:pt>
                <c:pt idx="189">
                  <c:v>14.549599808142935</c:v>
                </c:pt>
                <c:pt idx="190">
                  <c:v>14.335792262212447</c:v>
                </c:pt>
                <c:pt idx="191">
                  <c:v>14.118009483848535</c:v>
                </c:pt>
                <c:pt idx="192">
                  <c:v>13.896347639795277</c:v>
                </c:pt>
                <c:pt idx="193">
                  <c:v>13.670904609682978</c:v>
                </c:pt>
                <c:pt idx="194">
                  <c:v>13.441779942807253</c:v>
                </c:pt>
                <c:pt idx="195">
                  <c:v>13.209074814170872</c:v>
                </c:pt>
                <c:pt idx="196">
                  <c:v>12.972891979807729</c:v>
                </c:pt>
                <c:pt idx="197">
                  <c:v>12.733335731408655</c:v>
                </c:pt>
                <c:pt idx="198">
                  <c:v>12.490511850269161</c:v>
                </c:pt>
                <c:pt idx="199">
                  <c:v>12.244527560579385</c:v>
                </c:pt>
                <c:pt idx="200">
                  <c:v>11.995491482076918</c:v>
                </c:pt>
                <c:pt idx="201">
                  <c:v>11.743513582083372</c:v>
                </c:pt>
                <c:pt idx="202">
                  <c:v>11.488705126945916</c:v>
                </c:pt>
                <c:pt idx="203">
                  <c:v>11.231178632905191</c:v>
                </c:pt>
                <c:pt idx="204">
                  <c:v>10.971047816411296</c:v>
                </c:pt>
                <c:pt idx="205">
                  <c:v>10.708427543909815</c:v>
                </c:pt>
                <c:pt idx="206">
                  <c:v>10.443433781120021</c:v>
                </c:pt>
                <c:pt idx="207">
                  <c:v>10.176183541827683</c:v>
                </c:pt>
                <c:pt idx="208">
                  <c:v>9.9067948362150737</c:v>
                </c:pt>
                <c:pt idx="209">
                  <c:v>9.6353866187509851</c:v>
                </c:pt>
                <c:pt idx="210">
                  <c:v>9.3620787356638022</c:v>
                </c:pt>
                <c:pt idx="211">
                  <c:v>9.0869918720207608</c:v>
                </c:pt>
                <c:pt idx="212">
                  <c:v>8.8102474984368353</c:v>
                </c:pt>
                <c:pt idx="213">
                  <c:v>8.5319678174367297</c:v>
                </c:pt>
                <c:pt idx="214">
                  <c:v>8.2522757094936914</c:v>
                </c:pt>
                <c:pt idx="215">
                  <c:v>7.9712946787689107</c:v>
                </c:pt>
                <c:pt idx="216">
                  <c:v>7.6891487985756291</c:v>
                </c:pt>
                <c:pt idx="217">
                  <c:v>7.4059626565918082</c:v>
                </c:pt>
                <c:pt idx="218">
                  <c:v>7.1218612998457331</c:v>
                </c:pt>
                <c:pt idx="219">
                  <c:v>6.8369701794987634</c:v>
                </c:pt>
                <c:pt idx="220">
                  <c:v>6.5514150954496326</c:v>
                </c:pt>
                <c:pt idx="221">
                  <c:v>6.2653221407847521</c:v>
                </c:pt>
                <c:pt idx="222">
                  <c:v>5.9788176460990563</c:v>
                </c:pt>
                <c:pt idx="223">
                  <c:v>5.6920281237119692</c:v>
                </c:pt>
                <c:pt idx="224">
                  <c:v>5.4050802118031207</c:v>
                </c:pt>
                <c:pt idx="225">
                  <c:v>5.1181006184924973</c:v>
                </c:pt>
                <c:pt idx="226">
                  <c:v>4.8312160658896994</c:v>
                </c:pt>
                <c:pt idx="227">
                  <c:v>4.5445532341370258</c:v>
                </c:pt>
                <c:pt idx="228">
                  <c:v>4.2582387054710917</c:v>
                </c:pt>
                <c:pt idx="229">
                  <c:v>3.9723989083276732</c:v>
                </c:pt>
                <c:pt idx="230">
                  <c:v>3.6871600615144686</c:v>
                </c:pt>
                <c:pt idx="231">
                  <c:v>3.4026481184764306</c:v>
                </c:pt>
                <c:pt idx="232">
                  <c:v>3.118988711678266</c:v>
                </c:pt>
                <c:pt idx="233">
                  <c:v>2.836307097128679</c:v>
                </c:pt>
                <c:pt idx="234">
                  <c:v>2.5547280990708421</c:v>
                </c:pt>
                <c:pt idx="235">
                  <c:v>2.2743760548635255</c:v>
                </c:pt>
                <c:pt idx="236">
                  <c:v>1.9953747600772194</c:v>
                </c:pt>
                <c:pt idx="237">
                  <c:v>1.7178474138294937</c:v>
                </c:pt>
                <c:pt idx="238">
                  <c:v>1.4419165643837384</c:v>
                </c:pt>
                <c:pt idx="239">
                  <c:v>1.1677040550352977</c:v>
                </c:pt>
                <c:pt idx="240">
                  <c:v>0.89533097030890296</c:v>
                </c:pt>
                <c:pt idx="241">
                  <c:v>0.62491758249115392</c:v>
                </c:pt>
                <c:pt idx="242">
                  <c:v>0.35658329852167459</c:v>
                </c:pt>
                <c:pt idx="243">
                  <c:v>9.0446607266325252E-2</c:v>
                </c:pt>
                <c:pt idx="244">
                  <c:v>-0.17337497280407899</c:v>
                </c:pt>
                <c:pt idx="245">
                  <c:v>-0.43476494550665823</c:v>
                </c:pt>
                <c:pt idx="246">
                  <c:v>-0.69360788838789578</c:v>
                </c:pt>
                <c:pt idx="247">
                  <c:v>-0.94978950369094228</c:v>
                </c:pt>
                <c:pt idx="248">
                  <c:v>-1.2031966688262861</c:v>
                </c:pt>
                <c:pt idx="249">
                  <c:v>-1.4537174863235061</c:v>
                </c:pt>
                <c:pt idx="250">
                  <c:v>-1.7012413332420451</c:v>
                </c:pt>
                <c:pt idx="251">
                  <c:v>-1.9456589100191835</c:v>
                </c:pt>
                <c:pt idx="252">
                  <c:v>-2.1868622887336517</c:v>
                </c:pt>
                <c:pt idx="253">
                  <c:v>-2.4247449607635625</c:v>
                </c:pt>
                <c:pt idx="254">
                  <c:v>-2.6592018838176203</c:v>
                </c:pt>
                <c:pt idx="255">
                  <c:v>-2.890129528318834</c:v>
                </c:pt>
                <c:pt idx="256">
                  <c:v>-3.117425923120269</c:v>
                </c:pt>
                <c:pt idx="257">
                  <c:v>-3.3409907005326378</c:v>
                </c:pt>
                <c:pt idx="258">
                  <c:v>-3.5607251406438376</c:v>
                </c:pt>
                <c:pt idx="259">
                  <c:v>-3.7765322149108975</c:v>
                </c:pt>
                <c:pt idx="260">
                  <c:v>-3.988316629005034</c:v>
                </c:pt>
                <c:pt idx="261">
                  <c:v>-4.1959848648909599</c:v>
                </c:pt>
                <c:pt idx="262">
                  <c:v>-4.3994452221218054</c:v>
                </c:pt>
                <c:pt idx="263">
                  <c:v>-4.5986078583314605</c:v>
                </c:pt>
                <c:pt idx="264">
                  <c:v>-4.7933848289064347</c:v>
                </c:pt>
                <c:pt idx="265">
                  <c:v>-4.9836901258197148</c:v>
                </c:pt>
                <c:pt idx="266">
                  <c:v>-5.1694397156094976</c:v>
                </c:pt>
                <c:pt idx="267">
                  <c:v>-5.3505515764859961</c:v>
                </c:pt>
                <c:pt idx="268">
                  <c:v>-5.5269457345499546</c:v>
                </c:pt>
                <c:pt idx="269">
                  <c:v>-5.6985442991068709</c:v>
                </c:pt>
                <c:pt idx="270">
                  <c:v>-5.8652714970613307</c:v>
                </c:pt>
                <c:pt idx="271">
                  <c:v>-6.027053706376277</c:v>
                </c:pt>
                <c:pt idx="272">
                  <c:v>-6.18381948858244</c:v>
                </c:pt>
                <c:pt idx="273">
                  <c:v>-6.3354996203235334</c:v>
                </c:pt>
                <c:pt idx="274">
                  <c:v>-6.4820271239233449</c:v>
                </c:pt>
                <c:pt idx="275">
                  <c:v>-6.623337296961207</c:v>
                </c:pt>
                <c:pt idx="276">
                  <c:v>-6.7593677408427446</c:v>
                </c:pt>
                <c:pt idx="277">
                  <c:v>-6.8900583883533582</c:v>
                </c:pt>
                <c:pt idx="278">
                  <c:v>-7.0153515301821958</c:v>
                </c:pt>
                <c:pt idx="279">
                  <c:v>-7.135191840404973</c:v>
                </c:pt>
                <c:pt idx="280">
                  <c:v>-7.2495264009143359</c:v>
                </c:pt>
                <c:pt idx="281">
                  <c:v>-7.3583047247870148</c:v>
                </c:pt>
                <c:pt idx="282">
                  <c:v>-7.4614787785774226</c:v>
                </c:pt>
                <c:pt idx="283">
                  <c:v>-7.5590030035278737</c:v>
                </c:pt>
                <c:pt idx="284">
                  <c:v>-7.6508343356860458</c:v>
                </c:pt>
                <c:pt idx="285">
                  <c:v>-7.7369322249208192</c:v>
                </c:pt>
                <c:pt idx="286">
                  <c:v>-7.8172586528280608</c:v>
                </c:pt>
                <c:pt idx="287">
                  <c:v>-7.8917781495184887</c:v>
                </c:pt>
                <c:pt idx="288">
                  <c:v>-7.9604578092801717</c:v>
                </c:pt>
                <c:pt idx="289">
                  <c:v>-8.0232673051087726</c:v>
                </c:pt>
                <c:pt idx="290">
                  <c:v>-8.0801789020990924</c:v>
                </c:pt>
                <c:pt idx="291">
                  <c:v>-8.1311674696920253</c:v>
                </c:pt>
                <c:pt idx="292">
                  <c:v>-8.1762104927715118</c:v>
                </c:pt>
                <c:pt idx="293">
                  <c:v>-8.2152880816065732</c:v>
                </c:pt>
                <c:pt idx="294">
                  <c:v>-8.2483829806340552</c:v>
                </c:pt>
                <c:pt idx="295">
                  <c:v>-8.2754805760782091</c:v>
                </c:pt>
                <c:pt idx="296">
                  <c:v>-8.2965689024037168</c:v>
                </c:pt>
                <c:pt idx="297">
                  <c:v>-8.3116386475993291</c:v>
                </c:pt>
                <c:pt idx="298">
                  <c:v>-8.320683157289805</c:v>
                </c:pt>
                <c:pt idx="299">
                  <c:v>-8.3236984376742704</c:v>
                </c:pt>
              </c:numCache>
            </c:numRef>
          </c:xVal>
          <c:yVal>
            <c:numRef>
              <c:f>'Covariance   Correlation3'!yycir51</c:f>
              <c:numCache>
                <c:formatCode>General</c:formatCode>
                <c:ptCount val="300"/>
                <c:pt idx="0">
                  <c:v>-2.5220526323048139E-3</c:v>
                </c:pt>
                <c:pt idx="1">
                  <c:v>-2.6108765011434005E-3</c:v>
                </c:pt>
                <c:pt idx="2">
                  <c:v>-2.6978350778354429E-3</c:v>
                </c:pt>
                <c:pt idx="3">
                  <c:v>-2.7828899639214563E-3</c:v>
                </c:pt>
                <c:pt idx="4">
                  <c:v>-2.8660036015581399E-3</c:v>
                </c:pt>
                <c:pt idx="5">
                  <c:v>-2.9471392901028576E-3</c:v>
                </c:pt>
                <c:pt idx="6">
                  <c:v>-3.0262612023196091E-3</c:v>
                </c:pt>
                <c:pt idx="7">
                  <c:v>-3.1033344001993321E-3</c:v>
                </c:pt>
                <c:pt idx="8">
                  <c:v>-3.1783248503875448E-3</c:v>
                </c:pt>
                <c:pt idx="9">
                  <c:v>-3.2511994392125107E-3</c:v>
                </c:pt>
                <c:pt idx="10">
                  <c:v>-3.3219259873073065E-3</c:v>
                </c:pt>
                <c:pt idx="11">
                  <c:v>-3.390473263819329E-3</c:v>
                </c:pt>
                <c:pt idx="12">
                  <c:v>-3.4568110002009527E-3</c:v>
                </c:pt>
                <c:pt idx="13">
                  <c:v>-3.5209099035752763E-3</c:v>
                </c:pt>
                <c:pt idx="14">
                  <c:v>-3.5827416696710287E-3</c:v>
                </c:pt>
                <c:pt idx="15">
                  <c:v>-3.6422789953209347E-3</c:v>
                </c:pt>
                <c:pt idx="16">
                  <c:v>-3.6994955905180335E-3</c:v>
                </c:pt>
                <c:pt idx="17">
                  <c:v>-3.7543661900245979E-3</c:v>
                </c:pt>
                <c:pt idx="18">
                  <c:v>-3.8068665645285566E-3</c:v>
                </c:pt>
                <c:pt idx="19">
                  <c:v>-3.8569735313424749E-3</c:v>
                </c:pt>
                <c:pt idx="20">
                  <c:v>-3.9046649646403758E-3</c:v>
                </c:pt>
                <c:pt idx="21">
                  <c:v>-3.949919805227884E-3</c:v>
                </c:pt>
                <c:pt idx="22">
                  <c:v>-3.9927180698413715E-3</c:v>
                </c:pt>
                <c:pt idx="23">
                  <c:v>-4.0330408599720041E-3</c:v>
                </c:pt>
                <c:pt idx="24">
                  <c:v>-4.0708703702107959E-3</c:v>
                </c:pt>
                <c:pt idx="25">
                  <c:v>-4.1061898961109681E-3</c:v>
                </c:pt>
                <c:pt idx="26">
                  <c:v>-4.1389838415641679E-3</c:v>
                </c:pt>
                <c:pt idx="27">
                  <c:v>-4.1692377256872708E-3</c:v>
                </c:pt>
                <c:pt idx="28">
                  <c:v>-4.1969381892167298E-3</c:v>
                </c:pt>
                <c:pt idx="29">
                  <c:v>-4.2220730004076503E-3</c:v>
                </c:pt>
                <c:pt idx="30">
                  <c:v>-4.2446310604349839E-3</c:v>
                </c:pt>
                <c:pt idx="31">
                  <c:v>-4.2646024082944583E-3</c:v>
                </c:pt>
                <c:pt idx="32">
                  <c:v>-4.2819782252010745E-3</c:v>
                </c:pt>
                <c:pt idx="33">
                  <c:v>-4.2967508384832362E-3</c:v>
                </c:pt>
                <c:pt idx="34">
                  <c:v>-4.3089137249707832E-3</c:v>
                </c:pt>
                <c:pt idx="35">
                  <c:v>-4.3184615138754431E-3</c:v>
                </c:pt>
                <c:pt idx="36">
                  <c:v>-4.3253899891624158E-3</c:v>
                </c:pt>
                <c:pt idx="37">
                  <c:v>-4.3296960914120603E-3</c:v>
                </c:pt>
                <c:pt idx="38">
                  <c:v>-4.3313779191708436E-3</c:v>
                </c:pt>
                <c:pt idx="39">
                  <c:v>-4.3304347297909735E-3</c:v>
                </c:pt>
                <c:pt idx="40">
                  <c:v>-4.3268669397583288E-3</c:v>
                </c:pt>
                <c:pt idx="41">
                  <c:v>-4.3206761245085483E-3</c:v>
                </c:pt>
                <c:pt idx="42">
                  <c:v>-4.3118650177313709E-3</c:v>
                </c:pt>
                <c:pt idx="43">
                  <c:v>-4.3004375101635042E-3</c:v>
                </c:pt>
                <c:pt idx="44">
                  <c:v>-4.2863986478705934E-3</c:v>
                </c:pt>
                <c:pt idx="45">
                  <c:v>-4.2697546300190176E-3</c:v>
                </c:pt>
                <c:pt idx="46">
                  <c:v>-4.2505128061385107E-3</c:v>
                </c:pt>
                <c:pt idx="47">
                  <c:v>-4.22868167287682E-3</c:v>
                </c:pt>
                <c:pt idx="48">
                  <c:v>-4.2042708702478213E-3</c:v>
                </c:pt>
                <c:pt idx="49">
                  <c:v>-4.1772911773747638E-3</c:v>
                </c:pt>
                <c:pt idx="50">
                  <c:v>-4.1477545077305122E-3</c:v>
                </c:pt>
                <c:pt idx="51">
                  <c:v>-4.1156739038768885E-3</c:v>
                </c:pt>
                <c:pt idx="52">
                  <c:v>-4.0810635317054481E-3</c:v>
                </c:pt>
                <c:pt idx="53">
                  <c:v>-4.0439386741822226E-3</c:v>
                </c:pt>
                <c:pt idx="54">
                  <c:v>-4.0043157245991858E-3</c:v>
                </c:pt>
                <c:pt idx="55">
                  <c:v>-3.9622121793354411E-3</c:v>
                </c:pt>
                <c:pt idx="56">
                  <c:v>-3.9176466301313146E-3</c:v>
                </c:pt>
                <c:pt idx="57">
                  <c:v>-3.8706387558787624E-3</c:v>
                </c:pt>
                <c:pt idx="58">
                  <c:v>-3.8212093139317303E-3</c:v>
                </c:pt>
                <c:pt idx="59">
                  <c:v>-3.7693801309402857E-3</c:v>
                </c:pt>
                <c:pt idx="60">
                  <c:v>-3.7151740932125864E-3</c:v>
                </c:pt>
                <c:pt idx="61">
                  <c:v>-3.6586151366089312E-3</c:v>
                </c:pt>
                <c:pt idx="62">
                  <c:v>-3.5997282359723571E-3</c:v>
                </c:pt>
                <c:pt idx="63">
                  <c:v>-3.5385393941004496E-3</c:v>
                </c:pt>
                <c:pt idx="64">
                  <c:v>-3.475075630263245E-3</c:v>
                </c:pt>
                <c:pt idx="65">
                  <c:v>-3.4093649682722747E-3</c:v>
                </c:pt>
                <c:pt idx="66">
                  <c:v>-3.341436424106043E-3</c:v>
                </c:pt>
                <c:pt idx="67">
                  <c:v>-3.2713199930973886E-3</c:v>
                </c:pt>
                <c:pt idx="68">
                  <c:v>-3.1990466366883866E-3</c:v>
                </c:pt>
                <c:pt idx="69">
                  <c:v>-3.1246482687586471E-3</c:v>
                </c:pt>
                <c:pt idx="70">
                  <c:v>-3.0481577415330504E-3</c:v>
                </c:pt>
                <c:pt idx="71">
                  <c:v>-2.9696088310751231E-3</c:v>
                </c:pt>
                <c:pt idx="72">
                  <c:v>-2.8890362223724809E-3</c:v>
                </c:pt>
                <c:pt idx="73">
                  <c:v>-2.806475494020915E-3</c:v>
                </c:pt>
                <c:pt idx="74">
                  <c:v>-2.7219631025138858E-3</c:v>
                </c:pt>
                <c:pt idx="75">
                  <c:v>-2.6355363661443639E-3</c:v>
                </c:pt>
                <c:pt idx="76">
                  <c:v>-2.5472334485261154E-3</c:v>
                </c:pt>
                <c:pt idx="77">
                  <c:v>-2.4570933417417335E-3</c:v>
                </c:pt>
                <c:pt idx="78">
                  <c:v>-2.3651558491248263E-3</c:v>
                </c:pt>
                <c:pt idx="79">
                  <c:v>-2.2714615676839873E-3</c:v>
                </c:pt>
                <c:pt idx="80">
                  <c:v>-2.1760518701762995E-3</c:v>
                </c:pt>
                <c:pt idx="81">
                  <c:v>-2.0789688868382886E-3</c:v>
                </c:pt>
                <c:pt idx="82">
                  <c:v>-1.9802554867824015E-3</c:v>
                </c:pt>
                <c:pt idx="83">
                  <c:v>-1.8799552590672041E-3</c:v>
                </c:pt>
                <c:pt idx="84">
                  <c:v>-1.7781124934496914E-3</c:v>
                </c:pt>
                <c:pt idx="85">
                  <c:v>-1.6747721608281669E-3</c:v>
                </c:pt>
                <c:pt idx="86">
                  <c:v>-1.5699798933843691E-3</c:v>
                </c:pt>
                <c:pt idx="87">
                  <c:v>-1.4637819644335781E-3</c:v>
                </c:pt>
                <c:pt idx="88">
                  <c:v>-1.3562252679916239E-3</c:v>
                </c:pt>
                <c:pt idx="89">
                  <c:v>-1.2473572980678126E-3</c:v>
                </c:pt>
                <c:pt idx="90">
                  <c:v>-1.1372261276929019E-3</c:v>
                </c:pt>
                <c:pt idx="91">
                  <c:v>-1.0258803876914107E-3</c:v>
                </c:pt>
                <c:pt idx="92">
                  <c:v>-9.1336924520761444E-4</c:v>
                </c:pt>
                <c:pt idx="93">
                  <c:v>-7.9974238199471493E-4</c:v>
                </c:pt>
                <c:pt idx="94">
                  <c:v>-6.8504997247677973E-4</c:v>
                </c:pt>
                <c:pt idx="95">
                  <c:v>-5.6934266159313057E-4</c:v>
                </c:pt>
                <c:pt idx="96">
                  <c:v>-4.5267154243496042E-4</c:v>
                </c:pt>
                <c:pt idx="97">
                  <c:v>-3.3508813368406066E-4</c:v>
                </c:pt>
                <c:pt idx="98">
                  <c:v>-2.1664435686362892E-4</c:v>
                </c:pt>
                <c:pt idx="99">
                  <c:v>-9.7392513411181155E-5</c:v>
                </c:pt>
                <c:pt idx="100">
                  <c:v>2.2614738416291014E-5</c:v>
                </c:pt>
                <c:pt idx="101">
                  <c:v>1.4332440679472183E-4</c:v>
                </c:pt>
                <c:pt idx="102">
                  <c:v>2.6468318973267221E-4</c:v>
                </c:pt>
                <c:pt idx="103">
                  <c:v>3.866374986079852E-4</c:v>
                </c:pt>
                <c:pt idx="104">
                  <c:v>5.0913348183101621E-4</c:v>
                </c:pt>
                <c:pt idx="105">
                  <c:v>6.3211704862397612E-4</c:v>
                </c:pt>
                <c:pt idx="106">
                  <c:v>7.5553389290589643E-4</c:v>
                </c:pt>
                <c:pt idx="107">
                  <c:v>8.7932951727266858E-4</c:v>
                </c:pt>
                <c:pt idx="108">
                  <c:v>1.0034492570615643E-3</c:v>
                </c:pt>
                <c:pt idx="109">
                  <c:v>1.1278383044896045E-3</c:v>
                </c:pt>
                <c:pt idx="110">
                  <c:v>1.252441732855139E-3</c:v>
                </c:pt>
                <c:pt idx="111">
                  <c:v>1.3772045207919308E-3</c:v>
                </c:pt>
                <c:pt idx="112">
                  <c:v>1.5020715765650438E-3</c:v>
                </c:pt>
                <c:pt idx="113">
                  <c:v>1.6269877623977993E-3</c:v>
                </c:pt>
                <c:pt idx="114">
                  <c:v>1.7518979188190682E-3</c:v>
                </c:pt>
                <c:pt idx="115">
                  <c:v>1.8767468890201386E-3</c:v>
                </c:pt>
                <c:pt idx="116">
                  <c:v>2.0014795432104124E-3</c:v>
                </c:pt>
                <c:pt idx="117">
                  <c:v>2.1260408029611655E-3</c:v>
                </c:pt>
                <c:pt idx="118">
                  <c:v>2.2503756655266362E-3</c:v>
                </c:pt>
                <c:pt idx="119">
                  <c:v>2.3744292281316832E-3</c:v>
                </c:pt>
                <c:pt idx="120">
                  <c:v>2.4981467122153112E-3</c:v>
                </c:pt>
                <c:pt idx="121">
                  <c:v>2.6214734876193356E-3</c:v>
                </c:pt>
                <c:pt idx="122">
                  <c:v>2.7443550967115342E-3</c:v>
                </c:pt>
                <c:pt idx="123">
                  <c:v>2.8667372784325867E-3</c:v>
                </c:pt>
                <c:pt idx="124">
                  <c:v>2.9885659922562445E-3</c:v>
                </c:pt>
                <c:pt idx="125">
                  <c:v>3.1097874420521021E-3</c:v>
                </c:pt>
                <c:pt idx="126">
                  <c:v>3.2303480998404511E-3</c:v>
                </c:pt>
                <c:pt idx="127">
                  <c:v>3.3501947294287343E-3</c:v>
                </c:pt>
                <c:pt idx="128">
                  <c:v>3.4692744099191464E-3</c:v>
                </c:pt>
                <c:pt idx="129">
                  <c:v>3.5875345590770111E-3</c:v>
                </c:pt>
                <c:pt idx="130">
                  <c:v>3.704922956549621E-3</c:v>
                </c:pt>
                <c:pt idx="131">
                  <c:v>3.8213877669252697E-3</c:v>
                </c:pt>
                <c:pt idx="132">
                  <c:v>3.9368775626223134E-3</c:v>
                </c:pt>
                <c:pt idx="133">
                  <c:v>4.0513413465981425E-3</c:v>
                </c:pt>
                <c:pt idx="134">
                  <c:v>4.1647285748680415E-3</c:v>
                </c:pt>
                <c:pt idx="135">
                  <c:v>4.2769891788239853E-3</c:v>
                </c:pt>
                <c:pt idx="136">
                  <c:v>4.3880735873435307E-3</c:v>
                </c:pt>
                <c:pt idx="137">
                  <c:v>4.4979327486790359E-3</c:v>
                </c:pt>
                <c:pt idx="138">
                  <c:v>4.6065181521175108E-3</c:v>
                </c:pt>
                <c:pt idx="139">
                  <c:v>4.7137818494016022E-3</c:v>
                </c:pt>
                <c:pt idx="140">
                  <c:v>4.8196764759021868E-3</c:v>
                </c:pt>
                <c:pt idx="141">
                  <c:v>4.9241552715332555E-3</c:v>
                </c:pt>
                <c:pt idx="142">
                  <c:v>5.0271721013998572E-3</c:v>
                </c:pt>
                <c:pt idx="143">
                  <c:v>5.128681476169965E-3</c:v>
                </c:pt>
                <c:pt idx="144">
                  <c:v>5.2286385721612852E-3</c:v>
                </c:pt>
                <c:pt idx="145">
                  <c:v>5.326999251134135E-3</c:v>
                </c:pt>
                <c:pt idx="146">
                  <c:v>5.4237200797816474E-3</c:v>
                </c:pt>
                <c:pt idx="147">
                  <c:v>5.5187583489086931E-3</c:v>
                </c:pt>
                <c:pt idx="148">
                  <c:v>5.6120720922910629E-3</c:v>
                </c:pt>
                <c:pt idx="149">
                  <c:v>5.7036201052065661E-3</c:v>
                </c:pt>
                <c:pt idx="150">
                  <c:v>5.7933619626298815E-3</c:v>
                </c:pt>
                <c:pt idx="151">
                  <c:v>5.8812580370831103E-3</c:v>
                </c:pt>
                <c:pt idx="152">
                  <c:v>5.9672695161341466E-3</c:v>
                </c:pt>
                <c:pt idx="153">
                  <c:v>6.051358419535165E-3</c:v>
                </c:pt>
                <c:pt idx="154">
                  <c:v>6.1334876159936224E-3</c:v>
                </c:pt>
                <c:pt idx="155">
                  <c:v>6.2136208395683927E-3</c:v>
                </c:pt>
                <c:pt idx="156">
                  <c:v>6.2917227056837888E-3</c:v>
                </c:pt>
                <c:pt idx="157">
                  <c:v>6.3677587267543922E-3</c:v>
                </c:pt>
                <c:pt idx="158">
                  <c:v>6.4416953274137982E-3</c:v>
                </c:pt>
                <c:pt idx="159">
                  <c:v>6.513499859340556E-3</c:v>
                </c:pt>
                <c:pt idx="160">
                  <c:v>6.5831406156747468E-3</c:v>
                </c:pt>
                <c:pt idx="161">
                  <c:v>6.6505868450188414E-3</c:v>
                </c:pt>
                <c:pt idx="162">
                  <c:v>6.7158087650166492E-3</c:v>
                </c:pt>
                <c:pt idx="163">
                  <c:v>6.778777575504373E-3</c:v>
                </c:pt>
                <c:pt idx="164">
                  <c:v>6.8394654712279424E-3</c:v>
                </c:pt>
                <c:pt idx="165">
                  <c:v>6.8978456541210443E-3</c:v>
                </c:pt>
                <c:pt idx="166">
                  <c:v>6.9538923451383777E-3</c:v>
                </c:pt>
                <c:pt idx="167">
                  <c:v>7.0075807956389733E-3</c:v>
                </c:pt>
                <c:pt idx="168">
                  <c:v>7.0588872983144771E-3</c:v>
                </c:pt>
                <c:pt idx="169">
                  <c:v>7.107789197657647E-3</c:v>
                </c:pt>
                <c:pt idx="170">
                  <c:v>7.1542648999663762E-3</c:v>
                </c:pt>
                <c:pt idx="171">
                  <c:v>7.1982938828788721E-3</c:v>
                </c:pt>
                <c:pt idx="172">
                  <c:v>7.2398567044357444E-3</c:v>
                </c:pt>
                <c:pt idx="173">
                  <c:v>7.2789350116650355E-3</c:v>
                </c:pt>
                <c:pt idx="174">
                  <c:v>7.3155115486863726E-3</c:v>
                </c:pt>
                <c:pt idx="175">
                  <c:v>7.3495701643306781E-3</c:v>
                </c:pt>
                <c:pt idx="176">
                  <c:v>7.3810958192720728E-3</c:v>
                </c:pt>
                <c:pt idx="177">
                  <c:v>7.4100745926688194E-3</c:v>
                </c:pt>
                <c:pt idx="178">
                  <c:v>7.4364936883103677E-3</c:v>
                </c:pt>
                <c:pt idx="179">
                  <c:v>7.4603414402678141E-3</c:v>
                </c:pt>
                <c:pt idx="180">
                  <c:v>7.4816073180452355E-3</c:v>
                </c:pt>
                <c:pt idx="181">
                  <c:v>7.500281931229663E-3</c:v>
                </c:pt>
                <c:pt idx="182">
                  <c:v>7.5163570336376261E-3</c:v>
                </c:pt>
                <c:pt idx="183">
                  <c:v>7.5298255269564355E-3</c:v>
                </c:pt>
                <c:pt idx="184">
                  <c:v>7.540681463878594E-3</c:v>
                </c:pt>
                <c:pt idx="185">
                  <c:v>7.5489200507279641E-3</c:v>
                </c:pt>
                <c:pt idx="186">
                  <c:v>7.5545376495765194E-3</c:v>
                </c:pt>
                <c:pt idx="187">
                  <c:v>7.5575317798507492E-3</c:v>
                </c:pt>
                <c:pt idx="188">
                  <c:v>7.5579011194270122E-3</c:v>
                </c:pt>
                <c:pt idx="189">
                  <c:v>7.5556455052153502E-3</c:v>
                </c:pt>
                <c:pt idx="190">
                  <c:v>7.5507659332315017E-3</c:v>
                </c:pt>
                <c:pt idx="191">
                  <c:v>7.5432645581570874E-3</c:v>
                </c:pt>
                <c:pt idx="192">
                  <c:v>7.5331446923881671E-3</c:v>
                </c:pt>
                <c:pt idx="193">
                  <c:v>7.5204108045725804E-3</c:v>
                </c:pt>
                <c:pt idx="194">
                  <c:v>7.505068517636714E-3</c:v>
                </c:pt>
                <c:pt idx="195">
                  <c:v>7.4871246063025728E-3</c:v>
                </c:pt>
                <c:pt idx="196">
                  <c:v>7.4665869940962618E-3</c:v>
                </c:pt>
                <c:pt idx="197">
                  <c:v>7.4434647498491744E-3</c:v>
                </c:pt>
                <c:pt idx="198">
                  <c:v>7.4177680836934523E-3</c:v>
                </c:pt>
                <c:pt idx="199">
                  <c:v>7.3895083425534781E-3</c:v>
                </c:pt>
                <c:pt idx="200">
                  <c:v>7.358698005135395E-3</c:v>
                </c:pt>
                <c:pt idx="201">
                  <c:v>7.3253506764168613E-3</c:v>
                </c:pt>
                <c:pt idx="202">
                  <c:v>7.2894810816394751E-3</c:v>
                </c:pt>
                <c:pt idx="203">
                  <c:v>7.2511050598065155E-3</c:v>
                </c:pt>
                <c:pt idx="204">
                  <c:v>7.2102395566888983E-3</c:v>
                </c:pt>
                <c:pt idx="205">
                  <c:v>7.1669026173423883E-3</c:v>
                </c:pt>
                <c:pt idx="206">
                  <c:v>7.1211133781394157E-3</c:v>
                </c:pt>
                <c:pt idx="207">
                  <c:v>7.0728920583189945E-3</c:v>
                </c:pt>
                <c:pt idx="208">
                  <c:v>7.022259951058471E-3</c:v>
                </c:pt>
                <c:pt idx="209">
                  <c:v>6.9692394140710582E-3</c:v>
                </c:pt>
                <c:pt idx="210">
                  <c:v>6.9138538597333012E-3</c:v>
                </c:pt>
                <c:pt idx="211">
                  <c:v>6.8561277447468302E-3</c:v>
                </c:pt>
                <c:pt idx="212">
                  <c:v>6.7960865593389647E-3</c:v>
                </c:pt>
                <c:pt idx="213">
                  <c:v>6.7337568160069552E-3</c:v>
                </c:pt>
                <c:pt idx="214">
                  <c:v>6.6691660378108029E-3</c:v>
                </c:pt>
                <c:pt idx="215">
                  <c:v>6.6023427462198504E-3</c:v>
                </c:pt>
                <c:pt idx="216">
                  <c:v>6.5333164485185148E-3</c:v>
                </c:pt>
                <c:pt idx="217">
                  <c:v>6.462117624776692E-3</c:v>
                </c:pt>
                <c:pt idx="218">
                  <c:v>6.3887777143906152E-3</c:v>
                </c:pt>
                <c:pt idx="219">
                  <c:v>6.3133291022001107E-3</c:v>
                </c:pt>
                <c:pt idx="220">
                  <c:v>6.2358051041883564E-3</c:v>
                </c:pt>
                <c:pt idx="221">
                  <c:v>6.156239952770484E-3</c:v>
                </c:pt>
                <c:pt idx="222">
                  <c:v>6.0746687816775084E-3</c:v>
                </c:pt>
                <c:pt idx="223">
                  <c:v>5.9911276104422642E-3</c:v>
                </c:pt>
                <c:pt idx="224">
                  <c:v>5.9056533284941861E-3</c:v>
                </c:pt>
                <c:pt idx="225">
                  <c:v>5.8182836788699859E-3</c:v>
                </c:pt>
                <c:pt idx="226">
                  <c:v>5.7290572415473803E-3</c:v>
                </c:pt>
                <c:pt idx="227">
                  <c:v>5.6380134164092637E-3</c:v>
                </c:pt>
                <c:pt idx="228">
                  <c:v>5.54519240584583E-3</c:v>
                </c:pt>
                <c:pt idx="229">
                  <c:v>5.4506351970023247E-3</c:v>
                </c:pt>
                <c:pt idx="230">
                  <c:v>5.3543835436802821E-3</c:v>
                </c:pt>
                <c:pt idx="231">
                  <c:v>5.2564799479002094E-3</c:v>
                </c:pt>
                <c:pt idx="232">
                  <c:v>5.1569676411339083E-3</c:v>
                </c:pt>
                <c:pt idx="233">
                  <c:v>5.0558905652146602E-3</c:v>
                </c:pt>
                <c:pt idx="234">
                  <c:v>4.9532933529337544E-3</c:v>
                </c:pt>
                <c:pt idx="235">
                  <c:v>4.8492213083319042E-3</c:v>
                </c:pt>
                <c:pt idx="236">
                  <c:v>4.7437203866942616E-3</c:v>
                </c:pt>
                <c:pt idx="237">
                  <c:v>4.6368371742578456E-3</c:v>
                </c:pt>
                <c:pt idx="238">
                  <c:v>4.5286188676403839E-3</c:v>
                </c:pt>
                <c:pt idx="239">
                  <c:v>4.4191132529996105E-3</c:v>
                </c:pt>
                <c:pt idx="240">
                  <c:v>4.3083686849322411E-3</c:v>
                </c:pt>
                <c:pt idx="241">
                  <c:v>4.1964340651219467E-3</c:v>
                </c:pt>
                <c:pt idx="242">
                  <c:v>4.083358820745754E-3</c:v>
                </c:pt>
                <c:pt idx="243">
                  <c:v>3.9691928826483692E-3</c:v>
                </c:pt>
                <c:pt idx="244">
                  <c:v>3.853986663294162E-3</c:v>
                </c:pt>
                <c:pt idx="245">
                  <c:v>3.7377910345064089E-3</c:v>
                </c:pt>
                <c:pt idx="246">
                  <c:v>3.620657305003743E-3</c:v>
                </c:pt>
                <c:pt idx="247">
                  <c:v>3.5026371977436633E-3</c:v>
                </c:pt>
                <c:pt idx="248">
                  <c:v>3.3837828270831356E-3</c:v>
                </c:pt>
                <c:pt idx="249">
                  <c:v>3.2641466757663538E-3</c:v>
                </c:pt>
                <c:pt idx="250">
                  <c:v>3.1437815717498476E-3</c:v>
                </c:pt>
                <c:pt idx="251">
                  <c:v>3.0227406648751323E-3</c:v>
                </c:pt>
                <c:pt idx="252">
                  <c:v>2.9010774033992434E-3</c:v>
                </c:pt>
                <c:pt idx="253">
                  <c:v>2.7788455103934903E-3</c:v>
                </c:pt>
                <c:pt idx="254">
                  <c:v>2.6560989600208527E-3</c:v>
                </c:pt>
                <c:pt idx="255">
                  <c:v>2.5328919537025217E-3</c:v>
                </c:pt>
                <c:pt idx="256">
                  <c:v>2.4092788961840653E-3</c:v>
                </c:pt>
                <c:pt idx="257">
                  <c:v>2.2853143715118379E-3</c:v>
                </c:pt>
                <c:pt idx="258">
                  <c:v>2.1610531189301895E-3</c:v>
                </c:pt>
                <c:pt idx="259">
                  <c:v>2.0365500087101626E-3</c:v>
                </c:pt>
                <c:pt idx="260">
                  <c:v>1.9118600179203228E-3</c:v>
                </c:pt>
                <c:pt idx="261">
                  <c:v>1.7870382061504408E-3</c:v>
                </c:pt>
                <c:pt idx="262">
                  <c:v>1.6621396911987141E-3</c:v>
                </c:pt>
                <c:pt idx="263">
                  <c:v>1.5372196247333096E-3</c:v>
                </c:pt>
                <c:pt idx="264">
                  <c:v>1.4123331679389327E-3</c:v>
                </c:pt>
                <c:pt idx="265">
                  <c:v>1.28753546715921E-3</c:v>
                </c:pt>
                <c:pt idx="266">
                  <c:v>1.1628816295456055E-3</c:v>
                </c:pt>
                <c:pt idx="267">
                  <c:v>1.0384266987236595E-3</c:v>
                </c:pt>
                <c:pt idx="268">
                  <c:v>9.1422563048727595E-4</c:v>
                </c:pt>
                <c:pt idx="269">
                  <c:v>7.9033326853178345E-4</c:v>
                </c:pt>
                <c:pt idx="270">
                  <c:v>6.6680432023651006E-4</c:v>
                </c:pt>
                <c:pt idx="271">
                  <c:v>5.4369333250754584E-4</c:v>
                </c:pt>
                <c:pt idx="272">
                  <c:v>4.2105466769134592E-4</c:v>
                </c:pt>
                <c:pt idx="273">
                  <c:v>2.9894247956988029E-4</c:v>
                </c:pt>
                <c:pt idx="274">
                  <c:v>1.7741068944782242E-4</c:v>
                </c:pt>
                <c:pt idx="275">
                  <c:v>5.651296234243262E-5</c:v>
                </c:pt>
                <c:pt idx="276">
                  <c:v>-6.3697316713409984E-5</c:v>
                </c:pt>
                <c:pt idx="277">
                  <c:v>-1.831670662445317E-4</c:v>
                </c:pt>
                <c:pt idx="278">
                  <c:v>-3.0184353177275039E-4</c:v>
                </c:pt>
                <c:pt idx="279">
                  <c:v>-4.1967430911176709E-4</c:v>
                </c:pt>
                <c:pt idx="280">
                  <c:v>-5.3660736750738187E-4</c:v>
                </c:pt>
                <c:pt idx="281">
                  <c:v>-6.525910726128052E-4</c:v>
                </c:pt>
                <c:pt idx="282">
                  <c:v>-7.6757420928893951E-4</c:v>
                </c:pt>
                <c:pt idx="283">
                  <c:v>-8.8150600421953466E-4</c:v>
                </c:pt>
                <c:pt idx="284">
                  <c:v>-9.9433614833125978E-4</c:v>
                </c:pt>
                <c:pt idx="285">
                  <c:v>-1.1060148190087746E-3</c:v>
                </c:pt>
                <c:pt idx="286">
                  <c:v>-1.2164927020949894E-3</c:v>
                </c:pt>
                <c:pt idx="287">
                  <c:v>-1.3257210136668144E-3</c:v>
                </c:pt>
                <c:pt idx="288">
                  <c:v>-1.4336515215767607E-3</c:v>
                </c:pt>
                <c:pt idx="289">
                  <c:v>-1.5402365667509035E-3</c:v>
                </c:pt>
                <c:pt idx="290">
                  <c:v>-1.6454290842337843E-3</c:v>
                </c:pt>
                <c:pt idx="291">
                  <c:v>-1.7491826239709749E-3</c:v>
                </c:pt>
                <c:pt idx="292">
                  <c:v>-1.8514513713201071E-3</c:v>
                </c:pt>
                <c:pt idx="293">
                  <c:v>-1.952190167281335E-3</c:v>
                </c:pt>
                <c:pt idx="294">
                  <c:v>-2.0513545284382754E-3</c:v>
                </c:pt>
                <c:pt idx="295">
                  <c:v>-2.1489006666006306E-3</c:v>
                </c:pt>
                <c:pt idx="296">
                  <c:v>-2.2447855081398262E-3</c:v>
                </c:pt>
                <c:pt idx="297">
                  <c:v>-2.3389667130091041E-3</c:v>
                </c:pt>
                <c:pt idx="298">
                  <c:v>-2.4314026934397059E-3</c:v>
                </c:pt>
                <c:pt idx="299">
                  <c:v>-2.5220526323048468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387976"/>
        <c:axId val="283388760"/>
      </c:scatterChart>
      <c:valAx>
        <c:axId val="283387976"/>
        <c:scaling>
          <c:orientation val="minMax"/>
          <c:max val="15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388760"/>
        <c:crosses val="autoZero"/>
        <c:crossBetween val="midCat"/>
      </c:valAx>
      <c:valAx>
        <c:axId val="283388760"/>
        <c:scaling>
          <c:orientation val="minMax"/>
          <c:max val="0.01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387976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99242883101152"/>
          <c:y val="0.10679611650485436"/>
          <c:w val="0.65111371895820724"/>
          <c:h val="0.7039966363427872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FF0000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FF0000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CG$1:$CG$15</c:f>
              <c:numCache>
                <c:formatCode>General</c:formatCode>
                <c:ptCount val="15"/>
                <c:pt idx="0">
                  <c:v>0.109</c:v>
                </c:pt>
                <c:pt idx="1">
                  <c:v>0</c:v>
                </c:pt>
                <c:pt idx="2">
                  <c:v>0.59</c:v>
                </c:pt>
                <c:pt idx="3">
                  <c:v>0.85</c:v>
                </c:pt>
                <c:pt idx="4">
                  <c:v>0.5</c:v>
                </c:pt>
                <c:pt idx="5">
                  <c:v>219.19880000000001</c:v>
                </c:pt>
                <c:pt idx="6">
                  <c:v>124.09350000000001</c:v>
                </c:pt>
                <c:pt idx="7">
                  <c:v>170.1447</c:v>
                </c:pt>
                <c:pt idx="8">
                  <c:v>102.8198</c:v>
                </c:pt>
                <c:pt idx="9">
                  <c:v>133.8227</c:v>
                </c:pt>
                <c:pt idx="10">
                  <c:v>78.404910000000001</c:v>
                </c:pt>
                <c:pt idx="11">
                  <c:v>56.57591</c:v>
                </c:pt>
                <c:pt idx="12">
                  <c:v>113.7139</c:v>
                </c:pt>
                <c:pt idx="13">
                  <c:v>92.474109999999996</c:v>
                </c:pt>
                <c:pt idx="14">
                  <c:v>81.813429999999997</c:v>
                </c:pt>
              </c:numCache>
            </c:numRef>
          </c:xVal>
          <c:yVal>
            <c:numRef>
              <c:f>'Covariance   Correlation3_HID4'!$CH$1:$CH$15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3999999999999998E-3</c:v>
                </c:pt>
                <c:pt idx="6">
                  <c:v>2.3E-3</c:v>
                </c:pt>
                <c:pt idx="7">
                  <c:v>2.8E-3</c:v>
                </c:pt>
                <c:pt idx="8">
                  <c:v>6.0000000000000001E-3</c:v>
                </c:pt>
                <c:pt idx="9">
                  <c:v>4.3E-3</c:v>
                </c:pt>
                <c:pt idx="10">
                  <c:v>3.5999999999999999E-3</c:v>
                </c:pt>
                <c:pt idx="11">
                  <c:v>0</c:v>
                </c:pt>
                <c:pt idx="12">
                  <c:v>1.8E-3</c:v>
                </c:pt>
                <c:pt idx="13">
                  <c:v>0</c:v>
                </c:pt>
                <c:pt idx="14">
                  <c:v>0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52</c:f>
              <c:numCache>
                <c:formatCode>General</c:formatCode>
                <c:ptCount val="300"/>
                <c:pt idx="0">
                  <c:v>-125.6604566908927</c:v>
                </c:pt>
                <c:pt idx="1">
                  <c:v>-125.61541610310188</c:v>
                </c:pt>
                <c:pt idx="2">
                  <c:v>-125.48031422838501</c:v>
                </c:pt>
                <c:pt idx="3">
                  <c:v>-125.25521072392671</c:v>
                </c:pt>
                <c:pt idx="4">
                  <c:v>-124.94020498909764</c:v>
                </c:pt>
                <c:pt idx="5">
                  <c:v>-124.53543612156251</c:v>
                </c:pt>
                <c:pt idx="6">
                  <c:v>-124.04108285585853</c:v>
                </c:pt>
                <c:pt idx="7">
                  <c:v>-123.45736348447123</c:v>
                </c:pt>
                <c:pt idx="8">
                  <c:v>-122.78453576144263</c:v>
                </c:pt>
                <c:pt idx="9">
                  <c:v>-122.02289678855435</c:v>
                </c:pt>
                <c:pt idx="10">
                  <c:v>-121.17278288413577</c:v>
                </c:pt>
                <c:pt idx="11">
                  <c:v>-120.23456943455544</c:v>
                </c:pt>
                <c:pt idx="12">
                  <c:v>-119.20867072846092</c:v>
                </c:pt>
                <c:pt idx="13">
                  <c:v>-118.09553977384054</c:v>
                </c:pt>
                <c:pt idx="14">
                  <c:v>-116.89566809798801</c:v>
                </c:pt>
                <c:pt idx="15">
                  <c:v>-115.60958553045755</c:v>
                </c:pt>
                <c:pt idx="16">
                  <c:v>-114.23785996910634</c:v>
                </c:pt>
                <c:pt idx="17">
                  <c:v>-112.78109712932657</c:v>
                </c:pt>
                <c:pt idx="18">
                  <c:v>-111.23994027657879</c:v>
                </c:pt>
                <c:pt idx="19">
                  <c:v>-109.61506994234379</c:v>
                </c:pt>
                <c:pt idx="20">
                  <c:v>-107.90720362361925</c:v>
                </c:pt>
                <c:pt idx="21">
                  <c:v>-106.11709546609309</c:v>
                </c:pt>
                <c:pt idx="22">
                  <c:v>-104.24553593113409</c:v>
                </c:pt>
                <c:pt idx="23">
                  <c:v>-102.29335144674634</c:v>
                </c:pt>
                <c:pt idx="24">
                  <c:v>-100.26140404264187</c:v>
                </c:pt>
                <c:pt idx="25">
                  <c:v>-98.150590969592699</c:v>
                </c:pt>
                <c:pt idx="26">
                  <c:v>-95.961844303230052</c:v>
                </c:pt>
                <c:pt idx="27">
                  <c:v>-93.696130532466114</c:v>
                </c:pt>
                <c:pt idx="28">
                  <c:v>-91.354450132719549</c:v>
                </c:pt>
                <c:pt idx="29">
                  <c:v>-88.937837124133935</c:v>
                </c:pt>
                <c:pt idx="30">
                  <c:v>-86.447358614983429</c:v>
                </c:pt>
                <c:pt idx="31">
                  <c:v>-83.884114330467796</c:v>
                </c:pt>
                <c:pt idx="32">
                  <c:v>-81.249236127104851</c:v>
                </c:pt>
                <c:pt idx="33">
                  <c:v>-78.543887492934331</c:v>
                </c:pt>
                <c:pt idx="34">
                  <c:v>-75.769263033754484</c:v>
                </c:pt>
                <c:pt idx="35">
                  <c:v>-72.926587945617499</c:v>
                </c:pt>
                <c:pt idx="36">
                  <c:v>-70.017117473817805</c:v>
                </c:pt>
                <c:pt idx="37">
                  <c:v>-67.042136358610733</c:v>
                </c:pt>
                <c:pt idx="38">
                  <c:v>-64.002958267907687</c:v>
                </c:pt>
                <c:pt idx="39">
                  <c:v>-60.900925217197184</c:v>
                </c:pt>
                <c:pt idx="40">
                  <c:v>-57.737406976948577</c:v>
                </c:pt>
                <c:pt idx="41">
                  <c:v>-54.513800467760106</c:v>
                </c:pt>
                <c:pt idx="42">
                  <c:v>-51.231529143517989</c:v>
                </c:pt>
                <c:pt idx="43">
                  <c:v>-47.892042362839319</c:v>
                </c:pt>
                <c:pt idx="44">
                  <c:v>-44.496814749076037</c:v>
                </c:pt>
                <c:pt idx="45">
                  <c:v>-41.047345539162862</c:v>
                </c:pt>
                <c:pt idx="46">
                  <c:v>-37.545157921596314</c:v>
                </c:pt>
                <c:pt idx="47">
                  <c:v>-33.991798363837731</c:v>
                </c:pt>
                <c:pt idx="48">
                  <c:v>-30.388835929436667</c:v>
                </c:pt>
                <c:pt idx="49">
                  <c:v>-26.737861585176617</c:v>
                </c:pt>
                <c:pt idx="50">
                  <c:v>-23.040487498548899</c:v>
                </c:pt>
                <c:pt idx="51">
                  <c:v>-19.298346325864813</c:v>
                </c:pt>
                <c:pt idx="52">
                  <c:v>-15.513090491320668</c:v>
                </c:pt>
                <c:pt idx="53">
                  <c:v>-11.68639145733367</c:v>
                </c:pt>
                <c:pt idx="54">
                  <c:v>-7.8199389864713567</c:v>
                </c:pt>
                <c:pt idx="55">
                  <c:v>-3.9154403952996262</c:v>
                </c:pt>
                <c:pt idx="56">
                  <c:v>2.5380199519744906E-2</c:v>
                </c:pt>
                <c:pt idx="57">
                  <c:v>4.000782642550675</c:v>
                </c:pt>
                <c:pt idx="58">
                  <c:v>8.0090115079864717</c:v>
                </c:pt>
                <c:pt idx="59">
                  <c:v>12.048296874796407</c:v>
                </c:pt>
                <c:pt idx="60">
                  <c:v>16.116855108273029</c:v>
                </c:pt>
                <c:pt idx="61">
                  <c:v>20.212889647634974</c:v>
                </c:pt>
                <c:pt idx="62">
                  <c:v>24.334591799337829</c:v>
                </c:pt>
                <c:pt idx="63">
                  <c:v>28.480141535742014</c:v>
                </c:pt>
                <c:pt idx="64">
                  <c:v>32.647708298785915</c:v>
                </c:pt>
                <c:pt idx="65">
                  <c:v>36.835451808308761</c:v>
                </c:pt>
                <c:pt idx="66">
                  <c:v>41.041522874666555</c:v>
                </c:pt>
                <c:pt idx="67">
                  <c:v>45.264064215282104</c:v>
                </c:pt>
                <c:pt idx="68">
                  <c:v>49.501211274768757</c:v>
                </c:pt>
                <c:pt idx="69">
                  <c:v>53.75109304826568</c:v>
                </c:pt>
                <c:pt idx="70">
                  <c:v>58.011832907620715</c:v>
                </c:pt>
                <c:pt idx="71">
                  <c:v>62.281549430056685</c:v>
                </c:pt>
                <c:pt idx="72">
                  <c:v>66.558357228954719</c:v>
                </c:pt>
                <c:pt idx="73">
                  <c:v>70.840367786387873</c:v>
                </c:pt>
                <c:pt idx="74">
                  <c:v>75.125690287037486</c:v>
                </c:pt>
                <c:pt idx="75">
                  <c:v>79.412432453124012</c:v>
                </c:pt>
                <c:pt idx="76">
                  <c:v>83.698701379983689</c:v>
                </c:pt>
                <c:pt idx="77">
                  <c:v>87.982604371921767</c:v>
                </c:pt>
                <c:pt idx="78">
                  <c:v>92.262249777973807</c:v>
                </c:pt>
                <c:pt idx="79">
                  <c:v>96.535747827205427</c:v>
                </c:pt>
                <c:pt idx="80">
                  <c:v>100.80121146318197</c:v>
                </c:pt>
                <c:pt idx="81">
                  <c:v>105.05675717723948</c:v>
                </c:pt>
                <c:pt idx="82">
                  <c:v>109.3005058401891</c:v>
                </c:pt>
                <c:pt idx="83">
                  <c:v>113.53058353208776</c:v>
                </c:pt>
                <c:pt idx="84">
                  <c:v>117.74512236970821</c:v>
                </c:pt>
                <c:pt idx="85">
                  <c:v>121.94226133134387</c:v>
                </c:pt>
                <c:pt idx="86">
                  <c:v>126.1201470785836</c:v>
                </c:pt>
                <c:pt idx="87">
                  <c:v>130.27693477469364</c:v>
                </c:pt>
                <c:pt idx="88">
                  <c:v>134.4107888992458</c:v>
                </c:pt>
                <c:pt idx="89">
                  <c:v>138.51988405863133</c:v>
                </c:pt>
                <c:pt idx="90">
                  <c:v>142.6024057921037</c:v>
                </c:pt>
                <c:pt idx="91">
                  <c:v>146.65655137299305</c:v>
                </c:pt>
                <c:pt idx="92">
                  <c:v>150.68053060473972</c:v>
                </c:pt>
                <c:pt idx="93">
                  <c:v>154.67256661139459</c:v>
                </c:pt>
                <c:pt idx="94">
                  <c:v>158.63089662223751</c:v>
                </c:pt>
                <c:pt idx="95">
                  <c:v>162.55377275016727</c:v>
                </c:pt>
                <c:pt idx="96">
                  <c:v>166.4394627635192</c:v>
                </c:pt>
                <c:pt idx="97">
                  <c:v>170.28625085097008</c:v>
                </c:pt>
                <c:pt idx="98">
                  <c:v>174.092438379192</c:v>
                </c:pt>
                <c:pt idx="99">
                  <c:v>177.85634464292104</c:v>
                </c:pt>
                <c:pt idx="100">
                  <c:v>181.57630760710944</c:v>
                </c:pt>
                <c:pt idx="101">
                  <c:v>185.25068464083338</c:v>
                </c:pt>
                <c:pt idx="102">
                  <c:v>188.8778532426328</c:v>
                </c:pt>
                <c:pt idx="103">
                  <c:v>192.45621175696203</c:v>
                </c:pt>
                <c:pt idx="104">
                  <c:v>195.98418008143605</c:v>
                </c:pt>
                <c:pt idx="105">
                  <c:v>199.46020036455917</c:v>
                </c:pt>
                <c:pt idx="106">
                  <c:v>202.88273769362831</c:v>
                </c:pt>
                <c:pt idx="107">
                  <c:v>206.25028077250727</c:v>
                </c:pt>
                <c:pt idx="108">
                  <c:v>209.56134258897276</c:v>
                </c:pt>
                <c:pt idx="109">
                  <c:v>212.81446107133667</c:v>
                </c:pt>
                <c:pt idx="110">
                  <c:v>216.00819973405635</c:v>
                </c:pt>
                <c:pt idx="111">
                  <c:v>219.14114831204563</c:v>
                </c:pt>
                <c:pt idx="112">
                  <c:v>222.21192338340865</c:v>
                </c:pt>
                <c:pt idx="113">
                  <c:v>225.21916898031969</c:v>
                </c:pt>
                <c:pt idx="114">
                  <c:v>228.1615571877806</c:v>
                </c:pt>
                <c:pt idx="115">
                  <c:v>231.03778872999055</c:v>
                </c:pt>
                <c:pt idx="116">
                  <c:v>233.84659354406978</c:v>
                </c:pt>
                <c:pt idx="117">
                  <c:v>236.58673134088343</c:v>
                </c:pt>
                <c:pt idx="118">
                  <c:v>239.25699215271851</c:v>
                </c:pt>
                <c:pt idx="119">
                  <c:v>241.85619686757133</c:v>
                </c:pt>
                <c:pt idx="120">
                  <c:v>244.38319774981045</c:v>
                </c:pt>
                <c:pt idx="121">
                  <c:v>246.83687894698426</c:v>
                </c:pt>
                <c:pt idx="122">
                  <c:v>249.21615698255005</c:v>
                </c:pt>
                <c:pt idx="123">
                  <c:v>251.51998123430673</c:v>
                </c:pt>
                <c:pt idx="124">
                  <c:v>253.74733439831999</c:v>
                </c:pt>
                <c:pt idx="125">
                  <c:v>255.89723293813518</c:v>
                </c:pt>
                <c:pt idx="126">
                  <c:v>257.96872751907921</c:v>
                </c:pt>
                <c:pt idx="127">
                  <c:v>259.96090342746004</c:v>
                </c:pt>
                <c:pt idx="128">
                  <c:v>261.87288097447868</c:v>
                </c:pt>
                <c:pt idx="129">
                  <c:v>263.70381588467467</c:v>
                </c:pt>
                <c:pt idx="130">
                  <c:v>265.45289966873457</c:v>
                </c:pt>
                <c:pt idx="131">
                  <c:v>267.11935998049813</c:v>
                </c:pt>
                <c:pt idx="132">
                  <c:v>268.70246095800439</c:v>
                </c:pt>
                <c:pt idx="133">
                  <c:v>270.20150354842781</c:v>
                </c:pt>
                <c:pt idx="134">
                  <c:v>271.61582581676021</c:v>
                </c:pt>
                <c:pt idx="135">
                  <c:v>272.94480323810268</c:v>
                </c:pt>
                <c:pt idx="136">
                  <c:v>274.18784897343824</c:v>
                </c:pt>
                <c:pt idx="137">
                  <c:v>275.34441412876333</c:v>
                </c:pt>
                <c:pt idx="138">
                  <c:v>276.41398799746395</c:v>
                </c:pt>
                <c:pt idx="139">
                  <c:v>277.39609828582945</c:v>
                </c:pt>
                <c:pt idx="140">
                  <c:v>278.29031132160407</c:v>
                </c:pt>
                <c:pt idx="141">
                  <c:v>279.09623224548426</c:v>
                </c:pt>
                <c:pt idx="142">
                  <c:v>279.81350518547765</c:v>
                </c:pt>
                <c:pt idx="143">
                  <c:v>280.44181341404601</c:v>
                </c:pt>
                <c:pt idx="144">
                  <c:v>280.98087948796314</c:v>
                </c:pt>
                <c:pt idx="145">
                  <c:v>281.43046537082625</c:v>
                </c:pt>
                <c:pt idx="146">
                  <c:v>281.79037253816574</c:v>
                </c:pt>
                <c:pt idx="147">
                  <c:v>282.06044206510836</c:v>
                </c:pt>
                <c:pt idx="148">
                  <c:v>282.24055469655372</c:v>
                </c:pt>
                <c:pt idx="149">
                  <c:v>282.3306308998342</c:v>
                </c:pt>
                <c:pt idx="150">
                  <c:v>282.3306308998342</c:v>
                </c:pt>
                <c:pt idx="151">
                  <c:v>282.24055469655366</c:v>
                </c:pt>
                <c:pt idx="152">
                  <c:v>282.06044206510819</c:v>
                </c:pt>
                <c:pt idx="153">
                  <c:v>281.79037253816551</c:v>
                </c:pt>
                <c:pt idx="154">
                  <c:v>281.43046537082597</c:v>
                </c:pt>
                <c:pt idx="155">
                  <c:v>280.9808794879628</c:v>
                </c:pt>
                <c:pt idx="156">
                  <c:v>280.44181341404555</c:v>
                </c:pt>
                <c:pt idx="157">
                  <c:v>279.81350518547714</c:v>
                </c:pt>
                <c:pt idx="158">
                  <c:v>279.09623224548369</c:v>
                </c:pt>
                <c:pt idx="159">
                  <c:v>278.2903113216035</c:v>
                </c:pt>
                <c:pt idx="160">
                  <c:v>277.39609828582883</c:v>
                </c:pt>
                <c:pt idx="161">
                  <c:v>276.41398799746321</c:v>
                </c:pt>
                <c:pt idx="162">
                  <c:v>275.34441412876254</c:v>
                </c:pt>
                <c:pt idx="163">
                  <c:v>274.18784897343738</c:v>
                </c:pt>
                <c:pt idx="164">
                  <c:v>272.94480323810177</c:v>
                </c:pt>
                <c:pt idx="165">
                  <c:v>271.61582581675924</c:v>
                </c:pt>
                <c:pt idx="166">
                  <c:v>270.20150354842679</c:v>
                </c:pt>
                <c:pt idx="167">
                  <c:v>268.70246095800331</c:v>
                </c:pt>
                <c:pt idx="168">
                  <c:v>267.11935998049699</c:v>
                </c:pt>
                <c:pt idx="169">
                  <c:v>265.45289966873344</c:v>
                </c:pt>
                <c:pt idx="170">
                  <c:v>263.70381588467342</c:v>
                </c:pt>
                <c:pt idx="171">
                  <c:v>261.87288097447743</c:v>
                </c:pt>
                <c:pt idx="172">
                  <c:v>259.96090342745867</c:v>
                </c:pt>
                <c:pt idx="173">
                  <c:v>257.96872751907773</c:v>
                </c:pt>
                <c:pt idx="174">
                  <c:v>255.8972329381337</c:v>
                </c:pt>
                <c:pt idx="175">
                  <c:v>253.74733439831846</c:v>
                </c:pt>
                <c:pt idx="176">
                  <c:v>251.51998123430513</c:v>
                </c:pt>
                <c:pt idx="177">
                  <c:v>249.2161569825484</c:v>
                </c:pt>
                <c:pt idx="178">
                  <c:v>246.83687894698261</c:v>
                </c:pt>
                <c:pt idx="179">
                  <c:v>244.38319774980874</c:v>
                </c:pt>
                <c:pt idx="180">
                  <c:v>241.85619686756951</c:v>
                </c:pt>
                <c:pt idx="181">
                  <c:v>239.25699215271663</c:v>
                </c:pt>
                <c:pt idx="182">
                  <c:v>236.58673134088156</c:v>
                </c:pt>
                <c:pt idx="183">
                  <c:v>233.84659354406784</c:v>
                </c:pt>
                <c:pt idx="184">
                  <c:v>231.03778872998856</c:v>
                </c:pt>
                <c:pt idx="185">
                  <c:v>228.16155718777856</c:v>
                </c:pt>
                <c:pt idx="186">
                  <c:v>225.21916898031759</c:v>
                </c:pt>
                <c:pt idx="187">
                  <c:v>222.21192338340654</c:v>
                </c:pt>
                <c:pt idx="188">
                  <c:v>219.14114831204347</c:v>
                </c:pt>
                <c:pt idx="189">
                  <c:v>216.00819973405413</c:v>
                </c:pt>
                <c:pt idx="190">
                  <c:v>212.81446107133445</c:v>
                </c:pt>
                <c:pt idx="191">
                  <c:v>209.56134258897055</c:v>
                </c:pt>
                <c:pt idx="192">
                  <c:v>206.25028077250502</c:v>
                </c:pt>
                <c:pt idx="193">
                  <c:v>202.88273769362598</c:v>
                </c:pt>
                <c:pt idx="194">
                  <c:v>199.46020036455678</c:v>
                </c:pt>
                <c:pt idx="195">
                  <c:v>195.98418008143361</c:v>
                </c:pt>
                <c:pt idx="196">
                  <c:v>192.45621175695953</c:v>
                </c:pt>
                <c:pt idx="197">
                  <c:v>188.87785324263027</c:v>
                </c:pt>
                <c:pt idx="198">
                  <c:v>185.25068464083085</c:v>
                </c:pt>
                <c:pt idx="199">
                  <c:v>181.57630760710686</c:v>
                </c:pt>
                <c:pt idx="200">
                  <c:v>177.85634464291846</c:v>
                </c:pt>
                <c:pt idx="201">
                  <c:v>174.09243837918939</c:v>
                </c:pt>
                <c:pt idx="202">
                  <c:v>170.28625085096743</c:v>
                </c:pt>
                <c:pt idx="203">
                  <c:v>166.4394627635165</c:v>
                </c:pt>
                <c:pt idx="204">
                  <c:v>162.55377275016451</c:v>
                </c:pt>
                <c:pt idx="205">
                  <c:v>158.63089662223473</c:v>
                </c:pt>
                <c:pt idx="206">
                  <c:v>154.67256661139174</c:v>
                </c:pt>
                <c:pt idx="207">
                  <c:v>150.68053060473687</c:v>
                </c:pt>
                <c:pt idx="208">
                  <c:v>146.65655137299018</c:v>
                </c:pt>
                <c:pt idx="209">
                  <c:v>142.6024057921008</c:v>
                </c:pt>
                <c:pt idx="210">
                  <c:v>138.51988405862843</c:v>
                </c:pt>
                <c:pt idx="211">
                  <c:v>134.41078889924285</c:v>
                </c:pt>
                <c:pt idx="212">
                  <c:v>130.27693477469069</c:v>
                </c:pt>
                <c:pt idx="213">
                  <c:v>126.1201470785806</c:v>
                </c:pt>
                <c:pt idx="214">
                  <c:v>121.94226133134106</c:v>
                </c:pt>
                <c:pt idx="215">
                  <c:v>117.74512236970537</c:v>
                </c:pt>
                <c:pt idx="216">
                  <c:v>113.5305835320849</c:v>
                </c:pt>
                <c:pt idx="217">
                  <c:v>109.30050584018623</c:v>
                </c:pt>
                <c:pt idx="218">
                  <c:v>105.05675717723656</c:v>
                </c:pt>
                <c:pt idx="219">
                  <c:v>100.80121146317904</c:v>
                </c:pt>
                <c:pt idx="220">
                  <c:v>96.535747827202485</c:v>
                </c:pt>
                <c:pt idx="221">
                  <c:v>92.262249777970865</c:v>
                </c:pt>
                <c:pt idx="222">
                  <c:v>87.982604371918825</c:v>
                </c:pt>
                <c:pt idx="223">
                  <c:v>83.698701379980733</c:v>
                </c:pt>
                <c:pt idx="224">
                  <c:v>79.41243245312107</c:v>
                </c:pt>
                <c:pt idx="225">
                  <c:v>75.125690287034502</c:v>
                </c:pt>
                <c:pt idx="226">
                  <c:v>70.840367786384874</c:v>
                </c:pt>
                <c:pt idx="227">
                  <c:v>66.558357228951735</c:v>
                </c:pt>
                <c:pt idx="228">
                  <c:v>62.281549430053701</c:v>
                </c:pt>
                <c:pt idx="229">
                  <c:v>58.011832907617745</c:v>
                </c:pt>
                <c:pt idx="230">
                  <c:v>53.751093048262717</c:v>
                </c:pt>
                <c:pt idx="231">
                  <c:v>49.501211274765794</c:v>
                </c:pt>
                <c:pt idx="232">
                  <c:v>45.264064215279113</c:v>
                </c:pt>
                <c:pt idx="233">
                  <c:v>41.041522874663571</c:v>
                </c:pt>
                <c:pt idx="234">
                  <c:v>36.835451808305798</c:v>
                </c:pt>
                <c:pt idx="235">
                  <c:v>32.647708298782959</c:v>
                </c:pt>
                <c:pt idx="236">
                  <c:v>28.480141535739072</c:v>
                </c:pt>
                <c:pt idx="237">
                  <c:v>24.334591799334909</c:v>
                </c:pt>
                <c:pt idx="238">
                  <c:v>20.212889647632068</c:v>
                </c:pt>
                <c:pt idx="239">
                  <c:v>16.116855108270094</c:v>
                </c:pt>
                <c:pt idx="240">
                  <c:v>12.048296874793493</c:v>
                </c:pt>
                <c:pt idx="241">
                  <c:v>8.0090115079835726</c:v>
                </c:pt>
                <c:pt idx="242">
                  <c:v>4.0007826425479607</c:v>
                </c:pt>
                <c:pt idx="243">
                  <c:v>2.5380199517073265E-2</c:v>
                </c:pt>
                <c:pt idx="244">
                  <c:v>-3.9154403953022694</c:v>
                </c:pt>
                <c:pt idx="245">
                  <c:v>-7.8199389864739857</c:v>
                </c:pt>
                <c:pt idx="246">
                  <c:v>-11.686391457336356</c:v>
                </c:pt>
                <c:pt idx="247">
                  <c:v>-15.513090491323325</c:v>
                </c:pt>
                <c:pt idx="248">
                  <c:v>-19.298346325867442</c:v>
                </c:pt>
                <c:pt idx="249">
                  <c:v>-23.040487498551499</c:v>
                </c:pt>
                <c:pt idx="250">
                  <c:v>-26.737861585179203</c:v>
                </c:pt>
                <c:pt idx="251">
                  <c:v>-30.38883592943921</c:v>
                </c:pt>
                <c:pt idx="252">
                  <c:v>-33.991798363840232</c:v>
                </c:pt>
                <c:pt idx="253">
                  <c:v>-37.545157921598758</c:v>
                </c:pt>
                <c:pt idx="254">
                  <c:v>-41.047345539165278</c:v>
                </c:pt>
                <c:pt idx="255">
                  <c:v>-44.496814749078439</c:v>
                </c:pt>
                <c:pt idx="256">
                  <c:v>-47.892042362841678</c:v>
                </c:pt>
                <c:pt idx="257">
                  <c:v>-51.231529143520319</c:v>
                </c:pt>
                <c:pt idx="258">
                  <c:v>-54.513800467762351</c:v>
                </c:pt>
                <c:pt idx="259">
                  <c:v>-57.737406976950794</c:v>
                </c:pt>
                <c:pt idx="260">
                  <c:v>-60.900925217199372</c:v>
                </c:pt>
                <c:pt idx="261">
                  <c:v>-64.002958267909847</c:v>
                </c:pt>
                <c:pt idx="262">
                  <c:v>-67.042136358612836</c:v>
                </c:pt>
                <c:pt idx="263">
                  <c:v>-70.017117473819823</c:v>
                </c:pt>
                <c:pt idx="264">
                  <c:v>-72.926587945619517</c:v>
                </c:pt>
                <c:pt idx="265">
                  <c:v>-75.769263033756474</c:v>
                </c:pt>
                <c:pt idx="266">
                  <c:v>-78.543887492936321</c:v>
                </c:pt>
                <c:pt idx="267">
                  <c:v>-81.249236127106784</c:v>
                </c:pt>
                <c:pt idx="268">
                  <c:v>-83.884114330469671</c:v>
                </c:pt>
                <c:pt idx="269">
                  <c:v>-86.447358614985248</c:v>
                </c:pt>
                <c:pt idx="270">
                  <c:v>-88.937837124135697</c:v>
                </c:pt>
                <c:pt idx="271">
                  <c:v>-91.354450132721169</c:v>
                </c:pt>
                <c:pt idx="272">
                  <c:v>-93.696130532467649</c:v>
                </c:pt>
                <c:pt idx="273">
                  <c:v>-95.961844303231558</c:v>
                </c:pt>
                <c:pt idx="274">
                  <c:v>-98.150590969594148</c:v>
                </c:pt>
                <c:pt idx="275">
                  <c:v>-100.26140404264326</c:v>
                </c:pt>
                <c:pt idx="276">
                  <c:v>-102.29335144674771</c:v>
                </c:pt>
                <c:pt idx="277">
                  <c:v>-104.24553593113542</c:v>
                </c:pt>
                <c:pt idx="278">
                  <c:v>-106.11709546609437</c:v>
                </c:pt>
                <c:pt idx="279">
                  <c:v>-107.90720362362048</c:v>
                </c:pt>
                <c:pt idx="280">
                  <c:v>-109.61506994234499</c:v>
                </c:pt>
                <c:pt idx="281">
                  <c:v>-111.2399402765799</c:v>
                </c:pt>
                <c:pt idx="282">
                  <c:v>-112.78109712932762</c:v>
                </c:pt>
                <c:pt idx="283">
                  <c:v>-114.23785996910733</c:v>
                </c:pt>
                <c:pt idx="284">
                  <c:v>-115.60958553045849</c:v>
                </c:pt>
                <c:pt idx="285">
                  <c:v>-116.89566809798886</c:v>
                </c:pt>
                <c:pt idx="286">
                  <c:v>-118.09553977384134</c:v>
                </c:pt>
                <c:pt idx="287">
                  <c:v>-119.20867072846166</c:v>
                </c:pt>
                <c:pt idx="288">
                  <c:v>-120.23456943455612</c:v>
                </c:pt>
                <c:pt idx="289">
                  <c:v>-121.1727828841364</c:v>
                </c:pt>
                <c:pt idx="290">
                  <c:v>-122.02289678855492</c:v>
                </c:pt>
                <c:pt idx="291">
                  <c:v>-122.78453576144311</c:v>
                </c:pt>
                <c:pt idx="292">
                  <c:v>-123.45736348447166</c:v>
                </c:pt>
                <c:pt idx="293">
                  <c:v>-124.04108285585893</c:v>
                </c:pt>
                <c:pt idx="294">
                  <c:v>-124.53543612156285</c:v>
                </c:pt>
                <c:pt idx="295">
                  <c:v>-124.94020498909789</c:v>
                </c:pt>
                <c:pt idx="296">
                  <c:v>-125.25521072392691</c:v>
                </c:pt>
                <c:pt idx="297">
                  <c:v>-125.48031422838513</c:v>
                </c:pt>
                <c:pt idx="298">
                  <c:v>-125.61541610310194</c:v>
                </c:pt>
                <c:pt idx="299">
                  <c:v>-125.6604566908927</c:v>
                </c:pt>
              </c:numCache>
            </c:numRef>
          </c:xVal>
          <c:yVal>
            <c:numRef>
              <c:f>'Covariance   Correlation3'!yycir53</c:f>
              <c:numCache>
                <c:formatCode>General</c:formatCode>
                <c:ptCount val="300"/>
                <c:pt idx="0">
                  <c:v>-2.3550276096711144E-3</c:v>
                </c:pt>
                <c:pt idx="1">
                  <c:v>-2.4471585802997306E-3</c:v>
                </c:pt>
                <c:pt idx="2">
                  <c:v>-2.537496552006799E-3</c:v>
                </c:pt>
                <c:pt idx="3">
                  <c:v>-2.6260016340871328E-3</c:v>
                </c:pt>
                <c:pt idx="4">
                  <c:v>-2.7126347451880031E-3</c:v>
                </c:pt>
                <c:pt idx="5">
                  <c:v>-2.7973576305663716E-3</c:v>
                </c:pt>
                <c:pt idx="6">
                  <c:v>-2.8801328789810985E-3</c:v>
                </c:pt>
                <c:pt idx="7">
                  <c:v>-2.9609239392127044E-3</c:v>
                </c:pt>
                <c:pt idx="8">
                  <c:v>-3.0396951362033531E-3</c:v>
                </c:pt>
                <c:pt idx="9">
                  <c:v>-3.1164116868099521E-3</c:v>
                </c:pt>
                <c:pt idx="10">
                  <c:v>-3.1910397151634125E-3</c:v>
                </c:pt>
                <c:pt idx="11">
                  <c:v>-3.2635462676272788E-3</c:v>
                </c:pt>
                <c:pt idx="12">
                  <c:v>-3.3338993273491252E-3</c:v>
                </c:pt>
                <c:pt idx="13">
                  <c:v>-3.4020678283982978E-3</c:v>
                </c:pt>
                <c:pt idx="14">
                  <c:v>-3.4680216694837557E-3</c:v>
                </c:pt>
                <c:pt idx="15">
                  <c:v>-3.5317317272459507E-3</c:v>
                </c:pt>
                <c:pt idx="16">
                  <c:v>-3.5931698691168872E-3</c:v>
                </c:pt>
                <c:pt idx="17">
                  <c:v>-3.6523089657426689E-3</c:v>
                </c:pt>
                <c:pt idx="18">
                  <c:v>-3.7091229029630598E-3</c:v>
                </c:pt>
                <c:pt idx="19">
                  <c:v>-3.763586593342761E-3</c:v>
                </c:pt>
                <c:pt idx="20">
                  <c:v>-3.8156759872493163E-3</c:v>
                </c:pt>
                <c:pt idx="21">
                  <c:v>-3.8653680834727523E-3</c:v>
                </c:pt>
                <c:pt idx="22">
                  <c:v>-3.9126409393822666E-3</c:v>
                </c:pt>
                <c:pt idx="23">
                  <c:v>-3.957473680615475E-3</c:v>
                </c:pt>
                <c:pt idx="24">
                  <c:v>-3.9998465102959423E-3</c:v>
                </c:pt>
                <c:pt idx="25">
                  <c:v>-4.0397407177749246E-3</c:v>
                </c:pt>
                <c:pt idx="26">
                  <c:v>-4.0771386868934676E-3</c:v>
                </c:pt>
                <c:pt idx="27">
                  <c:v>-4.1120239037612041E-3</c:v>
                </c:pt>
                <c:pt idx="28">
                  <c:v>-4.1443809640484249E-3</c:v>
                </c:pt>
                <c:pt idx="29">
                  <c:v>-4.1741955797881944E-3</c:v>
                </c:pt>
                <c:pt idx="30">
                  <c:v>-4.2014545856855186E-3</c:v>
                </c:pt>
                <c:pt idx="31">
                  <c:v>-4.2261459449307653E-3</c:v>
                </c:pt>
                <c:pt idx="32">
                  <c:v>-4.2482587545147818E-3</c:v>
                </c:pt>
                <c:pt idx="33">
                  <c:v>-4.2677832500433565E-3</c:v>
                </c:pt>
                <c:pt idx="34">
                  <c:v>-4.2847108100489018E-3</c:v>
                </c:pt>
                <c:pt idx="35">
                  <c:v>-4.2990339597974488E-3</c:v>
                </c:pt>
                <c:pt idx="36">
                  <c:v>-4.3107463745892822E-3</c:v>
                </c:pt>
                <c:pt idx="37">
                  <c:v>-4.3198428825517478E-3</c:v>
                </c:pt>
                <c:pt idx="38">
                  <c:v>-4.3263194669230049E-3</c:v>
                </c:pt>
                <c:pt idx="39">
                  <c:v>-4.3301732678257213E-3</c:v>
                </c:pt>
                <c:pt idx="40">
                  <c:v>-4.3314025835299065E-3</c:v>
                </c:pt>
                <c:pt idx="41">
                  <c:v>-4.3300068712043491E-3</c:v>
                </c:pt>
                <c:pt idx="42">
                  <c:v>-4.3259867471563251E-3</c:v>
                </c:pt>
                <c:pt idx="43">
                  <c:v>-4.3193439865594416E-3</c:v>
                </c:pt>
                <c:pt idx="44">
                  <c:v>-4.3100815226697758E-3</c:v>
                </c:pt>
                <c:pt idx="45">
                  <c:v>-4.2982034455306337E-3</c:v>
                </c:pt>
                <c:pt idx="46">
                  <c:v>-4.2837150001664992E-3</c:v>
                </c:pt>
                <c:pt idx="47">
                  <c:v>-4.2666225842669762E-3</c:v>
                </c:pt>
                <c:pt idx="48">
                  <c:v>-4.2469337453617554E-3</c:v>
                </c:pt>
                <c:pt idx="49">
                  <c:v>-4.2246571774878349E-3</c:v>
                </c:pt>
                <c:pt idx="50">
                  <c:v>-4.1998027173504784E-3</c:v>
                </c:pt>
                <c:pt idx="51">
                  <c:v>-4.1723813399795976E-3</c:v>
                </c:pt>
                <c:pt idx="52">
                  <c:v>-4.142405153883498E-3</c:v>
                </c:pt>
                <c:pt idx="53">
                  <c:v>-4.1098873957020948E-3</c:v>
                </c:pt>
                <c:pt idx="54">
                  <c:v>-4.0748424243619904E-3</c:v>
                </c:pt>
                <c:pt idx="55">
                  <c:v>-4.0372857147359699E-3</c:v>
                </c:pt>
                <c:pt idx="56">
                  <c:v>-3.9972338508097423E-3</c:v>
                </c:pt>
                <c:pt idx="57">
                  <c:v>-3.9547045183589077E-3</c:v>
                </c:pt>
                <c:pt idx="58">
                  <c:v>-3.9097164971394309E-3</c:v>
                </c:pt>
                <c:pt idx="59">
                  <c:v>-3.862289652595015E-3</c:v>
                </c:pt>
                <c:pt idx="60">
                  <c:v>-3.8124449270850918E-3</c:v>
                </c:pt>
                <c:pt idx="61">
                  <c:v>-3.760204330637262E-3</c:v>
                </c:pt>
                <c:pt idx="62">
                  <c:v>-3.7055909312282797E-3</c:v>
                </c:pt>
                <c:pt idx="63">
                  <c:v>-3.6486288445978969E-3</c:v>
                </c:pt>
                <c:pt idx="64">
                  <c:v>-3.5893432236000227E-3</c:v>
                </c:pt>
                <c:pt idx="65">
                  <c:v>-3.5277602470959284E-3</c:v>
                </c:pt>
                <c:pt idx="66">
                  <c:v>-3.4639071083944072E-3</c:v>
                </c:pt>
                <c:pt idx="67">
                  <c:v>-3.3978120032439729E-3</c:v>
                </c:pt>
                <c:pt idx="68">
                  <c:v>-3.3295041173824055E-3</c:v>
                </c:pt>
                <c:pt idx="69">
                  <c:v>-3.2590136136491548E-3</c:v>
                </c:pt>
                <c:pt idx="70">
                  <c:v>-3.1863716186662809E-3</c:v>
                </c:pt>
                <c:pt idx="71">
                  <c:v>-3.1116102090938138E-3</c:v>
                </c:pt>
                <c:pt idx="72">
                  <c:v>-3.0347623974656007E-3</c:v>
                </c:pt>
                <c:pt idx="73">
                  <c:v>-2.9558621176119021E-3</c:v>
                </c:pt>
                <c:pt idx="74">
                  <c:v>-2.8749442096751682E-3</c:v>
                </c:pt>
                <c:pt idx="75">
                  <c:v>-2.792044404725612E-3</c:v>
                </c:pt>
                <c:pt idx="76">
                  <c:v>-2.7071993089833745E-3</c:v>
                </c:pt>
                <c:pt idx="77">
                  <c:v>-2.620446387654247E-3</c:v>
                </c:pt>
                <c:pt idx="78">
                  <c:v>-2.5318239483860952E-3</c:v>
                </c:pt>
                <c:pt idx="79">
                  <c:v>-2.4413711243532771E-3</c:v>
                </c:pt>
                <c:pt idx="80">
                  <c:v>-2.3491278569765335E-3</c:v>
                </c:pt>
                <c:pt idx="81">
                  <c:v>-2.255134878285985E-3</c:v>
                </c:pt>
                <c:pt idx="82">
                  <c:v>-2.1594336929350111E-3</c:v>
                </c:pt>
                <c:pt idx="83">
                  <c:v>-2.0620665598729626E-3</c:v>
                </c:pt>
                <c:pt idx="84">
                  <c:v>-1.9630764736848043E-3</c:v>
                </c:pt>
                <c:pt idx="85">
                  <c:v>-1.8625071456059121E-3</c:v>
                </c:pt>
                <c:pt idx="86">
                  <c:v>-1.7604029842204242E-3</c:v>
                </c:pt>
                <c:pt idx="87">
                  <c:v>-1.6568090758516585E-3</c:v>
                </c:pt>
                <c:pt idx="88">
                  <c:v>-1.5517711646532621E-3</c:v>
                </c:pt>
                <c:pt idx="89">
                  <c:v>-1.4453356324098845E-3</c:v>
                </c:pt>
                <c:pt idx="90">
                  <c:v>-1.3375494780562801E-3</c:v>
                </c:pt>
                <c:pt idx="91">
                  <c:v>-1.2284602969239073E-3</c:v>
                </c:pt>
                <c:pt idx="92">
                  <c:v>-1.1181162597241681E-3</c:v>
                </c:pt>
                <c:pt idx="93">
                  <c:v>-1.0065660912775799E-3</c:v>
                </c:pt>
                <c:pt idx="94">
                  <c:v>-8.9385904899826302E-4</c:v>
                </c:pt>
                <c:pt idx="95">
                  <c:v>-7.8004490114325412E-4</c:v>
                </c:pt>
                <c:pt idx="96">
                  <c:v>-6.6517390483624935E-4</c:v>
                </c:pt>
                <c:pt idx="97">
                  <c:v>-5.4929678387546465E-4</c:v>
                </c:pt>
                <c:pt idx="98">
                  <c:v>-4.3246470633544329E-4</c:v>
                </c:pt>
                <c:pt idx="99">
                  <c:v>-3.1472926197266917E-4</c:v>
                </c:pt>
                <c:pt idx="100">
                  <c:v>-1.9614243944498545E-4</c:v>
                </c:pt>
                <c:pt idx="101">
                  <c:v>-7.6756603354865074E-5</c:v>
                </c:pt>
                <c:pt idx="102">
                  <c:v>4.3375528873323618E-5</c:v>
                </c:pt>
                <c:pt idx="103">
                  <c:v>1.6420091027184508E-4</c:v>
                </c:pt>
                <c:pt idx="104">
                  <c:v>2.8566618775364809E-4</c:v>
                </c:pt>
                <c:pt idx="105">
                  <c:v>4.0771772567158374E-4</c:v>
                </c:pt>
                <c:pt idx="106">
                  <c:v>5.3030162950239677E-4</c:v>
                </c:pt>
                <c:pt idx="107">
                  <c:v>6.5336376964503359E-4</c:v>
                </c:pt>
                <c:pt idx="108">
                  <c:v>7.7684980532275079E-4</c:v>
                </c:pt>
                <c:pt idx="109">
                  <c:v>9.0070520857846561E-4</c:v>
                </c:pt>
                <c:pt idx="110">
                  <c:v>1.0248752883527711E-3</c:v>
                </c:pt>
                <c:pt idx="111">
                  <c:v>1.1493052146339701E-3</c:v>
                </c:pt>
                <c:pt idx="112">
                  <c:v>1.2739400426694616E-3</c:v>
                </c:pt>
                <c:pt idx="113">
                  <c:v>1.3987247372277997E-3</c:v>
                </c:pt>
                <c:pt idx="114">
                  <c:v>1.5236041969006993E-3</c:v>
                </c:pt>
                <c:pt idx="115">
                  <c:v>1.648523278434269E-3</c:v>
                </c:pt>
                <c:pt idx="116">
                  <c:v>1.7734268210787196E-3</c:v>
                </c:pt>
                <c:pt idx="117">
                  <c:v>1.8982596709457974E-3</c:v>
                </c:pt>
                <c:pt idx="118">
                  <c:v>2.0229667053631899E-3</c:v>
                </c:pt>
                <c:pt idx="119">
                  <c:v>2.147492857215143E-3</c:v>
                </c:pt>
                <c:pt idx="120">
                  <c:v>2.2717831392585551E-3</c:v>
                </c:pt>
                <c:pt idx="121">
                  <c:v>2.3957826684037863E-3</c:v>
                </c:pt>
                <c:pt idx="122">
                  <c:v>2.5194366899495011E-3</c:v>
                </c:pt>
                <c:pt idx="123">
                  <c:v>2.6426906017607841E-3</c:v>
                </c:pt>
                <c:pt idx="124">
                  <c:v>2.7654899783799199E-3</c:v>
                </c:pt>
                <c:pt idx="125">
                  <c:v>2.8877805950591369E-3</c:v>
                </c:pt>
                <c:pt idx="126">
                  <c:v>3.0095084517047302E-3</c:v>
                </c:pt>
                <c:pt idx="127">
                  <c:v>3.1306197967219838E-3</c:v>
                </c:pt>
                <c:pt idx="128">
                  <c:v>3.2510611507503631E-3</c:v>
                </c:pt>
                <c:pt idx="129">
                  <c:v>3.3707793302784898E-3</c:v>
                </c:pt>
                <c:pt idx="130">
                  <c:v>3.4897214711284907E-3</c:v>
                </c:pt>
                <c:pt idx="131">
                  <c:v>3.6078350517993229E-3</c:v>
                </c:pt>
                <c:pt idx="132">
                  <c:v>3.7250679166587961E-3</c:v>
                </c:pt>
                <c:pt idx="133">
                  <c:v>3.8413682989740265E-3</c:v>
                </c:pt>
                <c:pt idx="134">
                  <c:v>3.9566848437701755E-3</c:v>
                </c:pt>
                <c:pt idx="135">
                  <c:v>4.0709666305073526E-3</c:v>
                </c:pt>
                <c:pt idx="136">
                  <c:v>4.1841631955656967E-3</c:v>
                </c:pt>
                <c:pt idx="137">
                  <c:v>4.2962245545286951E-3</c:v>
                </c:pt>
                <c:pt idx="138">
                  <c:v>4.4071012242548847E-3</c:v>
                </c:pt>
                <c:pt idx="139">
                  <c:v>4.5167442447282199E-3</c:v>
                </c:pt>
                <c:pt idx="140">
                  <c:v>4.6251052006774356E-3</c:v>
                </c:pt>
                <c:pt idx="141">
                  <c:v>4.7321362429548711E-3</c:v>
                </c:pt>
                <c:pt idx="142">
                  <c:v>4.8377901096653027E-3</c:v>
                </c:pt>
                <c:pt idx="143">
                  <c:v>4.942020147035469E-3</c:v>
                </c:pt>
                <c:pt idx="144">
                  <c:v>5.0447803300150635E-3</c:v>
                </c:pt>
                <c:pt idx="145">
                  <c:v>5.1460252826000998E-3</c:v>
                </c:pt>
                <c:pt idx="146">
                  <c:v>5.2457102978696758E-3</c:v>
                </c:pt>
                <c:pt idx="147">
                  <c:v>5.3437913577272997E-3</c:v>
                </c:pt>
                <c:pt idx="148">
                  <c:v>5.4402251523380293E-3</c:v>
                </c:pt>
                <c:pt idx="149">
                  <c:v>5.5349690992528879E-3</c:v>
                </c:pt>
                <c:pt idx="150">
                  <c:v>5.6279813622120683E-3</c:v>
                </c:pt>
                <c:pt idx="151">
                  <c:v>5.7192208696186528E-3</c:v>
                </c:pt>
                <c:pt idx="152">
                  <c:v>5.8086473326746648E-3</c:v>
                </c:pt>
                <c:pt idx="153">
                  <c:v>5.8962212631714769E-3</c:v>
                </c:pt>
                <c:pt idx="154">
                  <c:v>5.9819039909266899E-3</c:v>
                </c:pt>
                <c:pt idx="155">
                  <c:v>6.0656576808597925E-3</c:v>
                </c:pt>
                <c:pt idx="156">
                  <c:v>6.1474453496990732E-3</c:v>
                </c:pt>
                <c:pt idx="157">
                  <c:v>6.2272308823123901E-3</c:v>
                </c:pt>
                <c:pt idx="158">
                  <c:v>6.304979047654596E-3</c:v>
                </c:pt>
                <c:pt idx="159">
                  <c:v>6.380655514324575E-3</c:v>
                </c:pt>
                <c:pt idx="160">
                  <c:v>6.4542268657250242E-3</c:v>
                </c:pt>
                <c:pt idx="161">
                  <c:v>6.5256606148182839E-3</c:v>
                </c:pt>
                <c:pt idx="162">
                  <c:v>6.5949252184716988E-3</c:v>
                </c:pt>
                <c:pt idx="163">
                  <c:v>6.6619900913861716E-3</c:v>
                </c:pt>
                <c:pt idx="164">
                  <c:v>6.7268256196017758E-3</c:v>
                </c:pt>
                <c:pt idx="165">
                  <c:v>6.7894031735744476E-3</c:v>
                </c:pt>
                <c:pt idx="166">
                  <c:v>6.8496951208179835E-3</c:v>
                </c:pt>
                <c:pt idx="167">
                  <c:v>6.9076748381057661E-3</c:v>
                </c:pt>
                <c:pt idx="168">
                  <c:v>6.9633167232268376E-3</c:v>
                </c:pt>
                <c:pt idx="169">
                  <c:v>7.0165962062911126E-3</c:v>
                </c:pt>
                <c:pt idx="170">
                  <c:v>7.0674897605787464E-3</c:v>
                </c:pt>
                <c:pt idx="171">
                  <c:v>7.1159749129288807E-3</c:v>
                </c:pt>
                <c:pt idx="172">
                  <c:v>7.1620302536631467E-3</c:v>
                </c:pt>
                <c:pt idx="173">
                  <c:v>7.20563544603959E-3</c:v>
                </c:pt>
                <c:pt idx="174">
                  <c:v>7.2467712352327924E-3</c:v>
                </c:pt>
                <c:pt idx="175">
                  <c:v>7.2854194568362646E-3</c:v>
                </c:pt>
                <c:pt idx="176">
                  <c:v>7.3215630448833415E-3</c:v>
                </c:pt>
                <c:pt idx="177">
                  <c:v>7.3551860393830217E-3</c:v>
                </c:pt>
                <c:pt idx="178">
                  <c:v>7.3862735933674598E-3</c:v>
                </c:pt>
                <c:pt idx="179">
                  <c:v>7.414811979447971E-3</c:v>
                </c:pt>
                <c:pt idx="180">
                  <c:v>7.4407885958766469E-3</c:v>
                </c:pt>
                <c:pt idx="181">
                  <c:v>7.4641919721109441E-3</c:v>
                </c:pt>
                <c:pt idx="182">
                  <c:v>7.4850117738787516E-3</c:v>
                </c:pt>
                <c:pt idx="183">
                  <c:v>7.5032388077417092E-3</c:v>
                </c:pt>
                <c:pt idx="184">
                  <c:v>7.5188650251547745E-3</c:v>
                </c:pt>
                <c:pt idx="185">
                  <c:v>7.5318835260202339E-3</c:v>
                </c:pt>
                <c:pt idx="186">
                  <c:v>7.5422885617345906E-3</c:v>
                </c:pt>
                <c:pt idx="187">
                  <c:v>7.5500755377269878E-3</c:v>
                </c:pt>
                <c:pt idx="188">
                  <c:v>7.5552410154880387E-3</c:v>
                </c:pt>
                <c:pt idx="189">
                  <c:v>7.5577827140881791E-3</c:v>
                </c:pt>
                <c:pt idx="190">
                  <c:v>7.5576995111848577E-3</c:v>
                </c:pt>
                <c:pt idx="191">
                  <c:v>7.5549914435181376E-3</c:v>
                </c:pt>
                <c:pt idx="192">
                  <c:v>7.5496597068944599E-3</c:v>
                </c:pt>
                <c:pt idx="193">
                  <c:v>7.5417066556586268E-3</c:v>
                </c:pt>
                <c:pt idx="194">
                  <c:v>7.5311358016541758E-3</c:v>
                </c:pt>
                <c:pt idx="195">
                  <c:v>7.5179518126726533E-3</c:v>
                </c:pt>
                <c:pt idx="196">
                  <c:v>7.5021605103924478E-3</c:v>
                </c:pt>
                <c:pt idx="197">
                  <c:v>7.4837688678081058E-3</c:v>
                </c:pt>
                <c:pt idx="198">
                  <c:v>7.4627850061512457E-3</c:v>
                </c:pt>
                <c:pt idx="199">
                  <c:v>7.4392181913044541E-3</c:v>
                </c:pt>
                <c:pt idx="200">
                  <c:v>7.413078829709735E-3</c:v>
                </c:pt>
                <c:pt idx="201">
                  <c:v>7.3843784637733154E-3</c:v>
                </c:pt>
                <c:pt idx="202">
                  <c:v>7.3531297667688462E-3</c:v>
                </c:pt>
                <c:pt idx="203">
                  <c:v>7.319346537241235E-3</c:v>
                </c:pt>
                <c:pt idx="204">
                  <c:v>7.2830436929136062E-3</c:v>
                </c:pt>
                <c:pt idx="205">
                  <c:v>7.2442372641000488E-3</c:v>
                </c:pt>
                <c:pt idx="206">
                  <c:v>7.2029443866270804E-3</c:v>
                </c:pt>
                <c:pt idx="207">
                  <c:v>7.1591832942669497E-3</c:v>
                </c:pt>
                <c:pt idx="208">
                  <c:v>7.1129733106861208E-3</c:v>
                </c:pt>
                <c:pt idx="209">
                  <c:v>7.0643348409124762E-3</c:v>
                </c:pt>
                <c:pt idx="210">
                  <c:v>7.0132893623250413E-3</c:v>
                </c:pt>
                <c:pt idx="211">
                  <c:v>6.9598594151701696E-3</c:v>
                </c:pt>
                <c:pt idx="212">
                  <c:v>6.9040685926084113E-3</c:v>
                </c:pt>
                <c:pt idx="213">
                  <c:v>6.8459415302964347E-3</c:v>
                </c:pt>
                <c:pt idx="214">
                  <c:v>6.7855038955086135E-3</c:v>
                </c:pt>
                <c:pt idx="215">
                  <c:v>6.722782375803078E-3</c:v>
                </c:pt>
                <c:pt idx="216">
                  <c:v>6.6578046672372496E-3</c:v>
                </c:pt>
                <c:pt idx="217">
                  <c:v>6.5905994621380335E-3</c:v>
                </c:pt>
                <c:pt idx="218">
                  <c:v>6.5211964364320961E-3</c:v>
                </c:pt>
                <c:pt idx="219">
                  <c:v>6.4496262365418174E-3</c:v>
                </c:pt>
                <c:pt idx="220">
                  <c:v>6.375920465852683E-3</c:v>
                </c:pt>
                <c:pt idx="221">
                  <c:v>6.3001116707581285E-3</c:v>
                </c:pt>
                <c:pt idx="222">
                  <c:v>6.2222333262879634E-3</c:v>
                </c:pt>
                <c:pt idx="223">
                  <c:v>6.1423198213267378E-3</c:v>
                </c:pt>
                <c:pt idx="224">
                  <c:v>6.0604064434285898E-3</c:v>
                </c:pt>
                <c:pt idx="225">
                  <c:v>5.9765293632352409E-3</c:v>
                </c:pt>
                <c:pt idx="226">
                  <c:v>5.8907256185040677E-3</c:v>
                </c:pt>
                <c:pt idx="227">
                  <c:v>5.8030330977532725E-3</c:v>
                </c:pt>
                <c:pt idx="228">
                  <c:v>5.7134905235313701E-3</c:v>
                </c:pt>
                <c:pt idx="229">
                  <c:v>5.6221374353184134E-3</c:v>
                </c:pt>
                <c:pt idx="230">
                  <c:v>5.5290141720664614E-3</c:v>
                </c:pt>
                <c:pt idx="231">
                  <c:v>5.4341618543870393E-3</c:v>
                </c:pt>
                <c:pt idx="232">
                  <c:v>5.3376223663934332E-3</c:v>
                </c:pt>
                <c:pt idx="233">
                  <c:v>5.2394383372058439E-3</c:v>
                </c:pt>
                <c:pt idx="234">
                  <c:v>5.1396531221275651E-3</c:v>
                </c:pt>
                <c:pt idx="235">
                  <c:v>5.03831078350051E-3</c:v>
                </c:pt>
                <c:pt idx="236">
                  <c:v>4.935456071248511E-3</c:v>
                </c:pt>
                <c:pt idx="237">
                  <c:v>4.8311344031170206E-3</c:v>
                </c:pt>
                <c:pt idx="238">
                  <c:v>4.725391844617911E-3</c:v>
                </c:pt>
                <c:pt idx="239">
                  <c:v>4.6182750886882423E-3</c:v>
                </c:pt>
                <c:pt idx="240">
                  <c:v>4.5098314350719712E-3</c:v>
                </c:pt>
                <c:pt idx="241">
                  <c:v>4.4001087694337214E-3</c:v>
                </c:pt>
                <c:pt idx="242">
                  <c:v>4.2891555422138253E-3</c:v>
                </c:pt>
                <c:pt idx="243">
                  <c:v>4.1770207472339518E-3</c:v>
                </c:pt>
                <c:pt idx="244">
                  <c:v>4.0637539000628478E-3</c:v>
                </c:pt>
                <c:pt idx="245">
                  <c:v>3.94940501615163E-3</c:v>
                </c:pt>
                <c:pt idx="246">
                  <c:v>3.8340245887483813E-3</c:v>
                </c:pt>
                <c:pt idx="247">
                  <c:v>3.717663566601752E-3</c:v>
                </c:pt>
                <c:pt idx="248">
                  <c:v>3.6003733314634253E-3</c:v>
                </c:pt>
                <c:pt idx="249">
                  <c:v>3.4822056753993826E-3</c:v>
                </c:pt>
                <c:pt idx="250">
                  <c:v>3.3632127779199879E-3</c:v>
                </c:pt>
                <c:pt idx="251">
                  <c:v>3.2434471829389804E-3</c:v>
                </c:pt>
                <c:pt idx="252">
                  <c:v>3.1229617755715658E-3</c:v>
                </c:pt>
                <c:pt idx="253">
                  <c:v>3.0018097587818341E-3</c:v>
                </c:pt>
                <c:pt idx="254">
                  <c:v>2.88004462988983E-3</c:v>
                </c:pt>
                <c:pt idx="255">
                  <c:v>2.7577201569486454E-3</c:v>
                </c:pt>
                <c:pt idx="256">
                  <c:v>2.6348903550019558E-3</c:v>
                </c:pt>
                <c:pt idx="257">
                  <c:v>2.5116094622325016E-3</c:v>
                </c:pt>
                <c:pt idx="258">
                  <c:v>2.3879319160120312E-3</c:v>
                </c:pt>
                <c:pt idx="259">
                  <c:v>2.2639123288632898E-3</c:v>
                </c:pt>
                <c:pt idx="260">
                  <c:v>2.1396054643446679E-3</c:v>
                </c:pt>
                <c:pt idx="261">
                  <c:v>2.0150662128681569E-3</c:v>
                </c:pt>
                <c:pt idx="262">
                  <c:v>1.8903495674612858E-3</c:v>
                </c:pt>
                <c:pt idx="263">
                  <c:v>1.7655105994837492E-3</c:v>
                </c:pt>
                <c:pt idx="264">
                  <c:v>1.6406044343094438E-3</c:v>
                </c:pt>
                <c:pt idx="265">
                  <c:v>1.5156862269846624E-3</c:v>
                </c:pt>
                <c:pt idx="266">
                  <c:v>1.3908111378731665E-3</c:v>
                </c:pt>
                <c:pt idx="267">
                  <c:v>1.2660343082989281E-3</c:v>
                </c:pt>
                <c:pt idx="268">
                  <c:v>1.1414108361972801E-3</c:v>
                </c:pt>
                <c:pt idx="269">
                  <c:v>1.0169957517852063E-3</c:v>
                </c:pt>
                <c:pt idx="270">
                  <c:v>8.9284399326155497E-4</c:v>
                </c:pt>
                <c:pt idx="271">
                  <c:v>7.6901038254788279E-4</c:v>
                </c:pt>
                <c:pt idx="272">
                  <c:v>6.4554960108061023E-4</c:v>
                </c:pt>
                <c:pt idx="273">
                  <c:v>5.2251616566527815E-4</c:v>
                </c:pt>
                <c:pt idx="274">
                  <c:v>3.9996440440342963E-4</c:v>
                </c:pt>
                <c:pt idx="275">
                  <c:v>2.7794843270286798E-4</c:v>
                </c:pt>
                <c:pt idx="276">
                  <c:v>1.565221293818057E-4</c:v>
                </c:pt>
                <c:pt idx="277">
                  <c:v>3.5739112877498924E-5</c:v>
                </c:pt>
                <c:pt idx="278">
                  <c:v>-8.4347282430145051E-5</c:v>
                </c:pt>
                <c:pt idx="279">
                  <c:v>-2.036840297695271E-4</c:v>
                </c:pt>
                <c:pt idx="280">
                  <c:v>-3.2221843339249028E-4</c:v>
                </c:pt>
                <c:pt idx="281">
                  <c:v>-4.3989815184327253E-4</c:v>
                </c:pt>
                <c:pt idx="282">
                  <c:v>-5.5667122107102727E-4</c:v>
                </c:pt>
                <c:pt idx="283">
                  <c:v>-6.7248607737567826E-4</c:v>
                </c:pt>
                <c:pt idx="284">
                  <c:v>-7.8729158017700309E-4</c:v>
                </c:pt>
                <c:pt idx="285">
                  <c:v>-9.0103703459687087E-4</c:v>
                </c:pt>
                <c:pt idx="286">
                  <c:v>-1.0136722138446761E-3</c:v>
                </c:pt>
                <c:pt idx="287">
                  <c:v>-1.1251473813960722E-3</c:v>
                </c:pt>
                <c:pt idx="288">
                  <c:v>-1.2354133129552224E-3</c:v>
                </c:pt>
                <c:pt idx="289">
                  <c:v>-1.3444213181908627E-3</c:v>
                </c:pt>
                <c:pt idx="290">
                  <c:v>-1.4521232622365819E-3</c:v>
                </c:pt>
                <c:pt idx="291">
                  <c:v>-1.5584715869458227E-3</c:v>
                </c:pt>
                <c:pt idx="292">
                  <c:v>-1.6634193318922209E-3</c:v>
                </c:pt>
                <c:pt idx="293">
                  <c:v>-1.7669201551060087E-3</c:v>
                </c:pt>
                <c:pt idx="294">
                  <c:v>-1.8689283535373215E-3</c:v>
                </c:pt>
                <c:pt idx="295">
                  <c:v>-1.9693988832373793E-3</c:v>
                </c:pt>
                <c:pt idx="296">
                  <c:v>-2.0682873792486284E-3</c:v>
                </c:pt>
                <c:pt idx="297">
                  <c:v>-2.1655501751950542E-3</c:v>
                </c:pt>
                <c:pt idx="298">
                  <c:v>-2.2611443225640264E-3</c:v>
                </c:pt>
                <c:pt idx="299">
                  <c:v>-2.3550276096711486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382096"/>
        <c:axId val="283382880"/>
      </c:scatterChart>
      <c:valAx>
        <c:axId val="283382096"/>
        <c:scaling>
          <c:orientation val="minMax"/>
          <c:max val="3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382880"/>
        <c:crosses val="autoZero"/>
        <c:crossBetween val="midCat"/>
      </c:valAx>
      <c:valAx>
        <c:axId val="283382880"/>
        <c:scaling>
          <c:orientation val="minMax"/>
          <c:max val="0.01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382096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99242883101152"/>
          <c:y val="0.10679611650485436"/>
          <c:w val="0.65111371895820724"/>
          <c:h val="0.7039966363427872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FF0000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FF0000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CM$1:$CM$15</c:f>
              <c:numCache>
                <c:formatCode>General</c:formatCode>
                <c:ptCount val="15"/>
                <c:pt idx="0">
                  <c:v>20.12323</c:v>
                </c:pt>
                <c:pt idx="1">
                  <c:v>0</c:v>
                </c:pt>
                <c:pt idx="2">
                  <c:v>0</c:v>
                </c:pt>
                <c:pt idx="3">
                  <c:v>9.9573979999999995</c:v>
                </c:pt>
                <c:pt idx="4">
                  <c:v>7.3840649999999997</c:v>
                </c:pt>
                <c:pt idx="5">
                  <c:v>182.50299999999999</c:v>
                </c:pt>
                <c:pt idx="6">
                  <c:v>215.07159999999999</c:v>
                </c:pt>
                <c:pt idx="7">
                  <c:v>168.19290000000001</c:v>
                </c:pt>
                <c:pt idx="8">
                  <c:v>170.3449</c:v>
                </c:pt>
                <c:pt idx="9">
                  <c:v>169.62780000000001</c:v>
                </c:pt>
                <c:pt idx="10">
                  <c:v>109.4692</c:v>
                </c:pt>
                <c:pt idx="11">
                  <c:v>104.2452</c:v>
                </c:pt>
                <c:pt idx="12">
                  <c:v>130.61089999999999</c:v>
                </c:pt>
                <c:pt idx="13">
                  <c:v>122.6031</c:v>
                </c:pt>
                <c:pt idx="14">
                  <c:v>129.15620000000001</c:v>
                </c:pt>
              </c:numCache>
            </c:numRef>
          </c:xVal>
          <c:yVal>
            <c:numRef>
              <c:f>'Covariance   Correlation3_HID4'!$CN$1:$CN$15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3999999999999998E-3</c:v>
                </c:pt>
                <c:pt idx="6">
                  <c:v>2.3E-3</c:v>
                </c:pt>
                <c:pt idx="7">
                  <c:v>2.8E-3</c:v>
                </c:pt>
                <c:pt idx="8">
                  <c:v>6.0000000000000001E-3</c:v>
                </c:pt>
                <c:pt idx="9">
                  <c:v>4.3E-3</c:v>
                </c:pt>
                <c:pt idx="10">
                  <c:v>3.5999999999999999E-3</c:v>
                </c:pt>
                <c:pt idx="11">
                  <c:v>0</c:v>
                </c:pt>
                <c:pt idx="12">
                  <c:v>1.8E-3</c:v>
                </c:pt>
                <c:pt idx="13">
                  <c:v>0</c:v>
                </c:pt>
                <c:pt idx="14">
                  <c:v>0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56</c:f>
              <c:numCache>
                <c:formatCode>General</c:formatCode>
                <c:ptCount val="300"/>
                <c:pt idx="0">
                  <c:v>-121.20560024334098</c:v>
                </c:pt>
                <c:pt idx="1">
                  <c:v>-121.15618285593435</c:v>
                </c:pt>
                <c:pt idx="2">
                  <c:v>-121.00795251504154</c:v>
                </c:pt>
                <c:pt idx="3">
                  <c:v>-120.76097467500826</c:v>
                </c:pt>
                <c:pt idx="4">
                  <c:v>-120.41535839429595</c:v>
                </c:pt>
                <c:pt idx="5">
                  <c:v>-119.97125628732472</c:v>
                </c:pt>
                <c:pt idx="6">
                  <c:v>-119.42886445708298</c:v>
                </c:pt>
                <c:pt idx="7">
                  <c:v>-118.78842240853403</c:v>
                </c:pt>
                <c:pt idx="8">
                  <c:v>-118.0502129428573</c:v>
                </c:pt>
                <c:pt idx="9">
                  <c:v>-117.21456203257144</c:v>
                </c:pt>
                <c:pt idx="10">
                  <c:v>-116.28183867759385</c:v>
                </c:pt>
                <c:pt idx="11">
                  <c:v>-115.25245474230088</c:v>
                </c:pt>
                <c:pt idx="12">
                  <c:v>-114.12686477366002</c:v>
                </c:pt>
                <c:pt idx="13">
                  <c:v>-112.90556580051474</c:v>
                </c:pt>
                <c:pt idx="14">
                  <c:v>-111.58909711411066</c:v>
                </c:pt>
                <c:pt idx="15">
                  <c:v>-110.17804002995952</c:v>
                </c:pt>
                <c:pt idx="16">
                  <c:v>-108.67301763114686</c:v>
                </c:pt>
                <c:pt idx="17">
                  <c:v>-107.07469449319588</c:v>
                </c:pt>
                <c:pt idx="18">
                  <c:v>-105.38377639060964</c:v>
                </c:pt>
                <c:pt idx="19">
                  <c:v>-103.60100998522098</c:v>
                </c:pt>
                <c:pt idx="20">
                  <c:v>-101.7271824964876</c:v>
                </c:pt>
                <c:pt idx="21">
                  <c:v>-99.763121353878105</c:v>
                </c:pt>
                <c:pt idx="22">
                  <c:v>-97.709693831502491</c:v>
                </c:pt>
                <c:pt idx="23">
                  <c:v>-95.567806665148382</c:v>
                </c:pt>
                <c:pt idx="24">
                  <c:v>-93.338405651891733</c:v>
                </c:pt>
                <c:pt idx="25">
                  <c:v>-91.022475232459826</c:v>
                </c:pt>
                <c:pt idx="26">
                  <c:v>-88.621038056529827</c:v>
                </c:pt>
                <c:pt idx="27">
                  <c:v>-86.135154531155351</c:v>
                </c:pt>
                <c:pt idx="28">
                  <c:v>-83.565922352520758</c:v>
                </c:pt>
                <c:pt idx="29">
                  <c:v>-80.914476021229333</c:v>
                </c:pt>
                <c:pt idx="30">
                  <c:v>-78.181986341339652</c:v>
                </c:pt>
                <c:pt idx="31">
                  <c:v>-75.369659903371641</c:v>
                </c:pt>
                <c:pt idx="32">
                  <c:v>-72.478738551510119</c:v>
                </c:pt>
                <c:pt idx="33">
                  <c:v>-69.510498835241307</c:v>
                </c:pt>
                <c:pt idx="34">
                  <c:v>-66.466251445664582</c:v>
                </c:pt>
                <c:pt idx="35">
                  <c:v>-63.347340636727992</c:v>
                </c:pt>
                <c:pt idx="36">
                  <c:v>-60.155143631643952</c:v>
                </c:pt>
                <c:pt idx="37">
                  <c:v>-56.891070014745836</c:v>
                </c:pt>
                <c:pt idx="38">
                  <c:v>-53.556561109055465</c:v>
                </c:pt>
                <c:pt idx="39">
                  <c:v>-50.153089339835375</c:v>
                </c:pt>
                <c:pt idx="40">
                  <c:v>-46.682157584407165</c:v>
                </c:pt>
                <c:pt idx="41">
                  <c:v>-43.145298508523283</c:v>
                </c:pt>
                <c:pt idx="42">
                  <c:v>-39.544073889585107</c:v>
                </c:pt>
                <c:pt idx="43">
                  <c:v>-35.880073927005625</c:v>
                </c:pt>
                <c:pt idx="44">
                  <c:v>-32.154916540022569</c:v>
                </c:pt>
                <c:pt idx="45">
                  <c:v>-28.37024665327057</c:v>
                </c:pt>
                <c:pt idx="46">
                  <c:v>-24.527735470428794</c:v>
                </c:pt>
                <c:pt idx="47">
                  <c:v>-20.629079736264472</c:v>
                </c:pt>
                <c:pt idx="48">
                  <c:v>-16.676000987398197</c:v>
                </c:pt>
                <c:pt idx="49">
                  <c:v>-12.670244792121736</c:v>
                </c:pt>
                <c:pt idx="50">
                  <c:v>-8.6135799796043244</c:v>
                </c:pt>
                <c:pt idx="51">
                  <c:v>-4.5077978588273453</c:v>
                </c:pt>
                <c:pt idx="52">
                  <c:v>-0.35471142759286067</c:v>
                </c:pt>
                <c:pt idx="53">
                  <c:v>3.8438454280452277</c:v>
                </c:pt>
                <c:pt idx="54">
                  <c:v>8.0860187435735895</c:v>
                </c:pt>
                <c:pt idx="55">
                  <c:v>12.369935294678328</c:v>
                </c:pt>
                <c:pt idx="56">
                  <c:v>16.693703424407573</c:v>
                </c:pt>
                <c:pt idx="57">
                  <c:v>21.055413878474255</c:v>
                </c:pt>
                <c:pt idx="58">
                  <c:v>25.453140648329011</c:v>
                </c:pt>
                <c:pt idx="59">
                  <c:v>29.884941821631358</c:v>
                </c:pt>
                <c:pt idx="60">
                  <c:v>34.348860439743447</c:v>
                </c:pt>
                <c:pt idx="61">
                  <c:v>38.842925361867913</c:v>
                </c:pt>
                <c:pt idx="62">
                  <c:v>43.365152135448326</c:v>
                </c:pt>
                <c:pt idx="63">
                  <c:v>47.91354387244732</c:v>
                </c:pt>
                <c:pt idx="64">
                  <c:v>52.486092131116287</c:v>
                </c:pt>
                <c:pt idx="65">
                  <c:v>57.080777802866677</c:v>
                </c:pt>
                <c:pt idx="66">
                  <c:v>61.695572003851531</c:v>
                </c:pt>
                <c:pt idx="67">
                  <c:v>66.32843697086345</c:v>
                </c:pt>
                <c:pt idx="68">
                  <c:v>70.977326961153437</c:v>
                </c:pt>
                <c:pt idx="69">
                  <c:v>75.640189155773442</c:v>
                </c:pt>
                <c:pt idx="70">
                  <c:v>80.314964566043244</c:v>
                </c:pt>
                <c:pt idx="71">
                  <c:v>84.999588942741923</c:v>
                </c:pt>
                <c:pt idx="72">
                  <c:v>89.691993687622329</c:v>
                </c:pt>
                <c:pt idx="73">
                  <c:v>94.390106766845676</c:v>
                </c:pt>
                <c:pt idx="74">
                  <c:v>99.091853625933467</c:v>
                </c:pt>
                <c:pt idx="75">
                  <c:v>103.79515810583227</c:v>
                </c:pt>
                <c:pt idx="76">
                  <c:v>108.49794335968728</c:v>
                </c:pt>
                <c:pt idx="77">
                  <c:v>113.19813276991914</c:v>
                </c:pt>
                <c:pt idx="78">
                  <c:v>117.89365086520004</c:v>
                </c:pt>
                <c:pt idx="79">
                  <c:v>122.58242423692333</c:v>
                </c:pt>
                <c:pt idx="80">
                  <c:v>127.26238245476242</c:v>
                </c:pt>
                <c:pt idx="81">
                  <c:v>131.93145898091447</c:v>
                </c:pt>
                <c:pt idx="82">
                  <c:v>136.58759208262543</c:v>
                </c:pt>
                <c:pt idx="83">
                  <c:v>141.2287257425931</c:v>
                </c:pt>
                <c:pt idx="84">
                  <c:v>145.8528105668465</c:v>
                </c:pt>
                <c:pt idx="85">
                  <c:v>150.45780468970051</c:v>
                </c:pt>
                <c:pt idx="86">
                  <c:v>155.04167467538633</c:v>
                </c:pt>
                <c:pt idx="87">
                  <c:v>159.60239641595956</c:v>
                </c:pt>
                <c:pt idx="88">
                  <c:v>164.13795602508904</c:v>
                </c:pt>
                <c:pt idx="89">
                  <c:v>168.64635072733256</c:v>
                </c:pt>
                <c:pt idx="90">
                  <c:v>173.12558974250624</c:v>
                </c:pt>
                <c:pt idx="91">
                  <c:v>177.57369516475663</c:v>
                </c:pt>
                <c:pt idx="92">
                  <c:v>181.98870283594854</c:v>
                </c:pt>
                <c:pt idx="93">
                  <c:v>186.36866321298191</c:v>
                </c:pt>
                <c:pt idx="94">
                  <c:v>190.71164222865517</c:v>
                </c:pt>
                <c:pt idx="95">
                  <c:v>195.01572214569484</c:v>
                </c:pt>
                <c:pt idx="96">
                  <c:v>199.27900240357431</c:v>
                </c:pt>
                <c:pt idx="97">
                  <c:v>203.49960045774802</c:v>
                </c:pt>
                <c:pt idx="98">
                  <c:v>207.67565261092989</c:v>
                </c:pt>
                <c:pt idx="99">
                  <c:v>211.80531483604975</c:v>
                </c:pt>
                <c:pt idx="100">
                  <c:v>215.88676359052371</c:v>
                </c:pt>
                <c:pt idx="101">
                  <c:v>219.91819662147924</c:v>
                </c:pt>
                <c:pt idx="102">
                  <c:v>223.89783376157942</c:v>
                </c:pt>
                <c:pt idx="103">
                  <c:v>227.8239177150945</c:v>
                </c:pt>
                <c:pt idx="104">
                  <c:v>231.69471483387434</c:v>
                </c:pt>
                <c:pt idx="105">
                  <c:v>235.50851588287873</c:v>
                </c:pt>
                <c:pt idx="106">
                  <c:v>239.26363679492727</c:v>
                </c:pt>
                <c:pt idx="107">
                  <c:v>242.95841941433616</c:v>
                </c:pt>
                <c:pt idx="108">
                  <c:v>246.59123222911313</c:v>
                </c:pt>
                <c:pt idx="109">
                  <c:v>250.16047109138697</c:v>
                </c:pt>
                <c:pt idx="110">
                  <c:v>253.6645599257543</c:v>
                </c:pt>
                <c:pt idx="111">
                  <c:v>257.10195142522991</c:v>
                </c:pt>
                <c:pt idx="112">
                  <c:v>260.47112773449425</c:v>
                </c:pt>
                <c:pt idx="113">
                  <c:v>263.77060112013527</c:v>
                </c:pt>
                <c:pt idx="114">
                  <c:v>266.9989146275899</c:v>
                </c:pt>
                <c:pt idx="115">
                  <c:v>270.1546427244939</c:v>
                </c:pt>
                <c:pt idx="116">
                  <c:v>273.23639193015714</c:v>
                </c:pt>
                <c:pt idx="117">
                  <c:v>276.24280143088509</c:v>
                </c:pt>
                <c:pt idx="118">
                  <c:v>279.17254368087623</c:v>
                </c:pt>
                <c:pt idx="119">
                  <c:v>282.02432498842842</c:v>
                </c:pt>
                <c:pt idx="120">
                  <c:v>284.79688608719727</c:v>
                </c:pt>
                <c:pt idx="121">
                  <c:v>287.48900269225226</c:v>
                </c:pt>
                <c:pt idx="122">
                  <c:v>290.09948604068688</c:v>
                </c:pt>
                <c:pt idx="123">
                  <c:v>292.62718341654249</c:v>
                </c:pt>
                <c:pt idx="124">
                  <c:v>295.07097865981558</c:v>
                </c:pt>
                <c:pt idx="125">
                  <c:v>297.42979265932235</c:v>
                </c:pt>
                <c:pt idx="126">
                  <c:v>299.70258382920377</c:v>
                </c:pt>
                <c:pt idx="127">
                  <c:v>301.88834856886115</c:v>
                </c:pt>
                <c:pt idx="128">
                  <c:v>303.9861217061171</c:v>
                </c:pt>
                <c:pt idx="129">
                  <c:v>305.99497692340896</c:v>
                </c:pt>
                <c:pt idx="130">
                  <c:v>307.91402716682433</c:v>
                </c:pt>
                <c:pt idx="131">
                  <c:v>309.74242503779925</c:v>
                </c:pt>
                <c:pt idx="132">
                  <c:v>311.47936316730539</c:v>
                </c:pt>
                <c:pt idx="133">
                  <c:v>313.12407457236151</c:v>
                </c:pt>
                <c:pt idx="134">
                  <c:v>314.6758329947117</c:v>
                </c:pt>
                <c:pt idx="135">
                  <c:v>316.13395322152041</c:v>
                </c:pt>
                <c:pt idx="136">
                  <c:v>317.49779138794321</c:v>
                </c:pt>
                <c:pt idx="137">
                  <c:v>318.7667452614395</c:v>
                </c:pt>
                <c:pt idx="138">
                  <c:v>319.94025450770118</c:v>
                </c:pt>
                <c:pt idx="139">
                  <c:v>321.01780093808077</c:v>
                </c:pt>
                <c:pt idx="140">
                  <c:v>321.99890873840877</c:v>
                </c:pt>
                <c:pt idx="141">
                  <c:v>322.88314467909993</c:v>
                </c:pt>
                <c:pt idx="142">
                  <c:v>323.67011830645498</c:v>
                </c:pt>
                <c:pt idx="143">
                  <c:v>324.3594821150744</c:v>
                </c:pt>
                <c:pt idx="144">
                  <c:v>324.95093170130662</c:v>
                </c:pt>
                <c:pt idx="145">
                  <c:v>325.4442058976644</c:v>
                </c:pt>
                <c:pt idx="146">
                  <c:v>325.83908688814881</c:v>
                </c:pt>
                <c:pt idx="147">
                  <c:v>326.13540030443085</c:v>
                </c:pt>
                <c:pt idx="148">
                  <c:v>326.3330153028474</c:v>
                </c:pt>
                <c:pt idx="149">
                  <c:v>326.43184462217829</c:v>
                </c:pt>
                <c:pt idx="150">
                  <c:v>326.43184462217829</c:v>
                </c:pt>
                <c:pt idx="151">
                  <c:v>326.33301530284729</c:v>
                </c:pt>
                <c:pt idx="152">
                  <c:v>326.13540030443068</c:v>
                </c:pt>
                <c:pt idx="153">
                  <c:v>325.83908688814859</c:v>
                </c:pt>
                <c:pt idx="154">
                  <c:v>325.44420589766412</c:v>
                </c:pt>
                <c:pt idx="155">
                  <c:v>324.95093170130627</c:v>
                </c:pt>
                <c:pt idx="156">
                  <c:v>324.35948211507394</c:v>
                </c:pt>
                <c:pt idx="157">
                  <c:v>323.67011830645447</c:v>
                </c:pt>
                <c:pt idx="158">
                  <c:v>322.8831446790993</c:v>
                </c:pt>
                <c:pt idx="159">
                  <c:v>321.99890873840815</c:v>
                </c:pt>
                <c:pt idx="160">
                  <c:v>321.01780093808003</c:v>
                </c:pt>
                <c:pt idx="161">
                  <c:v>319.94025450770039</c:v>
                </c:pt>
                <c:pt idx="162">
                  <c:v>318.76674526143859</c:v>
                </c:pt>
                <c:pt idx="163">
                  <c:v>317.49779138794224</c:v>
                </c:pt>
                <c:pt idx="164">
                  <c:v>316.13395322151939</c:v>
                </c:pt>
                <c:pt idx="165">
                  <c:v>314.67583299471062</c:v>
                </c:pt>
                <c:pt idx="166">
                  <c:v>313.12407457236037</c:v>
                </c:pt>
                <c:pt idx="167">
                  <c:v>311.4793631673042</c:v>
                </c:pt>
                <c:pt idx="168">
                  <c:v>309.742425037798</c:v>
                </c:pt>
                <c:pt idx="169">
                  <c:v>307.91402716682302</c:v>
                </c:pt>
                <c:pt idx="170">
                  <c:v>305.99497692340759</c:v>
                </c:pt>
                <c:pt idx="171">
                  <c:v>303.98612170611568</c:v>
                </c:pt>
                <c:pt idx="172">
                  <c:v>301.88834856885967</c:v>
                </c:pt>
                <c:pt idx="173">
                  <c:v>299.70258382920224</c:v>
                </c:pt>
                <c:pt idx="174">
                  <c:v>297.4297926593207</c:v>
                </c:pt>
                <c:pt idx="175">
                  <c:v>295.07097865981393</c:v>
                </c:pt>
                <c:pt idx="176">
                  <c:v>292.62718341654079</c:v>
                </c:pt>
                <c:pt idx="177">
                  <c:v>290.09948604068506</c:v>
                </c:pt>
                <c:pt idx="178">
                  <c:v>287.48900269225044</c:v>
                </c:pt>
                <c:pt idx="179">
                  <c:v>284.79688608719533</c:v>
                </c:pt>
                <c:pt idx="180">
                  <c:v>282.02432498842643</c:v>
                </c:pt>
                <c:pt idx="181">
                  <c:v>279.17254368087418</c:v>
                </c:pt>
                <c:pt idx="182">
                  <c:v>276.24280143088305</c:v>
                </c:pt>
                <c:pt idx="183">
                  <c:v>273.23639193015504</c:v>
                </c:pt>
                <c:pt idx="184">
                  <c:v>270.15464272449174</c:v>
                </c:pt>
                <c:pt idx="185">
                  <c:v>266.99891462758768</c:v>
                </c:pt>
                <c:pt idx="186">
                  <c:v>263.77060112013299</c:v>
                </c:pt>
                <c:pt idx="187">
                  <c:v>260.47112773449192</c:v>
                </c:pt>
                <c:pt idx="188">
                  <c:v>257.10195142522753</c:v>
                </c:pt>
                <c:pt idx="189">
                  <c:v>253.66455992575186</c:v>
                </c:pt>
                <c:pt idx="190">
                  <c:v>250.16047109138447</c:v>
                </c:pt>
                <c:pt idx="191">
                  <c:v>246.59123222911069</c:v>
                </c:pt>
                <c:pt idx="192">
                  <c:v>242.95841941433366</c:v>
                </c:pt>
                <c:pt idx="193">
                  <c:v>239.26363679492471</c:v>
                </c:pt>
                <c:pt idx="194">
                  <c:v>235.50851588287611</c:v>
                </c:pt>
                <c:pt idx="195">
                  <c:v>231.69471483387167</c:v>
                </c:pt>
                <c:pt idx="196">
                  <c:v>227.8239177150918</c:v>
                </c:pt>
                <c:pt idx="197">
                  <c:v>223.89783376157666</c:v>
                </c:pt>
                <c:pt idx="198">
                  <c:v>219.91819662147645</c:v>
                </c:pt>
                <c:pt idx="199">
                  <c:v>215.88676359052087</c:v>
                </c:pt>
                <c:pt idx="200">
                  <c:v>211.80531483604688</c:v>
                </c:pt>
                <c:pt idx="201">
                  <c:v>207.67565261092699</c:v>
                </c:pt>
                <c:pt idx="202">
                  <c:v>203.49960045774509</c:v>
                </c:pt>
                <c:pt idx="203">
                  <c:v>199.27900240357135</c:v>
                </c:pt>
                <c:pt idx="204">
                  <c:v>195.01572214569183</c:v>
                </c:pt>
                <c:pt idx="205">
                  <c:v>190.71164222865212</c:v>
                </c:pt>
                <c:pt idx="206">
                  <c:v>186.36866321297884</c:v>
                </c:pt>
                <c:pt idx="207">
                  <c:v>181.98870283594545</c:v>
                </c:pt>
                <c:pt idx="208">
                  <c:v>177.5736951647535</c:v>
                </c:pt>
                <c:pt idx="209">
                  <c:v>173.12558974250308</c:v>
                </c:pt>
                <c:pt idx="210">
                  <c:v>168.64635072732938</c:v>
                </c:pt>
                <c:pt idx="211">
                  <c:v>164.13795602508577</c:v>
                </c:pt>
                <c:pt idx="212">
                  <c:v>159.60239641595626</c:v>
                </c:pt>
                <c:pt idx="213">
                  <c:v>155.04167467538306</c:v>
                </c:pt>
                <c:pt idx="214">
                  <c:v>150.45780468969741</c:v>
                </c:pt>
                <c:pt idx="215">
                  <c:v>145.85281056684337</c:v>
                </c:pt>
                <c:pt idx="216">
                  <c:v>141.22872574258997</c:v>
                </c:pt>
                <c:pt idx="217">
                  <c:v>136.58759208262228</c:v>
                </c:pt>
                <c:pt idx="218">
                  <c:v>131.93145898091129</c:v>
                </c:pt>
                <c:pt idx="219">
                  <c:v>127.26238245475921</c:v>
                </c:pt>
                <c:pt idx="220">
                  <c:v>122.5824242369201</c:v>
                </c:pt>
                <c:pt idx="221">
                  <c:v>117.89365086519682</c:v>
                </c:pt>
                <c:pt idx="222">
                  <c:v>113.19813276991592</c:v>
                </c:pt>
                <c:pt idx="223">
                  <c:v>108.49794335968404</c:v>
                </c:pt>
                <c:pt idx="224">
                  <c:v>103.79515810582905</c:v>
                </c:pt>
                <c:pt idx="225">
                  <c:v>99.091853625930199</c:v>
                </c:pt>
                <c:pt idx="226">
                  <c:v>94.390106766842393</c:v>
                </c:pt>
                <c:pt idx="227">
                  <c:v>89.691993687619046</c:v>
                </c:pt>
                <c:pt idx="228">
                  <c:v>84.999588942738654</c:v>
                </c:pt>
                <c:pt idx="229">
                  <c:v>80.314964566039976</c:v>
                </c:pt>
                <c:pt idx="230">
                  <c:v>75.640189155770187</c:v>
                </c:pt>
                <c:pt idx="231">
                  <c:v>70.977326961150183</c:v>
                </c:pt>
                <c:pt idx="232">
                  <c:v>66.328436970860167</c:v>
                </c:pt>
                <c:pt idx="233">
                  <c:v>61.695572003848262</c:v>
                </c:pt>
                <c:pt idx="234">
                  <c:v>57.080777802863423</c:v>
                </c:pt>
                <c:pt idx="235">
                  <c:v>52.48609213111304</c:v>
                </c:pt>
                <c:pt idx="236">
                  <c:v>47.913543872444102</c:v>
                </c:pt>
                <c:pt idx="237">
                  <c:v>43.365152135445122</c:v>
                </c:pt>
                <c:pt idx="238">
                  <c:v>38.842925361864715</c:v>
                </c:pt>
                <c:pt idx="239">
                  <c:v>34.348860439740221</c:v>
                </c:pt>
                <c:pt idx="240">
                  <c:v>29.884941821628161</c:v>
                </c:pt>
                <c:pt idx="241">
                  <c:v>25.453140648325828</c:v>
                </c:pt>
                <c:pt idx="242">
                  <c:v>21.055413878471285</c:v>
                </c:pt>
                <c:pt idx="243">
                  <c:v>16.693703424404632</c:v>
                </c:pt>
                <c:pt idx="244">
                  <c:v>12.369935294675429</c:v>
                </c:pt>
                <c:pt idx="245">
                  <c:v>8.0860187435707047</c:v>
                </c:pt>
                <c:pt idx="246">
                  <c:v>3.843845428042286</c:v>
                </c:pt>
                <c:pt idx="247">
                  <c:v>-0.35471142759578811</c:v>
                </c:pt>
                <c:pt idx="248">
                  <c:v>-4.5077978588302301</c:v>
                </c:pt>
                <c:pt idx="249">
                  <c:v>-8.6135799796071666</c:v>
                </c:pt>
                <c:pt idx="250">
                  <c:v>-12.670244792124578</c:v>
                </c:pt>
                <c:pt idx="251">
                  <c:v>-16.676000987400982</c:v>
                </c:pt>
                <c:pt idx="252">
                  <c:v>-20.629079736267215</c:v>
                </c:pt>
                <c:pt idx="253">
                  <c:v>-24.52773547043148</c:v>
                </c:pt>
                <c:pt idx="254">
                  <c:v>-28.370246653273242</c:v>
                </c:pt>
                <c:pt idx="255">
                  <c:v>-32.154916540025184</c:v>
                </c:pt>
                <c:pt idx="256">
                  <c:v>-35.880073927008212</c:v>
                </c:pt>
                <c:pt idx="257">
                  <c:v>-39.544073889587636</c:v>
                </c:pt>
                <c:pt idx="258">
                  <c:v>-43.145298508525784</c:v>
                </c:pt>
                <c:pt idx="259">
                  <c:v>-46.68215758440958</c:v>
                </c:pt>
                <c:pt idx="260">
                  <c:v>-50.153089339837763</c:v>
                </c:pt>
                <c:pt idx="261">
                  <c:v>-53.556561109057824</c:v>
                </c:pt>
                <c:pt idx="262">
                  <c:v>-56.891070014748138</c:v>
                </c:pt>
                <c:pt idx="263">
                  <c:v>-60.155143631646197</c:v>
                </c:pt>
                <c:pt idx="264">
                  <c:v>-63.347340636730209</c:v>
                </c:pt>
                <c:pt idx="265">
                  <c:v>-66.466251445666742</c:v>
                </c:pt>
                <c:pt idx="266">
                  <c:v>-69.510498835243467</c:v>
                </c:pt>
                <c:pt idx="267">
                  <c:v>-72.478738551512251</c:v>
                </c:pt>
                <c:pt idx="268">
                  <c:v>-75.369659903373716</c:v>
                </c:pt>
                <c:pt idx="269">
                  <c:v>-78.181986341341641</c:v>
                </c:pt>
                <c:pt idx="270">
                  <c:v>-80.914476021231238</c:v>
                </c:pt>
                <c:pt idx="271">
                  <c:v>-83.565922352522549</c:v>
                </c:pt>
                <c:pt idx="272">
                  <c:v>-86.135154531157056</c:v>
                </c:pt>
                <c:pt idx="273">
                  <c:v>-88.621038056531447</c:v>
                </c:pt>
                <c:pt idx="274">
                  <c:v>-91.022475232461417</c:v>
                </c:pt>
                <c:pt idx="275">
                  <c:v>-93.338405651893268</c:v>
                </c:pt>
                <c:pt idx="276">
                  <c:v>-95.56780666514986</c:v>
                </c:pt>
                <c:pt idx="277">
                  <c:v>-97.709693831503969</c:v>
                </c:pt>
                <c:pt idx="278">
                  <c:v>-99.763121353879527</c:v>
                </c:pt>
                <c:pt idx="279">
                  <c:v>-101.72718249648894</c:v>
                </c:pt>
                <c:pt idx="280">
                  <c:v>-103.60100998522229</c:v>
                </c:pt>
                <c:pt idx="281">
                  <c:v>-105.38377639061086</c:v>
                </c:pt>
                <c:pt idx="282">
                  <c:v>-107.07469449319704</c:v>
                </c:pt>
                <c:pt idx="283">
                  <c:v>-108.67301763114797</c:v>
                </c:pt>
                <c:pt idx="284">
                  <c:v>-110.17804002996054</c:v>
                </c:pt>
                <c:pt idx="285">
                  <c:v>-111.5890971141116</c:v>
                </c:pt>
                <c:pt idx="286">
                  <c:v>-112.90556580051562</c:v>
                </c:pt>
                <c:pt idx="287">
                  <c:v>-114.12686477366084</c:v>
                </c:pt>
                <c:pt idx="288">
                  <c:v>-115.25245474230162</c:v>
                </c:pt>
                <c:pt idx="289">
                  <c:v>-116.28183867759456</c:v>
                </c:pt>
                <c:pt idx="290">
                  <c:v>-117.21456203257206</c:v>
                </c:pt>
                <c:pt idx="291">
                  <c:v>-118.05021294285784</c:v>
                </c:pt>
                <c:pt idx="292">
                  <c:v>-118.78842240853452</c:v>
                </c:pt>
                <c:pt idx="293">
                  <c:v>-119.42886445708341</c:v>
                </c:pt>
                <c:pt idx="294">
                  <c:v>-119.97125628732506</c:v>
                </c:pt>
                <c:pt idx="295">
                  <c:v>-120.41535839429623</c:v>
                </c:pt>
                <c:pt idx="296">
                  <c:v>-120.76097467500846</c:v>
                </c:pt>
                <c:pt idx="297">
                  <c:v>-121.00795251504165</c:v>
                </c:pt>
                <c:pt idx="298">
                  <c:v>-121.1561828559344</c:v>
                </c:pt>
                <c:pt idx="299">
                  <c:v>-121.20560024334098</c:v>
                </c:pt>
              </c:numCache>
            </c:numRef>
          </c:xVal>
          <c:yVal>
            <c:numRef>
              <c:f>'Covariance   Correlation3'!yycir57</c:f>
              <c:numCache>
                <c:formatCode>General</c:formatCode>
                <c:ptCount val="300"/>
                <c:pt idx="0">
                  <c:v>-2.5439986749425138E-3</c:v>
                </c:pt>
                <c:pt idx="1">
                  <c:v>-2.6323688569642968E-3</c:v>
                </c:pt>
                <c:pt idx="2">
                  <c:v>-2.7188642564202393E-3</c:v>
                </c:pt>
                <c:pt idx="3">
                  <c:v>-2.8034466793768866E-3</c:v>
                </c:pt>
                <c:pt idx="4">
                  <c:v>-2.8860787766173527E-3</c:v>
                </c:pt>
                <c:pt idx="5">
                  <c:v>-2.9667240601336858E-3</c:v>
                </c:pt>
                <c:pt idx="6">
                  <c:v>-3.0453469192389415E-3</c:v>
                </c:pt>
                <c:pt idx="7">
                  <c:v>-3.1219126362918626E-3</c:v>
                </c:pt>
                <c:pt idx="8">
                  <c:v>-3.1963874020272125E-3</c:v>
                </c:pt>
                <c:pt idx="9">
                  <c:v>-3.2687383304849937E-3</c:v>
                </c:pt>
                <c:pt idx="10">
                  <c:v>-3.3389334735319585E-3</c:v>
                </c:pt>
                <c:pt idx="11">
                  <c:v>-3.4069418349690133E-3</c:v>
                </c:pt>
                <c:pt idx="12">
                  <c:v>-3.4727333842182596E-3</c:v>
                </c:pt>
                <c:pt idx="13">
                  <c:v>-3.5362790695836577E-3</c:v>
                </c:pt>
                <c:pt idx="14">
                  <c:v>-3.5975508310794324E-3</c:v>
                </c:pt>
                <c:pt idx="15">
                  <c:v>-3.656521612820581E-3</c:v>
                </c:pt>
                <c:pt idx="16">
                  <c:v>-3.7131653749699779E-3</c:v>
                </c:pt>
                <c:pt idx="17">
                  <c:v>-3.767457105236848E-3</c:v>
                </c:pt>
                <c:pt idx="18">
                  <c:v>-3.8193728299214785E-3</c:v>
                </c:pt>
                <c:pt idx="19">
                  <c:v>-3.8688896245013364E-3</c:v>
                </c:pt>
                <c:pt idx="20">
                  <c:v>-3.91598562375389E-3</c:v>
                </c:pt>
                <c:pt idx="21">
                  <c:v>-3.9606400314116759E-3</c:v>
                </c:pt>
                <c:pt idx="22">
                  <c:v>-4.0028331293453451E-3</c:v>
                </c:pt>
                <c:pt idx="23">
                  <c:v>-4.0425462862706332E-3</c:v>
                </c:pt>
                <c:pt idx="24">
                  <c:v>-4.0797619659754154E-3</c:v>
                </c:pt>
                <c:pt idx="25">
                  <c:v>-4.1144637350631974E-3</c:v>
                </c:pt>
                <c:pt idx="26">
                  <c:v>-4.1466362702096433E-3</c:v>
                </c:pt>
                <c:pt idx="27">
                  <c:v>-4.1762653649289275E-3</c:v>
                </c:pt>
                <c:pt idx="28">
                  <c:v>-4.2033379358469153E-3</c:v>
                </c:pt>
                <c:pt idx="29">
                  <c:v>-4.2278420284784114E-3</c:v>
                </c:pt>
                <c:pt idx="30">
                  <c:v>-4.2497668225059309E-3</c:v>
                </c:pt>
                <c:pt idx="31">
                  <c:v>-4.2691026365576368E-3</c:v>
                </c:pt>
                <c:pt idx="32">
                  <c:v>-4.2858409324823717E-3</c:v>
                </c:pt>
                <c:pt idx="33">
                  <c:v>-4.2999743191198554E-3</c:v>
                </c:pt>
                <c:pt idx="34">
                  <c:v>-4.3114965555644197E-3</c:v>
                </c:pt>
                <c:pt idx="35">
                  <c:v>-4.3204025539208164E-3</c:v>
                </c:pt>
                <c:pt idx="36">
                  <c:v>-4.326688381550885E-3</c:v>
                </c:pt>
                <c:pt idx="37">
                  <c:v>-4.330351262810098E-3</c:v>
                </c:pt>
                <c:pt idx="38">
                  <c:v>-4.3313895802732033E-3</c:v>
                </c:pt>
                <c:pt idx="39">
                  <c:v>-4.3298028754484418E-3</c:v>
                </c:pt>
                <c:pt idx="40">
                  <c:v>-4.325591848979995E-3</c:v>
                </c:pt>
                <c:pt idx="41">
                  <c:v>-4.3187583603386051E-3</c:v>
                </c:pt>
                <c:pt idx="42">
                  <c:v>-4.3093054270004882E-3</c:v>
                </c:pt>
                <c:pt idx="43">
                  <c:v>-4.2972372231148935E-3</c:v>
                </c:pt>
                <c:pt idx="44">
                  <c:v>-4.2825590776609246E-3</c:v>
                </c:pt>
                <c:pt idx="45">
                  <c:v>-4.2652774720944048E-3</c:v>
                </c:pt>
                <c:pt idx="46">
                  <c:v>-4.245400037485858E-3</c:v>
                </c:pt>
                <c:pt idx="47">
                  <c:v>-4.2229355511508339E-3</c:v>
                </c:pt>
                <c:pt idx="48">
                  <c:v>-4.1978939327740961E-3</c:v>
                </c:pt>
                <c:pt idx="49">
                  <c:v>-4.1702862400293701E-3</c:v>
                </c:pt>
                <c:pt idx="50">
                  <c:v>-4.140124663696584E-3</c:v>
                </c:pt>
                <c:pt idx="51">
                  <c:v>-4.1074225222787614E-3</c:v>
                </c:pt>
                <c:pt idx="52">
                  <c:v>-4.072194256120952E-3</c:v>
                </c:pt>
                <c:pt idx="53">
                  <c:v>-4.034455421033774E-3</c:v>
                </c:pt>
                <c:pt idx="54">
                  <c:v>-3.9942226814244112E-3</c:v>
                </c:pt>
                <c:pt idx="55">
                  <c:v>-3.9515138029380757E-3</c:v>
                </c:pt>
                <c:pt idx="56">
                  <c:v>-3.9063476446132041E-3</c:v>
                </c:pt>
                <c:pt idx="57">
                  <c:v>-3.8587441505538314E-3</c:v>
                </c:pt>
                <c:pt idx="58">
                  <c:v>-3.8087243411228434E-3</c:v>
                </c:pt>
                <c:pt idx="59">
                  <c:v>-3.7563103036599692E-3</c:v>
                </c:pt>
                <c:pt idx="60">
                  <c:v>-3.7015251827286371E-3</c:v>
                </c:pt>
                <c:pt idx="61">
                  <c:v>-3.6443931698959871E-3</c:v>
                </c:pt>
                <c:pt idx="62">
                  <c:v>-3.5849394930505514E-3</c:v>
                </c:pt>
                <c:pt idx="63">
                  <c:v>-3.5231904052623383E-3</c:v>
                </c:pt>
                <c:pt idx="64">
                  <c:v>-3.4591731731902064E-3</c:v>
                </c:pt>
                <c:pt idx="65">
                  <c:v>-3.3929160650416805E-3</c:v>
                </c:pt>
                <c:pt idx="66">
                  <c:v>-3.3244483380905042E-3</c:v>
                </c:pt>
                <c:pt idx="67">
                  <c:v>-3.253800225757456E-3</c:v>
                </c:pt>
                <c:pt idx="68">
                  <c:v>-3.1810029242601151E-3</c:v>
                </c:pt>
                <c:pt idx="69">
                  <c:v>-3.1060885788374952E-3</c:v>
                </c:pt>
                <c:pt idx="70">
                  <c:v>-3.0290902695556091E-3</c:v>
                </c:pt>
                <c:pt idx="71">
                  <c:v>-2.9500419967002462E-3</c:v>
                </c:pt>
                <c:pt idx="72">
                  <c:v>-2.8689786657634005E-3</c:v>
                </c:pt>
                <c:pt idx="73">
                  <c:v>-2.7859360720299854E-3</c:v>
                </c:pt>
                <c:pt idx="74">
                  <c:v>-2.7009508847716515E-3</c:v>
                </c:pt>
                <c:pt idx="75">
                  <c:v>-2.6140606310546609E-3</c:v>
                </c:pt>
                <c:pt idx="76">
                  <c:v>-2.5253036791689928E-3</c:v>
                </c:pt>
                <c:pt idx="77">
                  <c:v>-2.43471922168599E-3</c:v>
                </c:pt>
                <c:pt idx="78">
                  <c:v>-2.342347258152023E-3</c:v>
                </c:pt>
                <c:pt idx="79">
                  <c:v>-2.2482285774258087E-3</c:v>
                </c:pt>
                <c:pt idx="80">
                  <c:v>-2.1524047396672091E-3</c:v>
                </c:pt>
                <c:pt idx="81">
                  <c:v>-2.0549180579854248E-3</c:v>
                </c:pt>
                <c:pt idx="82">
                  <c:v>-1.9558115797547269E-3</c:v>
                </c:pt>
                <c:pt idx="83">
                  <c:v>-1.8551290676059391E-3</c:v>
                </c:pt>
                <c:pt idx="84">
                  <c:v>-1.7529149801020982E-3</c:v>
                </c:pt>
                <c:pt idx="85">
                  <c:v>-1.6492144521068021E-3</c:v>
                </c:pt>
                <c:pt idx="86">
                  <c:v>-1.5440732748539247E-3</c:v>
                </c:pt>
                <c:pt idx="87">
                  <c:v>-1.4375378757274955E-3</c:v>
                </c:pt>
                <c:pt idx="88">
                  <c:v>-1.3296552977606745E-3</c:v>
                </c:pt>
                <c:pt idx="89">
                  <c:v>-1.220473178862876E-3</c:v>
                </c:pt>
                <c:pt idx="90">
                  <c:v>-1.1100397307841998E-3</c:v>
                </c:pt>
                <c:pt idx="91">
                  <c:v>-9.9840371782648979E-4</c:v>
                </c:pt>
                <c:pt idx="92">
                  <c:v>-8.8561443531038697E-4</c:v>
                </c:pt>
                <c:pt idx="93">
                  <c:v>-7.7172168780790173E-4</c:v>
                </c:pt>
                <c:pt idx="94">
                  <c:v>-6.5677576715011932E-4</c:v>
                </c:pt>
                <c:pt idx="95">
                  <c:v>-5.4082743021974375E-4</c:v>
                </c:pt>
                <c:pt idx="96">
                  <c:v>-4.2392787653828504E-4</c:v>
                </c:pt>
                <c:pt idx="97">
                  <c:v>-3.0612872565778898E-4</c:v>
                </c:pt>
                <c:pt idx="98">
                  <c:v>-1.8748199436710578E-4</c:v>
                </c:pt>
                <c:pt idx="99">
                  <c:v>-6.8040073722730292E-5</c:v>
                </c:pt>
                <c:pt idx="100">
                  <c:v>5.2144294085607924E-5</c:v>
                </c:pt>
                <c:pt idx="101">
                  <c:v>1.7301803902441222E-4</c:v>
                </c:pt>
                <c:pt idx="102">
                  <c:v>2.9452778665065363E-4</c:v>
                </c:pt>
                <c:pt idx="103">
                  <c:v>4.1661988168041836E-4</c:v>
                </c:pt>
                <c:pt idx="104">
                  <c:v>5.3924041168157411E-4</c:v>
                </c:pt>
                <c:pt idx="105">
                  <c:v>6.6233523087998181E-4</c:v>
                </c:pt>
                <c:pt idx="106">
                  <c:v>7.8584998406874265E-4</c:v>
                </c:pt>
                <c:pt idx="107">
                  <c:v>9.0973013060992964E-4</c:v>
                </c:pt>
                <c:pt idx="108">
                  <c:v>1.0339209685182038E-3</c:v>
                </c:pt>
                <c:pt idx="109">
                  <c:v>1.1583676586156555E-3</c:v>
                </c:pt>
                <c:pt idx="110">
                  <c:v>1.2830152487472569E-3</c:v>
                </c:pt>
                <c:pt idx="111">
                  <c:v>1.4078086980461773E-3</c:v>
                </c:pt>
                <c:pt idx="112">
                  <c:v>1.5326929012382858E-3</c:v>
                </c:pt>
                <c:pt idx="113">
                  <c:v>1.6576127129750871E-3</c:v>
                </c:pt>
                <c:pt idx="114">
                  <c:v>1.7825129721843534E-3</c:v>
                </c:pt>
                <c:pt idx="115">
                  <c:v>1.9073385264277046E-3</c:v>
                </c:pt>
                <c:pt idx="116">
                  <c:v>2.0320342562543696E-3</c:v>
                </c:pt>
                <c:pt idx="117">
                  <c:v>2.1565450995403843E-3</c:v>
                </c:pt>
                <c:pt idx="118">
                  <c:v>2.2808160758024782E-3</c:v>
                </c:pt>
                <c:pt idx="119">
                  <c:v>2.4047923104759026E-3</c:v>
                </c:pt>
                <c:pt idx="120">
                  <c:v>2.5284190591455011E-3</c:v>
                </c:pt>
                <c:pt idx="121">
                  <c:v>2.6516417317192925E-3</c:v>
                </c:pt>
                <c:pt idx="122">
                  <c:v>2.7744059165339344E-3</c:v>
                </c:pt>
                <c:pt idx="123">
                  <c:v>2.8966574043813617E-3</c:v>
                </c:pt>
                <c:pt idx="124">
                  <c:v>3.0183422124460614E-3</c:v>
                </c:pt>
                <c:pt idx="125">
                  <c:v>3.1394066081423598E-3</c:v>
                </c:pt>
                <c:pt idx="126">
                  <c:v>3.2597971328412177E-3</c:v>
                </c:pt>
                <c:pt idx="127">
                  <c:v>3.3794606254760611E-3</c:v>
                </c:pt>
                <c:pt idx="128">
                  <c:v>3.4983442460172062E-3</c:v>
                </c:pt>
                <c:pt idx="129">
                  <c:v>3.6163954988045338E-3</c:v>
                </c:pt>
                <c:pt idx="130">
                  <c:v>3.7335622557280908E-3</c:v>
                </c:pt>
                <c:pt idx="131">
                  <c:v>3.8497927792463986E-3</c:v>
                </c:pt>
                <c:pt idx="132">
                  <c:v>3.9650357452322947E-3</c:v>
                </c:pt>
                <c:pt idx="133">
                  <c:v>4.079240265636221E-3</c:v>
                </c:pt>
                <c:pt idx="134">
                  <c:v>4.1923559109569557E-3</c:v>
                </c:pt>
                <c:pt idx="135">
                  <c:v>4.3043327325098602E-3</c:v>
                </c:pt>
                <c:pt idx="136">
                  <c:v>4.4151212844828107E-3</c:v>
                </c:pt>
                <c:pt idx="137">
                  <c:v>4.524672645770088E-3</c:v>
                </c:pt>
                <c:pt idx="138">
                  <c:v>4.6329384415745379E-3</c:v>
                </c:pt>
                <c:pt idx="139">
                  <c:v>4.7398708647685426E-3</c:v>
                </c:pt>
                <c:pt idx="140">
                  <c:v>4.8454226970042896E-3</c:v>
                </c:pt>
                <c:pt idx="141">
                  <c:v>4.9495473295640682E-3</c:v>
                </c:pt>
                <c:pt idx="142">
                  <c:v>5.0521987839413692E-3</c:v>
                </c:pt>
                <c:pt idx="143">
                  <c:v>5.1533317321436952E-3</c:v>
                </c:pt>
                <c:pt idx="144">
                  <c:v>5.2529015167081285E-3</c:v>
                </c:pt>
                <c:pt idx="145">
                  <c:v>5.3508641704208097E-3</c:v>
                </c:pt>
                <c:pt idx="146">
                  <c:v>5.4471764357316215E-3</c:v>
                </c:pt>
                <c:pt idx="147">
                  <c:v>5.5417957838555026E-3</c:v>
                </c:pt>
                <c:pt idx="148">
                  <c:v>5.6346804335519647E-3</c:v>
                </c:pt>
                <c:pt idx="149">
                  <c:v>5.7257893695745118E-3</c:v>
                </c:pt>
                <c:pt idx="150">
                  <c:v>5.8150823607818142E-3</c:v>
                </c:pt>
                <c:pt idx="151">
                  <c:v>5.9025199779026618E-3</c:v>
                </c:pt>
                <c:pt idx="152">
                  <c:v>5.9880636109467984E-3</c:v>
                </c:pt>
                <c:pt idx="153">
                  <c:v>6.0716754862540261E-3</c:v>
                </c:pt>
                <c:pt idx="154">
                  <c:v>6.153318683173978E-3</c:v>
                </c:pt>
                <c:pt idx="155">
                  <c:v>6.2329571503692439E-3</c:v>
                </c:pt>
                <c:pt idx="156">
                  <c:v>6.3105557217346259E-3</c:v>
                </c:pt>
                <c:pt idx="157">
                  <c:v>6.3860801319254954E-3</c:v>
                </c:pt>
                <c:pt idx="158">
                  <c:v>6.4594970314884158E-3</c:v>
                </c:pt>
                <c:pt idx="159">
                  <c:v>6.5307740015873045E-3</c:v>
                </c:pt>
                <c:pt idx="160">
                  <c:v>6.5998795683186989E-3</c:v>
                </c:pt>
                <c:pt idx="161">
                  <c:v>6.6667832166097292E-3</c:v>
                </c:pt>
                <c:pt idx="162">
                  <c:v>6.7314554036927259E-3</c:v>
                </c:pt>
                <c:pt idx="163">
                  <c:v>6.7938675721504688E-3</c:v>
                </c:pt>
                <c:pt idx="164">
                  <c:v>6.8539921625263393E-3</c:v>
                </c:pt>
                <c:pt idx="165">
                  <c:v>6.9118026254938068E-3</c:v>
                </c:pt>
                <c:pt idx="166">
                  <c:v>6.9672734335798556E-3</c:v>
                </c:pt>
                <c:pt idx="167">
                  <c:v>7.0203800924372017E-3</c:v>
                </c:pt>
                <c:pt idx="168">
                  <c:v>7.0710991516603049E-3</c:v>
                </c:pt>
                <c:pt idx="169">
                  <c:v>7.1194082151404148E-3</c:v>
                </c:pt>
                <c:pt idx="170">
                  <c:v>7.165285950955053E-3</c:v>
                </c:pt>
                <c:pt idx="171">
                  <c:v>7.2087121007875943E-3</c:v>
                </c:pt>
                <c:pt idx="172">
                  <c:v>7.24966748887277E-3</c:v>
                </c:pt>
                <c:pt idx="173">
                  <c:v>7.2881340304641416E-3</c:v>
                </c:pt>
                <c:pt idx="174">
                  <c:v>7.3240947398198197E-3</c:v>
                </c:pt>
                <c:pt idx="175">
                  <c:v>7.3575337377028895E-3</c:v>
                </c:pt>
                <c:pt idx="176">
                  <c:v>7.3884362583932304E-3</c:v>
                </c:pt>
                <c:pt idx="177">
                  <c:v>7.4167886562076487E-3</c:v>
                </c:pt>
                <c:pt idx="178">
                  <c:v>7.4425784115254197E-3</c:v>
                </c:pt>
                <c:pt idx="179">
                  <c:v>7.4657941363166086E-3</c:v>
                </c:pt>
                <c:pt idx="180">
                  <c:v>7.4864255791706972E-3</c:v>
                </c:pt>
                <c:pt idx="181">
                  <c:v>7.5044636298233179E-3</c:v>
                </c:pt>
                <c:pt idx="182">
                  <c:v>7.5199003231790958E-3</c:v>
                </c:pt>
                <c:pt idx="183">
                  <c:v>7.5327288428288057E-3</c:v>
                </c:pt>
                <c:pt idx="184">
                  <c:v>7.542943524059308E-3</c:v>
                </c:pt>
                <c:pt idx="185">
                  <c:v>7.5505398563549229E-3</c:v>
                </c:pt>
                <c:pt idx="186">
                  <c:v>7.5555144853891587E-3</c:v>
                </c:pt>
                <c:pt idx="187">
                  <c:v>7.5578652145058735E-3</c:v>
                </c:pt>
                <c:pt idx="188">
                  <c:v>7.5575910056892666E-3</c:v>
                </c:pt>
                <c:pt idx="189">
                  <c:v>7.5546919800222288E-3</c:v>
                </c:pt>
                <c:pt idx="190">
                  <c:v>7.549169417632888E-3</c:v>
                </c:pt>
                <c:pt idx="191">
                  <c:v>7.5410257571293243E-3</c:v>
                </c:pt>
                <c:pt idx="192">
                  <c:v>7.5302645945227661E-3</c:v>
                </c:pt>
                <c:pt idx="193">
                  <c:v>7.5168906816396796E-3</c:v>
                </c:pt>
                <c:pt idx="194">
                  <c:v>7.5009099240235045E-3</c:v>
                </c:pt>
                <c:pt idx="195">
                  <c:v>7.4823293783269256E-3</c:v>
                </c:pt>
                <c:pt idx="196">
                  <c:v>7.4611572491958596E-3</c:v>
                </c:pt>
                <c:pt idx="197">
                  <c:v>7.4374028856465119E-3</c:v>
                </c:pt>
                <c:pt idx="198">
                  <c:v>7.4110767769371127E-3</c:v>
                </c:pt>
                <c:pt idx="199">
                  <c:v>7.3821905479361568E-3</c:v>
                </c:pt>
                <c:pt idx="200">
                  <c:v>7.3507569539891914E-3</c:v>
                </c:pt>
                <c:pt idx="201">
                  <c:v>7.3167898752864108E-3</c:v>
                </c:pt>
                <c:pt idx="202">
                  <c:v>7.28030431073356E-3</c:v>
                </c:pt>
                <c:pt idx="203">
                  <c:v>7.2413163713288334E-3</c:v>
                </c:pt>
                <c:pt idx="204">
                  <c:v>7.1998432730487174E-3</c:v>
                </c:pt>
                <c:pt idx="205">
                  <c:v>7.1559033292458961E-3</c:v>
                </c:pt>
                <c:pt idx="206">
                  <c:v>7.1095159425625934E-3</c:v>
                </c:pt>
                <c:pt idx="207">
                  <c:v>7.0607015963629113E-3</c:v>
                </c:pt>
                <c:pt idx="208">
                  <c:v>7.0094818456879517E-3</c:v>
                </c:pt>
                <c:pt idx="209">
                  <c:v>6.9558793077377154E-3</c:v>
                </c:pt>
                <c:pt idx="210">
                  <c:v>6.8999176518839906E-3</c:v>
                </c:pt>
                <c:pt idx="211">
                  <c:v>6.8416215892186166E-3</c:v>
                </c:pt>
                <c:pt idx="212">
                  <c:v>6.7810168616417657E-3</c:v>
                </c:pt>
                <c:pt idx="213">
                  <c:v>6.7181302304950424E-3</c:v>
                </c:pt>
                <c:pt idx="214">
                  <c:v>6.6529894647444346E-3</c:v>
                </c:pt>
                <c:pt idx="215">
                  <c:v>6.5856233287183022E-3</c:v>
                </c:pt>
                <c:pt idx="216">
                  <c:v>6.5160615694058836E-3</c:v>
                </c:pt>
                <c:pt idx="217">
                  <c:v>6.4443349033218508E-3</c:v>
                </c:pt>
                <c:pt idx="218">
                  <c:v>6.3704750029427541E-3</c:v>
                </c:pt>
                <c:pt idx="219">
                  <c:v>6.2945144827213631E-3</c:v>
                </c:pt>
                <c:pt idx="220">
                  <c:v>6.2164868846850303E-3</c:v>
                </c:pt>
                <c:pt idx="221">
                  <c:v>6.1364266636244813E-3</c:v>
                </c:pt>
                <c:pt idx="222">
                  <c:v>6.0543691718795509E-3</c:v>
                </c:pt>
                <c:pt idx="223">
                  <c:v>5.9703506437285793E-3</c:v>
                </c:pt>
                <c:pt idx="224">
                  <c:v>5.8844081793883807E-3</c:v>
                </c:pt>
                <c:pt idx="225">
                  <c:v>5.7965797286318298E-3</c:v>
                </c:pt>
                <c:pt idx="226">
                  <c:v>5.7069040740303067E-3</c:v>
                </c:pt>
                <c:pt idx="227">
                  <c:v>5.6154208138284112E-3</c:v>
                </c:pt>
                <c:pt idx="228">
                  <c:v>5.5221703444584911E-3</c:v>
                </c:pt>
                <c:pt idx="229">
                  <c:v>5.42719384270271E-3</c:v>
                </c:pt>
                <c:pt idx="230">
                  <c:v>5.3305332475105487E-3</c:v>
                </c:pt>
                <c:pt idx="231">
                  <c:v>5.2322312414797342E-3</c:v>
                </c:pt>
                <c:pt idx="232">
                  <c:v>5.1323312320088162E-3</c:v>
                </c:pt>
                <c:pt idx="233">
                  <c:v>5.0308773321296784E-3</c:v>
                </c:pt>
                <c:pt idx="234">
                  <c:v>4.9279143410284609E-3</c:v>
                </c:pt>
                <c:pt idx="235">
                  <c:v>4.8234877242635098E-3</c:v>
                </c:pt>
                <c:pt idx="236">
                  <c:v>4.7176435936890585E-3</c:v>
                </c:pt>
                <c:pt idx="237">
                  <c:v>4.6104286870935355E-3</c:v>
                </c:pt>
                <c:pt idx="238">
                  <c:v>4.5018903475614689E-3</c:v>
                </c:pt>
                <c:pt idx="239">
                  <c:v>4.392076502568119E-3</c:v>
                </c:pt>
                <c:pt idx="240">
                  <c:v>4.2810356428160477E-3</c:v>
                </c:pt>
                <c:pt idx="241">
                  <c:v>4.1688168008229935E-3</c:v>
                </c:pt>
                <c:pt idx="242">
                  <c:v>4.0554695292704963E-3</c:v>
                </c:pt>
                <c:pt idx="243">
                  <c:v>3.9410438791228092E-3</c:v>
                </c:pt>
                <c:pt idx="244">
                  <c:v>3.8255903775258272E-3</c:v>
                </c:pt>
                <c:pt idx="245">
                  <c:v>3.7091600054957085E-3</c:v>
                </c:pt>
                <c:pt idx="246">
                  <c:v>3.5918041754070913E-3</c:v>
                </c:pt>
                <c:pt idx="247">
                  <c:v>3.473574708290841E-3</c:v>
                </c:pt>
                <c:pt idx="248">
                  <c:v>3.3545238109513428E-3</c:v>
                </c:pt>
                <c:pt idx="249">
                  <c:v>3.2347040529134403E-3</c:v>
                </c:pt>
                <c:pt idx="250">
                  <c:v>3.1141683432092202E-3</c:v>
                </c:pt>
                <c:pt idx="251">
                  <c:v>2.9929699070148689E-3</c:v>
                </c:pt>
                <c:pt idx="252">
                  <c:v>2.8711622621479353E-3</c:v>
                </c:pt>
                <c:pt idx="253">
                  <c:v>2.7487991954353659E-3</c:v>
                </c:pt>
                <c:pt idx="254">
                  <c:v>2.6259347389627607E-3</c:v>
                </c:pt>
                <c:pt idx="255">
                  <c:v>2.5026231462153227E-3</c:v>
                </c:pt>
                <c:pt idx="256">
                  <c:v>2.3789188681210454E-3</c:v>
                </c:pt>
                <c:pt idx="257">
                  <c:v>2.2548765290067202E-3</c:v>
                </c:pt>
                <c:pt idx="258">
                  <c:v>2.130550902477363E-3</c:v>
                </c:pt>
                <c:pt idx="259">
                  <c:v>2.0059968872297397E-3</c:v>
                </c:pt>
                <c:pt idx="260">
                  <c:v>1.8812694828106466E-3</c:v>
                </c:pt>
                <c:pt idx="261">
                  <c:v>1.7564237653306548E-3</c:v>
                </c:pt>
                <c:pt idx="262">
                  <c:v>1.6315148631440529E-3</c:v>
                </c:pt>
                <c:pt idx="263">
                  <c:v>1.5065979325057178E-3</c:v>
                </c:pt>
                <c:pt idx="264">
                  <c:v>1.3817281332156629E-3</c:v>
                </c:pt>
                <c:pt idx="265">
                  <c:v>1.2569606042620281E-3</c:v>
                </c:pt>
                <c:pt idx="266">
                  <c:v>1.1323504394732497E-3</c:v>
                </c:pt>
                <c:pt idx="267">
                  <c:v>1.0079526631901776E-3</c:v>
                </c:pt>
                <c:pt idx="268">
                  <c:v>8.8382220596888196E-4</c:v>
                </c:pt>
                <c:pt idx="269">
                  <c:v>7.6001388032485157E-4</c:v>
                </c:pt>
                <c:pt idx="270">
                  <c:v>6.3658235652934827E-4</c:v>
                </c:pt>
                <c:pt idx="271">
                  <c:v>5.135821384685429E-4</c:v>
                </c:pt>
                <c:pt idx="272">
                  <c:v>3.9106753957612568E-4</c:v>
                </c:pt>
                <c:pt idx="273">
                  <c:v>2.6909265885004512E-4</c:v>
                </c:pt>
                <c:pt idx="274">
                  <c:v>1.477113569638964E-4</c:v>
                </c:pt>
                <c:pt idx="275">
                  <c:v>2.6977232483570233E-5</c:v>
                </c:pt>
                <c:pt idx="276">
                  <c:v>-9.3056401800367932E-5</c:v>
                </c:pt>
                <c:pt idx="277">
                  <c:v>-2.1233654241410195E-4</c:v>
                </c:pt>
                <c:pt idx="278">
                  <c:v>-3.3081051860541161E-4</c:v>
                </c:pt>
                <c:pt idx="279">
                  <c:v>-4.484260156015882E-4</c:v>
                </c:pt>
                <c:pt idx="280">
                  <c:v>-5.6513109771016978E-4</c:v>
                </c:pt>
                <c:pt idx="281">
                  <c:v>-6.8087423125227876E-4</c:v>
                </c:pt>
                <c:pt idx="282">
                  <c:v>-7.9560430731844684E-4</c:v>
                </c:pt>
                <c:pt idx="283">
                  <c:v>-9.0927066433686525E-4</c:v>
                </c:pt>
                <c:pt idx="284">
                  <c:v>-1.0218231104441125E-3</c:v>
                </c:pt>
                <c:pt idx="285">
                  <c:v>-1.13321194564847E-3</c:v>
                </c:pt>
                <c:pt idx="286">
                  <c:v>-1.2433879837760349E-3</c:v>
                </c:pt>
                <c:pt idx="287">
                  <c:v>-1.3523025741899522E-3</c:v>
                </c:pt>
                <c:pt idx="288">
                  <c:v>-1.4599076232731647E-3</c:v>
                </c:pt>
                <c:pt idx="289">
                  <c:v>-1.5661556156652038E-3</c:v>
                </c:pt>
                <c:pt idx="290">
                  <c:v>-1.6709996352436327E-3</c:v>
                </c:pt>
                <c:pt idx="291">
                  <c:v>-1.7743933858408844E-3</c:v>
                </c:pt>
                <c:pt idx="292">
                  <c:v>-1.8762912116873491E-3</c:v>
                </c:pt>
                <c:pt idx="293">
                  <c:v>-1.976648117571673E-3</c:v>
                </c:pt>
                <c:pt idx="294">
                  <c:v>-2.0754197887093801E-3</c:v>
                </c:pt>
                <c:pt idx="295">
                  <c:v>-2.1725626103110312E-3</c:v>
                </c:pt>
                <c:pt idx="296">
                  <c:v>-2.2680336868412905E-3</c:v>
                </c:pt>
                <c:pt idx="297">
                  <c:v>-2.3617908609603814E-3</c:v>
                </c:pt>
                <c:pt idx="298">
                  <c:v>-2.4537927321395866E-3</c:v>
                </c:pt>
                <c:pt idx="299">
                  <c:v>-2.5439986749425467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383664"/>
        <c:axId val="283943200"/>
      </c:scatterChart>
      <c:valAx>
        <c:axId val="283383664"/>
        <c:scaling>
          <c:orientation val="minMax"/>
          <c:max val="3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943200"/>
        <c:crosses val="autoZero"/>
        <c:crossBetween val="midCat"/>
      </c:valAx>
      <c:valAx>
        <c:axId val="283943200"/>
        <c:scaling>
          <c:orientation val="minMax"/>
          <c:max val="0.01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383664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037704421562688"/>
          <c:y val="0.10679611650485436"/>
          <c:w val="0.64366141732283466"/>
          <c:h val="0.7039966363427872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003CE6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003CE6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CV$1:$CV$15</c:f>
              <c:numCache>
                <c:formatCode>General</c:formatCode>
                <c:ptCount val="15"/>
                <c:pt idx="0">
                  <c:v>1248.77</c:v>
                </c:pt>
                <c:pt idx="1">
                  <c:v>2456.31</c:v>
                </c:pt>
                <c:pt idx="2">
                  <c:v>1500</c:v>
                </c:pt>
                <c:pt idx="3">
                  <c:v>2422.6</c:v>
                </c:pt>
                <c:pt idx="4">
                  <c:v>2067.77</c:v>
                </c:pt>
                <c:pt idx="5">
                  <c:v>1348.43</c:v>
                </c:pt>
                <c:pt idx="6">
                  <c:v>1409.69</c:v>
                </c:pt>
                <c:pt idx="7">
                  <c:v>2011.43</c:v>
                </c:pt>
                <c:pt idx="8">
                  <c:v>1302.08</c:v>
                </c:pt>
                <c:pt idx="9">
                  <c:v>1328.58</c:v>
                </c:pt>
                <c:pt idx="10">
                  <c:v>1299.6099999999999</c:v>
                </c:pt>
                <c:pt idx="11">
                  <c:v>1766.94</c:v>
                </c:pt>
                <c:pt idx="12">
                  <c:v>1844.76</c:v>
                </c:pt>
                <c:pt idx="13">
                  <c:v>1863.16</c:v>
                </c:pt>
                <c:pt idx="14">
                  <c:v>2044.99</c:v>
                </c:pt>
              </c:numCache>
            </c:numRef>
          </c:xVal>
          <c:yVal>
            <c:numRef>
              <c:f>'Covariance   Correlation3_HID4'!$CW$1:$CW$15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3999999999999998E-3</c:v>
                </c:pt>
                <c:pt idx="6">
                  <c:v>2.3E-3</c:v>
                </c:pt>
                <c:pt idx="7">
                  <c:v>2.8E-3</c:v>
                </c:pt>
                <c:pt idx="8">
                  <c:v>6.0000000000000001E-3</c:v>
                </c:pt>
                <c:pt idx="9">
                  <c:v>4.3E-3</c:v>
                </c:pt>
                <c:pt idx="10">
                  <c:v>3.5999999999999999E-3</c:v>
                </c:pt>
                <c:pt idx="11">
                  <c:v>0</c:v>
                </c:pt>
                <c:pt idx="12">
                  <c:v>1.8E-3</c:v>
                </c:pt>
                <c:pt idx="13">
                  <c:v>0</c:v>
                </c:pt>
                <c:pt idx="14">
                  <c:v>0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62</c:f>
              <c:numCache>
                <c:formatCode>General</c:formatCode>
                <c:ptCount val="300"/>
                <c:pt idx="0">
                  <c:v>502.20097903698002</c:v>
                </c:pt>
                <c:pt idx="1">
                  <c:v>502.47154637796257</c:v>
                </c:pt>
                <c:pt idx="2">
                  <c:v>503.28312892598888</c:v>
                </c:pt>
                <c:pt idx="3">
                  <c:v>504.63536830905309</c:v>
                </c:pt>
                <c:pt idx="4">
                  <c:v>506.52766741631035</c:v>
                </c:pt>
                <c:pt idx="5">
                  <c:v>508.95919066174542</c:v>
                </c:pt>
                <c:pt idx="6">
                  <c:v>511.92886435314335</c:v>
                </c:pt>
                <c:pt idx="7">
                  <c:v>515.43537716620153</c:v>
                </c:pt>
                <c:pt idx="8">
                  <c:v>519.47718072357452</c:v>
                </c:pt>
                <c:pt idx="9">
                  <c:v>524.05249027859236</c:v>
                </c:pt>
                <c:pt idx="10">
                  <c:v>529.15928550335593</c:v>
                </c:pt>
                <c:pt idx="11">
                  <c:v>534.79531138085622</c:v>
                </c:pt>
                <c:pt idx="12">
                  <c:v>540.95807920072616</c:v>
                </c:pt>
                <c:pt idx="13">
                  <c:v>547.64486765818583</c:v>
                </c:pt>
                <c:pt idx="14">
                  <c:v>554.85272405569276</c:v>
                </c:pt>
                <c:pt idx="15">
                  <c:v>562.57846560677126</c:v>
                </c:pt>
                <c:pt idx="16">
                  <c:v>570.81868084144139</c:v>
                </c:pt>
                <c:pt idx="17">
                  <c:v>579.56973111262641</c:v>
                </c:pt>
                <c:pt idx="18">
                  <c:v>588.82775220287908</c:v>
                </c:pt>
                <c:pt idx="19">
                  <c:v>598.5886560307099</c:v>
                </c:pt>
                <c:pt idx="20">
                  <c:v>608.84813245576902</c:v>
                </c:pt>
                <c:pt idx="21">
                  <c:v>619.60165118208306</c:v>
                </c:pt>
                <c:pt idx="22">
                  <c:v>630.84446375850666</c:v>
                </c:pt>
                <c:pt idx="23">
                  <c:v>642.57160567550363</c:v>
                </c:pt>
                <c:pt idx="24">
                  <c:v>654.77789855733658</c:v>
                </c:pt>
                <c:pt idx="25">
                  <c:v>667.45795244868987</c:v>
                </c:pt>
                <c:pt idx="26">
                  <c:v>680.6061681947233</c:v>
                </c:pt>
                <c:pt idx="27">
                  <c:v>694.21673991350031</c:v>
                </c:pt>
                <c:pt idx="28">
                  <c:v>708.28365755970367</c:v>
                </c:pt>
                <c:pt idx="29">
                  <c:v>722.80070957850035</c:v>
                </c:pt>
                <c:pt idx="30">
                  <c:v>737.7614856483907</c:v>
                </c:pt>
                <c:pt idx="31">
                  <c:v>753.15937951182548</c:v>
                </c:pt>
                <c:pt idx="32">
                  <c:v>768.98759189234249</c:v>
                </c:pt>
                <c:pt idx="33">
                  <c:v>785.23913349693726</c:v>
                </c:pt>
                <c:pt idx="34">
                  <c:v>801.90682810233625</c:v>
                </c:pt>
                <c:pt idx="35">
                  <c:v>818.98331572381733</c:v>
                </c:pt>
                <c:pt idx="36">
                  <c:v>836.46105586516899</c:v>
                </c:pt>
                <c:pt idx="37">
                  <c:v>854.33233084836354</c:v>
                </c:pt>
                <c:pt idx="38">
                  <c:v>872.58924922146537</c:v>
                </c:pt>
                <c:pt idx="39">
                  <c:v>891.2237492432738</c:v>
                </c:pt>
                <c:pt idx="40">
                  <c:v>910.22760244316203</c:v>
                </c:pt>
                <c:pt idx="41">
                  <c:v>929.59241725453728</c:v>
                </c:pt>
                <c:pt idx="42">
                  <c:v>949.30964272032054</c:v>
                </c:pt>
                <c:pt idx="43">
                  <c:v>969.37057226880893</c:v>
                </c:pt>
                <c:pt idx="44">
                  <c:v>989.76634755825171</c:v>
                </c:pt>
                <c:pt idx="45">
                  <c:v>1010.4879623884457</c:v>
                </c:pt>
                <c:pt idx="46">
                  <c:v>1031.5262666776193</c:v>
                </c:pt>
                <c:pt idx="47">
                  <c:v>1052.8719705028507</c:v>
                </c:pt>
                <c:pt idx="48">
                  <c:v>1074.5156482022367</c:v>
                </c:pt>
                <c:pt idx="49">
                  <c:v>1096.4477425369996</c:v>
                </c:pt>
                <c:pt idx="50">
                  <c:v>1118.6585689116953</c:v>
                </c:pt>
                <c:pt idx="51">
                  <c:v>1141.1383196506565</c:v>
                </c:pt>
                <c:pt idx="52">
                  <c:v>1163.877068328788</c:v>
                </c:pt>
                <c:pt idx="53">
                  <c:v>1186.8647741547952</c:v>
                </c:pt>
                <c:pt idx="54">
                  <c:v>1210.0912864049151</c:v>
                </c:pt>
                <c:pt idx="55">
                  <c:v>1233.5463489051924</c:v>
                </c:pt>
                <c:pt idx="56">
                  <c:v>1257.2196045603134</c:v>
                </c:pt>
                <c:pt idx="57">
                  <c:v>1281.1005999270099</c:v>
                </c:pt>
                <c:pt idx="58">
                  <c:v>1305.1787898300056</c:v>
                </c:pt>
                <c:pt idx="59">
                  <c:v>1329.4435420184677</c:v>
                </c:pt>
                <c:pt idx="60">
                  <c:v>1353.8841418609111</c:v>
                </c:pt>
                <c:pt idx="61">
                  <c:v>1378.4897970764755</c:v>
                </c:pt>
                <c:pt idx="62">
                  <c:v>1403.2496425004961</c:v>
                </c:pt>
                <c:pt idx="63">
                  <c:v>1428.152744882251</c:v>
                </c:pt>
                <c:pt idx="64">
                  <c:v>1453.1881077127798</c:v>
                </c:pt>
                <c:pt idx="65">
                  <c:v>1478.3446760806305</c:v>
                </c:pt>
                <c:pt idx="66">
                  <c:v>1503.6113415533985</c:v>
                </c:pt>
                <c:pt idx="67">
                  <c:v>1528.9769470828962</c:v>
                </c:pt>
                <c:pt idx="68">
                  <c:v>1554.4302919317929</c:v>
                </c:pt>
                <c:pt idx="69">
                  <c:v>1579.9601366195445</c:v>
                </c:pt>
                <c:pt idx="70">
                  <c:v>1605.5552078854312</c:v>
                </c:pt>
                <c:pt idx="71">
                  <c:v>1631.2042036665127</c:v>
                </c:pt>
                <c:pt idx="72">
                  <c:v>1656.8957980883006</c:v>
                </c:pt>
                <c:pt idx="73">
                  <c:v>1682.6186464659461</c:v>
                </c:pt>
                <c:pt idx="74">
                  <c:v>1708.3613903137336</c:v>
                </c:pt>
                <c:pt idx="75">
                  <c:v>1734.1126623606674</c:v>
                </c:pt>
                <c:pt idx="76">
                  <c:v>1759.8610915699401</c:v>
                </c:pt>
                <c:pt idx="77">
                  <c:v>1785.5953081600603</c:v>
                </c:pt>
                <c:pt idx="78">
                  <c:v>1811.3039486254295</c:v>
                </c:pt>
                <c:pt idx="79">
                  <c:v>1836.9756607541462</c:v>
                </c:pt>
                <c:pt idx="80">
                  <c:v>1862.5991086408224</c:v>
                </c:pt>
                <c:pt idx="81">
                  <c:v>1888.1629776922009</c:v>
                </c:pt>
                <c:pt idx="82">
                  <c:v>1913.6559796233605</c:v>
                </c:pt>
                <c:pt idx="83">
                  <c:v>1939.0668574423064</c:v>
                </c:pt>
                <c:pt idx="84">
                  <c:v>1964.384390420739</c:v>
                </c:pt>
                <c:pt idx="85">
                  <c:v>1989.5973990488123</c:v>
                </c:pt>
                <c:pt idx="86">
                  <c:v>2014.6947499716916</c:v>
                </c:pt>
                <c:pt idx="87">
                  <c:v>2039.6653609057287</c:v>
                </c:pt>
                <c:pt idx="88">
                  <c:v>2064.4982055320861</c:v>
                </c:pt>
                <c:pt idx="89">
                  <c:v>2089.1823183656497</c:v>
                </c:pt>
                <c:pt idx="90">
                  <c:v>2113.7067995970797</c:v>
                </c:pt>
                <c:pt idx="91">
                  <c:v>2138.0608199058552</c:v>
                </c:pt>
                <c:pt idx="92">
                  <c:v>2162.2336252422024</c:v>
                </c:pt>
                <c:pt idx="93">
                  <c:v>2186.2145415757764</c:v>
                </c:pt>
                <c:pt idx="94">
                  <c:v>2209.992979609015</c:v>
                </c:pt>
                <c:pt idx="95">
                  <c:v>2233.5584394530729</c:v>
                </c:pt>
                <c:pt idx="96">
                  <c:v>2256.9005152642776</c:v>
                </c:pt>
                <c:pt idx="97">
                  <c:v>2280.0088998390574</c:v>
                </c:pt>
                <c:pt idx="98">
                  <c:v>2302.8733891653114</c:v>
                </c:pt>
                <c:pt idx="99">
                  <c:v>2325.4838869282153</c:v>
                </c:pt>
                <c:pt idx="100">
                  <c:v>2347.830408968468</c:v>
                </c:pt>
                <c:pt idx="101">
                  <c:v>2369.9030876910174</c:v>
                </c:pt>
                <c:pt idx="102">
                  <c:v>2391.6921764223098</c:v>
                </c:pt>
                <c:pt idx="103">
                  <c:v>2413.1880537141501</c:v>
                </c:pt>
                <c:pt idx="104">
                  <c:v>2434.3812275922601</c:v>
                </c:pt>
                <c:pt idx="105">
                  <c:v>2455.2623397476664</c:v>
                </c:pt>
                <c:pt idx="106">
                  <c:v>2475.8221696690698</c:v>
                </c:pt>
                <c:pt idx="107">
                  <c:v>2496.0516387143584</c:v>
                </c:pt>
                <c:pt idx="108">
                  <c:v>2515.9418141194856</c:v>
                </c:pt>
                <c:pt idx="109">
                  <c:v>2535.4839129429238</c:v>
                </c:pt>
                <c:pt idx="110">
                  <c:v>2554.6693059439649</c:v>
                </c:pt>
                <c:pt idx="111">
                  <c:v>2573.4895213931504</c:v>
                </c:pt>
                <c:pt idx="112">
                  <c:v>2591.9362488131492</c:v>
                </c:pt>
                <c:pt idx="113">
                  <c:v>2610.0013426484279</c:v>
                </c:pt>
                <c:pt idx="114">
                  <c:v>2627.6768258621032</c:v>
                </c:pt>
                <c:pt idx="115">
                  <c:v>2644.9548934583727</c:v>
                </c:pt>
                <c:pt idx="116">
                  <c:v>2661.8279159289832</c:v>
                </c:pt>
                <c:pt idx="117">
                  <c:v>2678.2884426222067</c:v>
                </c:pt>
                <c:pt idx="118">
                  <c:v>2694.3292050328387</c:v>
                </c:pt>
                <c:pt idx="119">
                  <c:v>2709.9431200117633</c:v>
                </c:pt>
                <c:pt idx="120">
                  <c:v>2725.123292893677</c:v>
                </c:pt>
                <c:pt idx="121">
                  <c:v>2739.8630205415734</c:v>
                </c:pt>
                <c:pt idx="122">
                  <c:v>2754.1557943066641</c:v>
                </c:pt>
                <c:pt idx="123">
                  <c:v>2767.9953029024118</c:v>
                </c:pt>
                <c:pt idx="124">
                  <c:v>2781.3754351914195</c:v>
                </c:pt>
                <c:pt idx="125">
                  <c:v>2794.2902828839342</c:v>
                </c:pt>
                <c:pt idx="126">
                  <c:v>2806.7341431467821</c:v>
                </c:pt>
                <c:pt idx="127">
                  <c:v>2818.7015211215803</c:v>
                </c:pt>
                <c:pt idx="128">
                  <c:v>2830.1871323511109</c:v>
                </c:pt>
                <c:pt idx="129">
                  <c:v>2841.1859051127881</c:v>
                </c:pt>
                <c:pt idx="130">
                  <c:v>2851.6929826581882</c:v>
                </c:pt>
                <c:pt idx="131">
                  <c:v>2861.7037253576536</c:v>
                </c:pt>
                <c:pt idx="132">
                  <c:v>2871.2137127490223</c:v>
                </c:pt>
                <c:pt idx="133">
                  <c:v>2880.2187454895784</c:v>
                </c:pt>
                <c:pt idx="134">
                  <c:v>2888.7148472103672</c:v>
                </c:pt>
                <c:pt idx="135">
                  <c:v>2896.6982662720425</c:v>
                </c:pt>
                <c:pt idx="136">
                  <c:v>2904.1654774214894</c:v>
                </c:pt>
                <c:pt idx="137">
                  <c:v>2911.113183348476</c:v>
                </c:pt>
                <c:pt idx="138">
                  <c:v>2917.5383161416494</c:v>
                </c:pt>
                <c:pt idx="139">
                  <c:v>2923.4380386432431</c:v>
                </c:pt>
                <c:pt idx="140">
                  <c:v>2928.8097457018857</c:v>
                </c:pt>
                <c:pt idx="141">
                  <c:v>2933.6510653229579</c:v>
                </c:pt>
                <c:pt idx="142">
                  <c:v>2937.9598597160057</c:v>
                </c:pt>
                <c:pt idx="143">
                  <c:v>2941.7342262387215</c:v>
                </c:pt>
                <c:pt idx="144">
                  <c:v>2944.9724982371017</c:v>
                </c:pt>
                <c:pt idx="145">
                  <c:v>2947.6732457813932</c:v>
                </c:pt>
                <c:pt idx="146">
                  <c:v>2949.8352762975092</c:v>
                </c:pt>
                <c:pt idx="147">
                  <c:v>2951.4576350936377</c:v>
                </c:pt>
                <c:pt idx="148">
                  <c:v>2952.5396057818057</c:v>
                </c:pt>
                <c:pt idx="149">
                  <c:v>2953.0807105942158</c:v>
                </c:pt>
                <c:pt idx="150">
                  <c:v>2953.0807105942158</c:v>
                </c:pt>
                <c:pt idx="151">
                  <c:v>2952.5396057818052</c:v>
                </c:pt>
                <c:pt idx="152">
                  <c:v>2951.4576350936368</c:v>
                </c:pt>
                <c:pt idx="153">
                  <c:v>2949.8352762975078</c:v>
                </c:pt>
                <c:pt idx="154">
                  <c:v>2947.6732457813914</c:v>
                </c:pt>
                <c:pt idx="155">
                  <c:v>2944.9724982370999</c:v>
                </c:pt>
                <c:pt idx="156">
                  <c:v>2941.7342262387192</c:v>
                </c:pt>
                <c:pt idx="157">
                  <c:v>2937.9598597160029</c:v>
                </c:pt>
                <c:pt idx="158">
                  <c:v>2933.6510653229552</c:v>
                </c:pt>
                <c:pt idx="159">
                  <c:v>2928.8097457018821</c:v>
                </c:pt>
                <c:pt idx="160">
                  <c:v>2923.4380386432395</c:v>
                </c:pt>
                <c:pt idx="161">
                  <c:v>2917.5383161416448</c:v>
                </c:pt>
                <c:pt idx="162">
                  <c:v>2911.113183348471</c:v>
                </c:pt>
                <c:pt idx="163">
                  <c:v>2904.1654774214849</c:v>
                </c:pt>
                <c:pt idx="164">
                  <c:v>2896.698266272037</c:v>
                </c:pt>
                <c:pt idx="165">
                  <c:v>2888.7148472103613</c:v>
                </c:pt>
                <c:pt idx="166">
                  <c:v>2880.2187454895725</c:v>
                </c:pt>
                <c:pt idx="167">
                  <c:v>2871.2137127490155</c:v>
                </c:pt>
                <c:pt idx="168">
                  <c:v>2861.7037253576464</c:v>
                </c:pt>
                <c:pt idx="169">
                  <c:v>2851.6929826581809</c:v>
                </c:pt>
                <c:pt idx="170">
                  <c:v>2841.1859051127803</c:v>
                </c:pt>
                <c:pt idx="171">
                  <c:v>2830.1871323511032</c:v>
                </c:pt>
                <c:pt idx="172">
                  <c:v>2818.7015211215721</c:v>
                </c:pt>
                <c:pt idx="173">
                  <c:v>2806.734143146773</c:v>
                </c:pt>
                <c:pt idx="174">
                  <c:v>2794.2902828839251</c:v>
                </c:pt>
                <c:pt idx="175">
                  <c:v>2781.3754351914104</c:v>
                </c:pt>
                <c:pt idx="176">
                  <c:v>2767.9953029024027</c:v>
                </c:pt>
                <c:pt idx="177">
                  <c:v>2754.1557943066546</c:v>
                </c:pt>
                <c:pt idx="178">
                  <c:v>2739.8630205415639</c:v>
                </c:pt>
                <c:pt idx="179">
                  <c:v>2725.1232928936665</c:v>
                </c:pt>
                <c:pt idx="180">
                  <c:v>2709.9431200117529</c:v>
                </c:pt>
                <c:pt idx="181">
                  <c:v>2694.3292050328273</c:v>
                </c:pt>
                <c:pt idx="182">
                  <c:v>2678.2884426221954</c:v>
                </c:pt>
                <c:pt idx="183">
                  <c:v>2661.8279159289714</c:v>
                </c:pt>
                <c:pt idx="184">
                  <c:v>2644.9548934583609</c:v>
                </c:pt>
                <c:pt idx="185">
                  <c:v>2627.6768258620909</c:v>
                </c:pt>
                <c:pt idx="186">
                  <c:v>2610.0013426484156</c:v>
                </c:pt>
                <c:pt idx="187">
                  <c:v>2591.9362488131364</c:v>
                </c:pt>
                <c:pt idx="188">
                  <c:v>2573.4895213931377</c:v>
                </c:pt>
                <c:pt idx="189">
                  <c:v>2554.6693059439517</c:v>
                </c:pt>
                <c:pt idx="190">
                  <c:v>2535.4839129429106</c:v>
                </c:pt>
                <c:pt idx="191">
                  <c:v>2515.9418141194724</c:v>
                </c:pt>
                <c:pt idx="192">
                  <c:v>2496.0516387143448</c:v>
                </c:pt>
                <c:pt idx="193">
                  <c:v>2475.8221696690553</c:v>
                </c:pt>
                <c:pt idx="194">
                  <c:v>2455.2623397476523</c:v>
                </c:pt>
                <c:pt idx="195">
                  <c:v>2434.3812275922451</c:v>
                </c:pt>
                <c:pt idx="196">
                  <c:v>2413.1880537141351</c:v>
                </c:pt>
                <c:pt idx="197">
                  <c:v>2391.6921764222948</c:v>
                </c:pt>
                <c:pt idx="198">
                  <c:v>2369.9030876910019</c:v>
                </c:pt>
                <c:pt idx="199">
                  <c:v>2347.8304089684525</c:v>
                </c:pt>
                <c:pt idx="200">
                  <c:v>2325.4838869281998</c:v>
                </c:pt>
                <c:pt idx="201">
                  <c:v>2302.8733891652955</c:v>
                </c:pt>
                <c:pt idx="202">
                  <c:v>2280.0088998390411</c:v>
                </c:pt>
                <c:pt idx="203">
                  <c:v>2256.9005152642612</c:v>
                </c:pt>
                <c:pt idx="204">
                  <c:v>2233.5584394530561</c:v>
                </c:pt>
                <c:pt idx="205">
                  <c:v>2209.9929796089982</c:v>
                </c:pt>
                <c:pt idx="206">
                  <c:v>2186.2145415757595</c:v>
                </c:pt>
                <c:pt idx="207">
                  <c:v>2162.2336252421851</c:v>
                </c:pt>
                <c:pt idx="208">
                  <c:v>2138.0608199058383</c:v>
                </c:pt>
                <c:pt idx="209">
                  <c:v>2113.7067995970624</c:v>
                </c:pt>
                <c:pt idx="210">
                  <c:v>2089.1823183656325</c:v>
                </c:pt>
                <c:pt idx="211">
                  <c:v>2064.4982055320684</c:v>
                </c:pt>
                <c:pt idx="212">
                  <c:v>2039.6653609057107</c:v>
                </c:pt>
                <c:pt idx="213">
                  <c:v>2014.6947499716737</c:v>
                </c:pt>
                <c:pt idx="214">
                  <c:v>1989.5973990487953</c:v>
                </c:pt>
                <c:pt idx="215">
                  <c:v>1964.384390420722</c:v>
                </c:pt>
                <c:pt idx="216">
                  <c:v>1939.0668574422893</c:v>
                </c:pt>
                <c:pt idx="217">
                  <c:v>1913.6559796233432</c:v>
                </c:pt>
                <c:pt idx="218">
                  <c:v>1888.1629776921832</c:v>
                </c:pt>
                <c:pt idx="219">
                  <c:v>1862.5991086408048</c:v>
                </c:pt>
                <c:pt idx="220">
                  <c:v>1836.9756607541285</c:v>
                </c:pt>
                <c:pt idx="221">
                  <c:v>1811.3039486254117</c:v>
                </c:pt>
                <c:pt idx="222">
                  <c:v>1785.5953081600426</c:v>
                </c:pt>
                <c:pt idx="223">
                  <c:v>1759.8610915699223</c:v>
                </c:pt>
                <c:pt idx="224">
                  <c:v>1734.1126623606499</c:v>
                </c:pt>
                <c:pt idx="225">
                  <c:v>1708.3613903137157</c:v>
                </c:pt>
                <c:pt idx="226">
                  <c:v>1682.6186464659281</c:v>
                </c:pt>
                <c:pt idx="227">
                  <c:v>1656.8957980882826</c:v>
                </c:pt>
                <c:pt idx="228">
                  <c:v>1631.2042036664948</c:v>
                </c:pt>
                <c:pt idx="229">
                  <c:v>1605.5552078854134</c:v>
                </c:pt>
                <c:pt idx="230">
                  <c:v>1579.9601366195268</c:v>
                </c:pt>
                <c:pt idx="231">
                  <c:v>1554.4302919317752</c:v>
                </c:pt>
                <c:pt idx="232">
                  <c:v>1528.9769470828783</c:v>
                </c:pt>
                <c:pt idx="233">
                  <c:v>1503.6113415533805</c:v>
                </c:pt>
                <c:pt idx="234">
                  <c:v>1478.3446760806128</c:v>
                </c:pt>
                <c:pt idx="235">
                  <c:v>1453.1881077127621</c:v>
                </c:pt>
                <c:pt idx="236">
                  <c:v>1428.1527448822333</c:v>
                </c:pt>
                <c:pt idx="237">
                  <c:v>1403.2496425004783</c:v>
                </c:pt>
                <c:pt idx="238">
                  <c:v>1378.489797076458</c:v>
                </c:pt>
                <c:pt idx="239">
                  <c:v>1353.8841418608936</c:v>
                </c:pt>
                <c:pt idx="240">
                  <c:v>1329.4435420184504</c:v>
                </c:pt>
                <c:pt idx="241">
                  <c:v>1305.1787898299881</c:v>
                </c:pt>
                <c:pt idx="242">
                  <c:v>1281.1005999269937</c:v>
                </c:pt>
                <c:pt idx="243">
                  <c:v>1257.2196045602973</c:v>
                </c:pt>
                <c:pt idx="244">
                  <c:v>1233.5463489051765</c:v>
                </c:pt>
                <c:pt idx="245">
                  <c:v>1210.0912864048994</c:v>
                </c:pt>
                <c:pt idx="246">
                  <c:v>1186.8647741547791</c:v>
                </c:pt>
                <c:pt idx="247">
                  <c:v>1163.8770683287721</c:v>
                </c:pt>
                <c:pt idx="248">
                  <c:v>1141.1383196506408</c:v>
                </c:pt>
                <c:pt idx="249">
                  <c:v>1118.6585689116796</c:v>
                </c:pt>
                <c:pt idx="250">
                  <c:v>1096.4477425369842</c:v>
                </c:pt>
                <c:pt idx="251">
                  <c:v>1074.5156482022214</c:v>
                </c:pt>
                <c:pt idx="252">
                  <c:v>1052.8719705028357</c:v>
                </c:pt>
                <c:pt idx="253">
                  <c:v>1031.5262666776046</c:v>
                </c:pt>
                <c:pt idx="254">
                  <c:v>1010.4879623884311</c:v>
                </c:pt>
                <c:pt idx="255">
                  <c:v>989.76634755823727</c:v>
                </c:pt>
                <c:pt idx="256">
                  <c:v>969.37057226879472</c:v>
                </c:pt>
                <c:pt idx="257">
                  <c:v>949.30964272030667</c:v>
                </c:pt>
                <c:pt idx="258">
                  <c:v>929.59241725452375</c:v>
                </c:pt>
                <c:pt idx="259">
                  <c:v>910.22760244314861</c:v>
                </c:pt>
                <c:pt idx="260">
                  <c:v>891.22374924326061</c:v>
                </c:pt>
                <c:pt idx="261">
                  <c:v>872.58924922145241</c:v>
                </c:pt>
                <c:pt idx="262">
                  <c:v>854.33233084835092</c:v>
                </c:pt>
                <c:pt idx="263">
                  <c:v>836.46105586515671</c:v>
                </c:pt>
                <c:pt idx="264">
                  <c:v>818.98331572380516</c:v>
                </c:pt>
                <c:pt idx="265">
                  <c:v>801.90682810232443</c:v>
                </c:pt>
                <c:pt idx="266">
                  <c:v>785.23913349692543</c:v>
                </c:pt>
                <c:pt idx="267">
                  <c:v>768.9875918923309</c:v>
                </c:pt>
                <c:pt idx="268">
                  <c:v>753.15937951181411</c:v>
                </c:pt>
                <c:pt idx="269">
                  <c:v>737.7614856483799</c:v>
                </c:pt>
                <c:pt idx="270">
                  <c:v>722.80070957848989</c:v>
                </c:pt>
                <c:pt idx="271">
                  <c:v>708.28365755969401</c:v>
                </c:pt>
                <c:pt idx="272">
                  <c:v>694.21673991349098</c:v>
                </c:pt>
                <c:pt idx="273">
                  <c:v>680.6061681947142</c:v>
                </c:pt>
                <c:pt idx="274">
                  <c:v>667.45795244868123</c:v>
                </c:pt>
                <c:pt idx="275">
                  <c:v>654.77789855732817</c:v>
                </c:pt>
                <c:pt idx="276">
                  <c:v>642.57160567549545</c:v>
                </c:pt>
                <c:pt idx="277">
                  <c:v>630.84446375849848</c:v>
                </c:pt>
                <c:pt idx="278">
                  <c:v>619.60165118207533</c:v>
                </c:pt>
                <c:pt idx="279">
                  <c:v>608.84813245576152</c:v>
                </c:pt>
                <c:pt idx="280">
                  <c:v>598.58865603070285</c:v>
                </c:pt>
                <c:pt idx="281">
                  <c:v>588.82775220287249</c:v>
                </c:pt>
                <c:pt idx="282">
                  <c:v>579.56973111262027</c:v>
                </c:pt>
                <c:pt idx="283">
                  <c:v>570.81868084143525</c:v>
                </c:pt>
                <c:pt idx="284">
                  <c:v>562.5784656067658</c:v>
                </c:pt>
                <c:pt idx="285">
                  <c:v>554.85272405568753</c:v>
                </c:pt>
                <c:pt idx="286">
                  <c:v>547.64486765818106</c:v>
                </c:pt>
                <c:pt idx="287">
                  <c:v>540.95807920072161</c:v>
                </c:pt>
                <c:pt idx="288">
                  <c:v>534.79531138085213</c:v>
                </c:pt>
                <c:pt idx="289">
                  <c:v>529.15928550335229</c:v>
                </c:pt>
                <c:pt idx="290">
                  <c:v>524.05249027858895</c:v>
                </c:pt>
                <c:pt idx="291">
                  <c:v>519.47718072357156</c:v>
                </c:pt>
                <c:pt idx="292">
                  <c:v>515.43537716619903</c:v>
                </c:pt>
                <c:pt idx="293">
                  <c:v>511.92886435314108</c:v>
                </c:pt>
                <c:pt idx="294">
                  <c:v>508.95919066174338</c:v>
                </c:pt>
                <c:pt idx="295">
                  <c:v>506.52766741630876</c:v>
                </c:pt>
                <c:pt idx="296">
                  <c:v>504.63536830905196</c:v>
                </c:pt>
                <c:pt idx="297">
                  <c:v>503.28312892598819</c:v>
                </c:pt>
                <c:pt idx="298">
                  <c:v>502.47154637796211</c:v>
                </c:pt>
                <c:pt idx="299">
                  <c:v>502.20097903698002</c:v>
                </c:pt>
              </c:numCache>
            </c:numRef>
          </c:xVal>
          <c:yVal>
            <c:numRef>
              <c:f>'Covariance   Correlation3'!yycir63</c:f>
              <c:numCache>
                <c:formatCode>General</c:formatCode>
                <c:ptCount val="300"/>
                <c:pt idx="0">
                  <c:v>5.1075219419106843E-3</c:v>
                </c:pt>
                <c:pt idx="1">
                  <c:v>5.0056927146795594E-3</c:v>
                </c:pt>
                <c:pt idx="2">
                  <c:v>4.9023655170444469E-3</c:v>
                </c:pt>
                <c:pt idx="3">
                  <c:v>4.7975859753870429E-3</c:v>
                </c:pt>
                <c:pt idx="4">
                  <c:v>4.6914003574032781E-3</c:v>
                </c:pt>
                <c:pt idx="5">
                  <c:v>4.5838555516728077E-3</c:v>
                </c:pt>
                <c:pt idx="6">
                  <c:v>4.4749990469543314E-3</c:v>
                </c:pt>
                <c:pt idx="7">
                  <c:v>4.3648789112159005E-3</c:v>
                </c:pt>
                <c:pt idx="8">
                  <c:v>4.253543770409444E-3</c:v>
                </c:pt>
                <c:pt idx="9">
                  <c:v>4.1410427869989323E-3</c:v>
                </c:pt>
                <c:pt idx="10">
                  <c:v>4.0274256382516072E-3</c:v>
                </c:pt>
                <c:pt idx="11">
                  <c:v>3.9127424943019027E-3</c:v>
                </c:pt>
                <c:pt idx="12">
                  <c:v>3.7970439959977243E-3</c:v>
                </c:pt>
                <c:pt idx="13">
                  <c:v>3.6803812325388774E-3</c:v>
                </c:pt>
                <c:pt idx="14">
                  <c:v>3.5628057189175145E-3</c:v>
                </c:pt>
                <c:pt idx="15">
                  <c:v>3.4443693731705657E-3</c:v>
                </c:pt>
                <c:pt idx="16">
                  <c:v>3.3251244934541929E-3</c:v>
                </c:pt>
                <c:pt idx="17">
                  <c:v>3.205123734950399E-3</c:v>
                </c:pt>
                <c:pt idx="18">
                  <c:v>3.0844200866159792E-3</c:v>
                </c:pt>
                <c:pt idx="19">
                  <c:v>2.9630668477840924E-3</c:v>
                </c:pt>
                <c:pt idx="20">
                  <c:v>2.8411176046287739E-3</c:v>
                </c:pt>
                <c:pt idx="21">
                  <c:v>2.718626206502788E-3</c:v>
                </c:pt>
                <c:pt idx="22">
                  <c:v>2.5956467421592759E-3</c:v>
                </c:pt>
                <c:pt idx="23">
                  <c:v>2.4722335158676796E-3</c:v>
                </c:pt>
                <c:pt idx="24">
                  <c:v>2.348441023434501E-3</c:v>
                </c:pt>
                <c:pt idx="25">
                  <c:v>2.2243239281394996E-3</c:v>
                </c:pt>
                <c:pt idx="26">
                  <c:v>2.0999370365979192E-3</c:v>
                </c:pt>
                <c:pt idx="27">
                  <c:v>1.9753352745594303E-3</c:v>
                </c:pt>
                <c:pt idx="28">
                  <c:v>1.8505736626544659E-3</c:v>
                </c:pt>
                <c:pt idx="29">
                  <c:v>1.7257072920986625E-3</c:v>
                </c:pt>
                <c:pt idx="30">
                  <c:v>1.6007913003661237E-3</c:v>
                </c:pt>
                <c:pt idx="31">
                  <c:v>1.4758808468422701E-3</c:v>
                </c:pt>
                <c:pt idx="32">
                  <c:v>1.3510310884670058E-3</c:v>
                </c:pt>
                <c:pt idx="33">
                  <c:v>1.2262971553789652E-3</c:v>
                </c:pt>
                <c:pt idx="34">
                  <c:v>1.1017341265715983E-3</c:v>
                </c:pt>
                <c:pt idx="35">
                  <c:v>9.7739700557182953E-4</c:v>
                </c:pt>
                <c:pt idx="36">
                  <c:v>8.5334069615206195E-4</c:v>
                </c:pt>
                <c:pt idx="37">
                  <c:v>7.2961997808620787E-4</c:v>
                </c:pt>
                <c:pt idx="38">
                  <c:v>6.0628948296048398E-4</c:v>
                </c:pt>
                <c:pt idx="39">
                  <c:v>4.8340367004964368E-4</c:v>
                </c:pt>
                <c:pt idx="40">
                  <c:v>3.6101680226929053E-4</c:v>
                </c:pt>
                <c:pt idx="41">
                  <c:v>2.3918292221490655E-4</c:v>
                </c:pt>
                <c:pt idx="42">
                  <c:v>1.1795582829815911E-4</c:v>
                </c:pt>
                <c:pt idx="43">
                  <c:v>-2.6109490089596364E-6</c:v>
                </c:pt>
                <c:pt idx="44">
                  <c:v>-1.2246417081168432E-4</c:v>
                </c:pt>
                <c:pt idx="45">
                  <c:v>-2.4155091330127238E-4</c:v>
                </c:pt>
                <c:pt idx="46">
                  <c:v>-3.5981859112466964E-4</c:v>
                </c:pt>
                <c:pt idx="47">
                  <c:v>-4.7721498060472036E-4</c:v>
                </c:pt>
                <c:pt idx="48">
                  <c:v>-5.93688242800673E-4</c:v>
                </c:pt>
                <c:pt idx="49">
                  <c:v>-7.0918694639879884E-4</c:v>
                </c:pt>
                <c:pt idx="50">
                  <c:v>-8.2366009042300799E-4</c:v>
                </c:pt>
                <c:pt idx="51">
                  <c:v>-9.3705712675545209E-4</c:v>
                </c:pt>
                <c:pt idx="52">
                  <c:v>-1.0493279824571437E-3</c:v>
                </c:pt>
                <c:pt idx="53">
                  <c:v>-1.1604230818787566E-3</c:v>
                </c:pt>
                <c:pt idx="54">
                  <c:v>-1.2702933685518399E-3</c:v>
                </c:pt>
                <c:pt idx="55">
                  <c:v>-1.3788903268507782E-3</c:v>
                </c:pt>
                <c:pt idx="56">
                  <c:v>-1.4861660034159129E-3</c:v>
                </c:pt>
                <c:pt idx="57">
                  <c:v>-1.5920730283284072E-3</c:v>
                </c:pt>
                <c:pt idx="58">
                  <c:v>-1.6965646360274636E-3</c:v>
                </c:pt>
                <c:pt idx="59">
                  <c:v>-1.7995946859606815E-3</c:v>
                </c:pt>
                <c:pt idx="60">
                  <c:v>-1.9011176829584243E-3</c:v>
                </c:pt>
                <c:pt idx="61">
                  <c:v>-2.0010887973232055E-3</c:v>
                </c:pt>
                <c:pt idx="62">
                  <c:v>-2.0994638846252257E-3</c:v>
                </c:pt>
                <c:pt idx="63">
                  <c:v>-2.1961995051953038E-3</c:v>
                </c:pt>
                <c:pt idx="64">
                  <c:v>-2.2912529433066139E-3</c:v>
                </c:pt>
                <c:pt idx="65">
                  <c:v>-2.3845822260367506E-3</c:v>
                </c:pt>
                <c:pt idx="66">
                  <c:v>-2.4761461418017845E-3</c:v>
                </c:pt>
                <c:pt idx="67">
                  <c:v>-2.5659042585541463E-3</c:v>
                </c:pt>
                <c:pt idx="68">
                  <c:v>-2.6538169416362692E-3</c:v>
                </c:pt>
                <c:pt idx="69">
                  <c:v>-2.7398453712821503E-3</c:v>
                </c:pt>
                <c:pt idx="70">
                  <c:v>-2.823951559759055E-3</c:v>
                </c:pt>
                <c:pt idx="71">
                  <c:v>-2.9060983681418384E-3</c:v>
                </c:pt>
                <c:pt idx="72">
                  <c:v>-2.9862495227124452E-3</c:v>
                </c:pt>
                <c:pt idx="73">
                  <c:v>-3.0643696309773654E-3</c:v>
                </c:pt>
                <c:pt idx="74">
                  <c:v>-3.1404241972959588E-3</c:v>
                </c:pt>
                <c:pt idx="75">
                  <c:v>-3.2143796381127621E-3</c:v>
                </c:pt>
                <c:pt idx="76">
                  <c:v>-3.2862032967870426E-3</c:v>
                </c:pt>
                <c:pt idx="77">
                  <c:v>-3.3558634580130474E-3</c:v>
                </c:pt>
                <c:pt idx="78">
                  <c:v>-3.4233293618245939E-3</c:v>
                </c:pt>
                <c:pt idx="79">
                  <c:v>-3.4885712171777998E-3</c:v>
                </c:pt>
                <c:pt idx="80">
                  <c:v>-3.5515602151059765E-3</c:v>
                </c:pt>
                <c:pt idx="81">
                  <c:v>-3.6122685414408493E-3</c:v>
                </c:pt>
                <c:pt idx="82">
                  <c:v>-3.6706693890945184E-3</c:v>
                </c:pt>
                <c:pt idx="83">
                  <c:v>-3.726736969896712E-3</c:v>
                </c:pt>
                <c:pt idx="84">
                  <c:v>-3.7804465259821136E-3</c:v>
                </c:pt>
                <c:pt idx="85">
                  <c:v>-3.8317743407227426E-3</c:v>
                </c:pt>
                <c:pt idx="86">
                  <c:v>-3.8806977492005469E-3</c:v>
                </c:pt>
                <c:pt idx="87">
                  <c:v>-3.9271951482155905E-3</c:v>
                </c:pt>
                <c:pt idx="88">
                  <c:v>-3.9712460058254247E-3</c:v>
                </c:pt>
                <c:pt idx="89">
                  <c:v>-4.0128308704114116E-3</c:v>
                </c:pt>
                <c:pt idx="90">
                  <c:v>-4.0519313792680128E-3</c:v>
                </c:pt>
                <c:pt idx="91">
                  <c:v>-4.0885302667112398E-3</c:v>
                </c:pt>
                <c:pt idx="92">
                  <c:v>-4.122611371702699E-3</c:v>
                </c:pt>
                <c:pt idx="93">
                  <c:v>-4.1541596449858479E-3</c:v>
                </c:pt>
                <c:pt idx="94">
                  <c:v>-4.1831611557313249E-3</c:v>
                </c:pt>
                <c:pt idx="95">
                  <c:v>-4.2096030976884122E-3</c:v>
                </c:pt>
                <c:pt idx="96">
                  <c:v>-4.2334737948399107E-3</c:v>
                </c:pt>
                <c:pt idx="97">
                  <c:v>-4.2547627065579463E-3</c:v>
                </c:pt>
                <c:pt idx="98">
                  <c:v>-4.2734604322584128E-3</c:v>
                </c:pt>
                <c:pt idx="99">
                  <c:v>-4.2895587155520028E-3</c:v>
                </c:pt>
                <c:pt idx="100">
                  <c:v>-4.3030504478899978E-3</c:v>
                </c:pt>
                <c:pt idx="101">
                  <c:v>-4.3139296717032063E-3</c:v>
                </c:pt>
                <c:pt idx="102">
                  <c:v>-4.3221915830326547E-3</c:v>
                </c:pt>
                <c:pt idx="103">
                  <c:v>-4.3278325336508824E-3</c:v>
                </c:pt>
                <c:pt idx="104">
                  <c:v>-4.3308500326728946E-3</c:v>
                </c:pt>
                <c:pt idx="105">
                  <c:v>-4.3312427476560715E-3</c:v>
                </c:pt>
                <c:pt idx="106">
                  <c:v>-4.3290105051885294E-3</c:v>
                </c:pt>
                <c:pt idx="107">
                  <c:v>-4.3241542909657031E-3</c:v>
                </c:pt>
                <c:pt idx="108">
                  <c:v>-4.3166762493550863E-3</c:v>
                </c:pt>
                <c:pt idx="109">
                  <c:v>-4.3065796824493362E-3</c:v>
                </c:pt>
                <c:pt idx="110">
                  <c:v>-4.2938690486081709E-3</c:v>
                </c:pt>
                <c:pt idx="111">
                  <c:v>-4.2785499604896735E-3</c:v>
                </c:pt>
                <c:pt idx="112">
                  <c:v>-4.26062918257191E-3</c:v>
                </c:pt>
                <c:pt idx="113">
                  <c:v>-4.2401146281659157E-3</c:v>
                </c:pt>
                <c:pt idx="114">
                  <c:v>-4.2170153559214097E-3</c:v>
                </c:pt>
                <c:pt idx="115">
                  <c:v>-4.1913415658267426E-3</c:v>
                </c:pt>
                <c:pt idx="116">
                  <c:v>-4.1631045947048756E-3</c:v>
                </c:pt>
                <c:pt idx="117">
                  <c:v>-4.1323169112073514E-3</c:v>
                </c:pt>
                <c:pt idx="118">
                  <c:v>-4.0989921103084942E-3</c:v>
                </c:pt>
                <c:pt idx="119">
                  <c:v>-4.0631449073022493E-3</c:v>
                </c:pt>
                <c:pt idx="120">
                  <c:v>-4.0247911313043248E-3</c:v>
                </c:pt>
                <c:pt idx="121">
                  <c:v>-3.9839477182624988E-3</c:v>
                </c:pt>
                <c:pt idx="122">
                  <c:v>-3.9406327034781797E-3</c:v>
                </c:pt>
                <c:pt idx="123">
                  <c:v>-3.8948652136425316E-3</c:v>
                </c:pt>
                <c:pt idx="124">
                  <c:v>-3.8466654583906557E-3</c:v>
                </c:pt>
                <c:pt idx="125">
                  <c:v>-3.7960547213775949E-3</c:v>
                </c:pt>
                <c:pt idx="126">
                  <c:v>-3.7430553508800623E-3</c:v>
                </c:pt>
                <c:pt idx="127">
                  <c:v>-3.6876907499280771E-3</c:v>
                </c:pt>
                <c:pt idx="128">
                  <c:v>-3.6299853659708431E-3</c:v>
                </c:pt>
                <c:pt idx="129">
                  <c:v>-3.5699646800814418E-3</c:v>
                </c:pt>
                <c:pt idx="130">
                  <c:v>-3.5076551957051116E-3</c:v>
                </c:pt>
                <c:pt idx="131">
                  <c:v>-3.4430844269560685E-3</c:v>
                </c:pt>
                <c:pt idx="132">
                  <c:v>-3.3762808864680523E-3</c:v>
                </c:pt>
                <c:pt idx="133">
                  <c:v>-3.307274072803945E-3</c:v>
                </c:pt>
                <c:pt idx="134">
                  <c:v>-3.2360944574300393E-3</c:v>
                </c:pt>
                <c:pt idx="135">
                  <c:v>-3.1627734712606978E-3</c:v>
                </c:pt>
                <c:pt idx="136">
                  <c:v>-3.0873434907793427E-3</c:v>
                </c:pt>
                <c:pt idx="137">
                  <c:v>-3.0098378237419115E-3</c:v>
                </c:pt>
                <c:pt idx="138">
                  <c:v>-2.9302906944690963E-3</c:v>
                </c:pt>
                <c:pt idx="139">
                  <c:v>-2.8487372287338405E-3</c:v>
                </c:pt>
                <c:pt idx="140">
                  <c:v>-2.7652134382507897E-3</c:v>
                </c:pt>
                <c:pt idx="141">
                  <c:v>-2.6797562047745291E-3</c:v>
                </c:pt>
                <c:pt idx="142">
                  <c:v>-2.5924032638136437E-3</c:v>
                </c:pt>
                <c:pt idx="143">
                  <c:v>-2.5031931879677758E-3</c:v>
                </c:pt>
                <c:pt idx="144">
                  <c:v>-2.4121653698950529E-3</c:v>
                </c:pt>
                <c:pt idx="145">
                  <c:v>-2.3193600049173984E-3</c:v>
                </c:pt>
                <c:pt idx="146">
                  <c:v>-2.2248180732714084E-3</c:v>
                </c:pt>
                <c:pt idx="147">
                  <c:v>-2.1285813220126336E-3</c:v>
                </c:pt>
                <c:pt idx="148">
                  <c:v>-2.0306922465812552E-3</c:v>
                </c:pt>
                <c:pt idx="149">
                  <c:v>-1.9311940720372939E-3</c:v>
                </c:pt>
                <c:pt idx="150">
                  <c:v>-1.8301307339736422E-3</c:v>
                </c:pt>
                <c:pt idx="151">
                  <c:v>-1.7275468591153355E-3</c:v>
                </c:pt>
                <c:pt idx="152">
                  <c:v>-1.6234877456136592E-3</c:v>
                </c:pt>
                <c:pt idx="153">
                  <c:v>-1.517999343043753E-3</c:v>
                </c:pt>
                <c:pt idx="154">
                  <c:v>-1.4111282321145713E-3</c:v>
                </c:pt>
                <c:pt idx="155">
                  <c:v>-1.3029216041001556E-3</c:v>
                </c:pt>
                <c:pt idx="156">
                  <c:v>-1.1934272400012974E-3</c:v>
                </c:pt>
                <c:pt idx="157">
                  <c:v>-1.0826934894467895E-3</c:v>
                </c:pt>
                <c:pt idx="158">
                  <c:v>-9.7076924934359462E-4</c:v>
                </c:pt>
                <c:pt idx="159">
                  <c:v>-8.5770394228534656E-4</c:v>
                </c:pt>
                <c:pt idx="160">
                  <c:v>-7.4354749472872348E-4</c:v>
                </c:pt>
                <c:pt idx="161">
                  <c:v>-6.2835031494733141E-4</c:v>
                </c:pt>
                <c:pt idx="162">
                  <c:v>-5.1216327077282945E-4</c:v>
                </c:pt>
                <c:pt idx="163">
                  <c:v>-3.9503766713312608E-4</c:v>
                </c:pt>
                <c:pt idx="164">
                  <c:v>-2.7702522339757016E-4</c:v>
                </c:pt>
                <c:pt idx="165">
                  <c:v>-1.5817805053912467E-4</c:v>
                </c:pt>
                <c:pt idx="166">
                  <c:v>-3.8548628123642303E-5</c:v>
                </c:pt>
                <c:pt idx="167">
                  <c:v>8.1810218863644091E-5</c:v>
                </c:pt>
                <c:pt idx="168">
                  <c:v>2.0284534334414532E-4</c:v>
                </c:pt>
                <c:pt idx="169">
                  <c:v>3.2450329961416753E-4</c:v>
                </c:pt>
                <c:pt idx="170">
                  <c:v>4.4673036694503447E-4</c:v>
                </c:pt>
                <c:pt idx="171">
                  <c:v>5.6947257330464346E-4</c:v>
                </c:pt>
                <c:pt idx="172">
                  <c:v>6.9267571919000249E-4</c:v>
                </c:pt>
                <c:pt idx="173">
                  <c:v>8.1628540156019778E-4</c:v>
                </c:pt>
                <c:pt idx="174">
                  <c:v>9.4024703785924738E-4</c:v>
                </c:pt>
                <c:pt idx="175">
                  <c:v>1.0645058901182277E-3</c:v>
                </c:pt>
                <c:pt idx="176">
                  <c:v>1.1890070891260067E-3</c:v>
                </c:pt>
                <c:pt idx="177">
                  <c:v>1.3136956586579577E-3</c:v>
                </c:pt>
                <c:pt idx="178">
                  <c:v>1.4385165397518972E-3</c:v>
                </c:pt>
                <c:pt idx="179">
                  <c:v>1.5634146150205913E-3</c:v>
                </c:pt>
                <c:pt idx="180">
                  <c:v>1.6883347329900234E-3</c:v>
                </c:pt>
                <c:pt idx="181">
                  <c:v>1.813221732452742E-3</c:v>
                </c:pt>
                <c:pt idx="182">
                  <c:v>1.9380204668254979E-3</c:v>
                </c:pt>
                <c:pt idx="183">
                  <c:v>2.0626758285004192E-3</c:v>
                </c:pt>
                <c:pt idx="184">
                  <c:v>2.1871327731789836E-3</c:v>
                </c:pt>
                <c:pt idx="185">
                  <c:v>2.3113363441780248E-3</c:v>
                </c:pt>
                <c:pt idx="186">
                  <c:v>2.4352316966970637E-3</c:v>
                </c:pt>
                <c:pt idx="187">
                  <c:v>2.5587641220362243E-3</c:v>
                </c:pt>
                <c:pt idx="188">
                  <c:v>2.681879071754057E-3</c:v>
                </c:pt>
                <c:pt idx="189">
                  <c:v>2.804522181754593E-3</c:v>
                </c:pt>
                <c:pt idx="190">
                  <c:v>2.9266392962930005E-3</c:v>
                </c:pt>
                <c:pt idx="191">
                  <c:v>3.0481764918892356E-3</c:v>
                </c:pt>
                <c:pt idx="192">
                  <c:v>3.1690801011391386E-3</c:v>
                </c:pt>
                <c:pt idx="193">
                  <c:v>3.289296736412436E-3</c:v>
                </c:pt>
                <c:pt idx="194">
                  <c:v>3.4087733134272303E-3</c:v>
                </c:pt>
                <c:pt idx="195">
                  <c:v>3.5274570746905132E-3</c:v>
                </c:pt>
                <c:pt idx="196">
                  <c:v>3.6452956127943949E-3</c:v>
                </c:pt>
                <c:pt idx="197">
                  <c:v>3.7622368935577404E-3</c:v>
                </c:pt>
                <c:pt idx="198">
                  <c:v>3.8782292790029947E-3</c:v>
                </c:pt>
                <c:pt idx="199">
                  <c:v>3.9932215501580649E-3</c:v>
                </c:pt>
                <c:pt idx="200">
                  <c:v>4.1071629296731728E-3</c:v>
                </c:pt>
                <c:pt idx="201">
                  <c:v>4.2200031042427047E-3</c:v>
                </c:pt>
                <c:pt idx="202">
                  <c:v>4.3316922468221537E-3</c:v>
                </c:pt>
                <c:pt idx="203">
                  <c:v>4.4421810386303315E-3</c:v>
                </c:pt>
                <c:pt idx="204">
                  <c:v>4.5514206909271649E-3</c:v>
                </c:pt>
                <c:pt idx="205">
                  <c:v>4.6593629665574194E-3</c:v>
                </c:pt>
                <c:pt idx="206">
                  <c:v>4.765960201250875E-3</c:v>
                </c:pt>
                <c:pt idx="207">
                  <c:v>4.8711653246695276E-3</c:v>
                </c:pt>
                <c:pt idx="208">
                  <c:v>4.9749318811925201E-3</c:v>
                </c:pt>
                <c:pt idx="209">
                  <c:v>5.0772140504296397E-3</c:v>
                </c:pt>
                <c:pt idx="210">
                  <c:v>5.1779666674543114E-3</c:v>
                </c:pt>
                <c:pt idx="211">
                  <c:v>5.2771452427471596E-3</c:v>
                </c:pt>
                <c:pt idx="212">
                  <c:v>5.3747059818413257E-3</c:v>
                </c:pt>
                <c:pt idx="213">
                  <c:v>5.4706058046608717E-3</c:v>
                </c:pt>
                <c:pt idx="214">
                  <c:v>5.5648023645437283E-3</c:v>
                </c:pt>
                <c:pt idx="215">
                  <c:v>5.6572540669408006E-3</c:v>
                </c:pt>
                <c:pt idx="216">
                  <c:v>5.7479200877829251E-3</c:v>
                </c:pt>
                <c:pt idx="217">
                  <c:v>5.8367603915076543E-3</c:v>
                </c:pt>
                <c:pt idx="218">
                  <c:v>5.9237357487378177E-3</c:v>
                </c:pt>
                <c:pt idx="219">
                  <c:v>6.008807753604118E-3</c:v>
                </c:pt>
                <c:pt idx="220">
                  <c:v>6.0919388407040843E-3</c:v>
                </c:pt>
                <c:pt idx="221">
                  <c:v>6.1730923016898847E-3</c:v>
                </c:pt>
                <c:pt idx="222">
                  <c:v>6.2522323014777142E-3</c:v>
                </c:pt>
                <c:pt idx="223">
                  <c:v>6.3293238940715455E-3</c:v>
                </c:pt>
                <c:pt idx="224">
                  <c:v>6.404333037994309E-3</c:v>
                </c:pt>
                <c:pt idx="225">
                  <c:v>6.4772266113196416E-3</c:v>
                </c:pt>
                <c:pt idx="226">
                  <c:v>6.5479724262975979E-3</c:v>
                </c:pt>
                <c:pt idx="227">
                  <c:v>6.6165392435678632E-3</c:v>
                </c:pt>
                <c:pt idx="228">
                  <c:v>6.6828967859541627E-3</c:v>
                </c:pt>
                <c:pt idx="229">
                  <c:v>6.7470157518338221E-3</c:v>
                </c:pt>
                <c:pt idx="230">
                  <c:v>6.8088678280765298E-3</c:v>
                </c:pt>
                <c:pt idx="231">
                  <c:v>6.8684257025466251E-3</c:v>
                </c:pt>
                <c:pt idx="232">
                  <c:v>6.9256630761633624E-3</c:v>
                </c:pt>
                <c:pt idx="233">
                  <c:v>6.9805546745138536E-3</c:v>
                </c:pt>
                <c:pt idx="234">
                  <c:v>7.0330762590135277E-3</c:v>
                </c:pt>
                <c:pt idx="235">
                  <c:v>7.0832046376092112E-3</c:v>
                </c:pt>
                <c:pt idx="236">
                  <c:v>7.1309176750200889E-3</c:v>
                </c:pt>
                <c:pt idx="237">
                  <c:v>7.1761943025120158E-3</c:v>
                </c:pt>
                <c:pt idx="238">
                  <c:v>7.2190145272008821E-3</c:v>
                </c:pt>
                <c:pt idx="239">
                  <c:v>7.2593594408809038E-3</c:v>
                </c:pt>
                <c:pt idx="240">
                  <c:v>7.2972112283739531E-3</c:v>
                </c:pt>
                <c:pt idx="241">
                  <c:v>7.3325531753962473E-3</c:v>
                </c:pt>
                <c:pt idx="242">
                  <c:v>7.3653696759388952E-3</c:v>
                </c:pt>
                <c:pt idx="243">
                  <c:v>7.3956462391590811E-3</c:v>
                </c:pt>
                <c:pt idx="244">
                  <c:v>7.4233694957788069E-3</c:v>
                </c:pt>
                <c:pt idx="245">
                  <c:v>7.4485272039883903E-3</c:v>
                </c:pt>
                <c:pt idx="246">
                  <c:v>7.4711082548521053E-3</c:v>
                </c:pt>
                <c:pt idx="247">
                  <c:v>7.491102677213572E-3</c:v>
                </c:pt>
                <c:pt idx="248">
                  <c:v>7.5085016420987421E-3</c:v>
                </c:pt>
                <c:pt idx="249">
                  <c:v>7.5232974666145222E-3</c:v>
                </c:pt>
                <c:pt idx="250">
                  <c:v>7.5354836173413264E-3</c:v>
                </c:pt>
                <c:pt idx="251">
                  <c:v>7.5450547132180478E-3</c:v>
                </c:pt>
                <c:pt idx="252">
                  <c:v>7.552006527918184E-3</c:v>
                </c:pt>
                <c:pt idx="253">
                  <c:v>7.556335991716066E-3</c:v>
                </c:pt>
                <c:pt idx="254">
                  <c:v>7.5580411928423599E-3</c:v>
                </c:pt>
                <c:pt idx="255">
                  <c:v>7.5571213783282506E-3</c:v>
                </c:pt>
                <c:pt idx="256">
                  <c:v>7.5535769543379344E-3</c:v>
                </c:pt>
                <c:pt idx="257">
                  <c:v>7.5474094859892676E-3</c:v>
                </c:pt>
                <c:pt idx="258">
                  <c:v>7.5386216966626483E-3</c:v>
                </c:pt>
                <c:pt idx="259">
                  <c:v>7.5272174667984585E-3</c:v>
                </c:pt>
                <c:pt idx="260">
                  <c:v>7.513201832183564E-3</c:v>
                </c:pt>
                <c:pt idx="261">
                  <c:v>7.496580981727655E-3</c:v>
                </c:pt>
                <c:pt idx="262">
                  <c:v>7.4773622547303952E-3</c:v>
                </c:pt>
                <c:pt idx="263">
                  <c:v>7.4555541376405991E-3</c:v>
                </c:pt>
                <c:pt idx="264">
                  <c:v>7.4311662603088486E-3</c:v>
                </c:pt>
                <c:pt idx="265">
                  <c:v>7.4042093917352277E-3</c:v>
                </c:pt>
                <c:pt idx="266">
                  <c:v>7.3746954353140319E-3</c:v>
                </c:pt>
                <c:pt idx="267">
                  <c:v>7.3426374235775636E-3</c:v>
                </c:pt>
                <c:pt idx="268">
                  <c:v>7.3080495124413372E-3</c:v>
                </c:pt>
                <c:pt idx="269">
                  <c:v>7.2709469749532209E-3</c:v>
                </c:pt>
                <c:pt idx="270">
                  <c:v>7.2313461945492877E-3</c:v>
                </c:pt>
                <c:pt idx="271">
                  <c:v>7.1892646578193622E-3</c:v>
                </c:pt>
                <c:pt idx="272">
                  <c:v>7.1447209467854159E-3</c:v>
                </c:pt>
                <c:pt idx="273">
                  <c:v>7.0977347306962852E-3</c:v>
                </c:pt>
                <c:pt idx="274">
                  <c:v>7.0483267573422798E-3</c:v>
                </c:pt>
                <c:pt idx="275">
                  <c:v>6.9965188438935429E-3</c:v>
                </c:pt>
                <c:pt idx="276">
                  <c:v>6.9423338672661983E-3</c:v>
                </c:pt>
                <c:pt idx="277">
                  <c:v>6.8857957540205579E-3</c:v>
                </c:pt>
                <c:pt idx="278">
                  <c:v>6.8269294697958175E-3</c:v>
                </c:pt>
                <c:pt idx="279">
                  <c:v>6.7657610082859365E-3</c:v>
                </c:pt>
                <c:pt idx="280">
                  <c:v>6.7023173797615566E-3</c:v>
                </c:pt>
                <c:pt idx="281">
                  <c:v>6.6366265991430213E-3</c:v>
                </c:pt>
                <c:pt idx="282">
                  <c:v>6.5687176736297813E-3</c:v>
                </c:pt>
                <c:pt idx="283">
                  <c:v>6.4986205898916304E-3</c:v>
                </c:pt>
                <c:pt idx="284">
                  <c:v>6.4263663008274317E-3</c:v>
                </c:pt>
                <c:pt idx="285">
                  <c:v>6.3519867118971961E-3</c:v>
                </c:pt>
                <c:pt idx="286">
                  <c:v>6.2755146670335233E-3</c:v>
                </c:pt>
                <c:pt idx="287">
                  <c:v>6.1969839341386515E-3</c:v>
                </c:pt>
                <c:pt idx="288">
                  <c:v>6.1164291901734946E-3</c:v>
                </c:pt>
                <c:pt idx="289">
                  <c:v>6.0338860058452796E-3</c:v>
                </c:pt>
                <c:pt idx="290">
                  <c:v>5.9493908299005204E-3</c:v>
                </c:pt>
                <c:pt idx="291">
                  <c:v>5.8629809730302764E-3</c:v>
                </c:pt>
                <c:pt idx="292">
                  <c:v>5.7746945913948076E-3</c:v>
                </c:pt>
                <c:pt idx="293">
                  <c:v>5.6845706697748796E-3</c:v>
                </c:pt>
                <c:pt idx="294">
                  <c:v>5.5926490043571872E-3</c:v>
                </c:pt>
                <c:pt idx="295">
                  <c:v>5.4989701851614796E-3</c:v>
                </c:pt>
                <c:pt idx="296">
                  <c:v>5.403575578117146E-3</c:v>
                </c:pt>
                <c:pt idx="297">
                  <c:v>5.3065073067971903E-3</c:v>
                </c:pt>
                <c:pt idx="298">
                  <c:v>5.2078082338176445E-3</c:v>
                </c:pt>
                <c:pt idx="299">
                  <c:v>5.107521941910647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942416"/>
        <c:axId val="283944376"/>
      </c:scatterChart>
      <c:valAx>
        <c:axId val="283942416"/>
        <c:scaling>
          <c:orientation val="minMax"/>
          <c:max val="30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944376"/>
        <c:crosses val="autoZero"/>
        <c:crossBetween val="midCat"/>
      </c:valAx>
      <c:valAx>
        <c:axId val="283944376"/>
        <c:scaling>
          <c:orientation val="minMax"/>
          <c:max val="0.01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942416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922319806178074"/>
          <c:y val="0.10679611650485436"/>
          <c:w val="0.64894987886129618"/>
          <c:h val="0.7039966363427872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003CE6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003CE6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CY$1:$CY$15</c:f>
              <c:numCache>
                <c:formatCode>General</c:formatCode>
                <c:ptCount val="15"/>
                <c:pt idx="0">
                  <c:v>12.6</c:v>
                </c:pt>
                <c:pt idx="1">
                  <c:v>15.8</c:v>
                </c:pt>
                <c:pt idx="2">
                  <c:v>13.1</c:v>
                </c:pt>
                <c:pt idx="3">
                  <c:v>10</c:v>
                </c:pt>
                <c:pt idx="4">
                  <c:v>10.6</c:v>
                </c:pt>
                <c:pt idx="5">
                  <c:v>13.07</c:v>
                </c:pt>
                <c:pt idx="6">
                  <c:v>15.5</c:v>
                </c:pt>
                <c:pt idx="7">
                  <c:v>9.99</c:v>
                </c:pt>
                <c:pt idx="8">
                  <c:v>14.3</c:v>
                </c:pt>
                <c:pt idx="9">
                  <c:v>18</c:v>
                </c:pt>
                <c:pt idx="10">
                  <c:v>22.2</c:v>
                </c:pt>
                <c:pt idx="11">
                  <c:v>25</c:v>
                </c:pt>
                <c:pt idx="12">
                  <c:v>18.5</c:v>
                </c:pt>
                <c:pt idx="13">
                  <c:v>20.5</c:v>
                </c:pt>
                <c:pt idx="14">
                  <c:v>19.7</c:v>
                </c:pt>
              </c:numCache>
            </c:numRef>
          </c:xVal>
          <c:yVal>
            <c:numRef>
              <c:f>'Covariance   Correlation3_HID4'!$CZ$1:$CZ$15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3999999999999998E-3</c:v>
                </c:pt>
                <c:pt idx="6">
                  <c:v>2.3E-3</c:v>
                </c:pt>
                <c:pt idx="7">
                  <c:v>2.8E-3</c:v>
                </c:pt>
                <c:pt idx="8">
                  <c:v>6.0000000000000001E-3</c:v>
                </c:pt>
                <c:pt idx="9">
                  <c:v>4.3E-3</c:v>
                </c:pt>
                <c:pt idx="10">
                  <c:v>3.5999999999999999E-3</c:v>
                </c:pt>
                <c:pt idx="11">
                  <c:v>0</c:v>
                </c:pt>
                <c:pt idx="12">
                  <c:v>1.8E-3</c:v>
                </c:pt>
                <c:pt idx="13">
                  <c:v>0</c:v>
                </c:pt>
                <c:pt idx="14">
                  <c:v>0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64</c:f>
              <c:numCache>
                <c:formatCode>General</c:formatCode>
                <c:ptCount val="300"/>
                <c:pt idx="0">
                  <c:v>2.2847777708606003</c:v>
                </c:pt>
                <c:pt idx="1">
                  <c:v>2.2877891191489059</c:v>
                </c:pt>
                <c:pt idx="2">
                  <c:v>2.2968218342871918</c:v>
                </c:pt>
                <c:pt idx="3">
                  <c:v>2.3118719276827324</c:v>
                </c:pt>
                <c:pt idx="4">
                  <c:v>2.332932753637964</c:v>
                </c:pt>
                <c:pt idx="5">
                  <c:v>2.3599950122850295</c:v>
                </c:pt>
                <c:pt idx="6">
                  <c:v>2.3930467536923459</c:v>
                </c:pt>
                <c:pt idx="7">
                  <c:v>2.432073383141347</c:v>
                </c:pt>
                <c:pt idx="8">
                  <c:v>2.4770576675711187</c:v>
                </c:pt>
                <c:pt idx="9">
                  <c:v>2.5279797431880127</c:v>
                </c:pt>
                <c:pt idx="10">
                  <c:v>2.5848171242369542</c:v>
                </c:pt>
                <c:pt idx="11">
                  <c:v>2.6475447129305056</c:v>
                </c:pt>
                <c:pt idx="12">
                  <c:v>2.7161348105313579</c:v>
                </c:pt>
                <c:pt idx="13">
                  <c:v>2.7905571295832985</c:v>
                </c:pt>
                <c:pt idx="14">
                  <c:v>2.8707788072853067</c:v>
                </c:pt>
                <c:pt idx="15">
                  <c:v>2.9567644200028429</c:v>
                </c:pt>
                <c:pt idx="16">
                  <c:v>3.0484759989099253</c:v>
                </c:pt>
                <c:pt idx="17">
                  <c:v>3.1458730467550957</c:v>
                </c:pt>
                <c:pt idx="18">
                  <c:v>3.2489125557438623</c:v>
                </c:pt>
                <c:pt idx="19">
                  <c:v>3.3575490265297372</c:v>
                </c:pt>
                <c:pt idx="20">
                  <c:v>3.4717344883054615</c:v>
                </c:pt>
                <c:pt idx="21">
                  <c:v>3.5914185199855702</c:v>
                </c:pt>
                <c:pt idx="22">
                  <c:v>3.7165482724709129</c:v>
                </c:pt>
                <c:pt idx="23">
                  <c:v>3.8470684919853362</c:v>
                </c:pt>
                <c:pt idx="24">
                  <c:v>3.9829215444742037</c:v>
                </c:pt>
                <c:pt idx="25">
                  <c:v>4.1240474410539534</c:v>
                </c:pt>
                <c:pt idx="26">
                  <c:v>4.2703838645015111</c:v>
                </c:pt>
                <c:pt idx="27">
                  <c:v>4.4218661967718198</c:v>
                </c:pt>
                <c:pt idx="28">
                  <c:v>4.5784275475313532</c:v>
                </c:pt>
                <c:pt idx="29">
                  <c:v>4.7399987836949933</c:v>
                </c:pt>
                <c:pt idx="30">
                  <c:v>4.9065085599532701</c:v>
                </c:pt>
                <c:pt idx="31">
                  <c:v>5.07788335027643</c:v>
                </c:pt>
                <c:pt idx="32">
                  <c:v>5.2540474803814607</c:v>
                </c:pt>
                <c:pt idx="33">
                  <c:v>5.4349231611477311</c:v>
                </c:pt>
                <c:pt idx="34">
                  <c:v>5.6204305229664708</c:v>
                </c:pt>
                <c:pt idx="35">
                  <c:v>5.8104876510089518</c:v>
                </c:pt>
                <c:pt idx="36">
                  <c:v>6.0050106213977532</c:v>
                </c:pt>
                <c:pt idx="37">
                  <c:v>6.2039135382651995</c:v>
                </c:pt>
                <c:pt idx="38">
                  <c:v>6.4071085716825458</c:v>
                </c:pt>
                <c:pt idx="39">
                  <c:v>6.6145059964432065</c:v>
                </c:pt>
                <c:pt idx="40">
                  <c:v>6.8260142316828851</c:v>
                </c:pt>
                <c:pt idx="41">
                  <c:v>7.0415398813191015</c:v>
                </c:pt>
                <c:pt idx="42">
                  <c:v>7.260987775292266</c:v>
                </c:pt>
                <c:pt idx="43">
                  <c:v>7.4842610115901174</c:v>
                </c:pt>
                <c:pt idx="44">
                  <c:v>7.7112609990368988</c:v>
                </c:pt>
                <c:pt idx="45">
                  <c:v>7.9418875008284644</c:v>
                </c:pt>
                <c:pt idx="46">
                  <c:v>8.1760386787940273</c:v>
                </c:pt>
                <c:pt idx="47">
                  <c:v>8.4136111383650221</c:v>
                </c:pt>
                <c:pt idx="48">
                  <c:v>8.6544999742312392</c:v>
                </c:pt>
                <c:pt idx="49">
                  <c:v>8.8985988166640553</c:v>
                </c:pt>
                <c:pt idx="50">
                  <c:v>9.1457998784863186</c:v>
                </c:pt>
                <c:pt idx="51">
                  <c:v>9.3959940026681199</c:v>
                </c:pt>
                <c:pt idx="52">
                  <c:v>9.6490707105274733</c:v>
                </c:pt>
                <c:pt idx="53">
                  <c:v>9.9049182505145872</c:v>
                </c:pt>
                <c:pt idx="54">
                  <c:v>10.163423647558204</c:v>
                </c:pt>
                <c:pt idx="55">
                  <c:v>10.424472752952219</c:v>
                </c:pt>
                <c:pt idx="56">
                  <c:v>10.687950294760521</c:v>
                </c:pt>
                <c:pt idx="57">
                  <c:v>10.953739928717841</c:v>
                </c:pt>
                <c:pt idx="58">
                  <c:v>11.221724289604106</c:v>
                </c:pt>
                <c:pt idx="59">
                  <c:v>11.491785043069619</c:v>
                </c:pt>
                <c:pt idx="60">
                  <c:v>11.763802937888169</c:v>
                </c:pt>
                <c:pt idx="61">
                  <c:v>12.037657858615017</c:v>
                </c:pt>
                <c:pt idx="62">
                  <c:v>12.313228878626504</c:v>
                </c:pt>
                <c:pt idx="63">
                  <c:v>12.590394313517837</c:v>
                </c:pt>
                <c:pt idx="64">
                  <c:v>12.86903177483549</c:v>
                </c:pt>
                <c:pt idx="65">
                  <c:v>13.149018224120509</c:v>
                </c:pt>
                <c:pt idx="66">
                  <c:v>13.43023002723883</c:v>
                </c:pt>
                <c:pt idx="67">
                  <c:v>13.712543008974635</c:v>
                </c:pt>
                <c:pt idx="68">
                  <c:v>13.995832507862616</c:v>
                </c:pt>
                <c:pt idx="69">
                  <c:v>14.279973431234998</c:v>
                </c:pt>
                <c:pt idx="70">
                  <c:v>14.564840310458909</c:v>
                </c:pt>
                <c:pt idx="71">
                  <c:v>14.850307356339815</c:v>
                </c:pt>
                <c:pt idx="72">
                  <c:v>15.13624851466648</c:v>
                </c:pt>
                <c:pt idx="73">
                  <c:v>15.422537521872961</c:v>
                </c:pt>
                <c:pt idx="74">
                  <c:v>15.709047960793034</c:v>
                </c:pt>
                <c:pt idx="75">
                  <c:v>15.995653316482473</c:v>
                </c:pt>
                <c:pt idx="76">
                  <c:v>16.282227032084482</c:v>
                </c:pt>
                <c:pt idx="77">
                  <c:v>16.56864256471362</c:v>
                </c:pt>
                <c:pt idx="78">
                  <c:v>16.854773441333613</c:v>
                </c:pt>
                <c:pt idx="79">
                  <c:v>17.140493314604253</c:v>
                </c:pt>
                <c:pt idx="80">
                  <c:v>17.425676018672849</c:v>
                </c:pt>
                <c:pt idx="81">
                  <c:v>17.710195624885504</c:v>
                </c:pt>
                <c:pt idx="82">
                  <c:v>17.993926497393666</c:v>
                </c:pt>
                <c:pt idx="83">
                  <c:v>18.276743348631392</c:v>
                </c:pt>
                <c:pt idx="84">
                  <c:v>18.558521294638791</c:v>
                </c:pt>
                <c:pt idx="85">
                  <c:v>18.839135910207279</c:v>
                </c:pt>
                <c:pt idx="86">
                  <c:v>19.118463283822244</c:v>
                </c:pt>
                <c:pt idx="87">
                  <c:v>19.396380072378886</c:v>
                </c:pt>
                <c:pt idx="88">
                  <c:v>19.672763555647052</c:v>
                </c:pt>
                <c:pt idx="89">
                  <c:v>19.947491690461042</c:v>
                </c:pt>
                <c:pt idx="90">
                  <c:v>20.220443164610447</c:v>
                </c:pt>
                <c:pt idx="91">
                  <c:v>20.491497450408168</c:v>
                </c:pt>
                <c:pt idx="92">
                  <c:v>20.760534857912091</c:v>
                </c:pt>
                <c:pt idx="93">
                  <c:v>21.027436587776773</c:v>
                </c:pt>
                <c:pt idx="94">
                  <c:v>21.292084783711896</c:v>
                </c:pt>
                <c:pt idx="95">
                  <c:v>21.554362584524288</c:v>
                </c:pt>
                <c:pt idx="96">
                  <c:v>21.814154175720525</c:v>
                </c:pt>
                <c:pt idx="97">
                  <c:v>22.071344840647377</c:v>
                </c:pt>
                <c:pt idx="98">
                  <c:v>22.325821011147418</c:v>
                </c:pt>
                <c:pt idx="99">
                  <c:v>22.577470317707554</c:v>
                </c:pt>
                <c:pt idx="100">
                  <c:v>22.826181639078225</c:v>
                </c:pt>
                <c:pt idx="101">
                  <c:v>23.071845151341421</c:v>
                </c:pt>
                <c:pt idx="102">
                  <c:v>23.314352376405843</c:v>
                </c:pt>
                <c:pt idx="103">
                  <c:v>23.55359622990775</c:v>
                </c:pt>
                <c:pt idx="104">
                  <c:v>23.789471068496432</c:v>
                </c:pt>
                <c:pt idx="105">
                  <c:v>24.021872736483317</c:v>
                </c:pt>
                <c:pt idx="106">
                  <c:v>24.250698611834189</c:v>
                </c:pt>
                <c:pt idx="107">
                  <c:v>24.475847651484205</c:v>
                </c:pt>
                <c:pt idx="108">
                  <c:v>24.697220435955671</c:v>
                </c:pt>
                <c:pt idx="109">
                  <c:v>24.914719213258849</c:v>
                </c:pt>
                <c:pt idx="110">
                  <c:v>25.128247942056532</c:v>
                </c:pt>
                <c:pt idx="111">
                  <c:v>25.337712334073153</c:v>
                </c:pt>
                <c:pt idx="112">
                  <c:v>25.54301989572987</c:v>
                </c:pt>
                <c:pt idx="113">
                  <c:v>25.744079968987098</c:v>
                </c:pt>
                <c:pt idx="114">
                  <c:v>25.940803771376551</c:v>
                </c:pt>
                <c:pt idx="115">
                  <c:v>26.133104435205102</c:v>
                </c:pt>
                <c:pt idx="116">
                  <c:v>26.320897045913085</c:v>
                </c:pt>
                <c:pt idx="117">
                  <c:v>26.504098679570191</c:v>
                </c:pt>
                <c:pt idx="118">
                  <c:v>26.682628439492337</c:v>
                </c:pt>
                <c:pt idx="119">
                  <c:v>26.856407491963353</c:v>
                </c:pt>
                <c:pt idx="120">
                  <c:v>27.025359101045748</c:v>
                </c:pt>
                <c:pt idx="121">
                  <c:v>27.189408662465134</c:v>
                </c:pt>
                <c:pt idx="122">
                  <c:v>27.348483736553376</c:v>
                </c:pt>
                <c:pt idx="123">
                  <c:v>27.502514080235898</c:v>
                </c:pt>
                <c:pt idx="124">
                  <c:v>27.651431678049065</c:v>
                </c:pt>
                <c:pt idx="125">
                  <c:v>27.795170772173883</c:v>
                </c:pt>
                <c:pt idx="126">
                  <c:v>27.933667891472808</c:v>
                </c:pt>
                <c:pt idx="127">
                  <c:v>28.066861879516807</c:v>
                </c:pt>
                <c:pt idx="128">
                  <c:v>28.194693921590321</c:v>
                </c:pt>
                <c:pt idx="129">
                  <c:v>28.317107570662202</c:v>
                </c:pt>
                <c:pt idx="130">
                  <c:v>28.43404877231109</c:v>
                </c:pt>
                <c:pt idx="131">
                  <c:v>28.545465888594375</c:v>
                </c:pt>
                <c:pt idx="132">
                  <c:v>28.651309720850023</c:v>
                </c:pt>
                <c:pt idx="133">
                  <c:v>28.751533531421337</c:v>
                </c:pt>
                <c:pt idx="134">
                  <c:v>28.846093064294983</c:v>
                </c:pt>
                <c:pt idx="135">
                  <c:v>28.934946564643205</c:v>
                </c:pt>
                <c:pt idx="136">
                  <c:v>29.01805479726157</c:v>
                </c:pt>
                <c:pt idx="137">
                  <c:v>29.095381063894159</c:v>
                </c:pt>
                <c:pt idx="138">
                  <c:v>29.16689121943844</c:v>
                </c:pt>
                <c:pt idx="139">
                  <c:v>29.232553687022822</c:v>
                </c:pt>
                <c:pt idx="140">
                  <c:v>29.292339471950093</c:v>
                </c:pt>
                <c:pt idx="141">
                  <c:v>29.346222174500664</c:v>
                </c:pt>
                <c:pt idx="142">
                  <c:v>29.394178001589957</c:v>
                </c:pt>
                <c:pt idx="143">
                  <c:v>29.43618577727473</c:v>
                </c:pt>
                <c:pt idx="144">
                  <c:v>29.472226952103817</c:v>
                </c:pt>
                <c:pt idx="145">
                  <c:v>29.502285611309013</c:v>
                </c:pt>
                <c:pt idx="146">
                  <c:v>29.526348481832592</c:v>
                </c:pt>
                <c:pt idx="147">
                  <c:v>29.544404938188336</c:v>
                </c:pt>
                <c:pt idx="148">
                  <c:v>29.556447007153423</c:v>
                </c:pt>
                <c:pt idx="149">
                  <c:v>29.562469371289197</c:v>
                </c:pt>
                <c:pt idx="150">
                  <c:v>29.562469371289197</c:v>
                </c:pt>
                <c:pt idx="151">
                  <c:v>29.556447007153416</c:v>
                </c:pt>
                <c:pt idx="152">
                  <c:v>29.544404938188322</c:v>
                </c:pt>
                <c:pt idx="153">
                  <c:v>29.526348481832578</c:v>
                </c:pt>
                <c:pt idx="154">
                  <c:v>29.502285611308992</c:v>
                </c:pt>
                <c:pt idx="155">
                  <c:v>29.472226952103796</c:v>
                </c:pt>
                <c:pt idx="156">
                  <c:v>29.436185777274702</c:v>
                </c:pt>
                <c:pt idx="157">
                  <c:v>29.394178001589921</c:v>
                </c:pt>
                <c:pt idx="158">
                  <c:v>29.346222174500628</c:v>
                </c:pt>
                <c:pt idx="159">
                  <c:v>29.292339471950051</c:v>
                </c:pt>
                <c:pt idx="160">
                  <c:v>29.232553687022776</c:v>
                </c:pt>
                <c:pt idx="161">
                  <c:v>29.166891219438391</c:v>
                </c:pt>
                <c:pt idx="162">
                  <c:v>29.095381063894102</c:v>
                </c:pt>
                <c:pt idx="163">
                  <c:v>29.018054797261513</c:v>
                </c:pt>
                <c:pt idx="164">
                  <c:v>28.934946564643141</c:v>
                </c:pt>
                <c:pt idx="165">
                  <c:v>28.846093064294919</c:v>
                </c:pt>
                <c:pt idx="166">
                  <c:v>28.75153353142127</c:v>
                </c:pt>
                <c:pt idx="167">
                  <c:v>28.651309720849952</c:v>
                </c:pt>
                <c:pt idx="168">
                  <c:v>28.5454658885943</c:v>
                </c:pt>
                <c:pt idx="169">
                  <c:v>28.434048772311012</c:v>
                </c:pt>
                <c:pt idx="170">
                  <c:v>28.317107570662117</c:v>
                </c:pt>
                <c:pt idx="171">
                  <c:v>28.194693921590236</c:v>
                </c:pt>
                <c:pt idx="172">
                  <c:v>28.066861879516715</c:v>
                </c:pt>
                <c:pt idx="173">
                  <c:v>27.933667891472712</c:v>
                </c:pt>
                <c:pt idx="174">
                  <c:v>27.795170772173787</c:v>
                </c:pt>
                <c:pt idx="175">
                  <c:v>27.651431678048965</c:v>
                </c:pt>
                <c:pt idx="176">
                  <c:v>27.502514080235795</c:v>
                </c:pt>
                <c:pt idx="177">
                  <c:v>27.348483736553266</c:v>
                </c:pt>
                <c:pt idx="178">
                  <c:v>27.189408662465024</c:v>
                </c:pt>
                <c:pt idx="179">
                  <c:v>27.02535910104563</c:v>
                </c:pt>
                <c:pt idx="180">
                  <c:v>26.856407491963232</c:v>
                </c:pt>
                <c:pt idx="181">
                  <c:v>26.682628439492213</c:v>
                </c:pt>
                <c:pt idx="182">
                  <c:v>26.504098679570067</c:v>
                </c:pt>
                <c:pt idx="183">
                  <c:v>26.320897045912957</c:v>
                </c:pt>
                <c:pt idx="184">
                  <c:v>26.13310443520497</c:v>
                </c:pt>
                <c:pt idx="185">
                  <c:v>25.940803771376416</c:v>
                </c:pt>
                <c:pt idx="186">
                  <c:v>25.744079968986959</c:v>
                </c:pt>
                <c:pt idx="187">
                  <c:v>25.543019895729731</c:v>
                </c:pt>
                <c:pt idx="188">
                  <c:v>25.337712334073011</c:v>
                </c:pt>
                <c:pt idx="189">
                  <c:v>25.128247942056383</c:v>
                </c:pt>
                <c:pt idx="190">
                  <c:v>24.914719213258699</c:v>
                </c:pt>
                <c:pt idx="191">
                  <c:v>24.697220435955522</c:v>
                </c:pt>
                <c:pt idx="192">
                  <c:v>24.475847651484052</c:v>
                </c:pt>
                <c:pt idx="193">
                  <c:v>24.250698611834032</c:v>
                </c:pt>
                <c:pt idx="194">
                  <c:v>24.021872736483154</c:v>
                </c:pt>
                <c:pt idx="195">
                  <c:v>23.789471068496269</c:v>
                </c:pt>
                <c:pt idx="196">
                  <c:v>23.553596229907587</c:v>
                </c:pt>
                <c:pt idx="197">
                  <c:v>23.314352376405672</c:v>
                </c:pt>
                <c:pt idx="198">
                  <c:v>23.071845151341254</c:v>
                </c:pt>
                <c:pt idx="199">
                  <c:v>22.826181639078051</c:v>
                </c:pt>
                <c:pt idx="200">
                  <c:v>22.57747031770738</c:v>
                </c:pt>
                <c:pt idx="201">
                  <c:v>22.325821011147241</c:v>
                </c:pt>
                <c:pt idx="202">
                  <c:v>22.0713448406472</c:v>
                </c:pt>
                <c:pt idx="203">
                  <c:v>21.814154175720347</c:v>
                </c:pt>
                <c:pt idx="204">
                  <c:v>21.554362584524103</c:v>
                </c:pt>
                <c:pt idx="205">
                  <c:v>21.292084783711708</c:v>
                </c:pt>
                <c:pt idx="206">
                  <c:v>21.027436587776585</c:v>
                </c:pt>
                <c:pt idx="207">
                  <c:v>20.7605348579119</c:v>
                </c:pt>
                <c:pt idx="208">
                  <c:v>20.491497450407977</c:v>
                </c:pt>
                <c:pt idx="209">
                  <c:v>20.220443164610252</c:v>
                </c:pt>
                <c:pt idx="210">
                  <c:v>19.947491690460851</c:v>
                </c:pt>
                <c:pt idx="211">
                  <c:v>19.672763555646853</c:v>
                </c:pt>
                <c:pt idx="212">
                  <c:v>19.396380072378687</c:v>
                </c:pt>
                <c:pt idx="213">
                  <c:v>19.118463283822042</c:v>
                </c:pt>
                <c:pt idx="214">
                  <c:v>18.839135910207087</c:v>
                </c:pt>
                <c:pt idx="215">
                  <c:v>18.558521294638602</c:v>
                </c:pt>
                <c:pt idx="216">
                  <c:v>18.2767433486312</c:v>
                </c:pt>
                <c:pt idx="217">
                  <c:v>17.993926497393474</c:v>
                </c:pt>
                <c:pt idx="218">
                  <c:v>17.710195624885309</c:v>
                </c:pt>
                <c:pt idx="219">
                  <c:v>17.425676018672654</c:v>
                </c:pt>
                <c:pt idx="220">
                  <c:v>17.140493314604058</c:v>
                </c:pt>
                <c:pt idx="221">
                  <c:v>16.854773441333418</c:v>
                </c:pt>
                <c:pt idx="222">
                  <c:v>16.568642564713425</c:v>
                </c:pt>
                <c:pt idx="223">
                  <c:v>16.282227032084283</c:v>
                </c:pt>
                <c:pt idx="224">
                  <c:v>15.995653316482278</c:v>
                </c:pt>
                <c:pt idx="225">
                  <c:v>15.709047960792835</c:v>
                </c:pt>
                <c:pt idx="226">
                  <c:v>15.42253752187276</c:v>
                </c:pt>
                <c:pt idx="227">
                  <c:v>15.136248514666281</c:v>
                </c:pt>
                <c:pt idx="228">
                  <c:v>14.850307356339616</c:v>
                </c:pt>
                <c:pt idx="229">
                  <c:v>14.564840310458711</c:v>
                </c:pt>
                <c:pt idx="230">
                  <c:v>14.279973431234799</c:v>
                </c:pt>
                <c:pt idx="231">
                  <c:v>13.995832507862417</c:v>
                </c:pt>
                <c:pt idx="232">
                  <c:v>13.712543008974434</c:v>
                </c:pt>
                <c:pt idx="233">
                  <c:v>13.430230027238631</c:v>
                </c:pt>
                <c:pt idx="234">
                  <c:v>13.14901822412031</c:v>
                </c:pt>
                <c:pt idx="235">
                  <c:v>12.869031774835292</c:v>
                </c:pt>
                <c:pt idx="236">
                  <c:v>12.59039431351764</c:v>
                </c:pt>
                <c:pt idx="237">
                  <c:v>12.31322887862631</c:v>
                </c:pt>
                <c:pt idx="238">
                  <c:v>12.037657858614821</c:v>
                </c:pt>
                <c:pt idx="239">
                  <c:v>11.763802937887972</c:v>
                </c:pt>
                <c:pt idx="240">
                  <c:v>11.491785043069424</c:v>
                </c:pt>
                <c:pt idx="241">
                  <c:v>11.221724289603912</c:v>
                </c:pt>
                <c:pt idx="242">
                  <c:v>10.95373992871766</c:v>
                </c:pt>
                <c:pt idx="243">
                  <c:v>10.687950294760341</c:v>
                </c:pt>
                <c:pt idx="244">
                  <c:v>10.424472752952042</c:v>
                </c:pt>
                <c:pt idx="245">
                  <c:v>10.163423647558028</c:v>
                </c:pt>
                <c:pt idx="246">
                  <c:v>9.9049182505144096</c:v>
                </c:pt>
                <c:pt idx="247">
                  <c:v>9.6490707105272957</c:v>
                </c:pt>
                <c:pt idx="248">
                  <c:v>9.395994002667944</c:v>
                </c:pt>
                <c:pt idx="249">
                  <c:v>9.1457998784861445</c:v>
                </c:pt>
                <c:pt idx="250">
                  <c:v>8.898598816663883</c:v>
                </c:pt>
                <c:pt idx="251">
                  <c:v>8.6544999742310686</c:v>
                </c:pt>
                <c:pt idx="252">
                  <c:v>8.4136111383648551</c:v>
                </c:pt>
                <c:pt idx="253">
                  <c:v>8.1760386787938639</c:v>
                </c:pt>
                <c:pt idx="254">
                  <c:v>7.9418875008283027</c:v>
                </c:pt>
                <c:pt idx="255">
                  <c:v>7.7112609990367371</c:v>
                </c:pt>
                <c:pt idx="256">
                  <c:v>7.4842610115899593</c:v>
                </c:pt>
                <c:pt idx="257">
                  <c:v>7.2609877752921115</c:v>
                </c:pt>
                <c:pt idx="258">
                  <c:v>7.0415398813189505</c:v>
                </c:pt>
                <c:pt idx="259">
                  <c:v>6.8260142316827377</c:v>
                </c:pt>
                <c:pt idx="260">
                  <c:v>6.614505996443059</c:v>
                </c:pt>
                <c:pt idx="261">
                  <c:v>6.4071085716824019</c:v>
                </c:pt>
                <c:pt idx="262">
                  <c:v>6.2039135382650592</c:v>
                </c:pt>
                <c:pt idx="263">
                  <c:v>6.0050106213976182</c:v>
                </c:pt>
                <c:pt idx="264">
                  <c:v>5.8104876510088168</c:v>
                </c:pt>
                <c:pt idx="265">
                  <c:v>5.6204305229663394</c:v>
                </c:pt>
                <c:pt idx="266">
                  <c:v>5.4349231611475997</c:v>
                </c:pt>
                <c:pt idx="267">
                  <c:v>5.2540474803813311</c:v>
                </c:pt>
                <c:pt idx="268">
                  <c:v>5.0778833502763039</c:v>
                </c:pt>
                <c:pt idx="269">
                  <c:v>4.9065085599531493</c:v>
                </c:pt>
                <c:pt idx="270">
                  <c:v>4.739998783694876</c:v>
                </c:pt>
                <c:pt idx="271">
                  <c:v>4.5784275475312448</c:v>
                </c:pt>
                <c:pt idx="272">
                  <c:v>4.4218661967717168</c:v>
                </c:pt>
                <c:pt idx="273">
                  <c:v>4.2703838645014116</c:v>
                </c:pt>
                <c:pt idx="274">
                  <c:v>4.1240474410538575</c:v>
                </c:pt>
                <c:pt idx="275">
                  <c:v>3.9829215444741095</c:v>
                </c:pt>
                <c:pt idx="276">
                  <c:v>3.8470684919852456</c:v>
                </c:pt>
                <c:pt idx="277">
                  <c:v>3.7165482724708223</c:v>
                </c:pt>
                <c:pt idx="278">
                  <c:v>3.5914185199854831</c:v>
                </c:pt>
                <c:pt idx="279">
                  <c:v>3.4717344883053798</c:v>
                </c:pt>
                <c:pt idx="280">
                  <c:v>3.3575490265296573</c:v>
                </c:pt>
                <c:pt idx="281">
                  <c:v>3.2489125557437877</c:v>
                </c:pt>
                <c:pt idx="282">
                  <c:v>3.1458730467550247</c:v>
                </c:pt>
                <c:pt idx="283">
                  <c:v>3.0484759989098595</c:v>
                </c:pt>
                <c:pt idx="284">
                  <c:v>2.9567644200027807</c:v>
                </c:pt>
                <c:pt idx="285">
                  <c:v>2.8707788072852498</c:v>
                </c:pt>
                <c:pt idx="286">
                  <c:v>2.7905571295832452</c:v>
                </c:pt>
                <c:pt idx="287">
                  <c:v>2.7161348105313081</c:v>
                </c:pt>
                <c:pt idx="288">
                  <c:v>2.6475447129304612</c:v>
                </c:pt>
                <c:pt idx="289">
                  <c:v>2.5848171242369116</c:v>
                </c:pt>
                <c:pt idx="290">
                  <c:v>2.5279797431879754</c:v>
                </c:pt>
                <c:pt idx="291">
                  <c:v>2.4770576675710867</c:v>
                </c:pt>
                <c:pt idx="292">
                  <c:v>2.4320733831413186</c:v>
                </c:pt>
                <c:pt idx="293">
                  <c:v>2.3930467536923192</c:v>
                </c:pt>
                <c:pt idx="294">
                  <c:v>2.3599950122850082</c:v>
                </c:pt>
                <c:pt idx="295">
                  <c:v>2.3329327536379481</c:v>
                </c:pt>
                <c:pt idx="296">
                  <c:v>2.3118719276827218</c:v>
                </c:pt>
                <c:pt idx="297">
                  <c:v>2.2968218342871847</c:v>
                </c:pt>
                <c:pt idx="298">
                  <c:v>2.2877891191489024</c:v>
                </c:pt>
                <c:pt idx="299">
                  <c:v>2.2847777708606003</c:v>
                </c:pt>
              </c:numCache>
            </c:numRef>
          </c:xVal>
          <c:yVal>
            <c:numRef>
              <c:f>'Covariance   Correlation3'!yycir65</c:f>
              <c:numCache>
                <c:formatCode>General</c:formatCode>
                <c:ptCount val="300"/>
                <c:pt idx="0">
                  <c:v>1.6538428200306807E-3</c:v>
                </c:pt>
                <c:pt idx="1">
                  <c:v>1.5289232757053478E-3</c:v>
                </c:pt>
                <c:pt idx="2">
                  <c:v>1.4040410044852229E-3</c:v>
                </c:pt>
                <c:pt idx="3">
                  <c:v>1.2792511508656981E-3</c:v>
                </c:pt>
                <c:pt idx="4">
                  <c:v>1.1546088185331537E-3</c:v>
                </c:pt>
                <c:pt idx="5">
                  <c:v>1.0301690460327228E-3</c:v>
                </c:pt>
                <c:pt idx="6">
                  <c:v>9.0598678246481886E-4</c:v>
                </c:pt>
                <c:pt idx="7">
                  <c:v>7.8211686322116319E-4</c:v>
                </c:pt>
                <c:pt idx="8">
                  <c:v>6.5861398577100763E-4</c:v>
                </c:pt>
                <c:pt idx="9">
                  <c:v>5.3553268550828904E-4</c:v>
                </c:pt>
                <c:pt idx="10">
                  <c:v>4.1292731167032334E-4</c:v>
                </c:pt>
                <c:pt idx="11">
                  <c:v>2.9085200333871507E-4</c:v>
                </c:pt>
                <c:pt idx="12">
                  <c:v>1.6936066553306347E-4</c:v>
                </c:pt>
                <c:pt idx="13">
                  <c:v>4.8506945408022504E-5</c:v>
                </c:pt>
                <c:pt idx="14">
                  <c:v>-7.1655791435771117E-5</c:v>
                </c:pt>
                <c:pt idx="15">
                  <c:v>-1.9107448451644658E-4</c:v>
                </c:pt>
                <c:pt idx="16">
                  <c:v>-3.0969640190091325E-4</c:v>
                </c:pt>
                <c:pt idx="17">
                  <c:v>-4.2746916348979677E-4</c:v>
                </c:pt>
                <c:pt idx="18">
                  <c:v>-5.443407641470187E-4</c:v>
                </c:pt>
                <c:pt idx="19">
                  <c:v>-6.6025959666379829E-4</c:v>
                </c:pt>
                <c:pt idx="20">
                  <c:v>-7.7517447454694428E-4</c:v>
                </c:pt>
                <c:pt idx="21">
                  <c:v>-8.8903465462136994E-4</c:v>
                </c:pt>
                <c:pt idx="22">
                  <c:v>-1.0017898594368486E-3</c:v>
                </c:pt>
                <c:pt idx="23">
                  <c:v>-1.1133902994691202E-3</c:v>
                </c:pt>
                <c:pt idx="24">
                  <c:v>-1.223786695105552E-3</c:v>
                </c:pt>
                <c:pt idx="25">
                  <c:v>-1.3329302984056144E-3</c:v>
                </c:pt>
                <c:pt idx="26">
                  <c:v>-1.4407729146266068E-3</c:v>
                </c:pt>
                <c:pt idx="27">
                  <c:v>-1.5472669235050999E-3</c:v>
                </c:pt>
                <c:pt idx="28">
                  <c:v>-1.6523653002847027E-3</c:v>
                </c:pt>
                <c:pt idx="29">
                  <c:v>-1.756021636480868E-3</c:v>
                </c:pt>
                <c:pt idx="30">
                  <c:v>-1.8581901603735775E-3</c:v>
                </c:pt>
                <c:pt idx="31">
                  <c:v>-1.9588257572188414E-3</c:v>
                </c:pt>
                <c:pt idx="32">
                  <c:v>-2.0578839891700999E-3</c:v>
                </c:pt>
                <c:pt idx="33">
                  <c:v>-2.1553211149007265E-3</c:v>
                </c:pt>
                <c:pt idx="34">
                  <c:v>-2.2510941089189649E-3</c:v>
                </c:pt>
                <c:pt idx="35">
                  <c:v>-2.3451606805667781E-3</c:v>
                </c:pt>
                <c:pt idx="36">
                  <c:v>-2.4374792926942098E-3</c:v>
                </c:pt>
                <c:pt idx="37">
                  <c:v>-2.5280091800010157E-3</c:v>
                </c:pt>
                <c:pt idx="38">
                  <c:v>-2.6167103670374841E-3</c:v>
                </c:pt>
                <c:pt idx="39">
                  <c:v>-2.703543685856459E-3</c:v>
                </c:pt>
                <c:pt idx="40">
                  <c:v>-2.7884707933088088E-3</c:v>
                </c:pt>
                <c:pt idx="41">
                  <c:v>-2.871454187974676E-3</c:v>
                </c:pt>
                <c:pt idx="42">
                  <c:v>-2.9524572267230569E-3</c:v>
                </c:pt>
                <c:pt idx="43">
                  <c:v>-3.0314441408923654E-3</c:v>
                </c:pt>
                <c:pt idx="44">
                  <c:v>-3.1083800520848798E-3</c:v>
                </c:pt>
                <c:pt idx="45">
                  <c:v>-3.1832309875680503E-3</c:v>
                </c:pt>
                <c:pt idx="46">
                  <c:v>-3.2559638952759087E-3</c:v>
                </c:pt>
                <c:pt idx="47">
                  <c:v>-3.3265466584039235E-3</c:v>
                </c:pt>
                <c:pt idx="48">
                  <c:v>-3.3949481095908855E-3</c:v>
                </c:pt>
                <c:pt idx="49">
                  <c:v>-3.4611380446815296E-3</c:v>
                </c:pt>
                <c:pt idx="50">
                  <c:v>-3.5250872360638422E-3</c:v>
                </c:pt>
                <c:pt idx="51">
                  <c:v>-3.5867674455751517E-3</c:v>
                </c:pt>
                <c:pt idx="52">
                  <c:v>-3.6461514369713079E-3</c:v>
                </c:pt>
                <c:pt idx="53">
                  <c:v>-3.7032129879534361E-3</c:v>
                </c:pt>
                <c:pt idx="54">
                  <c:v>-3.7579269017469713E-3</c:v>
                </c:pt>
                <c:pt idx="55">
                  <c:v>-3.8102690182278427E-3</c:v>
                </c:pt>
                <c:pt idx="56">
                  <c:v>-3.8602162245909037E-3</c:v>
                </c:pt>
                <c:pt idx="57">
                  <c:v>-3.9077464655558935E-3</c:v>
                </c:pt>
                <c:pt idx="58">
                  <c:v>-3.9528387531064342E-3</c:v>
                </c:pt>
                <c:pt idx="59">
                  <c:v>-3.9954731757577437E-3</c:v>
                </c:pt>
                <c:pt idx="60">
                  <c:v>-4.0356309073489851E-3</c:v>
                </c:pt>
                <c:pt idx="61">
                  <c:v>-4.0732942153563758E-3</c:v>
                </c:pt>
                <c:pt idx="62">
                  <c:v>-4.1084464687233648E-3</c:v>
                </c:pt>
                <c:pt idx="63">
                  <c:v>-4.1410721452044413E-3</c:v>
                </c:pt>
                <c:pt idx="64">
                  <c:v>-4.1711568382193217E-3</c:v>
                </c:pt>
                <c:pt idx="65">
                  <c:v>-4.1986872632144897E-3</c:v>
                </c:pt>
                <c:pt idx="66">
                  <c:v>-4.2236512635292793E-3</c:v>
                </c:pt>
                <c:pt idx="67">
                  <c:v>-4.2460378157639176E-3</c:v>
                </c:pt>
                <c:pt idx="68">
                  <c:v>-4.2658370346471451E-3</c:v>
                </c:pt>
                <c:pt idx="69">
                  <c:v>-4.2830401774012735E-3</c:v>
                </c:pt>
                <c:pt idx="70">
                  <c:v>-4.2976396476027499E-3</c:v>
                </c:pt>
                <c:pt idx="71">
                  <c:v>-4.3096289985365263E-3</c:v>
                </c:pt>
                <c:pt idx="72">
                  <c:v>-4.3190029360427457E-3</c:v>
                </c:pt>
                <c:pt idx="73">
                  <c:v>-4.3257573208544901E-3</c:v>
                </c:pt>
                <c:pt idx="74">
                  <c:v>-4.3298891704255703E-3</c:v>
                </c:pt>
                <c:pt idx="75">
                  <c:v>-4.3313966602475332E-3</c:v>
                </c:pt>
                <c:pt idx="76">
                  <c:v>-4.3302791246553115E-3</c:v>
                </c:pt>
                <c:pt idx="77">
                  <c:v>-4.3265370571211612E-3</c:v>
                </c:pt>
                <c:pt idx="78">
                  <c:v>-4.3201721100367624E-3</c:v>
                </c:pt>
                <c:pt idx="79">
                  <c:v>-4.3111870939835685E-3</c:v>
                </c:pt>
                <c:pt idx="80">
                  <c:v>-4.2995859764917285E-3</c:v>
                </c:pt>
                <c:pt idx="81">
                  <c:v>-4.2853738802881413E-3</c:v>
                </c:pt>
                <c:pt idx="82">
                  <c:v>-4.268557081034405E-3</c:v>
                </c:pt>
                <c:pt idx="83">
                  <c:v>-4.2491430045556583E-3</c:v>
                </c:pt>
                <c:pt idx="84">
                  <c:v>-4.2271402235615442E-3</c:v>
                </c:pt>
                <c:pt idx="85">
                  <c:v>-4.2025584538607462E-3</c:v>
                </c:pt>
                <c:pt idx="86">
                  <c:v>-4.17540855007076E-3</c:v>
                </c:pt>
                <c:pt idx="87">
                  <c:v>-4.1457025008247985E-3</c:v>
                </c:pt>
                <c:pt idx="88">
                  <c:v>-4.1134534234779467E-3</c:v>
                </c:pt>
                <c:pt idx="89">
                  <c:v>-4.0786755583149164E-3</c:v>
                </c:pt>
                <c:pt idx="90">
                  <c:v>-4.0413842622619243E-3</c:v>
                </c:pt>
                <c:pt idx="91">
                  <c:v>-4.001596002105515E-3</c:v>
                </c:pt>
                <c:pt idx="92">
                  <c:v>-3.959328347221288E-3</c:v>
                </c:pt>
                <c:pt idx="93">
                  <c:v>-3.9145999618157576E-3</c:v>
                </c:pt>
                <c:pt idx="94">
                  <c:v>-3.8674305966847631E-3</c:v>
                </c:pt>
                <c:pt idx="95">
                  <c:v>-3.8178410804920741E-3</c:v>
                </c:pt>
                <c:pt idx="96">
                  <c:v>-3.7658533105720416E-3</c:v>
                </c:pt>
                <c:pt idx="97">
                  <c:v>-3.7114902432603433E-3</c:v>
                </c:pt>
                <c:pt idx="98">
                  <c:v>-3.6547758837571242E-3</c:v>
                </c:pt>
                <c:pt idx="99">
                  <c:v>-3.5957352755269659E-3</c:v>
                </c:pt>
                <c:pt idx="100">
                  <c:v>-3.5343944892404005E-3</c:v>
                </c:pt>
                <c:pt idx="101">
                  <c:v>-3.4707806112618408E-3</c:v>
                </c:pt>
                <c:pt idx="102">
                  <c:v>-3.4049217316889958E-3</c:v>
                </c:pt>
                <c:pt idx="103">
                  <c:v>-3.3368469319490835E-3</c:v>
                </c:pt>
                <c:pt idx="104">
                  <c:v>-3.266586271957285E-3</c:v>
                </c:pt>
                <c:pt idx="105">
                  <c:v>-3.1941707768431337E-3</c:v>
                </c:pt>
                <c:pt idx="106">
                  <c:v>-3.1196324232506934E-3</c:v>
                </c:pt>
                <c:pt idx="107">
                  <c:v>-3.043004125218571E-3</c:v>
                </c:pt>
                <c:pt idx="108">
                  <c:v>-2.9643197196460008E-3</c:v>
                </c:pt>
                <c:pt idx="109">
                  <c:v>-2.8836139513514275E-3</c:v>
                </c:pt>
                <c:pt idx="110">
                  <c:v>-2.8009224577301706E-3</c:v>
                </c:pt>
                <c:pt idx="111">
                  <c:v>-2.7162817530179532E-3</c:v>
                </c:pt>
                <c:pt idx="112">
                  <c:v>-2.629729212167242E-3</c:v>
                </c:pt>
                <c:pt idx="113">
                  <c:v>-2.541303054343524E-3</c:v>
                </c:pt>
                <c:pt idx="114">
                  <c:v>-2.4510423260487952E-3</c:v>
                </c:pt>
                <c:pt idx="115">
                  <c:v>-2.3589868838797285E-3</c:v>
                </c:pt>
                <c:pt idx="116">
                  <c:v>-2.2651773769281195E-3</c:v>
                </c:pt>
                <c:pt idx="117">
                  <c:v>-2.1696552288313917E-3</c:v>
                </c:pt>
                <c:pt idx="118">
                  <c:v>-2.0724626194810864E-3</c:v>
                </c:pt>
                <c:pt idx="119">
                  <c:v>-1.9736424663974093E-3</c:v>
                </c:pt>
                <c:pt idx="120">
                  <c:v>-1.8732384057780613E-3</c:v>
                </c:pt>
                <c:pt idx="121">
                  <c:v>-1.7712947732297247E-3</c:v>
                </c:pt>
                <c:pt idx="122">
                  <c:v>-1.6678565841906974E-3</c:v>
                </c:pt>
                <c:pt idx="123">
                  <c:v>-1.5629695140533582E-3</c:v>
                </c:pt>
                <c:pt idx="124">
                  <c:v>-1.4566798779951876E-3</c:v>
                </c:pt>
                <c:pt idx="125">
                  <c:v>-1.3490346105272939E-3</c:v>
                </c:pt>
                <c:pt idx="126">
                  <c:v>-1.2400812447694524E-3</c:v>
                </c:pt>
                <c:pt idx="127">
                  <c:v>-1.1298678914608202E-3</c:v>
                </c:pt>
                <c:pt idx="128">
                  <c:v>-1.0184432177155851E-3</c:v>
                </c:pt>
                <c:pt idx="129">
                  <c:v>-9.0585642553294061E-4</c:v>
                </c:pt>
                <c:pt idx="130">
                  <c:v>-7.9215723007086713E-4</c:v>
                </c:pt>
                <c:pt idx="131">
                  <c:v>-6.7739583769331761E-4</c:v>
                </c:pt>
                <c:pt idx="132">
                  <c:v>-5.6162292380050095E-4</c:v>
                </c:pt>
                <c:pt idx="133">
                  <c:v>-4.4488961045205188E-4</c:v>
                </c:pt>
                <c:pt idx="134">
                  <c:v>-3.2724744379296762E-4</c:v>
                </c:pt>
                <c:pt idx="135">
                  <c:v>-2.0874837129228324E-4</c:v>
                </c:pt>
                <c:pt idx="136">
                  <c:v>-8.9444718804532192E-5</c:v>
                </c:pt>
                <c:pt idx="137">
                  <c:v>3.0610832535886822E-5</c:v>
                </c:pt>
                <c:pt idx="138">
                  <c:v>1.513652695772008E-4</c:v>
                </c:pt>
                <c:pt idx="139">
                  <c:v>2.7276527055938876E-4</c:v>
                </c:pt>
                <c:pt idx="140">
                  <c:v>3.9475722865956646E-4</c:v>
                </c:pt>
                <c:pt idx="141">
                  <c:v>5.1728727566325043E-4</c:v>
                </c:pt>
                <c:pt idx="142">
                  <c:v>6.4030130575104581E-4</c:v>
                </c:pt>
                <c:pt idx="143">
                  <c:v>7.6374499939025177E-4</c:v>
                </c:pt>
                <c:pt idx="144">
                  <c:v>8.8756384732083921E-4</c:v>
                </c:pt>
                <c:pt idx="145">
                  <c:v>1.0117031746252048E-3</c:v>
                </c:pt>
                <c:pt idx="146">
                  <c:v>1.1361081648710758E-3</c:v>
                </c:pt>
                <c:pt idx="147">
                  <c:v>1.2607238843169027E-3</c:v>
                </c:pt>
                <c:pt idx="148">
                  <c:v>1.3854953061690541E-3</c:v>
                </c:pt>
                <c:pt idx="149">
                  <c:v>1.510367334880099E-3</c:v>
                </c:pt>
                <c:pt idx="150">
                  <c:v>1.6352848304774471E-3</c:v>
                </c:pt>
                <c:pt idx="151">
                  <c:v>1.760192632911619E-3</c:v>
                </c:pt>
                <c:pt idx="152">
                  <c:v>1.8850355864133549E-3</c:v>
                </c:pt>
                <c:pt idx="153">
                  <c:v>2.0097585638488616E-3</c:v>
                </c:pt>
                <c:pt idx="154">
                  <c:v>2.1343064910623981E-3</c:v>
                </c:pt>
                <c:pt idx="155">
                  <c:v>2.2586243711954744E-3</c:v>
                </c:pt>
                <c:pt idx="156">
                  <c:v>2.3826573089719147E-3</c:v>
                </c:pt>
                <c:pt idx="157">
                  <c:v>2.5063505349380674E-3</c:v>
                </c:pt>
                <c:pt idx="158">
                  <c:v>2.6296494296474513E-3</c:v>
                </c:pt>
                <c:pt idx="159">
                  <c:v>2.7524995477791686E-3</c:v>
                </c:pt>
                <c:pt idx="160">
                  <c:v>2.874846642179425E-3</c:v>
                </c:pt>
                <c:pt idx="161">
                  <c:v>2.9966366878155437E-3</c:v>
                </c:pt>
                <c:pt idx="162">
                  <c:v>3.1178159056319023E-3</c:v>
                </c:pt>
                <c:pt idx="163">
                  <c:v>3.2383307862972463E-3</c:v>
                </c:pt>
                <c:pt idx="164">
                  <c:v>3.3581281138329046E-3</c:v>
                </c:pt>
                <c:pt idx="165">
                  <c:v>3.4771549891114747E-3</c:v>
                </c:pt>
                <c:pt idx="166">
                  <c:v>3.595358853215574E-3</c:v>
                </c:pt>
                <c:pt idx="167">
                  <c:v>3.7126875106463894E-3</c:v>
                </c:pt>
                <c:pt idx="168">
                  <c:v>3.8290891523717358E-3</c:v>
                </c:pt>
                <c:pt idx="169">
                  <c:v>3.9445123787034669E-3</c:v>
                </c:pt>
                <c:pt idx="170">
                  <c:v>4.0589062219941316E-3</c:v>
                </c:pt>
                <c:pt idx="171">
                  <c:v>4.172220169142849E-3</c:v>
                </c:pt>
                <c:pt idx="172">
                  <c:v>4.2844041839004785E-3</c:v>
                </c:pt>
                <c:pt idx="173">
                  <c:v>4.395408728964211E-3</c:v>
                </c:pt>
                <c:pt idx="174">
                  <c:v>4.505184787851853E-3</c:v>
                </c:pt>
                <c:pt idx="175">
                  <c:v>4.613683886546119E-3</c:v>
                </c:pt>
                <c:pt idx="176">
                  <c:v>4.720858114899403E-3</c:v>
                </c:pt>
                <c:pt idx="177">
                  <c:v>4.8266601477895401E-3</c:v>
                </c:pt>
                <c:pt idx="178">
                  <c:v>4.931043266017252E-3</c:v>
                </c:pt>
                <c:pt idx="179">
                  <c:v>5.0339613769360405E-3</c:v>
                </c:pt>
                <c:pt idx="180">
                  <c:v>5.1353690348053841E-3</c:v>
                </c:pt>
                <c:pt idx="181">
                  <c:v>5.235221460858309E-3</c:v>
                </c:pt>
                <c:pt idx="182">
                  <c:v>5.3334745630744312E-3</c:v>
                </c:pt>
                <c:pt idx="183">
                  <c:v>5.4300849556497503E-3</c:v>
                </c:pt>
                <c:pt idx="184">
                  <c:v>5.5250099781545981E-3</c:v>
                </c:pt>
                <c:pt idx="185">
                  <c:v>5.6182077143712844E-3</c:v>
                </c:pt>
                <c:pt idx="186">
                  <c:v>5.7096370108031197E-3</c:v>
                </c:pt>
                <c:pt idx="187">
                  <c:v>5.7992574948466406E-3</c:v>
                </c:pt>
                <c:pt idx="188">
                  <c:v>5.8870295926190105E-3</c:v>
                </c:pt>
                <c:pt idx="189">
                  <c:v>5.9729145464327404E-3</c:v>
                </c:pt>
                <c:pt idx="190">
                  <c:v>6.0568744319099864E-3</c:v>
                </c:pt>
                <c:pt idx="191">
                  <c:v>6.1388721747288877E-3</c:v>
                </c:pt>
                <c:pt idx="192">
                  <c:v>6.2188715669945467E-3</c:v>
                </c:pt>
                <c:pt idx="193">
                  <c:v>6.2968372832274151E-3</c:v>
                </c:pt>
                <c:pt idx="194">
                  <c:v>6.3727348959620282E-3</c:v>
                </c:pt>
                <c:pt idx="195">
                  <c:v>6.4465308909492066E-3</c:v>
                </c:pt>
                <c:pt idx="196">
                  <c:v>6.5181926819550054E-3</c:v>
                </c:pt>
                <c:pt idx="197">
                  <c:v>6.587688625149881E-3</c:v>
                </c:pt>
                <c:pt idx="198">
                  <c:v>6.6549880330817055E-3</c:v>
                </c:pt>
                <c:pt idx="199">
                  <c:v>6.7200611882264954E-3</c:v>
                </c:pt>
                <c:pt idx="200">
                  <c:v>6.7828793561108209E-3</c:v>
                </c:pt>
                <c:pt idx="201">
                  <c:v>6.8434147980001468E-3</c:v>
                </c:pt>
                <c:pt idx="202">
                  <c:v>6.9016407831474806E-3</c:v>
                </c:pt>
                <c:pt idx="203">
                  <c:v>6.9575316005969067E-3</c:v>
                </c:pt>
                <c:pt idx="204">
                  <c:v>7.0110625705368298E-3</c:v>
                </c:pt>
                <c:pt idx="205">
                  <c:v>7.0622100551978855E-3</c:v>
                </c:pt>
                <c:pt idx="206">
                  <c:v>7.110951469290706E-3</c:v>
                </c:pt>
                <c:pt idx="207">
                  <c:v>7.1572652899789544E-3</c:v>
                </c:pt>
                <c:pt idx="208">
                  <c:v>7.2011310663832023E-3</c:v>
                </c:pt>
                <c:pt idx="209">
                  <c:v>7.2425294286114624E-3</c:v>
                </c:pt>
                <c:pt idx="210">
                  <c:v>7.2814420963123868E-3</c:v>
                </c:pt>
                <c:pt idx="211">
                  <c:v>7.317851886747352E-3</c:v>
                </c:pt>
                <c:pt idx="212">
                  <c:v>7.3517427223778829E-3</c:v>
                </c:pt>
                <c:pt idx="213">
                  <c:v>7.3830996379650286E-3</c:v>
                </c:pt>
                <c:pt idx="214">
                  <c:v>7.4119087871776001E-3</c:v>
                </c:pt>
                <c:pt idx="215">
                  <c:v>7.4381574487063151E-3</c:v>
                </c:pt>
                <c:pt idx="216">
                  <c:v>7.4618340318811736E-3</c:v>
                </c:pt>
                <c:pt idx="217">
                  <c:v>7.482928081789568E-3</c:v>
                </c:pt>
                <c:pt idx="218">
                  <c:v>7.5014302838928805E-3</c:v>
                </c:pt>
                <c:pt idx="219">
                  <c:v>7.5173324681395209E-3</c:v>
                </c:pt>
                <c:pt idx="220">
                  <c:v>7.5306276125725897E-3</c:v>
                </c:pt>
                <c:pt idx="221">
                  <c:v>7.5413098464305797E-3</c:v>
                </c:pt>
                <c:pt idx="222">
                  <c:v>7.5493744527397365E-3</c:v>
                </c:pt>
                <c:pt idx="223">
                  <c:v>7.5548178703969404E-3</c:v>
                </c:pt>
                <c:pt idx="224">
                  <c:v>7.5576376957421946E-3</c:v>
                </c:pt>
                <c:pt idx="225">
                  <c:v>7.5578326836200057E-3</c:v>
                </c:pt>
                <c:pt idx="226">
                  <c:v>7.5554027479292187E-3</c:v>
                </c:pt>
                <c:pt idx="227">
                  <c:v>7.5503489616610261E-3</c:v>
                </c:pt>
                <c:pt idx="228">
                  <c:v>7.5426735564251765E-3</c:v>
                </c:pt>
                <c:pt idx="229">
                  <c:v>7.5323799214645493E-3</c:v>
                </c:pt>
                <c:pt idx="230">
                  <c:v>7.5194726021585671E-3</c:v>
                </c:pt>
                <c:pt idx="231">
                  <c:v>7.5039572980160757E-3</c:v>
                </c:pt>
                <c:pt idx="232">
                  <c:v>7.4858408601586159E-3</c:v>
                </c:pt>
                <c:pt idx="233">
                  <c:v>7.4651312882951428E-3</c:v>
                </c:pt>
                <c:pt idx="234">
                  <c:v>7.4418377271895956E-3</c:v>
                </c:pt>
                <c:pt idx="235">
                  <c:v>7.415970462622816E-3</c:v>
                </c:pt>
                <c:pt idx="236">
                  <c:v>7.3875409168506464E-3</c:v>
                </c:pt>
                <c:pt idx="237">
                  <c:v>7.3565616435601715E-3</c:v>
                </c:pt>
                <c:pt idx="238">
                  <c:v>7.3230463223263771E-3</c:v>
                </c:pt>
                <c:pt idx="239">
                  <c:v>7.2870097525716254E-3</c:v>
                </c:pt>
                <c:pt idx="240">
                  <c:v>7.2484678470306468E-3</c:v>
                </c:pt>
                <c:pt idx="241">
                  <c:v>7.2074376247239329E-3</c:v>
                </c:pt>
                <c:pt idx="242">
                  <c:v>7.1639372034426043E-3</c:v>
                </c:pt>
                <c:pt idx="243">
                  <c:v>7.1179857917481109E-3</c:v>
                </c:pt>
                <c:pt idx="244">
                  <c:v>7.0696036804902742E-3</c:v>
                </c:pt>
                <c:pt idx="245">
                  <c:v>7.0188122338474121E-3</c:v>
                </c:pt>
                <c:pt idx="246">
                  <c:v>6.965633879892524E-3</c:v>
                </c:pt>
                <c:pt idx="247">
                  <c:v>6.9100921006896854E-3</c:v>
                </c:pt>
                <c:pt idx="248">
                  <c:v>6.8522114219250283E-3</c:v>
                </c:pt>
                <c:pt idx="249">
                  <c:v>6.7920174020768866E-3</c:v>
                </c:pt>
                <c:pt idx="250">
                  <c:v>6.7295366211298944E-3</c:v>
                </c:pt>
                <c:pt idx="251">
                  <c:v>6.6647966688380125E-3</c:v>
                </c:pt>
                <c:pt idx="252">
                  <c:v>6.5978261325416688E-3</c:v>
                </c:pt>
                <c:pt idx="253">
                  <c:v>6.5286545845443947E-3</c:v>
                </c:pt>
                <c:pt idx="254">
                  <c:v>6.4573125690545264E-3</c:v>
                </c:pt>
                <c:pt idx="255">
                  <c:v>6.3838315886977437E-3</c:v>
                </c:pt>
                <c:pt idx="256">
                  <c:v>6.3082440906064002E-3</c:v>
                </c:pt>
                <c:pt idx="257">
                  <c:v>6.2305834520917777E-3</c:v>
                </c:pt>
                <c:pt idx="258">
                  <c:v>6.1508839659056066E-3</c:v>
                </c:pt>
                <c:pt idx="259">
                  <c:v>6.0691808250973563E-3</c:v>
                </c:pt>
                <c:pt idx="260">
                  <c:v>5.9855101074739693E-3</c:v>
                </c:pt>
                <c:pt idx="261">
                  <c:v>5.8999087596689221E-3</c:v>
                </c:pt>
                <c:pt idx="262">
                  <c:v>5.8124145808276283E-3</c:v>
                </c:pt>
                <c:pt idx="263">
                  <c:v>5.7230662059164026E-3</c:v>
                </c:pt>
                <c:pt idx="264">
                  <c:v>5.6319030886623463E-3</c:v>
                </c:pt>
                <c:pt idx="265">
                  <c:v>5.5389654841316938E-3</c:v>
                </c:pt>
                <c:pt idx="266">
                  <c:v>5.4442944309543041E-3</c:v>
                </c:pt>
                <c:pt idx="267">
                  <c:v>5.3479317332021607E-3</c:v>
                </c:pt>
                <c:pt idx="268">
                  <c:v>5.2499199419298714E-3</c:v>
                </c:pt>
                <c:pt idx="269">
                  <c:v>5.1503023363853187E-3</c:v>
                </c:pt>
                <c:pt idx="270">
                  <c:v>5.0491229048987589E-3</c:v>
                </c:pt>
                <c:pt idx="271">
                  <c:v>4.9464263254588242E-3</c:v>
                </c:pt>
                <c:pt idx="272">
                  <c:v>4.8422579459839596E-3</c:v>
                </c:pt>
                <c:pt idx="273">
                  <c:v>4.7366637642980878E-3</c:v>
                </c:pt>
                <c:pt idx="274">
                  <c:v>4.6296904078192407E-3</c:v>
                </c:pt>
                <c:pt idx="275">
                  <c:v>4.5213851129702193E-3</c:v>
                </c:pt>
                <c:pt idx="276">
                  <c:v>4.4117957043203083E-3</c:v>
                </c:pt>
                <c:pt idx="277">
                  <c:v>4.3009705734673009E-3</c:v>
                </c:pt>
                <c:pt idx="278">
                  <c:v>4.1889586576691271E-3</c:v>
                </c:pt>
                <c:pt idx="279">
                  <c:v>4.0758094182345378E-3</c:v>
                </c:pt>
                <c:pt idx="280">
                  <c:v>3.9615728186823893E-3</c:v>
                </c:pt>
                <c:pt idx="281">
                  <c:v>3.8462993026791483E-3</c:v>
                </c:pt>
                <c:pt idx="282">
                  <c:v>3.7300397717644029E-3</c:v>
                </c:pt>
                <c:pt idx="283">
                  <c:v>3.6128455628741643E-3</c:v>
                </c:pt>
                <c:pt idx="284">
                  <c:v>3.4947684256719275E-3</c:v>
                </c:pt>
                <c:pt idx="285">
                  <c:v>3.3758604996974731E-3</c:v>
                </c:pt>
                <c:pt idx="286">
                  <c:v>3.256174291343518E-3</c:v>
                </c:pt>
                <c:pt idx="287">
                  <c:v>3.1357626506703651E-3</c:v>
                </c:pt>
                <c:pt idx="288">
                  <c:v>3.0146787480688116E-3</c:v>
                </c:pt>
                <c:pt idx="289">
                  <c:v>2.8929760507815944E-3</c:v>
                </c:pt>
                <c:pt idx="290">
                  <c:v>2.7707082992937644E-3</c:v>
                </c:pt>
                <c:pt idx="291">
                  <c:v>2.6479294836024014E-3</c:v>
                </c:pt>
                <c:pt idx="292">
                  <c:v>2.5246938193761504E-3</c:v>
                </c:pt>
                <c:pt idx="293">
                  <c:v>2.4010557240151074E-3</c:v>
                </c:pt>
                <c:pt idx="294">
                  <c:v>2.2770697926216294E-3</c:v>
                </c:pt>
                <c:pt idx="295">
                  <c:v>2.1527907738926742E-3</c:v>
                </c:pt>
                <c:pt idx="296">
                  <c:v>2.0282735459443151E-3</c:v>
                </c:pt>
                <c:pt idx="297">
                  <c:v>1.9035730920791099E-3</c:v>
                </c:pt>
                <c:pt idx="298">
                  <c:v>1.7787444765070255E-3</c:v>
                </c:pt>
                <c:pt idx="299">
                  <c:v>1.6538428200306347E-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940064"/>
        <c:axId val="283938496"/>
      </c:scatterChart>
      <c:valAx>
        <c:axId val="283940064"/>
        <c:scaling>
          <c:orientation val="minMax"/>
          <c:max val="3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938496"/>
        <c:crosses val="autoZero"/>
        <c:crossBetween val="midCat"/>
      </c:valAx>
      <c:valAx>
        <c:axId val="283938496"/>
        <c:scaling>
          <c:orientation val="minMax"/>
          <c:max val="0.01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940064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427868391451067"/>
          <c:y val="0.10679611650485436"/>
          <c:w val="0.60460559617547804"/>
          <c:h val="0.7039966363427872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003CE6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003CE6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DB$1:$DB$15</c:f>
              <c:numCache>
                <c:formatCode>General</c:formatCode>
                <c:ptCount val="15"/>
                <c:pt idx="0">
                  <c:v>138.99886778491901</c:v>
                </c:pt>
                <c:pt idx="1">
                  <c:v>162.91424412457732</c:v>
                </c:pt>
                <c:pt idx="2">
                  <c:v>161.81378103847999</c:v>
                </c:pt>
                <c:pt idx="3">
                  <c:v>71.559135701775006</c:v>
                </c:pt>
                <c:pt idx="4">
                  <c:v>46.166237429095098</c:v>
                </c:pt>
                <c:pt idx="5">
                  <c:v>69.021716759589793</c:v>
                </c:pt>
                <c:pt idx="6">
                  <c:v>89.470748764987405</c:v>
                </c:pt>
                <c:pt idx="7">
                  <c:v>148.91475822535801</c:v>
                </c:pt>
                <c:pt idx="8">
                  <c:v>155.77808522817401</c:v>
                </c:pt>
                <c:pt idx="9">
                  <c:v>200.41766017548801</c:v>
                </c:pt>
                <c:pt idx="10">
                  <c:v>362.51397650410098</c:v>
                </c:pt>
                <c:pt idx="11">
                  <c:v>376.12746722204901</c:v>
                </c:pt>
                <c:pt idx="12">
                  <c:v>172.90809699088169</c:v>
                </c:pt>
                <c:pt idx="13">
                  <c:v>316.49362074445901</c:v>
                </c:pt>
                <c:pt idx="14">
                  <c:v>206.08254805910366</c:v>
                </c:pt>
              </c:numCache>
            </c:numRef>
          </c:xVal>
          <c:yVal>
            <c:numRef>
              <c:f>'Covariance   Correlation3_HID4'!$DC$1:$DC$15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3999999999999998E-3</c:v>
                </c:pt>
                <c:pt idx="6">
                  <c:v>2.3E-3</c:v>
                </c:pt>
                <c:pt idx="7">
                  <c:v>2.8E-3</c:v>
                </c:pt>
                <c:pt idx="8">
                  <c:v>6.0000000000000001E-3</c:v>
                </c:pt>
                <c:pt idx="9">
                  <c:v>4.3E-3</c:v>
                </c:pt>
                <c:pt idx="10">
                  <c:v>3.5999999999999999E-3</c:v>
                </c:pt>
                <c:pt idx="11">
                  <c:v>0</c:v>
                </c:pt>
                <c:pt idx="12">
                  <c:v>1.8E-3</c:v>
                </c:pt>
                <c:pt idx="13">
                  <c:v>0</c:v>
                </c:pt>
                <c:pt idx="14">
                  <c:v>0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66</c:f>
              <c:numCache>
                <c:formatCode>General</c:formatCode>
                <c:ptCount val="300"/>
                <c:pt idx="0">
                  <c:v>-123.56687113635698</c:v>
                </c:pt>
                <c:pt idx="1">
                  <c:v>-123.50015428104538</c:v>
                </c:pt>
                <c:pt idx="2">
                  <c:v>-123.30003317539578</c:v>
                </c:pt>
                <c:pt idx="3">
                  <c:v>-122.96659618725485</c:v>
                </c:pt>
                <c:pt idx="4">
                  <c:v>-122.49999055300984</c:v>
                </c:pt>
                <c:pt idx="5">
                  <c:v>-121.90042231257334</c:v>
                </c:pt>
                <c:pt idx="6">
                  <c:v>-121.16815621840189</c:v>
                </c:pt>
                <c:pt idx="7">
                  <c:v>-120.30351561858848</c:v>
                </c:pt>
                <c:pt idx="8">
                  <c:v>-119.30688231408132</c:v>
                </c:pt>
                <c:pt idx="9">
                  <c:v>-118.1786963900914</c:v>
                </c:pt>
                <c:pt idx="10">
                  <c:v>-116.91945602176295</c:v>
                </c:pt>
                <c:pt idx="11">
                  <c:v>-115.52971725419357</c:v>
                </c:pt>
                <c:pt idx="12">
                  <c:v>-114.01009375690032</c:v>
                </c:pt>
                <c:pt idx="13">
                  <c:v>-112.36125655284044</c:v>
                </c:pt>
                <c:pt idx="14">
                  <c:v>-110.58393372210654</c:v>
                </c:pt>
                <c:pt idx="15">
                  <c:v>-108.67891008042702</c:v>
                </c:pt>
                <c:pt idx="16">
                  <c:v>-106.64702683261348</c:v>
                </c:pt>
                <c:pt idx="17">
                  <c:v>-104.48918120110827</c:v>
                </c:pt>
                <c:pt idx="18">
                  <c:v>-102.20632602979637</c:v>
                </c:pt>
                <c:pt idx="19">
                  <c:v>-99.79946936325652</c:v>
                </c:pt>
                <c:pt idx="20">
                  <c:v>-97.269674001636901</c:v>
                </c:pt>
                <c:pt idx="21">
                  <c:v>-94.618057031352492</c:v>
                </c:pt>
                <c:pt idx="22">
                  <c:v>-91.845789331811289</c:v>
                </c:pt>
                <c:pt idx="23">
                  <c:v>-88.954095058387026</c:v>
                </c:pt>
                <c:pt idx="24">
                  <c:v>-85.944251101866229</c:v>
                </c:pt>
                <c:pt idx="25">
                  <c:v>-82.817586524609482</c:v>
                </c:pt>
                <c:pt idx="26">
                  <c:v>-79.575481973674954</c:v>
                </c:pt>
                <c:pt idx="27">
                  <c:v>-76.219369071163385</c:v>
                </c:pt>
                <c:pt idx="28">
                  <c:v>-72.750729782054037</c:v>
                </c:pt>
                <c:pt idx="29">
                  <c:v>-69.171095759810896</c:v>
                </c:pt>
                <c:pt idx="30">
                  <c:v>-65.48204767004728</c:v>
                </c:pt>
                <c:pt idx="31">
                  <c:v>-61.68521449254871</c:v>
                </c:pt>
                <c:pt idx="32">
                  <c:v>-57.782272801961199</c:v>
                </c:pt>
                <c:pt idx="33">
                  <c:v>-53.77494602746296</c:v>
                </c:pt>
                <c:pt idx="34">
                  <c:v>-49.665003691746875</c:v>
                </c:pt>
                <c:pt idx="35">
                  <c:v>-45.454260629648616</c:v>
                </c:pt>
                <c:pt idx="36">
                  <c:v>-41.144576186767267</c:v>
                </c:pt>
                <c:pt idx="37">
                  <c:v>-36.737853398430161</c:v>
                </c:pt>
                <c:pt idx="38">
                  <c:v>-32.236038149366379</c:v>
                </c:pt>
                <c:pt idx="39">
                  <c:v>-27.641118314458623</c:v>
                </c:pt>
                <c:pt idx="40">
                  <c:v>-22.955122880953724</c:v>
                </c:pt>
                <c:pt idx="41">
                  <c:v>-18.180121052518928</c:v>
                </c:pt>
                <c:pt idx="42">
                  <c:v>-13.318221335539931</c:v>
                </c:pt>
                <c:pt idx="43">
                  <c:v>-8.3715706080636494</c:v>
                </c:pt>
                <c:pt idx="44">
                  <c:v>-3.3423531717974129</c:v>
                </c:pt>
                <c:pt idx="45">
                  <c:v>1.7672102124170692</c:v>
                </c:pt>
                <c:pt idx="46">
                  <c:v>6.9548633052295088</c:v>
                </c:pt>
                <c:pt idx="47">
                  <c:v>12.218315385072486</c:v>
                </c:pt>
                <c:pt idx="48">
                  <c:v>17.555242259679773</c:v>
                </c:pt>
                <c:pt idx="49">
                  <c:v>22.963287292384166</c:v>
                </c:pt>
                <c:pt idx="50">
                  <c:v>28.440062442741834</c:v>
                </c:pt>
                <c:pt idx="51">
                  <c:v>33.983149321024001</c:v>
                </c:pt>
                <c:pt idx="52">
                  <c:v>39.590100256109423</c:v>
                </c:pt>
                <c:pt idx="53">
                  <c:v>45.258439376307308</c:v>
                </c:pt>
                <c:pt idx="54">
                  <c:v>50.985663702632266</c:v>
                </c:pt>
                <c:pt idx="55">
                  <c:v>56.769244254050008</c:v>
                </c:pt>
                <c:pt idx="56">
                  <c:v>62.60662716420336</c:v>
                </c:pt>
                <c:pt idx="57">
                  <c:v>68.495234809128235</c:v>
                </c:pt>
                <c:pt idx="58">
                  <c:v>74.432466945459666</c:v>
                </c:pt>
                <c:pt idx="59">
                  <c:v>80.415701858626193</c:v>
                </c:pt>
                <c:pt idx="60">
                  <c:v>86.442297520525074</c:v>
                </c:pt>
                <c:pt idx="61">
                  <c:v>92.509592756167564</c:v>
                </c:pt>
                <c:pt idx="62">
                  <c:v>98.614908418779038</c:v>
                </c:pt>
                <c:pt idx="63">
                  <c:v>104.75554857283451</c:v>
                </c:pt>
                <c:pt idx="64">
                  <c:v>110.928801684508</c:v>
                </c:pt>
                <c:pt idx="65">
                  <c:v>117.13194181900957</c:v>
                </c:pt>
                <c:pt idx="66">
                  <c:v>123.36222984428134</c:v>
                </c:pt>
                <c:pt idx="67">
                  <c:v>129.61691464052112</c:v>
                </c:pt>
                <c:pt idx="68">
                  <c:v>135.8932343149994</c:v>
                </c:pt>
                <c:pt idx="69">
                  <c:v>142.18841742163363</c:v>
                </c:pt>
                <c:pt idx="70">
                  <c:v>148.49968418478056</c:v>
                </c:pt>
                <c:pt idx="71">
                  <c:v>154.82424772670691</c:v>
                </c:pt>
                <c:pt idx="72">
                  <c:v>161.15931529819639</c:v>
                </c:pt>
                <c:pt idx="73">
                  <c:v>167.50208951174881</c:v>
                </c:pt>
                <c:pt idx="74">
                  <c:v>173.84976957682784</c:v>
                </c:pt>
                <c:pt idx="75">
                  <c:v>180.19955253661115</c:v>
                </c:pt>
                <c:pt idx="76">
                  <c:v>186.54863450569758</c:v>
                </c:pt>
                <c:pt idx="77">
                  <c:v>192.89421190822341</c:v>
                </c:pt>
                <c:pt idx="78">
                  <c:v>199.23348271584302</c:v>
                </c:pt>
                <c:pt idx="79">
                  <c:v>205.5636476850255</c:v>
                </c:pt>
                <c:pt idx="80">
                  <c:v>211.88191159312186</c:v>
                </c:pt>
                <c:pt idx="81">
                  <c:v>218.1854844726567</c:v>
                </c:pt>
                <c:pt idx="82">
                  <c:v>224.47158284329919</c:v>
                </c:pt>
                <c:pt idx="83">
                  <c:v>230.73743094096983</c:v>
                </c:pt>
                <c:pt idx="84">
                  <c:v>236.98026194353946</c:v>
                </c:pt>
                <c:pt idx="85">
                  <c:v>243.19731919258021</c:v>
                </c:pt>
                <c:pt idx="86">
                  <c:v>249.38585741062826</c:v>
                </c:pt>
                <c:pt idx="87">
                  <c:v>255.54314391342089</c:v>
                </c:pt>
                <c:pt idx="88">
                  <c:v>261.66645981657325</c:v>
                </c:pt>
                <c:pt idx="89">
                  <c:v>267.75310123616072</c:v>
                </c:pt>
                <c:pt idx="90">
                  <c:v>273.80038048267863</c:v>
                </c:pt>
                <c:pt idx="91">
                  <c:v>279.80562724784932</c:v>
                </c:pt>
                <c:pt idx="92">
                  <c:v>285.76618978375609</c:v>
                </c:pt>
                <c:pt idx="93">
                  <c:v>291.67943607377964</c:v>
                </c:pt>
                <c:pt idx="94">
                  <c:v>297.54275499482299</c:v>
                </c:pt>
                <c:pt idx="95">
                  <c:v>303.3535574703098</c:v>
                </c:pt>
                <c:pt idx="96">
                  <c:v>309.1092776134476</c:v>
                </c:pt>
                <c:pt idx="97">
                  <c:v>314.80737386025135</c:v>
                </c:pt>
                <c:pt idx="98">
                  <c:v>320.44533009182652</c:v>
                </c:pt>
                <c:pt idx="99">
                  <c:v>326.02065674541609</c:v>
                </c:pt>
                <c:pt idx="100">
                  <c:v>331.53089191372169</c:v>
                </c:pt>
                <c:pt idx="101">
                  <c:v>336.97360243201246</c:v>
                </c:pt>
                <c:pt idx="102">
                  <c:v>342.34638495254205</c:v>
                </c:pt>
                <c:pt idx="103">
                  <c:v>347.64686700579949</c:v>
                </c:pt>
                <c:pt idx="104">
                  <c:v>352.87270804812465</c:v>
                </c:pt>
                <c:pt idx="105">
                  <c:v>358.02160049522661</c:v>
                </c:pt>
                <c:pt idx="106">
                  <c:v>363.09127074114804</c:v>
                </c:pt>
                <c:pt idx="107">
                  <c:v>368.07948016222531</c:v>
                </c:pt>
                <c:pt idx="108">
                  <c:v>372.98402610560208</c:v>
                </c:pt>
                <c:pt idx="109">
                  <c:v>377.80274286185818</c:v>
                </c:pt>
                <c:pt idx="110">
                  <c:v>382.53350262132653</c:v>
                </c:pt>
                <c:pt idx="111">
                  <c:v>387.17421641367366</c:v>
                </c:pt>
                <c:pt idx="112">
                  <c:v>391.72283503033037</c:v>
                </c:pt>
                <c:pt idx="113">
                  <c:v>396.17734992936425</c:v>
                </c:pt>
                <c:pt idx="114">
                  <c:v>400.53579412239571</c:v>
                </c:pt>
                <c:pt idx="115">
                  <c:v>404.79624304316422</c:v>
                </c:pt>
                <c:pt idx="116">
                  <c:v>408.95681539736302</c:v>
                </c:pt>
                <c:pt idx="117">
                  <c:v>413.01567399336523</c:v>
                </c:pt>
                <c:pt idx="118">
                  <c:v>416.97102655347658</c:v>
                </c:pt>
                <c:pt idx="119">
                  <c:v>420.82112650535407</c:v>
                </c:pt>
                <c:pt idx="120">
                  <c:v>424.56427375324381</c:v>
                </c:pt>
                <c:pt idx="121">
                  <c:v>428.19881542869484</c:v>
                </c:pt>
                <c:pt idx="122">
                  <c:v>431.7231466204201</c:v>
                </c:pt>
                <c:pt idx="123">
                  <c:v>435.13571108297913</c:v>
                </c:pt>
                <c:pt idx="124">
                  <c:v>438.43500192397278</c:v>
                </c:pt>
                <c:pt idx="125">
                  <c:v>441.61956226944471</c:v>
                </c:pt>
                <c:pt idx="126">
                  <c:v>444.6879859071953</c:v>
                </c:pt>
                <c:pt idx="127">
                  <c:v>447.63891790772573</c:v>
                </c:pt>
                <c:pt idx="128">
                  <c:v>450.47105522253673</c:v>
                </c:pt>
                <c:pt idx="129">
                  <c:v>453.18314725951791</c:v>
                </c:pt>
                <c:pt idx="130">
                  <c:v>455.77399643517435</c:v>
                </c:pt>
                <c:pt idx="131">
                  <c:v>458.24245870344544</c:v>
                </c:pt>
                <c:pt idx="132">
                  <c:v>460.58744406088363</c:v>
                </c:pt>
                <c:pt idx="133">
                  <c:v>462.80791702796898</c:v>
                </c:pt>
                <c:pt idx="134">
                  <c:v>464.90289710634818</c:v>
                </c:pt>
                <c:pt idx="135">
                  <c:v>466.87145921179456</c:v>
                </c:pt>
                <c:pt idx="136">
                  <c:v>468.71273408269985</c:v>
                </c:pt>
                <c:pt idx="137">
                  <c:v>470.42590866391492</c:v>
                </c:pt>
                <c:pt idx="138">
                  <c:v>472.01022646577258</c:v>
                </c:pt>
                <c:pt idx="139">
                  <c:v>473.46498789813199</c:v>
                </c:pt>
                <c:pt idx="140">
                  <c:v>474.78955057929772</c:v>
                </c:pt>
                <c:pt idx="141">
                  <c:v>475.98332961967765</c:v>
                </c:pt>
                <c:pt idx="142">
                  <c:v>477.04579788005401</c:v>
                </c:pt>
                <c:pt idx="143">
                  <c:v>477.97648620435257</c:v>
                </c:pt>
                <c:pt idx="144">
                  <c:v>478.77498362680922</c:v>
                </c:pt>
                <c:pt idx="145">
                  <c:v>479.44093755344102</c:v>
                </c:pt>
                <c:pt idx="146">
                  <c:v>479.97405391774112</c:v>
                </c:pt>
                <c:pt idx="147">
                  <c:v>480.37409731053106</c:v>
                </c:pt>
                <c:pt idx="148">
                  <c:v>480.64089108391022</c:v>
                </c:pt>
                <c:pt idx="149">
                  <c:v>480.77431742925876</c:v>
                </c:pt>
                <c:pt idx="150">
                  <c:v>480.77431742925864</c:v>
                </c:pt>
                <c:pt idx="151">
                  <c:v>480.64089108391011</c:v>
                </c:pt>
                <c:pt idx="152">
                  <c:v>480.37409731053083</c:v>
                </c:pt>
                <c:pt idx="153">
                  <c:v>479.97405391774078</c:v>
                </c:pt>
                <c:pt idx="154">
                  <c:v>479.44093755344056</c:v>
                </c:pt>
                <c:pt idx="155">
                  <c:v>478.77498362680876</c:v>
                </c:pt>
                <c:pt idx="156">
                  <c:v>477.97648620435189</c:v>
                </c:pt>
                <c:pt idx="157">
                  <c:v>477.04579788005321</c:v>
                </c:pt>
                <c:pt idx="158">
                  <c:v>475.98332961967685</c:v>
                </c:pt>
                <c:pt idx="159">
                  <c:v>474.78955057929682</c:v>
                </c:pt>
                <c:pt idx="160">
                  <c:v>473.46498789813097</c:v>
                </c:pt>
                <c:pt idx="161">
                  <c:v>472.01022646577155</c:v>
                </c:pt>
                <c:pt idx="162">
                  <c:v>470.42590866391379</c:v>
                </c:pt>
                <c:pt idx="163">
                  <c:v>468.7127340826986</c:v>
                </c:pt>
                <c:pt idx="164">
                  <c:v>466.87145921179331</c:v>
                </c:pt>
                <c:pt idx="165">
                  <c:v>464.9028971063467</c:v>
                </c:pt>
                <c:pt idx="166">
                  <c:v>462.80791702796751</c:v>
                </c:pt>
                <c:pt idx="167">
                  <c:v>460.58744406088204</c:v>
                </c:pt>
                <c:pt idx="168">
                  <c:v>458.24245870344384</c:v>
                </c:pt>
                <c:pt idx="169">
                  <c:v>455.77399643517265</c:v>
                </c:pt>
                <c:pt idx="170">
                  <c:v>453.18314725951609</c:v>
                </c:pt>
                <c:pt idx="171">
                  <c:v>450.4710552225348</c:v>
                </c:pt>
                <c:pt idx="172">
                  <c:v>447.63891790772368</c:v>
                </c:pt>
                <c:pt idx="173">
                  <c:v>444.68798590719314</c:v>
                </c:pt>
                <c:pt idx="174">
                  <c:v>441.61956226944255</c:v>
                </c:pt>
                <c:pt idx="175">
                  <c:v>438.43500192397062</c:v>
                </c:pt>
                <c:pt idx="176">
                  <c:v>435.13571108297674</c:v>
                </c:pt>
                <c:pt idx="177">
                  <c:v>431.72314662041765</c:v>
                </c:pt>
                <c:pt idx="178">
                  <c:v>428.19881542869246</c:v>
                </c:pt>
                <c:pt idx="179">
                  <c:v>424.5642737532412</c:v>
                </c:pt>
                <c:pt idx="180">
                  <c:v>420.8211265053514</c:v>
                </c:pt>
                <c:pt idx="181">
                  <c:v>416.97102655347385</c:v>
                </c:pt>
                <c:pt idx="182">
                  <c:v>413.0156739933625</c:v>
                </c:pt>
                <c:pt idx="183">
                  <c:v>408.95681539736017</c:v>
                </c:pt>
                <c:pt idx="184">
                  <c:v>404.79624304316133</c:v>
                </c:pt>
                <c:pt idx="185">
                  <c:v>400.5357941223927</c:v>
                </c:pt>
                <c:pt idx="186">
                  <c:v>396.17734992936118</c:v>
                </c:pt>
                <c:pt idx="187">
                  <c:v>391.72283503032725</c:v>
                </c:pt>
                <c:pt idx="188">
                  <c:v>387.17421641367048</c:v>
                </c:pt>
                <c:pt idx="189">
                  <c:v>382.53350262132324</c:v>
                </c:pt>
                <c:pt idx="190">
                  <c:v>377.80274286185482</c:v>
                </c:pt>
                <c:pt idx="191">
                  <c:v>372.98402610559879</c:v>
                </c:pt>
                <c:pt idx="192">
                  <c:v>368.07948016222196</c:v>
                </c:pt>
                <c:pt idx="193">
                  <c:v>363.09127074114451</c:v>
                </c:pt>
                <c:pt idx="194">
                  <c:v>358.02160049522308</c:v>
                </c:pt>
                <c:pt idx="195">
                  <c:v>352.87270804812101</c:v>
                </c:pt>
                <c:pt idx="196">
                  <c:v>347.6468670057958</c:v>
                </c:pt>
                <c:pt idx="197">
                  <c:v>342.34638495253836</c:v>
                </c:pt>
                <c:pt idx="198">
                  <c:v>336.9736024320087</c:v>
                </c:pt>
                <c:pt idx="199">
                  <c:v>331.53089191371788</c:v>
                </c:pt>
                <c:pt idx="200">
                  <c:v>326.02065674541223</c:v>
                </c:pt>
                <c:pt idx="201">
                  <c:v>320.4453300918226</c:v>
                </c:pt>
                <c:pt idx="202">
                  <c:v>314.80737386024748</c:v>
                </c:pt>
                <c:pt idx="203">
                  <c:v>309.10927761344362</c:v>
                </c:pt>
                <c:pt idx="204">
                  <c:v>303.3535574703057</c:v>
                </c:pt>
                <c:pt idx="205">
                  <c:v>297.54275499481884</c:v>
                </c:pt>
                <c:pt idx="206">
                  <c:v>291.67943607377543</c:v>
                </c:pt>
                <c:pt idx="207">
                  <c:v>285.76618978375188</c:v>
                </c:pt>
                <c:pt idx="208">
                  <c:v>279.80562724784511</c:v>
                </c:pt>
                <c:pt idx="209">
                  <c:v>273.80038048267431</c:v>
                </c:pt>
                <c:pt idx="210">
                  <c:v>267.75310123615645</c:v>
                </c:pt>
                <c:pt idx="211">
                  <c:v>261.66645981656882</c:v>
                </c:pt>
                <c:pt idx="212">
                  <c:v>255.54314391341649</c:v>
                </c:pt>
                <c:pt idx="213">
                  <c:v>249.38585741062383</c:v>
                </c:pt>
                <c:pt idx="214">
                  <c:v>243.197319192576</c:v>
                </c:pt>
                <c:pt idx="215">
                  <c:v>236.98026194353525</c:v>
                </c:pt>
                <c:pt idx="216">
                  <c:v>230.7374309409656</c:v>
                </c:pt>
                <c:pt idx="217">
                  <c:v>224.47158284329493</c:v>
                </c:pt>
                <c:pt idx="218">
                  <c:v>218.18548447265238</c:v>
                </c:pt>
                <c:pt idx="219">
                  <c:v>211.88191159311754</c:v>
                </c:pt>
                <c:pt idx="220">
                  <c:v>205.56364768502115</c:v>
                </c:pt>
                <c:pt idx="221">
                  <c:v>199.23348271583868</c:v>
                </c:pt>
                <c:pt idx="222">
                  <c:v>192.89421190821906</c:v>
                </c:pt>
                <c:pt idx="223">
                  <c:v>186.54863450569323</c:v>
                </c:pt>
                <c:pt idx="224">
                  <c:v>180.1995525366068</c:v>
                </c:pt>
                <c:pt idx="225">
                  <c:v>173.84976957682341</c:v>
                </c:pt>
                <c:pt idx="226">
                  <c:v>167.50208951174437</c:v>
                </c:pt>
                <c:pt idx="227">
                  <c:v>161.15931529819198</c:v>
                </c:pt>
                <c:pt idx="228">
                  <c:v>154.82424772670251</c:v>
                </c:pt>
                <c:pt idx="229">
                  <c:v>148.49968418477613</c:v>
                </c:pt>
                <c:pt idx="230">
                  <c:v>142.18841742162925</c:v>
                </c:pt>
                <c:pt idx="231">
                  <c:v>135.893234314995</c:v>
                </c:pt>
                <c:pt idx="232">
                  <c:v>129.61691464051668</c:v>
                </c:pt>
                <c:pt idx="233">
                  <c:v>123.36222984427692</c:v>
                </c:pt>
                <c:pt idx="234">
                  <c:v>117.13194181900518</c:v>
                </c:pt>
                <c:pt idx="235">
                  <c:v>110.92880168450363</c:v>
                </c:pt>
                <c:pt idx="236">
                  <c:v>104.75554857283016</c:v>
                </c:pt>
                <c:pt idx="237">
                  <c:v>98.614908418774718</c:v>
                </c:pt>
                <c:pt idx="238">
                  <c:v>92.509592756163258</c:v>
                </c:pt>
                <c:pt idx="239">
                  <c:v>86.442297520520739</c:v>
                </c:pt>
                <c:pt idx="240">
                  <c:v>80.415701858621873</c:v>
                </c:pt>
                <c:pt idx="241">
                  <c:v>74.432466945455374</c:v>
                </c:pt>
                <c:pt idx="242">
                  <c:v>68.495234809124227</c:v>
                </c:pt>
                <c:pt idx="243">
                  <c:v>62.606627164199409</c:v>
                </c:pt>
                <c:pt idx="244">
                  <c:v>56.769244254046086</c:v>
                </c:pt>
                <c:pt idx="245">
                  <c:v>50.985663702628372</c:v>
                </c:pt>
                <c:pt idx="246">
                  <c:v>45.258439376303329</c:v>
                </c:pt>
                <c:pt idx="247">
                  <c:v>39.590100256105501</c:v>
                </c:pt>
                <c:pt idx="248">
                  <c:v>33.983149321020107</c:v>
                </c:pt>
                <c:pt idx="249">
                  <c:v>28.440062442737997</c:v>
                </c:pt>
                <c:pt idx="250">
                  <c:v>22.963287292380329</c:v>
                </c:pt>
                <c:pt idx="251">
                  <c:v>17.555242259676021</c:v>
                </c:pt>
                <c:pt idx="252">
                  <c:v>12.218315385068792</c:v>
                </c:pt>
                <c:pt idx="253">
                  <c:v>6.9548633052258992</c:v>
                </c:pt>
                <c:pt idx="254">
                  <c:v>1.7672102124134881</c:v>
                </c:pt>
                <c:pt idx="255">
                  <c:v>-3.3423531718009656</c:v>
                </c:pt>
                <c:pt idx="256">
                  <c:v>-8.3715706080671168</c:v>
                </c:pt>
                <c:pt idx="257">
                  <c:v>-13.318221335543342</c:v>
                </c:pt>
                <c:pt idx="258">
                  <c:v>-18.180121052522281</c:v>
                </c:pt>
                <c:pt idx="259">
                  <c:v>-22.95512288095702</c:v>
                </c:pt>
                <c:pt idx="260">
                  <c:v>-27.641118314461892</c:v>
                </c:pt>
                <c:pt idx="261">
                  <c:v>-32.236038149369563</c:v>
                </c:pt>
                <c:pt idx="262">
                  <c:v>-36.737853398433288</c:v>
                </c:pt>
                <c:pt idx="263">
                  <c:v>-41.14457618677028</c:v>
                </c:pt>
                <c:pt idx="264">
                  <c:v>-45.4542606296516</c:v>
                </c:pt>
                <c:pt idx="265">
                  <c:v>-49.665003691749803</c:v>
                </c:pt>
                <c:pt idx="266">
                  <c:v>-53.774946027465887</c:v>
                </c:pt>
                <c:pt idx="267">
                  <c:v>-57.782272801964041</c:v>
                </c:pt>
                <c:pt idx="268">
                  <c:v>-61.685214492551495</c:v>
                </c:pt>
                <c:pt idx="269">
                  <c:v>-65.48204767004998</c:v>
                </c:pt>
                <c:pt idx="270">
                  <c:v>-69.171095759813483</c:v>
                </c:pt>
                <c:pt idx="271">
                  <c:v>-72.750729782056425</c:v>
                </c:pt>
                <c:pt idx="272">
                  <c:v>-76.219369071165659</c:v>
                </c:pt>
                <c:pt idx="273">
                  <c:v>-79.575481973677171</c:v>
                </c:pt>
                <c:pt idx="274">
                  <c:v>-82.817586524611642</c:v>
                </c:pt>
                <c:pt idx="275">
                  <c:v>-85.944251101868332</c:v>
                </c:pt>
                <c:pt idx="276">
                  <c:v>-88.954095058389072</c:v>
                </c:pt>
                <c:pt idx="277">
                  <c:v>-91.845789331813279</c:v>
                </c:pt>
                <c:pt idx="278">
                  <c:v>-94.618057031354368</c:v>
                </c:pt>
                <c:pt idx="279">
                  <c:v>-97.26967400163872</c:v>
                </c:pt>
                <c:pt idx="280">
                  <c:v>-99.799469363258282</c:v>
                </c:pt>
                <c:pt idx="281">
                  <c:v>-102.20632602979802</c:v>
                </c:pt>
                <c:pt idx="282">
                  <c:v>-104.4891812011098</c:v>
                </c:pt>
                <c:pt idx="283">
                  <c:v>-106.64702683261496</c:v>
                </c:pt>
                <c:pt idx="284">
                  <c:v>-108.67891008042838</c:v>
                </c:pt>
                <c:pt idx="285">
                  <c:v>-110.58393372210779</c:v>
                </c:pt>
                <c:pt idx="286">
                  <c:v>-112.36125655284158</c:v>
                </c:pt>
                <c:pt idx="287">
                  <c:v>-114.01009375690145</c:v>
                </c:pt>
                <c:pt idx="288">
                  <c:v>-115.52971725419459</c:v>
                </c:pt>
                <c:pt idx="289">
                  <c:v>-116.91945602176386</c:v>
                </c:pt>
                <c:pt idx="290">
                  <c:v>-118.1786963900922</c:v>
                </c:pt>
                <c:pt idx="291">
                  <c:v>-119.30688231408206</c:v>
                </c:pt>
                <c:pt idx="292">
                  <c:v>-120.3035156185891</c:v>
                </c:pt>
                <c:pt idx="293">
                  <c:v>-121.16815621840246</c:v>
                </c:pt>
                <c:pt idx="294">
                  <c:v>-121.90042231257385</c:v>
                </c:pt>
                <c:pt idx="295">
                  <c:v>-122.49999055301018</c:v>
                </c:pt>
                <c:pt idx="296">
                  <c:v>-122.96659618725513</c:v>
                </c:pt>
                <c:pt idx="297">
                  <c:v>-123.30003317539595</c:v>
                </c:pt>
                <c:pt idx="298">
                  <c:v>-123.5001542810455</c:v>
                </c:pt>
                <c:pt idx="299">
                  <c:v>-123.56687113635698</c:v>
                </c:pt>
              </c:numCache>
            </c:numRef>
          </c:xVal>
          <c:yVal>
            <c:numRef>
              <c:f>'Covariance   Correlation3'!yycir67</c:f>
              <c:numCache>
                <c:formatCode>General</c:formatCode>
                <c:ptCount val="300"/>
                <c:pt idx="0">
                  <c:v>1.7217877169353807E-3</c:v>
                </c:pt>
                <c:pt idx="1">
                  <c:v>1.5968710606202262E-3</c:v>
                </c:pt>
                <c:pt idx="2">
                  <c:v>1.4719616735812699E-3</c:v>
                </c:pt>
                <c:pt idx="3">
                  <c:v>1.3471147122874852E-3</c:v>
                </c:pt>
                <c:pt idx="4">
                  <c:v>1.2223853056423945E-3</c:v>
                </c:pt>
                <c:pt idx="5">
                  <c:v>1.0978285306406958E-3</c:v>
                </c:pt>
                <c:pt idx="6">
                  <c:v>9.7349938804781367E-4</c:v>
                </c:pt>
                <c:pt idx="7">
                  <c:v>8.4945277811311159E-4</c:v>
                </c:pt>
                <c:pt idx="8">
                  <c:v>7.2574347632747686E-4</c:v>
                </c:pt>
                <c:pt idx="9">
                  <c:v>6.0242610923602114E-4</c:v>
                </c:pt>
                <c:pt idx="10">
                  <c:v>4.7955513031652742E-4</c:v>
                </c:pt>
                <c:pt idx="11">
                  <c:v>3.5718479593432661E-4</c:v>
                </c:pt>
                <c:pt idx="12">
                  <c:v>2.3536914138421635E-4</c:v>
                </c:pt>
                <c:pt idx="13">
                  <c:v>1.1416195702999546E-4</c:v>
                </c:pt>
                <c:pt idx="14">
                  <c:v>-6.3832354478463694E-6</c:v>
                </c:pt>
                <c:pt idx="15">
                  <c:v>-1.2621320668579719E-4</c:v>
                </c:pt>
                <c:pt idx="16">
                  <c:v>-2.4527504314190919E-4</c:v>
                </c:pt>
                <c:pt idx="17">
                  <c:v>-3.6351617046093094E-4</c:v>
                </c:pt>
                <c:pt idx="18">
                  <c:v>-4.8088437668966253E-4</c:v>
                </c:pt>
                <c:pt idx="19">
                  <c:v>-5.9732783533228266E-4</c:v>
                </c:pt>
                <c:pt idx="20">
                  <c:v>-7.1279512823547173E-4</c:v>
                </c:pt>
                <c:pt idx="21">
                  <c:v>-8.2723526829322157E-4</c:v>
                </c:pt>
                <c:pt idx="22">
                  <c:v>-9.4059772196130329E-4</c:v>
                </c:pt>
                <c:pt idx="23">
                  <c:v>-1.0528324315714579E-3</c:v>
                </c:pt>
                <c:pt idx="24">
                  <c:v>-1.1638898374354628E-3</c:v>
                </c:pt>
                <c:pt idx="25">
                  <c:v>-1.2737208997292797E-3</c:v>
                </c:pt>
                <c:pt idx="26">
                  <c:v>-1.3822771201476697E-3</c:v>
                </c:pt>
                <c:pt idx="27">
                  <c:v>-1.4895105633196788E-3</c:v>
                </c:pt>
                <c:pt idx="28">
                  <c:v>-1.5953738779755477E-3</c:v>
                </c:pt>
                <c:pt idx="29">
                  <c:v>-1.6998203178556961E-3</c:v>
                </c:pt>
                <c:pt idx="30">
                  <c:v>-1.8028037623525623E-3</c:v>
                </c:pt>
                <c:pt idx="31">
                  <c:v>-1.9042787368761579E-3</c:v>
                </c:pt>
                <c:pt idx="32">
                  <c:v>-2.0042004329343709E-3</c:v>
                </c:pt>
                <c:pt idx="33">
                  <c:v>-2.1025247279191314E-3</c:v>
                </c:pt>
                <c:pt idx="34">
                  <c:v>-2.1992082045897161E-3</c:v>
                </c:pt>
                <c:pt idx="35">
                  <c:v>-2.2942081702445791E-3</c:v>
                </c:pt>
                <c:pt idx="36">
                  <c:v>-2.3874826755732464E-3</c:v>
                </c:pt>
                <c:pt idx="37">
                  <c:v>-2.4789905331799485E-3</c:v>
                </c:pt>
                <c:pt idx="38">
                  <c:v>-2.5686913357708162E-3</c:v>
                </c:pt>
                <c:pt idx="39">
                  <c:v>-2.6565454739966073E-3</c:v>
                </c:pt>
                <c:pt idx="40">
                  <c:v>-2.7425141539430776E-3</c:v>
                </c:pt>
                <c:pt idx="41">
                  <c:v>-2.8265594142612765E-3</c:v>
                </c:pt>
                <c:pt idx="42">
                  <c:v>-2.9086441429302212E-3</c:v>
                </c:pt>
                <c:pt idx="43">
                  <c:v>-2.9887320936445088E-3</c:v>
                </c:pt>
                <c:pt idx="44">
                  <c:v>-3.0667879018196728E-3</c:v>
                </c:pt>
                <c:pt idx="45">
                  <c:v>-3.1427771002081831E-3</c:v>
                </c:pt>
                <c:pt idx="46">
                  <c:v>-3.2166661341192161E-3</c:v>
                </c:pt>
                <c:pt idx="47">
                  <c:v>-3.288422376235456E-3</c:v>
                </c:pt>
                <c:pt idx="48">
                  <c:v>-3.3580141410204049E-3</c:v>
                </c:pt>
                <c:pt idx="49">
                  <c:v>-3.4254106987098242E-3</c:v>
                </c:pt>
                <c:pt idx="50">
                  <c:v>-3.4905822888811264E-3</c:v>
                </c:pt>
                <c:pt idx="51">
                  <c:v>-3.5535001335947488E-3</c:v>
                </c:pt>
                <c:pt idx="52">
                  <c:v>-3.6141364501016734E-3</c:v>
                </c:pt>
                <c:pt idx="53">
                  <c:v>-3.6724644631115147E-3</c:v>
                </c:pt>
                <c:pt idx="54">
                  <c:v>-3.7284584166157263E-3</c:v>
                </c:pt>
                <c:pt idx="55">
                  <c:v>-3.7820935852607364E-3</c:v>
                </c:pt>
                <c:pt idx="56">
                  <c:v>-3.8333462852659633E-3</c:v>
                </c:pt>
                <c:pt idx="57">
                  <c:v>-3.882193884881906E-3</c:v>
                </c:pt>
                <c:pt idx="58">
                  <c:v>-3.9286148143836902E-3</c:v>
                </c:pt>
                <c:pt idx="59">
                  <c:v>-3.972588575595651E-3</c:v>
                </c:pt>
                <c:pt idx="60">
                  <c:v>-4.0140957509427477E-3</c:v>
                </c:pt>
                <c:pt idx="61">
                  <c:v>-4.0531180120248244E-3</c:v>
                </c:pt>
                <c:pt idx="62">
                  <c:v>-4.0896381277099048E-3</c:v>
                </c:pt>
                <c:pt idx="63">
                  <c:v>-4.12363997174299E-3</c:v>
                </c:pt>
                <c:pt idx="64">
                  <c:v>-4.155108529866944E-3</c:v>
                </c:pt>
                <c:pt idx="65">
                  <c:v>-4.1840299064523738E-3</c:v>
                </c:pt>
                <c:pt idx="66">
                  <c:v>-4.2103913306335517E-3</c:v>
                </c:pt>
                <c:pt idx="67">
                  <c:v>-4.2341811619476628E-3</c:v>
                </c:pt>
                <c:pt idx="68">
                  <c:v>-4.2553888954749092E-3</c:v>
                </c:pt>
                <c:pt idx="69">
                  <c:v>-4.2740051664771879E-3</c:v>
                </c:pt>
                <c:pt idx="70">
                  <c:v>-4.2900217545332932E-3</c:v>
                </c:pt>
                <c:pt idx="71">
                  <c:v>-4.3034315871688248E-3</c:v>
                </c:pt>
                <c:pt idx="72">
                  <c:v>-4.3142287429791962E-3</c:v>
                </c:pt>
                <c:pt idx="73">
                  <c:v>-4.3224084542443485E-3</c:v>
                </c:pt>
                <c:pt idx="74">
                  <c:v>-4.327967109034059E-3</c:v>
                </c:pt>
                <c:pt idx="75">
                  <c:v>-4.3309022528028544E-3</c:v>
                </c:pt>
                <c:pt idx="76">
                  <c:v>-4.3312125894738734E-3</c:v>
                </c:pt>
                <c:pt idx="77">
                  <c:v>-4.3288979820111789E-3</c:v>
                </c:pt>
                <c:pt idx="78">
                  <c:v>-4.3239594524802681E-3</c:v>
                </c:pt>
                <c:pt idx="79">
                  <c:v>-4.3163991815967544E-3</c:v>
                </c:pt>
                <c:pt idx="80">
                  <c:v>-4.3062205077634324E-3</c:v>
                </c:pt>
                <c:pt idx="81">
                  <c:v>-4.2934279255961248E-3</c:v>
                </c:pt>
                <c:pt idx="82">
                  <c:v>-4.2780270839389888E-3</c:v>
                </c:pt>
                <c:pt idx="83">
                  <c:v>-4.2600247833701511E-3</c:v>
                </c:pt>
                <c:pt idx="84">
                  <c:v>-4.2394289731987568E-3</c:v>
                </c:pt>
                <c:pt idx="85">
                  <c:v>-4.2162487479547811E-3</c:v>
                </c:pt>
                <c:pt idx="86">
                  <c:v>-4.1904943433731445E-3</c:v>
                </c:pt>
                <c:pt idx="87">
                  <c:v>-4.1621771318738898E-3</c:v>
                </c:pt>
                <c:pt idx="88">
                  <c:v>-4.1313096175404559E-3</c:v>
                </c:pt>
                <c:pt idx="89">
                  <c:v>-4.0979054305982157E-3</c:v>
                </c:pt>
                <c:pt idx="90">
                  <c:v>-4.0619793213957584E-3</c:v>
                </c:pt>
                <c:pt idx="91">
                  <c:v>-4.0235471538915425E-3</c:v>
                </c:pt>
                <c:pt idx="92">
                  <c:v>-3.9826258986488316E-3</c:v>
                </c:pt>
                <c:pt idx="93">
                  <c:v>-3.93923362534196E-3</c:v>
                </c:pt>
                <c:pt idx="94">
                  <c:v>-3.893389494777277E-3</c:v>
                </c:pt>
                <c:pt idx="95">
                  <c:v>-3.8451137504322743E-3</c:v>
                </c:pt>
                <c:pt idx="96">
                  <c:v>-3.7944277095166398E-3</c:v>
                </c:pt>
                <c:pt idx="97">
                  <c:v>-3.7413537535591684E-3</c:v>
                </c:pt>
                <c:pt idx="98">
                  <c:v>-3.6859153185247193E-3</c:v>
                </c:pt>
                <c:pt idx="99">
                  <c:v>-3.6281368844655487E-3</c:v>
                </c:pt>
                <c:pt idx="100">
                  <c:v>-3.5680439647116069E-3</c:v>
                </c:pt>
                <c:pt idx="101">
                  <c:v>-3.5056630946045729E-3</c:v>
                </c:pt>
                <c:pt idx="102">
                  <c:v>-3.4410218197805922E-3</c:v>
                </c:pt>
                <c:pt idx="103">
                  <c:v>-3.3741486840069023E-3</c:v>
                </c:pt>
                <c:pt idx="104">
                  <c:v>-3.3050732165777036E-3</c:v>
                </c:pt>
                <c:pt idx="105">
                  <c:v>-3.2338259192748599E-3</c:v>
                </c:pt>
                <c:pt idx="106">
                  <c:v>-3.1604382528991675E-3</c:v>
                </c:pt>
                <c:pt idx="107">
                  <c:v>-3.0849426233781514E-3</c:v>
                </c:pt>
                <c:pt idx="108">
                  <c:v>-3.0073723674565169E-3</c:v>
                </c:pt>
                <c:pt idx="109">
                  <c:v>-2.9277617379755874E-3</c:v>
                </c:pt>
                <c:pt idx="110">
                  <c:v>-2.8461458887482126E-3</c:v>
                </c:pt>
                <c:pt idx="111">
                  <c:v>-2.7625608590358302E-3</c:v>
                </c:pt>
                <c:pt idx="112">
                  <c:v>-2.6770435576345475E-3</c:v>
                </c:pt>
                <c:pt idx="113">
                  <c:v>-2.5896317465772521E-3</c:v>
                </c:pt>
                <c:pt idx="114">
                  <c:v>-2.5003640244589645E-3</c:v>
                </c:pt>
                <c:pt idx="115">
                  <c:v>-2.409279809392784E-3</c:v>
                </c:pt>
                <c:pt idx="116">
                  <c:v>-2.3164193216039567E-3</c:v>
                </c:pt>
                <c:pt idx="117">
                  <c:v>-2.2218235656697618E-3</c:v>
                </c:pt>
                <c:pt idx="118">
                  <c:v>-2.1255343124130404E-3</c:v>
                </c:pt>
                <c:pt idx="119">
                  <c:v>-2.0275940804573775E-3</c:v>
                </c:pt>
                <c:pt idx="120">
                  <c:v>-1.9280461174520751E-3</c:v>
                </c:pt>
                <c:pt idx="121">
                  <c:v>-1.826934380975209E-3</c:v>
                </c:pt>
                <c:pt idx="122">
                  <c:v>-1.7243035191231899E-3</c:v>
                </c:pt>
                <c:pt idx="123">
                  <c:v>-1.6201988507954397E-3</c:v>
                </c:pt>
                <c:pt idx="124">
                  <c:v>-1.5146663456828235E-3</c:v>
                </c:pt>
                <c:pt idx="125">
                  <c:v>-1.4077526039687398E-3</c:v>
                </c:pt>
                <c:pt idx="126">
                  <c:v>-1.2995048357517835E-3</c:v>
                </c:pt>
                <c:pt idx="127">
                  <c:v>-1.1899708401991004E-3</c:v>
                </c:pt>
                <c:pt idx="128">
                  <c:v>-1.079198984439619E-3</c:v>
                </c:pt>
                <c:pt idx="129">
                  <c:v>-9.67238182206488E-4</c:v>
                </c:pt>
                <c:pt idx="130">
                  <c:v>-8.541378722381472E-4</c:v>
                </c:pt>
                <c:pt idx="131">
                  <c:v>-7.3994799644757606E-4</c:v>
                </c:pt>
                <c:pt idx="132">
                  <c:v>-6.2471897786934671E-4</c:v>
                </c:pt>
                <c:pt idx="133">
                  <c:v>-5.0850169839423477E-4</c:v>
                </c:pt>
                <c:pt idx="134">
                  <c:v>-3.9134747630120568E-4</c:v>
                </c:pt>
                <c:pt idx="135">
                  <c:v>-2.7330804359671033E-4</c:v>
                </c:pt>
                <c:pt idx="136">
                  <c:v>-1.5443552317128773E-4</c:v>
                </c:pt>
                <c:pt idx="137">
                  <c:v>-3.4782405783554592E-5</c:v>
                </c:pt>
                <c:pt idx="138">
                  <c:v>8.5598473118220453E-5</c:v>
                </c:pt>
                <c:pt idx="139">
                  <c:v>2.0665395672677509E-4</c:v>
                </c:pt>
                <c:pt idx="140">
                  <c:v>3.283305903483982E-4</c:v>
                </c:pt>
                <c:pt idx="141">
                  <c:v>4.5057464500701999E-4</c:v>
                </c:pt>
                <c:pt idx="142">
                  <c:v>5.7333214116941347E-4</c:v>
                </c:pt>
                <c:pt idx="143">
                  <c:v>6.9654887258103798E-4</c:v>
                </c:pt>
                <c:pt idx="144">
                  <c:v>8.2017043020199474E-4</c:v>
                </c:pt>
                <c:pt idx="145">
                  <c:v>9.441422262325271E-4</c:v>
                </c:pt>
                <c:pt idx="146">
                  <c:v>1.068409518217457E-3</c:v>
                </c:pt>
                <c:pt idx="147">
                  <c:v>1.1929174332189103E-3</c:v>
                </c:pt>
                <c:pt idx="148">
                  <c:v>1.3176109920466634E-3</c:v>
                </c:pt>
                <c:pt idx="149">
                  <c:v>1.4424351335354049E-3</c:v>
                </c:pt>
                <c:pt idx="150">
                  <c:v>1.5673347388581939E-3</c:v>
                </c:pt>
                <c:pt idx="151">
                  <c:v>1.6922546558653926E-3</c:v>
                </c:pt>
                <c:pt idx="152">
                  <c:v>1.8171397234382869E-3</c:v>
                </c:pt>
                <c:pt idx="153">
                  <c:v>1.9419347958466949E-3</c:v>
                </c:pt>
                <c:pt idx="154">
                  <c:v>2.0665847670997659E-3</c:v>
                </c:pt>
                <c:pt idx="155">
                  <c:v>2.191034595279234E-3</c:v>
                </c:pt>
                <c:pt idx="156">
                  <c:v>2.3152293268443812E-3</c:v>
                </c:pt>
                <c:pt idx="157">
                  <c:v>2.4391141208979727E-3</c:v>
                </c:pt>
                <c:pt idx="158">
                  <c:v>2.5626342734024537E-3</c:v>
                </c:pt>
                <c:pt idx="159">
                  <c:v>2.6857352413357121E-3</c:v>
                </c:pt>
                <c:pt idx="160">
                  <c:v>2.8083626667757423E-3</c:v>
                </c:pt>
                <c:pt idx="161">
                  <c:v>2.9304624009035738E-3</c:v>
                </c:pt>
                <c:pt idx="162">
                  <c:v>3.0519805279138625E-3</c:v>
                </c:pt>
                <c:pt idx="163">
                  <c:v>3.1728633888225962E-3</c:v>
                </c:pt>
                <c:pt idx="164">
                  <c:v>3.2930576051613861E-3</c:v>
                </c:pt>
                <c:pt idx="165">
                  <c:v>3.4125101025479073E-3</c:v>
                </c:pt>
                <c:pt idx="166">
                  <c:v>3.5311681341220372E-3</c:v>
                </c:pt>
                <c:pt idx="167">
                  <c:v>3.6489793038373916E-3</c:v>
                </c:pt>
                <c:pt idx="168">
                  <c:v>3.7658915895979451E-3</c:v>
                </c:pt>
                <c:pt idx="169">
                  <c:v>3.8818533662295191E-3</c:v>
                </c:pt>
                <c:pt idx="170">
                  <c:v>3.996813428276012E-3</c:v>
                </c:pt>
                <c:pt idx="171">
                  <c:v>4.1107210126102821E-3</c:v>
                </c:pt>
                <c:pt idx="172">
                  <c:v>4.223525820849716E-3</c:v>
                </c:pt>
                <c:pt idx="173">
                  <c:v>4.3351780415665812E-3</c:v>
                </c:pt>
                <c:pt idx="174">
                  <c:v>4.4456283722833457E-3</c:v>
                </c:pt>
                <c:pt idx="175">
                  <c:v>4.5548280412432687E-3</c:v>
                </c:pt>
                <c:pt idx="176">
                  <c:v>4.6627288289466358E-3</c:v>
                </c:pt>
                <c:pt idx="177">
                  <c:v>4.7692830894431257E-3</c:v>
                </c:pt>
                <c:pt idx="178">
                  <c:v>4.8744437713709272E-3</c:v>
                </c:pt>
                <c:pt idx="179">
                  <c:v>4.9781644387332999E-3</c:v>
                </c:pt>
                <c:pt idx="180">
                  <c:v>5.0803992914033903E-3</c:v>
                </c:pt>
                <c:pt idx="181">
                  <c:v>5.1811031853482873E-3</c:v>
                </c:pt>
                <c:pt idx="182">
                  <c:v>5.2802316525633547E-3</c:v>
                </c:pt>
                <c:pt idx="183">
                  <c:v>5.3777409207080504E-3</c:v>
                </c:pt>
                <c:pt idx="184">
                  <c:v>5.4735879324345621E-3</c:v>
                </c:pt>
                <c:pt idx="185">
                  <c:v>5.5677303644007118E-3</c:v>
                </c:pt>
                <c:pt idx="186">
                  <c:v>5.6601266459587627E-3</c:v>
                </c:pt>
                <c:pt idx="187">
                  <c:v>5.7507359775118396E-3</c:v>
                </c:pt>
                <c:pt idx="188">
                  <c:v>5.8395183485298848E-3</c:v>
                </c:pt>
                <c:pt idx="189">
                  <c:v>5.9264345552171842E-3</c:v>
                </c:pt>
                <c:pt idx="190">
                  <c:v>6.0114462178236551E-3</c:v>
                </c:pt>
                <c:pt idx="191">
                  <c:v>6.0945157975922639E-3</c:v>
                </c:pt>
                <c:pt idx="192">
                  <c:v>6.1756066133350929E-3</c:v>
                </c:pt>
                <c:pt idx="193">
                  <c:v>6.2546828576307079E-3</c:v>
                </c:pt>
                <c:pt idx="194">
                  <c:v>6.3317096126357161E-3</c:v>
                </c:pt>
                <c:pt idx="195">
                  <c:v>6.4066528655034975E-3</c:v>
                </c:pt>
                <c:pt idx="196">
                  <c:v>6.4794795234033248E-3</c:v>
                </c:pt>
                <c:pt idx="197">
                  <c:v>6.5501574281332242E-3</c:v>
                </c:pt>
                <c:pt idx="198">
                  <c:v>6.6186553703201298E-3</c:v>
                </c:pt>
                <c:pt idx="199">
                  <c:v>6.6849431032010688E-3</c:v>
                </c:pt>
                <c:pt idx="200">
                  <c:v>6.7489913559792766E-3</c:v>
                </c:pt>
                <c:pt idx="201">
                  <c:v>6.8107718467493583E-3</c:v>
                </c:pt>
                <c:pt idx="202">
                  <c:v>6.8702572949857817E-3</c:v>
                </c:pt>
                <c:pt idx="203">
                  <c:v>6.9274214335891884E-3</c:v>
                </c:pt>
                <c:pt idx="204">
                  <c:v>6.9822390204852093E-3</c:v>
                </c:pt>
                <c:pt idx="205">
                  <c:v>7.0346858497706468E-3</c:v>
                </c:pt>
                <c:pt idx="206">
                  <c:v>7.0847387624021286E-3</c:v>
                </c:pt>
                <c:pt idx="207">
                  <c:v>7.1323756564224822E-3</c:v>
                </c:pt>
                <c:pt idx="208">
                  <c:v>7.1775754967203431E-3</c:v>
                </c:pt>
                <c:pt idx="209">
                  <c:v>7.2203183243186621E-3</c:v>
                </c:pt>
                <c:pt idx="210">
                  <c:v>7.2605852651880338E-3</c:v>
                </c:pt>
                <c:pt idx="211">
                  <c:v>7.2983585385809268E-3</c:v>
                </c:pt>
                <c:pt idx="212">
                  <c:v>7.3336214648831747E-3</c:v>
                </c:pt>
                <c:pt idx="213">
                  <c:v>7.3663584729792139E-3</c:v>
                </c:pt>
                <c:pt idx="214">
                  <c:v>7.3965551071278526E-3</c:v>
                </c:pt>
                <c:pt idx="215">
                  <c:v>7.4241980333455224E-3</c:v>
                </c:pt>
                <c:pt idx="216">
                  <c:v>7.4492750452941842E-3</c:v>
                </c:pt>
                <c:pt idx="217">
                  <c:v>7.4717750696713095E-3</c:v>
                </c:pt>
                <c:pt idx="218">
                  <c:v>7.4916881710995345E-3</c:v>
                </c:pt>
                <c:pt idx="219">
                  <c:v>7.5090055565138446E-3</c:v>
                </c:pt>
                <c:pt idx="220">
                  <c:v>7.5237195790443454E-3</c:v>
                </c:pt>
                <c:pt idx="221">
                  <c:v>7.5358237413929042E-3</c:v>
                </c:pt>
                <c:pt idx="222">
                  <c:v>7.5453126987021736E-3</c:v>
                </c:pt>
                <c:pt idx="223">
                  <c:v>7.5521822609157302E-3</c:v>
                </c:pt>
                <c:pt idx="224">
                  <c:v>7.5564293946282892E-3</c:v>
                </c:pt>
                <c:pt idx="225">
                  <c:v>7.5580522244251616E-3</c:v>
                </c:pt>
                <c:pt idx="226">
                  <c:v>7.5570500337103965E-3</c:v>
                </c:pt>
                <c:pt idx="227">
                  <c:v>7.5534232650231979E-3</c:v>
                </c:pt>
                <c:pt idx="228">
                  <c:v>7.547173519842524E-3</c:v>
                </c:pt>
                <c:pt idx="229">
                  <c:v>7.5383035578799051E-3</c:v>
                </c:pt>
                <c:pt idx="230">
                  <c:v>7.526817295860847E-3</c:v>
                </c:pt>
                <c:pt idx="231">
                  <c:v>7.5127198057953039E-3</c:v>
                </c:pt>
                <c:pt idx="232">
                  <c:v>7.4960173127380297E-3</c:v>
                </c:pt>
                <c:pt idx="233">
                  <c:v>7.4767171920397642E-3</c:v>
                </c:pt>
                <c:pt idx="234">
                  <c:v>7.4548279660904852E-3</c:v>
                </c:pt>
                <c:pt idx="235">
                  <c:v>7.4303593005561677E-3</c:v>
                </c:pt>
                <c:pt idx="236">
                  <c:v>7.4033220001106887E-3</c:v>
                </c:pt>
                <c:pt idx="237">
                  <c:v>7.3737280036647946E-3</c:v>
                </c:pt>
                <c:pt idx="238">
                  <c:v>7.3415903790942103E-3</c:v>
                </c:pt>
                <c:pt idx="239">
                  <c:v>7.3069233174692374E-3</c:v>
                </c:pt>
                <c:pt idx="240">
                  <c:v>7.269742126788368E-3</c:v>
                </c:pt>
                <c:pt idx="241">
                  <c:v>7.2300632252187171E-3</c:v>
                </c:pt>
                <c:pt idx="242">
                  <c:v>7.1879041338462103E-3</c:v>
                </c:pt>
                <c:pt idx="243">
                  <c:v>7.14328346893877E-3</c:v>
                </c:pt>
                <c:pt idx="244">
                  <c:v>7.0962209337258955E-3</c:v>
                </c:pt>
                <c:pt idx="245">
                  <c:v>7.0467373096982739E-3</c:v>
                </c:pt>
                <c:pt idx="246">
                  <c:v>6.9948544474312544E-3</c:v>
                </c:pt>
                <c:pt idx="247">
                  <c:v>6.9405952569362517E-3</c:v>
                </c:pt>
                <c:pt idx="248">
                  <c:v>6.8839836975443311E-3</c:v>
                </c:pt>
                <c:pt idx="249">
                  <c:v>6.8250447673264374E-3</c:v>
                </c:pt>
                <c:pt idx="250">
                  <c:v>6.7638044920549575E-3</c:v>
                </c:pt>
                <c:pt idx="251">
                  <c:v>6.7002899137114684E-3</c:v>
                </c:pt>
                <c:pt idx="252">
                  <c:v>6.634529078545756E-3</c:v>
                </c:pt>
                <c:pt idx="253">
                  <c:v>6.5665510246913882E-3</c:v>
                </c:pt>
                <c:pt idx="254">
                  <c:v>6.4963857693432856E-3</c:v>
                </c:pt>
                <c:pt idx="255">
                  <c:v>6.4240642955029773E-3</c:v>
                </c:pt>
                <c:pt idx="256">
                  <c:v>6.3496185382973785E-3</c:v>
                </c:pt>
                <c:pt idx="257">
                  <c:v>6.2730813708771396E-3</c:v>
                </c:pt>
                <c:pt idx="258">
                  <c:v>6.1944865899007818E-3</c:v>
                </c:pt>
                <c:pt idx="259">
                  <c:v>6.1138689006110516E-3</c:v>
                </c:pt>
                <c:pt idx="260">
                  <c:v>6.0312639015100587E-3</c:v>
                </c:pt>
                <c:pt idx="261">
                  <c:v>5.9467080686399811E-3</c:v>
                </c:pt>
                <c:pt idx="262">
                  <c:v>5.8602387394762695E-3</c:v>
                </c:pt>
                <c:pt idx="263">
                  <c:v>5.7718940964404733E-3</c:v>
                </c:pt>
                <c:pt idx="264">
                  <c:v>5.6817131500399515E-3</c:v>
                </c:pt>
                <c:pt idx="265">
                  <c:v>5.5897357216419391E-3</c:v>
                </c:pt>
                <c:pt idx="266">
                  <c:v>5.4960024258895457E-3</c:v>
                </c:pt>
                <c:pt idx="267">
                  <c:v>5.4005546527674747E-3</c:v>
                </c:pt>
                <c:pt idx="268">
                  <c:v>5.3034345493253744E-3</c:v>
                </c:pt>
                <c:pt idx="269">
                  <c:v>5.2046850010668807E-3</c:v>
                </c:pt>
                <c:pt idx="270">
                  <c:v>5.1043496130125923E-3</c:v>
                </c:pt>
                <c:pt idx="271">
                  <c:v>5.0024726904453207E-3</c:v>
                </c:pt>
                <c:pt idx="272">
                  <c:v>4.8990992193461104E-3</c:v>
                </c:pt>
                <c:pt idx="273">
                  <c:v>4.7942748465297233E-3</c:v>
                </c:pt>
                <c:pt idx="274">
                  <c:v>4.6880458594882671E-3</c:v>
                </c:pt>
                <c:pt idx="275">
                  <c:v>4.5804591659519504E-3</c:v>
                </c:pt>
                <c:pt idx="276">
                  <c:v>4.4715622731759516E-3</c:v>
                </c:pt>
                <c:pt idx="277">
                  <c:v>4.3614032669625465E-3</c:v>
                </c:pt>
                <c:pt idx="278">
                  <c:v>4.2500307904277772E-3</c:v>
                </c:pt>
                <c:pt idx="279">
                  <c:v>4.1374940225220183E-3</c:v>
                </c:pt>
                <c:pt idx="280">
                  <c:v>4.0238426563139361E-3</c:v>
                </c:pt>
                <c:pt idx="281">
                  <c:v>3.9091268770474344E-3</c:v>
                </c:pt>
                <c:pt idx="282">
                  <c:v>3.7933973399812537E-3</c:v>
                </c:pt>
                <c:pt idx="283">
                  <c:v>3.6767051480210444E-3</c:v>
                </c:pt>
                <c:pt idx="284">
                  <c:v>3.5591018291537563E-3</c:v>
                </c:pt>
                <c:pt idx="285">
                  <c:v>3.4406393136943323E-3</c:v>
                </c:pt>
                <c:pt idx="286">
                  <c:v>3.3213699113547445E-3</c:v>
                </c:pt>
                <c:pt idx="287">
                  <c:v>3.2013462881454943E-3</c:v>
                </c:pt>
                <c:pt idx="288">
                  <c:v>3.0806214431197878E-3</c:v>
                </c:pt>
                <c:pt idx="289">
                  <c:v>2.9592486849706464E-3</c:v>
                </c:pt>
                <c:pt idx="290">
                  <c:v>2.8372816084912852E-3</c:v>
                </c:pt>
                <c:pt idx="291">
                  <c:v>2.7147740709091649E-3</c:v>
                </c:pt>
                <c:pt idx="292">
                  <c:v>2.5917801681041536E-3</c:v>
                </c:pt>
                <c:pt idx="293">
                  <c:v>2.4683542107213101E-3</c:v>
                </c:pt>
                <c:pt idx="294">
                  <c:v>2.3445507001888313E-3</c:v>
                </c:pt>
                <c:pt idx="295">
                  <c:v>2.220424304651759E-3</c:v>
                </c:pt>
                <c:pt idx="296">
                  <c:v>2.0960298348320608E-3</c:v>
                </c:pt>
                <c:pt idx="297">
                  <c:v>1.9714222198257613E-3</c:v>
                </c:pt>
                <c:pt idx="298">
                  <c:v>1.8466564828478009E-3</c:v>
                </c:pt>
                <c:pt idx="299">
                  <c:v>1.7217877169353347E-3</c:v>
                </c:pt>
              </c:numCache>
            </c:numRef>
          </c:yVal>
          <c:smooth val="0"/>
        </c:ser>
        <c:ser>
          <c:idx val="2"/>
          <c:order val="2"/>
          <c:spPr>
            <a:ln w="19050">
              <a:noFill/>
            </a:ln>
          </c:spPr>
          <c:marker>
            <c:symbol val="none"/>
          </c:marker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944768"/>
        <c:axId val="283937712"/>
      </c:scatterChart>
      <c:valAx>
        <c:axId val="283944768"/>
        <c:scaling>
          <c:orientation val="minMax"/>
          <c:max val="4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937712"/>
        <c:crosses val="autoZero"/>
        <c:crossBetween val="midCat"/>
      </c:valAx>
      <c:valAx>
        <c:axId val="283937712"/>
        <c:scaling>
          <c:orientation val="minMax"/>
          <c:max val="0.01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944768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03089036947306"/>
          <c:y val="0.15250000000000002"/>
          <c:w val="0.6520752574197457"/>
          <c:h val="0.71158333333333323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003CE6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003CE6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M$1:$M$15</c:f>
              <c:numCache>
                <c:formatCode>General</c:formatCode>
                <c:ptCount val="15"/>
                <c:pt idx="0">
                  <c:v>0.109</c:v>
                </c:pt>
                <c:pt idx="1">
                  <c:v>0</c:v>
                </c:pt>
                <c:pt idx="2">
                  <c:v>0.59</c:v>
                </c:pt>
                <c:pt idx="3">
                  <c:v>0.85</c:v>
                </c:pt>
                <c:pt idx="4">
                  <c:v>0.5</c:v>
                </c:pt>
                <c:pt idx="5">
                  <c:v>219.19880000000001</c:v>
                </c:pt>
                <c:pt idx="6">
                  <c:v>124.09350000000001</c:v>
                </c:pt>
                <c:pt idx="7">
                  <c:v>170.1447</c:v>
                </c:pt>
                <c:pt idx="8">
                  <c:v>102.8198</c:v>
                </c:pt>
                <c:pt idx="9">
                  <c:v>133.8227</c:v>
                </c:pt>
                <c:pt idx="10">
                  <c:v>78.404910000000001</c:v>
                </c:pt>
                <c:pt idx="11">
                  <c:v>56.57591</c:v>
                </c:pt>
                <c:pt idx="12">
                  <c:v>113.7139</c:v>
                </c:pt>
                <c:pt idx="13">
                  <c:v>92.474109999999996</c:v>
                </c:pt>
                <c:pt idx="14">
                  <c:v>81.813429999999997</c:v>
                </c:pt>
              </c:numCache>
            </c:numRef>
          </c:xVal>
          <c:yVal>
            <c:numRef>
              <c:f>'Covariance   Correlation3_HID4'!$N$1:$N$15</c:f>
              <c:numCache>
                <c:formatCode>General</c:formatCode>
                <c:ptCount val="15"/>
                <c:pt idx="0">
                  <c:v>1.0531999999999999</c:v>
                </c:pt>
                <c:pt idx="1">
                  <c:v>1.6315999999999999</c:v>
                </c:pt>
                <c:pt idx="2">
                  <c:v>1.4011</c:v>
                </c:pt>
                <c:pt idx="3">
                  <c:v>5.6500000000000002E-2</c:v>
                </c:pt>
                <c:pt idx="4">
                  <c:v>0.2228999999999999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E-3</c:v>
                </c:pt>
                <c:pt idx="9">
                  <c:v>0</c:v>
                </c:pt>
                <c:pt idx="10">
                  <c:v>0.48499999999999999</c:v>
                </c:pt>
                <c:pt idx="11">
                  <c:v>0.84172000000000002</c:v>
                </c:pt>
                <c:pt idx="12">
                  <c:v>3.6700000000000003E-2</c:v>
                </c:pt>
                <c:pt idx="13">
                  <c:v>0.17710000000000001</c:v>
                </c:pt>
                <c:pt idx="14">
                  <c:v>0.1247999999999999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8</c:f>
              <c:numCache>
                <c:formatCode>General</c:formatCode>
                <c:ptCount val="300"/>
                <c:pt idx="0">
                  <c:v>-125.6604566908927</c:v>
                </c:pt>
                <c:pt idx="1">
                  <c:v>-125.61541610310188</c:v>
                </c:pt>
                <c:pt idx="2">
                  <c:v>-125.48031422838501</c:v>
                </c:pt>
                <c:pt idx="3">
                  <c:v>-125.25521072392671</c:v>
                </c:pt>
                <c:pt idx="4">
                  <c:v>-124.94020498909764</c:v>
                </c:pt>
                <c:pt idx="5">
                  <c:v>-124.53543612156251</c:v>
                </c:pt>
                <c:pt idx="6">
                  <c:v>-124.04108285585853</c:v>
                </c:pt>
                <c:pt idx="7">
                  <c:v>-123.45736348447123</c:v>
                </c:pt>
                <c:pt idx="8">
                  <c:v>-122.78453576144263</c:v>
                </c:pt>
                <c:pt idx="9">
                  <c:v>-122.02289678855435</c:v>
                </c:pt>
                <c:pt idx="10">
                  <c:v>-121.17278288413577</c:v>
                </c:pt>
                <c:pt idx="11">
                  <c:v>-120.23456943455544</c:v>
                </c:pt>
                <c:pt idx="12">
                  <c:v>-119.20867072846092</c:v>
                </c:pt>
                <c:pt idx="13">
                  <c:v>-118.09553977384054</c:v>
                </c:pt>
                <c:pt idx="14">
                  <c:v>-116.89566809798801</c:v>
                </c:pt>
                <c:pt idx="15">
                  <c:v>-115.60958553045755</c:v>
                </c:pt>
                <c:pt idx="16">
                  <c:v>-114.23785996910634</c:v>
                </c:pt>
                <c:pt idx="17">
                  <c:v>-112.78109712932657</c:v>
                </c:pt>
                <c:pt idx="18">
                  <c:v>-111.23994027657879</c:v>
                </c:pt>
                <c:pt idx="19">
                  <c:v>-109.61506994234379</c:v>
                </c:pt>
                <c:pt idx="20">
                  <c:v>-107.90720362361925</c:v>
                </c:pt>
                <c:pt idx="21">
                  <c:v>-106.11709546609309</c:v>
                </c:pt>
                <c:pt idx="22">
                  <c:v>-104.24553593113409</c:v>
                </c:pt>
                <c:pt idx="23">
                  <c:v>-102.29335144674634</c:v>
                </c:pt>
                <c:pt idx="24">
                  <c:v>-100.26140404264187</c:v>
                </c:pt>
                <c:pt idx="25">
                  <c:v>-98.150590969592699</c:v>
                </c:pt>
                <c:pt idx="26">
                  <c:v>-95.961844303230052</c:v>
                </c:pt>
                <c:pt idx="27">
                  <c:v>-93.696130532466114</c:v>
                </c:pt>
                <c:pt idx="28">
                  <c:v>-91.354450132719549</c:v>
                </c:pt>
                <c:pt idx="29">
                  <c:v>-88.937837124133935</c:v>
                </c:pt>
                <c:pt idx="30">
                  <c:v>-86.447358614983429</c:v>
                </c:pt>
                <c:pt idx="31">
                  <c:v>-83.884114330467796</c:v>
                </c:pt>
                <c:pt idx="32">
                  <c:v>-81.249236127104851</c:v>
                </c:pt>
                <c:pt idx="33">
                  <c:v>-78.543887492934331</c:v>
                </c:pt>
                <c:pt idx="34">
                  <c:v>-75.769263033754484</c:v>
                </c:pt>
                <c:pt idx="35">
                  <c:v>-72.926587945617499</c:v>
                </c:pt>
                <c:pt idx="36">
                  <c:v>-70.017117473817805</c:v>
                </c:pt>
                <c:pt idx="37">
                  <c:v>-67.042136358610733</c:v>
                </c:pt>
                <c:pt idx="38">
                  <c:v>-64.002958267907687</c:v>
                </c:pt>
                <c:pt idx="39">
                  <c:v>-60.900925217197184</c:v>
                </c:pt>
                <c:pt idx="40">
                  <c:v>-57.737406976948577</c:v>
                </c:pt>
                <c:pt idx="41">
                  <c:v>-54.513800467760106</c:v>
                </c:pt>
                <c:pt idx="42">
                  <c:v>-51.231529143517989</c:v>
                </c:pt>
                <c:pt idx="43">
                  <c:v>-47.892042362839319</c:v>
                </c:pt>
                <c:pt idx="44">
                  <c:v>-44.496814749076037</c:v>
                </c:pt>
                <c:pt idx="45">
                  <c:v>-41.047345539162862</c:v>
                </c:pt>
                <c:pt idx="46">
                  <c:v>-37.545157921596314</c:v>
                </c:pt>
                <c:pt idx="47">
                  <c:v>-33.991798363837731</c:v>
                </c:pt>
                <c:pt idx="48">
                  <c:v>-30.388835929436667</c:v>
                </c:pt>
                <c:pt idx="49">
                  <c:v>-26.737861585176617</c:v>
                </c:pt>
                <c:pt idx="50">
                  <c:v>-23.040487498548899</c:v>
                </c:pt>
                <c:pt idx="51">
                  <c:v>-19.298346325864813</c:v>
                </c:pt>
                <c:pt idx="52">
                  <c:v>-15.513090491320668</c:v>
                </c:pt>
                <c:pt idx="53">
                  <c:v>-11.68639145733367</c:v>
                </c:pt>
                <c:pt idx="54">
                  <c:v>-7.8199389864713567</c:v>
                </c:pt>
                <c:pt idx="55">
                  <c:v>-3.9154403952996262</c:v>
                </c:pt>
                <c:pt idx="56">
                  <c:v>2.5380199519744906E-2</c:v>
                </c:pt>
                <c:pt idx="57">
                  <c:v>4.000782642550675</c:v>
                </c:pt>
                <c:pt idx="58">
                  <c:v>8.0090115079864717</c:v>
                </c:pt>
                <c:pt idx="59">
                  <c:v>12.048296874796407</c:v>
                </c:pt>
                <c:pt idx="60">
                  <c:v>16.116855108273029</c:v>
                </c:pt>
                <c:pt idx="61">
                  <c:v>20.212889647634974</c:v>
                </c:pt>
                <c:pt idx="62">
                  <c:v>24.334591799337829</c:v>
                </c:pt>
                <c:pt idx="63">
                  <c:v>28.480141535742014</c:v>
                </c:pt>
                <c:pt idx="64">
                  <c:v>32.647708298785915</c:v>
                </c:pt>
                <c:pt idx="65">
                  <c:v>36.835451808308761</c:v>
                </c:pt>
                <c:pt idx="66">
                  <c:v>41.041522874666555</c:v>
                </c:pt>
                <c:pt idx="67">
                  <c:v>45.264064215282104</c:v>
                </c:pt>
                <c:pt idx="68">
                  <c:v>49.501211274768757</c:v>
                </c:pt>
                <c:pt idx="69">
                  <c:v>53.75109304826568</c:v>
                </c:pt>
                <c:pt idx="70">
                  <c:v>58.011832907620715</c:v>
                </c:pt>
                <c:pt idx="71">
                  <c:v>62.281549430056685</c:v>
                </c:pt>
                <c:pt idx="72">
                  <c:v>66.558357228954719</c:v>
                </c:pt>
                <c:pt idx="73">
                  <c:v>70.840367786387873</c:v>
                </c:pt>
                <c:pt idx="74">
                  <c:v>75.125690287037486</c:v>
                </c:pt>
                <c:pt idx="75">
                  <c:v>79.412432453124012</c:v>
                </c:pt>
                <c:pt idx="76">
                  <c:v>83.698701379983689</c:v>
                </c:pt>
                <c:pt idx="77">
                  <c:v>87.982604371921767</c:v>
                </c:pt>
                <c:pt idx="78">
                  <c:v>92.262249777973807</c:v>
                </c:pt>
                <c:pt idx="79">
                  <c:v>96.535747827205427</c:v>
                </c:pt>
                <c:pt idx="80">
                  <c:v>100.80121146318197</c:v>
                </c:pt>
                <c:pt idx="81">
                  <c:v>105.05675717723948</c:v>
                </c:pt>
                <c:pt idx="82">
                  <c:v>109.3005058401891</c:v>
                </c:pt>
                <c:pt idx="83">
                  <c:v>113.53058353208776</c:v>
                </c:pt>
                <c:pt idx="84">
                  <c:v>117.74512236970821</c:v>
                </c:pt>
                <c:pt idx="85">
                  <c:v>121.94226133134387</c:v>
                </c:pt>
                <c:pt idx="86">
                  <c:v>126.1201470785836</c:v>
                </c:pt>
                <c:pt idx="87">
                  <c:v>130.27693477469364</c:v>
                </c:pt>
                <c:pt idx="88">
                  <c:v>134.4107888992458</c:v>
                </c:pt>
                <c:pt idx="89">
                  <c:v>138.51988405863133</c:v>
                </c:pt>
                <c:pt idx="90">
                  <c:v>142.6024057921037</c:v>
                </c:pt>
                <c:pt idx="91">
                  <c:v>146.65655137299305</c:v>
                </c:pt>
                <c:pt idx="92">
                  <c:v>150.68053060473972</c:v>
                </c:pt>
                <c:pt idx="93">
                  <c:v>154.67256661139459</c:v>
                </c:pt>
                <c:pt idx="94">
                  <c:v>158.63089662223751</c:v>
                </c:pt>
                <c:pt idx="95">
                  <c:v>162.55377275016727</c:v>
                </c:pt>
                <c:pt idx="96">
                  <c:v>166.4394627635192</c:v>
                </c:pt>
                <c:pt idx="97">
                  <c:v>170.28625085097008</c:v>
                </c:pt>
                <c:pt idx="98">
                  <c:v>174.092438379192</c:v>
                </c:pt>
                <c:pt idx="99">
                  <c:v>177.85634464292104</c:v>
                </c:pt>
                <c:pt idx="100">
                  <c:v>181.57630760710944</c:v>
                </c:pt>
                <c:pt idx="101">
                  <c:v>185.25068464083338</c:v>
                </c:pt>
                <c:pt idx="102">
                  <c:v>188.8778532426328</c:v>
                </c:pt>
                <c:pt idx="103">
                  <c:v>192.45621175696203</c:v>
                </c:pt>
                <c:pt idx="104">
                  <c:v>195.98418008143605</c:v>
                </c:pt>
                <c:pt idx="105">
                  <c:v>199.46020036455917</c:v>
                </c:pt>
                <c:pt idx="106">
                  <c:v>202.88273769362831</c:v>
                </c:pt>
                <c:pt idx="107">
                  <c:v>206.25028077250727</c:v>
                </c:pt>
                <c:pt idx="108">
                  <c:v>209.56134258897276</c:v>
                </c:pt>
                <c:pt idx="109">
                  <c:v>212.81446107133667</c:v>
                </c:pt>
                <c:pt idx="110">
                  <c:v>216.00819973405635</c:v>
                </c:pt>
                <c:pt idx="111">
                  <c:v>219.14114831204563</c:v>
                </c:pt>
                <c:pt idx="112">
                  <c:v>222.21192338340865</c:v>
                </c:pt>
                <c:pt idx="113">
                  <c:v>225.21916898031969</c:v>
                </c:pt>
                <c:pt idx="114">
                  <c:v>228.1615571877806</c:v>
                </c:pt>
                <c:pt idx="115">
                  <c:v>231.03778872999055</c:v>
                </c:pt>
                <c:pt idx="116">
                  <c:v>233.84659354406978</c:v>
                </c:pt>
                <c:pt idx="117">
                  <c:v>236.58673134088343</c:v>
                </c:pt>
                <c:pt idx="118">
                  <c:v>239.25699215271851</c:v>
                </c:pt>
                <c:pt idx="119">
                  <c:v>241.85619686757133</c:v>
                </c:pt>
                <c:pt idx="120">
                  <c:v>244.38319774981045</c:v>
                </c:pt>
                <c:pt idx="121">
                  <c:v>246.83687894698426</c:v>
                </c:pt>
                <c:pt idx="122">
                  <c:v>249.21615698255005</c:v>
                </c:pt>
                <c:pt idx="123">
                  <c:v>251.51998123430673</c:v>
                </c:pt>
                <c:pt idx="124">
                  <c:v>253.74733439831999</c:v>
                </c:pt>
                <c:pt idx="125">
                  <c:v>255.89723293813518</c:v>
                </c:pt>
                <c:pt idx="126">
                  <c:v>257.96872751907921</c:v>
                </c:pt>
                <c:pt idx="127">
                  <c:v>259.96090342746004</c:v>
                </c:pt>
                <c:pt idx="128">
                  <c:v>261.87288097447868</c:v>
                </c:pt>
                <c:pt idx="129">
                  <c:v>263.70381588467467</c:v>
                </c:pt>
                <c:pt idx="130">
                  <c:v>265.45289966873457</c:v>
                </c:pt>
                <c:pt idx="131">
                  <c:v>267.11935998049813</c:v>
                </c:pt>
                <c:pt idx="132">
                  <c:v>268.70246095800439</c:v>
                </c:pt>
                <c:pt idx="133">
                  <c:v>270.20150354842781</c:v>
                </c:pt>
                <c:pt idx="134">
                  <c:v>271.61582581676021</c:v>
                </c:pt>
                <c:pt idx="135">
                  <c:v>272.94480323810268</c:v>
                </c:pt>
                <c:pt idx="136">
                  <c:v>274.18784897343824</c:v>
                </c:pt>
                <c:pt idx="137">
                  <c:v>275.34441412876333</c:v>
                </c:pt>
                <c:pt idx="138">
                  <c:v>276.41398799746395</c:v>
                </c:pt>
                <c:pt idx="139">
                  <c:v>277.39609828582945</c:v>
                </c:pt>
                <c:pt idx="140">
                  <c:v>278.29031132160407</c:v>
                </c:pt>
                <c:pt idx="141">
                  <c:v>279.09623224548426</c:v>
                </c:pt>
                <c:pt idx="142">
                  <c:v>279.81350518547765</c:v>
                </c:pt>
                <c:pt idx="143">
                  <c:v>280.44181341404601</c:v>
                </c:pt>
                <c:pt idx="144">
                  <c:v>280.98087948796314</c:v>
                </c:pt>
                <c:pt idx="145">
                  <c:v>281.43046537082625</c:v>
                </c:pt>
                <c:pt idx="146">
                  <c:v>281.79037253816574</c:v>
                </c:pt>
                <c:pt idx="147">
                  <c:v>282.06044206510836</c:v>
                </c:pt>
                <c:pt idx="148">
                  <c:v>282.24055469655372</c:v>
                </c:pt>
                <c:pt idx="149">
                  <c:v>282.3306308998342</c:v>
                </c:pt>
                <c:pt idx="150">
                  <c:v>282.3306308998342</c:v>
                </c:pt>
                <c:pt idx="151">
                  <c:v>282.24055469655366</c:v>
                </c:pt>
                <c:pt idx="152">
                  <c:v>282.06044206510819</c:v>
                </c:pt>
                <c:pt idx="153">
                  <c:v>281.79037253816551</c:v>
                </c:pt>
                <c:pt idx="154">
                  <c:v>281.43046537082597</c:v>
                </c:pt>
                <c:pt idx="155">
                  <c:v>280.9808794879628</c:v>
                </c:pt>
                <c:pt idx="156">
                  <c:v>280.44181341404555</c:v>
                </c:pt>
                <c:pt idx="157">
                  <c:v>279.81350518547714</c:v>
                </c:pt>
                <c:pt idx="158">
                  <c:v>279.09623224548369</c:v>
                </c:pt>
                <c:pt idx="159">
                  <c:v>278.2903113216035</c:v>
                </c:pt>
                <c:pt idx="160">
                  <c:v>277.39609828582883</c:v>
                </c:pt>
                <c:pt idx="161">
                  <c:v>276.41398799746321</c:v>
                </c:pt>
                <c:pt idx="162">
                  <c:v>275.34441412876254</c:v>
                </c:pt>
                <c:pt idx="163">
                  <c:v>274.18784897343738</c:v>
                </c:pt>
                <c:pt idx="164">
                  <c:v>272.94480323810177</c:v>
                </c:pt>
                <c:pt idx="165">
                  <c:v>271.61582581675924</c:v>
                </c:pt>
                <c:pt idx="166">
                  <c:v>270.20150354842679</c:v>
                </c:pt>
                <c:pt idx="167">
                  <c:v>268.70246095800331</c:v>
                </c:pt>
                <c:pt idx="168">
                  <c:v>267.11935998049699</c:v>
                </c:pt>
                <c:pt idx="169">
                  <c:v>265.45289966873344</c:v>
                </c:pt>
                <c:pt idx="170">
                  <c:v>263.70381588467342</c:v>
                </c:pt>
                <c:pt idx="171">
                  <c:v>261.87288097447743</c:v>
                </c:pt>
                <c:pt idx="172">
                  <c:v>259.96090342745867</c:v>
                </c:pt>
                <c:pt idx="173">
                  <c:v>257.96872751907773</c:v>
                </c:pt>
                <c:pt idx="174">
                  <c:v>255.8972329381337</c:v>
                </c:pt>
                <c:pt idx="175">
                  <c:v>253.74733439831846</c:v>
                </c:pt>
                <c:pt idx="176">
                  <c:v>251.51998123430513</c:v>
                </c:pt>
                <c:pt idx="177">
                  <c:v>249.2161569825484</c:v>
                </c:pt>
                <c:pt idx="178">
                  <c:v>246.83687894698261</c:v>
                </c:pt>
                <c:pt idx="179">
                  <c:v>244.38319774980874</c:v>
                </c:pt>
                <c:pt idx="180">
                  <c:v>241.85619686756951</c:v>
                </c:pt>
                <c:pt idx="181">
                  <c:v>239.25699215271663</c:v>
                </c:pt>
                <c:pt idx="182">
                  <c:v>236.58673134088156</c:v>
                </c:pt>
                <c:pt idx="183">
                  <c:v>233.84659354406784</c:v>
                </c:pt>
                <c:pt idx="184">
                  <c:v>231.03778872998856</c:v>
                </c:pt>
                <c:pt idx="185">
                  <c:v>228.16155718777856</c:v>
                </c:pt>
                <c:pt idx="186">
                  <c:v>225.21916898031759</c:v>
                </c:pt>
                <c:pt idx="187">
                  <c:v>222.21192338340654</c:v>
                </c:pt>
                <c:pt idx="188">
                  <c:v>219.14114831204347</c:v>
                </c:pt>
                <c:pt idx="189">
                  <c:v>216.00819973405413</c:v>
                </c:pt>
                <c:pt idx="190">
                  <c:v>212.81446107133445</c:v>
                </c:pt>
                <c:pt idx="191">
                  <c:v>209.56134258897055</c:v>
                </c:pt>
                <c:pt idx="192">
                  <c:v>206.25028077250502</c:v>
                </c:pt>
                <c:pt idx="193">
                  <c:v>202.88273769362598</c:v>
                </c:pt>
                <c:pt idx="194">
                  <c:v>199.46020036455678</c:v>
                </c:pt>
                <c:pt idx="195">
                  <c:v>195.98418008143361</c:v>
                </c:pt>
                <c:pt idx="196">
                  <c:v>192.45621175695953</c:v>
                </c:pt>
                <c:pt idx="197">
                  <c:v>188.87785324263027</c:v>
                </c:pt>
                <c:pt idx="198">
                  <c:v>185.25068464083085</c:v>
                </c:pt>
                <c:pt idx="199">
                  <c:v>181.57630760710686</c:v>
                </c:pt>
                <c:pt idx="200">
                  <c:v>177.85634464291846</c:v>
                </c:pt>
                <c:pt idx="201">
                  <c:v>174.09243837918939</c:v>
                </c:pt>
                <c:pt idx="202">
                  <c:v>170.28625085096743</c:v>
                </c:pt>
                <c:pt idx="203">
                  <c:v>166.4394627635165</c:v>
                </c:pt>
                <c:pt idx="204">
                  <c:v>162.55377275016451</c:v>
                </c:pt>
                <c:pt idx="205">
                  <c:v>158.63089662223473</c:v>
                </c:pt>
                <c:pt idx="206">
                  <c:v>154.67256661139174</c:v>
                </c:pt>
                <c:pt idx="207">
                  <c:v>150.68053060473687</c:v>
                </c:pt>
                <c:pt idx="208">
                  <c:v>146.65655137299018</c:v>
                </c:pt>
                <c:pt idx="209">
                  <c:v>142.6024057921008</c:v>
                </c:pt>
                <c:pt idx="210">
                  <c:v>138.51988405862843</c:v>
                </c:pt>
                <c:pt idx="211">
                  <c:v>134.41078889924285</c:v>
                </c:pt>
                <c:pt idx="212">
                  <c:v>130.27693477469069</c:v>
                </c:pt>
                <c:pt idx="213">
                  <c:v>126.1201470785806</c:v>
                </c:pt>
                <c:pt idx="214">
                  <c:v>121.94226133134106</c:v>
                </c:pt>
                <c:pt idx="215">
                  <c:v>117.74512236970537</c:v>
                </c:pt>
                <c:pt idx="216">
                  <c:v>113.5305835320849</c:v>
                </c:pt>
                <c:pt idx="217">
                  <c:v>109.30050584018623</c:v>
                </c:pt>
                <c:pt idx="218">
                  <c:v>105.05675717723656</c:v>
                </c:pt>
                <c:pt idx="219">
                  <c:v>100.80121146317904</c:v>
                </c:pt>
                <c:pt idx="220">
                  <c:v>96.535747827202485</c:v>
                </c:pt>
                <c:pt idx="221">
                  <c:v>92.262249777970865</c:v>
                </c:pt>
                <c:pt idx="222">
                  <c:v>87.982604371918825</c:v>
                </c:pt>
                <c:pt idx="223">
                  <c:v>83.698701379980733</c:v>
                </c:pt>
                <c:pt idx="224">
                  <c:v>79.41243245312107</c:v>
                </c:pt>
                <c:pt idx="225">
                  <c:v>75.125690287034502</c:v>
                </c:pt>
                <c:pt idx="226">
                  <c:v>70.840367786384874</c:v>
                </c:pt>
                <c:pt idx="227">
                  <c:v>66.558357228951735</c:v>
                </c:pt>
                <c:pt idx="228">
                  <c:v>62.281549430053701</c:v>
                </c:pt>
                <c:pt idx="229">
                  <c:v>58.011832907617745</c:v>
                </c:pt>
                <c:pt idx="230">
                  <c:v>53.751093048262717</c:v>
                </c:pt>
                <c:pt idx="231">
                  <c:v>49.501211274765794</c:v>
                </c:pt>
                <c:pt idx="232">
                  <c:v>45.264064215279113</c:v>
                </c:pt>
                <c:pt idx="233">
                  <c:v>41.041522874663571</c:v>
                </c:pt>
                <c:pt idx="234">
                  <c:v>36.835451808305798</c:v>
                </c:pt>
                <c:pt idx="235">
                  <c:v>32.647708298782959</c:v>
                </c:pt>
                <c:pt idx="236">
                  <c:v>28.480141535739072</c:v>
                </c:pt>
                <c:pt idx="237">
                  <c:v>24.334591799334909</c:v>
                </c:pt>
                <c:pt idx="238">
                  <c:v>20.212889647632068</c:v>
                </c:pt>
                <c:pt idx="239">
                  <c:v>16.116855108270094</c:v>
                </c:pt>
                <c:pt idx="240">
                  <c:v>12.048296874793493</c:v>
                </c:pt>
                <c:pt idx="241">
                  <c:v>8.0090115079835726</c:v>
                </c:pt>
                <c:pt idx="242">
                  <c:v>4.0007826425479607</c:v>
                </c:pt>
                <c:pt idx="243">
                  <c:v>2.5380199517073265E-2</c:v>
                </c:pt>
                <c:pt idx="244">
                  <c:v>-3.9154403953022694</c:v>
                </c:pt>
                <c:pt idx="245">
                  <c:v>-7.8199389864739857</c:v>
                </c:pt>
                <c:pt idx="246">
                  <c:v>-11.686391457336356</c:v>
                </c:pt>
                <c:pt idx="247">
                  <c:v>-15.513090491323325</c:v>
                </c:pt>
                <c:pt idx="248">
                  <c:v>-19.298346325867442</c:v>
                </c:pt>
                <c:pt idx="249">
                  <c:v>-23.040487498551499</c:v>
                </c:pt>
                <c:pt idx="250">
                  <c:v>-26.737861585179203</c:v>
                </c:pt>
                <c:pt idx="251">
                  <c:v>-30.38883592943921</c:v>
                </c:pt>
                <c:pt idx="252">
                  <c:v>-33.991798363840232</c:v>
                </c:pt>
                <c:pt idx="253">
                  <c:v>-37.545157921598758</c:v>
                </c:pt>
                <c:pt idx="254">
                  <c:v>-41.047345539165278</c:v>
                </c:pt>
                <c:pt idx="255">
                  <c:v>-44.496814749078439</c:v>
                </c:pt>
                <c:pt idx="256">
                  <c:v>-47.892042362841678</c:v>
                </c:pt>
                <c:pt idx="257">
                  <c:v>-51.231529143520319</c:v>
                </c:pt>
                <c:pt idx="258">
                  <c:v>-54.513800467762351</c:v>
                </c:pt>
                <c:pt idx="259">
                  <c:v>-57.737406976950794</c:v>
                </c:pt>
                <c:pt idx="260">
                  <c:v>-60.900925217199372</c:v>
                </c:pt>
                <c:pt idx="261">
                  <c:v>-64.002958267909847</c:v>
                </c:pt>
                <c:pt idx="262">
                  <c:v>-67.042136358612836</c:v>
                </c:pt>
                <c:pt idx="263">
                  <c:v>-70.017117473819823</c:v>
                </c:pt>
                <c:pt idx="264">
                  <c:v>-72.926587945619517</c:v>
                </c:pt>
                <c:pt idx="265">
                  <c:v>-75.769263033756474</c:v>
                </c:pt>
                <c:pt idx="266">
                  <c:v>-78.543887492936321</c:v>
                </c:pt>
                <c:pt idx="267">
                  <c:v>-81.249236127106784</c:v>
                </c:pt>
                <c:pt idx="268">
                  <c:v>-83.884114330469671</c:v>
                </c:pt>
                <c:pt idx="269">
                  <c:v>-86.447358614985248</c:v>
                </c:pt>
                <c:pt idx="270">
                  <c:v>-88.937837124135697</c:v>
                </c:pt>
                <c:pt idx="271">
                  <c:v>-91.354450132721169</c:v>
                </c:pt>
                <c:pt idx="272">
                  <c:v>-93.696130532467649</c:v>
                </c:pt>
                <c:pt idx="273">
                  <c:v>-95.961844303231558</c:v>
                </c:pt>
                <c:pt idx="274">
                  <c:v>-98.150590969594148</c:v>
                </c:pt>
                <c:pt idx="275">
                  <c:v>-100.26140404264326</c:v>
                </c:pt>
                <c:pt idx="276">
                  <c:v>-102.29335144674771</c:v>
                </c:pt>
                <c:pt idx="277">
                  <c:v>-104.24553593113542</c:v>
                </c:pt>
                <c:pt idx="278">
                  <c:v>-106.11709546609437</c:v>
                </c:pt>
                <c:pt idx="279">
                  <c:v>-107.90720362362048</c:v>
                </c:pt>
                <c:pt idx="280">
                  <c:v>-109.61506994234499</c:v>
                </c:pt>
                <c:pt idx="281">
                  <c:v>-111.2399402765799</c:v>
                </c:pt>
                <c:pt idx="282">
                  <c:v>-112.78109712932762</c:v>
                </c:pt>
                <c:pt idx="283">
                  <c:v>-114.23785996910733</c:v>
                </c:pt>
                <c:pt idx="284">
                  <c:v>-115.60958553045849</c:v>
                </c:pt>
                <c:pt idx="285">
                  <c:v>-116.89566809798886</c:v>
                </c:pt>
                <c:pt idx="286">
                  <c:v>-118.09553977384134</c:v>
                </c:pt>
                <c:pt idx="287">
                  <c:v>-119.20867072846166</c:v>
                </c:pt>
                <c:pt idx="288">
                  <c:v>-120.23456943455612</c:v>
                </c:pt>
                <c:pt idx="289">
                  <c:v>-121.1727828841364</c:v>
                </c:pt>
                <c:pt idx="290">
                  <c:v>-122.02289678855492</c:v>
                </c:pt>
                <c:pt idx="291">
                  <c:v>-122.78453576144311</c:v>
                </c:pt>
                <c:pt idx="292">
                  <c:v>-123.45736348447166</c:v>
                </c:pt>
                <c:pt idx="293">
                  <c:v>-124.04108285585893</c:v>
                </c:pt>
                <c:pt idx="294">
                  <c:v>-124.53543612156285</c:v>
                </c:pt>
                <c:pt idx="295">
                  <c:v>-124.94020498909789</c:v>
                </c:pt>
                <c:pt idx="296">
                  <c:v>-125.25521072392691</c:v>
                </c:pt>
                <c:pt idx="297">
                  <c:v>-125.48031422838513</c:v>
                </c:pt>
                <c:pt idx="298">
                  <c:v>-125.61541610310194</c:v>
                </c:pt>
                <c:pt idx="299">
                  <c:v>-125.6604566908927</c:v>
                </c:pt>
              </c:numCache>
            </c:numRef>
          </c:xVal>
          <c:yVal>
            <c:numRef>
              <c:f>'Covariance   Correlation3'!yycir9</c:f>
              <c:numCache>
                <c:formatCode>General</c:formatCode>
                <c:ptCount val="300"/>
                <c:pt idx="0">
                  <c:v>1.4934239962633531</c:v>
                </c:pt>
                <c:pt idx="1">
                  <c:v>1.4671084395635059</c:v>
                </c:pt>
                <c:pt idx="2">
                  <c:v>1.4403226380886567</c:v>
                </c:pt>
                <c:pt idx="3">
                  <c:v>1.4130784196946862</c:v>
                </c:pt>
                <c:pt idx="4">
                  <c:v>1.3853878146614802</c:v>
                </c:pt>
                <c:pt idx="5">
                  <c:v>1.3572630503806997</c:v>
                </c:pt>
                <c:pt idx="6">
                  <c:v>1.3287165459565067</c:v>
                </c:pt>
                <c:pt idx="7">
                  <c:v>1.2997609067216382</c:v>
                </c:pt>
                <c:pt idx="8">
                  <c:v>1.2704089186712446</c:v>
                </c:pt>
                <c:pt idx="9">
                  <c:v>1.240673542816958</c:v>
                </c:pt>
                <c:pt idx="10">
                  <c:v>1.2105679094636701</c:v>
                </c:pt>
                <c:pt idx="11">
                  <c:v>1.1801053124115617</c:v>
                </c:pt>
                <c:pt idx="12">
                  <c:v>1.1492992030859337</c:v>
                </c:pt>
                <c:pt idx="13">
                  <c:v>1.1181631845974371</c:v>
                </c:pt>
                <c:pt idx="14">
                  <c:v>1.0867110057353218</c:v>
                </c:pt>
                <c:pt idx="15">
                  <c:v>1.0549565548963584</c:v>
                </c:pt>
                <c:pt idx="16">
                  <c:v>1.022913853952113</c:v>
                </c:pt>
                <c:pt idx="17">
                  <c:v>0.99059705205728354</c:v>
                </c:pt>
                <c:pt idx="18">
                  <c:v>0.9580204194018318</c:v>
                </c:pt>
                <c:pt idx="19">
                  <c:v>0.92519834090966879</c:v>
                </c:pt>
                <c:pt idx="20">
                  <c:v>0.89214530988667762</c:v>
                </c:pt>
                <c:pt idx="21">
                  <c:v>0.85887592162087689</c:v>
                </c:pt>
                <c:pt idx="22">
                  <c:v>0.82540486693755366</c:v>
                </c:pt>
                <c:pt idx="23">
                  <c:v>0.79174692571220773</c:v>
                </c:pt>
                <c:pt idx="24">
                  <c:v>0.75791696034417366</c:v>
                </c:pt>
                <c:pt idx="25">
                  <c:v>0.72392990919380562</c:v>
                </c:pt>
                <c:pt idx="26">
                  <c:v>0.68980077998611744</c:v>
                </c:pt>
                <c:pt idx="27">
                  <c:v>0.65554464318379313</c:v>
                </c:pt>
                <c:pt idx="28">
                  <c:v>0.6211766253324944</c:v>
                </c:pt>
                <c:pt idx="29">
                  <c:v>0.58671190238140614</c:v>
                </c:pt>
                <c:pt idx="30">
                  <c:v>0.55216569298196116</c:v>
                </c:pt>
                <c:pt idx="31">
                  <c:v>0.51755325176771494</c:v>
                </c:pt>
                <c:pt idx="32">
                  <c:v>0.48288986261832811</c:v>
                </c:pt>
                <c:pt idx="33">
                  <c:v>0.44819083191063447</c:v>
                </c:pt>
                <c:pt idx="34">
                  <c:v>0.41347148175977755</c:v>
                </c:pt>
                <c:pt idx="35">
                  <c:v>0.37874714325339343</c:v>
                </c:pt>
                <c:pt idx="36">
                  <c:v>0.34403314968183685</c:v>
                </c:pt>
                <c:pt idx="37">
                  <c:v>0.30934482976743005</c:v>
                </c:pt>
                <c:pt idx="38">
                  <c:v>0.27469750089573164</c:v>
                </c:pt>
                <c:pt idx="39">
                  <c:v>0.24010646235180877</c:v>
                </c:pt>
                <c:pt idx="40">
                  <c:v>0.2055869885645053</c:v>
                </c:pt>
                <c:pt idx="41">
                  <c:v>0.1711543223616826</c:v>
                </c:pt>
                <c:pt idx="42">
                  <c:v>0.13682366823941694</c:v>
                </c:pt>
                <c:pt idx="43">
                  <c:v>0.10261018564812119</c:v>
                </c:pt>
                <c:pt idx="44">
                  <c:v>6.8528982298558971E-2</c:v>
                </c:pt>
                <c:pt idx="45">
                  <c:v>3.459510749070438E-2</c:v>
                </c:pt>
                <c:pt idx="46">
                  <c:v>8.23545468394693E-4</c:v>
                </c:pt>
                <c:pt idx="47">
                  <c:v>-3.2770791197288762E-2</c:v>
                </c:pt>
                <c:pt idx="48">
                  <c:v>-6.6173068192994067E-2</c:v>
                </c:pt>
                <c:pt idx="49">
                  <c:v>-9.9368536013512032E-2</c:v>
                </c:pt>
                <c:pt idx="50">
                  <c:v>-0.13234253647474403</c:v>
                </c:pt>
                <c:pt idx="51">
                  <c:v>-0.16508050918634209</c:v>
                </c:pt>
                <c:pt idx="52">
                  <c:v>-0.19756799798116864</c:v>
                </c:pt>
                <c:pt idx="53">
                  <c:v>-0.22979065729873155</c:v>
                </c:pt>
                <c:pt idx="54">
                  <c:v>-0.26173425851978088</c:v>
                </c:pt>
                <c:pt idx="55">
                  <c:v>-0.2933846962492675</c:v>
                </c:pt>
                <c:pt idx="56">
                  <c:v>-0.32472799454488582</c:v>
                </c:pt>
                <c:pt idx="57">
                  <c:v>-0.35575031308845811</c:v>
                </c:pt>
                <c:pt idx="58">
                  <c:v>-0.38643795329742991</c:v>
                </c:pt>
                <c:pt idx="59">
                  <c:v>-0.41677736437377655</c:v>
                </c:pt>
                <c:pt idx="60">
                  <c:v>-0.44675514928765658</c:v>
                </c:pt>
                <c:pt idx="61">
                  <c:v>-0.47635807069316055</c:v>
                </c:pt>
                <c:pt idx="62">
                  <c:v>-0.50557305677355258</c:v>
                </c:pt>
                <c:pt idx="63">
                  <c:v>-0.53438720701341491</c:v>
                </c:pt>
                <c:pt idx="64">
                  <c:v>-0.56278779789515321</c:v>
                </c:pt>
                <c:pt idx="65">
                  <c:v>-0.59076228851734314</c:v>
                </c:pt>
                <c:pt idx="66">
                  <c:v>-0.61829832613243974</c:v>
                </c:pt>
                <c:pt idx="67">
                  <c:v>-0.6453837516014036</c:v>
                </c:pt>
                <c:pt idx="68">
                  <c:v>-0.67200660476283325</c:v>
                </c:pt>
                <c:pt idx="69">
                  <c:v>-0.69815512971423666</c:v>
                </c:pt>
                <c:pt idx="70">
                  <c:v>-0.72381778000310659</c:v>
                </c:pt>
                <c:pt idx="71">
                  <c:v>-0.74898322372550818</c:v>
                </c:pt>
                <c:pt idx="72">
                  <c:v>-0.77364034852992991</c:v>
                </c:pt>
                <c:pt idx="73">
                  <c:v>-0.79777826652418449</c:v>
                </c:pt>
                <c:pt idx="74">
                  <c:v>-0.82138631908319581</c:v>
                </c:pt>
                <c:pt idx="75">
                  <c:v>-0.84445408155554746</c:v>
                </c:pt>
                <c:pt idx="76">
                  <c:v>-0.86697136786671603</c:v>
                </c:pt>
                <c:pt idx="77">
                  <c:v>-0.88892823501695362</c:v>
                </c:pt>
                <c:pt idx="78">
                  <c:v>-0.91031498747183803</c:v>
                </c:pt>
                <c:pt idx="79">
                  <c:v>-0.93112218144354664</c:v>
                </c:pt>
                <c:pt idx="80">
                  <c:v>-0.95134062906096828</c:v>
                </c:pt>
                <c:pt idx="81">
                  <c:v>-0.97096140242680717</c:v>
                </c:pt>
                <c:pt idx="82">
                  <c:v>-0.98997583755989216</c:v>
                </c:pt>
                <c:pt idx="83">
                  <c:v>-1.0083755382209474</c:v>
                </c:pt>
                <c:pt idx="84">
                  <c:v>-1.0261523796201333</c:v>
                </c:pt>
                <c:pt idx="85">
                  <c:v>-1.0432985120047262</c:v>
                </c:pt>
                <c:pt idx="86">
                  <c:v>-1.0598063641253488</c:v>
                </c:pt>
                <c:pt idx="87">
                  <c:v>-1.0756686465792193</c:v>
                </c:pt>
                <c:pt idx="88">
                  <c:v>-1.090878355028948</c:v>
                </c:pt>
                <c:pt idx="89">
                  <c:v>-1.1054287732954537</c:v>
                </c:pt>
                <c:pt idx="90">
                  <c:v>-1.1193134763236414</c:v>
                </c:pt>
                <c:pt idx="91">
                  <c:v>-1.1325263330195241</c:v>
                </c:pt>
                <c:pt idx="92">
                  <c:v>-1.145061508957542</c:v>
                </c:pt>
                <c:pt idx="93">
                  <c:v>-1.1569134689568801</c:v>
                </c:pt>
                <c:pt idx="94">
                  <c:v>-1.1680769795256492</c:v>
                </c:pt>
                <c:pt idx="95">
                  <c:v>-1.1785471111718482</c:v>
                </c:pt>
                <c:pt idx="96">
                  <c:v>-1.1883192405800875</c:v>
                </c:pt>
                <c:pt idx="97">
                  <c:v>-1.1973890526531181</c:v>
                </c:pt>
                <c:pt idx="98">
                  <c:v>-1.2057525424172535</c:v>
                </c:pt>
                <c:pt idx="99">
                  <c:v>-1.2134060167908558</c:v>
                </c:pt>
                <c:pt idx="100">
                  <c:v>-1.220346096215096</c:v>
                </c:pt>
                <c:pt idx="101">
                  <c:v>-1.2265697161462712</c:v>
                </c:pt>
                <c:pt idx="102">
                  <c:v>-1.232074128409022</c:v>
                </c:pt>
                <c:pt idx="103">
                  <c:v>-1.236856902409849</c:v>
                </c:pt>
                <c:pt idx="104">
                  <c:v>-1.2409159262103935</c:v>
                </c:pt>
                <c:pt idx="105">
                  <c:v>-1.2442494074600117</c:v>
                </c:pt>
                <c:pt idx="106">
                  <c:v>-1.2468558741872249</c:v>
                </c:pt>
                <c:pt idx="107">
                  <c:v>-1.2487341754497014</c:v>
                </c:pt>
                <c:pt idx="108">
                  <c:v>-1.2498834818424807</c:v>
                </c:pt>
                <c:pt idx="109">
                  <c:v>-1.2503032858642125</c:v>
                </c:pt>
                <c:pt idx="110">
                  <c:v>-1.2499934021412606</c:v>
                </c:pt>
                <c:pt idx="111">
                  <c:v>-1.2489539675095522</c:v>
                </c:pt>
                <c:pt idx="112">
                  <c:v>-1.2471854409541598</c:v>
                </c:pt>
                <c:pt idx="113">
                  <c:v>-1.2446886034066242</c:v>
                </c:pt>
                <c:pt idx="114">
                  <c:v>-1.2414645574001177</c:v>
                </c:pt>
                <c:pt idx="115">
                  <c:v>-1.2375147265825959</c:v>
                </c:pt>
                <c:pt idx="116">
                  <c:v>-1.2328408550881558</c:v>
                </c:pt>
                <c:pt idx="117">
                  <c:v>-1.2274450067668741</c:v>
                </c:pt>
                <c:pt idx="118">
                  <c:v>-1.2213295642734707</c:v>
                </c:pt>
                <c:pt idx="119">
                  <c:v>-1.2144972280151936</c:v>
                </c:pt>
                <c:pt idx="120">
                  <c:v>-1.2069510149593961</c:v>
                </c:pt>
                <c:pt idx="121">
                  <c:v>-1.1986942573013297</c:v>
                </c:pt>
                <c:pt idx="122">
                  <c:v>-1.1897306009927386</c:v>
                </c:pt>
                <c:pt idx="123">
                  <c:v>-1.1800640041319115</c:v>
                </c:pt>
                <c:pt idx="124">
                  <c:v>-1.1696987352158961</c:v>
                </c:pt>
                <c:pt idx="125">
                  <c:v>-1.158639371255652</c:v>
                </c:pt>
                <c:pt idx="126">
                  <c:v>-1.1468907957549694</c:v>
                </c:pt>
                <c:pt idx="127">
                  <c:v>-1.1344581965540546</c:v>
                </c:pt>
                <c:pt idx="128">
                  <c:v>-1.1213470635387222</c:v>
                </c:pt>
                <c:pt idx="129">
                  <c:v>-1.1075631862162181</c:v>
                </c:pt>
                <c:pt idx="130">
                  <c:v>-1.0931126511587363</c:v>
                </c:pt>
                <c:pt idx="131">
                  <c:v>-1.0780018393157589</c:v>
                </c:pt>
                <c:pt idx="132">
                  <c:v>-1.0622374231964091</c:v>
                </c:pt>
                <c:pt idx="133">
                  <c:v>-1.0458263639230585</c:v>
                </c:pt>
                <c:pt idx="134">
                  <c:v>-1.0287759081574925</c:v>
                </c:pt>
                <c:pt idx="135">
                  <c:v>-1.011093584900987</c:v>
                </c:pt>
                <c:pt idx="136">
                  <c:v>-0.9927872021697145</c:v>
                </c:pt>
                <c:pt idx="137">
                  <c:v>-0.97386484354694314</c:v>
                </c:pt>
                <c:pt idx="138">
                  <c:v>-0.95433486461355455</c:v>
                </c:pt>
                <c:pt idx="139">
                  <c:v>-0.93420588925845449</c:v>
                </c:pt>
                <c:pt idx="140">
                  <c:v>-0.91348680587050635</c:v>
                </c:pt>
                <c:pt idx="141">
                  <c:v>-0.89218676341366776</c:v>
                </c:pt>
                <c:pt idx="142">
                  <c:v>-0.87031516738706727</c:v>
                </c:pt>
                <c:pt idx="143">
                  <c:v>-0.84788167567179962</c:v>
                </c:pt>
                <c:pt idx="144">
                  <c:v>-0.82489619426627736</c:v>
                </c:pt>
                <c:pt idx="145">
                  <c:v>-0.80136887291202208</c:v>
                </c:pt>
                <c:pt idx="146">
                  <c:v>-0.77731010061182237</c:v>
                </c:pt>
                <c:pt idx="147">
                  <c:v>-0.75273050104224359</c:v>
                </c:pt>
                <c:pt idx="148">
                  <c:v>-0.72764092786251244</c:v>
                </c:pt>
                <c:pt idx="149">
                  <c:v>-0.70205245992184406</c:v>
                </c:pt>
                <c:pt idx="150">
                  <c:v>-0.67597639636733708</c:v>
                </c:pt>
                <c:pt idx="151">
                  <c:v>-0.64942425165458506</c:v>
                </c:pt>
                <c:pt idx="152">
                  <c:v>-0.62240775046322017</c:v>
                </c:pt>
                <c:pt idx="153">
                  <c:v>-0.59493882251962316</c:v>
                </c:pt>
                <c:pt idx="154">
                  <c:v>-0.56702959732909186</c:v>
                </c:pt>
                <c:pt idx="155">
                  <c:v>-0.53869239881979369</c:v>
                </c:pt>
                <c:pt idx="156">
                  <c:v>-0.50993973990086572</c:v>
                </c:pt>
                <c:pt idx="157">
                  <c:v>-0.4807843169370658</c:v>
                </c:pt>
                <c:pt idx="158">
                  <c:v>-0.45123900414241669</c:v>
                </c:pt>
                <c:pt idx="159">
                  <c:v>-0.42131684789531376</c:v>
                </c:pt>
                <c:pt idx="160">
                  <c:v>-0.39103106097761242</c:v>
                </c:pt>
                <c:pt idx="161">
                  <c:v>-0.36039501674023577</c:v>
                </c:pt>
                <c:pt idx="162">
                  <c:v>-0.32942224319787961</c:v>
                </c:pt>
                <c:pt idx="163">
                  <c:v>-0.29812641705542087</c:v>
                </c:pt>
                <c:pt idx="164">
                  <c:v>-0.26652135766867158</c:v>
                </c:pt>
                <c:pt idx="165">
                  <c:v>-0.23462102094213633</c:v>
                </c:pt>
                <c:pt idx="166">
                  <c:v>-0.20243949316648324</c:v>
                </c:pt>
                <c:pt idx="167">
                  <c:v>-0.16999098479843111</c:v>
                </c:pt>
                <c:pt idx="168">
                  <c:v>-0.13728982418581259</c:v>
                </c:pt>
                <c:pt idx="169">
                  <c:v>-0.10435045124057885</c:v>
                </c:pt>
                <c:pt idx="170">
                  <c:v>-7.118741106254145E-2</c:v>
                </c:pt>
                <c:pt idx="171">
                  <c:v>-3.7815347516665154E-2</c:v>
                </c:pt>
                <c:pt idx="172">
                  <c:v>-4.2489967667499462E-3</c:v>
                </c:pt>
                <c:pt idx="173">
                  <c:v>2.9496819231644489E-2</c:v>
                </c:pt>
                <c:pt idx="174">
                  <c:v>6.3407199276156345E-2</c:v>
                </c:pt>
                <c:pt idx="175">
                  <c:v>9.7467169497574724E-2</c:v>
                </c:pt>
                <c:pt idx="176">
                  <c:v>0.13166168997187666</c:v>
                </c:pt>
                <c:pt idx="177">
                  <c:v>0.16597566136143593</c:v>
                </c:pt>
                <c:pt idx="178">
                  <c:v>0.20039393158246366</c:v>
                </c:pt>
                <c:pt idx="179">
                  <c:v>0.23490130249574592</c:v>
                </c:pt>
                <c:pt idx="180">
                  <c:v>0.26948253661770882</c:v>
                </c:pt>
                <c:pt idx="181">
                  <c:v>0.30412236384886515</c:v>
                </c:pt>
                <c:pt idx="182">
                  <c:v>0.3388054882166609</c:v>
                </c:pt>
                <c:pt idx="183">
                  <c:v>0.37351659462974496</c:v>
                </c:pt>
                <c:pt idx="184">
                  <c:v>0.40824035564068306</c:v>
                </c:pt>
                <c:pt idx="185">
                  <c:v>0.44296143821412626</c:v>
                </c:pt>
                <c:pt idx="186">
                  <c:v>0.47766451049744862</c:v>
                </c:pt>
                <c:pt idx="187">
                  <c:v>0.51233424859086096</c:v>
                </c:pt>
                <c:pt idx="188">
                  <c:v>0.54695534331401419</c:v>
                </c:pt>
                <c:pt idx="189">
                  <c:v>0.58151250696610302</c:v>
                </c:pt>
                <c:pt idx="190">
                  <c:v>0.61599048007648149</c:v>
                </c:pt>
                <c:pt idx="191">
                  <c:v>0.65037403814281824</c:v>
                </c:pt>
                <c:pt idx="192">
                  <c:v>0.68464799835380941</c:v>
                </c:pt>
                <c:pt idx="193">
                  <c:v>0.7187972262934762</c:v>
                </c:pt>
                <c:pt idx="194">
                  <c:v>0.75280664262410113</c:v>
                </c:pt>
                <c:pt idx="195">
                  <c:v>0.78666122974483599</c:v>
                </c:pt>
                <c:pt idx="196">
                  <c:v>0.82034603842305387</c:v>
                </c:pt>
                <c:pt idx="197">
                  <c:v>0.85384619439550913</c:v>
                </c:pt>
                <c:pt idx="198">
                  <c:v>0.88714690493639126</c:v>
                </c:pt>
                <c:pt idx="199">
                  <c:v>0.92023346538937978</c:v>
                </c:pt>
                <c:pt idx="200">
                  <c:v>0.95309126566080249</c:v>
                </c:pt>
                <c:pt idx="201">
                  <c:v>0.98570579667104463</c:v>
                </c:pt>
                <c:pt idx="202">
                  <c:v>1.0180626567613489</c:v>
                </c:pt>
                <c:pt idx="203">
                  <c:v>1.0501475580531818</c:v>
                </c:pt>
                <c:pt idx="204">
                  <c:v>1.0819463327573597</c:v>
                </c:pt>
                <c:pt idx="205">
                  <c:v>1.1134449394301456</c:v>
                </c:pt>
                <c:pt idx="206">
                  <c:v>1.1446294691735543</c:v>
                </c:pt>
                <c:pt idx="207">
                  <c:v>1.175486151777132</c:v>
                </c:pt>
                <c:pt idx="208">
                  <c:v>1.2060013617984917</c:v>
                </c:pt>
                <c:pt idx="209">
                  <c:v>1.2361616245799261</c:v>
                </c:pt>
                <c:pt idx="210">
                  <c:v>1.2659536221984371</c:v>
                </c:pt>
                <c:pt idx="211">
                  <c:v>1.2953641993465554</c:v>
                </c:pt>
                <c:pt idx="212">
                  <c:v>1.324380369141354</c:v>
                </c:pt>
                <c:pt idx="213">
                  <c:v>1.35298931885909</c:v>
                </c:pt>
                <c:pt idx="214">
                  <c:v>1.3811784155929419</c:v>
                </c:pt>
                <c:pt idx="215">
                  <c:v>1.408935211831349</c:v>
                </c:pt>
                <c:pt idx="216">
                  <c:v>1.4362474509544774</c:v>
                </c:pt>
                <c:pt idx="217">
                  <c:v>1.4631030726464018</c:v>
                </c:pt>
                <c:pt idx="218">
                  <c:v>1.4894902182205989</c:v>
                </c:pt>
                <c:pt idx="219">
                  <c:v>1.5153972358564121</c:v>
                </c:pt>
                <c:pt idx="220">
                  <c:v>1.5408126857441653</c:v>
                </c:pt>
                <c:pt idx="221">
                  <c:v>1.5657253451366626</c:v>
                </c:pt>
                <c:pt idx="222">
                  <c:v>1.5901242133048361</c:v>
                </c:pt>
                <c:pt idx="223">
                  <c:v>1.6139985163953587</c:v>
                </c:pt>
                <c:pt idx="224">
                  <c:v>1.637337712188075</c:v>
                </c:pt>
                <c:pt idx="225">
                  <c:v>1.6601314947511479</c:v>
                </c:pt>
                <c:pt idx="226">
                  <c:v>1.6823697989918687</c:v>
                </c:pt>
                <c:pt idx="227">
                  <c:v>1.7040428051011189</c:v>
                </c:pt>
                <c:pt idx="228">
                  <c:v>1.7251409428895201</c:v>
                </c:pt>
                <c:pt idx="229">
                  <c:v>1.7456548960133624</c:v>
                </c:pt>
                <c:pt idx="230">
                  <c:v>1.7655756060884371</c:v>
                </c:pt>
                <c:pt idx="231">
                  <c:v>1.7848942766899663</c:v>
                </c:pt>
                <c:pt idx="232">
                  <c:v>1.8036023772368548</c:v>
                </c:pt>
                <c:pt idx="233">
                  <c:v>1.821691646758556</c:v>
                </c:pt>
                <c:pt idx="234">
                  <c:v>1.8391540975428826</c:v>
                </c:pt>
                <c:pt idx="235">
                  <c:v>1.8559820186631562</c:v>
                </c:pt>
                <c:pt idx="236">
                  <c:v>1.8721679793831356</c:v>
                </c:pt>
                <c:pt idx="237">
                  <c:v>1.88770483243822</c:v>
                </c:pt>
                <c:pt idx="238">
                  <c:v>1.9025857171914811</c:v>
                </c:pt>
                <c:pt idx="239">
                  <c:v>1.9168040626631253</c:v>
                </c:pt>
                <c:pt idx="240">
                  <c:v>1.9303535904320552</c:v>
                </c:pt>
                <c:pt idx="241">
                  <c:v>1.9432283174082432</c:v>
                </c:pt>
                <c:pt idx="242">
                  <c:v>1.9554225584746938</c:v>
                </c:pt>
                <c:pt idx="243">
                  <c:v>1.9669309289978354</c:v>
                </c:pt>
                <c:pt idx="244">
                  <c:v>1.9777483472052184</c:v>
                </c:pt>
                <c:pt idx="245">
                  <c:v>1.9878700364294852</c:v>
                </c:pt>
                <c:pt idx="246">
                  <c:v>1.9972915272176111</c:v>
                </c:pt>
                <c:pt idx="247">
                  <c:v>2.0060086593044901</c:v>
                </c:pt>
                <c:pt idx="248">
                  <c:v>2.01401758344999</c:v>
                </c:pt>
                <c:pt idx="249">
                  <c:v>2.0213147631386685</c:v>
                </c:pt>
                <c:pt idx="250">
                  <c:v>2.0278969761413994</c:v>
                </c:pt>
                <c:pt idx="251">
                  <c:v>2.0337613159382171</c:v>
                </c:pt>
                <c:pt idx="252">
                  <c:v>2.0389051930017548</c:v>
                </c:pt>
                <c:pt idx="253">
                  <c:v>2.0433263359407086</c:v>
                </c:pt>
                <c:pt idx="254">
                  <c:v>2.0470227925028155</c:v>
                </c:pt>
                <c:pt idx="255">
                  <c:v>2.0499929304369182</c:v>
                </c:pt>
                <c:pt idx="256">
                  <c:v>2.0522354382137178</c:v>
                </c:pt>
                <c:pt idx="257">
                  <c:v>2.0537493256049082</c:v>
                </c:pt>
                <c:pt idx="258">
                  <c:v>2.0545339241204359</c:v>
                </c:pt>
                <c:pt idx="259">
                  <c:v>2.0545888873036842</c:v>
                </c:pt>
                <c:pt idx="260">
                  <c:v>2.0539141908844574</c:v>
                </c:pt>
                <c:pt idx="261">
                  <c:v>2.0525101327897022</c:v>
                </c:pt>
                <c:pt idx="262">
                  <c:v>2.0503773330119461</c:v>
                </c:pt>
                <c:pt idx="263">
                  <c:v>2.0475167333355309</c:v>
                </c:pt>
                <c:pt idx="264">
                  <c:v>2.0439295969207447</c:v>
                </c:pt>
                <c:pt idx="265">
                  <c:v>2.0396175077460459</c:v>
                </c:pt>
                <c:pt idx="266">
                  <c:v>2.0345823699086241</c:v>
                </c:pt>
                <c:pt idx="267">
                  <c:v>2.0288264067836028</c:v>
                </c:pt>
                <c:pt idx="268">
                  <c:v>2.0223521600422609</c:v>
                </c:pt>
                <c:pt idx="269">
                  <c:v>2.015162488529703</c:v>
                </c:pt>
                <c:pt idx="270">
                  <c:v>2.0072605670024708</c:v>
                </c:pt>
                <c:pt idx="271">
                  <c:v>1.9986498847266629</c:v>
                </c:pt>
                <c:pt idx="272">
                  <c:v>1.9893342439371713</c:v>
                </c:pt>
                <c:pt idx="273">
                  <c:v>1.9793177581587229</c:v>
                </c:pt>
                <c:pt idx="274">
                  <c:v>1.9686048503894615</c:v>
                </c:pt>
                <c:pt idx="275">
                  <c:v>1.9572002511478777</c:v>
                </c:pt>
                <c:pt idx="276">
                  <c:v>1.9451089963839439</c:v>
                </c:pt>
                <c:pt idx="277">
                  <c:v>1.932336425255381</c:v>
                </c:pt>
                <c:pt idx="278">
                  <c:v>1.9188881777700373</c:v>
                </c:pt>
                <c:pt idx="279">
                  <c:v>1.9047701922954183</c:v>
                </c:pt>
                <c:pt idx="280">
                  <c:v>1.8899887029364721</c:v>
                </c:pt>
                <c:pt idx="281">
                  <c:v>1.874550236782784</c:v>
                </c:pt>
                <c:pt idx="282">
                  <c:v>1.8584616110263965</c:v>
                </c:pt>
                <c:pt idx="283">
                  <c:v>1.8417299299515306</c:v>
                </c:pt>
                <c:pt idx="284">
                  <c:v>1.8243625817975326</c:v>
                </c:pt>
                <c:pt idx="285">
                  <c:v>1.8063672354964369</c:v>
                </c:pt>
                <c:pt idx="286">
                  <c:v>1.7877518372865804</c:v>
                </c:pt>
                <c:pt idx="287">
                  <c:v>1.7685246072037675</c:v>
                </c:pt>
                <c:pt idx="288">
                  <c:v>1.7486940354515337</c:v>
                </c:pt>
                <c:pt idx="289">
                  <c:v>1.7282688786521123</c:v>
                </c:pt>
                <c:pt idx="290">
                  <c:v>1.7072581559797539</c:v>
                </c:pt>
                <c:pt idx="291">
                  <c:v>1.6856711451781143</c:v>
                </c:pt>
                <c:pt idx="292">
                  <c:v>1.6635173784634651</c:v>
                </c:pt>
                <c:pt idx="293">
                  <c:v>1.6408066383155329</c:v>
                </c:pt>
                <c:pt idx="294">
                  <c:v>1.6175489531578338</c:v>
                </c:pt>
                <c:pt idx="295">
                  <c:v>1.5937545929294026</c:v>
                </c:pt>
                <c:pt idx="296">
                  <c:v>1.5694340645498777</c:v>
                </c:pt>
                <c:pt idx="297">
                  <c:v>1.5445981072799411</c:v>
                </c:pt>
                <c:pt idx="298">
                  <c:v>1.5192576879791624</c:v>
                </c:pt>
                <c:pt idx="299">
                  <c:v>1.493423996263343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4044664"/>
        <c:axId val="283420584"/>
      </c:scatterChart>
      <c:valAx>
        <c:axId val="484044664"/>
        <c:scaling>
          <c:orientation val="minMax"/>
          <c:max val="3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420584"/>
        <c:crosses val="autoZero"/>
        <c:crossBetween val="midCat"/>
      </c:valAx>
      <c:valAx>
        <c:axId val="283420584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484044664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03089036947306"/>
          <c:y val="0.15250000000000002"/>
          <c:w val="0.6520752574197457"/>
          <c:h val="0.71158333333333323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003CE6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003CE6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S$1:$S$15</c:f>
              <c:numCache>
                <c:formatCode>General</c:formatCode>
                <c:ptCount val="15"/>
                <c:pt idx="0">
                  <c:v>20.12323</c:v>
                </c:pt>
                <c:pt idx="1">
                  <c:v>0</c:v>
                </c:pt>
                <c:pt idx="2">
                  <c:v>0</c:v>
                </c:pt>
                <c:pt idx="3">
                  <c:v>9.9573979999999995</c:v>
                </c:pt>
                <c:pt idx="4">
                  <c:v>7.3840649999999997</c:v>
                </c:pt>
                <c:pt idx="5">
                  <c:v>182.50299999999999</c:v>
                </c:pt>
                <c:pt idx="6">
                  <c:v>215.07159999999999</c:v>
                </c:pt>
                <c:pt idx="7">
                  <c:v>168.19290000000001</c:v>
                </c:pt>
                <c:pt idx="8">
                  <c:v>170.3449</c:v>
                </c:pt>
                <c:pt idx="9">
                  <c:v>169.62780000000001</c:v>
                </c:pt>
                <c:pt idx="10">
                  <c:v>109.4692</c:v>
                </c:pt>
                <c:pt idx="11">
                  <c:v>104.2452</c:v>
                </c:pt>
                <c:pt idx="12">
                  <c:v>130.61089999999999</c:v>
                </c:pt>
                <c:pt idx="13">
                  <c:v>122.6031</c:v>
                </c:pt>
                <c:pt idx="14">
                  <c:v>129.15620000000001</c:v>
                </c:pt>
              </c:numCache>
            </c:numRef>
          </c:xVal>
          <c:yVal>
            <c:numRef>
              <c:f>'Covariance   Correlation3_HID4'!$T$1:$T$15</c:f>
              <c:numCache>
                <c:formatCode>General</c:formatCode>
                <c:ptCount val="15"/>
                <c:pt idx="0">
                  <c:v>1.0531999999999999</c:v>
                </c:pt>
                <c:pt idx="1">
                  <c:v>1.6315999999999999</c:v>
                </c:pt>
                <c:pt idx="2">
                  <c:v>1.4011</c:v>
                </c:pt>
                <c:pt idx="3">
                  <c:v>5.6500000000000002E-2</c:v>
                </c:pt>
                <c:pt idx="4">
                  <c:v>0.2228999999999999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E-3</c:v>
                </c:pt>
                <c:pt idx="9">
                  <c:v>0</c:v>
                </c:pt>
                <c:pt idx="10">
                  <c:v>0.48499999999999999</c:v>
                </c:pt>
                <c:pt idx="11">
                  <c:v>0.84172000000000002</c:v>
                </c:pt>
                <c:pt idx="12">
                  <c:v>3.6700000000000003E-2</c:v>
                </c:pt>
                <c:pt idx="13">
                  <c:v>0.17710000000000001</c:v>
                </c:pt>
                <c:pt idx="14">
                  <c:v>0.1247999999999999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12</c:f>
              <c:numCache>
                <c:formatCode>General</c:formatCode>
                <c:ptCount val="300"/>
                <c:pt idx="0">
                  <c:v>-121.20560024334098</c:v>
                </c:pt>
                <c:pt idx="1">
                  <c:v>-121.15618285593435</c:v>
                </c:pt>
                <c:pt idx="2">
                  <c:v>-121.00795251504154</c:v>
                </c:pt>
                <c:pt idx="3">
                  <c:v>-120.76097467500826</c:v>
                </c:pt>
                <c:pt idx="4">
                  <c:v>-120.41535839429595</c:v>
                </c:pt>
                <c:pt idx="5">
                  <c:v>-119.97125628732472</c:v>
                </c:pt>
                <c:pt idx="6">
                  <c:v>-119.42886445708298</c:v>
                </c:pt>
                <c:pt idx="7">
                  <c:v>-118.78842240853403</c:v>
                </c:pt>
                <c:pt idx="8">
                  <c:v>-118.0502129428573</c:v>
                </c:pt>
                <c:pt idx="9">
                  <c:v>-117.21456203257144</c:v>
                </c:pt>
                <c:pt idx="10">
                  <c:v>-116.28183867759385</c:v>
                </c:pt>
                <c:pt idx="11">
                  <c:v>-115.25245474230088</c:v>
                </c:pt>
                <c:pt idx="12">
                  <c:v>-114.12686477366002</c:v>
                </c:pt>
                <c:pt idx="13">
                  <c:v>-112.90556580051474</c:v>
                </c:pt>
                <c:pt idx="14">
                  <c:v>-111.58909711411066</c:v>
                </c:pt>
                <c:pt idx="15">
                  <c:v>-110.17804002995952</c:v>
                </c:pt>
                <c:pt idx="16">
                  <c:v>-108.67301763114686</c:v>
                </c:pt>
                <c:pt idx="17">
                  <c:v>-107.07469449319588</c:v>
                </c:pt>
                <c:pt idx="18">
                  <c:v>-105.38377639060964</c:v>
                </c:pt>
                <c:pt idx="19">
                  <c:v>-103.60100998522098</c:v>
                </c:pt>
                <c:pt idx="20">
                  <c:v>-101.7271824964876</c:v>
                </c:pt>
                <c:pt idx="21">
                  <c:v>-99.763121353878105</c:v>
                </c:pt>
                <c:pt idx="22">
                  <c:v>-97.709693831502491</c:v>
                </c:pt>
                <c:pt idx="23">
                  <c:v>-95.567806665148382</c:v>
                </c:pt>
                <c:pt idx="24">
                  <c:v>-93.338405651891733</c:v>
                </c:pt>
                <c:pt idx="25">
                  <c:v>-91.022475232459826</c:v>
                </c:pt>
                <c:pt idx="26">
                  <c:v>-88.621038056529827</c:v>
                </c:pt>
                <c:pt idx="27">
                  <c:v>-86.135154531155351</c:v>
                </c:pt>
                <c:pt idx="28">
                  <c:v>-83.565922352520758</c:v>
                </c:pt>
                <c:pt idx="29">
                  <c:v>-80.914476021229333</c:v>
                </c:pt>
                <c:pt idx="30">
                  <c:v>-78.181986341339652</c:v>
                </c:pt>
                <c:pt idx="31">
                  <c:v>-75.369659903371641</c:v>
                </c:pt>
                <c:pt idx="32">
                  <c:v>-72.478738551510119</c:v>
                </c:pt>
                <c:pt idx="33">
                  <c:v>-69.510498835241307</c:v>
                </c:pt>
                <c:pt idx="34">
                  <c:v>-66.466251445664582</c:v>
                </c:pt>
                <c:pt idx="35">
                  <c:v>-63.347340636727992</c:v>
                </c:pt>
                <c:pt idx="36">
                  <c:v>-60.155143631643952</c:v>
                </c:pt>
                <c:pt idx="37">
                  <c:v>-56.891070014745836</c:v>
                </c:pt>
                <c:pt idx="38">
                  <c:v>-53.556561109055465</c:v>
                </c:pt>
                <c:pt idx="39">
                  <c:v>-50.153089339835375</c:v>
                </c:pt>
                <c:pt idx="40">
                  <c:v>-46.682157584407165</c:v>
                </c:pt>
                <c:pt idx="41">
                  <c:v>-43.145298508523283</c:v>
                </c:pt>
                <c:pt idx="42">
                  <c:v>-39.544073889585107</c:v>
                </c:pt>
                <c:pt idx="43">
                  <c:v>-35.880073927005625</c:v>
                </c:pt>
                <c:pt idx="44">
                  <c:v>-32.154916540022569</c:v>
                </c:pt>
                <c:pt idx="45">
                  <c:v>-28.37024665327057</c:v>
                </c:pt>
                <c:pt idx="46">
                  <c:v>-24.527735470428794</c:v>
                </c:pt>
                <c:pt idx="47">
                  <c:v>-20.629079736264472</c:v>
                </c:pt>
                <c:pt idx="48">
                  <c:v>-16.676000987398197</c:v>
                </c:pt>
                <c:pt idx="49">
                  <c:v>-12.670244792121736</c:v>
                </c:pt>
                <c:pt idx="50">
                  <c:v>-8.6135799796043244</c:v>
                </c:pt>
                <c:pt idx="51">
                  <c:v>-4.5077978588273453</c:v>
                </c:pt>
                <c:pt idx="52">
                  <c:v>-0.35471142759286067</c:v>
                </c:pt>
                <c:pt idx="53">
                  <c:v>3.8438454280452277</c:v>
                </c:pt>
                <c:pt idx="54">
                  <c:v>8.0860187435735895</c:v>
                </c:pt>
                <c:pt idx="55">
                  <c:v>12.369935294678328</c:v>
                </c:pt>
                <c:pt idx="56">
                  <c:v>16.693703424407573</c:v>
                </c:pt>
                <c:pt idx="57">
                  <c:v>21.055413878474255</c:v>
                </c:pt>
                <c:pt idx="58">
                  <c:v>25.453140648329011</c:v>
                </c:pt>
                <c:pt idx="59">
                  <c:v>29.884941821631358</c:v>
                </c:pt>
                <c:pt idx="60">
                  <c:v>34.348860439743447</c:v>
                </c:pt>
                <c:pt idx="61">
                  <c:v>38.842925361867913</c:v>
                </c:pt>
                <c:pt idx="62">
                  <c:v>43.365152135448326</c:v>
                </c:pt>
                <c:pt idx="63">
                  <c:v>47.91354387244732</c:v>
                </c:pt>
                <c:pt idx="64">
                  <c:v>52.486092131116287</c:v>
                </c:pt>
                <c:pt idx="65">
                  <c:v>57.080777802866677</c:v>
                </c:pt>
                <c:pt idx="66">
                  <c:v>61.695572003851531</c:v>
                </c:pt>
                <c:pt idx="67">
                  <c:v>66.32843697086345</c:v>
                </c:pt>
                <c:pt idx="68">
                  <c:v>70.977326961153437</c:v>
                </c:pt>
                <c:pt idx="69">
                  <c:v>75.640189155773442</c:v>
                </c:pt>
                <c:pt idx="70">
                  <c:v>80.314964566043244</c:v>
                </c:pt>
                <c:pt idx="71">
                  <c:v>84.999588942741923</c:v>
                </c:pt>
                <c:pt idx="72">
                  <c:v>89.691993687622329</c:v>
                </c:pt>
                <c:pt idx="73">
                  <c:v>94.390106766845676</c:v>
                </c:pt>
                <c:pt idx="74">
                  <c:v>99.091853625933467</c:v>
                </c:pt>
                <c:pt idx="75">
                  <c:v>103.79515810583227</c:v>
                </c:pt>
                <c:pt idx="76">
                  <c:v>108.49794335968728</c:v>
                </c:pt>
                <c:pt idx="77">
                  <c:v>113.19813276991914</c:v>
                </c:pt>
                <c:pt idx="78">
                  <c:v>117.89365086520004</c:v>
                </c:pt>
                <c:pt idx="79">
                  <c:v>122.58242423692333</c:v>
                </c:pt>
                <c:pt idx="80">
                  <c:v>127.26238245476242</c:v>
                </c:pt>
                <c:pt idx="81">
                  <c:v>131.93145898091447</c:v>
                </c:pt>
                <c:pt idx="82">
                  <c:v>136.58759208262543</c:v>
                </c:pt>
                <c:pt idx="83">
                  <c:v>141.2287257425931</c:v>
                </c:pt>
                <c:pt idx="84">
                  <c:v>145.8528105668465</c:v>
                </c:pt>
                <c:pt idx="85">
                  <c:v>150.45780468970051</c:v>
                </c:pt>
                <c:pt idx="86">
                  <c:v>155.04167467538633</c:v>
                </c:pt>
                <c:pt idx="87">
                  <c:v>159.60239641595956</c:v>
                </c:pt>
                <c:pt idx="88">
                  <c:v>164.13795602508904</c:v>
                </c:pt>
                <c:pt idx="89">
                  <c:v>168.64635072733256</c:v>
                </c:pt>
                <c:pt idx="90">
                  <c:v>173.12558974250624</c:v>
                </c:pt>
                <c:pt idx="91">
                  <c:v>177.57369516475663</c:v>
                </c:pt>
                <c:pt idx="92">
                  <c:v>181.98870283594854</c:v>
                </c:pt>
                <c:pt idx="93">
                  <c:v>186.36866321298191</c:v>
                </c:pt>
                <c:pt idx="94">
                  <c:v>190.71164222865517</c:v>
                </c:pt>
                <c:pt idx="95">
                  <c:v>195.01572214569484</c:v>
                </c:pt>
                <c:pt idx="96">
                  <c:v>199.27900240357431</c:v>
                </c:pt>
                <c:pt idx="97">
                  <c:v>203.49960045774802</c:v>
                </c:pt>
                <c:pt idx="98">
                  <c:v>207.67565261092989</c:v>
                </c:pt>
                <c:pt idx="99">
                  <c:v>211.80531483604975</c:v>
                </c:pt>
                <c:pt idx="100">
                  <c:v>215.88676359052371</c:v>
                </c:pt>
                <c:pt idx="101">
                  <c:v>219.91819662147924</c:v>
                </c:pt>
                <c:pt idx="102">
                  <c:v>223.89783376157942</c:v>
                </c:pt>
                <c:pt idx="103">
                  <c:v>227.8239177150945</c:v>
                </c:pt>
                <c:pt idx="104">
                  <c:v>231.69471483387434</c:v>
                </c:pt>
                <c:pt idx="105">
                  <c:v>235.50851588287873</c:v>
                </c:pt>
                <c:pt idx="106">
                  <c:v>239.26363679492727</c:v>
                </c:pt>
                <c:pt idx="107">
                  <c:v>242.95841941433616</c:v>
                </c:pt>
                <c:pt idx="108">
                  <c:v>246.59123222911313</c:v>
                </c:pt>
                <c:pt idx="109">
                  <c:v>250.16047109138697</c:v>
                </c:pt>
                <c:pt idx="110">
                  <c:v>253.6645599257543</c:v>
                </c:pt>
                <c:pt idx="111">
                  <c:v>257.10195142522991</c:v>
                </c:pt>
                <c:pt idx="112">
                  <c:v>260.47112773449425</c:v>
                </c:pt>
                <c:pt idx="113">
                  <c:v>263.77060112013527</c:v>
                </c:pt>
                <c:pt idx="114">
                  <c:v>266.9989146275899</c:v>
                </c:pt>
                <c:pt idx="115">
                  <c:v>270.1546427244939</c:v>
                </c:pt>
                <c:pt idx="116">
                  <c:v>273.23639193015714</c:v>
                </c:pt>
                <c:pt idx="117">
                  <c:v>276.24280143088509</c:v>
                </c:pt>
                <c:pt idx="118">
                  <c:v>279.17254368087623</c:v>
                </c:pt>
                <c:pt idx="119">
                  <c:v>282.02432498842842</c:v>
                </c:pt>
                <c:pt idx="120">
                  <c:v>284.79688608719727</c:v>
                </c:pt>
                <c:pt idx="121">
                  <c:v>287.48900269225226</c:v>
                </c:pt>
                <c:pt idx="122">
                  <c:v>290.09948604068688</c:v>
                </c:pt>
                <c:pt idx="123">
                  <c:v>292.62718341654249</c:v>
                </c:pt>
                <c:pt idx="124">
                  <c:v>295.07097865981558</c:v>
                </c:pt>
                <c:pt idx="125">
                  <c:v>297.42979265932235</c:v>
                </c:pt>
                <c:pt idx="126">
                  <c:v>299.70258382920377</c:v>
                </c:pt>
                <c:pt idx="127">
                  <c:v>301.88834856886115</c:v>
                </c:pt>
                <c:pt idx="128">
                  <c:v>303.9861217061171</c:v>
                </c:pt>
                <c:pt idx="129">
                  <c:v>305.99497692340896</c:v>
                </c:pt>
                <c:pt idx="130">
                  <c:v>307.91402716682433</c:v>
                </c:pt>
                <c:pt idx="131">
                  <c:v>309.74242503779925</c:v>
                </c:pt>
                <c:pt idx="132">
                  <c:v>311.47936316730539</c:v>
                </c:pt>
                <c:pt idx="133">
                  <c:v>313.12407457236151</c:v>
                </c:pt>
                <c:pt idx="134">
                  <c:v>314.6758329947117</c:v>
                </c:pt>
                <c:pt idx="135">
                  <c:v>316.13395322152041</c:v>
                </c:pt>
                <c:pt idx="136">
                  <c:v>317.49779138794321</c:v>
                </c:pt>
                <c:pt idx="137">
                  <c:v>318.7667452614395</c:v>
                </c:pt>
                <c:pt idx="138">
                  <c:v>319.94025450770118</c:v>
                </c:pt>
                <c:pt idx="139">
                  <c:v>321.01780093808077</c:v>
                </c:pt>
                <c:pt idx="140">
                  <c:v>321.99890873840877</c:v>
                </c:pt>
                <c:pt idx="141">
                  <c:v>322.88314467909993</c:v>
                </c:pt>
                <c:pt idx="142">
                  <c:v>323.67011830645498</c:v>
                </c:pt>
                <c:pt idx="143">
                  <c:v>324.3594821150744</c:v>
                </c:pt>
                <c:pt idx="144">
                  <c:v>324.95093170130662</c:v>
                </c:pt>
                <c:pt idx="145">
                  <c:v>325.4442058976644</c:v>
                </c:pt>
                <c:pt idx="146">
                  <c:v>325.83908688814881</c:v>
                </c:pt>
                <c:pt idx="147">
                  <c:v>326.13540030443085</c:v>
                </c:pt>
                <c:pt idx="148">
                  <c:v>326.3330153028474</c:v>
                </c:pt>
                <c:pt idx="149">
                  <c:v>326.43184462217829</c:v>
                </c:pt>
                <c:pt idx="150">
                  <c:v>326.43184462217829</c:v>
                </c:pt>
                <c:pt idx="151">
                  <c:v>326.33301530284729</c:v>
                </c:pt>
                <c:pt idx="152">
                  <c:v>326.13540030443068</c:v>
                </c:pt>
                <c:pt idx="153">
                  <c:v>325.83908688814859</c:v>
                </c:pt>
                <c:pt idx="154">
                  <c:v>325.44420589766412</c:v>
                </c:pt>
                <c:pt idx="155">
                  <c:v>324.95093170130627</c:v>
                </c:pt>
                <c:pt idx="156">
                  <c:v>324.35948211507394</c:v>
                </c:pt>
                <c:pt idx="157">
                  <c:v>323.67011830645447</c:v>
                </c:pt>
                <c:pt idx="158">
                  <c:v>322.8831446790993</c:v>
                </c:pt>
                <c:pt idx="159">
                  <c:v>321.99890873840815</c:v>
                </c:pt>
                <c:pt idx="160">
                  <c:v>321.01780093808003</c:v>
                </c:pt>
                <c:pt idx="161">
                  <c:v>319.94025450770039</c:v>
                </c:pt>
                <c:pt idx="162">
                  <c:v>318.76674526143859</c:v>
                </c:pt>
                <c:pt idx="163">
                  <c:v>317.49779138794224</c:v>
                </c:pt>
                <c:pt idx="164">
                  <c:v>316.13395322151939</c:v>
                </c:pt>
                <c:pt idx="165">
                  <c:v>314.67583299471062</c:v>
                </c:pt>
                <c:pt idx="166">
                  <c:v>313.12407457236037</c:v>
                </c:pt>
                <c:pt idx="167">
                  <c:v>311.4793631673042</c:v>
                </c:pt>
                <c:pt idx="168">
                  <c:v>309.742425037798</c:v>
                </c:pt>
                <c:pt idx="169">
                  <c:v>307.91402716682302</c:v>
                </c:pt>
                <c:pt idx="170">
                  <c:v>305.99497692340759</c:v>
                </c:pt>
                <c:pt idx="171">
                  <c:v>303.98612170611568</c:v>
                </c:pt>
                <c:pt idx="172">
                  <c:v>301.88834856885967</c:v>
                </c:pt>
                <c:pt idx="173">
                  <c:v>299.70258382920224</c:v>
                </c:pt>
                <c:pt idx="174">
                  <c:v>297.4297926593207</c:v>
                </c:pt>
                <c:pt idx="175">
                  <c:v>295.07097865981393</c:v>
                </c:pt>
                <c:pt idx="176">
                  <c:v>292.62718341654079</c:v>
                </c:pt>
                <c:pt idx="177">
                  <c:v>290.09948604068506</c:v>
                </c:pt>
                <c:pt idx="178">
                  <c:v>287.48900269225044</c:v>
                </c:pt>
                <c:pt idx="179">
                  <c:v>284.79688608719533</c:v>
                </c:pt>
                <c:pt idx="180">
                  <c:v>282.02432498842643</c:v>
                </c:pt>
                <c:pt idx="181">
                  <c:v>279.17254368087418</c:v>
                </c:pt>
                <c:pt idx="182">
                  <c:v>276.24280143088305</c:v>
                </c:pt>
                <c:pt idx="183">
                  <c:v>273.23639193015504</c:v>
                </c:pt>
                <c:pt idx="184">
                  <c:v>270.15464272449174</c:v>
                </c:pt>
                <c:pt idx="185">
                  <c:v>266.99891462758768</c:v>
                </c:pt>
                <c:pt idx="186">
                  <c:v>263.77060112013299</c:v>
                </c:pt>
                <c:pt idx="187">
                  <c:v>260.47112773449192</c:v>
                </c:pt>
                <c:pt idx="188">
                  <c:v>257.10195142522753</c:v>
                </c:pt>
                <c:pt idx="189">
                  <c:v>253.66455992575186</c:v>
                </c:pt>
                <c:pt idx="190">
                  <c:v>250.16047109138447</c:v>
                </c:pt>
                <c:pt idx="191">
                  <c:v>246.59123222911069</c:v>
                </c:pt>
                <c:pt idx="192">
                  <c:v>242.95841941433366</c:v>
                </c:pt>
                <c:pt idx="193">
                  <c:v>239.26363679492471</c:v>
                </c:pt>
                <c:pt idx="194">
                  <c:v>235.50851588287611</c:v>
                </c:pt>
                <c:pt idx="195">
                  <c:v>231.69471483387167</c:v>
                </c:pt>
                <c:pt idx="196">
                  <c:v>227.8239177150918</c:v>
                </c:pt>
                <c:pt idx="197">
                  <c:v>223.89783376157666</c:v>
                </c:pt>
                <c:pt idx="198">
                  <c:v>219.91819662147645</c:v>
                </c:pt>
                <c:pt idx="199">
                  <c:v>215.88676359052087</c:v>
                </c:pt>
                <c:pt idx="200">
                  <c:v>211.80531483604688</c:v>
                </c:pt>
                <c:pt idx="201">
                  <c:v>207.67565261092699</c:v>
                </c:pt>
                <c:pt idx="202">
                  <c:v>203.49960045774509</c:v>
                </c:pt>
                <c:pt idx="203">
                  <c:v>199.27900240357135</c:v>
                </c:pt>
                <c:pt idx="204">
                  <c:v>195.01572214569183</c:v>
                </c:pt>
                <c:pt idx="205">
                  <c:v>190.71164222865212</c:v>
                </c:pt>
                <c:pt idx="206">
                  <c:v>186.36866321297884</c:v>
                </c:pt>
                <c:pt idx="207">
                  <c:v>181.98870283594545</c:v>
                </c:pt>
                <c:pt idx="208">
                  <c:v>177.5736951647535</c:v>
                </c:pt>
                <c:pt idx="209">
                  <c:v>173.12558974250308</c:v>
                </c:pt>
                <c:pt idx="210">
                  <c:v>168.64635072732938</c:v>
                </c:pt>
                <c:pt idx="211">
                  <c:v>164.13795602508577</c:v>
                </c:pt>
                <c:pt idx="212">
                  <c:v>159.60239641595626</c:v>
                </c:pt>
                <c:pt idx="213">
                  <c:v>155.04167467538306</c:v>
                </c:pt>
                <c:pt idx="214">
                  <c:v>150.45780468969741</c:v>
                </c:pt>
                <c:pt idx="215">
                  <c:v>145.85281056684337</c:v>
                </c:pt>
                <c:pt idx="216">
                  <c:v>141.22872574258997</c:v>
                </c:pt>
                <c:pt idx="217">
                  <c:v>136.58759208262228</c:v>
                </c:pt>
                <c:pt idx="218">
                  <c:v>131.93145898091129</c:v>
                </c:pt>
                <c:pt idx="219">
                  <c:v>127.26238245475921</c:v>
                </c:pt>
                <c:pt idx="220">
                  <c:v>122.5824242369201</c:v>
                </c:pt>
                <c:pt idx="221">
                  <c:v>117.89365086519682</c:v>
                </c:pt>
                <c:pt idx="222">
                  <c:v>113.19813276991592</c:v>
                </c:pt>
                <c:pt idx="223">
                  <c:v>108.49794335968404</c:v>
                </c:pt>
                <c:pt idx="224">
                  <c:v>103.79515810582905</c:v>
                </c:pt>
                <c:pt idx="225">
                  <c:v>99.091853625930199</c:v>
                </c:pt>
                <c:pt idx="226">
                  <c:v>94.390106766842393</c:v>
                </c:pt>
                <c:pt idx="227">
                  <c:v>89.691993687619046</c:v>
                </c:pt>
                <c:pt idx="228">
                  <c:v>84.999588942738654</c:v>
                </c:pt>
                <c:pt idx="229">
                  <c:v>80.314964566039976</c:v>
                </c:pt>
                <c:pt idx="230">
                  <c:v>75.640189155770187</c:v>
                </c:pt>
                <c:pt idx="231">
                  <c:v>70.977326961150183</c:v>
                </c:pt>
                <c:pt idx="232">
                  <c:v>66.328436970860167</c:v>
                </c:pt>
                <c:pt idx="233">
                  <c:v>61.695572003848262</c:v>
                </c:pt>
                <c:pt idx="234">
                  <c:v>57.080777802863423</c:v>
                </c:pt>
                <c:pt idx="235">
                  <c:v>52.48609213111304</c:v>
                </c:pt>
                <c:pt idx="236">
                  <c:v>47.913543872444102</c:v>
                </c:pt>
                <c:pt idx="237">
                  <c:v>43.365152135445122</c:v>
                </c:pt>
                <c:pt idx="238">
                  <c:v>38.842925361864715</c:v>
                </c:pt>
                <c:pt idx="239">
                  <c:v>34.348860439740221</c:v>
                </c:pt>
                <c:pt idx="240">
                  <c:v>29.884941821628161</c:v>
                </c:pt>
                <c:pt idx="241">
                  <c:v>25.453140648325828</c:v>
                </c:pt>
                <c:pt idx="242">
                  <c:v>21.055413878471285</c:v>
                </c:pt>
                <c:pt idx="243">
                  <c:v>16.693703424404632</c:v>
                </c:pt>
                <c:pt idx="244">
                  <c:v>12.369935294675429</c:v>
                </c:pt>
                <c:pt idx="245">
                  <c:v>8.0860187435707047</c:v>
                </c:pt>
                <c:pt idx="246">
                  <c:v>3.843845428042286</c:v>
                </c:pt>
                <c:pt idx="247">
                  <c:v>-0.35471142759578811</c:v>
                </c:pt>
                <c:pt idx="248">
                  <c:v>-4.5077978588302301</c:v>
                </c:pt>
                <c:pt idx="249">
                  <c:v>-8.6135799796071666</c:v>
                </c:pt>
                <c:pt idx="250">
                  <c:v>-12.670244792124578</c:v>
                </c:pt>
                <c:pt idx="251">
                  <c:v>-16.676000987400982</c:v>
                </c:pt>
                <c:pt idx="252">
                  <c:v>-20.629079736267215</c:v>
                </c:pt>
                <c:pt idx="253">
                  <c:v>-24.52773547043148</c:v>
                </c:pt>
                <c:pt idx="254">
                  <c:v>-28.370246653273242</c:v>
                </c:pt>
                <c:pt idx="255">
                  <c:v>-32.154916540025184</c:v>
                </c:pt>
                <c:pt idx="256">
                  <c:v>-35.880073927008212</c:v>
                </c:pt>
                <c:pt idx="257">
                  <c:v>-39.544073889587636</c:v>
                </c:pt>
                <c:pt idx="258">
                  <c:v>-43.145298508525784</c:v>
                </c:pt>
                <c:pt idx="259">
                  <c:v>-46.68215758440958</c:v>
                </c:pt>
                <c:pt idx="260">
                  <c:v>-50.153089339837763</c:v>
                </c:pt>
                <c:pt idx="261">
                  <c:v>-53.556561109057824</c:v>
                </c:pt>
                <c:pt idx="262">
                  <c:v>-56.891070014748138</c:v>
                </c:pt>
                <c:pt idx="263">
                  <c:v>-60.155143631646197</c:v>
                </c:pt>
                <c:pt idx="264">
                  <c:v>-63.347340636730209</c:v>
                </c:pt>
                <c:pt idx="265">
                  <c:v>-66.466251445666742</c:v>
                </c:pt>
                <c:pt idx="266">
                  <c:v>-69.510498835243467</c:v>
                </c:pt>
                <c:pt idx="267">
                  <c:v>-72.478738551512251</c:v>
                </c:pt>
                <c:pt idx="268">
                  <c:v>-75.369659903373716</c:v>
                </c:pt>
                <c:pt idx="269">
                  <c:v>-78.181986341341641</c:v>
                </c:pt>
                <c:pt idx="270">
                  <c:v>-80.914476021231238</c:v>
                </c:pt>
                <c:pt idx="271">
                  <c:v>-83.565922352522549</c:v>
                </c:pt>
                <c:pt idx="272">
                  <c:v>-86.135154531157056</c:v>
                </c:pt>
                <c:pt idx="273">
                  <c:v>-88.621038056531447</c:v>
                </c:pt>
                <c:pt idx="274">
                  <c:v>-91.022475232461417</c:v>
                </c:pt>
                <c:pt idx="275">
                  <c:v>-93.338405651893268</c:v>
                </c:pt>
                <c:pt idx="276">
                  <c:v>-95.56780666514986</c:v>
                </c:pt>
                <c:pt idx="277">
                  <c:v>-97.709693831503969</c:v>
                </c:pt>
                <c:pt idx="278">
                  <c:v>-99.763121353879527</c:v>
                </c:pt>
                <c:pt idx="279">
                  <c:v>-101.72718249648894</c:v>
                </c:pt>
                <c:pt idx="280">
                  <c:v>-103.60100998522229</c:v>
                </c:pt>
                <c:pt idx="281">
                  <c:v>-105.38377639061086</c:v>
                </c:pt>
                <c:pt idx="282">
                  <c:v>-107.07469449319704</c:v>
                </c:pt>
                <c:pt idx="283">
                  <c:v>-108.67301763114797</c:v>
                </c:pt>
                <c:pt idx="284">
                  <c:v>-110.17804002996054</c:v>
                </c:pt>
                <c:pt idx="285">
                  <c:v>-111.5890971141116</c:v>
                </c:pt>
                <c:pt idx="286">
                  <c:v>-112.90556580051562</c:v>
                </c:pt>
                <c:pt idx="287">
                  <c:v>-114.12686477366084</c:v>
                </c:pt>
                <c:pt idx="288">
                  <c:v>-115.25245474230162</c:v>
                </c:pt>
                <c:pt idx="289">
                  <c:v>-116.28183867759456</c:v>
                </c:pt>
                <c:pt idx="290">
                  <c:v>-117.21456203257206</c:v>
                </c:pt>
                <c:pt idx="291">
                  <c:v>-118.05021294285784</c:v>
                </c:pt>
                <c:pt idx="292">
                  <c:v>-118.78842240853452</c:v>
                </c:pt>
                <c:pt idx="293">
                  <c:v>-119.42886445708341</c:v>
                </c:pt>
                <c:pt idx="294">
                  <c:v>-119.97125628732506</c:v>
                </c:pt>
                <c:pt idx="295">
                  <c:v>-120.41535839429623</c:v>
                </c:pt>
                <c:pt idx="296">
                  <c:v>-120.76097467500846</c:v>
                </c:pt>
                <c:pt idx="297">
                  <c:v>-121.00795251504165</c:v>
                </c:pt>
                <c:pt idx="298">
                  <c:v>-121.1561828559344</c:v>
                </c:pt>
                <c:pt idx="299">
                  <c:v>-121.20560024334098</c:v>
                </c:pt>
              </c:numCache>
            </c:numRef>
          </c:xVal>
          <c:yVal>
            <c:numRef>
              <c:f>'Covariance   Correlation3'!yycir13</c:f>
              <c:numCache>
                <c:formatCode>General</c:formatCode>
                <c:ptCount val="300"/>
                <c:pt idx="0">
                  <c:v>1.5564446900317532</c:v>
                </c:pt>
                <c:pt idx="1">
                  <c:v>1.5313422229582523</c:v>
                </c:pt>
                <c:pt idx="2">
                  <c:v>1.5057411472792575</c:v>
                </c:pt>
                <c:pt idx="3">
                  <c:v>1.4796527677090885</c:v>
                </c:pt>
                <c:pt idx="4">
                  <c:v>1.4530886041417452</c:v>
                </c:pt>
                <c:pt idx="5">
                  <c:v>1.4260603865640484</c:v>
                </c:pt>
                <c:pt idx="6">
                  <c:v>1.3985800498760041</c:v>
                </c:pt>
                <c:pt idx="7">
                  <c:v>1.3706597286206916</c:v>
                </c:pt>
                <c:pt idx="8">
                  <c:v>1.3423117516259868</c:v>
                </c:pt>
                <c:pt idx="9">
                  <c:v>1.3135486365605034</c:v>
                </c:pt>
                <c:pt idx="10">
                  <c:v>1.2843830844061392</c:v>
                </c:pt>
                <c:pt idx="11">
                  <c:v>1.2548279738496817</c:v>
                </c:pt>
                <c:pt idx="12">
                  <c:v>1.2248963555959429</c:v>
                </c:pt>
                <c:pt idx="13">
                  <c:v>1.1946014466049335</c:v>
                </c:pt>
                <c:pt idx="14">
                  <c:v>1.1639566242556276</c:v>
                </c:pt>
                <c:pt idx="15">
                  <c:v>1.132975420438888</c:v>
                </c:pt>
                <c:pt idx="16">
                  <c:v>1.1016715155821633</c:v>
                </c:pt>
                <c:pt idx="17">
                  <c:v>1.0700587326085977</c:v>
                </c:pt>
                <c:pt idx="18">
                  <c:v>1.038151030833216</c:v>
                </c:pt>
                <c:pt idx="19">
                  <c:v>1.0059624997988839</c:v>
                </c:pt>
                <c:pt idx="20">
                  <c:v>0.97350735305476166</c:v>
                </c:pt>
                <c:pt idx="21">
                  <c:v>0.94079992188000172</c:v>
                </c:pt>
                <c:pt idx="22">
                  <c:v>0.90785464895545986</c:v>
                </c:pt>
                <c:pt idx="23">
                  <c:v>0.87468608198621223</c:v>
                </c:pt>
                <c:pt idx="24">
                  <c:v>0.84130886727769838</c:v>
                </c:pt>
                <c:pt idx="25">
                  <c:v>0.80773774326832681</c:v>
                </c:pt>
                <c:pt idx="26">
                  <c:v>0.77398753402139453</c:v>
                </c:pt>
                <c:pt idx="27">
                  <c:v>0.74007314267919799</c:v>
                </c:pt>
                <c:pt idx="28">
                  <c:v>0.70600954488222434</c:v>
                </c:pt>
                <c:pt idx="29">
                  <c:v>0.67181178215633197</c:v>
                </c:pt>
                <c:pt idx="30">
                  <c:v>0.63749495527083389</c:v>
                </c:pt>
                <c:pt idx="31">
                  <c:v>0.60307421757042445</c:v>
                </c:pt>
                <c:pt idx="32">
                  <c:v>0.56856476828388935</c:v>
                </c:pt>
                <c:pt idx="33">
                  <c:v>0.5339818458125527</c:v>
                </c:pt>
                <c:pt idx="34">
                  <c:v>0.49934072100142923</c:v>
                </c:pt>
                <c:pt idx="35">
                  <c:v>0.46465669039604707</c:v>
                </c:pt>
                <c:pt idx="36">
                  <c:v>0.42994506948792688</c:v>
                </c:pt>
                <c:pt idx="37">
                  <c:v>0.39522118595168931</c:v>
                </c:pt>
                <c:pt idx="38">
                  <c:v>0.36050037287678716</c:v>
                </c:pt>
                <c:pt idx="39">
                  <c:v>0.32579796199684341</c:v>
                </c:pt>
                <c:pt idx="40">
                  <c:v>0.29112927691958967</c:v>
                </c:pt>
                <c:pt idx="41">
                  <c:v>0.25650962636039298</c:v>
                </c:pt>
                <c:pt idx="42">
                  <c:v>0.2219542973823575</c:v>
                </c:pt>
                <c:pt idx="43">
                  <c:v>0.18747854864598723</c:v>
                </c:pt>
                <c:pt idx="44">
                  <c:v>0.15309760367139258</c:v>
                </c:pt>
                <c:pt idx="45">
                  <c:v>0.11882664411601129</c:v>
                </c:pt>
                <c:pt idx="46">
                  <c:v>8.4680803070815713E-2</c:v>
                </c:pt>
                <c:pt idx="47">
                  <c:v>5.0675158377966989E-2</c:v>
                </c:pt>
                <c:pt idx="48">
                  <c:v>1.6824725972863774E-2</c:v>
                </c:pt>
                <c:pt idx="49">
                  <c:v>-1.6855546746472827E-2</c:v>
                </c:pt>
                <c:pt idx="50">
                  <c:v>-5.0350787519748086E-2</c:v>
                </c:pt>
                <c:pt idx="51">
                  <c:v>-8.364620579156623E-2</c:v>
                </c:pt>
                <c:pt idx="52">
                  <c:v>-0.11672709924252256</c:v>
                </c:pt>
                <c:pt idx="53">
                  <c:v>-0.14957886028133405</c:v>
                </c:pt>
                <c:pt idx="54">
                  <c:v>-0.1821869824951407</c:v>
                </c:pt>
                <c:pt idx="55">
                  <c:v>-0.21453706705512987</c:v>
                </c:pt>
                <c:pt idx="56">
                  <c:v>-0.24661482907465165</c:v>
                </c:pt>
                <c:pt idx="57">
                  <c:v>-0.27840610391702358</c:v>
                </c:pt>
                <c:pt idx="58">
                  <c:v>-0.30989685345023649</c:v>
                </c:pt>
                <c:pt idx="59">
                  <c:v>-0.3410731722457972</c:v>
                </c:pt>
                <c:pt idx="60">
                  <c:v>-0.37192129371897492</c:v>
                </c:pt>
                <c:pt idx="61">
                  <c:v>-0.40242759620773677</c:v>
                </c:pt>
                <c:pt idx="62">
                  <c:v>-0.43257860898769163</c:v>
                </c:pt>
                <c:pt idx="63">
                  <c:v>-0.46236101822038145</c:v>
                </c:pt>
                <c:pt idx="64">
                  <c:v>-0.49176167283229805</c:v>
                </c:pt>
                <c:pt idx="65">
                  <c:v>-0.52076759032202713</c:v>
                </c:pt>
                <c:pt idx="66">
                  <c:v>-0.54936596249295488</c:v>
                </c:pt>
                <c:pt idx="67">
                  <c:v>-0.57754416110900786</c:v>
                </c:pt>
                <c:pt idx="68">
                  <c:v>-0.60528974347092546</c:v>
                </c:pt>
                <c:pt idx="69">
                  <c:v>-0.6325904579106072</c:v>
                </c:pt>
                <c:pt idx="70">
                  <c:v>-0.65943424920110283</c:v>
                </c:pt>
                <c:pt idx="71">
                  <c:v>-0.68580926387986207</c:v>
                </c:pt>
                <c:pt idx="72">
                  <c:v>-0.71170385548288995</c:v>
                </c:pt>
                <c:pt idx="73">
                  <c:v>-0.73710658968749654</c:v>
                </c:pt>
                <c:pt idx="74">
                  <c:v>-0.76200624936137373</c:v>
                </c:pt>
                <c:pt idx="75">
                  <c:v>-0.78639183951576308</c:v>
                </c:pt>
                <c:pt idx="76">
                  <c:v>-0.81025259216053536</c:v>
                </c:pt>
                <c:pt idx="77">
                  <c:v>-0.83357797105902964</c:v>
                </c:pt>
                <c:pt idx="78">
                  <c:v>-0.85635767638056137</c:v>
                </c:pt>
                <c:pt idx="79">
                  <c:v>-0.87858164924853455</c:v>
                </c:pt>
                <c:pt idx="80">
                  <c:v>-0.90024007618216184</c:v>
                </c:pt>
                <c:pt idx="81">
                  <c:v>-0.92132339342981839</c:v>
                </c:pt>
                <c:pt idx="82">
                  <c:v>-0.94182229119212713</c:v>
                </c:pt>
                <c:pt idx="83">
                  <c:v>-0.96172771773290444</c:v>
                </c:pt>
                <c:pt idx="84">
                  <c:v>-0.98103088337615008</c:v>
                </c:pt>
                <c:pt idx="85">
                  <c:v>-0.99972326438732229</c:v>
                </c:pt>
                <c:pt idx="86">
                  <c:v>-1.0177966067371789</c:v>
                </c:pt>
                <c:pt idx="87">
                  <c:v>-1.0352429297465231</c:v>
                </c:pt>
                <c:pt idx="88">
                  <c:v>-1.0520545296102479</c:v>
                </c:pt>
                <c:pt idx="89">
                  <c:v>-1.0682239827991198</c:v>
                </c:pt>
                <c:pt idx="90">
                  <c:v>-1.0837441493377993</c:v>
                </c:pt>
                <c:pt idx="91">
                  <c:v>-1.0986081759576529</c:v>
                </c:pt>
                <c:pt idx="92">
                  <c:v>-1.1128094991229653</c:v>
                </c:pt>
                <c:pt idx="93">
                  <c:v>-1.1263418479292098</c:v>
                </c:pt>
                <c:pt idx="94">
                  <c:v>-1.1391992468721048</c:v>
                </c:pt>
                <c:pt idx="95">
                  <c:v>-1.1513760184862281</c:v>
                </c:pt>
                <c:pt idx="96">
                  <c:v>-1.1628667858520243</c:v>
                </c:pt>
                <c:pt idx="97">
                  <c:v>-1.1736664749701036</c:v>
                </c:pt>
                <c:pt idx="98">
                  <c:v>-1.183770317001775</c:v>
                </c:pt>
                <c:pt idx="99">
                  <c:v>-1.1931738503748321</c:v>
                </c:pt>
                <c:pt idx="100">
                  <c:v>-1.2018729227536573</c:v>
                </c:pt>
                <c:pt idx="101">
                  <c:v>-1.2098636928727771</c:v>
                </c:pt>
                <c:pt idx="102">
                  <c:v>-1.2171426322330565</c:v>
                </c:pt>
                <c:pt idx="103">
                  <c:v>-1.2237065266597844</c:v>
                </c:pt>
                <c:pt idx="104">
                  <c:v>-1.2295524777219629</c:v>
                </c:pt>
                <c:pt idx="105">
                  <c:v>-1.2346779040121736</c:v>
                </c:pt>
                <c:pt idx="106">
                  <c:v>-1.2390805422864526</c:v>
                </c:pt>
                <c:pt idx="107">
                  <c:v>-1.2427584484636784</c:v>
                </c:pt>
                <c:pt idx="108">
                  <c:v>-1.2457099984840196</c:v>
                </c:pt>
                <c:pt idx="109">
                  <c:v>-1.2479338890260769</c:v>
                </c:pt>
                <c:pt idx="110">
                  <c:v>-1.2494291380823928</c:v>
                </c:pt>
                <c:pt idx="111">
                  <c:v>-1.2501950853930754</c:v>
                </c:pt>
                <c:pt idx="112">
                  <c:v>-1.2502313927373563</c:v>
                </c:pt>
                <c:pt idx="113">
                  <c:v>-1.2495380440829331</c:v>
                </c:pt>
                <c:pt idx="114">
                  <c:v>-1.2481153455930536</c:v>
                </c:pt>
                <c:pt idx="115">
                  <c:v>-1.2459639254913204</c:v>
                </c:pt>
                <c:pt idx="116">
                  <c:v>-1.2430847337842852</c:v>
                </c:pt>
                <c:pt idx="117">
                  <c:v>-1.2394790418419535</c:v>
                </c:pt>
                <c:pt idx="118">
                  <c:v>-1.2351484418363823</c:v>
                </c:pt>
                <c:pt idx="119">
                  <c:v>-1.2300948460386232</c:v>
                </c:pt>
                <c:pt idx="120">
                  <c:v>-1.2243204859743155</c:v>
                </c:pt>
                <c:pt idx="121">
                  <c:v>-1.2178279114383093</c:v>
                </c:pt>
                <c:pt idx="122">
                  <c:v>-1.2106199893687457</c:v>
                </c:pt>
                <c:pt idx="123">
                  <c:v>-1.2026999025810996</c:v>
                </c:pt>
                <c:pt idx="124">
                  <c:v>-1.1940711483627366</c:v>
                </c:pt>
                <c:pt idx="125">
                  <c:v>-1.1847375369286106</c:v>
                </c:pt>
                <c:pt idx="126">
                  <c:v>-1.1747031897387787</c:v>
                </c:pt>
                <c:pt idx="127">
                  <c:v>-1.1639725376784817</c:v>
                </c:pt>
                <c:pt idx="128">
                  <c:v>-1.1525503191015893</c:v>
                </c:pt>
                <c:pt idx="129">
                  <c:v>-1.1404415777382764</c:v>
                </c:pt>
                <c:pt idx="130">
                  <c:v>-1.1276516604678539</c:v>
                </c:pt>
                <c:pt idx="131">
                  <c:v>-1.114186214957738</c:v>
                </c:pt>
                <c:pt idx="132">
                  <c:v>-1.1000511871695975</c:v>
                </c:pt>
                <c:pt idx="133">
                  <c:v>-1.0852528187337869</c:v>
                </c:pt>
                <c:pt idx="134">
                  <c:v>-1.0697976441932162</c:v>
                </c:pt>
                <c:pt idx="135">
                  <c:v>-1.0536924881178817</c:v>
                </c:pt>
                <c:pt idx="136">
                  <c:v>-1.0369444620913277</c:v>
                </c:pt>
                <c:pt idx="137">
                  <c:v>-1.0195609615703711</c:v>
                </c:pt>
                <c:pt idx="138">
                  <c:v>-1.0015496626194762</c:v>
                </c:pt>
                <c:pt idx="139">
                  <c:v>-0.9829185185212217</c:v>
                </c:pt>
                <c:pt idx="140">
                  <c:v>-0.96367575626435253</c:v>
                </c:pt>
                <c:pt idx="141">
                  <c:v>-0.94382987291097609</c:v>
                </c:pt>
                <c:pt idx="142">
                  <c:v>-0.92338963184449641</c:v>
                </c:pt>
                <c:pt idx="143">
                  <c:v>-0.9023640588999523</c:v>
                </c:pt>
                <c:pt idx="144">
                  <c:v>-0.88076243837846191</c:v>
                </c:pt>
                <c:pt idx="145">
                  <c:v>-0.8585943089475373</c:v>
                </c:pt>
                <c:pt idx="146">
                  <c:v>-0.83586945942907676</c:v>
                </c:pt>
                <c:pt idx="147">
                  <c:v>-0.81259792447689683</c:v>
                </c:pt>
                <c:pt idx="148">
                  <c:v>-0.78878998014571233</c:v>
                </c:pt>
                <c:pt idx="149">
                  <c:v>-0.76445613935351875</c:v>
                </c:pt>
                <c:pt idx="150">
                  <c:v>-0.73960714723938459</c:v>
                </c:pt>
                <c:pt idx="151">
                  <c:v>-0.71425397641869925</c:v>
                </c:pt>
                <c:pt idx="152">
                  <c:v>-0.68840782213797636</c:v>
                </c:pt>
                <c:pt idx="153">
                  <c:v>-0.66208009733134743</c:v>
                </c:pt>
                <c:pt idx="154">
                  <c:v>-0.63528242758093167</c:v>
                </c:pt>
                <c:pt idx="155">
                  <c:v>-0.60802664598330503</c:v>
                </c:pt>
                <c:pt idx="156">
                  <c:v>-0.58032478792434006</c:v>
                </c:pt>
                <c:pt idx="157">
                  <c:v>-0.55218908576471637</c:v>
                </c:pt>
                <c:pt idx="158">
                  <c:v>-0.52363196343845486</c:v>
                </c:pt>
                <c:pt idx="159">
                  <c:v>-0.49466603096685957</c:v>
                </c:pt>
                <c:pt idx="160">
                  <c:v>-0.46530407889028536</c:v>
                </c:pt>
                <c:pt idx="161">
                  <c:v>-0.43555907262019655</c:v>
                </c:pt>
                <c:pt idx="162">
                  <c:v>-0.40544414671400619</c:v>
                </c:pt>
                <c:pt idx="163">
                  <c:v>-0.37497259907522418</c:v>
                </c:pt>
                <c:pt idx="164">
                  <c:v>-0.34415788508147993</c:v>
                </c:pt>
                <c:pt idx="165">
                  <c:v>-0.3130136116430019</c:v>
                </c:pt>
                <c:pt idx="166">
                  <c:v>-0.28155353119419413</c:v>
                </c:pt>
                <c:pt idx="167">
                  <c:v>-0.24979153562094514</c:v>
                </c:pt>
                <c:pt idx="168">
                  <c:v>-0.21774165012636382</c:v>
                </c:pt>
                <c:pt idx="169">
                  <c:v>-0.18541802703764354</c:v>
                </c:pt>
                <c:pt idx="170">
                  <c:v>-0.1528349395567925</c:v>
                </c:pt>
                <c:pt idx="171">
                  <c:v>-0.12000677545799165</c:v>
                </c:pt>
                <c:pt idx="172">
                  <c:v>-8.6948030734355863E-2</c:v>
                </c:pt>
                <c:pt idx="173">
                  <c:v>-5.3673303196913658E-2</c:v>
                </c:pt>
                <c:pt idx="174">
                  <c:v>-2.019728602862414E-2</c:v>
                </c:pt>
                <c:pt idx="175">
                  <c:v>1.3465238703720073E-2</c:v>
                </c:pt>
                <c:pt idx="176">
                  <c:v>4.7299406576835845E-2</c:v>
                </c:pt>
                <c:pt idx="177">
                  <c:v>8.1290277374660547E-2</c:v>
                </c:pt>
                <c:pt idx="178">
                  <c:v>0.11542284168553196</c:v>
                </c:pt>
                <c:pt idx="179">
                  <c:v>0.14968202752992221</c:v>
                </c:pt>
                <c:pt idx="180">
                  <c:v>0.18405270701579735</c:v>
                </c:pt>
                <c:pt idx="181">
                  <c:v>0.21851970301867052</c:v>
                </c:pt>
                <c:pt idx="182">
                  <c:v>0.25306779588339245</c:v>
                </c:pt>
                <c:pt idx="183">
                  <c:v>0.28768173014472265</c:v>
                </c:pt>
                <c:pt idx="184">
                  <c:v>0.32234622126371326</c:v>
                </c:pt>
                <c:pt idx="185">
                  <c:v>0.35704596237693087</c:v>
                </c:pt>
                <c:pt idx="186">
                  <c:v>0.39176563105553852</c:v>
                </c:pt>
                <c:pt idx="187">
                  <c:v>0.42648989607124543</c:v>
                </c:pt>
                <c:pt idx="188">
                  <c:v>0.46120342416614879</c:v>
                </c:pt>
                <c:pt idx="189">
                  <c:v>0.49589088682346805</c:v>
                </c:pt>
                <c:pt idx="190">
                  <c:v>0.53053696703618525</c:v>
                </c:pt>
                <c:pt idx="191">
                  <c:v>0.56512636607060474</c:v>
                </c:pt>
                <c:pt idx="192">
                  <c:v>0.59964381022184599</c:v>
                </c:pt>
                <c:pt idx="193">
                  <c:v>0.63407405755827606</c:v>
                </c:pt>
                <c:pt idx="194">
                  <c:v>0.66840190465192317</c:v>
                </c:pt>
                <c:pt idx="195">
                  <c:v>0.7026121932918783</c:v>
                </c:pt>
                <c:pt idx="196">
                  <c:v>0.7366898171777374</c:v>
                </c:pt>
                <c:pt idx="197">
                  <c:v>0.77061972859011696</c:v>
                </c:pt>
                <c:pt idx="198">
                  <c:v>0.80438694503530261</c:v>
                </c:pt>
                <c:pt idx="199">
                  <c:v>0.83797655586109865</c:v>
                </c:pt>
                <c:pt idx="200">
                  <c:v>0.87137372884095021</c:v>
                </c:pt>
                <c:pt idx="201">
                  <c:v>0.90456371672343838</c:v>
                </c:pt>
                <c:pt idx="202">
                  <c:v>0.93753186374425057</c:v>
                </c:pt>
                <c:pt idx="203">
                  <c:v>0.97026361209775325</c:v>
                </c:pt>
                <c:pt idx="204">
                  <c:v>1.0027445083653106</c:v>
                </c:pt>
                <c:pt idx="205">
                  <c:v>1.0349602098975044</c:v>
                </c:pt>
                <c:pt idx="206">
                  <c:v>1.0668964911474479</c:v>
                </c:pt>
                <c:pt idx="207">
                  <c:v>1.0985392499523836</c:v>
                </c:pt>
                <c:pt idx="208">
                  <c:v>1.1298745137608037</c:v>
                </c:pt>
                <c:pt idx="209">
                  <c:v>1.1608884458023336</c:v>
                </c:pt>
                <c:pt idx="210">
                  <c:v>1.1915673511976621</c:v>
                </c:pt>
                <c:pt idx="211">
                  <c:v>1.2218976830058126</c:v>
                </c:pt>
                <c:pt idx="212">
                  <c:v>1.2518660482060926</c:v>
                </c:pt>
                <c:pt idx="213">
                  <c:v>1.2814592136120737</c:v>
                </c:pt>
                <c:pt idx="214">
                  <c:v>1.3106641117149924</c:v>
                </c:pt>
                <c:pt idx="215">
                  <c:v>1.3394678464540011</c:v>
                </c:pt>
                <c:pt idx="216">
                  <c:v>1.3678576989106954</c:v>
                </c:pt>
                <c:pt idx="217">
                  <c:v>1.3958211329254375</c:v>
                </c:pt>
                <c:pt idx="218">
                  <c:v>1.4233458006329698</c:v>
                </c:pt>
                <c:pt idx="219">
                  <c:v>1.4504195479148831</c:v>
                </c:pt>
                <c:pt idx="220">
                  <c:v>1.4770304197665354</c:v>
                </c:pt>
                <c:pt idx="221">
                  <c:v>1.5031666655760429</c:v>
                </c:pt>
                <c:pt idx="222">
                  <c:v>1.5288167443130221</c:v>
                </c:pt>
                <c:pt idx="223">
                  <c:v>1.5539693296247816</c:v>
                </c:pt>
                <c:pt idx="224">
                  <c:v>1.5786133148377217</c:v>
                </c:pt>
                <c:pt idx="225">
                  <c:v>1.6027378178617295</c:v>
                </c:pt>
                <c:pt idx="226">
                  <c:v>1.6263321859954014</c:v>
                </c:pt>
                <c:pt idx="227">
                  <c:v>1.6493860006299788</c:v>
                </c:pt>
                <c:pt idx="228">
                  <c:v>1.6718890818499099</c:v>
                </c:pt>
                <c:pt idx="229">
                  <c:v>1.6938314929280158</c:v>
                </c:pt>
                <c:pt idx="230">
                  <c:v>1.7152035447132687</c:v>
                </c:pt>
                <c:pt idx="231">
                  <c:v>1.7359957999092477</c:v>
                </c:pt>
                <c:pt idx="232">
                  <c:v>1.756199077241384</c:v>
                </c:pt>
                <c:pt idx="233">
                  <c:v>1.7758044555111534</c:v>
                </c:pt>
                <c:pt idx="234">
                  <c:v>1.7948032775354263</c:v>
                </c:pt>
                <c:pt idx="235">
                  <c:v>1.813187153969235</c:v>
                </c:pt>
                <c:pt idx="236">
                  <c:v>1.8309479670102735</c:v>
                </c:pt>
                <c:pt idx="237">
                  <c:v>1.8480778739834904</c:v>
                </c:pt>
                <c:pt idx="238">
                  <c:v>1.864569310804193</c:v>
                </c:pt>
                <c:pt idx="239">
                  <c:v>1.8804149953181337</c:v>
                </c:pt>
                <c:pt idx="240">
                  <c:v>1.8956079305171059</c:v>
                </c:pt>
                <c:pt idx="241">
                  <c:v>1.9101414076286241</c:v>
                </c:pt>
                <c:pt idx="242">
                  <c:v>1.9240090090783291</c:v>
                </c:pt>
                <c:pt idx="243">
                  <c:v>1.9372046113238111</c:v>
                </c:pt>
                <c:pt idx="244">
                  <c:v>1.9497223875585896</c:v>
                </c:pt>
                <c:pt idx="245">
                  <c:v>1.9615568102850682</c:v>
                </c:pt>
                <c:pt idx="246">
                  <c:v>1.9727026537553243</c:v>
                </c:pt>
                <c:pt idx="247">
                  <c:v>1.9831549962786492</c:v>
                </c:pt>
                <c:pt idx="248">
                  <c:v>1.9929092223948306</c:v>
                </c:pt>
                <c:pt idx="249">
                  <c:v>2.0019610249122075</c:v>
                </c:pt>
                <c:pt idx="250">
                  <c:v>2.0103064068096081</c:v>
                </c:pt>
                <c:pt idx="251">
                  <c:v>2.0179416830013168</c:v>
                </c:pt>
                <c:pt idx="252">
                  <c:v>2.0248634819643105</c:v>
                </c:pt>
                <c:pt idx="253">
                  <c:v>2.0310687472270237</c:v>
                </c:pt>
                <c:pt idx="254">
                  <c:v>2.0365547387190013</c:v>
                </c:pt>
                <c:pt idx="255">
                  <c:v>2.0413190339808378</c:v>
                </c:pt>
                <c:pt idx="256">
                  <c:v>2.0453595292338651</c:v>
                </c:pt>
                <c:pt idx="257">
                  <c:v>2.0486744403091253</c:v>
                </c:pt>
                <c:pt idx="258">
                  <c:v>2.0512623034352049</c:v>
                </c:pt>
                <c:pt idx="259">
                  <c:v>2.0531219758845998</c:v>
                </c:pt>
                <c:pt idx="260">
                  <c:v>2.0542526364783069</c:v>
                </c:pt>
                <c:pt idx="261">
                  <c:v>2.0546537859484388</c:v>
                </c:pt>
                <c:pt idx="262">
                  <c:v>2.0543252471586824</c:v>
                </c:pt>
                <c:pt idx="263">
                  <c:v>2.053267165182517</c:v>
                </c:pt>
                <c:pt idx="264">
                  <c:v>2.0514800072391584</c:v>
                </c:pt>
                <c:pt idx="265">
                  <c:v>2.0489645624872432</c:v>
                </c:pt>
                <c:pt idx="266">
                  <c:v>2.0457219416763612</c:v>
                </c:pt>
                <c:pt idx="267">
                  <c:v>2.0417535766565793</c:v>
                </c:pt>
                <c:pt idx="268">
                  <c:v>2.0370612197461764</c:v>
                </c:pt>
                <c:pt idx="269">
                  <c:v>2.0316469429578681</c:v>
                </c:pt>
                <c:pt idx="270">
                  <c:v>2.0255131370838666</c:v>
                </c:pt>
                <c:pt idx="271">
                  <c:v>2.0186625106401723</c:v>
                </c:pt>
                <c:pt idx="272">
                  <c:v>2.0110980886705692</c:v>
                </c:pt>
                <c:pt idx="273">
                  <c:v>2.0028232114108522</c:v>
                </c:pt>
                <c:pt idx="274">
                  <c:v>1.9938415328138719</c:v>
                </c:pt>
                <c:pt idx="275">
                  <c:v>1.9841570189360522</c:v>
                </c:pt>
                <c:pt idx="276">
                  <c:v>1.973773946186091</c:v>
                </c:pt>
                <c:pt idx="277">
                  <c:v>1.9626968994366196</c:v>
                </c:pt>
                <c:pt idx="278">
                  <c:v>1.950930769999651</c:v>
                </c:pt>
                <c:pt idx="279">
                  <c:v>1.9384807534667143</c:v>
                </c:pt>
                <c:pt idx="280">
                  <c:v>1.9253523474146284</c:v>
                </c:pt>
                <c:pt idx="281">
                  <c:v>1.9115513489779259</c:v>
                </c:pt>
                <c:pt idx="282">
                  <c:v>1.8970838522890028</c:v>
                </c:pt>
                <c:pt idx="283">
                  <c:v>1.88195624578712</c:v>
                </c:pt>
                <c:pt idx="284">
                  <c:v>1.8661752093974493</c:v>
                </c:pt>
                <c:pt idx="285">
                  <c:v>1.8497477115814061</c:v>
                </c:pt>
                <c:pt idx="286">
                  <c:v>1.8326810062595731</c:v>
                </c:pt>
                <c:pt idx="287">
                  <c:v>1.8149826296085729</c:v>
                </c:pt>
                <c:pt idx="288">
                  <c:v>1.7966603967333052</c:v>
                </c:pt>
                <c:pt idx="289">
                  <c:v>1.7777223982160155</c:v>
                </c:pt>
                <c:pt idx="290">
                  <c:v>1.7581769965437228</c:v>
                </c:pt>
                <c:pt idx="291">
                  <c:v>1.7380328224155801</c:v>
                </c:pt>
                <c:pt idx="292">
                  <c:v>1.7172987709318006</c:v>
                </c:pt>
                <c:pt idx="293">
                  <c:v>1.6959839976658322</c:v>
                </c:pt>
                <c:pt idx="294">
                  <c:v>1.6740979146215138</c:v>
                </c:pt>
                <c:pt idx="295">
                  <c:v>1.6516501860769996</c:v>
                </c:pt>
                <c:pt idx="296">
                  <c:v>1.6286507243172852</c:v>
                </c:pt>
                <c:pt idx="297">
                  <c:v>1.6051096852572226</c:v>
                </c:pt>
                <c:pt idx="298">
                  <c:v>1.5810374639569533</c:v>
                </c:pt>
                <c:pt idx="299">
                  <c:v>1.556444690031744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423720"/>
        <c:axId val="283425288"/>
      </c:scatterChart>
      <c:valAx>
        <c:axId val="283423720"/>
        <c:scaling>
          <c:orientation val="minMax"/>
          <c:max val="3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425288"/>
        <c:crosses val="autoZero"/>
        <c:crossBetween val="midCat"/>
      </c:valAx>
      <c:valAx>
        <c:axId val="283425288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423720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980012113870381"/>
          <c:y val="0.15250000000000002"/>
          <c:w val="0.6542383403997577"/>
          <c:h val="0.71158333333333323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FF0000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FF0000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AB$1:$AB$15</c:f>
              <c:numCache>
                <c:formatCode>General</c:formatCode>
                <c:ptCount val="15"/>
                <c:pt idx="0">
                  <c:v>1248.77</c:v>
                </c:pt>
                <c:pt idx="1">
                  <c:v>2456.31</c:v>
                </c:pt>
                <c:pt idx="2">
                  <c:v>1500</c:v>
                </c:pt>
                <c:pt idx="3">
                  <c:v>2422.6</c:v>
                </c:pt>
                <c:pt idx="4">
                  <c:v>2067.77</c:v>
                </c:pt>
                <c:pt idx="5">
                  <c:v>1348.43</c:v>
                </c:pt>
                <c:pt idx="6">
                  <c:v>1409.69</c:v>
                </c:pt>
                <c:pt idx="7">
                  <c:v>2011.43</c:v>
                </c:pt>
                <c:pt idx="8">
                  <c:v>1302.08</c:v>
                </c:pt>
                <c:pt idx="9">
                  <c:v>1328.58</c:v>
                </c:pt>
                <c:pt idx="10">
                  <c:v>1299.6099999999999</c:v>
                </c:pt>
                <c:pt idx="11">
                  <c:v>1766.94</c:v>
                </c:pt>
                <c:pt idx="12">
                  <c:v>1844.76</c:v>
                </c:pt>
                <c:pt idx="13">
                  <c:v>1863.16</c:v>
                </c:pt>
                <c:pt idx="14">
                  <c:v>2044.99</c:v>
                </c:pt>
              </c:numCache>
            </c:numRef>
          </c:xVal>
          <c:yVal>
            <c:numRef>
              <c:f>'Covariance   Correlation3_HID4'!$AC$1:$AC$15</c:f>
              <c:numCache>
                <c:formatCode>General</c:formatCode>
                <c:ptCount val="15"/>
                <c:pt idx="0">
                  <c:v>1.0531999999999999</c:v>
                </c:pt>
                <c:pt idx="1">
                  <c:v>1.6315999999999999</c:v>
                </c:pt>
                <c:pt idx="2">
                  <c:v>1.4011</c:v>
                </c:pt>
                <c:pt idx="3">
                  <c:v>5.6500000000000002E-2</c:v>
                </c:pt>
                <c:pt idx="4">
                  <c:v>0.2228999999999999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E-3</c:v>
                </c:pt>
                <c:pt idx="9">
                  <c:v>0</c:v>
                </c:pt>
                <c:pt idx="10">
                  <c:v>0.48499999999999999</c:v>
                </c:pt>
                <c:pt idx="11">
                  <c:v>0.84172000000000002</c:v>
                </c:pt>
                <c:pt idx="12">
                  <c:v>3.6700000000000003E-2</c:v>
                </c:pt>
                <c:pt idx="13">
                  <c:v>0.17710000000000001</c:v>
                </c:pt>
                <c:pt idx="14">
                  <c:v>0.1247999999999999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18</c:f>
              <c:numCache>
                <c:formatCode>General</c:formatCode>
                <c:ptCount val="300"/>
                <c:pt idx="0">
                  <c:v>502.20097903698002</c:v>
                </c:pt>
                <c:pt idx="1">
                  <c:v>502.47154637796257</c:v>
                </c:pt>
                <c:pt idx="2">
                  <c:v>503.28312892598888</c:v>
                </c:pt>
                <c:pt idx="3">
                  <c:v>504.63536830905309</c:v>
                </c:pt>
                <c:pt idx="4">
                  <c:v>506.52766741631035</c:v>
                </c:pt>
                <c:pt idx="5">
                  <c:v>508.95919066174542</c:v>
                </c:pt>
                <c:pt idx="6">
                  <c:v>511.92886435314335</c:v>
                </c:pt>
                <c:pt idx="7">
                  <c:v>515.43537716620153</c:v>
                </c:pt>
                <c:pt idx="8">
                  <c:v>519.47718072357452</c:v>
                </c:pt>
                <c:pt idx="9">
                  <c:v>524.05249027859236</c:v>
                </c:pt>
                <c:pt idx="10">
                  <c:v>529.15928550335593</c:v>
                </c:pt>
                <c:pt idx="11">
                  <c:v>534.79531138085622</c:v>
                </c:pt>
                <c:pt idx="12">
                  <c:v>540.95807920072616</c:v>
                </c:pt>
                <c:pt idx="13">
                  <c:v>547.64486765818583</c:v>
                </c:pt>
                <c:pt idx="14">
                  <c:v>554.85272405569276</c:v>
                </c:pt>
                <c:pt idx="15">
                  <c:v>562.57846560677126</c:v>
                </c:pt>
                <c:pt idx="16">
                  <c:v>570.81868084144139</c:v>
                </c:pt>
                <c:pt idx="17">
                  <c:v>579.56973111262641</c:v>
                </c:pt>
                <c:pt idx="18">
                  <c:v>588.82775220287908</c:v>
                </c:pt>
                <c:pt idx="19">
                  <c:v>598.5886560307099</c:v>
                </c:pt>
                <c:pt idx="20">
                  <c:v>608.84813245576902</c:v>
                </c:pt>
                <c:pt idx="21">
                  <c:v>619.60165118208306</c:v>
                </c:pt>
                <c:pt idx="22">
                  <c:v>630.84446375850666</c:v>
                </c:pt>
                <c:pt idx="23">
                  <c:v>642.57160567550363</c:v>
                </c:pt>
                <c:pt idx="24">
                  <c:v>654.77789855733658</c:v>
                </c:pt>
                <c:pt idx="25">
                  <c:v>667.45795244868987</c:v>
                </c:pt>
                <c:pt idx="26">
                  <c:v>680.6061681947233</c:v>
                </c:pt>
                <c:pt idx="27">
                  <c:v>694.21673991350031</c:v>
                </c:pt>
                <c:pt idx="28">
                  <c:v>708.28365755970367</c:v>
                </c:pt>
                <c:pt idx="29">
                  <c:v>722.80070957850035</c:v>
                </c:pt>
                <c:pt idx="30">
                  <c:v>737.7614856483907</c:v>
                </c:pt>
                <c:pt idx="31">
                  <c:v>753.15937951182548</c:v>
                </c:pt>
                <c:pt idx="32">
                  <c:v>768.98759189234249</c:v>
                </c:pt>
                <c:pt idx="33">
                  <c:v>785.23913349693726</c:v>
                </c:pt>
                <c:pt idx="34">
                  <c:v>801.90682810233625</c:v>
                </c:pt>
                <c:pt idx="35">
                  <c:v>818.98331572381733</c:v>
                </c:pt>
                <c:pt idx="36">
                  <c:v>836.46105586516899</c:v>
                </c:pt>
                <c:pt idx="37">
                  <c:v>854.33233084836354</c:v>
                </c:pt>
                <c:pt idx="38">
                  <c:v>872.58924922146537</c:v>
                </c:pt>
                <c:pt idx="39">
                  <c:v>891.2237492432738</c:v>
                </c:pt>
                <c:pt idx="40">
                  <c:v>910.22760244316203</c:v>
                </c:pt>
                <c:pt idx="41">
                  <c:v>929.59241725453728</c:v>
                </c:pt>
                <c:pt idx="42">
                  <c:v>949.30964272032054</c:v>
                </c:pt>
                <c:pt idx="43">
                  <c:v>969.37057226880893</c:v>
                </c:pt>
                <c:pt idx="44">
                  <c:v>989.76634755825171</c:v>
                </c:pt>
                <c:pt idx="45">
                  <c:v>1010.4879623884457</c:v>
                </c:pt>
                <c:pt idx="46">
                  <c:v>1031.5262666776193</c:v>
                </c:pt>
                <c:pt idx="47">
                  <c:v>1052.8719705028507</c:v>
                </c:pt>
                <c:pt idx="48">
                  <c:v>1074.5156482022367</c:v>
                </c:pt>
                <c:pt idx="49">
                  <c:v>1096.4477425369996</c:v>
                </c:pt>
                <c:pt idx="50">
                  <c:v>1118.6585689116953</c:v>
                </c:pt>
                <c:pt idx="51">
                  <c:v>1141.1383196506565</c:v>
                </c:pt>
                <c:pt idx="52">
                  <c:v>1163.877068328788</c:v>
                </c:pt>
                <c:pt idx="53">
                  <c:v>1186.8647741547952</c:v>
                </c:pt>
                <c:pt idx="54">
                  <c:v>1210.0912864049151</c:v>
                </c:pt>
                <c:pt idx="55">
                  <c:v>1233.5463489051924</c:v>
                </c:pt>
                <c:pt idx="56">
                  <c:v>1257.2196045603134</c:v>
                </c:pt>
                <c:pt idx="57">
                  <c:v>1281.1005999270099</c:v>
                </c:pt>
                <c:pt idx="58">
                  <c:v>1305.1787898300056</c:v>
                </c:pt>
                <c:pt idx="59">
                  <c:v>1329.4435420184677</c:v>
                </c:pt>
                <c:pt idx="60">
                  <c:v>1353.8841418609111</c:v>
                </c:pt>
                <c:pt idx="61">
                  <c:v>1378.4897970764755</c:v>
                </c:pt>
                <c:pt idx="62">
                  <c:v>1403.2496425004961</c:v>
                </c:pt>
                <c:pt idx="63">
                  <c:v>1428.152744882251</c:v>
                </c:pt>
                <c:pt idx="64">
                  <c:v>1453.1881077127798</c:v>
                </c:pt>
                <c:pt idx="65">
                  <c:v>1478.3446760806305</c:v>
                </c:pt>
                <c:pt idx="66">
                  <c:v>1503.6113415533985</c:v>
                </c:pt>
                <c:pt idx="67">
                  <c:v>1528.9769470828962</c:v>
                </c:pt>
                <c:pt idx="68">
                  <c:v>1554.4302919317929</c:v>
                </c:pt>
                <c:pt idx="69">
                  <c:v>1579.9601366195445</c:v>
                </c:pt>
                <c:pt idx="70">
                  <c:v>1605.5552078854312</c:v>
                </c:pt>
                <c:pt idx="71">
                  <c:v>1631.2042036665127</c:v>
                </c:pt>
                <c:pt idx="72">
                  <c:v>1656.8957980883006</c:v>
                </c:pt>
                <c:pt idx="73">
                  <c:v>1682.6186464659461</c:v>
                </c:pt>
                <c:pt idx="74">
                  <c:v>1708.3613903137336</c:v>
                </c:pt>
                <c:pt idx="75">
                  <c:v>1734.1126623606674</c:v>
                </c:pt>
                <c:pt idx="76">
                  <c:v>1759.8610915699401</c:v>
                </c:pt>
                <c:pt idx="77">
                  <c:v>1785.5953081600603</c:v>
                </c:pt>
                <c:pt idx="78">
                  <c:v>1811.3039486254295</c:v>
                </c:pt>
                <c:pt idx="79">
                  <c:v>1836.9756607541462</c:v>
                </c:pt>
                <c:pt idx="80">
                  <c:v>1862.5991086408224</c:v>
                </c:pt>
                <c:pt idx="81">
                  <c:v>1888.1629776922009</c:v>
                </c:pt>
                <c:pt idx="82">
                  <c:v>1913.6559796233605</c:v>
                </c:pt>
                <c:pt idx="83">
                  <c:v>1939.0668574423064</c:v>
                </c:pt>
                <c:pt idx="84">
                  <c:v>1964.384390420739</c:v>
                </c:pt>
                <c:pt idx="85">
                  <c:v>1989.5973990488123</c:v>
                </c:pt>
                <c:pt idx="86">
                  <c:v>2014.6947499716916</c:v>
                </c:pt>
                <c:pt idx="87">
                  <c:v>2039.6653609057287</c:v>
                </c:pt>
                <c:pt idx="88">
                  <c:v>2064.4982055320861</c:v>
                </c:pt>
                <c:pt idx="89">
                  <c:v>2089.1823183656497</c:v>
                </c:pt>
                <c:pt idx="90">
                  <c:v>2113.7067995970797</c:v>
                </c:pt>
                <c:pt idx="91">
                  <c:v>2138.0608199058552</c:v>
                </c:pt>
                <c:pt idx="92">
                  <c:v>2162.2336252422024</c:v>
                </c:pt>
                <c:pt idx="93">
                  <c:v>2186.2145415757764</c:v>
                </c:pt>
                <c:pt idx="94">
                  <c:v>2209.992979609015</c:v>
                </c:pt>
                <c:pt idx="95">
                  <c:v>2233.5584394530729</c:v>
                </c:pt>
                <c:pt idx="96">
                  <c:v>2256.9005152642776</c:v>
                </c:pt>
                <c:pt idx="97">
                  <c:v>2280.0088998390574</c:v>
                </c:pt>
                <c:pt idx="98">
                  <c:v>2302.8733891653114</c:v>
                </c:pt>
                <c:pt idx="99">
                  <c:v>2325.4838869282153</c:v>
                </c:pt>
                <c:pt idx="100">
                  <c:v>2347.830408968468</c:v>
                </c:pt>
                <c:pt idx="101">
                  <c:v>2369.9030876910174</c:v>
                </c:pt>
                <c:pt idx="102">
                  <c:v>2391.6921764223098</c:v>
                </c:pt>
                <c:pt idx="103">
                  <c:v>2413.1880537141501</c:v>
                </c:pt>
                <c:pt idx="104">
                  <c:v>2434.3812275922601</c:v>
                </c:pt>
                <c:pt idx="105">
                  <c:v>2455.2623397476664</c:v>
                </c:pt>
                <c:pt idx="106">
                  <c:v>2475.8221696690698</c:v>
                </c:pt>
                <c:pt idx="107">
                  <c:v>2496.0516387143584</c:v>
                </c:pt>
                <c:pt idx="108">
                  <c:v>2515.9418141194856</c:v>
                </c:pt>
                <c:pt idx="109">
                  <c:v>2535.4839129429238</c:v>
                </c:pt>
                <c:pt idx="110">
                  <c:v>2554.6693059439649</c:v>
                </c:pt>
                <c:pt idx="111">
                  <c:v>2573.4895213931504</c:v>
                </c:pt>
                <c:pt idx="112">
                  <c:v>2591.9362488131492</c:v>
                </c:pt>
                <c:pt idx="113">
                  <c:v>2610.0013426484279</c:v>
                </c:pt>
                <c:pt idx="114">
                  <c:v>2627.6768258621032</c:v>
                </c:pt>
                <c:pt idx="115">
                  <c:v>2644.9548934583727</c:v>
                </c:pt>
                <c:pt idx="116">
                  <c:v>2661.8279159289832</c:v>
                </c:pt>
                <c:pt idx="117">
                  <c:v>2678.2884426222067</c:v>
                </c:pt>
                <c:pt idx="118">
                  <c:v>2694.3292050328387</c:v>
                </c:pt>
                <c:pt idx="119">
                  <c:v>2709.9431200117633</c:v>
                </c:pt>
                <c:pt idx="120">
                  <c:v>2725.123292893677</c:v>
                </c:pt>
                <c:pt idx="121">
                  <c:v>2739.8630205415734</c:v>
                </c:pt>
                <c:pt idx="122">
                  <c:v>2754.1557943066641</c:v>
                </c:pt>
                <c:pt idx="123">
                  <c:v>2767.9953029024118</c:v>
                </c:pt>
                <c:pt idx="124">
                  <c:v>2781.3754351914195</c:v>
                </c:pt>
                <c:pt idx="125">
                  <c:v>2794.2902828839342</c:v>
                </c:pt>
                <c:pt idx="126">
                  <c:v>2806.7341431467821</c:v>
                </c:pt>
                <c:pt idx="127">
                  <c:v>2818.7015211215803</c:v>
                </c:pt>
                <c:pt idx="128">
                  <c:v>2830.1871323511109</c:v>
                </c:pt>
                <c:pt idx="129">
                  <c:v>2841.1859051127881</c:v>
                </c:pt>
                <c:pt idx="130">
                  <c:v>2851.6929826581882</c:v>
                </c:pt>
                <c:pt idx="131">
                  <c:v>2861.7037253576536</c:v>
                </c:pt>
                <c:pt idx="132">
                  <c:v>2871.2137127490223</c:v>
                </c:pt>
                <c:pt idx="133">
                  <c:v>2880.2187454895784</c:v>
                </c:pt>
                <c:pt idx="134">
                  <c:v>2888.7148472103672</c:v>
                </c:pt>
                <c:pt idx="135">
                  <c:v>2896.6982662720425</c:v>
                </c:pt>
                <c:pt idx="136">
                  <c:v>2904.1654774214894</c:v>
                </c:pt>
                <c:pt idx="137">
                  <c:v>2911.113183348476</c:v>
                </c:pt>
                <c:pt idx="138">
                  <c:v>2917.5383161416494</c:v>
                </c:pt>
                <c:pt idx="139">
                  <c:v>2923.4380386432431</c:v>
                </c:pt>
                <c:pt idx="140">
                  <c:v>2928.8097457018857</c:v>
                </c:pt>
                <c:pt idx="141">
                  <c:v>2933.6510653229579</c:v>
                </c:pt>
                <c:pt idx="142">
                  <c:v>2937.9598597160057</c:v>
                </c:pt>
                <c:pt idx="143">
                  <c:v>2941.7342262387215</c:v>
                </c:pt>
                <c:pt idx="144">
                  <c:v>2944.9724982371017</c:v>
                </c:pt>
                <c:pt idx="145">
                  <c:v>2947.6732457813932</c:v>
                </c:pt>
                <c:pt idx="146">
                  <c:v>2949.8352762975092</c:v>
                </c:pt>
                <c:pt idx="147">
                  <c:v>2951.4576350936377</c:v>
                </c:pt>
                <c:pt idx="148">
                  <c:v>2952.5396057818057</c:v>
                </c:pt>
                <c:pt idx="149">
                  <c:v>2953.0807105942158</c:v>
                </c:pt>
                <c:pt idx="150">
                  <c:v>2953.0807105942158</c:v>
                </c:pt>
                <c:pt idx="151">
                  <c:v>2952.5396057818052</c:v>
                </c:pt>
                <c:pt idx="152">
                  <c:v>2951.4576350936368</c:v>
                </c:pt>
                <c:pt idx="153">
                  <c:v>2949.8352762975078</c:v>
                </c:pt>
                <c:pt idx="154">
                  <c:v>2947.6732457813914</c:v>
                </c:pt>
                <c:pt idx="155">
                  <c:v>2944.9724982370999</c:v>
                </c:pt>
                <c:pt idx="156">
                  <c:v>2941.7342262387192</c:v>
                </c:pt>
                <c:pt idx="157">
                  <c:v>2937.9598597160029</c:v>
                </c:pt>
                <c:pt idx="158">
                  <c:v>2933.6510653229552</c:v>
                </c:pt>
                <c:pt idx="159">
                  <c:v>2928.8097457018821</c:v>
                </c:pt>
                <c:pt idx="160">
                  <c:v>2923.4380386432395</c:v>
                </c:pt>
                <c:pt idx="161">
                  <c:v>2917.5383161416448</c:v>
                </c:pt>
                <c:pt idx="162">
                  <c:v>2911.113183348471</c:v>
                </c:pt>
                <c:pt idx="163">
                  <c:v>2904.1654774214849</c:v>
                </c:pt>
                <c:pt idx="164">
                  <c:v>2896.698266272037</c:v>
                </c:pt>
                <c:pt idx="165">
                  <c:v>2888.7148472103613</c:v>
                </c:pt>
                <c:pt idx="166">
                  <c:v>2880.2187454895725</c:v>
                </c:pt>
                <c:pt idx="167">
                  <c:v>2871.2137127490155</c:v>
                </c:pt>
                <c:pt idx="168">
                  <c:v>2861.7037253576464</c:v>
                </c:pt>
                <c:pt idx="169">
                  <c:v>2851.6929826581809</c:v>
                </c:pt>
                <c:pt idx="170">
                  <c:v>2841.1859051127803</c:v>
                </c:pt>
                <c:pt idx="171">
                  <c:v>2830.1871323511032</c:v>
                </c:pt>
                <c:pt idx="172">
                  <c:v>2818.7015211215721</c:v>
                </c:pt>
                <c:pt idx="173">
                  <c:v>2806.734143146773</c:v>
                </c:pt>
                <c:pt idx="174">
                  <c:v>2794.2902828839251</c:v>
                </c:pt>
                <c:pt idx="175">
                  <c:v>2781.3754351914104</c:v>
                </c:pt>
                <c:pt idx="176">
                  <c:v>2767.9953029024027</c:v>
                </c:pt>
                <c:pt idx="177">
                  <c:v>2754.1557943066546</c:v>
                </c:pt>
                <c:pt idx="178">
                  <c:v>2739.8630205415639</c:v>
                </c:pt>
                <c:pt idx="179">
                  <c:v>2725.1232928936665</c:v>
                </c:pt>
                <c:pt idx="180">
                  <c:v>2709.9431200117529</c:v>
                </c:pt>
                <c:pt idx="181">
                  <c:v>2694.3292050328273</c:v>
                </c:pt>
                <c:pt idx="182">
                  <c:v>2678.2884426221954</c:v>
                </c:pt>
                <c:pt idx="183">
                  <c:v>2661.8279159289714</c:v>
                </c:pt>
                <c:pt idx="184">
                  <c:v>2644.9548934583609</c:v>
                </c:pt>
                <c:pt idx="185">
                  <c:v>2627.6768258620909</c:v>
                </c:pt>
                <c:pt idx="186">
                  <c:v>2610.0013426484156</c:v>
                </c:pt>
                <c:pt idx="187">
                  <c:v>2591.9362488131364</c:v>
                </c:pt>
                <c:pt idx="188">
                  <c:v>2573.4895213931377</c:v>
                </c:pt>
                <c:pt idx="189">
                  <c:v>2554.6693059439517</c:v>
                </c:pt>
                <c:pt idx="190">
                  <c:v>2535.4839129429106</c:v>
                </c:pt>
                <c:pt idx="191">
                  <c:v>2515.9418141194724</c:v>
                </c:pt>
                <c:pt idx="192">
                  <c:v>2496.0516387143448</c:v>
                </c:pt>
                <c:pt idx="193">
                  <c:v>2475.8221696690553</c:v>
                </c:pt>
                <c:pt idx="194">
                  <c:v>2455.2623397476523</c:v>
                </c:pt>
                <c:pt idx="195">
                  <c:v>2434.3812275922451</c:v>
                </c:pt>
                <c:pt idx="196">
                  <c:v>2413.1880537141351</c:v>
                </c:pt>
                <c:pt idx="197">
                  <c:v>2391.6921764222948</c:v>
                </c:pt>
                <c:pt idx="198">
                  <c:v>2369.9030876910019</c:v>
                </c:pt>
                <c:pt idx="199">
                  <c:v>2347.8304089684525</c:v>
                </c:pt>
                <c:pt idx="200">
                  <c:v>2325.4838869281998</c:v>
                </c:pt>
                <c:pt idx="201">
                  <c:v>2302.8733891652955</c:v>
                </c:pt>
                <c:pt idx="202">
                  <c:v>2280.0088998390411</c:v>
                </c:pt>
                <c:pt idx="203">
                  <c:v>2256.9005152642612</c:v>
                </c:pt>
                <c:pt idx="204">
                  <c:v>2233.5584394530561</c:v>
                </c:pt>
                <c:pt idx="205">
                  <c:v>2209.9929796089982</c:v>
                </c:pt>
                <c:pt idx="206">
                  <c:v>2186.2145415757595</c:v>
                </c:pt>
                <c:pt idx="207">
                  <c:v>2162.2336252421851</c:v>
                </c:pt>
                <c:pt idx="208">
                  <c:v>2138.0608199058383</c:v>
                </c:pt>
                <c:pt idx="209">
                  <c:v>2113.7067995970624</c:v>
                </c:pt>
                <c:pt idx="210">
                  <c:v>2089.1823183656325</c:v>
                </c:pt>
                <c:pt idx="211">
                  <c:v>2064.4982055320684</c:v>
                </c:pt>
                <c:pt idx="212">
                  <c:v>2039.6653609057107</c:v>
                </c:pt>
                <c:pt idx="213">
                  <c:v>2014.6947499716737</c:v>
                </c:pt>
                <c:pt idx="214">
                  <c:v>1989.5973990487953</c:v>
                </c:pt>
                <c:pt idx="215">
                  <c:v>1964.384390420722</c:v>
                </c:pt>
                <c:pt idx="216">
                  <c:v>1939.0668574422893</c:v>
                </c:pt>
                <c:pt idx="217">
                  <c:v>1913.6559796233432</c:v>
                </c:pt>
                <c:pt idx="218">
                  <c:v>1888.1629776921832</c:v>
                </c:pt>
                <c:pt idx="219">
                  <c:v>1862.5991086408048</c:v>
                </c:pt>
                <c:pt idx="220">
                  <c:v>1836.9756607541285</c:v>
                </c:pt>
                <c:pt idx="221">
                  <c:v>1811.3039486254117</c:v>
                </c:pt>
                <c:pt idx="222">
                  <c:v>1785.5953081600426</c:v>
                </c:pt>
                <c:pt idx="223">
                  <c:v>1759.8610915699223</c:v>
                </c:pt>
                <c:pt idx="224">
                  <c:v>1734.1126623606499</c:v>
                </c:pt>
                <c:pt idx="225">
                  <c:v>1708.3613903137157</c:v>
                </c:pt>
                <c:pt idx="226">
                  <c:v>1682.6186464659281</c:v>
                </c:pt>
                <c:pt idx="227">
                  <c:v>1656.8957980882826</c:v>
                </c:pt>
                <c:pt idx="228">
                  <c:v>1631.2042036664948</c:v>
                </c:pt>
                <c:pt idx="229">
                  <c:v>1605.5552078854134</c:v>
                </c:pt>
                <c:pt idx="230">
                  <c:v>1579.9601366195268</c:v>
                </c:pt>
                <c:pt idx="231">
                  <c:v>1554.4302919317752</c:v>
                </c:pt>
                <c:pt idx="232">
                  <c:v>1528.9769470828783</c:v>
                </c:pt>
                <c:pt idx="233">
                  <c:v>1503.6113415533805</c:v>
                </c:pt>
                <c:pt idx="234">
                  <c:v>1478.3446760806128</c:v>
                </c:pt>
                <c:pt idx="235">
                  <c:v>1453.1881077127621</c:v>
                </c:pt>
                <c:pt idx="236">
                  <c:v>1428.1527448822333</c:v>
                </c:pt>
                <c:pt idx="237">
                  <c:v>1403.2496425004783</c:v>
                </c:pt>
                <c:pt idx="238">
                  <c:v>1378.489797076458</c:v>
                </c:pt>
                <c:pt idx="239">
                  <c:v>1353.8841418608936</c:v>
                </c:pt>
                <c:pt idx="240">
                  <c:v>1329.4435420184504</c:v>
                </c:pt>
                <c:pt idx="241">
                  <c:v>1305.1787898299881</c:v>
                </c:pt>
                <c:pt idx="242">
                  <c:v>1281.1005999269937</c:v>
                </c:pt>
                <c:pt idx="243">
                  <c:v>1257.2196045602973</c:v>
                </c:pt>
                <c:pt idx="244">
                  <c:v>1233.5463489051765</c:v>
                </c:pt>
                <c:pt idx="245">
                  <c:v>1210.0912864048994</c:v>
                </c:pt>
                <c:pt idx="246">
                  <c:v>1186.8647741547791</c:v>
                </c:pt>
                <c:pt idx="247">
                  <c:v>1163.8770683287721</c:v>
                </c:pt>
                <c:pt idx="248">
                  <c:v>1141.1383196506408</c:v>
                </c:pt>
                <c:pt idx="249">
                  <c:v>1118.6585689116796</c:v>
                </c:pt>
                <c:pt idx="250">
                  <c:v>1096.4477425369842</c:v>
                </c:pt>
                <c:pt idx="251">
                  <c:v>1074.5156482022214</c:v>
                </c:pt>
                <c:pt idx="252">
                  <c:v>1052.8719705028357</c:v>
                </c:pt>
                <c:pt idx="253">
                  <c:v>1031.5262666776046</c:v>
                </c:pt>
                <c:pt idx="254">
                  <c:v>1010.4879623884311</c:v>
                </c:pt>
                <c:pt idx="255">
                  <c:v>989.76634755823727</c:v>
                </c:pt>
                <c:pt idx="256">
                  <c:v>969.37057226879472</c:v>
                </c:pt>
                <c:pt idx="257">
                  <c:v>949.30964272030667</c:v>
                </c:pt>
                <c:pt idx="258">
                  <c:v>929.59241725452375</c:v>
                </c:pt>
                <c:pt idx="259">
                  <c:v>910.22760244314861</c:v>
                </c:pt>
                <c:pt idx="260">
                  <c:v>891.22374924326061</c:v>
                </c:pt>
                <c:pt idx="261">
                  <c:v>872.58924922145241</c:v>
                </c:pt>
                <c:pt idx="262">
                  <c:v>854.33233084835092</c:v>
                </c:pt>
                <c:pt idx="263">
                  <c:v>836.46105586515671</c:v>
                </c:pt>
                <c:pt idx="264">
                  <c:v>818.98331572380516</c:v>
                </c:pt>
                <c:pt idx="265">
                  <c:v>801.90682810232443</c:v>
                </c:pt>
                <c:pt idx="266">
                  <c:v>785.23913349692543</c:v>
                </c:pt>
                <c:pt idx="267">
                  <c:v>768.9875918923309</c:v>
                </c:pt>
                <c:pt idx="268">
                  <c:v>753.15937951181411</c:v>
                </c:pt>
                <c:pt idx="269">
                  <c:v>737.7614856483799</c:v>
                </c:pt>
                <c:pt idx="270">
                  <c:v>722.80070957848989</c:v>
                </c:pt>
                <c:pt idx="271">
                  <c:v>708.28365755969401</c:v>
                </c:pt>
                <c:pt idx="272">
                  <c:v>694.21673991349098</c:v>
                </c:pt>
                <c:pt idx="273">
                  <c:v>680.6061681947142</c:v>
                </c:pt>
                <c:pt idx="274">
                  <c:v>667.45795244868123</c:v>
                </c:pt>
                <c:pt idx="275">
                  <c:v>654.77789855732817</c:v>
                </c:pt>
                <c:pt idx="276">
                  <c:v>642.57160567549545</c:v>
                </c:pt>
                <c:pt idx="277">
                  <c:v>630.84446375849848</c:v>
                </c:pt>
                <c:pt idx="278">
                  <c:v>619.60165118207533</c:v>
                </c:pt>
                <c:pt idx="279">
                  <c:v>608.84813245576152</c:v>
                </c:pt>
                <c:pt idx="280">
                  <c:v>598.58865603070285</c:v>
                </c:pt>
                <c:pt idx="281">
                  <c:v>588.82775220287249</c:v>
                </c:pt>
                <c:pt idx="282">
                  <c:v>579.56973111262027</c:v>
                </c:pt>
                <c:pt idx="283">
                  <c:v>570.81868084143525</c:v>
                </c:pt>
                <c:pt idx="284">
                  <c:v>562.5784656067658</c:v>
                </c:pt>
                <c:pt idx="285">
                  <c:v>554.85272405568753</c:v>
                </c:pt>
                <c:pt idx="286">
                  <c:v>547.64486765818106</c:v>
                </c:pt>
                <c:pt idx="287">
                  <c:v>540.95807920072161</c:v>
                </c:pt>
                <c:pt idx="288">
                  <c:v>534.79531138085213</c:v>
                </c:pt>
                <c:pt idx="289">
                  <c:v>529.15928550335229</c:v>
                </c:pt>
                <c:pt idx="290">
                  <c:v>524.05249027858895</c:v>
                </c:pt>
                <c:pt idx="291">
                  <c:v>519.47718072357156</c:v>
                </c:pt>
                <c:pt idx="292">
                  <c:v>515.43537716619903</c:v>
                </c:pt>
                <c:pt idx="293">
                  <c:v>511.92886435314108</c:v>
                </c:pt>
                <c:pt idx="294">
                  <c:v>508.95919066174338</c:v>
                </c:pt>
                <c:pt idx="295">
                  <c:v>506.52766741630876</c:v>
                </c:pt>
                <c:pt idx="296">
                  <c:v>504.63536830905196</c:v>
                </c:pt>
                <c:pt idx="297">
                  <c:v>503.28312892598819</c:v>
                </c:pt>
                <c:pt idx="298">
                  <c:v>502.47154637796211</c:v>
                </c:pt>
                <c:pt idx="299">
                  <c:v>502.20097903698002</c:v>
                </c:pt>
              </c:numCache>
            </c:numRef>
          </c:xVal>
          <c:yVal>
            <c:numRef>
              <c:f>'Covariance   Correlation3'!yycir19</c:f>
              <c:numCache>
                <c:formatCode>General</c:formatCode>
                <c:ptCount val="300"/>
                <c:pt idx="0">
                  <c:v>0.21123718224520768</c:v>
                </c:pt>
                <c:pt idx="1">
                  <c:v>0.17678925073384866</c:v>
                </c:pt>
                <c:pt idx="2">
                  <c:v>0.14244084307730714</c:v>
                </c:pt>
                <c:pt idx="3">
                  <c:v>0.10820712656545714</c:v>
                </c:pt>
                <c:pt idx="4">
                  <c:v>7.4103217843791758E-2</c:v>
                </c:pt>
                <c:pt idx="5">
                  <c:v>4.0144176238338353E-2</c:v>
                </c:pt>
                <c:pt idx="6">
                  <c:v>6.3449971058837928E-3</c:v>
                </c:pt>
                <c:pt idx="7">
                  <c:v>-2.727939478755198E-2</c:v>
                </c:pt>
                <c:pt idx="8">
                  <c:v>-6.0714151857075571E-2</c:v>
                </c:pt>
                <c:pt idx="9">
                  <c:v>-9.3944510255191238E-2</c:v>
                </c:pt>
                <c:pt idx="10">
                  <c:v>-0.12695579639110305</c:v>
                </c:pt>
                <c:pt idx="11">
                  <c:v>-0.15973343341015903</c:v>
                </c:pt>
                <c:pt idx="12">
                  <c:v>-0.19226294763057977</c:v>
                </c:pt>
                <c:pt idx="13">
                  <c:v>-0.22452997493462878</c:v>
                </c:pt>
                <c:pt idx="14">
                  <c:v>-0.2565202671114023</c:v>
                </c:pt>
                <c:pt idx="15">
                  <c:v>-0.28821969814843862</c:v>
                </c:pt>
                <c:pt idx="16">
                  <c:v>-0.31961427046936736</c:v>
                </c:pt>
                <c:pt idx="17">
                  <c:v>-0.35069012111484449</c:v>
                </c:pt>
                <c:pt idx="18">
                  <c:v>-0.38143352786404633</c:v>
                </c:pt>
                <c:pt idx="19">
                  <c:v>-0.4118309152940145</c:v>
                </c:pt>
                <c:pt idx="20">
                  <c:v>-0.44186886077418119</c:v>
                </c:pt>
                <c:pt idx="21">
                  <c:v>-0.47153410039342508</c:v>
                </c:pt>
                <c:pt idx="22">
                  <c:v>-0.50081353481704105</c:v>
                </c:pt>
                <c:pt idx="23">
                  <c:v>-0.52969423507103652</c:v>
                </c:pt>
                <c:pt idx="24">
                  <c:v>-0.55816344825120545</c:v>
                </c:pt>
                <c:pt idx="25">
                  <c:v>-0.58620860315444812</c:v>
                </c:pt>
                <c:pt idx="26">
                  <c:v>-0.61381731582986254</c:v>
                </c:pt>
                <c:pt idx="27">
                  <c:v>-0.64097739504714801</c:v>
                </c:pt>
                <c:pt idx="28">
                  <c:v>-0.66767684767990998</c:v>
                </c:pt>
                <c:pt idx="29">
                  <c:v>-0.69390388400148562</c:v>
                </c:pt>
                <c:pt idx="30">
                  <c:v>-0.719646922890957</c:v>
                </c:pt>
                <c:pt idx="31">
                  <c:v>-0.74489459694704652</c:v>
                </c:pt>
                <c:pt idx="32">
                  <c:v>-0.7696357575076419</c:v>
                </c:pt>
                <c:pt idx="33">
                  <c:v>-0.79385947957273162</c:v>
                </c:pt>
                <c:pt idx="34">
                  <c:v>-0.81755506662857746</c:v>
                </c:pt>
                <c:pt idx="35">
                  <c:v>-0.84071205537099369</c:v>
                </c:pt>
                <c:pt idx="36">
                  <c:v>-0.86332022032564748</c:v>
                </c:pt>
                <c:pt idx="37">
                  <c:v>-0.88536957836334051</c:v>
                </c:pt>
                <c:pt idx="38">
                  <c:v>-0.9068503931082782</c:v>
                </c:pt>
                <c:pt idx="39">
                  <c:v>-0.92775317923737877</c:v>
                </c:pt>
                <c:pt idx="40">
                  <c:v>-0.94806870666872556</c:v>
                </c:pt>
                <c:pt idx="41">
                  <c:v>-0.96778800463730918</c:v>
                </c:pt>
                <c:pt idx="42">
                  <c:v>-0.98690236565626865</c:v>
                </c:pt>
                <c:pt idx="43">
                  <c:v>-1.0054033493618686</c:v>
                </c:pt>
                <c:pt idx="44">
                  <c:v>-1.0232827862405287</c:v>
                </c:pt>
                <c:pt idx="45">
                  <c:v>-1.0405327812362506</c:v>
                </c:pt>
                <c:pt idx="46">
                  <c:v>-1.0571457172368508</c:v>
                </c:pt>
                <c:pt idx="47">
                  <c:v>-1.0731142584374644</c:v>
                </c:pt>
                <c:pt idx="48">
                  <c:v>-1.0884313535798307</c:v>
                </c:pt>
                <c:pt idx="49">
                  <c:v>-1.1030902390659281</c:v>
                </c:pt>
                <c:pt idx="50">
                  <c:v>-1.1170844419445909</c:v>
                </c:pt>
                <c:pt idx="51">
                  <c:v>-1.1304077827697805</c:v>
                </c:pt>
                <c:pt idx="52">
                  <c:v>-1.1430543783292557</c:v>
                </c:pt>
                <c:pt idx="53">
                  <c:v>-1.1550186442424335</c:v>
                </c:pt>
                <c:pt idx="54">
                  <c:v>-1.166295297426295</c:v>
                </c:pt>
                <c:pt idx="55">
                  <c:v>-1.1768793584282449</c:v>
                </c:pt>
                <c:pt idx="56">
                  <c:v>-1.1867661536248981</c:v>
                </c:pt>
                <c:pt idx="57">
                  <c:v>-1.19595131728582</c:v>
                </c:pt>
                <c:pt idx="58">
                  <c:v>-1.2044307935013117</c:v>
                </c:pt>
                <c:pt idx="59">
                  <c:v>-1.2122008379733824</c:v>
                </c:pt>
                <c:pt idx="60">
                  <c:v>-1.2192580196691296</c:v>
                </c:pt>
                <c:pt idx="61">
                  <c:v>-1.2255992223357841</c:v>
                </c:pt>
                <c:pt idx="62">
                  <c:v>-1.2312216458767604</c:v>
                </c:pt>
                <c:pt idx="63">
                  <c:v>-1.2361228075881003</c:v>
                </c:pt>
                <c:pt idx="64">
                  <c:v>-1.2403005432547662</c:v>
                </c:pt>
                <c:pt idx="65">
                  <c:v>-1.2437530081062949</c:v>
                </c:pt>
                <c:pt idx="66">
                  <c:v>-1.2464786776313987</c:v>
                </c:pt>
                <c:pt idx="67">
                  <c:v>-1.248476348251147</c:v>
                </c:pt>
                <c:pt idx="68">
                  <c:v>-1.2497451378504301</c:v>
                </c:pt>
                <c:pt idx="69">
                  <c:v>-1.2502844861674787</c:v>
                </c:pt>
                <c:pt idx="70">
                  <c:v>-1.2500941550412596</c:v>
                </c:pt>
                <c:pt idx="71">
                  <c:v>-1.2491742285166405</c:v>
                </c:pt>
                <c:pt idx="72">
                  <c:v>-1.2475251128072771</c:v>
                </c:pt>
                <c:pt idx="73">
                  <c:v>-1.2451475361162421</c:v>
                </c:pt>
                <c:pt idx="74">
                  <c:v>-1.242042548314471</c:v>
                </c:pt>
                <c:pt idx="75">
                  <c:v>-1.2382115204771684</c:v>
                </c:pt>
                <c:pt idx="76">
                  <c:v>-1.2336561442783787</c:v>
                </c:pt>
                <c:pt idx="77">
                  <c:v>-1.2283784312439925</c:v>
                </c:pt>
                <c:pt idx="78">
                  <c:v>-1.2223807118635126</c:v>
                </c:pt>
                <c:pt idx="79">
                  <c:v>-1.215665634560974</c:v>
                </c:pt>
                <c:pt idx="80">
                  <c:v>-1.2082361645254769</c:v>
                </c:pt>
                <c:pt idx="81">
                  <c:v>-1.2000955824018402</c:v>
                </c:pt>
                <c:pt idx="82">
                  <c:v>-1.1912474828419639</c:v>
                </c:pt>
                <c:pt idx="83">
                  <c:v>-1.1816957729175286</c:v>
                </c:pt>
                <c:pt idx="84">
                  <c:v>-1.1714446703947459</c:v>
                </c:pt>
                <c:pt idx="85">
                  <c:v>-1.1604987018719088</c:v>
                </c:pt>
                <c:pt idx="86">
                  <c:v>-1.1488627007805765</c:v>
                </c:pt>
                <c:pt idx="87">
                  <c:v>-1.1365418052512635</c:v>
                </c:pt>
                <c:pt idx="88">
                  <c:v>-1.1235414558445878</c:v>
                </c:pt>
                <c:pt idx="89">
                  <c:v>-1.1098673931488736</c:v>
                </c:pt>
                <c:pt idx="90">
                  <c:v>-1.0955256552452659</c:v>
                </c:pt>
                <c:pt idx="91">
                  <c:v>-1.0805225750414866</c:v>
                </c:pt>
                <c:pt idx="92">
                  <c:v>-1.0648647774754001</c:v>
                </c:pt>
                <c:pt idx="93">
                  <c:v>-1.0485591765896265</c:v>
                </c:pt>
                <c:pt idx="94">
                  <c:v>-1.0316129724784955</c:v>
                </c:pt>
                <c:pt idx="95">
                  <c:v>-1.0140336481086876</c:v>
                </c:pt>
                <c:pt idx="96">
                  <c:v>-0.99582896601496618</c:v>
                </c:pt>
                <c:pt idx="97">
                  <c:v>-0.97700696487246086</c:v>
                </c:pt>
                <c:pt idx="98">
                  <c:v>-0.95757595594701561</c:v>
                </c:pt>
                <c:pt idx="99">
                  <c:v>-0.93754451942516659</c:v>
                </c:pt>
                <c:pt idx="100">
                  <c:v>-0.91692150062537381</c:v>
                </c:pt>
                <c:pt idx="101">
                  <c:v>-0.89571600609217772</c:v>
                </c:pt>
                <c:pt idx="102">
                  <c:v>-0.87393739957500494</c:v>
                </c:pt>
                <c:pt idx="103">
                  <c:v>-0.85159529789340094</c:v>
                </c:pt>
                <c:pt idx="104">
                  <c:v>-0.82869956669051192</c:v>
                </c:pt>
                <c:pt idx="105">
                  <c:v>-0.80526031607669657</c:v>
                </c:pt>
                <c:pt idx="106">
                  <c:v>-0.78128789616518401</c:v>
                </c:pt>
                <c:pt idx="107">
                  <c:v>-0.75679289250175619</c:v>
                </c:pt>
                <c:pt idx="108">
                  <c:v>-0.73178612139046761</c:v>
                </c:pt>
                <c:pt idx="109">
                  <c:v>-0.70627862511747175</c:v>
                </c:pt>
                <c:pt idx="110">
                  <c:v>-0.68028166707505822</c:v>
                </c:pt>
                <c:pt idx="111">
                  <c:v>-0.65380672678805363</c:v>
                </c:pt>
                <c:pt idx="112">
                  <c:v>-0.62686549484478937</c:v>
                </c:pt>
                <c:pt idx="113">
                  <c:v>-0.59946986773486421</c:v>
                </c:pt>
                <c:pt idx="114">
                  <c:v>-0.57163194259599193</c:v>
                </c:pt>
                <c:pt idx="115">
                  <c:v>-0.54336401187224448</c:v>
                </c:pt>
                <c:pt idx="116">
                  <c:v>-0.5146785578860541</c:v>
                </c:pt>
                <c:pt idx="117">
                  <c:v>-0.48558824732637318</c:v>
                </c:pt>
                <c:pt idx="118">
                  <c:v>-0.45610592565541885</c:v>
                </c:pt>
                <c:pt idx="119">
                  <c:v>-0.42624461143648018</c:v>
                </c:pt>
                <c:pt idx="120">
                  <c:v>-0.39601749058528563</c:v>
                </c:pt>
                <c:pt idx="121">
                  <c:v>-0.36543791054747554</c:v>
                </c:pt>
                <c:pt idx="122">
                  <c:v>-0.33451937440474305</c:v>
                </c:pt>
                <c:pt idx="123">
                  <c:v>-0.30327553491225728</c:v>
                </c:pt>
                <c:pt idx="124">
                  <c:v>-0.27172018846998786</c:v>
                </c:pt>
                <c:pt idx="125">
                  <c:v>-0.23986726903060462</c:v>
                </c:pt>
                <c:pt idx="126">
                  <c:v>-0.2077308419466356</c:v>
                </c:pt>
                <c:pt idx="127">
                  <c:v>-0.17532509775960395</c:v>
                </c:pt>
                <c:pt idx="128">
                  <c:v>-0.14266434593388352</c:v>
                </c:pt>
                <c:pt idx="129">
                  <c:v>-0.10976300853804297</c:v>
                </c:pt>
                <c:pt idx="130">
                  <c:v>-7.6635613876465586E-2</c:v>
                </c:pt>
                <c:pt idx="131">
                  <c:v>-4.3296790074060093E-2</c:v>
                </c:pt>
                <c:pt idx="132">
                  <c:v>-9.7612586168912274E-3</c:v>
                </c:pt>
                <c:pt idx="133">
                  <c:v>2.3956172148413279E-2</c:v>
                </c:pt>
                <c:pt idx="134">
                  <c:v>5.7840613553611836E-2</c:v>
                </c:pt>
                <c:pt idx="135">
                  <c:v>9.1877103183265918E-2</c:v>
                </c:pt>
                <c:pt idx="136">
                  <c:v>0.12605061148172059</c:v>
                </c:pt>
                <c:pt idx="137">
                  <c:v>0.16034604838973626</c:v>
                </c:pt>
                <c:pt idx="138">
                  <c:v>0.19474827000782946</c:v>
                </c:pt>
                <c:pt idx="139">
                  <c:v>0.22924208528339582</c:v>
                </c:pt>
                <c:pt idx="140">
                  <c:v>0.26381226271865021</c:v>
                </c:pt>
                <c:pt idx="141">
                  <c:v>0.2984435370964274</c:v>
                </c:pt>
                <c:pt idx="142">
                  <c:v>0.3331206162208723</c:v>
                </c:pt>
                <c:pt idx="143">
                  <c:v>0.36782818767004322</c:v>
                </c:pt>
                <c:pt idx="144">
                  <c:v>0.40255092555744615</c:v>
                </c:pt>
                <c:pt idx="145">
                  <c:v>0.43727349729951503</c:v>
                </c:pt>
                <c:pt idx="146">
                  <c:v>0.4719805703860489</c:v>
                </c:pt>
                <c:pt idx="147">
                  <c:v>0.50665681915061667</c:v>
                </c:pt>
                <c:pt idx="148">
                  <c:v>0.54128693153794027</c:v>
                </c:pt>
                <c:pt idx="149">
                  <c:v>0.57585561586526668</c:v>
                </c:pt>
                <c:pt idx="150">
                  <c:v>0.6103476075747446</c:v>
                </c:pt>
                <c:pt idx="151">
                  <c:v>0.64474767597382565</c:v>
                </c:pt>
                <c:pt idx="152">
                  <c:v>0.67904063096070566</c:v>
                </c:pt>
                <c:pt idx="153">
                  <c:v>0.71321132973184853</c:v>
                </c:pt>
                <c:pt idx="154">
                  <c:v>0.74724468346862116</c:v>
                </c:pt>
                <c:pt idx="155">
                  <c:v>0.78112566400009142</c:v>
                </c:pt>
                <c:pt idx="156">
                  <c:v>0.81483931043904534</c:v>
                </c:pt>
                <c:pt idx="157">
                  <c:v>0.84837073578829325</c:v>
                </c:pt>
                <c:pt idx="158">
                  <c:v>0.88170513351434909</c:v>
                </c:pt>
                <c:pt idx="159">
                  <c:v>0.91482778408557852</c:v>
                </c:pt>
                <c:pt idx="160">
                  <c:v>0.94772406147193011</c:v>
                </c:pt>
                <c:pt idx="161">
                  <c:v>0.98037943960337803</c:v>
                </c:pt>
                <c:pt idx="162">
                  <c:v>1.0127794987842258</c:v>
                </c:pt>
                <c:pt idx="163">
                  <c:v>1.044909932060438</c:v>
                </c:pt>
                <c:pt idx="164">
                  <c:v>1.076756551537188</c:v>
                </c:pt>
                <c:pt idx="165">
                  <c:v>1.108305294643835</c:v>
                </c:pt>
                <c:pt idx="166">
                  <c:v>1.1395422303435556</c:v>
                </c:pt>
                <c:pt idx="167">
                  <c:v>1.1704535652849009</c:v>
                </c:pt>
                <c:pt idx="168">
                  <c:v>1.20102564989255</c:v>
                </c:pt>
                <c:pt idx="169">
                  <c:v>1.2312449843945796</c:v>
                </c:pt>
                <c:pt idx="170">
                  <c:v>1.2610982247835825</c:v>
                </c:pt>
                <c:pt idx="171">
                  <c:v>1.2905721887090063</c:v>
                </c:pt>
                <c:pt idx="172">
                  <c:v>1.3196538612981072</c:v>
                </c:pt>
                <c:pt idx="173">
                  <c:v>1.3483304009029524</c:v>
                </c:pt>
                <c:pt idx="174">
                  <c:v>1.3765891447709295</c:v>
                </c:pt>
                <c:pt idx="175">
                  <c:v>1.4044176146362632</c:v>
                </c:pt>
                <c:pt idx="176">
                  <c:v>1.4318035222300645</c:v>
                </c:pt>
                <c:pt idx="177">
                  <c:v>1.4587347747064836</c:v>
                </c:pt>
                <c:pt idx="178">
                  <c:v>1.4851994799825732</c:v>
                </c:pt>
                <c:pt idx="179">
                  <c:v>1.5111859519894959</c:v>
                </c:pt>
                <c:pt idx="180">
                  <c:v>1.5366827158327621</c:v>
                </c:pt>
                <c:pt idx="181">
                  <c:v>1.5616785128592217</c:v>
                </c:pt>
                <c:pt idx="182">
                  <c:v>1.5861623056285681</c:v>
                </c:pt>
                <c:pt idx="183">
                  <c:v>1.610123282787161</c:v>
                </c:pt>
                <c:pt idx="184">
                  <c:v>1.6335508638420173</c:v>
                </c:pt>
                <c:pt idx="185">
                  <c:v>1.6564347038328551</c:v>
                </c:pt>
                <c:pt idx="186">
                  <c:v>1.6787646979001418</c:v>
                </c:pt>
                <c:pt idx="187">
                  <c:v>1.700530985747112</c:v>
                </c:pt>
                <c:pt idx="188">
                  <c:v>1.7217239559937987</c:v>
                </c:pt>
                <c:pt idx="189">
                  <c:v>1.742334250421147</c:v>
                </c:pt>
                <c:pt idx="190">
                  <c:v>1.7623527681033411</c:v>
                </c:pt>
                <c:pt idx="191">
                  <c:v>1.7817706694265174</c:v>
                </c:pt>
                <c:pt idx="192">
                  <c:v>1.8005793799920875</c:v>
                </c:pt>
                <c:pt idx="193">
                  <c:v>1.8187705944029529</c:v>
                </c:pt>
                <c:pt idx="194">
                  <c:v>1.8363362799309328</c:v>
                </c:pt>
                <c:pt idx="195">
                  <c:v>1.8532686800637928</c:v>
                </c:pt>
                <c:pt idx="196">
                  <c:v>1.8695603179303</c:v>
                </c:pt>
                <c:pt idx="197">
                  <c:v>1.8852039996018015</c:v>
                </c:pt>
                <c:pt idx="198">
                  <c:v>1.9001928172688585</c:v>
                </c:pt>
                <c:pt idx="199">
                  <c:v>1.9145201522915416</c:v>
                </c:pt>
                <c:pt idx="200">
                  <c:v>1.9281796781220362</c:v>
                </c:pt>
                <c:pt idx="201">
                  <c:v>1.9411653630982664</c:v>
                </c:pt>
                <c:pt idx="202">
                  <c:v>1.9534714731073088</c:v>
                </c:pt>
                <c:pt idx="203">
                  <c:v>1.9650925741174148</c:v>
                </c:pt>
                <c:pt idx="204">
                  <c:v>1.9760235345775252</c:v>
                </c:pt>
                <c:pt idx="205">
                  <c:v>1.98625952768322</c:v>
                </c:pt>
                <c:pt idx="206">
                  <c:v>1.9957960335080991</c:v>
                </c:pt>
                <c:pt idx="207">
                  <c:v>2.0046288409996533</c:v>
                </c:pt>
                <c:pt idx="208">
                  <c:v>2.0127540498387488</c:v>
                </c:pt>
                <c:pt idx="209">
                  <c:v>2.0201680721618951</c:v>
                </c:pt>
                <c:pt idx="210">
                  <c:v>2.0268676341455487</c:v>
                </c:pt>
                <c:pt idx="211">
                  <c:v>2.0328497774517369</c:v>
                </c:pt>
                <c:pt idx="212">
                  <c:v>2.0381118605343809</c:v>
                </c:pt>
                <c:pt idx="213">
                  <c:v>2.0426515598057247</c:v>
                </c:pt>
                <c:pt idx="214">
                  <c:v>2.0464668706623672</c:v>
                </c:pt>
                <c:pt idx="215">
                  <c:v>2.0495561083704406</c:v>
                </c:pt>
                <c:pt idx="216">
                  <c:v>2.0519179088095374</c:v>
                </c:pt>
                <c:pt idx="217">
                  <c:v>2.0535512290750724</c:v>
                </c:pt>
                <c:pt idx="218">
                  <c:v>2.0544553479387955</c:v>
                </c:pt>
                <c:pt idx="219">
                  <c:v>2.0546298661672679</c:v>
                </c:pt>
                <c:pt idx="220">
                  <c:v>2.0540747066981542</c:v>
                </c:pt>
                <c:pt idx="221">
                  <c:v>2.052790114674246</c:v>
                </c:pt>
                <c:pt idx="222">
                  <c:v>2.05077665733522</c:v>
                </c:pt>
                <c:pt idx="223">
                  <c:v>2.0480352237671542</c:v>
                </c:pt>
                <c:pt idx="224">
                  <c:v>2.0445670245099392</c:v>
                </c:pt>
                <c:pt idx="225">
                  <c:v>2.0403735910227314</c:v>
                </c:pt>
                <c:pt idx="226">
                  <c:v>2.0354567750077108</c:v>
                </c:pt>
                <c:pt idx="227">
                  <c:v>2.0298187475924152</c:v>
                </c:pt>
                <c:pt idx="228">
                  <c:v>2.0234619983710336</c:v>
                </c:pt>
                <c:pt idx="229">
                  <c:v>2.0163893343050723</c:v>
                </c:pt>
                <c:pt idx="230">
                  <c:v>2.0086038784838802</c:v>
                </c:pt>
                <c:pt idx="231">
                  <c:v>2.0001090687455765</c:v>
                </c:pt>
                <c:pt idx="232">
                  <c:v>1.9909086561590055</c:v>
                </c:pt>
                <c:pt idx="233">
                  <c:v>1.9810067033673611</c:v>
                </c:pt>
                <c:pt idx="234">
                  <c:v>1.9704075827942464</c:v>
                </c:pt>
                <c:pt idx="235">
                  <c:v>1.9591159747129274</c:v>
                </c:pt>
                <c:pt idx="236">
                  <c:v>1.9471368651796623</c:v>
                </c:pt>
                <c:pt idx="237">
                  <c:v>1.9344755438319949</c:v>
                </c:pt>
                <c:pt idx="238">
                  <c:v>1.9211376015530015</c:v>
                </c:pt>
                <c:pt idx="239">
                  <c:v>1.9071289280025145</c:v>
                </c:pt>
                <c:pt idx="240">
                  <c:v>1.8924557090164129</c:v>
                </c:pt>
                <c:pt idx="241">
                  <c:v>1.8771244238751337</c:v>
                </c:pt>
                <c:pt idx="242">
                  <c:v>1.8611418424426018</c:v>
                </c:pt>
                <c:pt idx="243">
                  <c:v>1.8445150221768494</c:v>
                </c:pt>
                <c:pt idx="244">
                  <c:v>1.8272513050136419</c:v>
                </c:pt>
                <c:pt idx="245">
                  <c:v>1.8093583141244853</c:v>
                </c:pt>
                <c:pt idx="246">
                  <c:v>1.7908439505504474</c:v>
                </c:pt>
                <c:pt idx="247">
                  <c:v>1.7717163897132826</c:v>
                </c:pt>
                <c:pt idx="248">
                  <c:v>1.7519840778053937</c:v>
                </c:pt>
                <c:pt idx="249">
                  <c:v>1.7316557280602316</c:v>
                </c:pt>
                <c:pt idx="250">
                  <c:v>1.7107403169047775</c:v>
                </c:pt>
                <c:pt idx="251">
                  <c:v>1.689247079995805</c:v>
                </c:pt>
                <c:pt idx="252">
                  <c:v>1.6671855081416735</c:v>
                </c:pt>
                <c:pt idx="253">
                  <c:v>1.6445653431114555</c:v>
                </c:pt>
                <c:pt idx="254">
                  <c:v>1.6213965733332445</c:v>
                </c:pt>
                <c:pt idx="255">
                  <c:v>1.5976894294835471</c:v>
                </c:pt>
                <c:pt idx="256">
                  <c:v>1.5734543799697038</c:v>
                </c:pt>
                <c:pt idx="257">
                  <c:v>1.5487021263073359</c:v>
                </c:pt>
                <c:pt idx="258">
                  <c:v>1.523443598394856</c:v>
                </c:pt>
                <c:pt idx="259">
                  <c:v>1.4976899496871334</c:v>
                </c:pt>
                <c:pt idx="260">
                  <c:v>1.4714525522704434</c:v>
                </c:pt>
                <c:pt idx="261">
                  <c:v>1.4447429918408714</c:v>
                </c:pt>
                <c:pt idx="262">
                  <c:v>1.4175730625883989</c:v>
                </c:pt>
                <c:pt idx="263">
                  <c:v>1.389954761988919</c:v>
                </c:pt>
                <c:pt idx="264">
                  <c:v>1.3619002855064894</c:v>
                </c:pt>
                <c:pt idx="265">
                  <c:v>1.3334220212081591</c:v>
                </c:pt>
                <c:pt idx="266">
                  <c:v>1.3045325442937463</c:v>
                </c:pt>
                <c:pt idx="267">
                  <c:v>1.2752446115429841</c:v>
                </c:pt>
                <c:pt idx="268">
                  <c:v>1.2455711556824873</c:v>
                </c:pt>
                <c:pt idx="269">
                  <c:v>1.2155252796750209</c:v>
                </c:pt>
                <c:pt idx="270">
                  <c:v>1.1851202509336043</c:v>
                </c:pt>
                <c:pt idx="271">
                  <c:v>1.1543694954629944</c:v>
                </c:pt>
                <c:pt idx="272">
                  <c:v>1.1232865919311357</c:v>
                </c:pt>
                <c:pt idx="273">
                  <c:v>1.0918852656732096</c:v>
                </c:pt>
                <c:pt idx="274">
                  <c:v>1.0601793826309078</c:v>
                </c:pt>
                <c:pt idx="275">
                  <c:v>1.0281829432296252</c:v>
                </c:pt>
                <c:pt idx="276">
                  <c:v>0.99591007619626437</c:v>
                </c:pt>
                <c:pt idx="277">
                  <c:v>0.96337503232038968</c:v>
                </c:pt>
                <c:pt idx="278">
                  <c:v>0.93059217816147721</c:v>
                </c:pt>
                <c:pt idx="279">
                  <c:v>0.89757598970504848</c:v>
                </c:pt>
                <c:pt idx="280">
                  <c:v>0.86434104597048278</c:v>
                </c:pt>
                <c:pt idx="281">
                  <c:v>0.83090202257333101</c:v>
                </c:pt>
                <c:pt idx="282">
                  <c:v>0.79727368524497866</c:v>
                </c:pt>
                <c:pt idx="283">
                  <c:v>0.76347088331251323</c:v>
                </c:pt>
                <c:pt idx="284">
                  <c:v>0.72950854314168079</c:v>
                </c:pt>
                <c:pt idx="285">
                  <c:v>0.69540166154582184</c:v>
                </c:pt>
                <c:pt idx="286">
                  <c:v>0.66116529916370081</c:v>
                </c:pt>
                <c:pt idx="287">
                  <c:v>0.62681457380915306</c:v>
                </c:pt>
                <c:pt idx="288">
                  <c:v>0.59236465379548275</c:v>
                </c:pt>
                <c:pt idx="289">
                  <c:v>0.55783075123756309</c:v>
                </c:pt>
                <c:pt idx="290">
                  <c:v>0.52322811533459435</c:v>
                </c:pt>
                <c:pt idx="291">
                  <c:v>0.48857202563648772</c:v>
                </c:pt>
                <c:pt idx="292">
                  <c:v>0.45387778529684486</c:v>
                </c:pt>
                <c:pt idx="293">
                  <c:v>0.41916071431551705</c:v>
                </c:pt>
                <c:pt idx="294">
                  <c:v>0.38443614277372434</c:v>
                </c:pt>
                <c:pt idx="295">
                  <c:v>0.34971940406472285</c:v>
                </c:pt>
                <c:pt idx="296">
                  <c:v>0.31502582812301061</c:v>
                </c:pt>
                <c:pt idx="297">
                  <c:v>0.28037073465505918</c:v>
                </c:pt>
                <c:pt idx="298">
                  <c:v>0.24576942637456345</c:v>
                </c:pt>
                <c:pt idx="299">
                  <c:v>0.2112371822451949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421368"/>
        <c:axId val="283423328"/>
      </c:scatterChart>
      <c:valAx>
        <c:axId val="283421368"/>
        <c:scaling>
          <c:orientation val="minMax"/>
          <c:max val="30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423328"/>
        <c:crosses val="autoZero"/>
        <c:crossBetween val="midCat"/>
      </c:valAx>
      <c:valAx>
        <c:axId val="283423328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421368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826165960024233"/>
          <c:y val="0.15250000000000002"/>
          <c:w val="0.64991141732283464"/>
          <c:h val="0.71158333333333323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FF0000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FF0000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AE$1:$AE$15</c:f>
              <c:numCache>
                <c:formatCode>General</c:formatCode>
                <c:ptCount val="15"/>
                <c:pt idx="0">
                  <c:v>12.6</c:v>
                </c:pt>
                <c:pt idx="1">
                  <c:v>15.8</c:v>
                </c:pt>
                <c:pt idx="2">
                  <c:v>13.1</c:v>
                </c:pt>
                <c:pt idx="3">
                  <c:v>10</c:v>
                </c:pt>
                <c:pt idx="4">
                  <c:v>10.6</c:v>
                </c:pt>
                <c:pt idx="5">
                  <c:v>13.07</c:v>
                </c:pt>
                <c:pt idx="6">
                  <c:v>15.5</c:v>
                </c:pt>
                <c:pt idx="7">
                  <c:v>9.99</c:v>
                </c:pt>
                <c:pt idx="8">
                  <c:v>14.3</c:v>
                </c:pt>
                <c:pt idx="9">
                  <c:v>18</c:v>
                </c:pt>
                <c:pt idx="10">
                  <c:v>22.2</c:v>
                </c:pt>
                <c:pt idx="11">
                  <c:v>25</c:v>
                </c:pt>
                <c:pt idx="12">
                  <c:v>18.5</c:v>
                </c:pt>
                <c:pt idx="13">
                  <c:v>20.5</c:v>
                </c:pt>
                <c:pt idx="14">
                  <c:v>19.7</c:v>
                </c:pt>
              </c:numCache>
            </c:numRef>
          </c:xVal>
          <c:yVal>
            <c:numRef>
              <c:f>'Covariance   Correlation3_HID4'!$AF$1:$AF$15</c:f>
              <c:numCache>
                <c:formatCode>General</c:formatCode>
                <c:ptCount val="15"/>
                <c:pt idx="0">
                  <c:v>1.0531999999999999</c:v>
                </c:pt>
                <c:pt idx="1">
                  <c:v>1.6315999999999999</c:v>
                </c:pt>
                <c:pt idx="2">
                  <c:v>1.4011</c:v>
                </c:pt>
                <c:pt idx="3">
                  <c:v>5.6500000000000002E-2</c:v>
                </c:pt>
                <c:pt idx="4">
                  <c:v>0.2228999999999999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E-3</c:v>
                </c:pt>
                <c:pt idx="9">
                  <c:v>0</c:v>
                </c:pt>
                <c:pt idx="10">
                  <c:v>0.48499999999999999</c:v>
                </c:pt>
                <c:pt idx="11">
                  <c:v>0.84172000000000002</c:v>
                </c:pt>
                <c:pt idx="12">
                  <c:v>3.6700000000000003E-2</c:v>
                </c:pt>
                <c:pt idx="13">
                  <c:v>0.17710000000000001</c:v>
                </c:pt>
                <c:pt idx="14">
                  <c:v>0.1247999999999999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20</c:f>
              <c:numCache>
                <c:formatCode>General</c:formatCode>
                <c:ptCount val="300"/>
                <c:pt idx="0">
                  <c:v>2.2847777708606003</c:v>
                </c:pt>
                <c:pt idx="1">
                  <c:v>2.2877891191489059</c:v>
                </c:pt>
                <c:pt idx="2">
                  <c:v>2.2968218342871918</c:v>
                </c:pt>
                <c:pt idx="3">
                  <c:v>2.3118719276827324</c:v>
                </c:pt>
                <c:pt idx="4">
                  <c:v>2.332932753637964</c:v>
                </c:pt>
                <c:pt idx="5">
                  <c:v>2.3599950122850295</c:v>
                </c:pt>
                <c:pt idx="6">
                  <c:v>2.3930467536923459</c:v>
                </c:pt>
                <c:pt idx="7">
                  <c:v>2.432073383141347</c:v>
                </c:pt>
                <c:pt idx="8">
                  <c:v>2.4770576675711187</c:v>
                </c:pt>
                <c:pt idx="9">
                  <c:v>2.5279797431880127</c:v>
                </c:pt>
                <c:pt idx="10">
                  <c:v>2.5848171242369542</c:v>
                </c:pt>
                <c:pt idx="11">
                  <c:v>2.6475447129305056</c:v>
                </c:pt>
                <c:pt idx="12">
                  <c:v>2.7161348105313579</c:v>
                </c:pt>
                <c:pt idx="13">
                  <c:v>2.7905571295832985</c:v>
                </c:pt>
                <c:pt idx="14">
                  <c:v>2.8707788072853067</c:v>
                </c:pt>
                <c:pt idx="15">
                  <c:v>2.9567644200028429</c:v>
                </c:pt>
                <c:pt idx="16">
                  <c:v>3.0484759989099253</c:v>
                </c:pt>
                <c:pt idx="17">
                  <c:v>3.1458730467550957</c:v>
                </c:pt>
                <c:pt idx="18">
                  <c:v>3.2489125557438623</c:v>
                </c:pt>
                <c:pt idx="19">
                  <c:v>3.3575490265297372</c:v>
                </c:pt>
                <c:pt idx="20">
                  <c:v>3.4717344883054615</c:v>
                </c:pt>
                <c:pt idx="21">
                  <c:v>3.5914185199855702</c:v>
                </c:pt>
                <c:pt idx="22">
                  <c:v>3.7165482724709129</c:v>
                </c:pt>
                <c:pt idx="23">
                  <c:v>3.8470684919853362</c:v>
                </c:pt>
                <c:pt idx="24">
                  <c:v>3.9829215444742037</c:v>
                </c:pt>
                <c:pt idx="25">
                  <c:v>4.1240474410539534</c:v>
                </c:pt>
                <c:pt idx="26">
                  <c:v>4.2703838645015111</c:v>
                </c:pt>
                <c:pt idx="27">
                  <c:v>4.4218661967718198</c:v>
                </c:pt>
                <c:pt idx="28">
                  <c:v>4.5784275475313532</c:v>
                </c:pt>
                <c:pt idx="29">
                  <c:v>4.7399987836949933</c:v>
                </c:pt>
                <c:pt idx="30">
                  <c:v>4.9065085599532701</c:v>
                </c:pt>
                <c:pt idx="31">
                  <c:v>5.07788335027643</c:v>
                </c:pt>
                <c:pt idx="32">
                  <c:v>5.2540474803814607</c:v>
                </c:pt>
                <c:pt idx="33">
                  <c:v>5.4349231611477311</c:v>
                </c:pt>
                <c:pt idx="34">
                  <c:v>5.6204305229664708</c:v>
                </c:pt>
                <c:pt idx="35">
                  <c:v>5.8104876510089518</c:v>
                </c:pt>
                <c:pt idx="36">
                  <c:v>6.0050106213977532</c:v>
                </c:pt>
                <c:pt idx="37">
                  <c:v>6.2039135382651995</c:v>
                </c:pt>
                <c:pt idx="38">
                  <c:v>6.4071085716825458</c:v>
                </c:pt>
                <c:pt idx="39">
                  <c:v>6.6145059964432065</c:v>
                </c:pt>
                <c:pt idx="40">
                  <c:v>6.8260142316828851</c:v>
                </c:pt>
                <c:pt idx="41">
                  <c:v>7.0415398813191015</c:v>
                </c:pt>
                <c:pt idx="42">
                  <c:v>7.260987775292266</c:v>
                </c:pt>
                <c:pt idx="43">
                  <c:v>7.4842610115901174</c:v>
                </c:pt>
                <c:pt idx="44">
                  <c:v>7.7112609990368988</c:v>
                </c:pt>
                <c:pt idx="45">
                  <c:v>7.9418875008284644</c:v>
                </c:pt>
                <c:pt idx="46">
                  <c:v>8.1760386787940273</c:v>
                </c:pt>
                <c:pt idx="47">
                  <c:v>8.4136111383650221</c:v>
                </c:pt>
                <c:pt idx="48">
                  <c:v>8.6544999742312392</c:v>
                </c:pt>
                <c:pt idx="49">
                  <c:v>8.8985988166640553</c:v>
                </c:pt>
                <c:pt idx="50">
                  <c:v>9.1457998784863186</c:v>
                </c:pt>
                <c:pt idx="51">
                  <c:v>9.3959940026681199</c:v>
                </c:pt>
                <c:pt idx="52">
                  <c:v>9.6490707105274733</c:v>
                </c:pt>
                <c:pt idx="53">
                  <c:v>9.9049182505145872</c:v>
                </c:pt>
                <c:pt idx="54">
                  <c:v>10.163423647558204</c:v>
                </c:pt>
                <c:pt idx="55">
                  <c:v>10.424472752952219</c:v>
                </c:pt>
                <c:pt idx="56">
                  <c:v>10.687950294760521</c:v>
                </c:pt>
                <c:pt idx="57">
                  <c:v>10.953739928717841</c:v>
                </c:pt>
                <c:pt idx="58">
                  <c:v>11.221724289604106</c:v>
                </c:pt>
                <c:pt idx="59">
                  <c:v>11.491785043069619</c:v>
                </c:pt>
                <c:pt idx="60">
                  <c:v>11.763802937888169</c:v>
                </c:pt>
                <c:pt idx="61">
                  <c:v>12.037657858615017</c:v>
                </c:pt>
                <c:pt idx="62">
                  <c:v>12.313228878626504</c:v>
                </c:pt>
                <c:pt idx="63">
                  <c:v>12.590394313517837</c:v>
                </c:pt>
                <c:pt idx="64">
                  <c:v>12.86903177483549</c:v>
                </c:pt>
                <c:pt idx="65">
                  <c:v>13.149018224120509</c:v>
                </c:pt>
                <c:pt idx="66">
                  <c:v>13.43023002723883</c:v>
                </c:pt>
                <c:pt idx="67">
                  <c:v>13.712543008974635</c:v>
                </c:pt>
                <c:pt idx="68">
                  <c:v>13.995832507862616</c:v>
                </c:pt>
                <c:pt idx="69">
                  <c:v>14.279973431234998</c:v>
                </c:pt>
                <c:pt idx="70">
                  <c:v>14.564840310458909</c:v>
                </c:pt>
                <c:pt idx="71">
                  <c:v>14.850307356339815</c:v>
                </c:pt>
                <c:pt idx="72">
                  <c:v>15.13624851466648</c:v>
                </c:pt>
                <c:pt idx="73">
                  <c:v>15.422537521872961</c:v>
                </c:pt>
                <c:pt idx="74">
                  <c:v>15.709047960793034</c:v>
                </c:pt>
                <c:pt idx="75">
                  <c:v>15.995653316482473</c:v>
                </c:pt>
                <c:pt idx="76">
                  <c:v>16.282227032084482</c:v>
                </c:pt>
                <c:pt idx="77">
                  <c:v>16.56864256471362</c:v>
                </c:pt>
                <c:pt idx="78">
                  <c:v>16.854773441333613</c:v>
                </c:pt>
                <c:pt idx="79">
                  <c:v>17.140493314604253</c:v>
                </c:pt>
                <c:pt idx="80">
                  <c:v>17.425676018672849</c:v>
                </c:pt>
                <c:pt idx="81">
                  <c:v>17.710195624885504</c:v>
                </c:pt>
                <c:pt idx="82">
                  <c:v>17.993926497393666</c:v>
                </c:pt>
                <c:pt idx="83">
                  <c:v>18.276743348631392</c:v>
                </c:pt>
                <c:pt idx="84">
                  <c:v>18.558521294638791</c:v>
                </c:pt>
                <c:pt idx="85">
                  <c:v>18.839135910207279</c:v>
                </c:pt>
                <c:pt idx="86">
                  <c:v>19.118463283822244</c:v>
                </c:pt>
                <c:pt idx="87">
                  <c:v>19.396380072378886</c:v>
                </c:pt>
                <c:pt idx="88">
                  <c:v>19.672763555647052</c:v>
                </c:pt>
                <c:pt idx="89">
                  <c:v>19.947491690461042</c:v>
                </c:pt>
                <c:pt idx="90">
                  <c:v>20.220443164610447</c:v>
                </c:pt>
                <c:pt idx="91">
                  <c:v>20.491497450408168</c:v>
                </c:pt>
                <c:pt idx="92">
                  <c:v>20.760534857912091</c:v>
                </c:pt>
                <c:pt idx="93">
                  <c:v>21.027436587776773</c:v>
                </c:pt>
                <c:pt idx="94">
                  <c:v>21.292084783711896</c:v>
                </c:pt>
                <c:pt idx="95">
                  <c:v>21.554362584524288</c:v>
                </c:pt>
                <c:pt idx="96">
                  <c:v>21.814154175720525</c:v>
                </c:pt>
                <c:pt idx="97">
                  <c:v>22.071344840647377</c:v>
                </c:pt>
                <c:pt idx="98">
                  <c:v>22.325821011147418</c:v>
                </c:pt>
                <c:pt idx="99">
                  <c:v>22.577470317707554</c:v>
                </c:pt>
                <c:pt idx="100">
                  <c:v>22.826181639078225</c:v>
                </c:pt>
                <c:pt idx="101">
                  <c:v>23.071845151341421</c:v>
                </c:pt>
                <c:pt idx="102">
                  <c:v>23.314352376405843</c:v>
                </c:pt>
                <c:pt idx="103">
                  <c:v>23.55359622990775</c:v>
                </c:pt>
                <c:pt idx="104">
                  <c:v>23.789471068496432</c:v>
                </c:pt>
                <c:pt idx="105">
                  <c:v>24.021872736483317</c:v>
                </c:pt>
                <c:pt idx="106">
                  <c:v>24.250698611834189</c:v>
                </c:pt>
                <c:pt idx="107">
                  <c:v>24.475847651484205</c:v>
                </c:pt>
                <c:pt idx="108">
                  <c:v>24.697220435955671</c:v>
                </c:pt>
                <c:pt idx="109">
                  <c:v>24.914719213258849</c:v>
                </c:pt>
                <c:pt idx="110">
                  <c:v>25.128247942056532</c:v>
                </c:pt>
                <c:pt idx="111">
                  <c:v>25.337712334073153</c:v>
                </c:pt>
                <c:pt idx="112">
                  <c:v>25.54301989572987</c:v>
                </c:pt>
                <c:pt idx="113">
                  <c:v>25.744079968987098</c:v>
                </c:pt>
                <c:pt idx="114">
                  <c:v>25.940803771376551</c:v>
                </c:pt>
                <c:pt idx="115">
                  <c:v>26.133104435205102</c:v>
                </c:pt>
                <c:pt idx="116">
                  <c:v>26.320897045913085</c:v>
                </c:pt>
                <c:pt idx="117">
                  <c:v>26.504098679570191</c:v>
                </c:pt>
                <c:pt idx="118">
                  <c:v>26.682628439492337</c:v>
                </c:pt>
                <c:pt idx="119">
                  <c:v>26.856407491963353</c:v>
                </c:pt>
                <c:pt idx="120">
                  <c:v>27.025359101045748</c:v>
                </c:pt>
                <c:pt idx="121">
                  <c:v>27.189408662465134</c:v>
                </c:pt>
                <c:pt idx="122">
                  <c:v>27.348483736553376</c:v>
                </c:pt>
                <c:pt idx="123">
                  <c:v>27.502514080235898</c:v>
                </c:pt>
                <c:pt idx="124">
                  <c:v>27.651431678049065</c:v>
                </c:pt>
                <c:pt idx="125">
                  <c:v>27.795170772173883</c:v>
                </c:pt>
                <c:pt idx="126">
                  <c:v>27.933667891472808</c:v>
                </c:pt>
                <c:pt idx="127">
                  <c:v>28.066861879516807</c:v>
                </c:pt>
                <c:pt idx="128">
                  <c:v>28.194693921590321</c:v>
                </c:pt>
                <c:pt idx="129">
                  <c:v>28.317107570662202</c:v>
                </c:pt>
                <c:pt idx="130">
                  <c:v>28.43404877231109</c:v>
                </c:pt>
                <c:pt idx="131">
                  <c:v>28.545465888594375</c:v>
                </c:pt>
                <c:pt idx="132">
                  <c:v>28.651309720850023</c:v>
                </c:pt>
                <c:pt idx="133">
                  <c:v>28.751533531421337</c:v>
                </c:pt>
                <c:pt idx="134">
                  <c:v>28.846093064294983</c:v>
                </c:pt>
                <c:pt idx="135">
                  <c:v>28.934946564643205</c:v>
                </c:pt>
                <c:pt idx="136">
                  <c:v>29.01805479726157</c:v>
                </c:pt>
                <c:pt idx="137">
                  <c:v>29.095381063894159</c:v>
                </c:pt>
                <c:pt idx="138">
                  <c:v>29.16689121943844</c:v>
                </c:pt>
                <c:pt idx="139">
                  <c:v>29.232553687022822</c:v>
                </c:pt>
                <c:pt idx="140">
                  <c:v>29.292339471950093</c:v>
                </c:pt>
                <c:pt idx="141">
                  <c:v>29.346222174500664</c:v>
                </c:pt>
                <c:pt idx="142">
                  <c:v>29.394178001589957</c:v>
                </c:pt>
                <c:pt idx="143">
                  <c:v>29.43618577727473</c:v>
                </c:pt>
                <c:pt idx="144">
                  <c:v>29.472226952103817</c:v>
                </c:pt>
                <c:pt idx="145">
                  <c:v>29.502285611309013</c:v>
                </c:pt>
                <c:pt idx="146">
                  <c:v>29.526348481832592</c:v>
                </c:pt>
                <c:pt idx="147">
                  <c:v>29.544404938188336</c:v>
                </c:pt>
                <c:pt idx="148">
                  <c:v>29.556447007153423</c:v>
                </c:pt>
                <c:pt idx="149">
                  <c:v>29.562469371289197</c:v>
                </c:pt>
                <c:pt idx="150">
                  <c:v>29.562469371289197</c:v>
                </c:pt>
                <c:pt idx="151">
                  <c:v>29.556447007153416</c:v>
                </c:pt>
                <c:pt idx="152">
                  <c:v>29.544404938188322</c:v>
                </c:pt>
                <c:pt idx="153">
                  <c:v>29.526348481832578</c:v>
                </c:pt>
                <c:pt idx="154">
                  <c:v>29.502285611308992</c:v>
                </c:pt>
                <c:pt idx="155">
                  <c:v>29.472226952103796</c:v>
                </c:pt>
                <c:pt idx="156">
                  <c:v>29.436185777274702</c:v>
                </c:pt>
                <c:pt idx="157">
                  <c:v>29.394178001589921</c:v>
                </c:pt>
                <c:pt idx="158">
                  <c:v>29.346222174500628</c:v>
                </c:pt>
                <c:pt idx="159">
                  <c:v>29.292339471950051</c:v>
                </c:pt>
                <c:pt idx="160">
                  <c:v>29.232553687022776</c:v>
                </c:pt>
                <c:pt idx="161">
                  <c:v>29.166891219438391</c:v>
                </c:pt>
                <c:pt idx="162">
                  <c:v>29.095381063894102</c:v>
                </c:pt>
                <c:pt idx="163">
                  <c:v>29.018054797261513</c:v>
                </c:pt>
                <c:pt idx="164">
                  <c:v>28.934946564643141</c:v>
                </c:pt>
                <c:pt idx="165">
                  <c:v>28.846093064294919</c:v>
                </c:pt>
                <c:pt idx="166">
                  <c:v>28.75153353142127</c:v>
                </c:pt>
                <c:pt idx="167">
                  <c:v>28.651309720849952</c:v>
                </c:pt>
                <c:pt idx="168">
                  <c:v>28.5454658885943</c:v>
                </c:pt>
                <c:pt idx="169">
                  <c:v>28.434048772311012</c:v>
                </c:pt>
                <c:pt idx="170">
                  <c:v>28.317107570662117</c:v>
                </c:pt>
                <c:pt idx="171">
                  <c:v>28.194693921590236</c:v>
                </c:pt>
                <c:pt idx="172">
                  <c:v>28.066861879516715</c:v>
                </c:pt>
                <c:pt idx="173">
                  <c:v>27.933667891472712</c:v>
                </c:pt>
                <c:pt idx="174">
                  <c:v>27.795170772173787</c:v>
                </c:pt>
                <c:pt idx="175">
                  <c:v>27.651431678048965</c:v>
                </c:pt>
                <c:pt idx="176">
                  <c:v>27.502514080235795</c:v>
                </c:pt>
                <c:pt idx="177">
                  <c:v>27.348483736553266</c:v>
                </c:pt>
                <c:pt idx="178">
                  <c:v>27.189408662465024</c:v>
                </c:pt>
                <c:pt idx="179">
                  <c:v>27.02535910104563</c:v>
                </c:pt>
                <c:pt idx="180">
                  <c:v>26.856407491963232</c:v>
                </c:pt>
                <c:pt idx="181">
                  <c:v>26.682628439492213</c:v>
                </c:pt>
                <c:pt idx="182">
                  <c:v>26.504098679570067</c:v>
                </c:pt>
                <c:pt idx="183">
                  <c:v>26.320897045912957</c:v>
                </c:pt>
                <c:pt idx="184">
                  <c:v>26.13310443520497</c:v>
                </c:pt>
                <c:pt idx="185">
                  <c:v>25.940803771376416</c:v>
                </c:pt>
                <c:pt idx="186">
                  <c:v>25.744079968986959</c:v>
                </c:pt>
                <c:pt idx="187">
                  <c:v>25.543019895729731</c:v>
                </c:pt>
                <c:pt idx="188">
                  <c:v>25.337712334073011</c:v>
                </c:pt>
                <c:pt idx="189">
                  <c:v>25.128247942056383</c:v>
                </c:pt>
                <c:pt idx="190">
                  <c:v>24.914719213258699</c:v>
                </c:pt>
                <c:pt idx="191">
                  <c:v>24.697220435955522</c:v>
                </c:pt>
                <c:pt idx="192">
                  <c:v>24.475847651484052</c:v>
                </c:pt>
                <c:pt idx="193">
                  <c:v>24.250698611834032</c:v>
                </c:pt>
                <c:pt idx="194">
                  <c:v>24.021872736483154</c:v>
                </c:pt>
                <c:pt idx="195">
                  <c:v>23.789471068496269</c:v>
                </c:pt>
                <c:pt idx="196">
                  <c:v>23.553596229907587</c:v>
                </c:pt>
                <c:pt idx="197">
                  <c:v>23.314352376405672</c:v>
                </c:pt>
                <c:pt idx="198">
                  <c:v>23.071845151341254</c:v>
                </c:pt>
                <c:pt idx="199">
                  <c:v>22.826181639078051</c:v>
                </c:pt>
                <c:pt idx="200">
                  <c:v>22.57747031770738</c:v>
                </c:pt>
                <c:pt idx="201">
                  <c:v>22.325821011147241</c:v>
                </c:pt>
                <c:pt idx="202">
                  <c:v>22.0713448406472</c:v>
                </c:pt>
                <c:pt idx="203">
                  <c:v>21.814154175720347</c:v>
                </c:pt>
                <c:pt idx="204">
                  <c:v>21.554362584524103</c:v>
                </c:pt>
                <c:pt idx="205">
                  <c:v>21.292084783711708</c:v>
                </c:pt>
                <c:pt idx="206">
                  <c:v>21.027436587776585</c:v>
                </c:pt>
                <c:pt idx="207">
                  <c:v>20.7605348579119</c:v>
                </c:pt>
                <c:pt idx="208">
                  <c:v>20.491497450407977</c:v>
                </c:pt>
                <c:pt idx="209">
                  <c:v>20.220443164610252</c:v>
                </c:pt>
                <c:pt idx="210">
                  <c:v>19.947491690460851</c:v>
                </c:pt>
                <c:pt idx="211">
                  <c:v>19.672763555646853</c:v>
                </c:pt>
                <c:pt idx="212">
                  <c:v>19.396380072378687</c:v>
                </c:pt>
                <c:pt idx="213">
                  <c:v>19.118463283822042</c:v>
                </c:pt>
                <c:pt idx="214">
                  <c:v>18.839135910207087</c:v>
                </c:pt>
                <c:pt idx="215">
                  <c:v>18.558521294638602</c:v>
                </c:pt>
                <c:pt idx="216">
                  <c:v>18.2767433486312</c:v>
                </c:pt>
                <c:pt idx="217">
                  <c:v>17.993926497393474</c:v>
                </c:pt>
                <c:pt idx="218">
                  <c:v>17.710195624885309</c:v>
                </c:pt>
                <c:pt idx="219">
                  <c:v>17.425676018672654</c:v>
                </c:pt>
                <c:pt idx="220">
                  <c:v>17.140493314604058</c:v>
                </c:pt>
                <c:pt idx="221">
                  <c:v>16.854773441333418</c:v>
                </c:pt>
                <c:pt idx="222">
                  <c:v>16.568642564713425</c:v>
                </c:pt>
                <c:pt idx="223">
                  <c:v>16.282227032084283</c:v>
                </c:pt>
                <c:pt idx="224">
                  <c:v>15.995653316482278</c:v>
                </c:pt>
                <c:pt idx="225">
                  <c:v>15.709047960792835</c:v>
                </c:pt>
                <c:pt idx="226">
                  <c:v>15.42253752187276</c:v>
                </c:pt>
                <c:pt idx="227">
                  <c:v>15.136248514666281</c:v>
                </c:pt>
                <c:pt idx="228">
                  <c:v>14.850307356339616</c:v>
                </c:pt>
                <c:pt idx="229">
                  <c:v>14.564840310458711</c:v>
                </c:pt>
                <c:pt idx="230">
                  <c:v>14.279973431234799</c:v>
                </c:pt>
                <c:pt idx="231">
                  <c:v>13.995832507862417</c:v>
                </c:pt>
                <c:pt idx="232">
                  <c:v>13.712543008974434</c:v>
                </c:pt>
                <c:pt idx="233">
                  <c:v>13.430230027238631</c:v>
                </c:pt>
                <c:pt idx="234">
                  <c:v>13.14901822412031</c:v>
                </c:pt>
                <c:pt idx="235">
                  <c:v>12.869031774835292</c:v>
                </c:pt>
                <c:pt idx="236">
                  <c:v>12.59039431351764</c:v>
                </c:pt>
                <c:pt idx="237">
                  <c:v>12.31322887862631</c:v>
                </c:pt>
                <c:pt idx="238">
                  <c:v>12.037657858614821</c:v>
                </c:pt>
                <c:pt idx="239">
                  <c:v>11.763802937887972</c:v>
                </c:pt>
                <c:pt idx="240">
                  <c:v>11.491785043069424</c:v>
                </c:pt>
                <c:pt idx="241">
                  <c:v>11.221724289603912</c:v>
                </c:pt>
                <c:pt idx="242">
                  <c:v>10.95373992871766</c:v>
                </c:pt>
                <c:pt idx="243">
                  <c:v>10.687950294760341</c:v>
                </c:pt>
                <c:pt idx="244">
                  <c:v>10.424472752952042</c:v>
                </c:pt>
                <c:pt idx="245">
                  <c:v>10.163423647558028</c:v>
                </c:pt>
                <c:pt idx="246">
                  <c:v>9.9049182505144096</c:v>
                </c:pt>
                <c:pt idx="247">
                  <c:v>9.6490707105272957</c:v>
                </c:pt>
                <c:pt idx="248">
                  <c:v>9.395994002667944</c:v>
                </c:pt>
                <c:pt idx="249">
                  <c:v>9.1457998784861445</c:v>
                </c:pt>
                <c:pt idx="250">
                  <c:v>8.898598816663883</c:v>
                </c:pt>
                <c:pt idx="251">
                  <c:v>8.6544999742310686</c:v>
                </c:pt>
                <c:pt idx="252">
                  <c:v>8.4136111383648551</c:v>
                </c:pt>
                <c:pt idx="253">
                  <c:v>8.1760386787938639</c:v>
                </c:pt>
                <c:pt idx="254">
                  <c:v>7.9418875008283027</c:v>
                </c:pt>
                <c:pt idx="255">
                  <c:v>7.7112609990367371</c:v>
                </c:pt>
                <c:pt idx="256">
                  <c:v>7.4842610115899593</c:v>
                </c:pt>
                <c:pt idx="257">
                  <c:v>7.2609877752921115</c:v>
                </c:pt>
                <c:pt idx="258">
                  <c:v>7.0415398813189505</c:v>
                </c:pt>
                <c:pt idx="259">
                  <c:v>6.8260142316827377</c:v>
                </c:pt>
                <c:pt idx="260">
                  <c:v>6.614505996443059</c:v>
                </c:pt>
                <c:pt idx="261">
                  <c:v>6.4071085716824019</c:v>
                </c:pt>
                <c:pt idx="262">
                  <c:v>6.2039135382650592</c:v>
                </c:pt>
                <c:pt idx="263">
                  <c:v>6.0050106213976182</c:v>
                </c:pt>
                <c:pt idx="264">
                  <c:v>5.8104876510088168</c:v>
                </c:pt>
                <c:pt idx="265">
                  <c:v>5.6204305229663394</c:v>
                </c:pt>
                <c:pt idx="266">
                  <c:v>5.4349231611475997</c:v>
                </c:pt>
                <c:pt idx="267">
                  <c:v>5.2540474803813311</c:v>
                </c:pt>
                <c:pt idx="268">
                  <c:v>5.0778833502763039</c:v>
                </c:pt>
                <c:pt idx="269">
                  <c:v>4.9065085599531493</c:v>
                </c:pt>
                <c:pt idx="270">
                  <c:v>4.739998783694876</c:v>
                </c:pt>
                <c:pt idx="271">
                  <c:v>4.5784275475312448</c:v>
                </c:pt>
                <c:pt idx="272">
                  <c:v>4.4218661967717168</c:v>
                </c:pt>
                <c:pt idx="273">
                  <c:v>4.2703838645014116</c:v>
                </c:pt>
                <c:pt idx="274">
                  <c:v>4.1240474410538575</c:v>
                </c:pt>
                <c:pt idx="275">
                  <c:v>3.9829215444741095</c:v>
                </c:pt>
                <c:pt idx="276">
                  <c:v>3.8470684919852456</c:v>
                </c:pt>
                <c:pt idx="277">
                  <c:v>3.7165482724708223</c:v>
                </c:pt>
                <c:pt idx="278">
                  <c:v>3.5914185199854831</c:v>
                </c:pt>
                <c:pt idx="279">
                  <c:v>3.4717344883053798</c:v>
                </c:pt>
                <c:pt idx="280">
                  <c:v>3.3575490265296573</c:v>
                </c:pt>
                <c:pt idx="281">
                  <c:v>3.2489125557437877</c:v>
                </c:pt>
                <c:pt idx="282">
                  <c:v>3.1458730467550247</c:v>
                </c:pt>
                <c:pt idx="283">
                  <c:v>3.0484759989098595</c:v>
                </c:pt>
                <c:pt idx="284">
                  <c:v>2.9567644200027807</c:v>
                </c:pt>
                <c:pt idx="285">
                  <c:v>2.8707788072852498</c:v>
                </c:pt>
                <c:pt idx="286">
                  <c:v>2.7905571295832452</c:v>
                </c:pt>
                <c:pt idx="287">
                  <c:v>2.7161348105313081</c:v>
                </c:pt>
                <c:pt idx="288">
                  <c:v>2.6475447129304612</c:v>
                </c:pt>
                <c:pt idx="289">
                  <c:v>2.5848171242369116</c:v>
                </c:pt>
                <c:pt idx="290">
                  <c:v>2.5279797431879754</c:v>
                </c:pt>
                <c:pt idx="291">
                  <c:v>2.4770576675710867</c:v>
                </c:pt>
                <c:pt idx="292">
                  <c:v>2.4320733831413186</c:v>
                </c:pt>
                <c:pt idx="293">
                  <c:v>2.3930467536923192</c:v>
                </c:pt>
                <c:pt idx="294">
                  <c:v>2.3599950122850082</c:v>
                </c:pt>
                <c:pt idx="295">
                  <c:v>2.3329327536379481</c:v>
                </c:pt>
                <c:pt idx="296">
                  <c:v>2.3118719276827218</c:v>
                </c:pt>
                <c:pt idx="297">
                  <c:v>2.2968218342871847</c:v>
                </c:pt>
                <c:pt idx="298">
                  <c:v>2.2877891191489024</c:v>
                </c:pt>
                <c:pt idx="299">
                  <c:v>2.2847777708606003</c:v>
                </c:pt>
              </c:numCache>
            </c:numRef>
          </c:xVal>
          <c:yVal>
            <c:numRef>
              <c:f>'Covariance   Correlation3'!yycir21</c:f>
              <c:numCache>
                <c:formatCode>General</c:formatCode>
                <c:ptCount val="300"/>
                <c:pt idx="0">
                  <c:v>0.26994995808116368</c:v>
                </c:pt>
                <c:pt idx="1">
                  <c:v>0.23536783093855507</c:v>
                </c:pt>
                <c:pt idx="2">
                  <c:v>0.20085936099879981</c:v>
                </c:pt>
                <c:pt idx="3">
                  <c:v>0.16643978623077041</c:v>
                </c:pt>
                <c:pt idx="4">
                  <c:v>0.13212430534973368</c:v>
                </c:pt>
                <c:pt idx="5">
                  <c:v>9.792807110602661E-2</c:v>
                </c:pt>
                <c:pt idx="6">
                  <c:v>6.386618359402782E-2</c:v>
                </c:pt>
                <c:pt idx="7">
                  <c:v>2.9953683584382135E-2</c:v>
                </c:pt>
                <c:pt idx="8">
                  <c:v>-3.7944541175834456E-3</c:v>
                </c:pt>
                <c:pt idx="9">
                  <c:v>-3.7363327284308023E-2</c:v>
                </c:pt>
                <c:pt idx="10">
                  <c:v>-7.07381128464033E-2</c:v>
                </c:pt>
                <c:pt idx="11">
                  <c:v>-0.10390407343810376</c:v>
                </c:pt>
                <c:pt idx="12">
                  <c:v>-0.13684656390487204</c:v>
                </c:pt>
                <c:pt idx="13">
                  <c:v>-0.16955103777028691</c:v>
                </c:pt>
                <c:pt idx="14">
                  <c:v>-0.20200305365935781</c:v>
                </c:pt>
                <c:pt idx="15">
                  <c:v>-0.23418828167542979</c:v>
                </c:pt>
                <c:pt idx="16">
                  <c:v>-0.26609250972786219</c:v>
                </c:pt>
                <c:pt idx="17">
                  <c:v>-0.29770164980768743</c:v>
                </c:pt>
                <c:pt idx="18">
                  <c:v>-0.32900174420848016</c:v>
                </c:pt>
                <c:pt idx="19">
                  <c:v>-0.35997897168968662</c:v>
                </c:pt>
                <c:pt idx="20">
                  <c:v>-0.39061965357969541</c:v>
                </c:pt>
                <c:pt idx="21">
                  <c:v>-0.42091025981595453</c:v>
                </c:pt>
                <c:pt idx="22">
                  <c:v>-0.45083741491946527</c:v>
                </c:pt>
                <c:pt idx="23">
                  <c:v>-0.48038790390101727</c:v>
                </c:pt>
                <c:pt idx="24">
                  <c:v>-0.50954867809655757</c:v>
                </c:pt>
                <c:pt idx="25">
                  <c:v>-0.53830686092911018</c:v>
                </c:pt>
                <c:pt idx="26">
                  <c:v>-0.56664975359471215</c:v>
                </c:pt>
                <c:pt idx="27">
                  <c:v>-0.59456484066984716</c:v>
                </c:pt>
                <c:pt idx="28">
                  <c:v>-0.62203979563790501</c:v>
                </c:pt>
                <c:pt idx="29">
                  <c:v>-0.64906248633222274</c:v>
                </c:pt>
                <c:pt idx="30">
                  <c:v>-0.67562098029331019</c:v>
                </c:pt>
                <c:pt idx="31">
                  <c:v>-0.70170355003788587</c:v>
                </c:pt>
                <c:pt idx="32">
                  <c:v>-0.72729867823740502</c:v>
                </c:pt>
                <c:pt idx="33">
                  <c:v>-0.75239506280378676</c:v>
                </c:pt>
                <c:pt idx="34">
                  <c:v>-0.77698162188009878</c:v>
                </c:pt>
                <c:pt idx="35">
                  <c:v>-0.80104749873399295</c:v>
                </c:pt>
                <c:pt idx="36">
                  <c:v>-0.82458206655173294</c:v>
                </c:pt>
                <c:pt idx="37">
                  <c:v>-0.84757493313069521</c:v>
                </c:pt>
                <c:pt idx="38">
                  <c:v>-0.87001594546827421</c:v>
                </c:pt>
                <c:pt idx="39">
                  <c:v>-0.89189519424516162</c:v>
                </c:pt>
                <c:pt idx="40">
                  <c:v>-0.91320301820102445</c:v>
                </c:pt>
                <c:pt idx="41">
                  <c:v>-0.93393000840064255</c:v>
                </c:pt>
                <c:pt idx="42">
                  <c:v>-0.95406701238863267</c:v>
                </c:pt>
                <c:pt idx="43">
                  <c:v>-0.97360513823091344</c:v>
                </c:pt>
                <c:pt idx="44">
                  <c:v>-0.99253575844113406</c:v>
                </c:pt>
                <c:pt idx="45">
                  <c:v>-1.0108505137903276</c:v>
                </c:pt>
                <c:pt idx="46">
                  <c:v>-1.0285413169981144</c:v>
                </c:pt>
                <c:pt idx="47">
                  <c:v>-1.0456003563038132</c:v>
                </c:pt>
                <c:pt idx="48">
                  <c:v>-1.0620200989158988</c:v>
                </c:pt>
                <c:pt idx="49">
                  <c:v>-1.0777932943382682</c:v>
                </c:pt>
                <c:pt idx="50">
                  <c:v>-1.0929129775718562</c:v>
                </c:pt>
                <c:pt idx="51">
                  <c:v>-1.1073724721901836</c:v>
                </c:pt>
                <c:pt idx="52">
                  <c:v>-1.1211653932874783</c:v>
                </c:pt>
                <c:pt idx="53">
                  <c:v>-1.1342856502980703</c:v>
                </c:pt>
                <c:pt idx="54">
                  <c:v>-1.1467274496858137</c:v>
                </c:pt>
                <c:pt idx="55">
                  <c:v>-1.1584852975023503</c:v>
                </c:pt>
                <c:pt idx="56">
                  <c:v>-1.1695540018130812</c:v>
                </c:pt>
                <c:pt idx="57">
                  <c:v>-1.1799286749897793</c:v>
                </c:pt>
                <c:pt idx="58">
                  <c:v>-1.1896047358688289</c:v>
                </c:pt>
                <c:pt idx="59">
                  <c:v>-1.198577911774138</c:v>
                </c:pt>
                <c:pt idx="60">
                  <c:v>-1.2068442404038318</c:v>
                </c:pt>
                <c:pt idx="61">
                  <c:v>-1.2144000715798944</c:v>
                </c:pt>
                <c:pt idx="62">
                  <c:v>-1.2212420688599837</c:v>
                </c:pt>
                <c:pt idx="63">
                  <c:v>-1.2273672110107106</c:v>
                </c:pt>
                <c:pt idx="64">
                  <c:v>-1.2327727933417316</c:v>
                </c:pt>
                <c:pt idx="65">
                  <c:v>-1.2374564289000625</c:v>
                </c:pt>
                <c:pt idx="66">
                  <c:v>-1.2414160495240902</c:v>
                </c:pt>
                <c:pt idx="67">
                  <c:v>-1.2446499067568155</c:v>
                </c:pt>
                <c:pt idx="68">
                  <c:v>-1.2471565726179208</c:v>
                </c:pt>
                <c:pt idx="69">
                  <c:v>-1.2489349402343277</c:v>
                </c:pt>
                <c:pt idx="70">
                  <c:v>-1.2499842243289594</c:v>
                </c:pt>
                <c:pt idx="71">
                  <c:v>-1.2503039615674985</c:v>
                </c:pt>
                <c:pt idx="72">
                  <c:v>-1.2498940107629819</c:v>
                </c:pt>
                <c:pt idx="73">
                  <c:v>-1.2487545529381434</c:v>
                </c:pt>
                <c:pt idx="74">
                  <c:v>-1.246886091245482</c:v>
                </c:pt>
                <c:pt idx="75">
                  <c:v>-1.2442894507450819</c:v>
                </c:pt>
                <c:pt idx="76">
                  <c:v>-1.2409657780402894</c:v>
                </c:pt>
                <c:pt idx="77">
                  <c:v>-1.2369165407714056</c:v>
                </c:pt>
                <c:pt idx="78">
                  <c:v>-1.2321435269676184</c:v>
                </c:pt>
                <c:pt idx="79">
                  <c:v>-1.226648844257457</c:v>
                </c:pt>
                <c:pt idx="80">
                  <c:v>-1.2204349189381249</c:v>
                </c:pt>
                <c:pt idx="81">
                  <c:v>-1.2135044949041141</c:v>
                </c:pt>
                <c:pt idx="82">
                  <c:v>-1.2058606324355783</c:v>
                </c:pt>
                <c:pt idx="83">
                  <c:v>-1.1975067068470002</c:v>
                </c:pt>
                <c:pt idx="84">
                  <c:v>-1.1884464069967473</c:v>
                </c:pt>
                <c:pt idx="85">
                  <c:v>-1.1786837336581755</c:v>
                </c:pt>
                <c:pt idx="86">
                  <c:v>-1.1682229977530008</c:v>
                </c:pt>
                <c:pt idx="87">
                  <c:v>-1.1570688184477167</c:v>
                </c:pt>
                <c:pt idx="88">
                  <c:v>-1.1452261211139017</c:v>
                </c:pt>
                <c:pt idx="89">
                  <c:v>-1.1327001351533132</c:v>
                </c:pt>
                <c:pt idx="90">
                  <c:v>-1.1194963916887302</c:v>
                </c:pt>
                <c:pt idx="91">
                  <c:v>-1.1056207211215663</c:v>
                </c:pt>
                <c:pt idx="92">
                  <c:v>-1.0910792505573275</c:v>
                </c:pt>
                <c:pt idx="93">
                  <c:v>-1.0758784011000562</c:v>
                </c:pt>
                <c:pt idx="94">
                  <c:v>-1.0600248850169511</c:v>
                </c:pt>
                <c:pt idx="95">
                  <c:v>-1.04352570277442</c:v>
                </c:pt>
                <c:pt idx="96">
                  <c:v>-1.0263881399468708</c:v>
                </c:pt>
                <c:pt idx="97">
                  <c:v>-1.0086197639996048</c:v>
                </c:pt>
                <c:pt idx="98">
                  <c:v>-0.99022842094724128</c:v>
                </c:pt>
                <c:pt idx="99">
                  <c:v>-0.97122223188913415</c:v>
                </c:pt>
                <c:pt idx="100">
                  <c:v>-0.95160958942332541</c:v>
                </c:pt>
                <c:pt idx="101">
                  <c:v>-0.93139915394060946</c:v>
                </c:pt>
                <c:pt idx="102">
                  <c:v>-0.91059984980034891</c:v>
                </c:pt>
                <c:pt idx="103">
                  <c:v>-0.88922086138972745</c:v>
                </c:pt>
                <c:pt idx="104">
                  <c:v>-0.86727162906818434</c:v>
                </c:pt>
                <c:pt idx="105">
                  <c:v>-0.84476184499881635</c:v>
                </c:pt>
                <c:pt idx="106">
                  <c:v>-0.82170144886859275</c:v>
                </c:pt>
                <c:pt idx="107">
                  <c:v>-0.7981006234992678</c:v>
                </c:pt>
                <c:pt idx="108">
                  <c:v>-0.77396979035093383</c:v>
                </c:pt>
                <c:pt idx="109">
                  <c:v>-0.74931960492019845</c:v>
                </c:pt>
                <c:pt idx="110">
                  <c:v>-0.72416095203501762</c:v>
                </c:pt>
                <c:pt idx="111">
                  <c:v>-0.69850494104825966</c:v>
                </c:pt>
                <c:pt idx="112">
                  <c:v>-0.67236290093213058</c:v>
                </c:pt>
                <c:pt idx="113">
                  <c:v>-0.64574637527561696</c:v>
                </c:pt>
                <c:pt idx="114">
                  <c:v>-0.61866711718716294</c:v>
                </c:pt>
                <c:pt idx="115">
                  <c:v>-0.59113708410482824</c:v>
                </c:pt>
                <c:pt idx="116">
                  <c:v>-0.56316843251622029</c:v>
                </c:pt>
                <c:pt idx="117">
                  <c:v>-0.5347735125905303</c:v>
                </c:pt>
                <c:pt idx="118">
                  <c:v>-0.50596486272504815</c:v>
                </c:pt>
                <c:pt idx="119">
                  <c:v>-0.47675520400855781</c:v>
                </c:pt>
                <c:pt idx="120">
                  <c:v>-0.4471574346040631</c:v>
                </c:pt>
                <c:pt idx="121">
                  <c:v>-0.41718462405332246</c:v>
                </c:pt>
                <c:pt idx="122">
                  <c:v>-0.38685000750570459</c:v>
                </c:pt>
                <c:pt idx="123">
                  <c:v>-0.35616697987392354</c:v>
                </c:pt>
                <c:pt idx="124">
                  <c:v>-0.32514908991921865</c:v>
                </c:pt>
                <c:pt idx="125">
                  <c:v>-0.29381003426860502</c:v>
                </c:pt>
                <c:pt idx="126">
                  <c:v>-0.26216365136682729</c:v>
                </c:pt>
                <c:pt idx="127">
                  <c:v>-0.23022391536569309</c:v>
                </c:pt>
                <c:pt idx="128">
                  <c:v>-0.19800492995348007</c:v>
                </c:pt>
                <c:pt idx="129">
                  <c:v>-0.16552092212714486</c:v>
                </c:pt>
                <c:pt idx="130">
                  <c:v>-0.13278623591008143</c:v>
                </c:pt>
                <c:pt idx="131">
                  <c:v>-9.9815326018204087E-2</c:v>
                </c:pt>
                <c:pt idx="132">
                  <c:v>-6.6622751477152214E-2</c:v>
                </c:pt>
                <c:pt idx="133">
                  <c:v>-3.3223169193434002E-2</c:v>
                </c:pt>
                <c:pt idx="134">
                  <c:v>3.6867251765063114E-4</c:v>
                </c:pt>
                <c:pt idx="135">
                  <c:v>3.4137940444451037E-2</c:v>
                </c:pt>
                <c:pt idx="136">
                  <c:v>6.8069723028893803E-2</c:v>
                </c:pt>
                <c:pt idx="137">
                  <c:v>0.10214903695100966</c:v>
                </c:pt>
                <c:pt idx="138">
                  <c:v>0.13636083374514169</c:v>
                </c:pt>
                <c:pt idx="139">
                  <c:v>0.1706900064449271</c:v>
                </c:pt>
                <c:pt idx="140">
                  <c:v>0.20512139625410727</c:v>
                </c:pt>
                <c:pt idx="141">
                  <c:v>0.2396397992402256</c:v>
                </c:pt>
                <c:pt idx="142">
                  <c:v>0.27422997304825625</c:v>
                </c:pt>
                <c:pt idx="143">
                  <c:v>0.3088766436311986</c:v>
                </c:pt>
                <c:pt idx="144">
                  <c:v>0.34356451199466687</c:v>
                </c:pt>
                <c:pt idx="145">
                  <c:v>0.37827826095249506</c:v>
                </c:pt>
                <c:pt idx="146">
                  <c:v>0.41300256189037543</c:v>
                </c:pt>
                <c:pt idx="147">
                  <c:v>0.44772208153454263</c:v>
                </c:pt>
                <c:pt idx="148">
                  <c:v>0.48242148872251622</c:v>
                </c:pt>
                <c:pt idx="149">
                  <c:v>0.51708546117291032</c:v>
                </c:pt>
                <c:pt idx="150">
                  <c:v>0.55169869225132051</c:v>
                </c:pt>
                <c:pt idx="151">
                  <c:v>0.58624589772930646</c:v>
                </c:pt>
                <c:pt idx="152">
                  <c:v>0.62071182253347179</c:v>
                </c:pt>
                <c:pt idx="153">
                  <c:v>0.65508124748167829</c:v>
                </c:pt>
                <c:pt idx="154">
                  <c:v>0.68933899600340776</c:v>
                </c:pt>
                <c:pt idx="155">
                  <c:v>0.72346994084130811</c:v>
                </c:pt>
                <c:pt idx="156">
                  <c:v>0.75745901073096389</c:v>
                </c:pt>
                <c:pt idx="157">
                  <c:v>0.79129119705594353</c:v>
                </c:pt>
                <c:pt idx="158">
                  <c:v>0.82495156047518048</c:v>
                </c:pt>
                <c:pt idx="159">
                  <c:v>0.85842523751976707</c:v>
                </c:pt>
                <c:pt idx="160">
                  <c:v>0.89169744715624266</c:v>
                </c:pt>
                <c:pt idx="161">
                  <c:v>0.92475349731348289</c:v>
                </c:pt>
                <c:pt idx="162">
                  <c:v>0.95757879137030388</c:v>
                </c:pt>
                <c:pt idx="163">
                  <c:v>0.99015883460092002</c:v>
                </c:pt>
                <c:pt idx="164">
                  <c:v>1.022479240575406</c:v>
                </c:pt>
                <c:pt idx="165">
                  <c:v>1.0545257375123405</c:v>
                </c:pt>
                <c:pt idx="166">
                  <c:v>1.086284174580822</c:v>
                </c:pt>
                <c:pt idx="167">
                  <c:v>1.1177405281490773</c:v>
                </c:pt>
                <c:pt idx="168">
                  <c:v>1.1488809079769031</c:v>
                </c:pt>
                <c:pt idx="169">
                  <c:v>1.1796915633492051</c:v>
                </c:pt>
                <c:pt idx="170">
                  <c:v>1.210158889147926</c:v>
                </c:pt>
                <c:pt idx="171">
                  <c:v>1.2402694318596834</c:v>
                </c:pt>
                <c:pt idx="172">
                  <c:v>1.2700098955164625</c:v>
                </c:pt>
                <c:pt idx="173">
                  <c:v>1.2993671475667399</c:v>
                </c:pt>
                <c:pt idx="174">
                  <c:v>1.3283282246744514</c:v>
                </c:pt>
                <c:pt idx="175">
                  <c:v>1.3568803384432335</c:v>
                </c:pt>
                <c:pt idx="176">
                  <c:v>1.3850108810634203</c:v>
                </c:pt>
                <c:pt idx="177">
                  <c:v>1.4127074308792986</c:v>
                </c:pt>
                <c:pt idx="178">
                  <c:v>1.439957757874158</c:v>
                </c:pt>
                <c:pt idx="179">
                  <c:v>1.4667498290707275</c:v>
                </c:pt>
                <c:pt idx="180">
                  <c:v>1.4930718138445938</c:v>
                </c:pt>
                <c:pt idx="181">
                  <c:v>1.5189120891482737</c:v>
                </c:pt>
                <c:pt idx="182">
                  <c:v>1.5442592446436276</c:v>
                </c:pt>
                <c:pt idx="183">
                  <c:v>1.5691020877403401</c:v>
                </c:pt>
                <c:pt idx="184">
                  <c:v>1.5934296485382542</c:v>
                </c:pt>
                <c:pt idx="185">
                  <c:v>1.6172311846713701</c:v>
                </c:pt>
                <c:pt idx="186">
                  <c:v>1.6404961860513725</c:v>
                </c:pt>
                <c:pt idx="187">
                  <c:v>1.6632143795085879</c:v>
                </c:pt>
                <c:pt idx="188">
                  <c:v>1.6853757333283292</c:v>
                </c:pt>
                <c:pt idx="189">
                  <c:v>1.7069704616806174</c:v>
                </c:pt>
                <c:pt idx="190">
                  <c:v>1.727989028941328</c:v>
                </c:pt>
                <c:pt idx="191">
                  <c:v>1.7484221539028557</c:v>
                </c:pt>
                <c:pt idx="192">
                  <c:v>1.7682608138724336</c:v>
                </c:pt>
                <c:pt idx="193">
                  <c:v>1.7874962486563004</c:v>
                </c:pt>
                <c:pt idx="194">
                  <c:v>1.8061199644279546</c:v>
                </c:pt>
                <c:pt idx="195">
                  <c:v>1.8241237374787909</c:v>
                </c:pt>
                <c:pt idx="196">
                  <c:v>1.8414996178494567</c:v>
                </c:pt>
                <c:pt idx="197">
                  <c:v>1.8582399328403314</c:v>
                </c:pt>
                <c:pt idx="198">
                  <c:v>1.8743372903995736</c:v>
                </c:pt>
                <c:pt idx="199">
                  <c:v>1.8897845823872452</c:v>
                </c:pt>
                <c:pt idx="200">
                  <c:v>1.9045749877140628</c:v>
                </c:pt>
                <c:pt idx="201">
                  <c:v>1.9187019753534014</c:v>
                </c:pt>
                <c:pt idx="202">
                  <c:v>1.9321593072252101</c:v>
                </c:pt>
                <c:pt idx="203">
                  <c:v>1.9449410409505736</c:v>
                </c:pt>
                <c:pt idx="204">
                  <c:v>1.9570415324756998</c:v>
                </c:pt>
                <c:pt idx="205">
                  <c:v>1.968455438564173</c:v>
                </c:pt>
                <c:pt idx="206">
                  <c:v>1.9791777191563797</c:v>
                </c:pt>
                <c:pt idx="207">
                  <c:v>1.9892036395950552</c:v>
                </c:pt>
                <c:pt idx="208">
                  <c:v>1.9985287727159746</c:v>
                </c:pt>
                <c:pt idx="209">
                  <c:v>2.0071490008028645</c:v>
                </c:pt>
                <c:pt idx="210">
                  <c:v>2.0150605174056717</c:v>
                </c:pt>
                <c:pt idx="211">
                  <c:v>2.0222598290213827</c:v>
                </c:pt>
                <c:pt idx="212">
                  <c:v>2.0287437566366564</c:v>
                </c:pt>
                <c:pt idx="213">
                  <c:v>2.0345094371315886</c:v>
                </c:pt>
                <c:pt idx="214">
                  <c:v>2.0395543245439822</c:v>
                </c:pt>
                <c:pt idx="215">
                  <c:v>2.0438761911935761</c:v>
                </c:pt>
                <c:pt idx="216">
                  <c:v>2.0474731286657235</c:v>
                </c:pt>
                <c:pt idx="217">
                  <c:v>2.050343548654094</c:v>
                </c:pt>
                <c:pt idx="218">
                  <c:v>2.052486183662027</c:v>
                </c:pt>
                <c:pt idx="219">
                  <c:v>2.0539000875622198</c:v>
                </c:pt>
                <c:pt idx="220">
                  <c:v>2.0545846360145137</c:v>
                </c:pt>
                <c:pt idx="221">
                  <c:v>2.0545395267415829</c:v>
                </c:pt>
                <c:pt idx="222">
                  <c:v>2.0537647796624126</c:v>
                </c:pt>
                <c:pt idx="223">
                  <c:v>2.0522607368835026</c:v>
                </c:pt>
                <c:pt idx="224">
                  <c:v>2.0500280625478036</c:v>
                </c:pt>
                <c:pt idx="225">
                  <c:v>2.0470677425414499</c:v>
                </c:pt>
                <c:pt idx="226">
                  <c:v>2.0433810840584199</c:v>
                </c:pt>
                <c:pt idx="227">
                  <c:v>2.0389697150233164</c:v>
                </c:pt>
                <c:pt idx="228">
                  <c:v>2.0338355833725199</c:v>
                </c:pt>
                <c:pt idx="229">
                  <c:v>2.0279809561940354</c:v>
                </c:pt>
                <c:pt idx="230">
                  <c:v>2.021408418726411</c:v>
                </c:pt>
                <c:pt idx="231">
                  <c:v>2.0141208732171676</c:v>
                </c:pt>
                <c:pt idx="232">
                  <c:v>2.0061215376412496</c:v>
                </c:pt>
                <c:pt idx="233">
                  <c:v>1.9974139442800563</c:v>
                </c:pt>
                <c:pt idx="234">
                  <c:v>1.9880019381616871</c:v>
                </c:pt>
                <c:pt idx="235">
                  <c:v>1.9778896753630861</c:v>
                </c:pt>
                <c:pt idx="236">
                  <c:v>1.9670816211748328</c:v>
                </c:pt>
                <c:pt idx="237">
                  <c:v>1.9555825481293974</c:v>
                </c:pt>
                <c:pt idx="238">
                  <c:v>1.9433975338937246</c:v>
                </c:pt>
                <c:pt idx="239">
                  <c:v>1.9305319590270791</c:v>
                </c:pt>
                <c:pt idx="240">
                  <c:v>1.9169915046051409</c:v>
                </c:pt>
                <c:pt idx="241">
                  <c:v>1.9027821497114041</c:v>
                </c:pt>
                <c:pt idx="242">
                  <c:v>1.8879101687969797</c:v>
                </c:pt>
                <c:pt idx="243">
                  <c:v>1.8723821289099756</c:v>
                </c:pt>
                <c:pt idx="244">
                  <c:v>1.8562048867956742</c:v>
                </c:pt>
                <c:pt idx="245">
                  <c:v>1.8393855858687853</c:v>
                </c:pt>
                <c:pt idx="246">
                  <c:v>1.8219316530591154</c:v>
                </c:pt>
                <c:pt idx="247">
                  <c:v>1.8038507955320451</c:v>
                </c:pt>
                <c:pt idx="248">
                  <c:v>1.7851509972852617</c:v>
                </c:pt>
                <c:pt idx="249">
                  <c:v>1.7658405156232493</c:v>
                </c:pt>
                <c:pt idx="250">
                  <c:v>1.7459278775110987</c:v>
                </c:pt>
                <c:pt idx="251">
                  <c:v>1.7254218758092357</c:v>
                </c:pt>
                <c:pt idx="252">
                  <c:v>1.7043315653907449</c:v>
                </c:pt>
                <c:pt idx="253">
                  <c:v>1.6826662591429904</c:v>
                </c:pt>
                <c:pt idx="254">
                  <c:v>1.6604355238553079</c:v>
                </c:pt>
                <c:pt idx="255">
                  <c:v>1.6376491759945799</c:v>
                </c:pt>
                <c:pt idx="256">
                  <c:v>1.6143172773705596</c:v>
                </c:pt>
                <c:pt idx="257">
                  <c:v>1.5904501306928598</c:v>
                </c:pt>
                <c:pt idx="258">
                  <c:v>1.5660582750215657</c:v>
                </c:pt>
                <c:pt idx="259">
                  <c:v>1.5411524811134827</c:v>
                </c:pt>
                <c:pt idx="260">
                  <c:v>1.5157437466660741</c:v>
                </c:pt>
                <c:pt idx="261">
                  <c:v>1.4898432914611872</c:v>
                </c:pt>
                <c:pt idx="262">
                  <c:v>1.4634625524107128</c:v>
                </c:pt>
                <c:pt idx="263">
                  <c:v>1.4366131785063667</c:v>
                </c:pt>
                <c:pt idx="264">
                  <c:v>1.4093070256758251</c:v>
                </c:pt>
                <c:pt idx="265">
                  <c:v>1.3815561515474781</c:v>
                </c:pt>
                <c:pt idx="266">
                  <c:v>1.353372810126122</c:v>
                </c:pt>
                <c:pt idx="267">
                  <c:v>1.3247694463819346</c:v>
                </c:pt>
                <c:pt idx="268">
                  <c:v>1.2957586907551282</c:v>
                </c:pt>
                <c:pt idx="269">
                  <c:v>1.2663533535787015</c:v>
                </c:pt>
                <c:pt idx="270">
                  <c:v>1.2365664194217572</c:v>
                </c:pt>
                <c:pt idx="271">
                  <c:v>1.2064110413558842</c:v>
                </c:pt>
                <c:pt idx="272">
                  <c:v>1.1759005351471252</c:v>
                </c:pt>
                <c:pt idx="273">
                  <c:v>1.1450483733761174</c:v>
                </c:pt>
                <c:pt idx="274">
                  <c:v>1.1138681794889751</c:v>
                </c:pt>
                <c:pt idx="275">
                  <c:v>1.0823737217815605</c:v>
                </c:pt>
                <c:pt idx="276">
                  <c:v>1.0505789073197924</c:v>
                </c:pt>
                <c:pt idx="277">
                  <c:v>1.018497775798676</c:v>
                </c:pt>
                <c:pt idx="278">
                  <c:v>0.98614449334277077</c:v>
                </c:pt>
                <c:pt idx="279">
                  <c:v>0.95353334625082675</c:v>
                </c:pt>
                <c:pt idx="280">
                  <c:v>0.92067873468735895</c:v>
                </c:pt>
                <c:pt idx="281">
                  <c:v>0.88759516632393831</c:v>
                </c:pt>
                <c:pt idx="282">
                  <c:v>0.85429724993301404</c:v>
                </c:pt>
                <c:pt idx="283">
                  <c:v>0.82079968893708943</c:v>
                </c:pt>
                <c:pt idx="284">
                  <c:v>0.78711727491610561</c:v>
                </c:pt>
                <c:pt idx="285">
                  <c:v>0.75326488107589562</c:v>
                </c:pt>
                <c:pt idx="286">
                  <c:v>0.71925745568059529</c:v>
                </c:pt>
                <c:pt idx="287">
                  <c:v>0.68511001545191141</c:v>
                </c:pt>
                <c:pt idx="288">
                  <c:v>0.65083763893815916</c:v>
                </c:pt>
                <c:pt idx="289">
                  <c:v>0.61645545985600003</c:v>
                </c:pt>
                <c:pt idx="290">
                  <c:v>0.58197866040781898</c:v>
                </c:pt>
                <c:pt idx="291">
                  <c:v>0.54742246457769106</c:v>
                </c:pt>
                <c:pt idx="292">
                  <c:v>0.51280213140889797</c:v>
                </c:pt>
                <c:pt idx="293">
                  <c:v>0.47813294826596497</c:v>
                </c:pt>
                <c:pt idx="294">
                  <c:v>0.44343022408419058</c:v>
                </c:pt>
                <c:pt idx="295">
                  <c:v>0.408709282609652</c:v>
                </c:pt>
                <c:pt idx="296">
                  <c:v>0.37398545563266994</c:v>
                </c:pt>
                <c:pt idx="297">
                  <c:v>0.33927407621772177</c:v>
                </c:pt>
                <c:pt idx="298">
                  <c:v>0.30459047193279198</c:v>
                </c:pt>
                <c:pt idx="299">
                  <c:v>0.2699499580811509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424504"/>
        <c:axId val="283424112"/>
      </c:scatterChart>
      <c:valAx>
        <c:axId val="283424504"/>
        <c:scaling>
          <c:orientation val="minMax"/>
          <c:max val="3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424112"/>
        <c:crosses val="autoZero"/>
        <c:crossBetween val="midCat"/>
      </c:valAx>
      <c:valAx>
        <c:axId val="283424112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424504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338582677165359"/>
          <c:y val="0.15250000000000002"/>
          <c:w val="0.60549845331833529"/>
          <c:h val="0.71158333333333323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FF0000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FF0000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AH$1:$AH$15</c:f>
              <c:numCache>
                <c:formatCode>General</c:formatCode>
                <c:ptCount val="15"/>
                <c:pt idx="0">
                  <c:v>138.99886778491901</c:v>
                </c:pt>
                <c:pt idx="1">
                  <c:v>162.91424412457732</c:v>
                </c:pt>
                <c:pt idx="2">
                  <c:v>161.81378103847999</c:v>
                </c:pt>
                <c:pt idx="3">
                  <c:v>71.559135701775006</c:v>
                </c:pt>
                <c:pt idx="4">
                  <c:v>46.166237429095098</c:v>
                </c:pt>
                <c:pt idx="5">
                  <c:v>69.021716759589793</c:v>
                </c:pt>
                <c:pt idx="6">
                  <c:v>89.470748764987405</c:v>
                </c:pt>
                <c:pt idx="7">
                  <c:v>148.91475822535801</c:v>
                </c:pt>
                <c:pt idx="8">
                  <c:v>155.77808522817401</c:v>
                </c:pt>
                <c:pt idx="9">
                  <c:v>200.41766017548801</c:v>
                </c:pt>
                <c:pt idx="10">
                  <c:v>362.51397650410098</c:v>
                </c:pt>
                <c:pt idx="11">
                  <c:v>376.12746722204901</c:v>
                </c:pt>
                <c:pt idx="12">
                  <c:v>172.90809699088169</c:v>
                </c:pt>
                <c:pt idx="13">
                  <c:v>316.49362074445901</c:v>
                </c:pt>
                <c:pt idx="14">
                  <c:v>206.08254805910366</c:v>
                </c:pt>
              </c:numCache>
            </c:numRef>
          </c:xVal>
          <c:yVal>
            <c:numRef>
              <c:f>'Covariance   Correlation3_HID4'!$AI$1:$AI$15</c:f>
              <c:numCache>
                <c:formatCode>General</c:formatCode>
                <c:ptCount val="15"/>
                <c:pt idx="0">
                  <c:v>1.0531999999999999</c:v>
                </c:pt>
                <c:pt idx="1">
                  <c:v>1.6315999999999999</c:v>
                </c:pt>
                <c:pt idx="2">
                  <c:v>1.4011</c:v>
                </c:pt>
                <c:pt idx="3">
                  <c:v>5.6500000000000002E-2</c:v>
                </c:pt>
                <c:pt idx="4">
                  <c:v>0.2228999999999999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E-3</c:v>
                </c:pt>
                <c:pt idx="9">
                  <c:v>0</c:v>
                </c:pt>
                <c:pt idx="10">
                  <c:v>0.48499999999999999</c:v>
                </c:pt>
                <c:pt idx="11">
                  <c:v>0.84172000000000002</c:v>
                </c:pt>
                <c:pt idx="12">
                  <c:v>3.6700000000000003E-2</c:v>
                </c:pt>
                <c:pt idx="13">
                  <c:v>0.17710000000000001</c:v>
                </c:pt>
                <c:pt idx="14">
                  <c:v>0.1247999999999999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22</c:f>
              <c:numCache>
                <c:formatCode>General</c:formatCode>
                <c:ptCount val="300"/>
                <c:pt idx="0">
                  <c:v>-123.56687113635698</c:v>
                </c:pt>
                <c:pt idx="1">
                  <c:v>-123.50015428104538</c:v>
                </c:pt>
                <c:pt idx="2">
                  <c:v>-123.30003317539578</c:v>
                </c:pt>
                <c:pt idx="3">
                  <c:v>-122.96659618725485</c:v>
                </c:pt>
                <c:pt idx="4">
                  <c:v>-122.49999055300984</c:v>
                </c:pt>
                <c:pt idx="5">
                  <c:v>-121.90042231257334</c:v>
                </c:pt>
                <c:pt idx="6">
                  <c:v>-121.16815621840189</c:v>
                </c:pt>
                <c:pt idx="7">
                  <c:v>-120.30351561858848</c:v>
                </c:pt>
                <c:pt idx="8">
                  <c:v>-119.30688231408132</c:v>
                </c:pt>
                <c:pt idx="9">
                  <c:v>-118.1786963900914</c:v>
                </c:pt>
                <c:pt idx="10">
                  <c:v>-116.91945602176295</c:v>
                </c:pt>
                <c:pt idx="11">
                  <c:v>-115.52971725419357</c:v>
                </c:pt>
                <c:pt idx="12">
                  <c:v>-114.01009375690032</c:v>
                </c:pt>
                <c:pt idx="13">
                  <c:v>-112.36125655284044</c:v>
                </c:pt>
                <c:pt idx="14">
                  <c:v>-110.58393372210654</c:v>
                </c:pt>
                <c:pt idx="15">
                  <c:v>-108.67891008042702</c:v>
                </c:pt>
                <c:pt idx="16">
                  <c:v>-106.64702683261348</c:v>
                </c:pt>
                <c:pt idx="17">
                  <c:v>-104.48918120110827</c:v>
                </c:pt>
                <c:pt idx="18">
                  <c:v>-102.20632602979637</c:v>
                </c:pt>
                <c:pt idx="19">
                  <c:v>-99.79946936325652</c:v>
                </c:pt>
                <c:pt idx="20">
                  <c:v>-97.269674001636901</c:v>
                </c:pt>
                <c:pt idx="21">
                  <c:v>-94.618057031352492</c:v>
                </c:pt>
                <c:pt idx="22">
                  <c:v>-91.845789331811289</c:v>
                </c:pt>
                <c:pt idx="23">
                  <c:v>-88.954095058387026</c:v>
                </c:pt>
                <c:pt idx="24">
                  <c:v>-85.944251101866229</c:v>
                </c:pt>
                <c:pt idx="25">
                  <c:v>-82.817586524609482</c:v>
                </c:pt>
                <c:pt idx="26">
                  <c:v>-79.575481973674954</c:v>
                </c:pt>
                <c:pt idx="27">
                  <c:v>-76.219369071163385</c:v>
                </c:pt>
                <c:pt idx="28">
                  <c:v>-72.750729782054037</c:v>
                </c:pt>
                <c:pt idx="29">
                  <c:v>-69.171095759810896</c:v>
                </c:pt>
                <c:pt idx="30">
                  <c:v>-65.48204767004728</c:v>
                </c:pt>
                <c:pt idx="31">
                  <c:v>-61.68521449254871</c:v>
                </c:pt>
                <c:pt idx="32">
                  <c:v>-57.782272801961199</c:v>
                </c:pt>
                <c:pt idx="33">
                  <c:v>-53.77494602746296</c:v>
                </c:pt>
                <c:pt idx="34">
                  <c:v>-49.665003691746875</c:v>
                </c:pt>
                <c:pt idx="35">
                  <c:v>-45.454260629648616</c:v>
                </c:pt>
                <c:pt idx="36">
                  <c:v>-41.144576186767267</c:v>
                </c:pt>
                <c:pt idx="37">
                  <c:v>-36.737853398430161</c:v>
                </c:pt>
                <c:pt idx="38">
                  <c:v>-32.236038149366379</c:v>
                </c:pt>
                <c:pt idx="39">
                  <c:v>-27.641118314458623</c:v>
                </c:pt>
                <c:pt idx="40">
                  <c:v>-22.955122880953724</c:v>
                </c:pt>
                <c:pt idx="41">
                  <c:v>-18.180121052518928</c:v>
                </c:pt>
                <c:pt idx="42">
                  <c:v>-13.318221335539931</c:v>
                </c:pt>
                <c:pt idx="43">
                  <c:v>-8.3715706080636494</c:v>
                </c:pt>
                <c:pt idx="44">
                  <c:v>-3.3423531717974129</c:v>
                </c:pt>
                <c:pt idx="45">
                  <c:v>1.7672102124170692</c:v>
                </c:pt>
                <c:pt idx="46">
                  <c:v>6.9548633052295088</c:v>
                </c:pt>
                <c:pt idx="47">
                  <c:v>12.218315385072486</c:v>
                </c:pt>
                <c:pt idx="48">
                  <c:v>17.555242259679773</c:v>
                </c:pt>
                <c:pt idx="49">
                  <c:v>22.963287292384166</c:v>
                </c:pt>
                <c:pt idx="50">
                  <c:v>28.440062442741834</c:v>
                </c:pt>
                <c:pt idx="51">
                  <c:v>33.983149321024001</c:v>
                </c:pt>
                <c:pt idx="52">
                  <c:v>39.590100256109423</c:v>
                </c:pt>
                <c:pt idx="53">
                  <c:v>45.258439376307308</c:v>
                </c:pt>
                <c:pt idx="54">
                  <c:v>50.985663702632266</c:v>
                </c:pt>
                <c:pt idx="55">
                  <c:v>56.769244254050008</c:v>
                </c:pt>
                <c:pt idx="56">
                  <c:v>62.60662716420336</c:v>
                </c:pt>
                <c:pt idx="57">
                  <c:v>68.495234809128235</c:v>
                </c:pt>
                <c:pt idx="58">
                  <c:v>74.432466945459666</c:v>
                </c:pt>
                <c:pt idx="59">
                  <c:v>80.415701858626193</c:v>
                </c:pt>
                <c:pt idx="60">
                  <c:v>86.442297520525074</c:v>
                </c:pt>
                <c:pt idx="61">
                  <c:v>92.509592756167564</c:v>
                </c:pt>
                <c:pt idx="62">
                  <c:v>98.614908418779038</c:v>
                </c:pt>
                <c:pt idx="63">
                  <c:v>104.75554857283451</c:v>
                </c:pt>
                <c:pt idx="64">
                  <c:v>110.928801684508</c:v>
                </c:pt>
                <c:pt idx="65">
                  <c:v>117.13194181900957</c:v>
                </c:pt>
                <c:pt idx="66">
                  <c:v>123.36222984428134</c:v>
                </c:pt>
                <c:pt idx="67">
                  <c:v>129.61691464052112</c:v>
                </c:pt>
                <c:pt idx="68">
                  <c:v>135.8932343149994</c:v>
                </c:pt>
                <c:pt idx="69">
                  <c:v>142.18841742163363</c:v>
                </c:pt>
                <c:pt idx="70">
                  <c:v>148.49968418478056</c:v>
                </c:pt>
                <c:pt idx="71">
                  <c:v>154.82424772670691</c:v>
                </c:pt>
                <c:pt idx="72">
                  <c:v>161.15931529819639</c:v>
                </c:pt>
                <c:pt idx="73">
                  <c:v>167.50208951174881</c:v>
                </c:pt>
                <c:pt idx="74">
                  <c:v>173.84976957682784</c:v>
                </c:pt>
                <c:pt idx="75">
                  <c:v>180.19955253661115</c:v>
                </c:pt>
                <c:pt idx="76">
                  <c:v>186.54863450569758</c:v>
                </c:pt>
                <c:pt idx="77">
                  <c:v>192.89421190822341</c:v>
                </c:pt>
                <c:pt idx="78">
                  <c:v>199.23348271584302</c:v>
                </c:pt>
                <c:pt idx="79">
                  <c:v>205.5636476850255</c:v>
                </c:pt>
                <c:pt idx="80">
                  <c:v>211.88191159312186</c:v>
                </c:pt>
                <c:pt idx="81">
                  <c:v>218.1854844726567</c:v>
                </c:pt>
                <c:pt idx="82">
                  <c:v>224.47158284329919</c:v>
                </c:pt>
                <c:pt idx="83">
                  <c:v>230.73743094096983</c:v>
                </c:pt>
                <c:pt idx="84">
                  <c:v>236.98026194353946</c:v>
                </c:pt>
                <c:pt idx="85">
                  <c:v>243.19731919258021</c:v>
                </c:pt>
                <c:pt idx="86">
                  <c:v>249.38585741062826</c:v>
                </c:pt>
                <c:pt idx="87">
                  <c:v>255.54314391342089</c:v>
                </c:pt>
                <c:pt idx="88">
                  <c:v>261.66645981657325</c:v>
                </c:pt>
                <c:pt idx="89">
                  <c:v>267.75310123616072</c:v>
                </c:pt>
                <c:pt idx="90">
                  <c:v>273.80038048267863</c:v>
                </c:pt>
                <c:pt idx="91">
                  <c:v>279.80562724784932</c:v>
                </c:pt>
                <c:pt idx="92">
                  <c:v>285.76618978375609</c:v>
                </c:pt>
                <c:pt idx="93">
                  <c:v>291.67943607377964</c:v>
                </c:pt>
                <c:pt idx="94">
                  <c:v>297.54275499482299</c:v>
                </c:pt>
                <c:pt idx="95">
                  <c:v>303.3535574703098</c:v>
                </c:pt>
                <c:pt idx="96">
                  <c:v>309.1092776134476</c:v>
                </c:pt>
                <c:pt idx="97">
                  <c:v>314.80737386025135</c:v>
                </c:pt>
                <c:pt idx="98">
                  <c:v>320.44533009182652</c:v>
                </c:pt>
                <c:pt idx="99">
                  <c:v>326.02065674541609</c:v>
                </c:pt>
                <c:pt idx="100">
                  <c:v>331.53089191372169</c:v>
                </c:pt>
                <c:pt idx="101">
                  <c:v>336.97360243201246</c:v>
                </c:pt>
                <c:pt idx="102">
                  <c:v>342.34638495254205</c:v>
                </c:pt>
                <c:pt idx="103">
                  <c:v>347.64686700579949</c:v>
                </c:pt>
                <c:pt idx="104">
                  <c:v>352.87270804812465</c:v>
                </c:pt>
                <c:pt idx="105">
                  <c:v>358.02160049522661</c:v>
                </c:pt>
                <c:pt idx="106">
                  <c:v>363.09127074114804</c:v>
                </c:pt>
                <c:pt idx="107">
                  <c:v>368.07948016222531</c:v>
                </c:pt>
                <c:pt idx="108">
                  <c:v>372.98402610560208</c:v>
                </c:pt>
                <c:pt idx="109">
                  <c:v>377.80274286185818</c:v>
                </c:pt>
                <c:pt idx="110">
                  <c:v>382.53350262132653</c:v>
                </c:pt>
                <c:pt idx="111">
                  <c:v>387.17421641367366</c:v>
                </c:pt>
                <c:pt idx="112">
                  <c:v>391.72283503033037</c:v>
                </c:pt>
                <c:pt idx="113">
                  <c:v>396.17734992936425</c:v>
                </c:pt>
                <c:pt idx="114">
                  <c:v>400.53579412239571</c:v>
                </c:pt>
                <c:pt idx="115">
                  <c:v>404.79624304316422</c:v>
                </c:pt>
                <c:pt idx="116">
                  <c:v>408.95681539736302</c:v>
                </c:pt>
                <c:pt idx="117">
                  <c:v>413.01567399336523</c:v>
                </c:pt>
                <c:pt idx="118">
                  <c:v>416.97102655347658</c:v>
                </c:pt>
                <c:pt idx="119">
                  <c:v>420.82112650535407</c:v>
                </c:pt>
                <c:pt idx="120">
                  <c:v>424.56427375324381</c:v>
                </c:pt>
                <c:pt idx="121">
                  <c:v>428.19881542869484</c:v>
                </c:pt>
                <c:pt idx="122">
                  <c:v>431.7231466204201</c:v>
                </c:pt>
                <c:pt idx="123">
                  <c:v>435.13571108297913</c:v>
                </c:pt>
                <c:pt idx="124">
                  <c:v>438.43500192397278</c:v>
                </c:pt>
                <c:pt idx="125">
                  <c:v>441.61956226944471</c:v>
                </c:pt>
                <c:pt idx="126">
                  <c:v>444.6879859071953</c:v>
                </c:pt>
                <c:pt idx="127">
                  <c:v>447.63891790772573</c:v>
                </c:pt>
                <c:pt idx="128">
                  <c:v>450.47105522253673</c:v>
                </c:pt>
                <c:pt idx="129">
                  <c:v>453.18314725951791</c:v>
                </c:pt>
                <c:pt idx="130">
                  <c:v>455.77399643517435</c:v>
                </c:pt>
                <c:pt idx="131">
                  <c:v>458.24245870344544</c:v>
                </c:pt>
                <c:pt idx="132">
                  <c:v>460.58744406088363</c:v>
                </c:pt>
                <c:pt idx="133">
                  <c:v>462.80791702796898</c:v>
                </c:pt>
                <c:pt idx="134">
                  <c:v>464.90289710634818</c:v>
                </c:pt>
                <c:pt idx="135">
                  <c:v>466.87145921179456</c:v>
                </c:pt>
                <c:pt idx="136">
                  <c:v>468.71273408269985</c:v>
                </c:pt>
                <c:pt idx="137">
                  <c:v>470.42590866391492</c:v>
                </c:pt>
                <c:pt idx="138">
                  <c:v>472.01022646577258</c:v>
                </c:pt>
                <c:pt idx="139">
                  <c:v>473.46498789813199</c:v>
                </c:pt>
                <c:pt idx="140">
                  <c:v>474.78955057929772</c:v>
                </c:pt>
                <c:pt idx="141">
                  <c:v>475.98332961967765</c:v>
                </c:pt>
                <c:pt idx="142">
                  <c:v>477.04579788005401</c:v>
                </c:pt>
                <c:pt idx="143">
                  <c:v>477.97648620435257</c:v>
                </c:pt>
                <c:pt idx="144">
                  <c:v>478.77498362680922</c:v>
                </c:pt>
                <c:pt idx="145">
                  <c:v>479.44093755344102</c:v>
                </c:pt>
                <c:pt idx="146">
                  <c:v>479.97405391774112</c:v>
                </c:pt>
                <c:pt idx="147">
                  <c:v>480.37409731053106</c:v>
                </c:pt>
                <c:pt idx="148">
                  <c:v>480.64089108391022</c:v>
                </c:pt>
                <c:pt idx="149">
                  <c:v>480.77431742925876</c:v>
                </c:pt>
                <c:pt idx="150">
                  <c:v>480.77431742925864</c:v>
                </c:pt>
                <c:pt idx="151">
                  <c:v>480.64089108391011</c:v>
                </c:pt>
                <c:pt idx="152">
                  <c:v>480.37409731053083</c:v>
                </c:pt>
                <c:pt idx="153">
                  <c:v>479.97405391774078</c:v>
                </c:pt>
                <c:pt idx="154">
                  <c:v>479.44093755344056</c:v>
                </c:pt>
                <c:pt idx="155">
                  <c:v>478.77498362680876</c:v>
                </c:pt>
                <c:pt idx="156">
                  <c:v>477.97648620435189</c:v>
                </c:pt>
                <c:pt idx="157">
                  <c:v>477.04579788005321</c:v>
                </c:pt>
                <c:pt idx="158">
                  <c:v>475.98332961967685</c:v>
                </c:pt>
                <c:pt idx="159">
                  <c:v>474.78955057929682</c:v>
                </c:pt>
                <c:pt idx="160">
                  <c:v>473.46498789813097</c:v>
                </c:pt>
                <c:pt idx="161">
                  <c:v>472.01022646577155</c:v>
                </c:pt>
                <c:pt idx="162">
                  <c:v>470.42590866391379</c:v>
                </c:pt>
                <c:pt idx="163">
                  <c:v>468.7127340826986</c:v>
                </c:pt>
                <c:pt idx="164">
                  <c:v>466.87145921179331</c:v>
                </c:pt>
                <c:pt idx="165">
                  <c:v>464.9028971063467</c:v>
                </c:pt>
                <c:pt idx="166">
                  <c:v>462.80791702796751</c:v>
                </c:pt>
                <c:pt idx="167">
                  <c:v>460.58744406088204</c:v>
                </c:pt>
                <c:pt idx="168">
                  <c:v>458.24245870344384</c:v>
                </c:pt>
                <c:pt idx="169">
                  <c:v>455.77399643517265</c:v>
                </c:pt>
                <c:pt idx="170">
                  <c:v>453.18314725951609</c:v>
                </c:pt>
                <c:pt idx="171">
                  <c:v>450.4710552225348</c:v>
                </c:pt>
                <c:pt idx="172">
                  <c:v>447.63891790772368</c:v>
                </c:pt>
                <c:pt idx="173">
                  <c:v>444.68798590719314</c:v>
                </c:pt>
                <c:pt idx="174">
                  <c:v>441.61956226944255</c:v>
                </c:pt>
                <c:pt idx="175">
                  <c:v>438.43500192397062</c:v>
                </c:pt>
                <c:pt idx="176">
                  <c:v>435.13571108297674</c:v>
                </c:pt>
                <c:pt idx="177">
                  <c:v>431.72314662041765</c:v>
                </c:pt>
                <c:pt idx="178">
                  <c:v>428.19881542869246</c:v>
                </c:pt>
                <c:pt idx="179">
                  <c:v>424.5642737532412</c:v>
                </c:pt>
                <c:pt idx="180">
                  <c:v>420.8211265053514</c:v>
                </c:pt>
                <c:pt idx="181">
                  <c:v>416.97102655347385</c:v>
                </c:pt>
                <c:pt idx="182">
                  <c:v>413.0156739933625</c:v>
                </c:pt>
                <c:pt idx="183">
                  <c:v>408.95681539736017</c:v>
                </c:pt>
                <c:pt idx="184">
                  <c:v>404.79624304316133</c:v>
                </c:pt>
                <c:pt idx="185">
                  <c:v>400.5357941223927</c:v>
                </c:pt>
                <c:pt idx="186">
                  <c:v>396.17734992936118</c:v>
                </c:pt>
                <c:pt idx="187">
                  <c:v>391.72283503032725</c:v>
                </c:pt>
                <c:pt idx="188">
                  <c:v>387.17421641367048</c:v>
                </c:pt>
                <c:pt idx="189">
                  <c:v>382.53350262132324</c:v>
                </c:pt>
                <c:pt idx="190">
                  <c:v>377.80274286185482</c:v>
                </c:pt>
                <c:pt idx="191">
                  <c:v>372.98402610559879</c:v>
                </c:pt>
                <c:pt idx="192">
                  <c:v>368.07948016222196</c:v>
                </c:pt>
                <c:pt idx="193">
                  <c:v>363.09127074114451</c:v>
                </c:pt>
                <c:pt idx="194">
                  <c:v>358.02160049522308</c:v>
                </c:pt>
                <c:pt idx="195">
                  <c:v>352.87270804812101</c:v>
                </c:pt>
                <c:pt idx="196">
                  <c:v>347.6468670057958</c:v>
                </c:pt>
                <c:pt idx="197">
                  <c:v>342.34638495253836</c:v>
                </c:pt>
                <c:pt idx="198">
                  <c:v>336.9736024320087</c:v>
                </c:pt>
                <c:pt idx="199">
                  <c:v>331.53089191371788</c:v>
                </c:pt>
                <c:pt idx="200">
                  <c:v>326.02065674541223</c:v>
                </c:pt>
                <c:pt idx="201">
                  <c:v>320.4453300918226</c:v>
                </c:pt>
                <c:pt idx="202">
                  <c:v>314.80737386024748</c:v>
                </c:pt>
                <c:pt idx="203">
                  <c:v>309.10927761344362</c:v>
                </c:pt>
                <c:pt idx="204">
                  <c:v>303.3535574703057</c:v>
                </c:pt>
                <c:pt idx="205">
                  <c:v>297.54275499481884</c:v>
                </c:pt>
                <c:pt idx="206">
                  <c:v>291.67943607377543</c:v>
                </c:pt>
                <c:pt idx="207">
                  <c:v>285.76618978375188</c:v>
                </c:pt>
                <c:pt idx="208">
                  <c:v>279.80562724784511</c:v>
                </c:pt>
                <c:pt idx="209">
                  <c:v>273.80038048267431</c:v>
                </c:pt>
                <c:pt idx="210">
                  <c:v>267.75310123615645</c:v>
                </c:pt>
                <c:pt idx="211">
                  <c:v>261.66645981656882</c:v>
                </c:pt>
                <c:pt idx="212">
                  <c:v>255.54314391341649</c:v>
                </c:pt>
                <c:pt idx="213">
                  <c:v>249.38585741062383</c:v>
                </c:pt>
                <c:pt idx="214">
                  <c:v>243.197319192576</c:v>
                </c:pt>
                <c:pt idx="215">
                  <c:v>236.98026194353525</c:v>
                </c:pt>
                <c:pt idx="216">
                  <c:v>230.7374309409656</c:v>
                </c:pt>
                <c:pt idx="217">
                  <c:v>224.47158284329493</c:v>
                </c:pt>
                <c:pt idx="218">
                  <c:v>218.18548447265238</c:v>
                </c:pt>
                <c:pt idx="219">
                  <c:v>211.88191159311754</c:v>
                </c:pt>
                <c:pt idx="220">
                  <c:v>205.56364768502115</c:v>
                </c:pt>
                <c:pt idx="221">
                  <c:v>199.23348271583868</c:v>
                </c:pt>
                <c:pt idx="222">
                  <c:v>192.89421190821906</c:v>
                </c:pt>
                <c:pt idx="223">
                  <c:v>186.54863450569323</c:v>
                </c:pt>
                <c:pt idx="224">
                  <c:v>180.1995525366068</c:v>
                </c:pt>
                <c:pt idx="225">
                  <c:v>173.84976957682341</c:v>
                </c:pt>
                <c:pt idx="226">
                  <c:v>167.50208951174437</c:v>
                </c:pt>
                <c:pt idx="227">
                  <c:v>161.15931529819198</c:v>
                </c:pt>
                <c:pt idx="228">
                  <c:v>154.82424772670251</c:v>
                </c:pt>
                <c:pt idx="229">
                  <c:v>148.49968418477613</c:v>
                </c:pt>
                <c:pt idx="230">
                  <c:v>142.18841742162925</c:v>
                </c:pt>
                <c:pt idx="231">
                  <c:v>135.893234314995</c:v>
                </c:pt>
                <c:pt idx="232">
                  <c:v>129.61691464051668</c:v>
                </c:pt>
                <c:pt idx="233">
                  <c:v>123.36222984427692</c:v>
                </c:pt>
                <c:pt idx="234">
                  <c:v>117.13194181900518</c:v>
                </c:pt>
                <c:pt idx="235">
                  <c:v>110.92880168450363</c:v>
                </c:pt>
                <c:pt idx="236">
                  <c:v>104.75554857283016</c:v>
                </c:pt>
                <c:pt idx="237">
                  <c:v>98.614908418774718</c:v>
                </c:pt>
                <c:pt idx="238">
                  <c:v>92.509592756163258</c:v>
                </c:pt>
                <c:pt idx="239">
                  <c:v>86.442297520520739</c:v>
                </c:pt>
                <c:pt idx="240">
                  <c:v>80.415701858621873</c:v>
                </c:pt>
                <c:pt idx="241">
                  <c:v>74.432466945455374</c:v>
                </c:pt>
                <c:pt idx="242">
                  <c:v>68.495234809124227</c:v>
                </c:pt>
                <c:pt idx="243">
                  <c:v>62.606627164199409</c:v>
                </c:pt>
                <c:pt idx="244">
                  <c:v>56.769244254046086</c:v>
                </c:pt>
                <c:pt idx="245">
                  <c:v>50.985663702628372</c:v>
                </c:pt>
                <c:pt idx="246">
                  <c:v>45.258439376303329</c:v>
                </c:pt>
                <c:pt idx="247">
                  <c:v>39.590100256105501</c:v>
                </c:pt>
                <c:pt idx="248">
                  <c:v>33.983149321020107</c:v>
                </c:pt>
                <c:pt idx="249">
                  <c:v>28.440062442737997</c:v>
                </c:pt>
                <c:pt idx="250">
                  <c:v>22.963287292380329</c:v>
                </c:pt>
                <c:pt idx="251">
                  <c:v>17.555242259676021</c:v>
                </c:pt>
                <c:pt idx="252">
                  <c:v>12.218315385068792</c:v>
                </c:pt>
                <c:pt idx="253">
                  <c:v>6.9548633052258992</c:v>
                </c:pt>
                <c:pt idx="254">
                  <c:v>1.7672102124134881</c:v>
                </c:pt>
                <c:pt idx="255">
                  <c:v>-3.3423531718009656</c:v>
                </c:pt>
                <c:pt idx="256">
                  <c:v>-8.3715706080671168</c:v>
                </c:pt>
                <c:pt idx="257">
                  <c:v>-13.318221335543342</c:v>
                </c:pt>
                <c:pt idx="258">
                  <c:v>-18.180121052522281</c:v>
                </c:pt>
                <c:pt idx="259">
                  <c:v>-22.95512288095702</c:v>
                </c:pt>
                <c:pt idx="260">
                  <c:v>-27.641118314461892</c:v>
                </c:pt>
                <c:pt idx="261">
                  <c:v>-32.236038149369563</c:v>
                </c:pt>
                <c:pt idx="262">
                  <c:v>-36.737853398433288</c:v>
                </c:pt>
                <c:pt idx="263">
                  <c:v>-41.14457618677028</c:v>
                </c:pt>
                <c:pt idx="264">
                  <c:v>-45.4542606296516</c:v>
                </c:pt>
                <c:pt idx="265">
                  <c:v>-49.665003691749803</c:v>
                </c:pt>
                <c:pt idx="266">
                  <c:v>-53.774946027465887</c:v>
                </c:pt>
                <c:pt idx="267">
                  <c:v>-57.782272801964041</c:v>
                </c:pt>
                <c:pt idx="268">
                  <c:v>-61.685214492551495</c:v>
                </c:pt>
                <c:pt idx="269">
                  <c:v>-65.48204767004998</c:v>
                </c:pt>
                <c:pt idx="270">
                  <c:v>-69.171095759813483</c:v>
                </c:pt>
                <c:pt idx="271">
                  <c:v>-72.750729782056425</c:v>
                </c:pt>
                <c:pt idx="272">
                  <c:v>-76.219369071165659</c:v>
                </c:pt>
                <c:pt idx="273">
                  <c:v>-79.575481973677171</c:v>
                </c:pt>
                <c:pt idx="274">
                  <c:v>-82.817586524611642</c:v>
                </c:pt>
                <c:pt idx="275">
                  <c:v>-85.944251101868332</c:v>
                </c:pt>
                <c:pt idx="276">
                  <c:v>-88.954095058389072</c:v>
                </c:pt>
                <c:pt idx="277">
                  <c:v>-91.845789331813279</c:v>
                </c:pt>
                <c:pt idx="278">
                  <c:v>-94.618057031354368</c:v>
                </c:pt>
                <c:pt idx="279">
                  <c:v>-97.26967400163872</c:v>
                </c:pt>
                <c:pt idx="280">
                  <c:v>-99.799469363258282</c:v>
                </c:pt>
                <c:pt idx="281">
                  <c:v>-102.20632602979802</c:v>
                </c:pt>
                <c:pt idx="282">
                  <c:v>-104.4891812011098</c:v>
                </c:pt>
                <c:pt idx="283">
                  <c:v>-106.64702683261496</c:v>
                </c:pt>
                <c:pt idx="284">
                  <c:v>-108.67891008042838</c:v>
                </c:pt>
                <c:pt idx="285">
                  <c:v>-110.58393372210779</c:v>
                </c:pt>
                <c:pt idx="286">
                  <c:v>-112.36125655284158</c:v>
                </c:pt>
                <c:pt idx="287">
                  <c:v>-114.01009375690145</c:v>
                </c:pt>
                <c:pt idx="288">
                  <c:v>-115.52971725419459</c:v>
                </c:pt>
                <c:pt idx="289">
                  <c:v>-116.91945602176386</c:v>
                </c:pt>
                <c:pt idx="290">
                  <c:v>-118.1786963900922</c:v>
                </c:pt>
                <c:pt idx="291">
                  <c:v>-119.30688231408206</c:v>
                </c:pt>
                <c:pt idx="292">
                  <c:v>-120.3035156185891</c:v>
                </c:pt>
                <c:pt idx="293">
                  <c:v>-121.16815621840246</c:v>
                </c:pt>
                <c:pt idx="294">
                  <c:v>-121.90042231257385</c:v>
                </c:pt>
                <c:pt idx="295">
                  <c:v>-122.49999055301018</c:v>
                </c:pt>
                <c:pt idx="296">
                  <c:v>-122.96659618725513</c:v>
                </c:pt>
                <c:pt idx="297">
                  <c:v>-123.30003317539595</c:v>
                </c:pt>
                <c:pt idx="298">
                  <c:v>-123.5001542810455</c:v>
                </c:pt>
                <c:pt idx="299">
                  <c:v>-123.56687113635698</c:v>
                </c:pt>
              </c:numCache>
            </c:numRef>
          </c:xVal>
          <c:yVal>
            <c:numRef>
              <c:f>'Covariance   Correlation3'!yycir23</c:f>
              <c:numCache>
                <c:formatCode>General</c:formatCode>
                <c:ptCount val="300"/>
                <c:pt idx="0">
                  <c:v>7.7095479000513778E-2</c:v>
                </c:pt>
                <c:pt idx="1">
                  <c:v>4.3123100967528472E-2</c:v>
                </c:pt>
                <c:pt idx="2">
                  <c:v>9.3092699982418314E-3</c:v>
                </c:pt>
                <c:pt idx="3">
                  <c:v>-2.4331082671488369E-2</c:v>
                </c:pt>
                <c:pt idx="4">
                  <c:v>-5.7783102408937748E-2</c:v>
                </c:pt>
                <c:pt idx="5">
                  <c:v>-9.1032017743903015E-2</c:v>
                </c:pt>
                <c:pt idx="6">
                  <c:v>-0.12406314689136747</c:v>
                </c:pt>
                <c:pt idx="7">
                  <c:v>-0.15686190423456306</c:v>
                </c:pt>
                <c:pt idx="8">
                  <c:v>-0.18941380676557118</c:v>
                </c:pt>
                <c:pt idx="9">
                  <c:v>-0.22170448048060692</c:v>
                </c:pt>
                <c:pt idx="10">
                  <c:v>-0.25371966672717722</c:v>
                </c:pt>
                <c:pt idx="11">
                  <c:v>-0.28544522850029991</c:v>
                </c:pt>
                <c:pt idx="12">
                  <c:v>-0.31686715668500709</c:v>
                </c:pt>
                <c:pt idx="13">
                  <c:v>-0.34797157624237562</c:v>
                </c:pt>
                <c:pt idx="14">
                  <c:v>-0.37874475233635413</c:v>
                </c:pt>
                <c:pt idx="15">
                  <c:v>-0.40917309639867988</c:v>
                </c:pt>
                <c:pt idx="16">
                  <c:v>-0.43924317212920777</c:v>
                </c:pt>
                <c:pt idx="17">
                  <c:v>-0.46894170142900221</c:v>
                </c:pt>
                <c:pt idx="18">
                  <c:v>-0.49825557026357237</c:v>
                </c:pt>
                <c:pt idx="19">
                  <c:v>-0.52717183445366</c:v>
                </c:pt>
                <c:pt idx="20">
                  <c:v>-0.55567772539102456</c:v>
                </c:pt>
                <c:pt idx="21">
                  <c:v>-0.58376065567670188</c:v>
                </c:pt>
                <c:pt idx="22">
                  <c:v>-0.61140822467924472</c:v>
                </c:pt>
                <c:pt idx="23">
                  <c:v>-0.63860822401049155</c:v>
                </c:pt>
                <c:pt idx="24">
                  <c:v>-0.66534864291645013</c:v>
                </c:pt>
                <c:pt idx="25">
                  <c:v>-0.69161767358090454</c:v>
                </c:pt>
                <c:pt idx="26">
                  <c:v>-0.7174037163394168</c:v>
                </c:pt>
                <c:pt idx="27">
                  <c:v>-0.7426953848014114</c:v>
                </c:pt>
                <c:pt idx="28">
                  <c:v>-0.76748151087808525</c:v>
                </c:pt>
                <c:pt idx="29">
                  <c:v>-0.79175114971392047</c:v>
                </c:pt>
                <c:pt idx="30">
                  <c:v>-0.81549358451962561</c:v>
                </c:pt>
                <c:pt idx="31">
                  <c:v>-0.83869833130436744</c:v>
                </c:pt>
                <c:pt idx="32">
                  <c:v>-0.86135514350520581</c:v>
                </c:pt>
                <c:pt idx="33">
                  <c:v>-0.8834540165116882</c:v>
                </c:pt>
                <c:pt idx="34">
                  <c:v>-0.9049851920836034</c:v>
                </c:pt>
                <c:pt idx="35">
                  <c:v>-0.92593916265994669</c:v>
                </c:pt>
                <c:pt idx="36">
                  <c:v>-0.94630667555718995</c:v>
                </c:pt>
                <c:pt idx="37">
                  <c:v>-0.96607873705500591</c:v>
                </c:pt>
                <c:pt idx="38">
                  <c:v>-0.98524661636764399</c:v>
                </c:pt>
                <c:pt idx="39">
                  <c:v>-1.0038018494991976</c:v>
                </c:pt>
                <c:pt idx="40">
                  <c:v>-1.0217362429810668</c:v>
                </c:pt>
                <c:pt idx="41">
                  <c:v>-1.0390418774899635</c:v>
                </c:pt>
                <c:pt idx="42">
                  <c:v>-1.0557111113448625</c:v>
                </c:pt>
                <c:pt idx="43">
                  <c:v>-1.0717365838813511</c:v>
                </c:pt>
                <c:pt idx="44">
                  <c:v>-1.087111218701893</c:v>
                </c:pt>
                <c:pt idx="45">
                  <c:v>-1.1018282268005652</c:v>
                </c:pt>
                <c:pt idx="46">
                  <c:v>-1.1158811095608918</c:v>
                </c:pt>
                <c:pt idx="47">
                  <c:v>-1.1292636616254503</c:v>
                </c:pt>
                <c:pt idx="48">
                  <c:v>-1.1419699736359838</c:v>
                </c:pt>
                <c:pt idx="49">
                  <c:v>-1.1539944348428057</c:v>
                </c:pt>
                <c:pt idx="50">
                  <c:v>-1.1653317355823491</c:v>
                </c:pt>
                <c:pt idx="51">
                  <c:v>-1.1759768696217658</c:v>
                </c:pt>
                <c:pt idx="52">
                  <c:v>-1.1859251363695364</c:v>
                </c:pt>
                <c:pt idx="53">
                  <c:v>-1.1951721429511206</c:v>
                </c:pt>
                <c:pt idx="54">
                  <c:v>-1.2037138061487254</c:v>
                </c:pt>
                <c:pt idx="55">
                  <c:v>-1.2115463542043408</c:v>
                </c:pt>
                <c:pt idx="56">
                  <c:v>-1.2186663284852401</c:v>
                </c:pt>
                <c:pt idx="57">
                  <c:v>-1.2250705850112169</c:v>
                </c:pt>
                <c:pt idx="58">
                  <c:v>-1.2307562958428766</c:v>
                </c:pt>
                <c:pt idx="59">
                  <c:v>-1.2357209503303745</c:v>
                </c:pt>
                <c:pt idx="60">
                  <c:v>-1.2399623562220503</c:v>
                </c:pt>
                <c:pt idx="61">
                  <c:v>-1.2434786406324625</c:v>
                </c:pt>
                <c:pt idx="62">
                  <c:v>-1.2462682508694025</c:v>
                </c:pt>
                <c:pt idx="63">
                  <c:v>-1.2483299551195213</c:v>
                </c:pt>
                <c:pt idx="64">
                  <c:v>-1.2496628429922605</c:v>
                </c:pt>
                <c:pt idx="65">
                  <c:v>-1.2502663259218585</c:v>
                </c:pt>
                <c:pt idx="66">
                  <c:v>-1.2501401374272418</c:v>
                </c:pt>
                <c:pt idx="67">
                  <c:v>-1.2492843332296977</c:v>
                </c:pt>
                <c:pt idx="68">
                  <c:v>-1.2476992912282674</c:v>
                </c:pt>
                <c:pt idx="69">
                  <c:v>-1.2453857113328786</c:v>
                </c:pt>
                <c:pt idx="70">
                  <c:v>-1.2423446151552828</c:v>
                </c:pt>
                <c:pt idx="71">
                  <c:v>-1.2385773455579414</c:v>
                </c:pt>
                <c:pt idx="72">
                  <c:v>-1.2340855660610568</c:v>
                </c:pt>
                <c:pt idx="73">
                  <c:v>-1.2288712601080045</c:v>
                </c:pt>
                <c:pt idx="74">
                  <c:v>-1.222936730189506</c:v>
                </c:pt>
                <c:pt idx="75">
                  <c:v>-1.2162845968269085</c:v>
                </c:pt>
                <c:pt idx="76">
                  <c:v>-1.2089177974150405</c:v>
                </c:pt>
                <c:pt idx="77">
                  <c:v>-1.2008395849251376</c:v>
                </c:pt>
                <c:pt idx="78">
                  <c:v>-1.1920535264684251</c:v>
                </c:pt>
                <c:pt idx="79">
                  <c:v>-1.1825635017209792</c:v>
                </c:pt>
                <c:pt idx="80">
                  <c:v>-1.1723737012105742</c:v>
                </c:pt>
                <c:pt idx="81">
                  <c:v>-1.1614886244662601</c:v>
                </c:pt>
                <c:pt idx="82">
                  <c:v>-1.1499130780314999</c:v>
                </c:pt>
                <c:pt idx="83">
                  <c:v>-1.1376521733417344</c:v>
                </c:pt>
                <c:pt idx="84">
                  <c:v>-1.1247113244673161</c:v>
                </c:pt>
                <c:pt idx="85">
                  <c:v>-1.111096245722808</c:v>
                </c:pt>
                <c:pt idx="86">
                  <c:v>-1.0968129491437038</c:v>
                </c:pt>
                <c:pt idx="87">
                  <c:v>-1.0818677418316811</c:v>
                </c:pt>
                <c:pt idx="88">
                  <c:v>-1.0662672231695647</c:v>
                </c:pt>
                <c:pt idx="89">
                  <c:v>-1.0500182819072232</c:v>
                </c:pt>
                <c:pt idx="90">
                  <c:v>-1.0331280931196916</c:v>
                </c:pt>
                <c:pt idx="91">
                  <c:v>-1.0156041150388602</c:v>
                </c:pt>
                <c:pt idx="92">
                  <c:v>-0.99745408576012906</c:v>
                </c:pt>
                <c:pt idx="93">
                  <c:v>-0.97868601982548398</c:v>
                </c:pt>
                <c:pt idx="94">
                  <c:v>-0.95930820468449896</c:v>
                </c:pt>
                <c:pt idx="95">
                  <c:v>-0.93932919703483209</c:v>
                </c:pt>
                <c:pt idx="96">
                  <c:v>-0.91875781904383058</c:v>
                </c:pt>
                <c:pt idx="97">
                  <c:v>-0.89760315445290595</c:v>
                </c:pt>
                <c:pt idx="98">
                  <c:v>-0.875874544566414</c:v>
                </c:pt>
                <c:pt idx="99">
                  <c:v>-0.85358158412679552</c:v>
                </c:pt>
                <c:pt idx="100">
                  <c:v>-0.83073411707780775</c:v>
                </c:pt>
                <c:pt idx="101">
                  <c:v>-0.80734223221771773</c:v>
                </c:pt>
                <c:pt idx="102">
                  <c:v>-0.78341625874437049</c:v>
                </c:pt>
                <c:pt idx="103">
                  <c:v>-0.75896676169410848</c:v>
                </c:pt>
                <c:pt idx="104">
                  <c:v>-0.7340045372765478</c:v>
                </c:pt>
                <c:pt idx="105">
                  <c:v>-0.70854060810727582</c:v>
                </c:pt>
                <c:pt idx="106">
                  <c:v>-0.6825862183405752</c:v>
                </c:pt>
                <c:pt idx="107">
                  <c:v>-0.65615282870432079</c:v>
                </c:pt>
                <c:pt idx="108">
                  <c:v>-0.62925211143924531</c:v>
                </c:pt>
                <c:pt idx="109">
                  <c:v>-0.60189594514480704</c:v>
                </c:pt>
                <c:pt idx="110">
                  <c:v>-0.57409640953393426</c:v>
                </c:pt>
                <c:pt idx="111">
                  <c:v>-0.54586578009896392</c:v>
                </c:pt>
                <c:pt idx="112">
                  <c:v>-0.5172165226911295</c:v>
                </c:pt>
                <c:pt idx="113">
                  <c:v>-0.48816128801599334</c:v>
                </c:pt>
                <c:pt idx="114">
                  <c:v>-0.45871290604724924</c:v>
                </c:pt>
                <c:pt idx="115">
                  <c:v>-0.428884380361369</c:v>
                </c:pt>
                <c:pt idx="116">
                  <c:v>-0.39868888239558853</c:v>
                </c:pt>
                <c:pt idx="117">
                  <c:v>-0.36813974563177099</c:v>
                </c:pt>
                <c:pt idx="118">
                  <c:v>-0.33725045970871825</c:v>
                </c:pt>
                <c:pt idx="119">
                  <c:v>-0.30603466446552524</c:v>
                </c:pt>
                <c:pt idx="120">
                  <c:v>-0.27450614391861061</c:v>
                </c:pt>
                <c:pt idx="121">
                  <c:v>-0.24267882017508446</c:v>
                </c:pt>
                <c:pt idx="122">
                  <c:v>-0.21056674728513491</c:v>
                </c:pt>
                <c:pt idx="123">
                  <c:v>-0.17818410503615906</c:v>
                </c:pt>
                <c:pt idx="124">
                  <c:v>-0.14554519269136557</c:v>
                </c:pt>
                <c:pt idx="125">
                  <c:v>-0.11266442267562288</c:v>
                </c:pt>
                <c:pt idx="126">
                  <c:v>-7.955631421133863E-2</c:v>
                </c:pt>
                <c:pt idx="127">
                  <c:v>-4.6235486907179213E-2</c:v>
                </c:pt>
                <c:pt idx="128">
                  <c:v>-1.2716654302462826E-2</c:v>
                </c:pt>
                <c:pt idx="129">
                  <c:v>2.0985382629926386E-2</c:v>
                </c:pt>
                <c:pt idx="130">
                  <c:v>5.4855742019229714E-2</c:v>
                </c:pt>
                <c:pt idx="131">
                  <c:v>8.8879467668230627E-2</c:v>
                </c:pt>
                <c:pt idx="132">
                  <c:v>0.12304153565748949</c:v>
                </c:pt>
                <c:pt idx="133">
                  <c:v>0.15732686097948351</c:v>
                </c:pt>
                <c:pt idx="134">
                  <c:v>0.19172030419972202</c:v>
                </c:pt>
                <c:pt idx="135">
                  <c:v>0.22620667814189382</c:v>
                </c:pt>
                <c:pt idx="136">
                  <c:v>0.26077075459409632</c:v>
                </c:pt>
                <c:pt idx="137">
                  <c:v>0.29539727103318819</c:v>
                </c:pt>
                <c:pt idx="138">
                  <c:v>0.33007093736428544</c:v>
                </c:pt>
                <c:pt idx="139">
                  <c:v>0.36477644267243975</c:v>
                </c:pt>
                <c:pt idx="140">
                  <c:v>0.39949846198350702</c:v>
                </c:pt>
                <c:pt idx="141">
                  <c:v>0.43422166303122411</c:v>
                </c:pt>
                <c:pt idx="142">
                  <c:v>0.46893071302750633</c:v>
                </c:pt>
                <c:pt idx="143">
                  <c:v>0.50361028543297504</c:v>
                </c:pt>
                <c:pt idx="144">
                  <c:v>0.53824506672472583</c:v>
                </c:pt>
                <c:pt idx="145">
                  <c:v>0.57281976315834904</c:v>
                </c:pt>
                <c:pt idx="146">
                  <c:v>0.60731910752121698</c:v>
                </c:pt>
                <c:pt idx="147">
                  <c:v>0.64172786587405539</c:v>
                </c:pt>
                <c:pt idx="148">
                  <c:v>0.67603084427782156</c:v>
                </c:pt>
                <c:pt idx="149">
                  <c:v>0.71021289550292077</c:v>
                </c:pt>
                <c:pt idx="150">
                  <c:v>0.74425892571779517</c:v>
                </c:pt>
                <c:pt idx="151">
                  <c:v>0.77815390115393834</c:v>
                </c:pt>
                <c:pt idx="152">
                  <c:v>0.81188285474437938</c:v>
                </c:pt>
                <c:pt idx="153">
                  <c:v>0.84543089273272143</c:v>
                </c:pt>
                <c:pt idx="154">
                  <c:v>0.87878320124980491</c:v>
                </c:pt>
                <c:pt idx="155">
                  <c:v>0.91192505285509418</c:v>
                </c:pt>
                <c:pt idx="156">
                  <c:v>0.944841813039902</c:v>
                </c:pt>
                <c:pt idx="157">
                  <c:v>0.97751894668957495</c:v>
                </c:pt>
                <c:pt idx="158">
                  <c:v>1.0099420245017923</c:v>
                </c:pt>
                <c:pt idx="159">
                  <c:v>1.0420967293581391</c:v>
                </c:pt>
                <c:pt idx="160">
                  <c:v>1.0739688626461428</c:v>
                </c:pt>
                <c:pt idx="161">
                  <c:v>1.1055443505289804</c:v>
                </c:pt>
                <c:pt idx="162">
                  <c:v>1.136809250160089</c:v>
                </c:pt>
                <c:pt idx="163">
                  <c:v>1.1677497558399348</c:v>
                </c:pt>
                <c:pt idx="164">
                  <c:v>1.1983522051122195</c:v>
                </c:pt>
                <c:pt idx="165">
                  <c:v>1.2286030847968397</c:v>
                </c:pt>
                <c:pt idx="166">
                  <c:v>1.258489036956923</c:v>
                </c:pt>
                <c:pt idx="167">
                  <c:v>1.2879968647973197</c:v>
                </c:pt>
                <c:pt idx="168">
                  <c:v>1.3171135384919346</c:v>
                </c:pt>
                <c:pt idx="169">
                  <c:v>1.3458262009373321</c:v>
                </c:pt>
                <c:pt idx="170">
                  <c:v>1.3741221734300701</c:v>
                </c:pt>
                <c:pt idx="171">
                  <c:v>1.401988961265261</c:v>
                </c:pt>
                <c:pt idx="172">
                  <c:v>1.4294142592538783</c:v>
                </c:pt>
                <c:pt idx="173">
                  <c:v>1.456385957156384</c:v>
                </c:pt>
                <c:pt idx="174">
                  <c:v>1.4828921450302681</c:v>
                </c:pt>
                <c:pt idx="175">
                  <c:v>1.508921118489146</c:v>
                </c:pt>
                <c:pt idx="176">
                  <c:v>1.5344613838710832</c:v>
                </c:pt>
                <c:pt idx="177">
                  <c:v>1.5595016633138752</c:v>
                </c:pt>
                <c:pt idx="178">
                  <c:v>1.5840308997350316</c:v>
                </c:pt>
                <c:pt idx="179">
                  <c:v>1.6080382617142768</c:v>
                </c:pt>
                <c:pt idx="180">
                  <c:v>1.6315131482763949</c:v>
                </c:pt>
                <c:pt idx="181">
                  <c:v>1.6544451935723246</c:v>
                </c:pt>
                <c:pt idx="182">
                  <c:v>1.676824271456427</c:v>
                </c:pt>
                <c:pt idx="183">
                  <c:v>1.6986404999579052</c:v>
                </c:pt>
                <c:pt idx="184">
                  <c:v>1.719884245644405</c:v>
                </c:pt>
                <c:pt idx="185">
                  <c:v>1.7405461278758667</c:v>
                </c:pt>
                <c:pt idx="186">
                  <c:v>1.760617022946753</c:v>
                </c:pt>
                <c:pt idx="187">
                  <c:v>1.780088068114819</c:v>
                </c:pt>
                <c:pt idx="188">
                  <c:v>1.7989506655146512</c:v>
                </c:pt>
                <c:pt idx="189">
                  <c:v>1.8171964859542413</c:v>
                </c:pt>
                <c:pt idx="190">
                  <c:v>1.834817472592924</c:v>
                </c:pt>
                <c:pt idx="191">
                  <c:v>1.8518058444990508</c:v>
                </c:pt>
                <c:pt idx="192">
                  <c:v>1.8681541000858302</c:v>
                </c:pt>
                <c:pt idx="193">
                  <c:v>1.8838550204238171</c:v>
                </c:pt>
                <c:pt idx="194">
                  <c:v>1.8989016724285894</c:v>
                </c:pt>
                <c:pt idx="195">
                  <c:v>1.9132874119222021</c:v>
                </c:pt>
                <c:pt idx="196">
                  <c:v>1.9270058865670701</c:v>
                </c:pt>
                <c:pt idx="197">
                  <c:v>1.9400510386709808</c:v>
                </c:pt>
                <c:pt idx="198">
                  <c:v>1.9524171078620016</c:v>
                </c:pt>
                <c:pt idx="199">
                  <c:v>1.9640986336320962</c:v>
                </c:pt>
                <c:pt idx="200">
                  <c:v>1.9750904577483333</c:v>
                </c:pt>
                <c:pt idx="201">
                  <c:v>1.9853877265306155</c:v>
                </c:pt>
                <c:pt idx="202">
                  <c:v>1.9949858929949285</c:v>
                </c:pt>
                <c:pt idx="203">
                  <c:v>2.0038807188611614</c:v>
                </c:pt>
                <c:pt idx="204">
                  <c:v>2.0120682764246105</c:v>
                </c:pt>
                <c:pt idx="205">
                  <c:v>2.0195449502903458</c:v>
                </c:pt>
                <c:pt idx="206">
                  <c:v>2.0263074389696643</c:v>
                </c:pt>
                <c:pt idx="207">
                  <c:v>2.032352756337938</c:v>
                </c:pt>
                <c:pt idx="208">
                  <c:v>2.0376782329531986</c:v>
                </c:pt>
                <c:pt idx="209">
                  <c:v>2.0422815172348923</c:v>
                </c:pt>
                <c:pt idx="210">
                  <c:v>2.0461605765022672</c:v>
                </c:pt>
                <c:pt idx="211">
                  <c:v>2.0493136978719506</c:v>
                </c:pt>
                <c:pt idx="212">
                  <c:v>2.0517394890143104</c:v>
                </c:pt>
                <c:pt idx="213">
                  <c:v>2.0534368787682666</c:v>
                </c:pt>
                <c:pt idx="214">
                  <c:v>2.0544051176142868</c:v>
                </c:pt>
                <c:pt idx="215">
                  <c:v>2.0546437780053548</c:v>
                </c:pt>
                <c:pt idx="216">
                  <c:v>2.0541527545557594</c:v>
                </c:pt>
                <c:pt idx="217">
                  <c:v>2.0529322640876342</c:v>
                </c:pt>
                <c:pt idx="218">
                  <c:v>2.0509828455352102</c:v>
                </c:pt>
                <c:pt idx="219">
                  <c:v>2.0483053597068426</c:v>
                </c:pt>
                <c:pt idx="220">
                  <c:v>2.0449009889048995</c:v>
                </c:pt>
                <c:pt idx="221">
                  <c:v>2.040771236403689</c:v>
                </c:pt>
                <c:pt idx="222">
                  <c:v>2.0359179257856592</c:v>
                </c:pt>
                <c:pt idx="223">
                  <c:v>2.0303432001361519</c:v>
                </c:pt>
                <c:pt idx="224">
                  <c:v>2.0240495210970799</c:v>
                </c:pt>
                <c:pt idx="225">
                  <c:v>2.0170396677799314</c:v>
                </c:pt>
                <c:pt idx="226">
                  <c:v>2.0093167355385972</c:v>
                </c:pt>
                <c:pt idx="227">
                  <c:v>2.0008841346025452</c:v>
                </c:pt>
                <c:pt idx="228">
                  <c:v>1.9917455885709607</c:v>
                </c:pt>
                <c:pt idx="229">
                  <c:v>1.9819051327685113</c:v>
                </c:pt>
                <c:pt idx="230">
                  <c:v>1.9713671124634591</c:v>
                </c:pt>
                <c:pt idx="231">
                  <c:v>1.9601361809489135</c:v>
                </c:pt>
                <c:pt idx="232">
                  <c:v>1.9482172974880672</c:v>
                </c:pt>
                <c:pt idx="233">
                  <c:v>1.9356157251243269</c:v>
                </c:pt>
                <c:pt idx="234">
                  <c:v>1.9223370283572994</c:v>
                </c:pt>
                <c:pt idx="235">
                  <c:v>1.9083870706856663</c:v>
                </c:pt>
                <c:pt idx="236">
                  <c:v>1.8937720120180284</c:v>
                </c:pt>
                <c:pt idx="237">
                  <c:v>1.8784983059528626</c:v>
                </c:pt>
                <c:pt idx="238">
                  <c:v>1.8625726969287943</c:v>
                </c:pt>
                <c:pt idx="239">
                  <c:v>1.8460022172464454</c:v>
                </c:pt>
                <c:pt idx="240">
                  <c:v>1.8287941839631647</c:v>
                </c:pt>
                <c:pt idx="241">
                  <c:v>1.8109561956620246</c:v>
                </c:pt>
                <c:pt idx="242">
                  <c:v>1.7924961290964994</c:v>
                </c:pt>
                <c:pt idx="243">
                  <c:v>1.773422135712311</c:v>
                </c:pt>
                <c:pt idx="244">
                  <c:v>1.7537426380479844</c:v>
                </c:pt>
                <c:pt idx="245">
                  <c:v>1.7334663260156868</c:v>
                </c:pt>
                <c:pt idx="246">
                  <c:v>1.7126021530640108</c:v>
                </c:pt>
                <c:pt idx="247">
                  <c:v>1.691159332224381</c:v>
                </c:pt>
                <c:pt idx="248">
                  <c:v>1.6691473320428403</c:v>
                </c:pt>
                <c:pt idx="249">
                  <c:v>1.6465758723990054</c:v>
                </c:pt>
                <c:pt idx="250">
                  <c:v>1.6234549202140434</c:v>
                </c:pt>
                <c:pt idx="251">
                  <c:v>1.599794685049557</c:v>
                </c:pt>
                <c:pt idx="252">
                  <c:v>1.5756056145993325</c:v>
                </c:pt>
                <c:pt idx="253">
                  <c:v>1.5508983900759303</c:v>
                </c:pt>
                <c:pt idx="254">
                  <c:v>1.5256839214941631</c:v>
                </c:pt>
                <c:pt idx="255">
                  <c:v>1.4999733428535409</c:v>
                </c:pt>
                <c:pt idx="256">
                  <c:v>1.4737780072218083</c:v>
                </c:pt>
                <c:pt idx="257">
                  <c:v>1.4471094817217522</c:v>
                </c:pt>
                <c:pt idx="258">
                  <c:v>1.4199795424234831</c:v>
                </c:pt>
                <c:pt idx="259">
                  <c:v>1.3924001691444567</c:v>
                </c:pt>
                <c:pt idx="260">
                  <c:v>1.3643835401595217</c:v>
                </c:pt>
                <c:pt idx="261">
                  <c:v>1.3359420268233377</c:v>
                </c:pt>
                <c:pt idx="262">
                  <c:v>1.3070881881075327</c:v>
                </c:pt>
                <c:pt idx="263">
                  <c:v>1.2778347650550148</c:v>
                </c:pt>
                <c:pt idx="264">
                  <c:v>1.2481946751538864</c:v>
                </c:pt>
                <c:pt idx="265">
                  <c:v>1.2181810066334453</c:v>
                </c:pt>
                <c:pt idx="266">
                  <c:v>1.1878070126847911</c:v>
                </c:pt>
                <c:pt idx="267">
                  <c:v>1.1570861056085884</c:v>
                </c:pt>
                <c:pt idx="268">
                  <c:v>1.1260318508925731</c:v>
                </c:pt>
                <c:pt idx="269">
                  <c:v>1.0946579612214158</c:v>
                </c:pt>
                <c:pt idx="270">
                  <c:v>1.0629782904215832</c:v>
                </c:pt>
                <c:pt idx="271">
                  <c:v>1.0310068273438826</c:v>
                </c:pt>
                <c:pt idx="272">
                  <c:v>0.99875768968637391</c:v>
                </c:pt>
                <c:pt idx="273">
                  <c:v>0.96624511776039745</c:v>
                </c:pt>
                <c:pt idx="274">
                  <c:v>0.93348346820244887</c:v>
                </c:pt>
                <c:pt idx="275">
                  <c:v>0.90048720763469547</c:v>
                </c:pt>
                <c:pt idx="276">
                  <c:v>0.86727090627692149</c:v>
                </c:pt>
                <c:pt idx="277">
                  <c:v>0.83384923151272872</c:v>
                </c:pt>
                <c:pt idx="278">
                  <c:v>0.80023694141283519</c:v>
                </c:pt>
                <c:pt idx="279">
                  <c:v>0.76644887821832408</c:v>
                </c:pt>
                <c:pt idx="280">
                  <c:v>0.73249996178672938</c:v>
                </c:pt>
                <c:pt idx="281">
                  <c:v>0.69840518300384624</c:v>
                </c:pt>
                <c:pt idx="282">
                  <c:v>0.66417959716417818</c:v>
                </c:pt>
                <c:pt idx="283">
                  <c:v>0.62983831732294193</c:v>
                </c:pt>
                <c:pt idx="284">
                  <c:v>0.59539650762256946</c:v>
                </c:pt>
                <c:pt idx="285">
                  <c:v>0.56086937659664771</c:v>
                </c:pt>
                <c:pt idx="286">
                  <c:v>0.52627217045425922</c:v>
                </c:pt>
                <c:pt idx="287">
                  <c:v>0.49162016634768552</c:v>
                </c:pt>
                <c:pt idx="288">
                  <c:v>0.45692866562644607</c:v>
                </c:pt>
                <c:pt idx="289">
                  <c:v>0.42221298708065419</c:v>
                </c:pt>
                <c:pt idx="290">
                  <c:v>0.38748846017666916</c:v>
                </c:pt>
                <c:pt idx="291">
                  <c:v>0.35277041828803657</c:v>
                </c:pt>
                <c:pt idx="292">
                  <c:v>0.31807419192470165</c:v>
                </c:pt>
                <c:pt idx="293">
                  <c:v>0.28341510196348763</c:v>
                </c:pt>
                <c:pt idx="294">
                  <c:v>0.24880845288282838</c:v>
                </c:pt>
                <c:pt idx="295">
                  <c:v>0.21426952600474108</c:v>
                </c:pt>
                <c:pt idx="296">
                  <c:v>0.17981357274702442</c:v>
                </c:pt>
                <c:pt idx="297">
                  <c:v>0.1454558078886623</c:v>
                </c:pt>
                <c:pt idx="298">
                  <c:v>0.11121140285140568</c:v>
                </c:pt>
                <c:pt idx="299">
                  <c:v>7.7095479000501232E-2</c:v>
                </c:pt>
              </c:numCache>
            </c:numRef>
          </c:yVal>
          <c:smooth val="0"/>
        </c:ser>
        <c:ser>
          <c:idx val="2"/>
          <c:order val="2"/>
          <c:spPr>
            <a:ln w="19050">
              <a:noFill/>
            </a:ln>
          </c:spPr>
          <c:marker>
            <c:symbol val="none"/>
          </c:marker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419800"/>
        <c:axId val="283420192"/>
      </c:scatterChart>
      <c:valAx>
        <c:axId val="283419800"/>
        <c:scaling>
          <c:orientation val="minMax"/>
          <c:max val="4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420192"/>
        <c:crosses val="autoZero"/>
        <c:crossBetween val="midCat"/>
      </c:valAx>
      <c:valAx>
        <c:axId val="283420192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419800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826165960024233"/>
          <c:y val="0.10679611650485436"/>
          <c:w val="0.64991141732283464"/>
          <c:h val="0.70399634502923969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FF0000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FF0000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AT$1:$AT$15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6</c:v>
                </c:pt>
                <c:pt idx="6">
                  <c:v>9</c:v>
                </c:pt>
                <c:pt idx="7">
                  <c:v>13</c:v>
                </c:pt>
                <c:pt idx="8">
                  <c:v>13</c:v>
                </c:pt>
                <c:pt idx="9">
                  <c:v>6</c:v>
                </c:pt>
                <c:pt idx="10">
                  <c:v>6</c:v>
                </c:pt>
                <c:pt idx="11">
                  <c:v>4</c:v>
                </c:pt>
                <c:pt idx="12">
                  <c:v>9</c:v>
                </c:pt>
                <c:pt idx="13">
                  <c:v>6</c:v>
                </c:pt>
                <c:pt idx="14">
                  <c:v>8</c:v>
                </c:pt>
              </c:numCache>
            </c:numRef>
          </c:xVal>
          <c:yVal>
            <c:numRef>
              <c:f>'Covariance   Correlation3_HID4'!$AU$1:$AU$15</c:f>
              <c:numCache>
                <c:formatCode>General</c:formatCode>
                <c:ptCount val="15"/>
                <c:pt idx="0">
                  <c:v>9.1300000000000006E-2</c:v>
                </c:pt>
                <c:pt idx="1">
                  <c:v>0.44719999999999999</c:v>
                </c:pt>
                <c:pt idx="2">
                  <c:v>0.40560000000000002</c:v>
                </c:pt>
                <c:pt idx="3">
                  <c:v>0.29530000000000001</c:v>
                </c:pt>
                <c:pt idx="4">
                  <c:v>0.10879999999999999</c:v>
                </c:pt>
                <c:pt idx="5">
                  <c:v>1.6014999999999999</c:v>
                </c:pt>
                <c:pt idx="6">
                  <c:v>1.0639000000000001</c:v>
                </c:pt>
                <c:pt idx="7">
                  <c:v>1.5142</c:v>
                </c:pt>
                <c:pt idx="8">
                  <c:v>1.4415</c:v>
                </c:pt>
                <c:pt idx="9">
                  <c:v>1.0116000000000001</c:v>
                </c:pt>
                <c:pt idx="10">
                  <c:v>0.59709999999999996</c:v>
                </c:pt>
                <c:pt idx="11">
                  <c:v>0.1628</c:v>
                </c:pt>
                <c:pt idx="12">
                  <c:v>0.2384</c:v>
                </c:pt>
                <c:pt idx="13">
                  <c:v>2.1299999999999999E-2</c:v>
                </c:pt>
                <c:pt idx="14">
                  <c:v>0.614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28</c:f>
              <c:numCache>
                <c:formatCode>General</c:formatCode>
                <c:ptCount val="300"/>
                <c:pt idx="0">
                  <c:v>-8.3236984376742704</c:v>
                </c:pt>
                <c:pt idx="1">
                  <c:v>-8.3206831572897997</c:v>
                </c:pt>
                <c:pt idx="2">
                  <c:v>-8.311638647599322</c:v>
                </c:pt>
                <c:pt idx="3">
                  <c:v>-8.2965689024037044</c:v>
                </c:pt>
                <c:pt idx="4">
                  <c:v>-8.2754805760781931</c:v>
                </c:pt>
                <c:pt idx="5">
                  <c:v>-8.2483829806340339</c:v>
                </c:pt>
                <c:pt idx="6">
                  <c:v>-8.2152880816065466</c:v>
                </c:pt>
                <c:pt idx="7">
                  <c:v>-8.1762104927714834</c:v>
                </c:pt>
                <c:pt idx="8">
                  <c:v>-8.1311674696919916</c:v>
                </c:pt>
                <c:pt idx="9">
                  <c:v>-8.0801789020990551</c:v>
                </c:pt>
                <c:pt idx="10">
                  <c:v>-8.02326730510873</c:v>
                </c:pt>
                <c:pt idx="11">
                  <c:v>-7.9604578092801255</c:v>
                </c:pt>
                <c:pt idx="12">
                  <c:v>-7.8917781495184389</c:v>
                </c:pt>
                <c:pt idx="13">
                  <c:v>-7.8172586528280075</c:v>
                </c:pt>
                <c:pt idx="14">
                  <c:v>-7.7369322249207624</c:v>
                </c:pt>
                <c:pt idx="15">
                  <c:v>-7.6508343356859836</c:v>
                </c:pt>
                <c:pt idx="16">
                  <c:v>-7.5590030035278062</c:v>
                </c:pt>
                <c:pt idx="17">
                  <c:v>-7.4614787785773533</c:v>
                </c:pt>
                <c:pt idx="18">
                  <c:v>-7.3583047247869402</c:v>
                </c:pt>
                <c:pt idx="19">
                  <c:v>-7.2495264009142577</c:v>
                </c:pt>
                <c:pt idx="20">
                  <c:v>-7.1351918404048895</c:v>
                </c:pt>
                <c:pt idx="21">
                  <c:v>-7.0153515301821088</c:v>
                </c:pt>
                <c:pt idx="22">
                  <c:v>-6.8900583883532676</c:v>
                </c:pt>
                <c:pt idx="23">
                  <c:v>-6.759367740842654</c:v>
                </c:pt>
                <c:pt idx="24">
                  <c:v>-6.6233372969611128</c:v>
                </c:pt>
                <c:pt idx="25">
                  <c:v>-6.482027123923249</c:v>
                </c:pt>
                <c:pt idx="26">
                  <c:v>-6.3354996203234322</c:v>
                </c:pt>
                <c:pt idx="27">
                  <c:v>-6.183819488582337</c:v>
                </c:pt>
                <c:pt idx="28">
                  <c:v>-6.0270537063761687</c:v>
                </c:pt>
                <c:pt idx="29">
                  <c:v>-5.8652714970612134</c:v>
                </c:pt>
                <c:pt idx="30">
                  <c:v>-5.6985442991067501</c:v>
                </c:pt>
                <c:pt idx="31">
                  <c:v>-5.5269457345498285</c:v>
                </c:pt>
                <c:pt idx="32">
                  <c:v>-5.3505515764858682</c:v>
                </c:pt>
                <c:pt idx="33">
                  <c:v>-5.1694397156093661</c:v>
                </c:pt>
                <c:pt idx="34">
                  <c:v>-4.9836901258195834</c:v>
                </c:pt>
                <c:pt idx="35">
                  <c:v>-4.7933848289062997</c:v>
                </c:pt>
                <c:pt idx="36">
                  <c:v>-4.5986078583313237</c:v>
                </c:pt>
                <c:pt idx="37">
                  <c:v>-4.3994452221216651</c:v>
                </c:pt>
                <c:pt idx="38">
                  <c:v>-4.195984864890816</c:v>
                </c:pt>
                <c:pt idx="39">
                  <c:v>-3.9883166290048884</c:v>
                </c:pt>
                <c:pt idx="40">
                  <c:v>-3.7765322149107483</c:v>
                </c:pt>
                <c:pt idx="41">
                  <c:v>-3.5607251406436866</c:v>
                </c:pt>
                <c:pt idx="42">
                  <c:v>-3.3409907005324833</c:v>
                </c:pt>
                <c:pt idx="43">
                  <c:v>-3.1174259231201109</c:v>
                </c:pt>
                <c:pt idx="44">
                  <c:v>-2.8901295283186723</c:v>
                </c:pt>
                <c:pt idx="45">
                  <c:v>-2.6592018838174587</c:v>
                </c:pt>
                <c:pt idx="46">
                  <c:v>-2.4247449607633991</c:v>
                </c:pt>
                <c:pt idx="47">
                  <c:v>-2.1868622887334848</c:v>
                </c:pt>
                <c:pt idx="48">
                  <c:v>-1.9456589100190129</c:v>
                </c:pt>
                <c:pt idx="49">
                  <c:v>-1.7012413332418719</c:v>
                </c:pt>
                <c:pt idx="50">
                  <c:v>-1.453717486323332</c:v>
                </c:pt>
                <c:pt idx="51">
                  <c:v>-1.2031966688261102</c:v>
                </c:pt>
                <c:pt idx="52">
                  <c:v>-0.94978950369076465</c:v>
                </c:pt>
                <c:pt idx="53">
                  <c:v>-0.69360788838771636</c:v>
                </c:pt>
                <c:pt idx="54">
                  <c:v>-0.43476494550648237</c:v>
                </c:pt>
                <c:pt idx="55">
                  <c:v>-0.17337497280390135</c:v>
                </c:pt>
                <c:pt idx="56">
                  <c:v>9.0446607266503776E-2</c:v>
                </c:pt>
                <c:pt idx="57">
                  <c:v>0.35658329852185577</c:v>
                </c:pt>
                <c:pt idx="58">
                  <c:v>0.62491758249134755</c:v>
                </c:pt>
                <c:pt idx="59">
                  <c:v>0.89533097030909747</c:v>
                </c:pt>
                <c:pt idx="60">
                  <c:v>1.167704055035494</c:v>
                </c:pt>
                <c:pt idx="61">
                  <c:v>1.4419165643839329</c:v>
                </c:pt>
                <c:pt idx="62">
                  <c:v>1.7178474138296895</c:v>
                </c:pt>
                <c:pt idx="63">
                  <c:v>1.9953747600774161</c:v>
                </c:pt>
                <c:pt idx="64">
                  <c:v>2.2743760548637235</c:v>
                </c:pt>
                <c:pt idx="65">
                  <c:v>2.554728099071041</c:v>
                </c:pt>
                <c:pt idx="66">
                  <c:v>2.8363070971288789</c:v>
                </c:pt>
                <c:pt idx="67">
                  <c:v>3.1189887116784663</c:v>
                </c:pt>
                <c:pt idx="68">
                  <c:v>3.4026481184766286</c:v>
                </c:pt>
                <c:pt idx="69">
                  <c:v>3.6871600615146676</c:v>
                </c:pt>
                <c:pt idx="70">
                  <c:v>3.9723989083278721</c:v>
                </c:pt>
                <c:pt idx="71">
                  <c:v>4.2582387054712916</c:v>
                </c:pt>
                <c:pt idx="72">
                  <c:v>4.5445532341372257</c:v>
                </c:pt>
                <c:pt idx="73">
                  <c:v>4.8312160658898993</c:v>
                </c:pt>
                <c:pt idx="74">
                  <c:v>5.1181006184926972</c:v>
                </c:pt>
                <c:pt idx="75">
                  <c:v>5.4050802118033179</c:v>
                </c:pt>
                <c:pt idx="76">
                  <c:v>5.6920281237121664</c:v>
                </c:pt>
                <c:pt idx="77">
                  <c:v>5.9788176460992535</c:v>
                </c:pt>
                <c:pt idx="78">
                  <c:v>6.2653221407849484</c:v>
                </c:pt>
                <c:pt idx="79">
                  <c:v>6.5514150954498289</c:v>
                </c:pt>
                <c:pt idx="80">
                  <c:v>6.8369701794989597</c:v>
                </c:pt>
                <c:pt idx="81">
                  <c:v>7.1218612998459285</c:v>
                </c:pt>
                <c:pt idx="82">
                  <c:v>7.405962656592</c:v>
                </c:pt>
                <c:pt idx="83">
                  <c:v>7.68914879857582</c:v>
                </c:pt>
                <c:pt idx="84">
                  <c:v>7.9712946787691017</c:v>
                </c:pt>
                <c:pt idx="85">
                  <c:v>8.2522757094938815</c:v>
                </c:pt>
                <c:pt idx="86">
                  <c:v>8.5319678174369304</c:v>
                </c:pt>
                <c:pt idx="87">
                  <c:v>8.810247498437036</c:v>
                </c:pt>
                <c:pt idx="88">
                  <c:v>9.0869918720209597</c:v>
                </c:pt>
                <c:pt idx="89">
                  <c:v>9.3620787356639958</c:v>
                </c:pt>
                <c:pt idx="90">
                  <c:v>9.6353866187511805</c:v>
                </c:pt>
                <c:pt idx="91">
                  <c:v>9.9067948362152656</c:v>
                </c:pt>
                <c:pt idx="92">
                  <c:v>10.176183541827875</c:v>
                </c:pt>
                <c:pt idx="93">
                  <c:v>10.443433781120209</c:v>
                </c:pt>
                <c:pt idx="94">
                  <c:v>10.708427543910002</c:v>
                </c:pt>
                <c:pt idx="95">
                  <c:v>10.971047816411481</c:v>
                </c:pt>
                <c:pt idx="96">
                  <c:v>11.231178632905372</c:v>
                </c:pt>
                <c:pt idx="97">
                  <c:v>11.488705126946096</c:v>
                </c:pt>
                <c:pt idx="98">
                  <c:v>11.743513582083548</c:v>
                </c:pt>
                <c:pt idx="99">
                  <c:v>11.995491482077092</c:v>
                </c:pt>
                <c:pt idx="100">
                  <c:v>12.244527560579559</c:v>
                </c:pt>
                <c:pt idx="101">
                  <c:v>12.49051185026933</c:v>
                </c:pt>
                <c:pt idx="102">
                  <c:v>12.733335731408822</c:v>
                </c:pt>
                <c:pt idx="103">
                  <c:v>12.972891979807894</c:v>
                </c:pt>
                <c:pt idx="104">
                  <c:v>13.209074814171037</c:v>
                </c:pt>
                <c:pt idx="105">
                  <c:v>13.441779942807415</c:v>
                </c:pt>
                <c:pt idx="106">
                  <c:v>13.670904609683134</c:v>
                </c:pt>
                <c:pt idx="107">
                  <c:v>13.896347639795428</c:v>
                </c:pt>
                <c:pt idx="108">
                  <c:v>14.118009483848683</c:v>
                </c:pt>
                <c:pt idx="109">
                  <c:v>14.335792262212598</c:v>
                </c:pt>
                <c:pt idx="110">
                  <c:v>14.549599808143082</c:v>
                </c:pt>
                <c:pt idx="111">
                  <c:v>14.759337710246781</c:v>
                </c:pt>
                <c:pt idx="112">
                  <c:v>14.96491335417049</c:v>
                </c:pt>
                <c:pt idx="113">
                  <c:v>15.166235963497041</c:v>
                </c:pt>
                <c:pt idx="114">
                  <c:v>15.363216639829616</c:v>
                </c:pt>
                <c:pt idx="115">
                  <c:v>15.555768402046786</c:v>
                </c:pt>
                <c:pt idx="116">
                  <c:v>15.743806224710902</c:v>
                </c:pt>
                <c:pt idx="117">
                  <c:v>15.927247075612961</c:v>
                </c:pt>
                <c:pt idx="118">
                  <c:v>16.106009952437276</c:v>
                </c:pt>
                <c:pt idx="119">
                  <c:v>16.280015918529813</c:v>
                </c:pt>
                <c:pt idx="120">
                  <c:v>16.449188137754426</c:v>
                </c:pt>
                <c:pt idx="121">
                  <c:v>16.613451908421482</c:v>
                </c:pt>
                <c:pt idx="122">
                  <c:v>16.772734696274085</c:v>
                </c:pt>
                <c:pt idx="123">
                  <c:v>16.926966166517104</c:v>
                </c:pt>
                <c:pt idx="124">
                  <c:v>17.076078214875075</c:v>
                </c:pt>
                <c:pt idx="125">
                  <c:v>17.220004997665121</c:v>
                </c:pt>
                <c:pt idx="126">
                  <c:v>17.358682960871661</c:v>
                </c:pt>
                <c:pt idx="127">
                  <c:v>17.492050868210089</c:v>
                </c:pt>
                <c:pt idx="128">
                  <c:v>17.620049828166984</c:v>
                </c:pt>
                <c:pt idx="129">
                  <c:v>17.742623320004949</c:v>
                </c:pt>
                <c:pt idx="130">
                  <c:v>17.859717218720569</c:v>
                </c:pt>
                <c:pt idx="131">
                  <c:v>17.971279818944502</c:v>
                </c:pt>
                <c:pt idx="132">
                  <c:v>18.077261857773109</c:v>
                </c:pt>
                <c:pt idx="133">
                  <c:v>18.177616536521548</c:v>
                </c:pt>
                <c:pt idx="134">
                  <c:v>18.27229954138879</c:v>
                </c:pt>
                <c:pt idx="135">
                  <c:v>18.361269063025325</c:v>
                </c:pt>
                <c:pt idx="136">
                  <c:v>18.44448581499498</c:v>
                </c:pt>
                <c:pt idx="137">
                  <c:v>18.521913051122745</c:v>
                </c:pt>
                <c:pt idx="138">
                  <c:v>18.593516581720806</c:v>
                </c:pt>
                <c:pt idx="139">
                  <c:v>18.659264788685775</c:v>
                </c:pt>
                <c:pt idx="140">
                  <c:v>18.719128639460344</c:v>
                </c:pt>
                <c:pt idx="141">
                  <c:v>18.773081699853243</c:v>
                </c:pt>
                <c:pt idx="142">
                  <c:v>18.821100145711846</c:v>
                </c:pt>
                <c:pt idx="143">
                  <c:v>18.863162773442234</c:v>
                </c:pt>
                <c:pt idx="144">
                  <c:v>18.899251009372115</c:v>
                </c:pt>
                <c:pt idx="145">
                  <c:v>18.929348917952431</c:v>
                </c:pt>
                <c:pt idx="146">
                  <c:v>18.953443208794035</c:v>
                </c:pt>
                <c:pt idx="147">
                  <c:v>18.971523242536382</c:v>
                </c:pt>
                <c:pt idx="148">
                  <c:v>18.983581035545541</c:v>
                </c:pt>
                <c:pt idx="149">
                  <c:v>18.989611263439556</c:v>
                </c:pt>
                <c:pt idx="150">
                  <c:v>18.989611263439556</c:v>
                </c:pt>
                <c:pt idx="151">
                  <c:v>18.983581035545534</c:v>
                </c:pt>
                <c:pt idx="152">
                  <c:v>18.971523242536371</c:v>
                </c:pt>
                <c:pt idx="153">
                  <c:v>18.95344320879402</c:v>
                </c:pt>
                <c:pt idx="154">
                  <c:v>18.92934891795241</c:v>
                </c:pt>
                <c:pt idx="155">
                  <c:v>18.899251009372094</c:v>
                </c:pt>
                <c:pt idx="156">
                  <c:v>18.863162773442205</c:v>
                </c:pt>
                <c:pt idx="157">
                  <c:v>18.82110014571181</c:v>
                </c:pt>
                <c:pt idx="158">
                  <c:v>18.773081699853208</c:v>
                </c:pt>
                <c:pt idx="159">
                  <c:v>18.719128639460301</c:v>
                </c:pt>
                <c:pt idx="160">
                  <c:v>18.659264788685732</c:v>
                </c:pt>
                <c:pt idx="161">
                  <c:v>18.593516581720756</c:v>
                </c:pt>
                <c:pt idx="162">
                  <c:v>18.521913051122691</c:v>
                </c:pt>
                <c:pt idx="163">
                  <c:v>18.444485814994923</c:v>
                </c:pt>
                <c:pt idx="164">
                  <c:v>18.361269063025262</c:v>
                </c:pt>
                <c:pt idx="165">
                  <c:v>18.272299541388726</c:v>
                </c:pt>
                <c:pt idx="166">
                  <c:v>18.17761653652148</c:v>
                </c:pt>
                <c:pt idx="167">
                  <c:v>18.077261857773035</c:v>
                </c:pt>
                <c:pt idx="168">
                  <c:v>17.971279818944428</c:v>
                </c:pt>
                <c:pt idx="169">
                  <c:v>17.85971721872049</c:v>
                </c:pt>
                <c:pt idx="170">
                  <c:v>17.742623320004867</c:v>
                </c:pt>
                <c:pt idx="171">
                  <c:v>17.620049828166898</c:v>
                </c:pt>
                <c:pt idx="172">
                  <c:v>17.492050868210001</c:v>
                </c:pt>
                <c:pt idx="173">
                  <c:v>17.358682960871565</c:v>
                </c:pt>
                <c:pt idx="174">
                  <c:v>17.220004997665022</c:v>
                </c:pt>
                <c:pt idx="175">
                  <c:v>17.076078214874975</c:v>
                </c:pt>
                <c:pt idx="176">
                  <c:v>16.926966166516998</c:v>
                </c:pt>
                <c:pt idx="177">
                  <c:v>16.772734696273975</c:v>
                </c:pt>
                <c:pt idx="178">
                  <c:v>16.613451908421375</c:v>
                </c:pt>
                <c:pt idx="179">
                  <c:v>16.449188137754305</c:v>
                </c:pt>
                <c:pt idx="180">
                  <c:v>16.280015918529692</c:v>
                </c:pt>
                <c:pt idx="181">
                  <c:v>16.106009952437148</c:v>
                </c:pt>
                <c:pt idx="182">
                  <c:v>15.927247075612835</c:v>
                </c:pt>
                <c:pt idx="183">
                  <c:v>15.743806224710774</c:v>
                </c:pt>
                <c:pt idx="184">
                  <c:v>15.555768402046652</c:v>
                </c:pt>
                <c:pt idx="185">
                  <c:v>15.363216639829481</c:v>
                </c:pt>
                <c:pt idx="186">
                  <c:v>15.1662359634969</c:v>
                </c:pt>
                <c:pt idx="187">
                  <c:v>14.964913354170349</c:v>
                </c:pt>
                <c:pt idx="188">
                  <c:v>14.759337710246637</c:v>
                </c:pt>
                <c:pt idx="189">
                  <c:v>14.549599808142935</c:v>
                </c:pt>
                <c:pt idx="190">
                  <c:v>14.335792262212447</c:v>
                </c:pt>
                <c:pt idx="191">
                  <c:v>14.118009483848535</c:v>
                </c:pt>
                <c:pt idx="192">
                  <c:v>13.896347639795277</c:v>
                </c:pt>
                <c:pt idx="193">
                  <c:v>13.670904609682978</c:v>
                </c:pt>
                <c:pt idx="194">
                  <c:v>13.441779942807253</c:v>
                </c:pt>
                <c:pt idx="195">
                  <c:v>13.209074814170872</c:v>
                </c:pt>
                <c:pt idx="196">
                  <c:v>12.972891979807729</c:v>
                </c:pt>
                <c:pt idx="197">
                  <c:v>12.733335731408655</c:v>
                </c:pt>
                <c:pt idx="198">
                  <c:v>12.490511850269161</c:v>
                </c:pt>
                <c:pt idx="199">
                  <c:v>12.244527560579385</c:v>
                </c:pt>
                <c:pt idx="200">
                  <c:v>11.995491482076918</c:v>
                </c:pt>
                <c:pt idx="201">
                  <c:v>11.743513582083372</c:v>
                </c:pt>
                <c:pt idx="202">
                  <c:v>11.488705126945916</c:v>
                </c:pt>
                <c:pt idx="203">
                  <c:v>11.231178632905191</c:v>
                </c:pt>
                <c:pt idx="204">
                  <c:v>10.971047816411296</c:v>
                </c:pt>
                <c:pt idx="205">
                  <c:v>10.708427543909815</c:v>
                </c:pt>
                <c:pt idx="206">
                  <c:v>10.443433781120021</c:v>
                </c:pt>
                <c:pt idx="207">
                  <c:v>10.176183541827683</c:v>
                </c:pt>
                <c:pt idx="208">
                  <c:v>9.9067948362150737</c:v>
                </c:pt>
                <c:pt idx="209">
                  <c:v>9.6353866187509851</c:v>
                </c:pt>
                <c:pt idx="210">
                  <c:v>9.3620787356638022</c:v>
                </c:pt>
                <c:pt idx="211">
                  <c:v>9.0869918720207608</c:v>
                </c:pt>
                <c:pt idx="212">
                  <c:v>8.8102474984368353</c:v>
                </c:pt>
                <c:pt idx="213">
                  <c:v>8.5319678174367297</c:v>
                </c:pt>
                <c:pt idx="214">
                  <c:v>8.2522757094936914</c:v>
                </c:pt>
                <c:pt idx="215">
                  <c:v>7.9712946787689107</c:v>
                </c:pt>
                <c:pt idx="216">
                  <c:v>7.6891487985756291</c:v>
                </c:pt>
                <c:pt idx="217">
                  <c:v>7.4059626565918082</c:v>
                </c:pt>
                <c:pt idx="218">
                  <c:v>7.1218612998457331</c:v>
                </c:pt>
                <c:pt idx="219">
                  <c:v>6.8369701794987634</c:v>
                </c:pt>
                <c:pt idx="220">
                  <c:v>6.5514150954496326</c:v>
                </c:pt>
                <c:pt idx="221">
                  <c:v>6.2653221407847521</c:v>
                </c:pt>
                <c:pt idx="222">
                  <c:v>5.9788176460990563</c:v>
                </c:pt>
                <c:pt idx="223">
                  <c:v>5.6920281237119692</c:v>
                </c:pt>
                <c:pt idx="224">
                  <c:v>5.4050802118031207</c:v>
                </c:pt>
                <c:pt idx="225">
                  <c:v>5.1181006184924973</c:v>
                </c:pt>
                <c:pt idx="226">
                  <c:v>4.8312160658896994</c:v>
                </c:pt>
                <c:pt idx="227">
                  <c:v>4.5445532341370258</c:v>
                </c:pt>
                <c:pt idx="228">
                  <c:v>4.2582387054710917</c:v>
                </c:pt>
                <c:pt idx="229">
                  <c:v>3.9723989083276732</c:v>
                </c:pt>
                <c:pt idx="230">
                  <c:v>3.6871600615144686</c:v>
                </c:pt>
                <c:pt idx="231">
                  <c:v>3.4026481184764306</c:v>
                </c:pt>
                <c:pt idx="232">
                  <c:v>3.118988711678266</c:v>
                </c:pt>
                <c:pt idx="233">
                  <c:v>2.836307097128679</c:v>
                </c:pt>
                <c:pt idx="234">
                  <c:v>2.5547280990708421</c:v>
                </c:pt>
                <c:pt idx="235">
                  <c:v>2.2743760548635255</c:v>
                </c:pt>
                <c:pt idx="236">
                  <c:v>1.9953747600772194</c:v>
                </c:pt>
                <c:pt idx="237">
                  <c:v>1.7178474138294937</c:v>
                </c:pt>
                <c:pt idx="238">
                  <c:v>1.4419165643837384</c:v>
                </c:pt>
                <c:pt idx="239">
                  <c:v>1.1677040550352977</c:v>
                </c:pt>
                <c:pt idx="240">
                  <c:v>0.89533097030890296</c:v>
                </c:pt>
                <c:pt idx="241">
                  <c:v>0.62491758249115392</c:v>
                </c:pt>
                <c:pt idx="242">
                  <c:v>0.35658329852167459</c:v>
                </c:pt>
                <c:pt idx="243">
                  <c:v>9.0446607266325252E-2</c:v>
                </c:pt>
                <c:pt idx="244">
                  <c:v>-0.17337497280407899</c:v>
                </c:pt>
                <c:pt idx="245">
                  <c:v>-0.43476494550665823</c:v>
                </c:pt>
                <c:pt idx="246">
                  <c:v>-0.69360788838789578</c:v>
                </c:pt>
                <c:pt idx="247">
                  <c:v>-0.94978950369094228</c:v>
                </c:pt>
                <c:pt idx="248">
                  <c:v>-1.2031966688262861</c:v>
                </c:pt>
                <c:pt idx="249">
                  <c:v>-1.4537174863235061</c:v>
                </c:pt>
                <c:pt idx="250">
                  <c:v>-1.7012413332420451</c:v>
                </c:pt>
                <c:pt idx="251">
                  <c:v>-1.9456589100191835</c:v>
                </c:pt>
                <c:pt idx="252">
                  <c:v>-2.1868622887336517</c:v>
                </c:pt>
                <c:pt idx="253">
                  <c:v>-2.4247449607635625</c:v>
                </c:pt>
                <c:pt idx="254">
                  <c:v>-2.6592018838176203</c:v>
                </c:pt>
                <c:pt idx="255">
                  <c:v>-2.890129528318834</c:v>
                </c:pt>
                <c:pt idx="256">
                  <c:v>-3.117425923120269</c:v>
                </c:pt>
                <c:pt idx="257">
                  <c:v>-3.3409907005326378</c:v>
                </c:pt>
                <c:pt idx="258">
                  <c:v>-3.5607251406438376</c:v>
                </c:pt>
                <c:pt idx="259">
                  <c:v>-3.7765322149108975</c:v>
                </c:pt>
                <c:pt idx="260">
                  <c:v>-3.988316629005034</c:v>
                </c:pt>
                <c:pt idx="261">
                  <c:v>-4.1959848648909599</c:v>
                </c:pt>
                <c:pt idx="262">
                  <c:v>-4.3994452221218054</c:v>
                </c:pt>
                <c:pt idx="263">
                  <c:v>-4.5986078583314605</c:v>
                </c:pt>
                <c:pt idx="264">
                  <c:v>-4.7933848289064347</c:v>
                </c:pt>
                <c:pt idx="265">
                  <c:v>-4.9836901258197148</c:v>
                </c:pt>
                <c:pt idx="266">
                  <c:v>-5.1694397156094976</c:v>
                </c:pt>
                <c:pt idx="267">
                  <c:v>-5.3505515764859961</c:v>
                </c:pt>
                <c:pt idx="268">
                  <c:v>-5.5269457345499546</c:v>
                </c:pt>
                <c:pt idx="269">
                  <c:v>-5.6985442991068709</c:v>
                </c:pt>
                <c:pt idx="270">
                  <c:v>-5.8652714970613307</c:v>
                </c:pt>
                <c:pt idx="271">
                  <c:v>-6.027053706376277</c:v>
                </c:pt>
                <c:pt idx="272">
                  <c:v>-6.18381948858244</c:v>
                </c:pt>
                <c:pt idx="273">
                  <c:v>-6.3354996203235334</c:v>
                </c:pt>
                <c:pt idx="274">
                  <c:v>-6.4820271239233449</c:v>
                </c:pt>
                <c:pt idx="275">
                  <c:v>-6.623337296961207</c:v>
                </c:pt>
                <c:pt idx="276">
                  <c:v>-6.7593677408427446</c:v>
                </c:pt>
                <c:pt idx="277">
                  <c:v>-6.8900583883533582</c:v>
                </c:pt>
                <c:pt idx="278">
                  <c:v>-7.0153515301821958</c:v>
                </c:pt>
                <c:pt idx="279">
                  <c:v>-7.135191840404973</c:v>
                </c:pt>
                <c:pt idx="280">
                  <c:v>-7.2495264009143359</c:v>
                </c:pt>
                <c:pt idx="281">
                  <c:v>-7.3583047247870148</c:v>
                </c:pt>
                <c:pt idx="282">
                  <c:v>-7.4614787785774226</c:v>
                </c:pt>
                <c:pt idx="283">
                  <c:v>-7.5590030035278737</c:v>
                </c:pt>
                <c:pt idx="284">
                  <c:v>-7.6508343356860458</c:v>
                </c:pt>
                <c:pt idx="285">
                  <c:v>-7.7369322249208192</c:v>
                </c:pt>
                <c:pt idx="286">
                  <c:v>-7.8172586528280608</c:v>
                </c:pt>
                <c:pt idx="287">
                  <c:v>-7.8917781495184887</c:v>
                </c:pt>
                <c:pt idx="288">
                  <c:v>-7.9604578092801717</c:v>
                </c:pt>
                <c:pt idx="289">
                  <c:v>-8.0232673051087726</c:v>
                </c:pt>
                <c:pt idx="290">
                  <c:v>-8.0801789020990924</c:v>
                </c:pt>
                <c:pt idx="291">
                  <c:v>-8.1311674696920253</c:v>
                </c:pt>
                <c:pt idx="292">
                  <c:v>-8.1762104927715118</c:v>
                </c:pt>
                <c:pt idx="293">
                  <c:v>-8.2152880816065732</c:v>
                </c:pt>
                <c:pt idx="294">
                  <c:v>-8.2483829806340552</c:v>
                </c:pt>
                <c:pt idx="295">
                  <c:v>-8.2754805760782091</c:v>
                </c:pt>
                <c:pt idx="296">
                  <c:v>-8.2965689024037168</c:v>
                </c:pt>
                <c:pt idx="297">
                  <c:v>-8.3116386475993291</c:v>
                </c:pt>
                <c:pt idx="298">
                  <c:v>-8.320683157289805</c:v>
                </c:pt>
                <c:pt idx="299">
                  <c:v>-8.3236984376742704</c:v>
                </c:pt>
              </c:numCache>
            </c:numRef>
          </c:xVal>
          <c:yVal>
            <c:numRef>
              <c:f>'Covariance   Correlation3'!yycir29</c:f>
              <c:numCache>
                <c:formatCode>General</c:formatCode>
                <c:ptCount val="300"/>
                <c:pt idx="0">
                  <c:v>-0.4531618579445269</c:v>
                </c:pt>
                <c:pt idx="1">
                  <c:v>-0.47820720426509633</c:v>
                </c:pt>
                <c:pt idx="2">
                  <c:v>-0.502758328415982</c:v>
                </c:pt>
                <c:pt idx="3">
                  <c:v>-0.52680438931190066</c:v>
                </c:pt>
                <c:pt idx="4">
                  <c:v>-0.55033476888928534</c:v>
                </c:pt>
                <c:pt idx="5">
                  <c:v>-0.57333907679492202</c:v>
                </c:pt>
                <c:pt idx="6">
                  <c:v>-0.59580715497403669</c:v>
                </c:pt>
                <c:pt idx="7">
                  <c:v>-0.61772908215580768</c:v>
                </c:pt>
                <c:pt idx="8">
                  <c:v>-0.63909517823432005</c:v>
                </c:pt>
                <c:pt idx="9">
                  <c:v>-0.65989600854302477</c:v>
                </c:pt>
                <c:pt idx="10">
                  <c:v>-0.68012238802082492</c:v>
                </c:pt>
                <c:pt idx="11">
                  <c:v>-0.69976538526793908</c:v>
                </c:pt>
                <c:pt idx="12">
                  <c:v>-0.71881632648975569</c:v>
                </c:pt>
                <c:pt idx="13">
                  <c:v>-0.73726679932693706</c:v>
                </c:pt>
                <c:pt idx="14">
                  <c:v>-0.75510865657008064</c:v>
                </c:pt>
                <c:pt idx="15">
                  <c:v>-0.77233401975729621</c:v>
                </c:pt>
                <c:pt idx="16">
                  <c:v>-0.78893528265311419</c:v>
                </c:pt>
                <c:pt idx="17">
                  <c:v>-0.80490511460718439</c:v>
                </c:pt>
                <c:pt idx="18">
                  <c:v>-0.82023646379128523</c:v>
                </c:pt>
                <c:pt idx="19">
                  <c:v>-0.83492256031321188</c:v>
                </c:pt>
                <c:pt idx="20">
                  <c:v>-0.848956919206171</c:v>
                </c:pt>
                <c:pt idx="21">
                  <c:v>-0.86233334329235856</c:v>
                </c:pt>
                <c:pt idx="22">
                  <c:v>-0.87504592591945973</c:v>
                </c:pt>
                <c:pt idx="23">
                  <c:v>-0.88708905356886025</c:v>
                </c:pt>
                <c:pt idx="24">
                  <c:v>-0.89845740833441834</c:v>
                </c:pt>
                <c:pt idx="25">
                  <c:v>-0.90914597027070143</c:v>
                </c:pt>
                <c:pt idx="26">
                  <c:v>-0.91915001960965392</c:v>
                </c:pt>
                <c:pt idx="27">
                  <c:v>-0.92846513884471316</c:v>
                </c:pt>
                <c:pt idx="28">
                  <c:v>-0.93708721468145617</c:v>
                </c:pt>
                <c:pt idx="29">
                  <c:v>-0.94501243985391492</c:v>
                </c:pt>
                <c:pt idx="30">
                  <c:v>-0.95223731480575746</c:v>
                </c:pt>
                <c:pt idx="31">
                  <c:v>-0.9587586492355934</c:v>
                </c:pt>
                <c:pt idx="32">
                  <c:v>-0.96457356350572176</c:v>
                </c:pt>
                <c:pt idx="33">
                  <c:v>-0.96967948991369735</c:v>
                </c:pt>
                <c:pt idx="34">
                  <c:v>-0.97407417382615602</c:v>
                </c:pt>
                <c:pt idx="35">
                  <c:v>-0.9777556746743975</c:v>
                </c:pt>
                <c:pt idx="36">
                  <c:v>-0.98072236681128577</c:v>
                </c:pt>
                <c:pt idx="37">
                  <c:v>-0.98297294022908865</c:v>
                </c:pt>
                <c:pt idx="38">
                  <c:v>-0.98450640113794141</c:v>
                </c:pt>
                <c:pt idx="39">
                  <c:v>-0.98532207240467529</c:v>
                </c:pt>
                <c:pt idx="40">
                  <c:v>-0.9854195938518211</c:v>
                </c:pt>
                <c:pt idx="41">
                  <c:v>-0.98479892241665268</c:v>
                </c:pt>
                <c:pt idx="42">
                  <c:v>-0.98346033217020368</c:v>
                </c:pt>
                <c:pt idx="43">
                  <c:v>-0.9814044141962438</c:v>
                </c:pt>
                <c:pt idx="44">
                  <c:v>-0.97863207633027394</c:v>
                </c:pt>
                <c:pt idx="45">
                  <c:v>-0.97514454275865137</c:v>
                </c:pt>
                <c:pt idx="46">
                  <c:v>-0.97094335347802296</c:v>
                </c:pt>
                <c:pt idx="47">
                  <c:v>-0.96603036361530703</c:v>
                </c:pt>
                <c:pt idx="48">
                  <c:v>-0.96040774260852035</c:v>
                </c:pt>
                <c:pt idx="49">
                  <c:v>-0.95407797324881638</c:v>
                </c:pt>
                <c:pt idx="50">
                  <c:v>-0.94704385058415441</c:v>
                </c:pt>
                <c:pt idx="51">
                  <c:v>-0.9393084806850841</c:v>
                </c:pt>
                <c:pt idx="52">
                  <c:v>-0.93087527927319336</c:v>
                </c:pt>
                <c:pt idx="53">
                  <c:v>-0.92174797021282151</c:v>
                </c:pt>
                <c:pt idx="54">
                  <c:v>-0.91193058386670578</c:v>
                </c:pt>
                <c:pt idx="55">
                  <c:v>-0.9014274553162851</c:v>
                </c:pt>
                <c:pt idx="56">
                  <c:v>-0.89024322244745258</c:v>
                </c:pt>
                <c:pt idx="57">
                  <c:v>-0.87838282390259392</c:v>
                </c:pt>
                <c:pt idx="58">
                  <c:v>-0.86585149689982299</c:v>
                </c:pt>
                <c:pt idx="59">
                  <c:v>-0.852654774920373</c:v>
                </c:pt>
                <c:pt idx="60">
                  <c:v>-0.83879848526516676</c:v>
                </c:pt>
                <c:pt idx="61">
                  <c:v>-0.82428874648164596</c:v>
                </c:pt>
                <c:pt idx="62">
                  <c:v>-0.80913196566199108</c:v>
                </c:pt>
                <c:pt idx="63">
                  <c:v>-0.79333483561393203</c:v>
                </c:pt>
                <c:pt idx="64">
                  <c:v>-0.7769043319053901</c:v>
                </c:pt>
                <c:pt idx="65">
                  <c:v>-0.7598477097842653</c:v>
                </c:pt>
                <c:pt idx="66">
                  <c:v>-0.74217250097472331</c:v>
                </c:pt>
                <c:pt idx="67">
                  <c:v>-0.72388651035139684</c:v>
                </c:pt>
                <c:pt idx="68">
                  <c:v>-0.70499781249297355</c:v>
                </c:pt>
                <c:pt idx="69">
                  <c:v>-0.68551474811668878</c:v>
                </c:pt>
                <c:pt idx="70">
                  <c:v>-0.66544592039530048</c:v>
                </c:pt>
                <c:pt idx="71">
                  <c:v>-0.64480019115817044</c:v>
                </c:pt>
                <c:pt idx="72">
                  <c:v>-0.62358667697812831</c:v>
                </c:pt>
                <c:pt idx="73">
                  <c:v>-0.6018147451458512</c:v>
                </c:pt>
                <c:pt idx="74">
                  <c:v>-0.5794940095335317</c:v>
                </c:pt>
                <c:pt idx="75">
                  <c:v>-0.55663432634966159</c:v>
                </c:pt>
                <c:pt idx="76">
                  <c:v>-0.53324578978680848</c:v>
                </c:pt>
                <c:pt idx="77">
                  <c:v>-0.50933872756430432</c:v>
                </c:pt>
                <c:pt idx="78">
                  <c:v>-0.4849236963678154</c:v>
                </c:pt>
                <c:pt idx="79">
                  <c:v>-0.46001147718780688</c:v>
                </c:pt>
                <c:pt idx="80">
                  <c:v>-0.43461307055896131</c:v>
                </c:pt>
                <c:pt idx="81">
                  <c:v>-0.40873969170265112</c:v>
                </c:pt>
                <c:pt idx="82">
                  <c:v>-0.38240276557461461</c:v>
                </c:pt>
                <c:pt idx="83">
                  <c:v>-0.35561392182001439</c:v>
                </c:pt>
                <c:pt idx="84">
                  <c:v>-0.32838498963811624</c:v>
                </c:pt>
                <c:pt idx="85">
                  <c:v>-0.30072799255884608</c:v>
                </c:pt>
                <c:pt idx="86">
                  <c:v>-0.27265514313353761</c:v>
                </c:pt>
                <c:pt idx="87">
                  <c:v>-0.24417883754221392</c:v>
                </c:pt>
                <c:pt idx="88">
                  <c:v>-0.21531165011978376</c:v>
                </c:pt>
                <c:pt idx="89">
                  <c:v>-0.18606632780356858</c:v>
                </c:pt>
                <c:pt idx="90">
                  <c:v>-0.15645578450461328</c:v>
                </c:pt>
                <c:pt idx="91">
                  <c:v>-0.12649309540526793</c:v>
                </c:pt>
                <c:pt idx="92">
                  <c:v>-9.6191491185554701E-2</c:v>
                </c:pt>
                <c:pt idx="93">
                  <c:v>-6.5564352180872199E-2</c:v>
                </c:pt>
                <c:pt idx="94">
                  <c:v>-3.4625202473615724E-2</c:v>
                </c:pt>
                <c:pt idx="95">
                  <c:v>-3.3877039213234261E-3</c:v>
                </c:pt>
                <c:pt idx="96">
                  <c:v>2.813434987601543E-2</c:v>
                </c:pt>
                <c:pt idx="97">
                  <c:v>5.9927039666826276E-2</c:v>
                </c:pt>
                <c:pt idx="98">
                  <c:v>9.1976326694298116E-2</c:v>
                </c:pt>
                <c:pt idx="99">
                  <c:v>0.12426805889550374</c:v>
                </c:pt>
                <c:pt idx="100">
                  <c:v>0.15678797715055259</c:v>
                </c:pt>
                <c:pt idx="101">
                  <c:v>0.18952172157901626</c:v>
                </c:pt>
                <c:pt idx="102">
                  <c:v>0.22245483788084774</c:v>
                </c:pt>
                <c:pt idx="103">
                  <c:v>0.25557278371899295</c:v>
                </c:pt>
                <c:pt idx="104">
                  <c:v>0.28886093514087818</c:v>
                </c:pt>
                <c:pt idx="105">
                  <c:v>0.3223045930359355</c:v>
                </c:pt>
                <c:pt idx="106">
                  <c:v>0.35588898962631521</c:v>
                </c:pt>
                <c:pt idx="107">
                  <c:v>0.38959929498792223</c:v>
                </c:pt>
                <c:pt idx="108">
                  <c:v>0.42342062359889376</c:v>
                </c:pt>
                <c:pt idx="109">
                  <c:v>0.45733804091262398</c:v>
                </c:pt>
                <c:pt idx="110">
                  <c:v>0.49133656995244124</c:v>
                </c:pt>
                <c:pt idx="111">
                  <c:v>0.52540119792501916</c:v>
                </c:pt>
                <c:pt idx="112">
                  <c:v>0.55951688284960377</c:v>
                </c:pt>
                <c:pt idx="113">
                  <c:v>0.59366856020012782</c:v>
                </c:pt>
                <c:pt idx="114">
                  <c:v>0.62784114955728254</c:v>
                </c:pt>
                <c:pt idx="115">
                  <c:v>0.66201956126760508</c:v>
                </c:pt>
                <c:pt idx="116">
                  <c:v>0.69618870310664616</c:v>
                </c:pt>
                <c:pt idx="117">
                  <c:v>0.73033348694326983</c:v>
                </c:pt>
                <c:pt idx="118">
                  <c:v>0.76443883540214919</c:v>
                </c:pt>
                <c:pt idx="119">
                  <c:v>0.79848968852150926</c:v>
                </c:pt>
                <c:pt idx="120">
                  <c:v>0.83247101040318316</c:v>
                </c:pt>
                <c:pt idx="121">
                  <c:v>0.86636779585204049</c:v>
                </c:pt>
                <c:pt idx="122">
                  <c:v>0.90016507700186221</c:v>
                </c:pt>
                <c:pt idx="123">
                  <c:v>0.93384792992472365</c:v>
                </c:pt>
                <c:pt idx="124">
                  <c:v>0.96740148122098546</c:v>
                </c:pt>
                <c:pt idx="125">
                  <c:v>1.0008109145869661</c:v>
                </c:pt>
                <c:pt idx="126">
                  <c:v>1.0340614773574051</c:v>
                </c:pt>
                <c:pt idx="127">
                  <c:v>1.0671384870198246</c:v>
                </c:pt>
                <c:pt idx="128">
                  <c:v>1.1000273376979135</c:v>
                </c:pt>
                <c:pt idx="129">
                  <c:v>1.1327135066010712</c:v>
                </c:pt>
                <c:pt idx="130">
                  <c:v>1.1651825604372636</c:v>
                </c:pt>
                <c:pt idx="131">
                  <c:v>1.1974201617863574</c:v>
                </c:pt>
                <c:pt idx="132">
                  <c:v>1.2294120754311226</c:v>
                </c:pt>
                <c:pt idx="133">
                  <c:v>1.2611441746431027</c:v>
                </c:pt>
                <c:pt idx="134">
                  <c:v>1.2926024474205806</c:v>
                </c:pt>
                <c:pt idx="135">
                  <c:v>1.3237730026758849</c:v>
                </c:pt>
                <c:pt idx="136">
                  <c:v>1.3546420763693003</c:v>
                </c:pt>
                <c:pt idx="137">
                  <c:v>1.3851960375868857</c:v>
                </c:pt>
                <c:pt idx="138">
                  <c:v>1.4154213945594953</c:v>
                </c:pt>
                <c:pt idx="139">
                  <c:v>1.4453048006203688</c:v>
                </c:pt>
                <c:pt idx="140">
                  <c:v>1.4748330600986421</c:v>
                </c:pt>
                <c:pt idx="141">
                  <c:v>1.5039931341461839</c:v>
                </c:pt>
                <c:pt idx="142">
                  <c:v>1.5327721464951842</c:v>
                </c:pt>
                <c:pt idx="143">
                  <c:v>1.5611573891439523</c:v>
                </c:pt>
                <c:pt idx="144">
                  <c:v>1.5891363279684112</c:v>
                </c:pt>
                <c:pt idx="145">
                  <c:v>1.6166966082568157</c:v>
                </c:pt>
                <c:pt idx="146">
                  <c:v>1.6438260601652441</c:v>
                </c:pt>
                <c:pt idx="147">
                  <c:v>1.6705127040914585</c:v>
                </c:pt>
                <c:pt idx="148">
                  <c:v>1.6967447559647613</c:v>
                </c:pt>
                <c:pt idx="149">
                  <c:v>1.7225106324495068</c:v>
                </c:pt>
                <c:pt idx="150">
                  <c:v>1.7477989560599785</c:v>
                </c:pt>
                <c:pt idx="151">
                  <c:v>1.7725985601843663</c:v>
                </c:pt>
                <c:pt idx="152">
                  <c:v>1.7968984940156258</c:v>
                </c:pt>
                <c:pt idx="153">
                  <c:v>1.8206880273870478</c:v>
                </c:pt>
                <c:pt idx="154">
                  <c:v>1.8439566555103988</c:v>
                </c:pt>
                <c:pt idx="155">
                  <c:v>1.8666941036145375</c:v>
                </c:pt>
                <c:pt idx="156">
                  <c:v>1.8888903314824668</c:v>
                </c:pt>
                <c:pt idx="157">
                  <c:v>1.910535537884809</c:v>
                </c:pt>
                <c:pt idx="158">
                  <c:v>1.9316201649077551</c:v>
                </c:pt>
                <c:pt idx="159">
                  <c:v>1.9521349021735679</c:v>
                </c:pt>
                <c:pt idx="160">
                  <c:v>1.9720706909517838</c:v>
                </c:pt>
                <c:pt idx="161">
                  <c:v>1.9914187281592941</c:v>
                </c:pt>
                <c:pt idx="162">
                  <c:v>2.0101704702475374</c:v>
                </c:pt>
                <c:pt idx="163">
                  <c:v>2.0283176369750908</c:v>
                </c:pt>
                <c:pt idx="164">
                  <c:v>2.0458522150639906</c:v>
                </c:pt>
                <c:pt idx="165">
                  <c:v>2.0627664617381711</c:v>
                </c:pt>
                <c:pt idx="166">
                  <c:v>2.0790529081424576</c:v>
                </c:pt>
                <c:pt idx="167">
                  <c:v>2.094704362640599</c:v>
                </c:pt>
                <c:pt idx="168">
                  <c:v>2.109713913990896</c:v>
                </c:pt>
                <c:pt idx="169">
                  <c:v>2.1240749343980081</c:v>
                </c:pt>
                <c:pt idx="170">
                  <c:v>2.1377810824396026</c:v>
                </c:pt>
                <c:pt idx="171">
                  <c:v>2.1508263058665484</c:v>
                </c:pt>
                <c:pt idx="172">
                  <c:v>2.1632048442754184</c:v>
                </c:pt>
                <c:pt idx="173">
                  <c:v>2.1749112316521209</c:v>
                </c:pt>
                <c:pt idx="174">
                  <c:v>2.185940298785539</c:v>
                </c:pt>
                <c:pt idx="175">
                  <c:v>2.1962871755501068</c:v>
                </c:pt>
                <c:pt idx="176">
                  <c:v>2.2059472930563224</c:v>
                </c:pt>
                <c:pt idx="177">
                  <c:v>2.2149163856682379</c:v>
                </c:pt>
                <c:pt idx="178">
                  <c:v>2.2231904928870461</c:v>
                </c:pt>
                <c:pt idx="179">
                  <c:v>2.2307659610999249</c:v>
                </c:pt>
                <c:pt idx="180">
                  <c:v>2.2376394451933703</c:v>
                </c:pt>
                <c:pt idx="181">
                  <c:v>2.2438079100303021</c:v>
                </c:pt>
                <c:pt idx="182">
                  <c:v>2.2492686317902986</c:v>
                </c:pt>
                <c:pt idx="183">
                  <c:v>2.2540191991723555</c:v>
                </c:pt>
                <c:pt idx="184">
                  <c:v>2.2580575144596509</c:v>
                </c:pt>
                <c:pt idx="185">
                  <c:v>2.2613817944458372</c:v>
                </c:pt>
                <c:pt idx="186">
                  <c:v>2.2639905712224548</c:v>
                </c:pt>
                <c:pt idx="187">
                  <c:v>2.2658826928271196</c:v>
                </c:pt>
                <c:pt idx="188">
                  <c:v>2.267057323752196</c:v>
                </c:pt>
                <c:pt idx="189">
                  <c:v>2.2675139453137345</c:v>
                </c:pt>
                <c:pt idx="190">
                  <c:v>2.2672523558805082</c:v>
                </c:pt>
                <c:pt idx="191">
                  <c:v>2.2662726709630467</c:v>
                </c:pt>
                <c:pt idx="192">
                  <c:v>2.2645753231626307</c:v>
                </c:pt>
                <c:pt idx="193">
                  <c:v>2.2621610619802661</c:v>
                </c:pt>
                <c:pt idx="194">
                  <c:v>2.2590309534857269</c:v>
                </c:pt>
                <c:pt idx="195">
                  <c:v>2.2551863798468084</c:v>
                </c:pt>
                <c:pt idx="196">
                  <c:v>2.2506290387189996</c:v>
                </c:pt>
                <c:pt idx="197">
                  <c:v>2.2453609424958492</c:v>
                </c:pt>
                <c:pt idx="198">
                  <c:v>2.2393844174203457</c:v>
                </c:pt>
                <c:pt idx="199">
                  <c:v>2.2327021025577167</c:v>
                </c:pt>
                <c:pt idx="200">
                  <c:v>2.2253169486300903</c:v>
                </c:pt>
                <c:pt idx="201">
                  <c:v>2.217232216713541</c:v>
                </c:pt>
                <c:pt idx="202">
                  <c:v>2.2084514767980883</c:v>
                </c:pt>
                <c:pt idx="203">
                  <c:v>2.1989786062112908</c:v>
                </c:pt>
                <c:pt idx="204">
                  <c:v>2.1888177879061272</c:v>
                </c:pt>
                <c:pt idx="205">
                  <c:v>2.1779735086139231</c:v>
                </c:pt>
                <c:pt idx="206">
                  <c:v>2.1664505568631349</c:v>
                </c:pt>
                <c:pt idx="207">
                  <c:v>2.1542540208648711</c:v>
                </c:pt>
                <c:pt idx="208">
                  <c:v>2.1413892862660817</c:v>
                </c:pt>
                <c:pt idx="209">
                  <c:v>2.1278620337714091</c:v>
                </c:pt>
                <c:pt idx="210">
                  <c:v>2.1136782366347471</c:v>
                </c:pt>
                <c:pt idx="211">
                  <c:v>2.0988441580216213</c:v>
                </c:pt>
                <c:pt idx="212">
                  <c:v>2.0833663482435498</c:v>
                </c:pt>
                <c:pt idx="213">
                  <c:v>2.0672516418656137</c:v>
                </c:pt>
                <c:pt idx="214">
                  <c:v>2.0505071546885021</c:v>
                </c:pt>
                <c:pt idx="215">
                  <c:v>2.0331402806063745</c:v>
                </c:pt>
                <c:pt idx="216">
                  <c:v>2.0151586883419292</c:v>
                </c:pt>
                <c:pt idx="217">
                  <c:v>1.9965703180601073</c:v>
                </c:pt>
                <c:pt idx="218">
                  <c:v>1.9773833778619412</c:v>
                </c:pt>
                <c:pt idx="219">
                  <c:v>1.9576063401600883</c:v>
                </c:pt>
                <c:pt idx="220">
                  <c:v>1.937247937937651</c:v>
                </c:pt>
                <c:pt idx="221">
                  <c:v>1.9163171608919394</c:v>
                </c:pt>
                <c:pt idx="222">
                  <c:v>1.89482325146487</c:v>
                </c:pt>
                <c:pt idx="223">
                  <c:v>1.872775700761768</c:v>
                </c:pt>
                <c:pt idx="224">
                  <c:v>1.8501842443603607</c:v>
                </c:pt>
                <c:pt idx="225">
                  <c:v>1.827058858011819</c:v>
                </c:pt>
                <c:pt idx="226">
                  <c:v>1.8034097532357478</c:v>
                </c:pt>
                <c:pt idx="227">
                  <c:v>1.7792473728110672</c:v>
                </c:pt>
                <c:pt idx="228">
                  <c:v>1.7545823861647742</c:v>
                </c:pt>
                <c:pt idx="229">
                  <c:v>1.7294256846606237</c:v>
                </c:pt>
                <c:pt idx="230">
                  <c:v>1.7037883767898101</c:v>
                </c:pt>
                <c:pt idx="231">
                  <c:v>1.6776817832657693</c:v>
                </c:pt>
                <c:pt idx="232">
                  <c:v>1.6511174320252711</c:v>
                </c:pt>
                <c:pt idx="233">
                  <c:v>1.624107053138006</c:v>
                </c:pt>
                <c:pt idx="234">
                  <c:v>1.596662573626918</c:v>
                </c:pt>
                <c:pt idx="235">
                  <c:v>1.5687961122015648</c:v>
                </c:pt>
                <c:pt idx="236">
                  <c:v>1.5405199739068389</c:v>
                </c:pt>
                <c:pt idx="237">
                  <c:v>1.5118466446894065</c:v>
                </c:pt>
                <c:pt idx="238">
                  <c:v>1.4827887858842623</c:v>
                </c:pt>
                <c:pt idx="239">
                  <c:v>1.4533592286238421</c:v>
                </c:pt>
                <c:pt idx="240">
                  <c:v>1.4235709681721569</c:v>
                </c:pt>
                <c:pt idx="241">
                  <c:v>1.3934371581864475</c:v>
                </c:pt>
                <c:pt idx="242">
                  <c:v>1.3629711049089046</c:v>
                </c:pt>
                <c:pt idx="243">
                  <c:v>1.3321862612909978</c:v>
                </c:pt>
                <c:pt idx="244">
                  <c:v>1.3010962210530423</c:v>
                </c:pt>
                <c:pt idx="245">
                  <c:v>1.2697147126815855</c:v>
                </c:pt>
                <c:pt idx="246">
                  <c:v>1.2380555933672999</c:v>
                </c:pt>
                <c:pt idx="247">
                  <c:v>1.206132842886033</c:v>
                </c:pt>
                <c:pt idx="248">
                  <c:v>1.1739605574257364</c:v>
                </c:pt>
                <c:pt idx="249">
                  <c:v>1.1415529433619811</c:v>
                </c:pt>
                <c:pt idx="250">
                  <c:v>1.1089243109848277</c:v>
                </c:pt>
                <c:pt idx="251">
                  <c:v>1.0760890681797992</c:v>
                </c:pt>
                <c:pt idx="252">
                  <c:v>1.0430617140657694</c:v>
                </c:pt>
                <c:pt idx="253">
                  <c:v>1.0098568325925568</c:v>
                </c:pt>
                <c:pt idx="254">
                  <c:v>0.97648908610106389</c:v>
                </c:pt>
                <c:pt idx="255">
                  <c:v>0.94297320884880154</c:v>
                </c:pt>
                <c:pt idx="256">
                  <c:v>0.90932400050365336</c:v>
                </c:pt>
                <c:pt idx="257">
                  <c:v>0.87555631960876124</c:v>
                </c:pt>
                <c:pt idx="258">
                  <c:v>0.84168507702140904</c:v>
                </c:pt>
                <c:pt idx="259">
                  <c:v>0.80772522932880908</c:v>
                </c:pt>
                <c:pt idx="260">
                  <c:v>0.77369177224369334</c:v>
                </c:pt>
                <c:pt idx="261">
                  <c:v>0.73959973398263024</c:v>
                </c:pt>
                <c:pt idx="262">
                  <c:v>0.70546416862998551</c:v>
                </c:pt>
                <c:pt idx="263">
                  <c:v>0.67130014949046346</c:v>
                </c:pt>
                <c:pt idx="264">
                  <c:v>0.63712276243315935</c:v>
                </c:pt>
                <c:pt idx="265">
                  <c:v>0.60294709923006606</c:v>
                </c:pt>
                <c:pt idx="266">
                  <c:v>0.56878825089196872</c:v>
                </c:pt>
                <c:pt idx="267">
                  <c:v>0.53466130100468323</c:v>
                </c:pt>
                <c:pt idx="268">
                  <c:v>0.50058131906856662</c:v>
                </c:pt>
                <c:pt idx="269">
                  <c:v>0.46656335384425185</c:v>
                </c:pt>
                <c:pt idx="270">
                  <c:v>0.43262242670753648</c:v>
                </c:pt>
                <c:pt idx="271">
                  <c:v>0.39877352501636942</c:v>
                </c:pt>
                <c:pt idx="272">
                  <c:v>0.36503159549284991</c:v>
                </c:pt>
                <c:pt idx="273">
                  <c:v>0.33141153762318221</c:v>
                </c:pt>
                <c:pt idx="274">
                  <c:v>0.29792819707847817</c:v>
                </c:pt>
                <c:pt idx="275">
                  <c:v>0.26459635915932833</c:v>
                </c:pt>
                <c:pt idx="276">
                  <c:v>0.2314307422670282</c:v>
                </c:pt>
                <c:pt idx="277">
                  <c:v>0.19844599140434671</c:v>
                </c:pt>
                <c:pt idx="278">
                  <c:v>0.16565667170870679</c:v>
                </c:pt>
                <c:pt idx="279">
                  <c:v>0.13307726202062886</c:v>
                </c:pt>
                <c:pt idx="280">
                  <c:v>0.10072214849028294</c:v>
                </c:pt>
                <c:pt idx="281">
                  <c:v>6.8605618224971021E-2</c:v>
                </c:pt>
                <c:pt idx="282">
                  <c:v>3.6741852980340717E-2</c:v>
                </c:pt>
                <c:pt idx="283">
                  <c:v>5.1449228981219619E-3</c:v>
                </c:pt>
                <c:pt idx="284">
                  <c:v>-2.6171219706849769E-2</c:v>
                </c:pt>
                <c:pt idx="285">
                  <c:v>-5.7192746507586101E-2</c:v>
                </c:pt>
                <c:pt idx="286">
                  <c:v>-8.7905959271143641E-2</c:v>
                </c:pt>
                <c:pt idx="287">
                  <c:v>-0.11829729590737814</c:v>
                </c:pt>
                <c:pt idx="288">
                  <c:v>-0.14835333645758164</c:v>
                </c:pt>
                <c:pt idx="289">
                  <c:v>-0.17806080902035992</c:v>
                </c:pt>
                <c:pt idx="290">
                  <c:v>-0.20740659561212804</c:v>
                </c:pt>
                <c:pt idx="291">
                  <c:v>-0.23637773795964512</c:v>
                </c:pt>
                <c:pt idx="292">
                  <c:v>-0.26496144322202131</c:v>
                </c:pt>
                <c:pt idx="293">
                  <c:v>-0.293145089639677</c:v>
                </c:pt>
                <c:pt idx="294">
                  <c:v>-0.32091623210775622</c:v>
                </c:pt>
                <c:pt idx="295">
                  <c:v>-0.34826260767153427</c:v>
                </c:pt>
                <c:pt idx="296">
                  <c:v>-0.37517214094139473</c:v>
                </c:pt>
                <c:pt idx="297">
                  <c:v>-0.40163294942497907</c:v>
                </c:pt>
                <c:pt idx="298">
                  <c:v>-0.42763334877416403</c:v>
                </c:pt>
                <c:pt idx="299">
                  <c:v>-0.4531618579445362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424896"/>
        <c:axId val="283422152"/>
      </c:scatterChart>
      <c:valAx>
        <c:axId val="283424896"/>
        <c:scaling>
          <c:orientation val="minMax"/>
          <c:max val="15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422152"/>
        <c:crosses val="autoZero"/>
        <c:crossBetween val="midCat"/>
      </c:valAx>
      <c:valAx>
        <c:axId val="283422152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424896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03089036947306"/>
          <c:y val="0.10679611650485436"/>
          <c:w val="0.6520752574197457"/>
          <c:h val="0.7039966363427872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FF0000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FF0000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AW$1:$AW$15</c:f>
              <c:numCache>
                <c:formatCode>General</c:formatCode>
                <c:ptCount val="15"/>
                <c:pt idx="0">
                  <c:v>0.109</c:v>
                </c:pt>
                <c:pt idx="1">
                  <c:v>0</c:v>
                </c:pt>
                <c:pt idx="2">
                  <c:v>0.59</c:v>
                </c:pt>
                <c:pt idx="3">
                  <c:v>0.85</c:v>
                </c:pt>
                <c:pt idx="4">
                  <c:v>0.5</c:v>
                </c:pt>
                <c:pt idx="5">
                  <c:v>219.19880000000001</c:v>
                </c:pt>
                <c:pt idx="6">
                  <c:v>124.09350000000001</c:v>
                </c:pt>
                <c:pt idx="7">
                  <c:v>170.1447</c:v>
                </c:pt>
                <c:pt idx="8">
                  <c:v>102.8198</c:v>
                </c:pt>
                <c:pt idx="9">
                  <c:v>133.8227</c:v>
                </c:pt>
                <c:pt idx="10">
                  <c:v>78.404910000000001</c:v>
                </c:pt>
                <c:pt idx="11">
                  <c:v>56.57591</c:v>
                </c:pt>
                <c:pt idx="12">
                  <c:v>113.7139</c:v>
                </c:pt>
                <c:pt idx="13">
                  <c:v>92.474109999999996</c:v>
                </c:pt>
                <c:pt idx="14">
                  <c:v>81.813429999999997</c:v>
                </c:pt>
              </c:numCache>
            </c:numRef>
          </c:xVal>
          <c:yVal>
            <c:numRef>
              <c:f>'Covariance   Correlation3_HID4'!$AX$1:$AX$15</c:f>
              <c:numCache>
                <c:formatCode>General</c:formatCode>
                <c:ptCount val="15"/>
                <c:pt idx="0">
                  <c:v>9.1300000000000006E-2</c:v>
                </c:pt>
                <c:pt idx="1">
                  <c:v>0.44719999999999999</c:v>
                </c:pt>
                <c:pt idx="2">
                  <c:v>0.40560000000000002</c:v>
                </c:pt>
                <c:pt idx="3">
                  <c:v>0.29530000000000001</c:v>
                </c:pt>
                <c:pt idx="4">
                  <c:v>0.10879999999999999</c:v>
                </c:pt>
                <c:pt idx="5">
                  <c:v>1.6014999999999999</c:v>
                </c:pt>
                <c:pt idx="6">
                  <c:v>1.0639000000000001</c:v>
                </c:pt>
                <c:pt idx="7">
                  <c:v>1.5142</c:v>
                </c:pt>
                <c:pt idx="8">
                  <c:v>1.4415</c:v>
                </c:pt>
                <c:pt idx="9">
                  <c:v>1.0116000000000001</c:v>
                </c:pt>
                <c:pt idx="10">
                  <c:v>0.59709999999999996</c:v>
                </c:pt>
                <c:pt idx="11">
                  <c:v>0.1628</c:v>
                </c:pt>
                <c:pt idx="12">
                  <c:v>0.2384</c:v>
                </c:pt>
                <c:pt idx="13">
                  <c:v>2.1299999999999999E-2</c:v>
                </c:pt>
                <c:pt idx="14">
                  <c:v>0.614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30</c:f>
              <c:numCache>
                <c:formatCode>General</c:formatCode>
                <c:ptCount val="300"/>
                <c:pt idx="0">
                  <c:v>-125.6604566908927</c:v>
                </c:pt>
                <c:pt idx="1">
                  <c:v>-125.61541610310188</c:v>
                </c:pt>
                <c:pt idx="2">
                  <c:v>-125.48031422838501</c:v>
                </c:pt>
                <c:pt idx="3">
                  <c:v>-125.25521072392671</c:v>
                </c:pt>
                <c:pt idx="4">
                  <c:v>-124.94020498909764</c:v>
                </c:pt>
                <c:pt idx="5">
                  <c:v>-124.53543612156251</c:v>
                </c:pt>
                <c:pt idx="6">
                  <c:v>-124.04108285585853</c:v>
                </c:pt>
                <c:pt idx="7">
                  <c:v>-123.45736348447123</c:v>
                </c:pt>
                <c:pt idx="8">
                  <c:v>-122.78453576144263</c:v>
                </c:pt>
                <c:pt idx="9">
                  <c:v>-122.02289678855435</c:v>
                </c:pt>
                <c:pt idx="10">
                  <c:v>-121.17278288413577</c:v>
                </c:pt>
                <c:pt idx="11">
                  <c:v>-120.23456943455544</c:v>
                </c:pt>
                <c:pt idx="12">
                  <c:v>-119.20867072846092</c:v>
                </c:pt>
                <c:pt idx="13">
                  <c:v>-118.09553977384054</c:v>
                </c:pt>
                <c:pt idx="14">
                  <c:v>-116.89566809798801</c:v>
                </c:pt>
                <c:pt idx="15">
                  <c:v>-115.60958553045755</c:v>
                </c:pt>
                <c:pt idx="16">
                  <c:v>-114.23785996910634</c:v>
                </c:pt>
                <c:pt idx="17">
                  <c:v>-112.78109712932657</c:v>
                </c:pt>
                <c:pt idx="18">
                  <c:v>-111.23994027657879</c:v>
                </c:pt>
                <c:pt idx="19">
                  <c:v>-109.61506994234379</c:v>
                </c:pt>
                <c:pt idx="20">
                  <c:v>-107.90720362361925</c:v>
                </c:pt>
                <c:pt idx="21">
                  <c:v>-106.11709546609309</c:v>
                </c:pt>
                <c:pt idx="22">
                  <c:v>-104.24553593113409</c:v>
                </c:pt>
                <c:pt idx="23">
                  <c:v>-102.29335144674634</c:v>
                </c:pt>
                <c:pt idx="24">
                  <c:v>-100.26140404264187</c:v>
                </c:pt>
                <c:pt idx="25">
                  <c:v>-98.150590969592699</c:v>
                </c:pt>
                <c:pt idx="26">
                  <c:v>-95.961844303230052</c:v>
                </c:pt>
                <c:pt idx="27">
                  <c:v>-93.696130532466114</c:v>
                </c:pt>
                <c:pt idx="28">
                  <c:v>-91.354450132719549</c:v>
                </c:pt>
                <c:pt idx="29">
                  <c:v>-88.937837124133935</c:v>
                </c:pt>
                <c:pt idx="30">
                  <c:v>-86.447358614983429</c:v>
                </c:pt>
                <c:pt idx="31">
                  <c:v>-83.884114330467796</c:v>
                </c:pt>
                <c:pt idx="32">
                  <c:v>-81.249236127104851</c:v>
                </c:pt>
                <c:pt idx="33">
                  <c:v>-78.543887492934331</c:v>
                </c:pt>
                <c:pt idx="34">
                  <c:v>-75.769263033754484</c:v>
                </c:pt>
                <c:pt idx="35">
                  <c:v>-72.926587945617499</c:v>
                </c:pt>
                <c:pt idx="36">
                  <c:v>-70.017117473817805</c:v>
                </c:pt>
                <c:pt idx="37">
                  <c:v>-67.042136358610733</c:v>
                </c:pt>
                <c:pt idx="38">
                  <c:v>-64.002958267907687</c:v>
                </c:pt>
                <c:pt idx="39">
                  <c:v>-60.900925217197184</c:v>
                </c:pt>
                <c:pt idx="40">
                  <c:v>-57.737406976948577</c:v>
                </c:pt>
                <c:pt idx="41">
                  <c:v>-54.513800467760106</c:v>
                </c:pt>
                <c:pt idx="42">
                  <c:v>-51.231529143517989</c:v>
                </c:pt>
                <c:pt idx="43">
                  <c:v>-47.892042362839319</c:v>
                </c:pt>
                <c:pt idx="44">
                  <c:v>-44.496814749076037</c:v>
                </c:pt>
                <c:pt idx="45">
                  <c:v>-41.047345539162862</c:v>
                </c:pt>
                <c:pt idx="46">
                  <c:v>-37.545157921596314</c:v>
                </c:pt>
                <c:pt idx="47">
                  <c:v>-33.991798363837731</c:v>
                </c:pt>
                <c:pt idx="48">
                  <c:v>-30.388835929436667</c:v>
                </c:pt>
                <c:pt idx="49">
                  <c:v>-26.737861585176617</c:v>
                </c:pt>
                <c:pt idx="50">
                  <c:v>-23.040487498548899</c:v>
                </c:pt>
                <c:pt idx="51">
                  <c:v>-19.298346325864813</c:v>
                </c:pt>
                <c:pt idx="52">
                  <c:v>-15.513090491320668</c:v>
                </c:pt>
                <c:pt idx="53">
                  <c:v>-11.68639145733367</c:v>
                </c:pt>
                <c:pt idx="54">
                  <c:v>-7.8199389864713567</c:v>
                </c:pt>
                <c:pt idx="55">
                  <c:v>-3.9154403952996262</c:v>
                </c:pt>
                <c:pt idx="56">
                  <c:v>2.5380199519744906E-2</c:v>
                </c:pt>
                <c:pt idx="57">
                  <c:v>4.000782642550675</c:v>
                </c:pt>
                <c:pt idx="58">
                  <c:v>8.0090115079864717</c:v>
                </c:pt>
                <c:pt idx="59">
                  <c:v>12.048296874796407</c:v>
                </c:pt>
                <c:pt idx="60">
                  <c:v>16.116855108273029</c:v>
                </c:pt>
                <c:pt idx="61">
                  <c:v>20.212889647634974</c:v>
                </c:pt>
                <c:pt idx="62">
                  <c:v>24.334591799337829</c:v>
                </c:pt>
                <c:pt idx="63">
                  <c:v>28.480141535742014</c:v>
                </c:pt>
                <c:pt idx="64">
                  <c:v>32.647708298785915</c:v>
                </c:pt>
                <c:pt idx="65">
                  <c:v>36.835451808308761</c:v>
                </c:pt>
                <c:pt idx="66">
                  <c:v>41.041522874666555</c:v>
                </c:pt>
                <c:pt idx="67">
                  <c:v>45.264064215282104</c:v>
                </c:pt>
                <c:pt idx="68">
                  <c:v>49.501211274768757</c:v>
                </c:pt>
                <c:pt idx="69">
                  <c:v>53.75109304826568</c:v>
                </c:pt>
                <c:pt idx="70">
                  <c:v>58.011832907620715</c:v>
                </c:pt>
                <c:pt idx="71">
                  <c:v>62.281549430056685</c:v>
                </c:pt>
                <c:pt idx="72">
                  <c:v>66.558357228954719</c:v>
                </c:pt>
                <c:pt idx="73">
                  <c:v>70.840367786387873</c:v>
                </c:pt>
                <c:pt idx="74">
                  <c:v>75.125690287037486</c:v>
                </c:pt>
                <c:pt idx="75">
                  <c:v>79.412432453124012</c:v>
                </c:pt>
                <c:pt idx="76">
                  <c:v>83.698701379983689</c:v>
                </c:pt>
                <c:pt idx="77">
                  <c:v>87.982604371921767</c:v>
                </c:pt>
                <c:pt idx="78">
                  <c:v>92.262249777973807</c:v>
                </c:pt>
                <c:pt idx="79">
                  <c:v>96.535747827205427</c:v>
                </c:pt>
                <c:pt idx="80">
                  <c:v>100.80121146318197</c:v>
                </c:pt>
                <c:pt idx="81">
                  <c:v>105.05675717723948</c:v>
                </c:pt>
                <c:pt idx="82">
                  <c:v>109.3005058401891</c:v>
                </c:pt>
                <c:pt idx="83">
                  <c:v>113.53058353208776</c:v>
                </c:pt>
                <c:pt idx="84">
                  <c:v>117.74512236970821</c:v>
                </c:pt>
                <c:pt idx="85">
                  <c:v>121.94226133134387</c:v>
                </c:pt>
                <c:pt idx="86">
                  <c:v>126.1201470785836</c:v>
                </c:pt>
                <c:pt idx="87">
                  <c:v>130.27693477469364</c:v>
                </c:pt>
                <c:pt idx="88">
                  <c:v>134.4107888992458</c:v>
                </c:pt>
                <c:pt idx="89">
                  <c:v>138.51988405863133</c:v>
                </c:pt>
                <c:pt idx="90">
                  <c:v>142.6024057921037</c:v>
                </c:pt>
                <c:pt idx="91">
                  <c:v>146.65655137299305</c:v>
                </c:pt>
                <c:pt idx="92">
                  <c:v>150.68053060473972</c:v>
                </c:pt>
                <c:pt idx="93">
                  <c:v>154.67256661139459</c:v>
                </c:pt>
                <c:pt idx="94">
                  <c:v>158.63089662223751</c:v>
                </c:pt>
                <c:pt idx="95">
                  <c:v>162.55377275016727</c:v>
                </c:pt>
                <c:pt idx="96">
                  <c:v>166.4394627635192</c:v>
                </c:pt>
                <c:pt idx="97">
                  <c:v>170.28625085097008</c:v>
                </c:pt>
                <c:pt idx="98">
                  <c:v>174.092438379192</c:v>
                </c:pt>
                <c:pt idx="99">
                  <c:v>177.85634464292104</c:v>
                </c:pt>
                <c:pt idx="100">
                  <c:v>181.57630760710944</c:v>
                </c:pt>
                <c:pt idx="101">
                  <c:v>185.25068464083338</c:v>
                </c:pt>
                <c:pt idx="102">
                  <c:v>188.8778532426328</c:v>
                </c:pt>
                <c:pt idx="103">
                  <c:v>192.45621175696203</c:v>
                </c:pt>
                <c:pt idx="104">
                  <c:v>195.98418008143605</c:v>
                </c:pt>
                <c:pt idx="105">
                  <c:v>199.46020036455917</c:v>
                </c:pt>
                <c:pt idx="106">
                  <c:v>202.88273769362831</c:v>
                </c:pt>
                <c:pt idx="107">
                  <c:v>206.25028077250727</c:v>
                </c:pt>
                <c:pt idx="108">
                  <c:v>209.56134258897276</c:v>
                </c:pt>
                <c:pt idx="109">
                  <c:v>212.81446107133667</c:v>
                </c:pt>
                <c:pt idx="110">
                  <c:v>216.00819973405635</c:v>
                </c:pt>
                <c:pt idx="111">
                  <c:v>219.14114831204563</c:v>
                </c:pt>
                <c:pt idx="112">
                  <c:v>222.21192338340865</c:v>
                </c:pt>
                <c:pt idx="113">
                  <c:v>225.21916898031969</c:v>
                </c:pt>
                <c:pt idx="114">
                  <c:v>228.1615571877806</c:v>
                </c:pt>
                <c:pt idx="115">
                  <c:v>231.03778872999055</c:v>
                </c:pt>
                <c:pt idx="116">
                  <c:v>233.84659354406978</c:v>
                </c:pt>
                <c:pt idx="117">
                  <c:v>236.58673134088343</c:v>
                </c:pt>
                <c:pt idx="118">
                  <c:v>239.25699215271851</c:v>
                </c:pt>
                <c:pt idx="119">
                  <c:v>241.85619686757133</c:v>
                </c:pt>
                <c:pt idx="120">
                  <c:v>244.38319774981045</c:v>
                </c:pt>
                <c:pt idx="121">
                  <c:v>246.83687894698426</c:v>
                </c:pt>
                <c:pt idx="122">
                  <c:v>249.21615698255005</c:v>
                </c:pt>
                <c:pt idx="123">
                  <c:v>251.51998123430673</c:v>
                </c:pt>
                <c:pt idx="124">
                  <c:v>253.74733439831999</c:v>
                </c:pt>
                <c:pt idx="125">
                  <c:v>255.89723293813518</c:v>
                </c:pt>
                <c:pt idx="126">
                  <c:v>257.96872751907921</c:v>
                </c:pt>
                <c:pt idx="127">
                  <c:v>259.96090342746004</c:v>
                </c:pt>
                <c:pt idx="128">
                  <c:v>261.87288097447868</c:v>
                </c:pt>
                <c:pt idx="129">
                  <c:v>263.70381588467467</c:v>
                </c:pt>
                <c:pt idx="130">
                  <c:v>265.45289966873457</c:v>
                </c:pt>
                <c:pt idx="131">
                  <c:v>267.11935998049813</c:v>
                </c:pt>
                <c:pt idx="132">
                  <c:v>268.70246095800439</c:v>
                </c:pt>
                <c:pt idx="133">
                  <c:v>270.20150354842781</c:v>
                </c:pt>
                <c:pt idx="134">
                  <c:v>271.61582581676021</c:v>
                </c:pt>
                <c:pt idx="135">
                  <c:v>272.94480323810268</c:v>
                </c:pt>
                <c:pt idx="136">
                  <c:v>274.18784897343824</c:v>
                </c:pt>
                <c:pt idx="137">
                  <c:v>275.34441412876333</c:v>
                </c:pt>
                <c:pt idx="138">
                  <c:v>276.41398799746395</c:v>
                </c:pt>
                <c:pt idx="139">
                  <c:v>277.39609828582945</c:v>
                </c:pt>
                <c:pt idx="140">
                  <c:v>278.29031132160407</c:v>
                </c:pt>
                <c:pt idx="141">
                  <c:v>279.09623224548426</c:v>
                </c:pt>
                <c:pt idx="142">
                  <c:v>279.81350518547765</c:v>
                </c:pt>
                <c:pt idx="143">
                  <c:v>280.44181341404601</c:v>
                </c:pt>
                <c:pt idx="144">
                  <c:v>280.98087948796314</c:v>
                </c:pt>
                <c:pt idx="145">
                  <c:v>281.43046537082625</c:v>
                </c:pt>
                <c:pt idx="146">
                  <c:v>281.79037253816574</c:v>
                </c:pt>
                <c:pt idx="147">
                  <c:v>282.06044206510836</c:v>
                </c:pt>
                <c:pt idx="148">
                  <c:v>282.24055469655372</c:v>
                </c:pt>
                <c:pt idx="149">
                  <c:v>282.3306308998342</c:v>
                </c:pt>
                <c:pt idx="150">
                  <c:v>282.3306308998342</c:v>
                </c:pt>
                <c:pt idx="151">
                  <c:v>282.24055469655366</c:v>
                </c:pt>
                <c:pt idx="152">
                  <c:v>282.06044206510819</c:v>
                </c:pt>
                <c:pt idx="153">
                  <c:v>281.79037253816551</c:v>
                </c:pt>
                <c:pt idx="154">
                  <c:v>281.43046537082597</c:v>
                </c:pt>
                <c:pt idx="155">
                  <c:v>280.9808794879628</c:v>
                </c:pt>
                <c:pt idx="156">
                  <c:v>280.44181341404555</c:v>
                </c:pt>
                <c:pt idx="157">
                  <c:v>279.81350518547714</c:v>
                </c:pt>
                <c:pt idx="158">
                  <c:v>279.09623224548369</c:v>
                </c:pt>
                <c:pt idx="159">
                  <c:v>278.2903113216035</c:v>
                </c:pt>
                <c:pt idx="160">
                  <c:v>277.39609828582883</c:v>
                </c:pt>
                <c:pt idx="161">
                  <c:v>276.41398799746321</c:v>
                </c:pt>
                <c:pt idx="162">
                  <c:v>275.34441412876254</c:v>
                </c:pt>
                <c:pt idx="163">
                  <c:v>274.18784897343738</c:v>
                </c:pt>
                <c:pt idx="164">
                  <c:v>272.94480323810177</c:v>
                </c:pt>
                <c:pt idx="165">
                  <c:v>271.61582581675924</c:v>
                </c:pt>
                <c:pt idx="166">
                  <c:v>270.20150354842679</c:v>
                </c:pt>
                <c:pt idx="167">
                  <c:v>268.70246095800331</c:v>
                </c:pt>
                <c:pt idx="168">
                  <c:v>267.11935998049699</c:v>
                </c:pt>
                <c:pt idx="169">
                  <c:v>265.45289966873344</c:v>
                </c:pt>
                <c:pt idx="170">
                  <c:v>263.70381588467342</c:v>
                </c:pt>
                <c:pt idx="171">
                  <c:v>261.87288097447743</c:v>
                </c:pt>
                <c:pt idx="172">
                  <c:v>259.96090342745867</c:v>
                </c:pt>
                <c:pt idx="173">
                  <c:v>257.96872751907773</c:v>
                </c:pt>
                <c:pt idx="174">
                  <c:v>255.8972329381337</c:v>
                </c:pt>
                <c:pt idx="175">
                  <c:v>253.74733439831846</c:v>
                </c:pt>
                <c:pt idx="176">
                  <c:v>251.51998123430513</c:v>
                </c:pt>
                <c:pt idx="177">
                  <c:v>249.2161569825484</c:v>
                </c:pt>
                <c:pt idx="178">
                  <c:v>246.83687894698261</c:v>
                </c:pt>
                <c:pt idx="179">
                  <c:v>244.38319774980874</c:v>
                </c:pt>
                <c:pt idx="180">
                  <c:v>241.85619686756951</c:v>
                </c:pt>
                <c:pt idx="181">
                  <c:v>239.25699215271663</c:v>
                </c:pt>
                <c:pt idx="182">
                  <c:v>236.58673134088156</c:v>
                </c:pt>
                <c:pt idx="183">
                  <c:v>233.84659354406784</c:v>
                </c:pt>
                <c:pt idx="184">
                  <c:v>231.03778872998856</c:v>
                </c:pt>
                <c:pt idx="185">
                  <c:v>228.16155718777856</c:v>
                </c:pt>
                <c:pt idx="186">
                  <c:v>225.21916898031759</c:v>
                </c:pt>
                <c:pt idx="187">
                  <c:v>222.21192338340654</c:v>
                </c:pt>
                <c:pt idx="188">
                  <c:v>219.14114831204347</c:v>
                </c:pt>
                <c:pt idx="189">
                  <c:v>216.00819973405413</c:v>
                </c:pt>
                <c:pt idx="190">
                  <c:v>212.81446107133445</c:v>
                </c:pt>
                <c:pt idx="191">
                  <c:v>209.56134258897055</c:v>
                </c:pt>
                <c:pt idx="192">
                  <c:v>206.25028077250502</c:v>
                </c:pt>
                <c:pt idx="193">
                  <c:v>202.88273769362598</c:v>
                </c:pt>
                <c:pt idx="194">
                  <c:v>199.46020036455678</c:v>
                </c:pt>
                <c:pt idx="195">
                  <c:v>195.98418008143361</c:v>
                </c:pt>
                <c:pt idx="196">
                  <c:v>192.45621175695953</c:v>
                </c:pt>
                <c:pt idx="197">
                  <c:v>188.87785324263027</c:v>
                </c:pt>
                <c:pt idx="198">
                  <c:v>185.25068464083085</c:v>
                </c:pt>
                <c:pt idx="199">
                  <c:v>181.57630760710686</c:v>
                </c:pt>
                <c:pt idx="200">
                  <c:v>177.85634464291846</c:v>
                </c:pt>
                <c:pt idx="201">
                  <c:v>174.09243837918939</c:v>
                </c:pt>
                <c:pt idx="202">
                  <c:v>170.28625085096743</c:v>
                </c:pt>
                <c:pt idx="203">
                  <c:v>166.4394627635165</c:v>
                </c:pt>
                <c:pt idx="204">
                  <c:v>162.55377275016451</c:v>
                </c:pt>
                <c:pt idx="205">
                  <c:v>158.63089662223473</c:v>
                </c:pt>
                <c:pt idx="206">
                  <c:v>154.67256661139174</c:v>
                </c:pt>
                <c:pt idx="207">
                  <c:v>150.68053060473687</c:v>
                </c:pt>
                <c:pt idx="208">
                  <c:v>146.65655137299018</c:v>
                </c:pt>
                <c:pt idx="209">
                  <c:v>142.6024057921008</c:v>
                </c:pt>
                <c:pt idx="210">
                  <c:v>138.51988405862843</c:v>
                </c:pt>
                <c:pt idx="211">
                  <c:v>134.41078889924285</c:v>
                </c:pt>
                <c:pt idx="212">
                  <c:v>130.27693477469069</c:v>
                </c:pt>
                <c:pt idx="213">
                  <c:v>126.1201470785806</c:v>
                </c:pt>
                <c:pt idx="214">
                  <c:v>121.94226133134106</c:v>
                </c:pt>
                <c:pt idx="215">
                  <c:v>117.74512236970537</c:v>
                </c:pt>
                <c:pt idx="216">
                  <c:v>113.5305835320849</c:v>
                </c:pt>
                <c:pt idx="217">
                  <c:v>109.30050584018623</c:v>
                </c:pt>
                <c:pt idx="218">
                  <c:v>105.05675717723656</c:v>
                </c:pt>
                <c:pt idx="219">
                  <c:v>100.80121146317904</c:v>
                </c:pt>
                <c:pt idx="220">
                  <c:v>96.535747827202485</c:v>
                </c:pt>
                <c:pt idx="221">
                  <c:v>92.262249777970865</c:v>
                </c:pt>
                <c:pt idx="222">
                  <c:v>87.982604371918825</c:v>
                </c:pt>
                <c:pt idx="223">
                  <c:v>83.698701379980733</c:v>
                </c:pt>
                <c:pt idx="224">
                  <c:v>79.41243245312107</c:v>
                </c:pt>
                <c:pt idx="225">
                  <c:v>75.125690287034502</c:v>
                </c:pt>
                <c:pt idx="226">
                  <c:v>70.840367786384874</c:v>
                </c:pt>
                <c:pt idx="227">
                  <c:v>66.558357228951735</c:v>
                </c:pt>
                <c:pt idx="228">
                  <c:v>62.281549430053701</c:v>
                </c:pt>
                <c:pt idx="229">
                  <c:v>58.011832907617745</c:v>
                </c:pt>
                <c:pt idx="230">
                  <c:v>53.751093048262717</c:v>
                </c:pt>
                <c:pt idx="231">
                  <c:v>49.501211274765794</c:v>
                </c:pt>
                <c:pt idx="232">
                  <c:v>45.264064215279113</c:v>
                </c:pt>
                <c:pt idx="233">
                  <c:v>41.041522874663571</c:v>
                </c:pt>
                <c:pt idx="234">
                  <c:v>36.835451808305798</c:v>
                </c:pt>
                <c:pt idx="235">
                  <c:v>32.647708298782959</c:v>
                </c:pt>
                <c:pt idx="236">
                  <c:v>28.480141535739072</c:v>
                </c:pt>
                <c:pt idx="237">
                  <c:v>24.334591799334909</c:v>
                </c:pt>
                <c:pt idx="238">
                  <c:v>20.212889647632068</c:v>
                </c:pt>
                <c:pt idx="239">
                  <c:v>16.116855108270094</c:v>
                </c:pt>
                <c:pt idx="240">
                  <c:v>12.048296874793493</c:v>
                </c:pt>
                <c:pt idx="241">
                  <c:v>8.0090115079835726</c:v>
                </c:pt>
                <c:pt idx="242">
                  <c:v>4.0007826425479607</c:v>
                </c:pt>
                <c:pt idx="243">
                  <c:v>2.5380199517073265E-2</c:v>
                </c:pt>
                <c:pt idx="244">
                  <c:v>-3.9154403953022694</c:v>
                </c:pt>
                <c:pt idx="245">
                  <c:v>-7.8199389864739857</c:v>
                </c:pt>
                <c:pt idx="246">
                  <c:v>-11.686391457336356</c:v>
                </c:pt>
                <c:pt idx="247">
                  <c:v>-15.513090491323325</c:v>
                </c:pt>
                <c:pt idx="248">
                  <c:v>-19.298346325867442</c:v>
                </c:pt>
                <c:pt idx="249">
                  <c:v>-23.040487498551499</c:v>
                </c:pt>
                <c:pt idx="250">
                  <c:v>-26.737861585179203</c:v>
                </c:pt>
                <c:pt idx="251">
                  <c:v>-30.38883592943921</c:v>
                </c:pt>
                <c:pt idx="252">
                  <c:v>-33.991798363840232</c:v>
                </c:pt>
                <c:pt idx="253">
                  <c:v>-37.545157921598758</c:v>
                </c:pt>
                <c:pt idx="254">
                  <c:v>-41.047345539165278</c:v>
                </c:pt>
                <c:pt idx="255">
                  <c:v>-44.496814749078439</c:v>
                </c:pt>
                <c:pt idx="256">
                  <c:v>-47.892042362841678</c:v>
                </c:pt>
                <c:pt idx="257">
                  <c:v>-51.231529143520319</c:v>
                </c:pt>
                <c:pt idx="258">
                  <c:v>-54.513800467762351</c:v>
                </c:pt>
                <c:pt idx="259">
                  <c:v>-57.737406976950794</c:v>
                </c:pt>
                <c:pt idx="260">
                  <c:v>-60.900925217199372</c:v>
                </c:pt>
                <c:pt idx="261">
                  <c:v>-64.002958267909847</c:v>
                </c:pt>
                <c:pt idx="262">
                  <c:v>-67.042136358612836</c:v>
                </c:pt>
                <c:pt idx="263">
                  <c:v>-70.017117473819823</c:v>
                </c:pt>
                <c:pt idx="264">
                  <c:v>-72.926587945619517</c:v>
                </c:pt>
                <c:pt idx="265">
                  <c:v>-75.769263033756474</c:v>
                </c:pt>
                <c:pt idx="266">
                  <c:v>-78.543887492936321</c:v>
                </c:pt>
                <c:pt idx="267">
                  <c:v>-81.249236127106784</c:v>
                </c:pt>
                <c:pt idx="268">
                  <c:v>-83.884114330469671</c:v>
                </c:pt>
                <c:pt idx="269">
                  <c:v>-86.447358614985248</c:v>
                </c:pt>
                <c:pt idx="270">
                  <c:v>-88.937837124135697</c:v>
                </c:pt>
                <c:pt idx="271">
                  <c:v>-91.354450132721169</c:v>
                </c:pt>
                <c:pt idx="272">
                  <c:v>-93.696130532467649</c:v>
                </c:pt>
                <c:pt idx="273">
                  <c:v>-95.961844303231558</c:v>
                </c:pt>
                <c:pt idx="274">
                  <c:v>-98.150590969594148</c:v>
                </c:pt>
                <c:pt idx="275">
                  <c:v>-100.26140404264326</c:v>
                </c:pt>
                <c:pt idx="276">
                  <c:v>-102.29335144674771</c:v>
                </c:pt>
                <c:pt idx="277">
                  <c:v>-104.24553593113542</c:v>
                </c:pt>
                <c:pt idx="278">
                  <c:v>-106.11709546609437</c:v>
                </c:pt>
                <c:pt idx="279">
                  <c:v>-107.90720362362048</c:v>
                </c:pt>
                <c:pt idx="280">
                  <c:v>-109.61506994234499</c:v>
                </c:pt>
                <c:pt idx="281">
                  <c:v>-111.2399402765799</c:v>
                </c:pt>
                <c:pt idx="282">
                  <c:v>-112.78109712932762</c:v>
                </c:pt>
                <c:pt idx="283">
                  <c:v>-114.23785996910733</c:v>
                </c:pt>
                <c:pt idx="284">
                  <c:v>-115.60958553045849</c:v>
                </c:pt>
                <c:pt idx="285">
                  <c:v>-116.89566809798886</c:v>
                </c:pt>
                <c:pt idx="286">
                  <c:v>-118.09553977384134</c:v>
                </c:pt>
                <c:pt idx="287">
                  <c:v>-119.20867072846166</c:v>
                </c:pt>
                <c:pt idx="288">
                  <c:v>-120.23456943455612</c:v>
                </c:pt>
                <c:pt idx="289">
                  <c:v>-121.1727828841364</c:v>
                </c:pt>
                <c:pt idx="290">
                  <c:v>-122.02289678855492</c:v>
                </c:pt>
                <c:pt idx="291">
                  <c:v>-122.78453576144311</c:v>
                </c:pt>
                <c:pt idx="292">
                  <c:v>-123.45736348447166</c:v>
                </c:pt>
                <c:pt idx="293">
                  <c:v>-124.04108285585893</c:v>
                </c:pt>
                <c:pt idx="294">
                  <c:v>-124.53543612156285</c:v>
                </c:pt>
                <c:pt idx="295">
                  <c:v>-124.94020498909789</c:v>
                </c:pt>
                <c:pt idx="296">
                  <c:v>-125.25521072392691</c:v>
                </c:pt>
                <c:pt idx="297">
                  <c:v>-125.48031422838513</c:v>
                </c:pt>
                <c:pt idx="298">
                  <c:v>-125.61541610310194</c:v>
                </c:pt>
                <c:pt idx="299">
                  <c:v>-125.6604566908927</c:v>
                </c:pt>
              </c:numCache>
            </c:numRef>
          </c:xVal>
          <c:yVal>
            <c:numRef>
              <c:f>'Covariance   Correlation3'!yycir31</c:f>
              <c:numCache>
                <c:formatCode>General</c:formatCode>
                <c:ptCount val="300"/>
                <c:pt idx="0">
                  <c:v>-0.61041922358929634</c:v>
                </c:pt>
                <c:pt idx="1">
                  <c:v>-0.63197328712315826</c:v>
                </c:pt>
                <c:pt idx="2">
                  <c:v>-0.65296522971383797</c:v>
                </c:pt>
                <c:pt idx="3">
                  <c:v>-0.67338578191043474</c:v>
                </c:pt>
                <c:pt idx="4">
                  <c:v>-0.69322592657196036</c:v>
                </c:pt>
                <c:pt idx="5">
                  <c:v>-0.71247690284905552</c:v>
                </c:pt>
                <c:pt idx="6">
                  <c:v>-0.73113021005253331</c:v>
                </c:pt>
                <c:pt idx="7">
                  <c:v>-0.74917761140704409</c:v>
                </c:pt>
                <c:pt idx="8">
                  <c:v>-0.76661113768820566</c:v>
                </c:pt>
                <c:pt idx="9">
                  <c:v>-0.78342309074158589</c:v>
                </c:pt>
                <c:pt idx="10">
                  <c:v>-0.79960604688199166</c:v>
                </c:pt>
                <c:pt idx="11">
                  <c:v>-0.81515286017156097</c:v>
                </c:pt>
                <c:pt idx="12">
                  <c:v>-0.83005666557520508</c:v>
                </c:pt>
                <c:pt idx="13">
                  <c:v>-0.8443108819920172</c:v>
                </c:pt>
                <c:pt idx="14">
                  <c:v>-0.85790921516130059</c:v>
                </c:pt>
                <c:pt idx="15">
                  <c:v>-0.87084566044193568</c:v>
                </c:pt>
                <c:pt idx="16">
                  <c:v>-0.88311450546386305</c:v>
                </c:pt>
                <c:pt idx="17">
                  <c:v>-0.89471033265050282</c:v>
                </c:pt>
                <c:pt idx="18">
                  <c:v>-0.9056280216110052</c:v>
                </c:pt>
                <c:pt idx="19">
                  <c:v>-0.91586275140127049</c:v>
                </c:pt>
                <c:pt idx="20">
                  <c:v>-0.92541000265274342</c:v>
                </c:pt>
                <c:pt idx="21">
                  <c:v>-0.93426555956803681</c:v>
                </c:pt>
                <c:pt idx="22">
                  <c:v>-0.9424255117825111</c:v>
                </c:pt>
                <c:pt idx="23">
                  <c:v>-0.94988625609098021</c:v>
                </c:pt>
                <c:pt idx="24">
                  <c:v>-0.95664449803878659</c:v>
                </c:pt>
                <c:pt idx="25">
                  <c:v>-0.96269725337653822</c:v>
                </c:pt>
                <c:pt idx="26">
                  <c:v>-0.96804184937786952</c:v>
                </c:pt>
                <c:pt idx="27">
                  <c:v>-0.97267592601964314</c:v>
                </c:pt>
                <c:pt idx="28">
                  <c:v>-0.97659743702406876</c:v>
                </c:pt>
                <c:pt idx="29">
                  <c:v>-0.97980465076228163</c:v>
                </c:pt>
                <c:pt idx="30">
                  <c:v>-0.98229615101898171</c:v>
                </c:pt>
                <c:pt idx="31">
                  <c:v>-0.98407083761779446</c:v>
                </c:pt>
                <c:pt idx="32">
                  <c:v>-0.98512792690707718</c:v>
                </c:pt>
                <c:pt idx="33">
                  <c:v>-0.98546695210595792</c:v>
                </c:pt>
                <c:pt idx="34">
                  <c:v>-0.98508776351045313</c:v>
                </c:pt>
                <c:pt idx="35">
                  <c:v>-0.98399052855957148</c:v>
                </c:pt>
                <c:pt idx="36">
                  <c:v>-0.98217573176137929</c:v>
                </c:pt>
                <c:pt idx="37">
                  <c:v>-0.97964417447905383</c:v>
                </c:pt>
                <c:pt idx="38">
                  <c:v>-0.97639697457702468</c:v>
                </c:pt>
                <c:pt idx="39">
                  <c:v>-0.97243556592735636</c:v>
                </c:pt>
                <c:pt idx="40">
                  <c:v>-0.96776169777659027</c:v>
                </c:pt>
                <c:pt idx="41">
                  <c:v>-0.96237743397332676</c:v>
                </c:pt>
                <c:pt idx="42">
                  <c:v>-0.95628515205688869</c:v>
                </c:pt>
                <c:pt idx="43">
                  <c:v>-0.94948754220746501</c:v>
                </c:pt>
                <c:pt idx="44">
                  <c:v>-0.94198760605820508</c:v>
                </c:pt>
                <c:pt idx="45">
                  <c:v>-0.93378865536978073</c:v>
                </c:pt>
                <c:pt idx="46">
                  <c:v>-0.92489431056800575</c:v>
                </c:pt>
                <c:pt idx="47">
                  <c:v>-0.91530849914515866</c:v>
                </c:pt>
                <c:pt idx="48">
                  <c:v>-0.90503545392571216</c:v>
                </c:pt>
                <c:pt idx="49">
                  <c:v>-0.89407971119723728</c:v>
                </c:pt>
                <c:pt idx="50">
                  <c:v>-0.88244610870730611</c:v>
                </c:pt>
                <c:pt idx="51">
                  <c:v>-0.87013978352727883</c:v>
                </c:pt>
                <c:pt idx="52">
                  <c:v>-0.85716616978391791</c:v>
                </c:pt>
                <c:pt idx="53">
                  <c:v>-0.84353099625983008</c:v>
                </c:pt>
                <c:pt idx="54">
                  <c:v>-0.82924028386379822</c:v>
                </c:pt>
                <c:pt idx="55">
                  <c:v>-0.81430034297211595</c:v>
                </c:pt>
                <c:pt idx="56">
                  <c:v>-0.79871777064210459</c:v>
                </c:pt>
                <c:pt idx="57">
                  <c:v>-0.78249944769903779</c:v>
                </c:pt>
                <c:pt idx="58">
                  <c:v>-0.76565253569776293</c:v>
                </c:pt>
                <c:pt idx="59">
                  <c:v>-0.74818447376035979</c:v>
                </c:pt>
                <c:pt idx="60">
                  <c:v>-0.7301029752912338</c:v>
                </c:pt>
                <c:pt idx="61">
                  <c:v>-0.71141602457109432</c:v>
                </c:pt>
                <c:pt idx="62">
                  <c:v>-0.69213187323131975</c:v>
                </c:pt>
                <c:pt idx="63">
                  <c:v>-0.67225903661027087</c:v>
                </c:pt>
                <c:pt idx="64">
                  <c:v>-0.6518062899931566</c:v>
                </c:pt>
                <c:pt idx="65">
                  <c:v>-0.63078266473711442</c:v>
                </c:pt>
                <c:pt idx="66">
                  <c:v>-0.60919744428321831</c:v>
                </c:pt>
                <c:pt idx="67">
                  <c:v>-0.58706016005717199</c:v>
                </c:pt>
                <c:pt idx="68">
                  <c:v>-0.56438058726049989</c:v>
                </c:pt>
                <c:pt idx="69">
                  <c:v>-0.54116874055409281</c:v>
                </c:pt>
                <c:pt idx="70">
                  <c:v>-0.5174348696360157</c:v>
                </c:pt>
                <c:pt idx="71">
                  <c:v>-0.49318945471553088</c:v>
                </c:pt>
                <c:pt idx="72">
                  <c:v>-0.46844320188533051</c:v>
                </c:pt>
                <c:pt idx="73">
                  <c:v>-0.44320703839402936</c:v>
                </c:pt>
                <c:pt idx="74">
                  <c:v>-0.41749210782099799</c:v>
                </c:pt>
                <c:pt idx="75">
                  <c:v>-0.39130976515567273</c:v>
                </c:pt>
                <c:pt idx="76">
                  <c:v>-0.36467157178351145</c:v>
                </c:pt>
                <c:pt idx="77">
                  <c:v>-0.33758929038081115</c:v>
                </c:pt>
                <c:pt idx="78">
                  <c:v>-0.31007487972064263</c:v>
                </c:pt>
                <c:pt idx="79">
                  <c:v>-0.28214048939219077</c:v>
                </c:pt>
                <c:pt idx="80">
                  <c:v>-0.25379845443583948</c:v>
                </c:pt>
                <c:pt idx="81">
                  <c:v>-0.22506128989636451</c:v>
                </c:pt>
                <c:pt idx="82">
                  <c:v>-0.19594168529664285</c:v>
                </c:pt>
                <c:pt idx="83">
                  <c:v>-0.16645249903431455</c:v>
                </c:pt>
                <c:pt idx="84">
                  <c:v>-0.13660675270387923</c:v>
                </c:pt>
                <c:pt idx="85">
                  <c:v>-0.106417625346724</c:v>
                </c:pt>
                <c:pt idx="86">
                  <c:v>-7.5898447631631449E-2</c:v>
                </c:pt>
                <c:pt idx="87">
                  <c:v>-4.5062695968330235E-2</c:v>
                </c:pt>
                <c:pt idx="88">
                  <c:v>-1.3923986556693302E-2</c:v>
                </c:pt>
                <c:pt idx="89">
                  <c:v>1.7503930625793085E-2</c:v>
                </c:pt>
                <c:pt idx="90">
                  <c:v>4.9207177895634224E-2</c:v>
                </c:pt>
                <c:pt idx="91">
                  <c:v>8.1171755991317873E-2</c:v>
                </c:pt>
                <c:pt idx="92">
                  <c:v>0.1133835502549968</c:v>
                </c:pt>
                <c:pt idx="93">
                  <c:v>0.1458283368651232</c:v>
                </c:pt>
                <c:pt idx="94">
                  <c:v>0.17849178911728791</c:v>
                </c:pt>
                <c:pt idx="95">
                  <c:v>0.21135948375049018</c:v>
                </c:pt>
                <c:pt idx="96">
                  <c:v>0.24441690731604304</c:v>
                </c:pt>
                <c:pt idx="97">
                  <c:v>0.27764946258630496</c:v>
                </c:pt>
                <c:pt idx="98">
                  <c:v>0.31104247500040305</c:v>
                </c:pt>
                <c:pt idx="99">
                  <c:v>0.34458119914410668</c:v>
                </c:pt>
                <c:pt idx="100">
                  <c:v>0.37825082526098797</c:v>
                </c:pt>
                <c:pt idx="101">
                  <c:v>0.41203648579199181</c:v>
                </c:pt>
                <c:pt idx="102">
                  <c:v>0.44592326194053344</c:v>
                </c:pt>
                <c:pt idx="103">
                  <c:v>0.47989619026021713</c:v>
                </c:pt>
                <c:pt idx="104">
                  <c:v>0.51394026926227376</c:v>
                </c:pt>
                <c:pt idx="105">
                  <c:v>0.54804046603979617</c:v>
                </c:pt>
                <c:pt idx="106">
                  <c:v>0.58218172290584691</c:v>
                </c:pt>
                <c:pt idx="107">
                  <c:v>0.61634896404250894</c:v>
                </c:pt>
                <c:pt idx="108">
                  <c:v>0.65052710215794496</c:v>
                </c:pt>
                <c:pt idx="109">
                  <c:v>0.68470104514851604</c:v>
                </c:pt>
                <c:pt idx="110">
                  <c:v>0.71885570276303357</c:v>
                </c:pt>
                <c:pt idx="111">
                  <c:v>0.75297599326618769</c:v>
                </c:pt>
                <c:pt idx="112">
                  <c:v>0.78704685009821762</c:v>
                </c:pt>
                <c:pt idx="113">
                  <c:v>0.8210532285278801</c:v>
                </c:pt>
                <c:pt idx="114">
                  <c:v>0.85498011229577942</c:v>
                </c:pt>
                <c:pt idx="115">
                  <c:v>0.88881252024512403</c:v>
                </c:pt>
                <c:pt idx="116">
                  <c:v>0.92253551293698488</c:v>
                </c:pt>
                <c:pt idx="117">
                  <c:v>0.95613419924713039</c:v>
                </c:pt>
                <c:pt idx="118">
                  <c:v>0.98959374294152747</c:v>
                </c:pt>
                <c:pt idx="119">
                  <c:v>1.0228993692276052</c:v>
                </c:pt>
                <c:pt idx="120">
                  <c:v>1.0560363712783873</c:v>
                </c:pt>
                <c:pt idx="121">
                  <c:v>1.0889901167266123</c:v>
                </c:pt>
                <c:pt idx="122">
                  <c:v>1.1217460541259774</c:v>
                </c:pt>
                <c:pt idx="123">
                  <c:v>1.1542897193766435</c:v>
                </c:pt>
                <c:pt idx="124">
                  <c:v>1.1866067421121775</c:v>
                </c:pt>
                <c:pt idx="125">
                  <c:v>1.218682852045101</c:v>
                </c:pt>
                <c:pt idx="126">
                  <c:v>1.2505038852682464</c:v>
                </c:pt>
                <c:pt idx="127">
                  <c:v>1.2820557905091414</c:v>
                </c:pt>
                <c:pt idx="128">
                  <c:v>1.3133246353346544</c:v>
                </c:pt>
                <c:pt idx="129">
                  <c:v>1.3442966123031632</c:v>
                </c:pt>
                <c:pt idx="130">
                  <c:v>1.3749580450615364</c:v>
                </c:pt>
                <c:pt idx="131">
                  <c:v>1.4052953943842219</c:v>
                </c:pt>
                <c:pt idx="132">
                  <c:v>1.4352952641517902</c:v>
                </c:pt>
                <c:pt idx="133">
                  <c:v>1.4649444072662827</c:v>
                </c:pt>
                <c:pt idx="134">
                  <c:v>1.4942297315007576</c:v>
                </c:pt>
                <c:pt idx="135">
                  <c:v>1.5231383052804484</c:v>
                </c:pt>
                <c:pt idx="136">
                  <c:v>1.5516573633929827</c:v>
                </c:pt>
                <c:pt idx="137">
                  <c:v>1.5797743126251438</c:v>
                </c:pt>
                <c:pt idx="138">
                  <c:v>1.6074767373236742</c:v>
                </c:pt>
                <c:pt idx="139">
                  <c:v>1.6347524048776827</c:v>
                </c:pt>
                <c:pt idx="140">
                  <c:v>1.6615892711202185</c:v>
                </c:pt>
                <c:pt idx="141">
                  <c:v>1.6879754856466378</c:v>
                </c:pt>
                <c:pt idx="142">
                  <c:v>1.7138993970474075</c:v>
                </c:pt>
                <c:pt idx="143">
                  <c:v>1.7393495580530411</c:v>
                </c:pt>
                <c:pt idx="144">
                  <c:v>1.76431473058889</c:v>
                </c:pt>
                <c:pt idx="145">
                  <c:v>1.7887838907375606</c:v>
                </c:pt>
                <c:pt idx="146">
                  <c:v>1.8127462336067659</c:v>
                </c:pt>
                <c:pt idx="147">
                  <c:v>1.8361911781004627</c:v>
                </c:pt>
                <c:pt idx="148">
                  <c:v>1.8591083715911645</c:v>
                </c:pt>
                <c:pt idx="149">
                  <c:v>1.8814876944913714</c:v>
                </c:pt>
                <c:pt idx="150">
                  <c:v>1.9033192647220936</c:v>
                </c:pt>
                <c:pt idx="151">
                  <c:v>1.9245934420765018</c:v>
                </c:pt>
                <c:pt idx="152">
                  <c:v>1.9453008324767689</c:v>
                </c:pt>
                <c:pt idx="153">
                  <c:v>1.9654322921222303</c:v>
                </c:pt>
                <c:pt idx="154">
                  <c:v>1.984978931527031</c:v>
                </c:pt>
                <c:pt idx="155">
                  <c:v>2.0039321194454693</c:v>
                </c:pt>
                <c:pt idx="156">
                  <c:v>2.0222834866833157</c:v>
                </c:pt>
                <c:pt idx="157">
                  <c:v>2.0400249297934088</c:v>
                </c:pt>
                <c:pt idx="158">
                  <c:v>2.0571486146539137</c:v>
                </c:pt>
                <c:pt idx="159">
                  <c:v>2.0736469799276476</c:v>
                </c:pt>
                <c:pt idx="160">
                  <c:v>2.089512740400953</c:v>
                </c:pt>
                <c:pt idx="161">
                  <c:v>2.104738890200645</c:v>
                </c:pt>
                <c:pt idx="162">
                  <c:v>2.1193187058876051</c:v>
                </c:pt>
                <c:pt idx="163">
                  <c:v>2.1332457494256651</c:v>
                </c:pt>
                <c:pt idx="164">
                  <c:v>2.1465138710244598</c:v>
                </c:pt>
                <c:pt idx="165">
                  <c:v>2.1591172118550048</c:v>
                </c:pt>
                <c:pt idx="166">
                  <c:v>2.1710502066367878</c:v>
                </c:pt>
                <c:pt idx="167">
                  <c:v>2.1823075860952414</c:v>
                </c:pt>
                <c:pt idx="168">
                  <c:v>2.1928843792885035</c:v>
                </c:pt>
                <c:pt idx="169">
                  <c:v>2.2027759158024498</c:v>
                </c:pt>
                <c:pt idx="170">
                  <c:v>2.2119778278130133</c:v>
                </c:pt>
                <c:pt idx="171">
                  <c:v>2.2204860520148948</c:v>
                </c:pt>
                <c:pt idx="172">
                  <c:v>2.2282968314158031</c:v>
                </c:pt>
                <c:pt idx="173">
                  <c:v>2.2354067169954375</c:v>
                </c:pt>
                <c:pt idx="174">
                  <c:v>2.2418125692284763</c:v>
                </c:pt>
                <c:pt idx="175">
                  <c:v>2.2475115594709072</c:v>
                </c:pt>
                <c:pt idx="176">
                  <c:v>2.2525011712090706</c:v>
                </c:pt>
                <c:pt idx="177">
                  <c:v>2.2567792011708874</c:v>
                </c:pt>
                <c:pt idx="178">
                  <c:v>2.2603437602987571</c:v>
                </c:pt>
                <c:pt idx="179">
                  <c:v>2.263193274583716</c:v>
                </c:pt>
                <c:pt idx="180">
                  <c:v>2.2653264857604727</c:v>
                </c:pt>
                <c:pt idx="181">
                  <c:v>2.2667424518630233</c:v>
                </c:pt>
                <c:pt idx="182">
                  <c:v>2.2674405476405988</c:v>
                </c:pt>
                <c:pt idx="183">
                  <c:v>2.2674204648337559</c:v>
                </c:pt>
                <c:pt idx="184">
                  <c:v>2.2666822123104966</c:v>
                </c:pt>
                <c:pt idx="185">
                  <c:v>2.2652261160623519</c:v>
                </c:pt>
                <c:pt idx="186">
                  <c:v>2.2630528190604351</c:v>
                </c:pt>
                <c:pt idx="187">
                  <c:v>2.2601632809715211</c:v>
                </c:pt>
                <c:pt idx="188">
                  <c:v>2.2565587777342864</c:v>
                </c:pt>
                <c:pt idx="189">
                  <c:v>2.2522409009958895</c:v>
                </c:pt>
                <c:pt idx="190">
                  <c:v>2.2472115574091442</c:v>
                </c:pt>
                <c:pt idx="191">
                  <c:v>2.2414729677905978</c:v>
                </c:pt>
                <c:pt idx="192">
                  <c:v>2.2350276661398771</c:v>
                </c:pt>
                <c:pt idx="193">
                  <c:v>2.2278784985207492</c:v>
                </c:pt>
                <c:pt idx="194">
                  <c:v>2.2200286218043761</c:v>
                </c:pt>
                <c:pt idx="195">
                  <c:v>2.2114815022753338</c:v>
                </c:pt>
                <c:pt idx="196">
                  <c:v>2.2022409141009951</c:v>
                </c:pt>
                <c:pt idx="197">
                  <c:v>2.1923109376649643</c:v>
                </c:pt>
                <c:pt idx="198">
                  <c:v>2.1816959577652946</c:v>
                </c:pt>
                <c:pt idx="199">
                  <c:v>2.1704006616782872</c:v>
                </c:pt>
                <c:pt idx="200">
                  <c:v>2.1584300370887179</c:v>
                </c:pt>
                <c:pt idx="201">
                  <c:v>2.1457893698874182</c:v>
                </c:pt>
                <c:pt idx="202">
                  <c:v>2.1324842418371754</c:v>
                </c:pt>
                <c:pt idx="203">
                  <c:v>2.118520528107982</c:v>
                </c:pt>
                <c:pt idx="204">
                  <c:v>2.1039043946827256</c:v>
                </c:pt>
                <c:pt idx="205">
                  <c:v>2.0886422956344664</c:v>
                </c:pt>
                <c:pt idx="206">
                  <c:v>2.0727409702764983</c:v>
                </c:pt>
                <c:pt idx="207">
                  <c:v>2.056207440186459</c:v>
                </c:pt>
                <c:pt idx="208">
                  <c:v>2.039049006105798</c:v>
                </c:pt>
                <c:pt idx="209">
                  <c:v>2.0212732447159758</c:v>
                </c:pt>
                <c:pt idx="210">
                  <c:v>2.0028880052928142</c:v>
                </c:pt>
                <c:pt idx="211">
                  <c:v>1.9839014062404765</c:v>
                </c:pt>
                <c:pt idx="212">
                  <c:v>1.9643218315066102</c:v>
                </c:pt>
                <c:pt idx="213">
                  <c:v>1.9441579268802296</c:v>
                </c:pt>
                <c:pt idx="214">
                  <c:v>1.9234185961739825</c:v>
                </c:pt>
                <c:pt idx="215">
                  <c:v>1.9021129972924697</c:v>
                </c:pt>
                <c:pt idx="216">
                  <c:v>1.8802505381883823</c:v>
                </c:pt>
                <c:pt idx="217">
                  <c:v>1.8578408727082063</c:v>
                </c:pt>
                <c:pt idx="218">
                  <c:v>1.8348938963293606</c:v>
                </c:pt>
                <c:pt idx="219">
                  <c:v>1.8114197417906299</c:v>
                </c:pt>
                <c:pt idx="220">
                  <c:v>1.787428774617835</c:v>
                </c:pt>
                <c:pt idx="221">
                  <c:v>1.7629315885467047</c:v>
                </c:pt>
                <c:pt idx="222">
                  <c:v>1.7379390008449851</c:v>
                </c:pt>
                <c:pt idx="223">
                  <c:v>1.7124620475358348</c:v>
                </c:pt>
                <c:pt idx="224">
                  <c:v>1.6865119785246299</c:v>
                </c:pt>
                <c:pt idx="225">
                  <c:v>1.6601002526313211</c:v>
                </c:pt>
                <c:pt idx="226">
                  <c:v>1.6332385325305427</c:v>
                </c:pt>
                <c:pt idx="227">
                  <c:v>1.605938679601703</c:v>
                </c:pt>
                <c:pt idx="228">
                  <c:v>1.5782127486913333</c:v>
                </c:pt>
                <c:pt idx="229">
                  <c:v>1.5500729827900064</c:v>
                </c:pt>
                <c:pt idx="230">
                  <c:v>1.5215318076261775</c:v>
                </c:pt>
                <c:pt idx="231">
                  <c:v>1.4926018261793328</c:v>
                </c:pt>
                <c:pt idx="232">
                  <c:v>1.4632958131148657</c:v>
                </c:pt>
                <c:pt idx="233">
                  <c:v>1.4336267091431489</c:v>
                </c:pt>
                <c:pt idx="234">
                  <c:v>1.4036076153052766</c:v>
                </c:pt>
                <c:pt idx="235">
                  <c:v>1.3732517871880148</c:v>
                </c:pt>
                <c:pt idx="236">
                  <c:v>1.3425726290705096</c:v>
                </c:pt>
                <c:pt idx="237">
                  <c:v>1.3115836880053318</c:v>
                </c:pt>
                <c:pt idx="238">
                  <c:v>1.2802986478364811</c:v>
                </c:pt>
                <c:pt idx="239">
                  <c:v>1.248731323156987</c:v>
                </c:pt>
                <c:pt idx="240">
                  <c:v>1.2168956532087709</c:v>
                </c:pt>
                <c:pt idx="241">
                  <c:v>1.1848056957274715</c:v>
                </c:pt>
                <c:pt idx="242">
                  <c:v>1.1524756207349449</c:v>
                </c:pt>
                <c:pt idx="243">
                  <c:v>1.1199197042821758</c:v>
                </c:pt>
                <c:pt idx="244">
                  <c:v>1.0871523221453849</c:v>
                </c:pt>
                <c:pt idx="245">
                  <c:v>1.0541879434780848</c:v>
                </c:pt>
                <c:pt idx="246">
                  <c:v>1.0210411244219093</c:v>
                </c:pt>
                <c:pt idx="247">
                  <c:v>0.98772650167903242</c:v>
                </c:pt>
                <c:pt idx="248">
                  <c:v>0.95425878604901326</c:v>
                </c:pt>
                <c:pt idx="249">
                  <c:v>0.92065275593291851</c:v>
                </c:pt>
                <c:pt idx="250">
                  <c:v>0.88692325080759959</c:v>
                </c:pt>
                <c:pt idx="251">
                  <c:v>0.85308516467299544</c:v>
                </c:pt>
                <c:pt idx="252">
                  <c:v>0.81915343947536223</c:v>
                </c:pt>
                <c:pt idx="253">
                  <c:v>0.78514305850932997</c:v>
                </c:pt>
                <c:pt idx="254">
                  <c:v>0.75106903980170192</c:v>
                </c:pt>
                <c:pt idx="255">
                  <c:v>0.7169464294799166</c:v>
                </c:pt>
                <c:pt idx="256">
                  <c:v>0.68279029512810152</c:v>
                </c:pt>
                <c:pt idx="257">
                  <c:v>0.64861571913365235</c:v>
                </c:pt>
                <c:pt idx="258">
                  <c:v>0.61443779202727389</c:v>
                </c:pt>
                <c:pt idx="259">
                  <c:v>0.58027160581942916</c:v>
                </c:pt>
                <c:pt idx="260">
                  <c:v>0.54613224733612942</c:v>
                </c:pt>
                <c:pt idx="261">
                  <c:v>0.51203479155701925</c:v>
                </c:pt>
                <c:pt idx="262">
                  <c:v>0.47799429495868795</c:v>
                </c:pt>
                <c:pt idx="263">
                  <c:v>0.44402578886615462</c:v>
                </c:pt>
                <c:pt idx="264">
                  <c:v>0.41014427281545673</c:v>
                </c:pt>
                <c:pt idx="265">
                  <c:v>0.37636470793027876</c:v>
                </c:pt>
                <c:pt idx="266">
                  <c:v>0.3427020103155406</c:v>
                </c:pt>
                <c:pt idx="267">
                  <c:v>0.30917104447086519</c:v>
                </c:pt>
                <c:pt idx="268">
                  <c:v>0.27578661672683469</c:v>
                </c:pt>
                <c:pt idx="269">
                  <c:v>0.24256346870693046</c:v>
                </c:pt>
                <c:pt idx="270">
                  <c:v>0.20951627081804824</c:v>
                </c:pt>
                <c:pt idx="271">
                  <c:v>0.1766596157724607</c:v>
                </c:pt>
                <c:pt idx="272">
                  <c:v>0.14400801214408054</c:v>
                </c:pt>
                <c:pt idx="273">
                  <c:v>0.11157587796189161</c:v>
                </c:pt>
                <c:pt idx="274">
                  <c:v>7.9377534343346268E-2</c:v>
                </c:pt>
                <c:pt idx="275">
                  <c:v>4.7427199170566814E-2</c:v>
                </c:pt>
                <c:pt idx="276">
                  <c:v>1.5738980812126435E-2</c:v>
                </c:pt>
                <c:pt idx="277">
                  <c:v>-1.5673128106807432E-2</c:v>
                </c:pt>
                <c:pt idx="278">
                  <c:v>-4.6795256883222835E-2</c:v>
                </c:pt>
                <c:pt idx="279">
                  <c:v>-7.7613662861176325E-2</c:v>
                </c:pt>
                <c:pt idx="280">
                  <c:v>-0.10811473750016143</c:v>
                </c:pt>
                <c:pt idx="281">
                  <c:v>-0.13828501238425739</c:v>
                </c:pt>
                <c:pt idx="282">
                  <c:v>-0.16811116516940383</c:v>
                </c:pt>
                <c:pt idx="283">
                  <c:v>-0.19758002546617137</c:v>
                </c:pt>
                <c:pt idx="284">
                  <c:v>-0.22667858065543478</c:v>
                </c:pt>
                <c:pt idx="285">
                  <c:v>-0.25539398163438021</c:v>
                </c:pt>
                <c:pt idx="286">
                  <c:v>-0.2837135484903075</c:v>
                </c:pt>
                <c:pt idx="287">
                  <c:v>-0.31162477609972095</c:v>
                </c:pt>
                <c:pt idx="288">
                  <c:v>-0.33911533965024154</c:v>
                </c:pt>
                <c:pt idx="289">
                  <c:v>-0.36617310008289627</c:v>
                </c:pt>
                <c:pt idx="290">
                  <c:v>-0.39278610945238479</c:v>
                </c:pt>
                <c:pt idx="291">
                  <c:v>-0.41894261620295692</c:v>
                </c:pt>
                <c:pt idx="292">
                  <c:v>-0.44463107035756688</c:v>
                </c:pt>
                <c:pt idx="293">
                  <c:v>-0.46984012861801994</c:v>
                </c:pt>
                <c:pt idx="294">
                  <c:v>-0.49455865937385168</c:v>
                </c:pt>
                <c:pt idx="295">
                  <c:v>-0.51877574761773571</c:v>
                </c:pt>
                <c:pt idx="296">
                  <c:v>-0.5424806997652426</c:v>
                </c:pt>
                <c:pt idx="297">
                  <c:v>-0.56566304837682491</c:v>
                </c:pt>
                <c:pt idx="298">
                  <c:v>-0.58831255677994643</c:v>
                </c:pt>
                <c:pt idx="299">
                  <c:v>-0.6104192235893044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418624"/>
        <c:axId val="283419016"/>
      </c:scatterChart>
      <c:valAx>
        <c:axId val="283418624"/>
        <c:scaling>
          <c:orientation val="minMax"/>
          <c:max val="3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419016"/>
        <c:crosses val="autoZero"/>
        <c:crossBetween val="midCat"/>
      </c:valAx>
      <c:valAx>
        <c:axId val="283419016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418624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03089036947306"/>
          <c:y val="0.10679611650485436"/>
          <c:w val="0.6520752574197457"/>
          <c:h val="0.7039966363427872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>
              <a:noFill/>
            </a:ln>
            <a:effectLst/>
          </c:spPr>
          <c:marker>
            <c:symbol val="circle"/>
            <c:size val="3"/>
            <c:spPr>
              <a:solidFill>
                <a:srgbClr val="003CE6"/>
              </a:solidFill>
              <a:ln w="6350">
                <a:solidFill>
                  <a:srgbClr val="FF0000"/>
                </a:solidFill>
                <a:prstDash val="solid"/>
              </a:ln>
            </c:spPr>
          </c:marker>
          <c:trendline>
            <c:spPr>
              <a:ln w="12700">
                <a:solidFill>
                  <a:srgbClr val="FF0000"/>
                </a:solidFill>
                <a:prstDash val="solid"/>
              </a:ln>
            </c:spPr>
            <c:trendlineType val="linear"/>
            <c:dispRSqr val="0"/>
            <c:dispEq val="0"/>
          </c:trendline>
          <c:xVal>
            <c:numRef>
              <c:f>'Covariance   Correlation3_HID4'!$BC$1:$BC$15</c:f>
              <c:numCache>
                <c:formatCode>General</c:formatCode>
                <c:ptCount val="15"/>
                <c:pt idx="0">
                  <c:v>20.12323</c:v>
                </c:pt>
                <c:pt idx="1">
                  <c:v>0</c:v>
                </c:pt>
                <c:pt idx="2">
                  <c:v>0</c:v>
                </c:pt>
                <c:pt idx="3">
                  <c:v>9.9573979999999995</c:v>
                </c:pt>
                <c:pt idx="4">
                  <c:v>7.3840649999999997</c:v>
                </c:pt>
                <c:pt idx="5">
                  <c:v>182.50299999999999</c:v>
                </c:pt>
                <c:pt idx="6">
                  <c:v>215.07159999999999</c:v>
                </c:pt>
                <c:pt idx="7">
                  <c:v>168.19290000000001</c:v>
                </c:pt>
                <c:pt idx="8">
                  <c:v>170.3449</c:v>
                </c:pt>
                <c:pt idx="9">
                  <c:v>169.62780000000001</c:v>
                </c:pt>
                <c:pt idx="10">
                  <c:v>109.4692</c:v>
                </c:pt>
                <c:pt idx="11">
                  <c:v>104.2452</c:v>
                </c:pt>
                <c:pt idx="12">
                  <c:v>130.61089999999999</c:v>
                </c:pt>
                <c:pt idx="13">
                  <c:v>122.6031</c:v>
                </c:pt>
                <c:pt idx="14">
                  <c:v>129.15620000000001</c:v>
                </c:pt>
              </c:numCache>
            </c:numRef>
          </c:xVal>
          <c:yVal>
            <c:numRef>
              <c:f>'Covariance   Correlation3_HID4'!$BD$1:$BD$15</c:f>
              <c:numCache>
                <c:formatCode>General</c:formatCode>
                <c:ptCount val="15"/>
                <c:pt idx="0">
                  <c:v>9.1300000000000006E-2</c:v>
                </c:pt>
                <c:pt idx="1">
                  <c:v>0.44719999999999999</c:v>
                </c:pt>
                <c:pt idx="2">
                  <c:v>0.40560000000000002</c:v>
                </c:pt>
                <c:pt idx="3">
                  <c:v>0.29530000000000001</c:v>
                </c:pt>
                <c:pt idx="4">
                  <c:v>0.10879999999999999</c:v>
                </c:pt>
                <c:pt idx="5">
                  <c:v>1.6014999999999999</c:v>
                </c:pt>
                <c:pt idx="6">
                  <c:v>1.0639000000000001</c:v>
                </c:pt>
                <c:pt idx="7">
                  <c:v>1.5142</c:v>
                </c:pt>
                <c:pt idx="8">
                  <c:v>1.4415</c:v>
                </c:pt>
                <c:pt idx="9">
                  <c:v>1.0116000000000001</c:v>
                </c:pt>
                <c:pt idx="10">
                  <c:v>0.59709999999999996</c:v>
                </c:pt>
                <c:pt idx="11">
                  <c:v>0.1628</c:v>
                </c:pt>
                <c:pt idx="12">
                  <c:v>0.2384</c:v>
                </c:pt>
                <c:pt idx="13">
                  <c:v>2.1299999999999999E-2</c:v>
                </c:pt>
                <c:pt idx="14">
                  <c:v>0.6149</c:v>
                </c:pt>
              </c:numCache>
            </c:numRef>
          </c:yVal>
          <c:smooth val="0"/>
        </c:ser>
        <c:ser>
          <c:idx val="1"/>
          <c:order val="1"/>
          <c:tx>
            <c:v/>
          </c:tx>
          <c:spPr>
            <a:ln w="12700">
              <a:solidFill>
                <a:srgbClr val="003CE6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Covariance   Correlation3'!ycir34</c:f>
              <c:numCache>
                <c:formatCode>General</c:formatCode>
                <c:ptCount val="300"/>
                <c:pt idx="0">
                  <c:v>-121.20560024334098</c:v>
                </c:pt>
                <c:pt idx="1">
                  <c:v>-121.15618285593435</c:v>
                </c:pt>
                <c:pt idx="2">
                  <c:v>-121.00795251504154</c:v>
                </c:pt>
                <c:pt idx="3">
                  <c:v>-120.76097467500826</c:v>
                </c:pt>
                <c:pt idx="4">
                  <c:v>-120.41535839429595</c:v>
                </c:pt>
                <c:pt idx="5">
                  <c:v>-119.97125628732472</c:v>
                </c:pt>
                <c:pt idx="6">
                  <c:v>-119.42886445708298</c:v>
                </c:pt>
                <c:pt idx="7">
                  <c:v>-118.78842240853403</c:v>
                </c:pt>
                <c:pt idx="8">
                  <c:v>-118.0502129428573</c:v>
                </c:pt>
                <c:pt idx="9">
                  <c:v>-117.21456203257144</c:v>
                </c:pt>
                <c:pt idx="10">
                  <c:v>-116.28183867759385</c:v>
                </c:pt>
                <c:pt idx="11">
                  <c:v>-115.25245474230088</c:v>
                </c:pt>
                <c:pt idx="12">
                  <c:v>-114.12686477366002</c:v>
                </c:pt>
                <c:pt idx="13">
                  <c:v>-112.90556580051474</c:v>
                </c:pt>
                <c:pt idx="14">
                  <c:v>-111.58909711411066</c:v>
                </c:pt>
                <c:pt idx="15">
                  <c:v>-110.17804002995952</c:v>
                </c:pt>
                <c:pt idx="16">
                  <c:v>-108.67301763114686</c:v>
                </c:pt>
                <c:pt idx="17">
                  <c:v>-107.07469449319588</c:v>
                </c:pt>
                <c:pt idx="18">
                  <c:v>-105.38377639060964</c:v>
                </c:pt>
                <c:pt idx="19">
                  <c:v>-103.60100998522098</c:v>
                </c:pt>
                <c:pt idx="20">
                  <c:v>-101.7271824964876</c:v>
                </c:pt>
                <c:pt idx="21">
                  <c:v>-99.763121353878105</c:v>
                </c:pt>
                <c:pt idx="22">
                  <c:v>-97.709693831502491</c:v>
                </c:pt>
                <c:pt idx="23">
                  <c:v>-95.567806665148382</c:v>
                </c:pt>
                <c:pt idx="24">
                  <c:v>-93.338405651891733</c:v>
                </c:pt>
                <c:pt idx="25">
                  <c:v>-91.022475232459826</c:v>
                </c:pt>
                <c:pt idx="26">
                  <c:v>-88.621038056529827</c:v>
                </c:pt>
                <c:pt idx="27">
                  <c:v>-86.135154531155351</c:v>
                </c:pt>
                <c:pt idx="28">
                  <c:v>-83.565922352520758</c:v>
                </c:pt>
                <c:pt idx="29">
                  <c:v>-80.914476021229333</c:v>
                </c:pt>
                <c:pt idx="30">
                  <c:v>-78.181986341339652</c:v>
                </c:pt>
                <c:pt idx="31">
                  <c:v>-75.369659903371641</c:v>
                </c:pt>
                <c:pt idx="32">
                  <c:v>-72.478738551510119</c:v>
                </c:pt>
                <c:pt idx="33">
                  <c:v>-69.510498835241307</c:v>
                </c:pt>
                <c:pt idx="34">
                  <c:v>-66.466251445664582</c:v>
                </c:pt>
                <c:pt idx="35">
                  <c:v>-63.347340636727992</c:v>
                </c:pt>
                <c:pt idx="36">
                  <c:v>-60.155143631643952</c:v>
                </c:pt>
                <c:pt idx="37">
                  <c:v>-56.891070014745836</c:v>
                </c:pt>
                <c:pt idx="38">
                  <c:v>-53.556561109055465</c:v>
                </c:pt>
                <c:pt idx="39">
                  <c:v>-50.153089339835375</c:v>
                </c:pt>
                <c:pt idx="40">
                  <c:v>-46.682157584407165</c:v>
                </c:pt>
                <c:pt idx="41">
                  <c:v>-43.145298508523283</c:v>
                </c:pt>
                <c:pt idx="42">
                  <c:v>-39.544073889585107</c:v>
                </c:pt>
                <c:pt idx="43">
                  <c:v>-35.880073927005625</c:v>
                </c:pt>
                <c:pt idx="44">
                  <c:v>-32.154916540022569</c:v>
                </c:pt>
                <c:pt idx="45">
                  <c:v>-28.37024665327057</c:v>
                </c:pt>
                <c:pt idx="46">
                  <c:v>-24.527735470428794</c:v>
                </c:pt>
                <c:pt idx="47">
                  <c:v>-20.629079736264472</c:v>
                </c:pt>
                <c:pt idx="48">
                  <c:v>-16.676000987398197</c:v>
                </c:pt>
                <c:pt idx="49">
                  <c:v>-12.670244792121736</c:v>
                </c:pt>
                <c:pt idx="50">
                  <c:v>-8.6135799796043244</c:v>
                </c:pt>
                <c:pt idx="51">
                  <c:v>-4.5077978588273453</c:v>
                </c:pt>
                <c:pt idx="52">
                  <c:v>-0.35471142759286067</c:v>
                </c:pt>
                <c:pt idx="53">
                  <c:v>3.8438454280452277</c:v>
                </c:pt>
                <c:pt idx="54">
                  <c:v>8.0860187435735895</c:v>
                </c:pt>
                <c:pt idx="55">
                  <c:v>12.369935294678328</c:v>
                </c:pt>
                <c:pt idx="56">
                  <c:v>16.693703424407573</c:v>
                </c:pt>
                <c:pt idx="57">
                  <c:v>21.055413878474255</c:v>
                </c:pt>
                <c:pt idx="58">
                  <c:v>25.453140648329011</c:v>
                </c:pt>
                <c:pt idx="59">
                  <c:v>29.884941821631358</c:v>
                </c:pt>
                <c:pt idx="60">
                  <c:v>34.348860439743447</c:v>
                </c:pt>
                <c:pt idx="61">
                  <c:v>38.842925361867913</c:v>
                </c:pt>
                <c:pt idx="62">
                  <c:v>43.365152135448326</c:v>
                </c:pt>
                <c:pt idx="63">
                  <c:v>47.91354387244732</c:v>
                </c:pt>
                <c:pt idx="64">
                  <c:v>52.486092131116287</c:v>
                </c:pt>
                <c:pt idx="65">
                  <c:v>57.080777802866677</c:v>
                </c:pt>
                <c:pt idx="66">
                  <c:v>61.695572003851531</c:v>
                </c:pt>
                <c:pt idx="67">
                  <c:v>66.32843697086345</c:v>
                </c:pt>
                <c:pt idx="68">
                  <c:v>70.977326961153437</c:v>
                </c:pt>
                <c:pt idx="69">
                  <c:v>75.640189155773442</c:v>
                </c:pt>
                <c:pt idx="70">
                  <c:v>80.314964566043244</c:v>
                </c:pt>
                <c:pt idx="71">
                  <c:v>84.999588942741923</c:v>
                </c:pt>
                <c:pt idx="72">
                  <c:v>89.691993687622329</c:v>
                </c:pt>
                <c:pt idx="73">
                  <c:v>94.390106766845676</c:v>
                </c:pt>
                <c:pt idx="74">
                  <c:v>99.091853625933467</c:v>
                </c:pt>
                <c:pt idx="75">
                  <c:v>103.79515810583227</c:v>
                </c:pt>
                <c:pt idx="76">
                  <c:v>108.49794335968728</c:v>
                </c:pt>
                <c:pt idx="77">
                  <c:v>113.19813276991914</c:v>
                </c:pt>
                <c:pt idx="78">
                  <c:v>117.89365086520004</c:v>
                </c:pt>
                <c:pt idx="79">
                  <c:v>122.58242423692333</c:v>
                </c:pt>
                <c:pt idx="80">
                  <c:v>127.26238245476242</c:v>
                </c:pt>
                <c:pt idx="81">
                  <c:v>131.93145898091447</c:v>
                </c:pt>
                <c:pt idx="82">
                  <c:v>136.58759208262543</c:v>
                </c:pt>
                <c:pt idx="83">
                  <c:v>141.2287257425931</c:v>
                </c:pt>
                <c:pt idx="84">
                  <c:v>145.8528105668465</c:v>
                </c:pt>
                <c:pt idx="85">
                  <c:v>150.45780468970051</c:v>
                </c:pt>
                <c:pt idx="86">
                  <c:v>155.04167467538633</c:v>
                </c:pt>
                <c:pt idx="87">
                  <c:v>159.60239641595956</c:v>
                </c:pt>
                <c:pt idx="88">
                  <c:v>164.13795602508904</c:v>
                </c:pt>
                <c:pt idx="89">
                  <c:v>168.64635072733256</c:v>
                </c:pt>
                <c:pt idx="90">
                  <c:v>173.12558974250624</c:v>
                </c:pt>
                <c:pt idx="91">
                  <c:v>177.57369516475663</c:v>
                </c:pt>
                <c:pt idx="92">
                  <c:v>181.98870283594854</c:v>
                </c:pt>
                <c:pt idx="93">
                  <c:v>186.36866321298191</c:v>
                </c:pt>
                <c:pt idx="94">
                  <c:v>190.71164222865517</c:v>
                </c:pt>
                <c:pt idx="95">
                  <c:v>195.01572214569484</c:v>
                </c:pt>
                <c:pt idx="96">
                  <c:v>199.27900240357431</c:v>
                </c:pt>
                <c:pt idx="97">
                  <c:v>203.49960045774802</c:v>
                </c:pt>
                <c:pt idx="98">
                  <c:v>207.67565261092989</c:v>
                </c:pt>
                <c:pt idx="99">
                  <c:v>211.80531483604975</c:v>
                </c:pt>
                <c:pt idx="100">
                  <c:v>215.88676359052371</c:v>
                </c:pt>
                <c:pt idx="101">
                  <c:v>219.91819662147924</c:v>
                </c:pt>
                <c:pt idx="102">
                  <c:v>223.89783376157942</c:v>
                </c:pt>
                <c:pt idx="103">
                  <c:v>227.8239177150945</c:v>
                </c:pt>
                <c:pt idx="104">
                  <c:v>231.69471483387434</c:v>
                </c:pt>
                <c:pt idx="105">
                  <c:v>235.50851588287873</c:v>
                </c:pt>
                <c:pt idx="106">
                  <c:v>239.26363679492727</c:v>
                </c:pt>
                <c:pt idx="107">
                  <c:v>242.95841941433616</c:v>
                </c:pt>
                <c:pt idx="108">
                  <c:v>246.59123222911313</c:v>
                </c:pt>
                <c:pt idx="109">
                  <c:v>250.16047109138697</c:v>
                </c:pt>
                <c:pt idx="110">
                  <c:v>253.6645599257543</c:v>
                </c:pt>
                <c:pt idx="111">
                  <c:v>257.10195142522991</c:v>
                </c:pt>
                <c:pt idx="112">
                  <c:v>260.47112773449425</c:v>
                </c:pt>
                <c:pt idx="113">
                  <c:v>263.77060112013527</c:v>
                </c:pt>
                <c:pt idx="114">
                  <c:v>266.9989146275899</c:v>
                </c:pt>
                <c:pt idx="115">
                  <c:v>270.1546427244939</c:v>
                </c:pt>
                <c:pt idx="116">
                  <c:v>273.23639193015714</c:v>
                </c:pt>
                <c:pt idx="117">
                  <c:v>276.24280143088509</c:v>
                </c:pt>
                <c:pt idx="118">
                  <c:v>279.17254368087623</c:v>
                </c:pt>
                <c:pt idx="119">
                  <c:v>282.02432498842842</c:v>
                </c:pt>
                <c:pt idx="120">
                  <c:v>284.79688608719727</c:v>
                </c:pt>
                <c:pt idx="121">
                  <c:v>287.48900269225226</c:v>
                </c:pt>
                <c:pt idx="122">
                  <c:v>290.09948604068688</c:v>
                </c:pt>
                <c:pt idx="123">
                  <c:v>292.62718341654249</c:v>
                </c:pt>
                <c:pt idx="124">
                  <c:v>295.07097865981558</c:v>
                </c:pt>
                <c:pt idx="125">
                  <c:v>297.42979265932235</c:v>
                </c:pt>
                <c:pt idx="126">
                  <c:v>299.70258382920377</c:v>
                </c:pt>
                <c:pt idx="127">
                  <c:v>301.88834856886115</c:v>
                </c:pt>
                <c:pt idx="128">
                  <c:v>303.9861217061171</c:v>
                </c:pt>
                <c:pt idx="129">
                  <c:v>305.99497692340896</c:v>
                </c:pt>
                <c:pt idx="130">
                  <c:v>307.91402716682433</c:v>
                </c:pt>
                <c:pt idx="131">
                  <c:v>309.74242503779925</c:v>
                </c:pt>
                <c:pt idx="132">
                  <c:v>311.47936316730539</c:v>
                </c:pt>
                <c:pt idx="133">
                  <c:v>313.12407457236151</c:v>
                </c:pt>
                <c:pt idx="134">
                  <c:v>314.6758329947117</c:v>
                </c:pt>
                <c:pt idx="135">
                  <c:v>316.13395322152041</c:v>
                </c:pt>
                <c:pt idx="136">
                  <c:v>317.49779138794321</c:v>
                </c:pt>
                <c:pt idx="137">
                  <c:v>318.7667452614395</c:v>
                </c:pt>
                <c:pt idx="138">
                  <c:v>319.94025450770118</c:v>
                </c:pt>
                <c:pt idx="139">
                  <c:v>321.01780093808077</c:v>
                </c:pt>
                <c:pt idx="140">
                  <c:v>321.99890873840877</c:v>
                </c:pt>
                <c:pt idx="141">
                  <c:v>322.88314467909993</c:v>
                </c:pt>
                <c:pt idx="142">
                  <c:v>323.67011830645498</c:v>
                </c:pt>
                <c:pt idx="143">
                  <c:v>324.3594821150744</c:v>
                </c:pt>
                <c:pt idx="144">
                  <c:v>324.95093170130662</c:v>
                </c:pt>
                <c:pt idx="145">
                  <c:v>325.4442058976644</c:v>
                </c:pt>
                <c:pt idx="146">
                  <c:v>325.83908688814881</c:v>
                </c:pt>
                <c:pt idx="147">
                  <c:v>326.13540030443085</c:v>
                </c:pt>
                <c:pt idx="148">
                  <c:v>326.3330153028474</c:v>
                </c:pt>
                <c:pt idx="149">
                  <c:v>326.43184462217829</c:v>
                </c:pt>
                <c:pt idx="150">
                  <c:v>326.43184462217829</c:v>
                </c:pt>
                <c:pt idx="151">
                  <c:v>326.33301530284729</c:v>
                </c:pt>
                <c:pt idx="152">
                  <c:v>326.13540030443068</c:v>
                </c:pt>
                <c:pt idx="153">
                  <c:v>325.83908688814859</c:v>
                </c:pt>
                <c:pt idx="154">
                  <c:v>325.44420589766412</c:v>
                </c:pt>
                <c:pt idx="155">
                  <c:v>324.95093170130627</c:v>
                </c:pt>
                <c:pt idx="156">
                  <c:v>324.35948211507394</c:v>
                </c:pt>
                <c:pt idx="157">
                  <c:v>323.67011830645447</c:v>
                </c:pt>
                <c:pt idx="158">
                  <c:v>322.8831446790993</c:v>
                </c:pt>
                <c:pt idx="159">
                  <c:v>321.99890873840815</c:v>
                </c:pt>
                <c:pt idx="160">
                  <c:v>321.01780093808003</c:v>
                </c:pt>
                <c:pt idx="161">
                  <c:v>319.94025450770039</c:v>
                </c:pt>
                <c:pt idx="162">
                  <c:v>318.76674526143859</c:v>
                </c:pt>
                <c:pt idx="163">
                  <c:v>317.49779138794224</c:v>
                </c:pt>
                <c:pt idx="164">
                  <c:v>316.13395322151939</c:v>
                </c:pt>
                <c:pt idx="165">
                  <c:v>314.67583299471062</c:v>
                </c:pt>
                <c:pt idx="166">
                  <c:v>313.12407457236037</c:v>
                </c:pt>
                <c:pt idx="167">
                  <c:v>311.4793631673042</c:v>
                </c:pt>
                <c:pt idx="168">
                  <c:v>309.742425037798</c:v>
                </c:pt>
                <c:pt idx="169">
                  <c:v>307.91402716682302</c:v>
                </c:pt>
                <c:pt idx="170">
                  <c:v>305.99497692340759</c:v>
                </c:pt>
                <c:pt idx="171">
                  <c:v>303.98612170611568</c:v>
                </c:pt>
                <c:pt idx="172">
                  <c:v>301.88834856885967</c:v>
                </c:pt>
                <c:pt idx="173">
                  <c:v>299.70258382920224</c:v>
                </c:pt>
                <c:pt idx="174">
                  <c:v>297.4297926593207</c:v>
                </c:pt>
                <c:pt idx="175">
                  <c:v>295.07097865981393</c:v>
                </c:pt>
                <c:pt idx="176">
                  <c:v>292.62718341654079</c:v>
                </c:pt>
                <c:pt idx="177">
                  <c:v>290.09948604068506</c:v>
                </c:pt>
                <c:pt idx="178">
                  <c:v>287.48900269225044</c:v>
                </c:pt>
                <c:pt idx="179">
                  <c:v>284.79688608719533</c:v>
                </c:pt>
                <c:pt idx="180">
                  <c:v>282.02432498842643</c:v>
                </c:pt>
                <c:pt idx="181">
                  <c:v>279.17254368087418</c:v>
                </c:pt>
                <c:pt idx="182">
                  <c:v>276.24280143088305</c:v>
                </c:pt>
                <c:pt idx="183">
                  <c:v>273.23639193015504</c:v>
                </c:pt>
                <c:pt idx="184">
                  <c:v>270.15464272449174</c:v>
                </c:pt>
                <c:pt idx="185">
                  <c:v>266.99891462758768</c:v>
                </c:pt>
                <c:pt idx="186">
                  <c:v>263.77060112013299</c:v>
                </c:pt>
                <c:pt idx="187">
                  <c:v>260.47112773449192</c:v>
                </c:pt>
                <c:pt idx="188">
                  <c:v>257.10195142522753</c:v>
                </c:pt>
                <c:pt idx="189">
                  <c:v>253.66455992575186</c:v>
                </c:pt>
                <c:pt idx="190">
                  <c:v>250.16047109138447</c:v>
                </c:pt>
                <c:pt idx="191">
                  <c:v>246.59123222911069</c:v>
                </c:pt>
                <c:pt idx="192">
                  <c:v>242.95841941433366</c:v>
                </c:pt>
                <c:pt idx="193">
                  <c:v>239.26363679492471</c:v>
                </c:pt>
                <c:pt idx="194">
                  <c:v>235.50851588287611</c:v>
                </c:pt>
                <c:pt idx="195">
                  <c:v>231.69471483387167</c:v>
                </c:pt>
                <c:pt idx="196">
                  <c:v>227.8239177150918</c:v>
                </c:pt>
                <c:pt idx="197">
                  <c:v>223.89783376157666</c:v>
                </c:pt>
                <c:pt idx="198">
                  <c:v>219.91819662147645</c:v>
                </c:pt>
                <c:pt idx="199">
                  <c:v>215.88676359052087</c:v>
                </c:pt>
                <c:pt idx="200">
                  <c:v>211.80531483604688</c:v>
                </c:pt>
                <c:pt idx="201">
                  <c:v>207.67565261092699</c:v>
                </c:pt>
                <c:pt idx="202">
                  <c:v>203.49960045774509</c:v>
                </c:pt>
                <c:pt idx="203">
                  <c:v>199.27900240357135</c:v>
                </c:pt>
                <c:pt idx="204">
                  <c:v>195.01572214569183</c:v>
                </c:pt>
                <c:pt idx="205">
                  <c:v>190.71164222865212</c:v>
                </c:pt>
                <c:pt idx="206">
                  <c:v>186.36866321297884</c:v>
                </c:pt>
                <c:pt idx="207">
                  <c:v>181.98870283594545</c:v>
                </c:pt>
                <c:pt idx="208">
                  <c:v>177.5736951647535</c:v>
                </c:pt>
                <c:pt idx="209">
                  <c:v>173.12558974250308</c:v>
                </c:pt>
                <c:pt idx="210">
                  <c:v>168.64635072732938</c:v>
                </c:pt>
                <c:pt idx="211">
                  <c:v>164.13795602508577</c:v>
                </c:pt>
                <c:pt idx="212">
                  <c:v>159.60239641595626</c:v>
                </c:pt>
                <c:pt idx="213">
                  <c:v>155.04167467538306</c:v>
                </c:pt>
                <c:pt idx="214">
                  <c:v>150.45780468969741</c:v>
                </c:pt>
                <c:pt idx="215">
                  <c:v>145.85281056684337</c:v>
                </c:pt>
                <c:pt idx="216">
                  <c:v>141.22872574258997</c:v>
                </c:pt>
                <c:pt idx="217">
                  <c:v>136.58759208262228</c:v>
                </c:pt>
                <c:pt idx="218">
                  <c:v>131.93145898091129</c:v>
                </c:pt>
                <c:pt idx="219">
                  <c:v>127.26238245475921</c:v>
                </c:pt>
                <c:pt idx="220">
                  <c:v>122.5824242369201</c:v>
                </c:pt>
                <c:pt idx="221">
                  <c:v>117.89365086519682</c:v>
                </c:pt>
                <c:pt idx="222">
                  <c:v>113.19813276991592</c:v>
                </c:pt>
                <c:pt idx="223">
                  <c:v>108.49794335968404</c:v>
                </c:pt>
                <c:pt idx="224">
                  <c:v>103.79515810582905</c:v>
                </c:pt>
                <c:pt idx="225">
                  <c:v>99.091853625930199</c:v>
                </c:pt>
                <c:pt idx="226">
                  <c:v>94.390106766842393</c:v>
                </c:pt>
                <c:pt idx="227">
                  <c:v>89.691993687619046</c:v>
                </c:pt>
                <c:pt idx="228">
                  <c:v>84.999588942738654</c:v>
                </c:pt>
                <c:pt idx="229">
                  <c:v>80.314964566039976</c:v>
                </c:pt>
                <c:pt idx="230">
                  <c:v>75.640189155770187</c:v>
                </c:pt>
                <c:pt idx="231">
                  <c:v>70.977326961150183</c:v>
                </c:pt>
                <c:pt idx="232">
                  <c:v>66.328436970860167</c:v>
                </c:pt>
                <c:pt idx="233">
                  <c:v>61.695572003848262</c:v>
                </c:pt>
                <c:pt idx="234">
                  <c:v>57.080777802863423</c:v>
                </c:pt>
                <c:pt idx="235">
                  <c:v>52.48609213111304</c:v>
                </c:pt>
                <c:pt idx="236">
                  <c:v>47.913543872444102</c:v>
                </c:pt>
                <c:pt idx="237">
                  <c:v>43.365152135445122</c:v>
                </c:pt>
                <c:pt idx="238">
                  <c:v>38.842925361864715</c:v>
                </c:pt>
                <c:pt idx="239">
                  <c:v>34.348860439740221</c:v>
                </c:pt>
                <c:pt idx="240">
                  <c:v>29.884941821628161</c:v>
                </c:pt>
                <c:pt idx="241">
                  <c:v>25.453140648325828</c:v>
                </c:pt>
                <c:pt idx="242">
                  <c:v>21.055413878471285</c:v>
                </c:pt>
                <c:pt idx="243">
                  <c:v>16.693703424404632</c:v>
                </c:pt>
                <c:pt idx="244">
                  <c:v>12.369935294675429</c:v>
                </c:pt>
                <c:pt idx="245">
                  <c:v>8.0860187435707047</c:v>
                </c:pt>
                <c:pt idx="246">
                  <c:v>3.843845428042286</c:v>
                </c:pt>
                <c:pt idx="247">
                  <c:v>-0.35471142759578811</c:v>
                </c:pt>
                <c:pt idx="248">
                  <c:v>-4.5077978588302301</c:v>
                </c:pt>
                <c:pt idx="249">
                  <c:v>-8.6135799796071666</c:v>
                </c:pt>
                <c:pt idx="250">
                  <c:v>-12.670244792124578</c:v>
                </c:pt>
                <c:pt idx="251">
                  <c:v>-16.676000987400982</c:v>
                </c:pt>
                <c:pt idx="252">
                  <c:v>-20.629079736267215</c:v>
                </c:pt>
                <c:pt idx="253">
                  <c:v>-24.52773547043148</c:v>
                </c:pt>
                <c:pt idx="254">
                  <c:v>-28.370246653273242</c:v>
                </c:pt>
                <c:pt idx="255">
                  <c:v>-32.154916540025184</c:v>
                </c:pt>
                <c:pt idx="256">
                  <c:v>-35.880073927008212</c:v>
                </c:pt>
                <c:pt idx="257">
                  <c:v>-39.544073889587636</c:v>
                </c:pt>
                <c:pt idx="258">
                  <c:v>-43.145298508525784</c:v>
                </c:pt>
                <c:pt idx="259">
                  <c:v>-46.68215758440958</c:v>
                </c:pt>
                <c:pt idx="260">
                  <c:v>-50.153089339837763</c:v>
                </c:pt>
                <c:pt idx="261">
                  <c:v>-53.556561109057824</c:v>
                </c:pt>
                <c:pt idx="262">
                  <c:v>-56.891070014748138</c:v>
                </c:pt>
                <c:pt idx="263">
                  <c:v>-60.155143631646197</c:v>
                </c:pt>
                <c:pt idx="264">
                  <c:v>-63.347340636730209</c:v>
                </c:pt>
                <c:pt idx="265">
                  <c:v>-66.466251445666742</c:v>
                </c:pt>
                <c:pt idx="266">
                  <c:v>-69.510498835243467</c:v>
                </c:pt>
                <c:pt idx="267">
                  <c:v>-72.478738551512251</c:v>
                </c:pt>
                <c:pt idx="268">
                  <c:v>-75.369659903373716</c:v>
                </c:pt>
                <c:pt idx="269">
                  <c:v>-78.181986341341641</c:v>
                </c:pt>
                <c:pt idx="270">
                  <c:v>-80.914476021231238</c:v>
                </c:pt>
                <c:pt idx="271">
                  <c:v>-83.565922352522549</c:v>
                </c:pt>
                <c:pt idx="272">
                  <c:v>-86.135154531157056</c:v>
                </c:pt>
                <c:pt idx="273">
                  <c:v>-88.621038056531447</c:v>
                </c:pt>
                <c:pt idx="274">
                  <c:v>-91.022475232461417</c:v>
                </c:pt>
                <c:pt idx="275">
                  <c:v>-93.338405651893268</c:v>
                </c:pt>
                <c:pt idx="276">
                  <c:v>-95.56780666514986</c:v>
                </c:pt>
                <c:pt idx="277">
                  <c:v>-97.709693831503969</c:v>
                </c:pt>
                <c:pt idx="278">
                  <c:v>-99.763121353879527</c:v>
                </c:pt>
                <c:pt idx="279">
                  <c:v>-101.72718249648894</c:v>
                </c:pt>
                <c:pt idx="280">
                  <c:v>-103.60100998522229</c:v>
                </c:pt>
                <c:pt idx="281">
                  <c:v>-105.38377639061086</c:v>
                </c:pt>
                <c:pt idx="282">
                  <c:v>-107.07469449319704</c:v>
                </c:pt>
                <c:pt idx="283">
                  <c:v>-108.67301763114797</c:v>
                </c:pt>
                <c:pt idx="284">
                  <c:v>-110.17804002996054</c:v>
                </c:pt>
                <c:pt idx="285">
                  <c:v>-111.5890971141116</c:v>
                </c:pt>
                <c:pt idx="286">
                  <c:v>-112.90556580051562</c:v>
                </c:pt>
                <c:pt idx="287">
                  <c:v>-114.12686477366084</c:v>
                </c:pt>
                <c:pt idx="288">
                  <c:v>-115.25245474230162</c:v>
                </c:pt>
                <c:pt idx="289">
                  <c:v>-116.28183867759456</c:v>
                </c:pt>
                <c:pt idx="290">
                  <c:v>-117.21456203257206</c:v>
                </c:pt>
                <c:pt idx="291">
                  <c:v>-118.05021294285784</c:v>
                </c:pt>
                <c:pt idx="292">
                  <c:v>-118.78842240853452</c:v>
                </c:pt>
                <c:pt idx="293">
                  <c:v>-119.42886445708341</c:v>
                </c:pt>
                <c:pt idx="294">
                  <c:v>-119.97125628732506</c:v>
                </c:pt>
                <c:pt idx="295">
                  <c:v>-120.41535839429623</c:v>
                </c:pt>
                <c:pt idx="296">
                  <c:v>-120.76097467500846</c:v>
                </c:pt>
                <c:pt idx="297">
                  <c:v>-121.00795251504165</c:v>
                </c:pt>
                <c:pt idx="298">
                  <c:v>-121.1561828559344</c:v>
                </c:pt>
                <c:pt idx="299">
                  <c:v>-121.20560024334098</c:v>
                </c:pt>
              </c:numCache>
            </c:numRef>
          </c:xVal>
          <c:yVal>
            <c:numRef>
              <c:f>'Covariance   Correlation3'!yycir35</c:f>
              <c:numCache>
                <c:formatCode>General</c:formatCode>
                <c:ptCount val="300"/>
                <c:pt idx="0">
                  <c:v>-0.50040499978392672</c:v>
                </c:pt>
                <c:pt idx="1">
                  <c:v>-0.52450039110313251</c:v>
                </c:pt>
                <c:pt idx="2">
                  <c:v>-0.54808111848455332</c:v>
                </c:pt>
                <c:pt idx="3">
                  <c:v>-0.57113676934280155</c:v>
                </c:pt>
                <c:pt idx="4">
                  <c:v>-0.59365716295150139</c:v>
                </c:pt>
                <c:pt idx="5">
                  <c:v>-0.61563235493881074</c:v>
                </c:pt>
                <c:pt idx="6">
                  <c:v>-0.63705264167857412</c:v>
                </c:pt>
                <c:pt idx="7">
                  <c:v>-0.65790856457517288</c:v>
                </c:pt>
                <c:pt idx="8">
                  <c:v>-0.67819091424017497</c:v>
                </c:pt>
                <c:pt idx="9">
                  <c:v>-0.69789073455893957</c:v>
                </c:pt>
                <c:pt idx="10">
                  <c:v>-0.71699932664538579</c:v>
                </c:pt>
                <c:pt idx="11">
                  <c:v>-0.73550825268317754</c:v>
                </c:pt>
                <c:pt idx="12">
                  <c:v>-0.75340933965162438</c:v>
                </c:pt>
                <c:pt idx="13">
                  <c:v>-0.77069468293465671</c:v>
                </c:pt>
                <c:pt idx="14">
                  <c:v>-0.78735664981128295</c:v>
                </c:pt>
                <c:pt idx="15">
                  <c:v>-0.80338788282598439</c:v>
                </c:pt>
                <c:pt idx="16">
                  <c:v>-0.81878130303755881</c:v>
                </c:pt>
                <c:pt idx="17">
                  <c:v>-0.83353011314498371</c:v>
                </c:pt>
                <c:pt idx="18">
                  <c:v>-0.84762780048891129</c:v>
                </c:pt>
                <c:pt idx="19">
                  <c:v>-0.86106813992747677</c:v>
                </c:pt>
                <c:pt idx="20">
                  <c:v>-0.87384519658514503</c:v>
                </c:pt>
                <c:pt idx="21">
                  <c:v>-0.8859533284733847</c:v>
                </c:pt>
                <c:pt idx="22">
                  <c:v>-0.89738718898201197</c:v>
                </c:pt>
                <c:pt idx="23">
                  <c:v>-0.90814172924010217</c:v>
                </c:pt>
                <c:pt idx="24">
                  <c:v>-0.91821220034543072</c:v>
                </c:pt>
                <c:pt idx="25">
                  <c:v>-0.92759415546145241</c:v>
                </c:pt>
                <c:pt idx="26">
                  <c:v>-0.93628345178090056</c:v>
                </c:pt>
                <c:pt idx="27">
                  <c:v>-0.94427625235513457</c:v>
                </c:pt>
                <c:pt idx="28">
                  <c:v>-0.95156902778842722</c:v>
                </c:pt>
                <c:pt idx="29">
                  <c:v>-0.95815855779644721</c:v>
                </c:pt>
                <c:pt idx="30">
                  <c:v>-0.96404193262824589</c:v>
                </c:pt>
                <c:pt idx="31">
                  <c:v>-0.96921655435112108</c:v>
                </c:pt>
                <c:pt idx="32">
                  <c:v>-0.97368013799779196</c:v>
                </c:pt>
                <c:pt idx="33">
                  <c:v>-0.97743071257537462</c:v>
                </c:pt>
                <c:pt idx="34">
                  <c:v>-0.98046662193571898</c:v>
                </c:pt>
                <c:pt idx="35">
                  <c:v>-0.98278652550671552</c:v>
                </c:pt>
                <c:pt idx="36">
                  <c:v>-0.98438939888425558</c:v>
                </c:pt>
                <c:pt idx="37">
                  <c:v>-0.98527453428457823</c:v>
                </c:pt>
                <c:pt idx="38">
                  <c:v>-0.98544154085680813</c:v>
                </c:pt>
                <c:pt idx="39">
                  <c:v>-0.98489034485554461</c:v>
                </c:pt>
                <c:pt idx="40">
                  <c:v>-0.98362118967342504</c:v>
                </c:pt>
                <c:pt idx="41">
                  <c:v>-0.98163463573364929</c:v>
                </c:pt>
                <c:pt idx="42">
                  <c:v>-0.97893156024251404</c:v>
                </c:pt>
                <c:pt idx="43">
                  <c:v>-0.97551315680206074</c:v>
                </c:pt>
                <c:pt idx="44">
                  <c:v>-0.97138093488301724</c:v>
                </c:pt>
                <c:pt idx="45">
                  <c:v>-0.96653671915825612</c:v>
                </c:pt>
                <c:pt idx="46">
                  <c:v>-0.96098264869707117</c:v>
                </c:pt>
                <c:pt idx="47">
                  <c:v>-0.95472117602062445</c:v>
                </c:pt>
                <c:pt idx="48">
                  <c:v>-0.9477550660189823</c:v>
                </c:pt>
                <c:pt idx="49">
                  <c:v>-0.94008739473021741</c:v>
                </c:pt>
                <c:pt idx="50">
                  <c:v>-0.93172154798211748</c:v>
                </c:pt>
                <c:pt idx="51">
                  <c:v>-0.92266121989709771</c:v>
                </c:pt>
                <c:pt idx="52">
                  <c:v>-0.91291041126098216</c:v>
                </c:pt>
                <c:pt idx="53">
                  <c:v>-0.90247342775636785</c:v>
                </c:pt>
                <c:pt idx="54">
                  <c:v>-0.89135487806135782</c:v>
                </c:pt>
                <c:pt idx="55">
                  <c:v>-0.8795596718144969</c:v>
                </c:pt>
                <c:pt idx="56">
                  <c:v>-0.86709301744681544</c:v>
                </c:pt>
                <c:pt idx="57">
                  <c:v>-0.85396041988193094</c:v>
                </c:pt>
                <c:pt idx="58">
                  <c:v>-0.84016767810523119</c:v>
                </c:pt>
                <c:pt idx="59">
                  <c:v>-0.82572088260320298</c:v>
                </c:pt>
                <c:pt idx="60">
                  <c:v>-0.81062641267404567</c:v>
                </c:pt>
                <c:pt idx="61">
                  <c:v>-0.79489093361075414</c:v>
                </c:pt>
                <c:pt idx="62">
                  <c:v>-0.77852139375790985</c:v>
                </c:pt>
                <c:pt idx="63">
                  <c:v>-0.76152502144349121</c:v>
                </c:pt>
                <c:pt idx="64">
                  <c:v>-0.74390932178704494</c:v>
                </c:pt>
                <c:pt idx="65">
                  <c:v>-0.72568207338563651</c:v>
                </c:pt>
                <c:pt idx="66">
                  <c:v>-0.70685132487904268</c:v>
                </c:pt>
                <c:pt idx="67">
                  <c:v>-0.68742539139569625</c:v>
                </c:pt>
                <c:pt idx="68">
                  <c:v>-0.66741285088096169</c:v>
                </c:pt>
                <c:pt idx="69">
                  <c:v>-0.64682254030935349</c:v>
                </c:pt>
                <c:pt idx="70">
                  <c:v>-0.62566355178237965</c:v>
                </c:pt>
                <c:pt idx="71">
                  <c:v>-0.6039452285137239</c:v>
                </c:pt>
                <c:pt idx="72">
                  <c:v>-0.58167716070354591</c:v>
                </c:pt>
                <c:pt idx="73">
                  <c:v>-0.55886918130371865</c:v>
                </c:pt>
                <c:pt idx="74">
                  <c:v>-0.53553136167587467</c:v>
                </c:pt>
                <c:pt idx="75">
                  <c:v>-0.51167400714417499</c:v>
                </c:pt>
                <c:pt idx="76">
                  <c:v>-0.48730765244476898</c:v>
                </c:pt>
                <c:pt idx="77">
                  <c:v>-0.46244305707395061</c:v>
                </c:pt>
                <c:pt idx="78">
                  <c:v>-0.43709120053706907</c:v>
                </c:pt>
                <c:pt idx="79">
                  <c:v>-0.41126327750028713</c:v>
                </c:pt>
                <c:pt idx="80">
                  <c:v>-0.3849706928473321</c:v>
                </c:pt>
                <c:pt idx="81">
                  <c:v>-0.35822505664342019</c:v>
                </c:pt>
                <c:pt idx="82">
                  <c:v>-0.33103817900857901</c:v>
                </c:pt>
                <c:pt idx="83">
                  <c:v>-0.30342206490262952</c:v>
                </c:pt>
                <c:pt idx="84">
                  <c:v>-0.27538890882413619</c:v>
                </c:pt>
                <c:pt idx="85">
                  <c:v>-0.24695108942565741</c:v>
                </c:pt>
                <c:pt idx="86">
                  <c:v>-0.21812116404768261</c:v>
                </c:pt>
                <c:pt idx="87">
                  <c:v>-0.18891186317366276</c:v>
                </c:pt>
                <c:pt idx="88">
                  <c:v>-0.15933608480858857</c:v>
                </c:pt>
                <c:pt idx="89">
                  <c:v>-0.12940688878359452</c:v>
                </c:pt>
                <c:pt idx="90">
                  <c:v>-9.9137490989103016E-2</c:v>
                </c:pt>
                <c:pt idx="91">
                  <c:v>-6.8541257539062261E-2</c:v>
                </c:pt>
                <c:pt idx="92">
                  <c:v>-3.7631698868844488E-2</c:v>
                </c:pt>
                <c:pt idx="93">
                  <c:v>-6.4224637694191844E-3</c:v>
                </c:pt>
                <c:pt idx="94">
                  <c:v>2.5072666639569807E-2</c:v>
                </c:pt>
                <c:pt idx="95">
                  <c:v>5.6839784995158127E-2</c:v>
                </c:pt>
                <c:pt idx="96">
                  <c:v>8.8864863832160079E-2</c:v>
                </c:pt>
                <c:pt idx="97">
                  <c:v>0.12113376177730495</c:v>
                </c:pt>
                <c:pt idx="98">
                  <c:v>0.15363222979366642</c:v>
                </c:pt>
                <c:pt idx="99">
                  <c:v>0.18634591747263729</c:v>
                </c:pt>
                <c:pt idx="100">
                  <c:v>0.219260379370667</c:v>
                </c:pt>
                <c:pt idx="101">
                  <c:v>0.25236108138796087</c:v>
                </c:pt>
                <c:pt idx="102">
                  <c:v>0.28563340718633112</c:v>
                </c:pt>
                <c:pt idx="103">
                  <c:v>0.31906266464335931</c:v>
                </c:pt>
                <c:pt idx="104">
                  <c:v>0.3526340923400243</c:v>
                </c:pt>
                <c:pt idx="105">
                  <c:v>0.38633286607892969</c:v>
                </c:pt>
                <c:pt idx="106">
                  <c:v>0.42014410543025138</c:v>
                </c:pt>
                <c:pt idx="107">
                  <c:v>0.45405288030251667</c:v>
                </c:pt>
                <c:pt idx="108">
                  <c:v>0.48804421753531402</c:v>
                </c:pt>
                <c:pt idx="109">
                  <c:v>0.52210310751101607</c:v>
                </c:pt>
                <c:pt idx="110">
                  <c:v>0.55621451078260642</c:v>
                </c:pt>
                <c:pt idx="111">
                  <c:v>0.59036336471467554</c:v>
                </c:pt>
                <c:pt idx="112">
                  <c:v>0.6245345901346564</c:v>
                </c:pt>
                <c:pt idx="113">
                  <c:v>0.65871309799136302</c:v>
                </c:pt>
                <c:pt idx="114">
                  <c:v>0.69288379601788996</c:v>
                </c:pt>
                <c:pt idx="115">
                  <c:v>0.72703159539593309</c:v>
                </c:pt>
                <c:pt idx="116">
                  <c:v>0.7611414174185871</c:v>
                </c:pt>
                <c:pt idx="117">
                  <c:v>0.79519820014867715</c:v>
                </c:pt>
                <c:pt idx="118">
                  <c:v>0.82918690506968762</c:v>
                </c:pt>
                <c:pt idx="119">
                  <c:v>0.86309252372634604</c:v>
                </c:pt>
                <c:pt idx="120">
                  <c:v>0.89690008435193591</c:v>
                </c:pt>
                <c:pt idx="121">
                  <c:v>0.93059465847940592</c:v>
                </c:pt>
                <c:pt idx="122">
                  <c:v>0.96416136753336401</c:v>
                </c:pt>
                <c:pt idx="123">
                  <c:v>0.99758538940003239</c:v>
                </c:pt>
                <c:pt idx="124">
                  <c:v>1.0308519649722794</c:v>
                </c:pt>
                <c:pt idx="125">
                  <c:v>1.063946404666825</c:v>
                </c:pt>
                <c:pt idx="126">
                  <c:v>1.0968540949107459</c:v>
                </c:pt>
                <c:pt idx="127">
                  <c:v>1.1295605045944201</c:v>
                </c:pt>
                <c:pt idx="128">
                  <c:v>1.1620511914880545</c:v>
                </c:pt>
                <c:pt idx="129">
                  <c:v>1.1943118086189664</c:v>
                </c:pt>
                <c:pt idx="130">
                  <c:v>1.2263281106068051</c:v>
                </c:pt>
                <c:pt idx="131">
                  <c:v>1.2580859599539078</c:v>
                </c:pt>
                <c:pt idx="132">
                  <c:v>1.2895713332880232</c:v>
                </c:pt>
                <c:pt idx="133">
                  <c:v>1.3207703275546359</c:v>
                </c:pt>
                <c:pt idx="134">
                  <c:v>1.3516691661561655</c:v>
                </c:pt>
                <c:pt idx="135">
                  <c:v>1.3822542050353237</c:v>
                </c:pt>
                <c:pt idx="136">
                  <c:v>1.4125119386999441</c:v>
                </c:pt>
                <c:pt idx="137">
                  <c:v>1.4424290061866327</c:v>
                </c:pt>
                <c:pt idx="138">
                  <c:v>1.4719921969605854</c:v>
                </c:pt>
                <c:pt idx="139">
                  <c:v>1.501188456748995</c:v>
                </c:pt>
                <c:pt idx="140">
                  <c:v>1.5300048933054471</c:v>
                </c:pt>
                <c:pt idx="141">
                  <c:v>1.5584287821027738</c:v>
                </c:pt>
                <c:pt idx="142">
                  <c:v>1.5864475719518474</c:v>
                </c:pt>
                <c:pt idx="143">
                  <c:v>1.6140488905438324</c:v>
                </c:pt>
                <c:pt idx="144">
                  <c:v>1.6412205499134465</c:v>
                </c:pt>
                <c:pt idx="145">
                  <c:v>1.6679505518208257</c:v>
                </c:pt>
                <c:pt idx="146">
                  <c:v>1.6942270930496084</c:v>
                </c:pt>
                <c:pt idx="147">
                  <c:v>1.7200385706189025</c:v>
                </c:pt>
                <c:pt idx="148">
                  <c:v>1.7453735869068363</c:v>
                </c:pt>
                <c:pt idx="149">
                  <c:v>1.7702209546834267</c:v>
                </c:pt>
                <c:pt idx="150">
                  <c:v>1.7945697020505449</c:v>
                </c:pt>
                <c:pt idx="151">
                  <c:v>1.8184090772868</c:v>
                </c:pt>
                <c:pt idx="152">
                  <c:v>1.8417285535951928</c:v>
                </c:pt>
                <c:pt idx="153">
                  <c:v>1.8645178337514559</c:v>
                </c:pt>
                <c:pt idx="154">
                  <c:v>1.8867668546510166</c:v>
                </c:pt>
                <c:pt idx="155">
                  <c:v>1.9084657917525809</c:v>
                </c:pt>
                <c:pt idx="156">
                  <c:v>1.9296050634163748</c:v>
                </c:pt>
                <c:pt idx="157">
                  <c:v>1.9501753351351265</c:v>
                </c:pt>
                <c:pt idx="158">
                  <c:v>1.9701675236559217</c:v>
                </c:pt>
                <c:pt idx="159">
                  <c:v>1.9895728009911133</c:v>
                </c:pt>
                <c:pt idx="160">
                  <c:v>2.0083825983165102</c:v>
                </c:pt>
                <c:pt idx="161">
                  <c:v>2.0265886097551307</c:v>
                </c:pt>
                <c:pt idx="162">
                  <c:v>2.0441827960448444</c:v>
                </c:pt>
                <c:pt idx="163">
                  <c:v>2.0611573880882816</c:v>
                </c:pt>
                <c:pt idx="164">
                  <c:v>2.0775048903834508</c:v>
                </c:pt>
                <c:pt idx="165">
                  <c:v>2.0932180843335391</c:v>
                </c:pt>
                <c:pt idx="166">
                  <c:v>2.1082900314344428</c:v>
                </c:pt>
                <c:pt idx="167">
                  <c:v>2.1227140763386148</c:v>
                </c:pt>
                <c:pt idx="168">
                  <c:v>2.1364838497938785</c:v>
                </c:pt>
                <c:pt idx="169">
                  <c:v>2.1495932714559114</c:v>
                </c:pt>
                <c:pt idx="170">
                  <c:v>2.1620365525731522</c:v>
                </c:pt>
                <c:pt idx="171">
                  <c:v>2.1738081985429529</c:v>
                </c:pt>
                <c:pt idx="172">
                  <c:v>2.1849030113378385</c:v>
                </c:pt>
                <c:pt idx="173">
                  <c:v>2.1953160918008106</c:v>
                </c:pt>
                <c:pt idx="174">
                  <c:v>2.2050428418086763</c:v>
                </c:pt>
                <c:pt idx="175">
                  <c:v>2.214078966302452</c:v>
                </c:pt>
                <c:pt idx="176">
                  <c:v>2.2224204751839376</c:v>
                </c:pt>
                <c:pt idx="177">
                  <c:v>2.230063685077635</c:v>
                </c:pt>
                <c:pt idx="178">
                  <c:v>2.23700522095722</c:v>
                </c:pt>
                <c:pt idx="179">
                  <c:v>2.2432420176358603</c:v>
                </c:pt>
                <c:pt idx="180">
                  <c:v>2.2487713211197158</c:v>
                </c:pt>
                <c:pt idx="181">
                  <c:v>2.2535906898240241</c:v>
                </c:pt>
                <c:pt idx="182">
                  <c:v>2.2576979956512364</c:v>
                </c:pt>
                <c:pt idx="183">
                  <c:v>2.2610914249307243</c:v>
                </c:pt>
                <c:pt idx="184">
                  <c:v>2.2637694792196474</c:v>
                </c:pt>
                <c:pt idx="185">
                  <c:v>2.265730975964622</c:v>
                </c:pt>
                <c:pt idx="186">
                  <c:v>2.2669750490239036</c:v>
                </c:pt>
                <c:pt idx="187">
                  <c:v>2.2675011490498513</c:v>
                </c:pt>
                <c:pt idx="188">
                  <c:v>2.2673090437315038</c:v>
                </c:pt>
                <c:pt idx="189">
                  <c:v>2.2663988178971621</c:v>
                </c:pt>
                <c:pt idx="190">
                  <c:v>2.2647708734769316</c:v>
                </c:pt>
                <c:pt idx="191">
                  <c:v>2.262425929325238</c:v>
                </c:pt>
                <c:pt idx="192">
                  <c:v>2.2593650209034064</c:v>
                </c:pt>
                <c:pt idx="193">
                  <c:v>2.2555894998224284</c:v>
                </c:pt>
                <c:pt idx="194">
                  <c:v>2.2511010332461279</c:v>
                </c:pt>
                <c:pt idx="195">
                  <c:v>2.245901603154989</c:v>
                </c:pt>
                <c:pt idx="196">
                  <c:v>2.2399935054709701</c:v>
                </c:pt>
                <c:pt idx="197">
                  <c:v>2.2333793490436893</c:v>
                </c:pt>
                <c:pt idx="198">
                  <c:v>2.2260620544984286</c:v>
                </c:pt>
                <c:pt idx="199">
                  <c:v>2.218044852946468</c:v>
                </c:pt>
                <c:pt idx="200">
                  <c:v>2.2093312845583211</c:v>
                </c:pt>
                <c:pt idx="201">
                  <c:v>2.1999251970004896</c:v>
                </c:pt>
                <c:pt idx="202">
                  <c:v>2.1898307437364477</c:v>
                </c:pt>
                <c:pt idx="203">
                  <c:v>2.1790523821925865</c:v>
                </c:pt>
                <c:pt idx="204">
                  <c:v>2.1675948717899396</c:v>
                </c:pt>
                <c:pt idx="205">
                  <c:v>2.1554632718425597</c:v>
                </c:pt>
                <c:pt idx="206">
                  <c:v>2.1426629393234644</c:v>
                </c:pt>
                <c:pt idx="207">
                  <c:v>2.1291995264991503</c:v>
                </c:pt>
                <c:pt idx="208">
                  <c:v>2.1150789784337101</c:v>
                </c:pt>
                <c:pt idx="209">
                  <c:v>2.1003075303636596</c:v>
                </c:pt>
                <c:pt idx="210">
                  <c:v>2.084891704944634</c:v>
                </c:pt>
                <c:pt idx="211">
                  <c:v>2.0688383093711646</c:v>
                </c:pt>
                <c:pt idx="212">
                  <c:v>2.052154432370815</c:v>
                </c:pt>
                <c:pt idx="213">
                  <c:v>2.0348474410739987</c:v>
                </c:pt>
                <c:pt idx="214">
                  <c:v>2.0169249777608615</c:v>
                </c:pt>
                <c:pt idx="215">
                  <c:v>1.9983949564866619</c:v>
                </c:pt>
                <c:pt idx="216">
                  <c:v>1.9792655595871553</c:v>
                </c:pt>
                <c:pt idx="217">
                  <c:v>1.9595452340654971</c:v>
                </c:pt>
                <c:pt idx="218">
                  <c:v>1.9392426878622886</c:v>
                </c:pt>
                <c:pt idx="219">
                  <c:v>1.9183668860103926</c:v>
                </c:pt>
                <c:pt idx="220">
                  <c:v>1.8969270466762298</c:v>
                </c:pt>
                <c:pt idx="221">
                  <c:v>1.8749326370892927</c:v>
                </c:pt>
                <c:pt idx="222">
                  <c:v>1.8523933693616881</c:v>
                </c:pt>
                <c:pt idx="223">
                  <c:v>1.8293191961995381</c:v>
                </c:pt>
                <c:pt idx="224">
                  <c:v>1.8057203065081462</c:v>
                </c:pt>
                <c:pt idx="225">
                  <c:v>1.781607120892865</c:v>
                </c:pt>
                <c:pt idx="226">
                  <c:v>1.7569902870576473</c:v>
                </c:pt>
                <c:pt idx="227">
                  <c:v>1.7318806751033229</c:v>
                </c:pt>
                <c:pt idx="228">
                  <c:v>1.7062893727276669</c:v>
                </c:pt>
                <c:pt idx="229">
                  <c:v>1.6802276803293839</c:v>
                </c:pt>
                <c:pt idx="230">
                  <c:v>1.6537071060181698</c:v>
                </c:pt>
                <c:pt idx="231">
                  <c:v>1.6267393605330556</c:v>
                </c:pt>
                <c:pt idx="232">
                  <c:v>1.5993363520712756</c:v>
                </c:pt>
                <c:pt idx="233">
                  <c:v>1.5715101810299394</c:v>
                </c:pt>
                <c:pt idx="234">
                  <c:v>1.5432731346628403</c:v>
                </c:pt>
                <c:pt idx="235">
                  <c:v>1.5146376816547491</c:v>
                </c:pt>
                <c:pt idx="236">
                  <c:v>1.4856164666155927</c:v>
                </c:pt>
                <c:pt idx="237">
                  <c:v>1.4562223044969522</c:v>
                </c:pt>
                <c:pt idx="238">
                  <c:v>1.4264681749333397</c:v>
                </c:pt>
                <c:pt idx="239">
                  <c:v>1.3963672165107579</c:v>
                </c:pt>
                <c:pt idx="240">
                  <c:v>1.3659327209650687</c:v>
                </c:pt>
                <c:pt idx="241">
                  <c:v>1.3351781273127403</c:v>
                </c:pt>
                <c:pt idx="242">
                  <c:v>1.3041170159165527</c:v>
                </c:pt>
                <c:pt idx="243">
                  <c:v>1.2727631024888906</c:v>
                </c:pt>
                <c:pt idx="244">
                  <c:v>1.2411302320352759</c:v>
                </c:pt>
                <c:pt idx="245">
                  <c:v>1.2092323727407992</c:v>
                </c:pt>
                <c:pt idx="246">
                  <c:v>1.177083609802164</c:v>
                </c:pt>
                <c:pt idx="247">
                  <c:v>1.1446981392080582</c:v>
                </c:pt>
                <c:pt idx="248">
                  <c:v>1.1120902614706094</c:v>
                </c:pt>
                <c:pt idx="249">
                  <c:v>1.0792743753106764</c:v>
                </c:pt>
                <c:pt idx="250">
                  <c:v>1.0462649712997831</c:v>
                </c:pt>
                <c:pt idx="251">
                  <c:v>1.0130766254614876</c:v>
                </c:pt>
                <c:pt idx="252">
                  <c:v>0.97972399283502209</c:v>
                </c:pt>
                <c:pt idx="253">
                  <c:v>0.9462218010040393</c:v>
                </c:pt>
                <c:pt idx="254">
                  <c:v>0.91258484359332703</c:v>
                </c:pt>
                <c:pt idx="255">
                  <c:v>0.87882797373635879</c:v>
                </c:pt>
                <c:pt idx="256">
                  <c:v>0.84496609751656815</c:v>
                </c:pt>
                <c:pt idx="257">
                  <c:v>0.8110141673852439</c:v>
                </c:pt>
                <c:pt idx="258">
                  <c:v>0.77698717555894603</c:v>
                </c:pt>
                <c:pt idx="259">
                  <c:v>0.74290014739936538</c:v>
                </c:pt>
                <c:pt idx="260">
                  <c:v>0.70876813477854872</c:v>
                </c:pt>
                <c:pt idx="261">
                  <c:v>0.67460620943241401</c:v>
                </c:pt>
                <c:pt idx="262">
                  <c:v>0.64042945630549686</c:v>
                </c:pt>
                <c:pt idx="263">
                  <c:v>0.60625296688986308</c:v>
                </c:pt>
                <c:pt idx="264">
                  <c:v>0.57209183256113083</c:v>
                </c:pt>
                <c:pt idx="265">
                  <c:v>0.53796113791454525</c:v>
                </c:pt>
                <c:pt idx="266">
                  <c:v>0.50387595410404329</c:v>
                </c:pt>
                <c:pt idx="267">
                  <c:v>0.46985133218725872</c:v>
                </c:pt>
                <c:pt idx="268">
                  <c:v>0.43590229647939815</c:v>
                </c:pt>
                <c:pt idx="269">
                  <c:v>0.40204383791892551</c:v>
                </c:pt>
                <c:pt idx="270">
                  <c:v>0.36829090744798676</c:v>
                </c:pt>
                <c:pt idx="271">
                  <c:v>0.33465840941049496</c:v>
                </c:pt>
                <c:pt idx="272">
                  <c:v>0.30116119497078797</c:v>
                </c:pt>
                <c:pt idx="273">
                  <c:v>0.26781405555577831</c:v>
                </c:pt>
                <c:pt idx="274">
                  <c:v>0.23463171632347113</c:v>
                </c:pt>
                <c:pt idx="275">
                  <c:v>0.20162882966075102</c:v>
                </c:pt>
                <c:pt idx="276">
                  <c:v>0.16881996871329874</c:v>
                </c:pt>
                <c:pt idx="277">
                  <c:v>0.13621962095050133</c:v>
                </c:pt>
                <c:pt idx="278">
                  <c:v>0.10384218176819404</c:v>
                </c:pt>
                <c:pt idx="279">
                  <c:v>7.1701948132057103E-2</c:v>
                </c:pt>
                <c:pt idx="280">
                  <c:v>3.9813112264480477E-2</c:v>
                </c:pt>
                <c:pt idx="281">
                  <c:v>8.1897553776753007E-3</c:v>
                </c:pt>
                <c:pt idx="282">
                  <c:v>-2.3154158544190784E-2</c:v>
                </c:pt>
                <c:pt idx="283">
                  <c:v>-5.4204788911097257E-2</c:v>
                </c:pt>
                <c:pt idx="284">
                  <c:v>-8.4948424638784825E-2</c:v>
                </c:pt>
                <c:pt idx="285">
                  <c:v>-0.11537149020318482</c:v>
                </c:pt>
                <c:pt idx="286">
                  <c:v>-0.14546055163498828</c:v>
                </c:pt>
                <c:pt idx="287">
                  <c:v>-0.17520232245170875</c:v>
                </c:pt>
                <c:pt idx="288">
                  <c:v>-0.20458366952461837</c:v>
                </c:pt>
                <c:pt idx="289">
                  <c:v>-0.23359161887796853</c:v>
                </c:pt>
                <c:pt idx="290">
                  <c:v>-0.26221336141793172</c:v>
                </c:pt>
                <c:pt idx="291">
                  <c:v>-0.29043625858873745</c:v>
                </c:pt>
                <c:pt idx="292">
                  <c:v>-0.31824784795350181</c:v>
                </c:pt>
                <c:pt idx="293">
                  <c:v>-0.34563584869729014</c:v>
                </c:pt>
                <c:pt idx="294">
                  <c:v>-0.37258816704997699</c:v>
                </c:pt>
                <c:pt idx="295">
                  <c:v>-0.39909290162651678</c:v>
                </c:pt>
                <c:pt idx="296">
                  <c:v>-0.4251383486822593</c:v>
                </c:pt>
                <c:pt idx="297">
                  <c:v>-0.45071300728099362</c:v>
                </c:pt>
                <c:pt idx="298">
                  <c:v>-0.47580558437343934</c:v>
                </c:pt>
                <c:pt idx="299">
                  <c:v>-0.5004049997839357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3384840"/>
        <c:axId val="283385232"/>
      </c:scatterChart>
      <c:valAx>
        <c:axId val="283384840"/>
        <c:scaling>
          <c:orientation val="minMax"/>
          <c:max val="300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700"/>
            </a:pPr>
            <a:endParaRPr lang="ko-KR"/>
          </a:p>
        </c:txPr>
        <c:crossAx val="283385232"/>
        <c:crosses val="autoZero"/>
        <c:crossBetween val="midCat"/>
      </c:valAx>
      <c:valAx>
        <c:axId val="283385232"/>
        <c:scaling>
          <c:orientation val="minMax"/>
          <c:max val="2"/>
          <c:min val="0"/>
        </c:scaling>
        <c:delete val="0"/>
        <c:axPos val="l"/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700"/>
            </a:pPr>
            <a:endParaRPr lang="ko-KR"/>
          </a:p>
        </c:txPr>
        <c:crossAx val="283384840"/>
        <c:crosses val="autoZero"/>
        <c:crossBetween val="midCat"/>
      </c:valAx>
      <c:spPr>
        <a:ln>
          <a:solidFill>
            <a:srgbClr val="C0C0C0"/>
          </a:solidFill>
          <a:prstDash val="solid"/>
        </a:ln>
      </c:spPr>
    </c:plotArea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Relationship Id="rId4" Type="http://schemas.openxmlformats.org/officeDocument/2006/relationships/image" Target="../media/image11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image" Target="../media/image2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5955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7214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9944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2979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1637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7761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2660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94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9788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282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2237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F0024-5D1C-4290-9FAF-54CAD484E436}" type="datetimeFigureOut">
              <a:rPr lang="ko-KR" altLang="en-US" smtClean="0"/>
              <a:t>2018-08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DF1218-DB03-45DE-8FB6-206CFB1663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6119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oleObject" Target="../embeddings/oleObject5.bin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oleObject" Target="../embeddings/oleObject9.bin"/><Relationship Id="rId18" Type="http://schemas.openxmlformats.org/officeDocument/2006/relationships/image" Target="../media/image11.emf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12" Type="http://schemas.openxmlformats.org/officeDocument/2006/relationships/image" Target="../media/image8.emf"/><Relationship Id="rId17" Type="http://schemas.openxmlformats.org/officeDocument/2006/relationships/oleObject" Target="../embeddings/oleObject11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0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15.png"/><Relationship Id="rId11" Type="http://schemas.openxmlformats.org/officeDocument/2006/relationships/oleObject" Target="../embeddings/oleObject8.bin"/><Relationship Id="rId5" Type="http://schemas.openxmlformats.org/officeDocument/2006/relationships/image" Target="../media/image14.png"/><Relationship Id="rId15" Type="http://schemas.openxmlformats.org/officeDocument/2006/relationships/oleObject" Target="../embeddings/oleObject10.bin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Relationship Id="rId1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21.png"/><Relationship Id="rId7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6.emf"/><Relationship Id="rId5" Type="http://schemas.openxmlformats.org/officeDocument/2006/relationships/oleObject" Target="../embeddings/oleObject14.bin"/><Relationship Id="rId4" Type="http://schemas.openxmlformats.org/officeDocument/2006/relationships/image" Target="../media/image25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TextBox 69"/>
          <p:cNvSpPr txBox="1"/>
          <p:nvPr/>
        </p:nvSpPr>
        <p:spPr>
          <a:xfrm>
            <a:off x="465921" y="256807"/>
            <a:ext cx="8280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WIKIM30 and different Toll-like receptor (TLR) ligands induce distinct patterns of cytokine secretion by BMDCs.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MDCs were stimulated for 24 h with Pam3Cys-Ser-Ly4 (PAM3; 100 ng/ml, TLR1/2), </a:t>
            </a:r>
            <a:r>
              <a:rPr lang="en-US" altLang="ko-K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yinosinic:polycytidylic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cid (Poly(I:C); 1 </a:t>
            </a:r>
            <a:r>
              <a:rPr lang="en-US" altLang="ko-KR" sz="11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/ml, TLR3), lipopolysaccharide (LPS; 100 ng/ml, TLR4), </a:t>
            </a:r>
            <a:r>
              <a:rPr lang="en-US" altLang="ko-K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agellin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FLA;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altLang="ko-KR" sz="11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g/ml,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LR5), Pam2CGDPKHPKSF (FSL-1; 100 ng/ml, TLR6/2), and ssRNA40 (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altLang="ko-KR" sz="11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g/ml,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LR7), or medium alone. The expression levels of cytokines in culture supernatants were measured with the cytometry bead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rray kit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Data represent the mean ± standard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rror. ##</a:t>
            </a:r>
            <a:r>
              <a:rPr lang="en-US" altLang="ko-KR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&lt; 0.01,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  <a:r>
              <a:rPr lang="en-US" altLang="ko-KR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&lt; 0.001 vs.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KIM30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group.</a:t>
            </a:r>
            <a:endParaRPr lang="en-US" altLang="ko-KR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1044436" y="1939925"/>
            <a:ext cx="6562379" cy="3897341"/>
            <a:chOff x="1044436" y="1939925"/>
            <a:chExt cx="6562379" cy="3897341"/>
          </a:xfrm>
        </p:grpSpPr>
        <p:sp>
          <p:nvSpPr>
            <p:cNvPr id="4" name="TextBox 3"/>
            <p:cNvSpPr txBox="1"/>
            <p:nvPr/>
          </p:nvSpPr>
          <p:spPr>
            <a:xfrm rot="16200000">
              <a:off x="583733" y="4524139"/>
              <a:ext cx="117532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12p70 (</a:t>
              </a:r>
              <a:r>
                <a:rPr lang="en-US" altLang="ko-KR" sz="10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" name="개체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55786004"/>
                </p:ext>
              </p:extLst>
            </p:nvPr>
          </p:nvGraphicFramePr>
          <p:xfrm>
            <a:off x="1357927" y="3894663"/>
            <a:ext cx="2644775" cy="1704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38" name="Prism 6" r:id="rId3" imgW="2645197" imgH="1704609" progId="Prism6.Document">
                    <p:embed/>
                  </p:oleObj>
                </mc:Choice>
                <mc:Fallback>
                  <p:oleObj name="Prism 6" r:id="rId3" imgW="2645197" imgH="1704609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357927" y="3894663"/>
                          <a:ext cx="2644775" cy="1704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" name="개체 1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36913623"/>
                </p:ext>
              </p:extLst>
            </p:nvPr>
          </p:nvGraphicFramePr>
          <p:xfrm>
            <a:off x="4962040" y="3894663"/>
            <a:ext cx="2644775" cy="1704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39" name="Prism 6" r:id="rId5" imgW="2645197" imgH="1704609" progId="Prism6.Document">
                    <p:embed/>
                  </p:oleObj>
                </mc:Choice>
                <mc:Fallback>
                  <p:oleObj name="Prism 6" r:id="rId5" imgW="2645197" imgH="1704609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962040" y="3894663"/>
                          <a:ext cx="2644775" cy="1704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" name="TextBox 18"/>
            <p:cNvSpPr txBox="1"/>
            <p:nvPr/>
          </p:nvSpPr>
          <p:spPr>
            <a:xfrm rot="16200000">
              <a:off x="4277846" y="4456406"/>
              <a:ext cx="94929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10 (</a:t>
              </a:r>
              <a:r>
                <a:rPr lang="en-US" altLang="ko-KR" sz="10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0" name="개체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68885931"/>
                </p:ext>
              </p:extLst>
            </p:nvPr>
          </p:nvGraphicFramePr>
          <p:xfrm>
            <a:off x="1190631" y="1941513"/>
            <a:ext cx="2814638" cy="1701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40" name="Prism 6" r:id="rId7" imgW="2814461" imgH="1701368" progId="Prism6.Document">
                    <p:embed/>
                  </p:oleObj>
                </mc:Choice>
                <mc:Fallback>
                  <p:oleObj name="Prism 6" r:id="rId7" imgW="2814461" imgH="1701368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190631" y="1941513"/>
                          <a:ext cx="2814638" cy="1701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" name="TextBox 20"/>
            <p:cNvSpPr txBox="1"/>
            <p:nvPr/>
          </p:nvSpPr>
          <p:spPr>
            <a:xfrm rot="16200000">
              <a:off x="659875" y="2570038"/>
              <a:ext cx="102303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F-</a:t>
              </a:r>
              <a:r>
                <a:rPr lang="en-US" altLang="ko-KR" sz="1050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altLang="ko-K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ko-KR" sz="10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2" name="개체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99474468"/>
                </p:ext>
              </p:extLst>
            </p:nvPr>
          </p:nvGraphicFramePr>
          <p:xfrm>
            <a:off x="4811717" y="1939925"/>
            <a:ext cx="2790825" cy="1704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41" name="Prism 6" r:id="rId9" imgW="2791412" imgH="1704609" progId="Prism6.Document">
                    <p:embed/>
                  </p:oleObj>
                </mc:Choice>
                <mc:Fallback>
                  <p:oleObj name="Prism 6" r:id="rId9" imgW="2791412" imgH="1704609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811717" y="1939925"/>
                          <a:ext cx="2790825" cy="1704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TextBox 22"/>
            <p:cNvSpPr txBox="1"/>
            <p:nvPr/>
          </p:nvSpPr>
          <p:spPr>
            <a:xfrm rot="16200000">
              <a:off x="4315517" y="2531281"/>
              <a:ext cx="87395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6 (</a:t>
              </a:r>
              <a:r>
                <a:rPr lang="en-US" altLang="ko-KR" sz="10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그룹 1"/>
            <p:cNvGrpSpPr/>
            <p:nvPr/>
          </p:nvGrpSpPr>
          <p:grpSpPr>
            <a:xfrm>
              <a:off x="1670413" y="3279522"/>
              <a:ext cx="2152876" cy="623889"/>
              <a:chOff x="1518007" y="3279522"/>
              <a:chExt cx="2152876" cy="623889"/>
            </a:xfrm>
          </p:grpSpPr>
          <p:sp>
            <p:nvSpPr>
              <p:cNvPr id="82" name="TextBox 81"/>
              <p:cNvSpPr txBox="1"/>
              <p:nvPr/>
            </p:nvSpPr>
            <p:spPr>
              <a:xfrm rot="18302587">
                <a:off x="1329173" y="3468356"/>
                <a:ext cx="6238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 LAB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 rot="18302587">
                <a:off x="1689718" y="339617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30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 rot="18302587">
                <a:off x="1884351" y="3459826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1/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 rot="18302587">
                <a:off x="2209629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3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 rot="18302587">
                <a:off x="2482008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4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 rot="18302587">
                <a:off x="2754387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5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 rot="18302587">
                <a:off x="3299147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7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 rot="18302587">
                <a:off x="2973867" y="3459826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6/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" name="TextBox 2"/>
            <p:cNvSpPr txBox="1"/>
            <p:nvPr/>
          </p:nvSpPr>
          <p:spPr>
            <a:xfrm>
              <a:off x="2258717" y="2500144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2504808" y="3006790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3044688" y="3035863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3302371" y="2753586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3581377" y="3026666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6097473" y="303921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6642964" y="3033063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7184830" y="303305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5862417" y="2211212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2212018" y="4982223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2491422" y="498222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3024821" y="499068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3575157" y="4990683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3304792" y="498016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5834805" y="495668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6097275" y="4973618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6639138" y="493974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7173110" y="4954626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6376669" y="4745010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6901602" y="473653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6" name="그룹 125"/>
            <p:cNvGrpSpPr/>
            <p:nvPr/>
          </p:nvGrpSpPr>
          <p:grpSpPr>
            <a:xfrm>
              <a:off x="5268332" y="3288289"/>
              <a:ext cx="2152876" cy="623889"/>
              <a:chOff x="1518007" y="3279522"/>
              <a:chExt cx="2152876" cy="623889"/>
            </a:xfrm>
          </p:grpSpPr>
          <p:sp>
            <p:nvSpPr>
              <p:cNvPr id="127" name="TextBox 126"/>
              <p:cNvSpPr txBox="1"/>
              <p:nvPr/>
            </p:nvSpPr>
            <p:spPr>
              <a:xfrm rot="18302587">
                <a:off x="1329173" y="3468356"/>
                <a:ext cx="6238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 LAB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 rot="18302587">
                <a:off x="1689718" y="339617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30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 rot="18302587">
                <a:off x="1884351" y="3459826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1/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 rot="18302587">
                <a:off x="2209629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3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 rot="18302587">
                <a:off x="2482008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4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 rot="18302587">
                <a:off x="2754387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5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 rot="18302587">
                <a:off x="3299147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7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 rot="18302587">
                <a:off x="2973867" y="3459826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6/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5" name="그룹 134"/>
            <p:cNvGrpSpPr/>
            <p:nvPr/>
          </p:nvGrpSpPr>
          <p:grpSpPr>
            <a:xfrm>
              <a:off x="1644802" y="5213377"/>
              <a:ext cx="2152876" cy="623889"/>
              <a:chOff x="1518007" y="3279522"/>
              <a:chExt cx="2152876" cy="623889"/>
            </a:xfrm>
          </p:grpSpPr>
          <p:sp>
            <p:nvSpPr>
              <p:cNvPr id="136" name="TextBox 135"/>
              <p:cNvSpPr txBox="1"/>
              <p:nvPr/>
            </p:nvSpPr>
            <p:spPr>
              <a:xfrm rot="18302587">
                <a:off x="1329173" y="3468356"/>
                <a:ext cx="6238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 LAB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 rot="18302587">
                <a:off x="1689718" y="339617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30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TextBox 137"/>
              <p:cNvSpPr txBox="1"/>
              <p:nvPr/>
            </p:nvSpPr>
            <p:spPr>
              <a:xfrm rot="18302587">
                <a:off x="1884351" y="3459826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1/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TextBox 138"/>
              <p:cNvSpPr txBox="1"/>
              <p:nvPr/>
            </p:nvSpPr>
            <p:spPr>
              <a:xfrm rot="18302587">
                <a:off x="2209629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3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 rot="18302587">
                <a:off x="2482008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4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 rot="18302587">
                <a:off x="2754387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5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 rot="18302587">
                <a:off x="3299147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7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 rot="18302587">
                <a:off x="2973867" y="3459826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6/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4" name="그룹 143"/>
            <p:cNvGrpSpPr/>
            <p:nvPr/>
          </p:nvGrpSpPr>
          <p:grpSpPr>
            <a:xfrm>
              <a:off x="5234148" y="5213376"/>
              <a:ext cx="2152876" cy="623889"/>
              <a:chOff x="1518007" y="3279522"/>
              <a:chExt cx="2152876" cy="623889"/>
            </a:xfrm>
          </p:grpSpPr>
          <p:sp>
            <p:nvSpPr>
              <p:cNvPr id="145" name="TextBox 144"/>
              <p:cNvSpPr txBox="1"/>
              <p:nvPr/>
            </p:nvSpPr>
            <p:spPr>
              <a:xfrm rot="18302587">
                <a:off x="1329173" y="3468356"/>
                <a:ext cx="6238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 LAB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 rot="18302587">
                <a:off x="1689718" y="339617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30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 rot="18302587">
                <a:off x="1884351" y="3459826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1/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TextBox 147"/>
              <p:cNvSpPr txBox="1"/>
              <p:nvPr/>
            </p:nvSpPr>
            <p:spPr>
              <a:xfrm rot="18302587">
                <a:off x="2209629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3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 rot="18302587">
                <a:off x="2482008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4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 rot="18302587">
                <a:off x="2754387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5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 rot="18302587">
                <a:off x="3299147" y="3416516"/>
                <a:ext cx="4972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7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 rot="18302587">
                <a:off x="2973867" y="3459826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LR6/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19094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464606" y="256785"/>
            <a:ext cx="82800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04838" indent="-604838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Mice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were intraperitoneally injected with 50 </a:t>
            </a:r>
            <a:r>
              <a:rPr lang="el-GR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g of OVA mixed with Alum. </a:t>
            </a:r>
            <a:endParaRPr lang="en-US" altLang="ko-KR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ice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were boosted by injection of the OVA/Alum mixture 7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ys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later. Mice were sacrificed on day 14 after sensitization, and single </a:t>
            </a:r>
            <a:r>
              <a:rPr lang="en-US" altLang="ko-KR" sz="1100" dirty="0" err="1">
                <a:latin typeface="Arial" panose="020B0604020202020204" pitchFamily="34" charset="0"/>
                <a:cs typeface="Arial" panose="020B0604020202020204" pitchFamily="34" charset="0"/>
              </a:rPr>
              <a:t>splenocyte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suspensions were co-cultured with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KIM30 in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he presenc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ko-KR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bsence of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200 </a:t>
            </a:r>
            <a:r>
              <a:rPr lang="el-G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g/ml OVA for 24 h.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altLang="ko-KR" sz="1100" dirty="0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IL-4, and IL-10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level in the supernatant were detected by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he cytometry bead array kit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Data represent the mean ± standard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rror. *</a:t>
            </a:r>
            <a:r>
              <a:rPr lang="en-US" altLang="ko-KR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&lt; 0.05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r>
              <a:rPr lang="en-US" altLang="ko-KR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&lt; 0.001.</a:t>
            </a:r>
            <a:endParaRPr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1337379" y="2565400"/>
            <a:ext cx="6292146" cy="2247757"/>
            <a:chOff x="1337379" y="2565400"/>
            <a:chExt cx="6292146" cy="2247757"/>
          </a:xfrm>
        </p:grpSpPr>
        <p:sp>
          <p:nvSpPr>
            <p:cNvPr id="4" name="TextBox 3"/>
            <p:cNvSpPr txBox="1"/>
            <p:nvPr/>
          </p:nvSpPr>
          <p:spPr>
            <a:xfrm rot="16200000">
              <a:off x="5298358" y="3309705"/>
              <a:ext cx="9092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10 (</a:t>
              </a:r>
              <a:r>
                <a:rPr lang="en-US" altLang="ko-KR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" name="개체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33401834"/>
                </p:ext>
              </p:extLst>
            </p:nvPr>
          </p:nvGraphicFramePr>
          <p:xfrm>
            <a:off x="5811838" y="2565400"/>
            <a:ext cx="1817687" cy="16097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4" name="Prism 6" r:id="rId3" imgW="1817245" imgH="1609889" progId="Prism6.Document">
                    <p:embed/>
                  </p:oleObj>
                </mc:Choice>
                <mc:Fallback>
                  <p:oleObj name="Prism 6" r:id="rId3" imgW="1817245" imgH="1609889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811838" y="2565400"/>
                          <a:ext cx="1817687" cy="16097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 rot="18165862">
              <a:off x="5962605" y="4280290"/>
              <a:ext cx="8195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+I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8165862">
              <a:off x="6394362" y="4280290"/>
              <a:ext cx="8195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 LAB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8165862">
              <a:off x="6789419" y="4280290"/>
              <a:ext cx="8195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IKIM3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9" name="개체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02781196"/>
                </p:ext>
              </p:extLst>
            </p:nvPr>
          </p:nvGraphicFramePr>
          <p:xfrm>
            <a:off x="1497013" y="2565400"/>
            <a:ext cx="1817687" cy="16097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5" name="Prism 6" r:id="rId5" imgW="1817245" imgH="1609889" progId="Prism6.Document">
                    <p:embed/>
                  </p:oleObj>
                </mc:Choice>
                <mc:Fallback>
                  <p:oleObj name="Prism 6" r:id="rId5" imgW="1817245" imgH="1609889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497013" y="2565400"/>
                          <a:ext cx="1817687" cy="16097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 rot="16200000">
              <a:off x="990649" y="3309704"/>
              <a:ext cx="9396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n-US" altLang="ko-KR" sz="1000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ko-KR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8165862">
              <a:off x="1606754" y="4280289"/>
              <a:ext cx="8195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+I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8165862">
              <a:off x="2038511" y="4280289"/>
              <a:ext cx="8195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 LAB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8165862">
              <a:off x="2433568" y="4280289"/>
              <a:ext cx="8195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IKIM3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3238781" y="3309703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4 (</a:t>
              </a:r>
              <a:r>
                <a:rPr lang="en-US" altLang="ko-KR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8165862">
              <a:off x="3731967" y="4280288"/>
              <a:ext cx="8195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+I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8165862">
              <a:off x="4163724" y="4280288"/>
              <a:ext cx="8195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 LAB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8165862">
              <a:off x="4558781" y="4280288"/>
              <a:ext cx="8195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IKIM3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8" name="개체 1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1007709"/>
                </p:ext>
              </p:extLst>
            </p:nvPr>
          </p:nvGraphicFramePr>
          <p:xfrm>
            <a:off x="3698875" y="2565400"/>
            <a:ext cx="1744663" cy="16097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96" name="Prism 6" r:id="rId7" imgW="1744137" imgH="1609889" progId="Prism6.Document">
                    <p:embed/>
                  </p:oleObj>
                </mc:Choice>
                <mc:Fallback>
                  <p:oleObj name="Prism 6" r:id="rId7" imgW="1744137" imgH="1609889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698875" y="2565400"/>
                          <a:ext cx="1744663" cy="16097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5" name="그룹 24"/>
            <p:cNvGrpSpPr/>
            <p:nvPr/>
          </p:nvGrpSpPr>
          <p:grpSpPr>
            <a:xfrm>
              <a:off x="2669139" y="3295103"/>
              <a:ext cx="421724" cy="468000"/>
              <a:chOff x="838200" y="5528732"/>
              <a:chExt cx="396000" cy="657107"/>
            </a:xfrm>
          </p:grpSpPr>
          <p:cxnSp>
            <p:nvCxnSpPr>
              <p:cNvPr id="3" name="직선 연결선 2"/>
              <p:cNvCxnSpPr/>
              <p:nvPr/>
            </p:nvCxnSpPr>
            <p:spPr>
              <a:xfrm>
                <a:off x="838200" y="5528732"/>
                <a:ext cx="0" cy="6571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직선 연결선 21"/>
              <p:cNvCxnSpPr/>
              <p:nvPr/>
            </p:nvCxnSpPr>
            <p:spPr>
              <a:xfrm>
                <a:off x="1234015" y="5528733"/>
                <a:ext cx="0" cy="44026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직선 연결선 23"/>
              <p:cNvCxnSpPr/>
              <p:nvPr/>
            </p:nvCxnSpPr>
            <p:spPr>
              <a:xfrm>
                <a:off x="838200" y="5528733"/>
                <a:ext cx="396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그룹 25"/>
            <p:cNvGrpSpPr/>
            <p:nvPr/>
          </p:nvGrpSpPr>
          <p:grpSpPr>
            <a:xfrm>
              <a:off x="4774609" y="3335268"/>
              <a:ext cx="421724" cy="432000"/>
              <a:chOff x="838200" y="5528732"/>
              <a:chExt cx="396000" cy="606561"/>
            </a:xfrm>
          </p:grpSpPr>
          <p:cxnSp>
            <p:nvCxnSpPr>
              <p:cNvPr id="27" name="직선 연결선 26"/>
              <p:cNvCxnSpPr/>
              <p:nvPr/>
            </p:nvCxnSpPr>
            <p:spPr>
              <a:xfrm>
                <a:off x="838200" y="5528732"/>
                <a:ext cx="0" cy="15164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직선 연결선 27"/>
              <p:cNvCxnSpPr/>
              <p:nvPr/>
            </p:nvCxnSpPr>
            <p:spPr>
              <a:xfrm>
                <a:off x="1234015" y="5528732"/>
                <a:ext cx="0" cy="60656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직선 연결선 28"/>
              <p:cNvCxnSpPr/>
              <p:nvPr/>
            </p:nvCxnSpPr>
            <p:spPr>
              <a:xfrm>
                <a:off x="838200" y="5528733"/>
                <a:ext cx="396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그룹 29"/>
            <p:cNvGrpSpPr/>
            <p:nvPr/>
          </p:nvGrpSpPr>
          <p:grpSpPr>
            <a:xfrm>
              <a:off x="6971379" y="2855966"/>
              <a:ext cx="421724" cy="972000"/>
              <a:chOff x="838200" y="5528732"/>
              <a:chExt cx="396000" cy="1364765"/>
            </a:xfrm>
          </p:grpSpPr>
          <p:cxnSp>
            <p:nvCxnSpPr>
              <p:cNvPr id="31" name="직선 연결선 30"/>
              <p:cNvCxnSpPr/>
              <p:nvPr/>
            </p:nvCxnSpPr>
            <p:spPr>
              <a:xfrm>
                <a:off x="838200" y="5528732"/>
                <a:ext cx="0" cy="136476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직선 연결선 31"/>
              <p:cNvCxnSpPr/>
              <p:nvPr/>
            </p:nvCxnSpPr>
            <p:spPr>
              <a:xfrm>
                <a:off x="1234015" y="5528733"/>
                <a:ext cx="0" cy="15164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직선 연결선 32"/>
              <p:cNvCxnSpPr/>
              <p:nvPr/>
            </p:nvCxnSpPr>
            <p:spPr>
              <a:xfrm>
                <a:off x="838200" y="5528733"/>
                <a:ext cx="396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" name="TextBox 33"/>
            <p:cNvSpPr txBox="1"/>
            <p:nvPr/>
          </p:nvSpPr>
          <p:spPr>
            <a:xfrm>
              <a:off x="4865887" y="3147734"/>
              <a:ext cx="2391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009812" y="2664691"/>
              <a:ext cx="3481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739263" y="3066317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104051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/>
          <p:cNvSpPr txBox="1"/>
          <p:nvPr/>
        </p:nvSpPr>
        <p:spPr>
          <a:xfrm>
            <a:off x="466361" y="259779"/>
            <a:ext cx="82800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04838" indent="-604838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The number or population of draining lymph node were measured. </a:t>
            </a:r>
          </a:p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ingle cell isolated lymphocytes were stained with antibodies for CD3, CD4, CD8, and CD19 and then analyzed by flow cytometer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. Data represent the mean ± standard error. *</a:t>
            </a:r>
            <a:r>
              <a:rPr lang="en-US" altLang="ko-KR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&lt;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.05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vs. AD group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509197" y="1380339"/>
            <a:ext cx="8141297" cy="3060054"/>
            <a:chOff x="593128" y="1393591"/>
            <a:chExt cx="8141297" cy="3060054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10432" y="1819784"/>
              <a:ext cx="1089501" cy="1080000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673118" y="1819784"/>
              <a:ext cx="1089501" cy="108000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653916" y="1819784"/>
              <a:ext cx="1089502" cy="1080000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10432" y="3146519"/>
              <a:ext cx="1089502" cy="1080000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673118" y="3146520"/>
              <a:ext cx="1089502" cy="1080000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653916" y="3146520"/>
              <a:ext cx="1089502" cy="1080000"/>
            </a:xfrm>
            <a:prstGeom prst="rect">
              <a:avLst/>
            </a:prstGeom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641881" y="3146519"/>
              <a:ext cx="1089502" cy="1080000"/>
            </a:xfrm>
            <a:prstGeom prst="rect">
              <a:avLst/>
            </a:prstGeom>
          </p:spPr>
        </p:pic>
        <p:cxnSp>
          <p:nvCxnSpPr>
            <p:cNvPr id="11" name="직선 화살표 연결선 10"/>
            <p:cNvCxnSpPr/>
            <p:nvPr/>
          </p:nvCxnSpPr>
          <p:spPr>
            <a:xfrm>
              <a:off x="1006108" y="2854518"/>
              <a:ext cx="378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912072" y="2835423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직선 화살표 연결선 12"/>
            <p:cNvCxnSpPr/>
            <p:nvPr/>
          </p:nvCxnSpPr>
          <p:spPr>
            <a:xfrm flipV="1">
              <a:off x="841967" y="1885795"/>
              <a:ext cx="0" cy="82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 rot="16200000">
              <a:off x="449179" y="2416618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n-US" altLang="ko-KR" sz="1000" dirty="0" err="1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endParaRPr lang="ko-KR" altLang="en-US" sz="100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cxnSp>
          <p:nvCxnSpPr>
            <p:cNvPr id="15" name="직선 화살표 연결선 14"/>
            <p:cNvCxnSpPr/>
            <p:nvPr/>
          </p:nvCxnSpPr>
          <p:spPr>
            <a:xfrm>
              <a:off x="1006108" y="4226519"/>
              <a:ext cx="378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912072" y="4207424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직선 화살표 연결선 16"/>
            <p:cNvCxnSpPr/>
            <p:nvPr/>
          </p:nvCxnSpPr>
          <p:spPr>
            <a:xfrm flipV="1">
              <a:off x="841967" y="3257796"/>
              <a:ext cx="0" cy="82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 rot="16200000">
              <a:off x="495666" y="3788619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ko-KR" altLang="en-US" sz="100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pic>
          <p:nvPicPr>
            <p:cNvPr id="19" name="그림 18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641881" y="1819783"/>
              <a:ext cx="1089502" cy="1080000"/>
            </a:xfrm>
            <a:prstGeom prst="rect">
              <a:avLst/>
            </a:prstGeom>
          </p:spPr>
        </p:pic>
        <p:graphicFrame>
          <p:nvGraphicFramePr>
            <p:cNvPr id="20" name="개체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35854230"/>
                </p:ext>
              </p:extLst>
            </p:nvPr>
          </p:nvGraphicFramePr>
          <p:xfrm>
            <a:off x="4905093" y="1402883"/>
            <a:ext cx="1924050" cy="14303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86" name="Prism 6" r:id="rId11" imgW="1923845" imgH="1430172" progId="Prism6.Document">
                    <p:embed/>
                  </p:oleObj>
                </mc:Choice>
                <mc:Fallback>
                  <p:oleObj name="Prism 6" r:id="rId11" imgW="1923845" imgH="1430172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905093" y="1402883"/>
                          <a:ext cx="1924050" cy="14303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" name="TextBox 20"/>
            <p:cNvSpPr txBox="1"/>
            <p:nvPr/>
          </p:nvSpPr>
          <p:spPr>
            <a:xfrm>
              <a:off x="1140312" y="1610530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ïve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255841" y="1610530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118651" y="1610530"/>
              <a:ext cx="4459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eto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096120" y="1610530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3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직선 연결선 24"/>
            <p:cNvCxnSpPr/>
            <p:nvPr/>
          </p:nvCxnSpPr>
          <p:spPr>
            <a:xfrm>
              <a:off x="1987433" y="1610530"/>
              <a:ext cx="270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3048465" y="1393591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DNCB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392129" y="2692288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107194" y="2692287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 cells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16200000">
              <a:off x="4569499" y="2049340"/>
              <a:ext cx="7056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s (%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0" name="개체 2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54291791"/>
                </p:ext>
              </p:extLst>
            </p:nvPr>
          </p:nvGraphicFramePr>
          <p:xfrm>
            <a:off x="6889750" y="1403350"/>
            <a:ext cx="1844675" cy="14303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87" name="Prism 6" r:id="rId13" imgW="1844615" imgH="1430172" progId="Prism6.Document">
                    <p:embed/>
                  </p:oleObj>
                </mc:Choice>
                <mc:Fallback>
                  <p:oleObj name="Prism 6" r:id="rId13" imgW="1844615" imgH="1430172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6889750" y="1403350"/>
                          <a:ext cx="1844675" cy="14303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1" name="TextBox 30"/>
            <p:cNvSpPr txBox="1"/>
            <p:nvPr/>
          </p:nvSpPr>
          <p:spPr>
            <a:xfrm>
              <a:off x="7337911" y="2692288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8052976" y="2692287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 cells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6416469" y="2049340"/>
              <a:ext cx="8659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s (X10</a:t>
              </a:r>
              <a:r>
                <a:rPr lang="en-US" altLang="ko-KR" sz="10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4" name="개체 3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38735695"/>
                </p:ext>
              </p:extLst>
            </p:nvPr>
          </p:nvGraphicFramePr>
          <p:xfrm>
            <a:off x="4976318" y="2809748"/>
            <a:ext cx="1851025" cy="14303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88" name="Prism 6" r:id="rId15" imgW="1850737" imgH="1430172" progId="Prism6.Document">
                    <p:embed/>
                  </p:oleObj>
                </mc:Choice>
                <mc:Fallback>
                  <p:oleObj name="Prism 6" r:id="rId15" imgW="1850737" imgH="1430172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4976318" y="2809748"/>
                          <a:ext cx="1851025" cy="14303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5" name="TextBox 34"/>
            <p:cNvSpPr txBox="1"/>
            <p:nvPr/>
          </p:nvSpPr>
          <p:spPr>
            <a:xfrm>
              <a:off x="5449037" y="4098788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167307" y="4098787"/>
              <a:ext cx="4411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4569499" y="3455840"/>
              <a:ext cx="7056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s (%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8" name="개체 3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41365104"/>
                </p:ext>
              </p:extLst>
            </p:nvPr>
          </p:nvGraphicFramePr>
          <p:xfrm>
            <a:off x="6889750" y="2809875"/>
            <a:ext cx="1844675" cy="14303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89" name="Prism 6" r:id="rId17" imgW="1844615" imgH="1430172" progId="Prism6.Document">
                    <p:embed/>
                  </p:oleObj>
                </mc:Choice>
                <mc:Fallback>
                  <p:oleObj name="Prism 6" r:id="rId17" imgW="1844615" imgH="1430172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6889750" y="2809875"/>
                          <a:ext cx="1844675" cy="14303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9" name="TextBox 38"/>
            <p:cNvSpPr txBox="1"/>
            <p:nvPr/>
          </p:nvSpPr>
          <p:spPr>
            <a:xfrm>
              <a:off x="7394818" y="4098788"/>
              <a:ext cx="4411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8113089" y="4098787"/>
              <a:ext cx="4411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6407138" y="3455840"/>
              <a:ext cx="8659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s (X10</a:t>
              </a:r>
              <a:r>
                <a:rPr lang="en-US" altLang="ko-KR" sz="10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7521644" y="3279763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665577" y="3228959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8228814" y="3644163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8381214" y="3652628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7521642" y="1840427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665575" y="1789623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8228812" y="2204827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8381212" y="2213292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834204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그룹 37"/>
          <p:cNvGrpSpPr/>
          <p:nvPr/>
        </p:nvGrpSpPr>
        <p:grpSpPr>
          <a:xfrm>
            <a:off x="1046726" y="1668293"/>
            <a:ext cx="6717939" cy="2339511"/>
            <a:chOff x="1220589" y="3497093"/>
            <a:chExt cx="6717939" cy="2339511"/>
          </a:xfrm>
        </p:grpSpPr>
        <p:grpSp>
          <p:nvGrpSpPr>
            <p:cNvPr id="37" name="그룹 36"/>
            <p:cNvGrpSpPr/>
            <p:nvPr/>
          </p:nvGrpSpPr>
          <p:grpSpPr>
            <a:xfrm>
              <a:off x="1356078" y="4324470"/>
              <a:ext cx="4481988" cy="1165236"/>
              <a:chOff x="114300" y="1558199"/>
              <a:chExt cx="3942451" cy="1080000"/>
            </a:xfrm>
          </p:grpSpPr>
          <p:pic>
            <p:nvPicPr>
              <p:cNvPr id="33" name="그림 3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4300" y="1558199"/>
                <a:ext cx="1089502" cy="1080000"/>
              </a:xfrm>
              <a:prstGeom prst="rect">
                <a:avLst/>
              </a:prstGeom>
            </p:spPr>
          </p:pic>
          <p:pic>
            <p:nvPicPr>
              <p:cNvPr id="34" name="그림 33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062162" y="1558199"/>
                <a:ext cx="1089501" cy="1080000"/>
              </a:xfrm>
              <a:prstGeom prst="rect">
                <a:avLst/>
              </a:prstGeom>
            </p:spPr>
          </p:pic>
          <p:pic>
            <p:nvPicPr>
              <p:cNvPr id="35" name="그림 34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019825" y="1558199"/>
                <a:ext cx="1089501" cy="1080000"/>
              </a:xfrm>
              <a:prstGeom prst="rect">
                <a:avLst/>
              </a:prstGeom>
            </p:spPr>
          </p:pic>
          <p:pic>
            <p:nvPicPr>
              <p:cNvPr id="36" name="그림 35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967250" y="1558199"/>
                <a:ext cx="1089501" cy="1080000"/>
              </a:xfrm>
              <a:prstGeom prst="rect">
                <a:avLst/>
              </a:prstGeom>
            </p:spPr>
          </p:pic>
        </p:grpSp>
        <p:graphicFrame>
          <p:nvGraphicFramePr>
            <p:cNvPr id="4" name="개체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21416294"/>
                </p:ext>
              </p:extLst>
            </p:nvPr>
          </p:nvGraphicFramePr>
          <p:xfrm>
            <a:off x="6266891" y="3917366"/>
            <a:ext cx="1671637" cy="1695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46" name="Prism 6" r:id="rId7" imgW="1671030" imgH="1695245" progId="Prism6.Document">
                    <p:embed/>
                  </p:oleObj>
                </mc:Choice>
                <mc:Fallback>
                  <p:oleObj name="Prism 6" r:id="rId7" imgW="1671030" imgH="1695245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266891" y="3917366"/>
                          <a:ext cx="1671637" cy="16954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>
              <a:off x="4012326" y="3911051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DNCB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876770" y="4145561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ïve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004838" y="4145561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078418" y="4145561"/>
              <a:ext cx="4459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eto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151183" y="4145561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3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직선 연결선 13"/>
            <p:cNvCxnSpPr/>
            <p:nvPr/>
          </p:nvCxnSpPr>
          <p:spPr>
            <a:xfrm>
              <a:off x="2739478" y="4132861"/>
              <a:ext cx="313245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직선 화살표 연결선 14"/>
            <p:cNvCxnSpPr/>
            <p:nvPr/>
          </p:nvCxnSpPr>
          <p:spPr>
            <a:xfrm>
              <a:off x="1626952" y="5482160"/>
              <a:ext cx="42962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5150242" y="5489706"/>
              <a:ext cx="5389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Foxp3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1123127" y="4893361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142583" y="4387697"/>
              <a:ext cx="4315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.6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270223" y="4387697"/>
              <a:ext cx="4315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.9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377368" y="4387697"/>
              <a:ext cx="4315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.5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458064" y="4387697"/>
              <a:ext cx="4315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.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그룹 21"/>
            <p:cNvGrpSpPr/>
            <p:nvPr/>
          </p:nvGrpSpPr>
          <p:grpSpPr>
            <a:xfrm>
              <a:off x="6549465" y="5194034"/>
              <a:ext cx="1290783" cy="642570"/>
              <a:chOff x="1857971" y="4560346"/>
              <a:chExt cx="874102" cy="642570"/>
            </a:xfrm>
          </p:grpSpPr>
          <p:sp>
            <p:nvSpPr>
              <p:cNvPr id="23" name="TextBox 22"/>
              <p:cNvSpPr txBox="1"/>
              <p:nvPr/>
            </p:nvSpPr>
            <p:spPr>
              <a:xfrm rot="18246494">
                <a:off x="2112558" y="4779885"/>
                <a:ext cx="540000" cy="166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eto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8246494">
                <a:off x="2333166" y="4779885"/>
                <a:ext cx="540000" cy="166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30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8246494">
                <a:off x="1891949" y="4779885"/>
                <a:ext cx="540000" cy="166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8246494">
                <a:off x="1671340" y="4746977"/>
                <a:ext cx="540000" cy="166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aïve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7" name="직선 연결선 26"/>
              <p:cNvCxnSpPr/>
              <p:nvPr/>
            </p:nvCxnSpPr>
            <p:spPr>
              <a:xfrm>
                <a:off x="2048073" y="4986312"/>
                <a:ext cx="68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2210943" y="4956695"/>
                <a:ext cx="37147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NCB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9" name="TextBox 28"/>
            <p:cNvSpPr txBox="1"/>
            <p:nvPr/>
          </p:nvSpPr>
          <p:spPr>
            <a:xfrm>
              <a:off x="7560298" y="4113592"/>
              <a:ext cx="2391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518967" y="3497093"/>
              <a:ext cx="14269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ko-KR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  <a:r>
                <a:rPr lang="en-US" altLang="ko-KR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gated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직선 화살표 연결선 30"/>
            <p:cNvCxnSpPr/>
            <p:nvPr/>
          </p:nvCxnSpPr>
          <p:spPr>
            <a:xfrm flipV="1">
              <a:off x="1465591" y="4348967"/>
              <a:ext cx="0" cy="97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 rot="16200000">
              <a:off x="5450088" y="4531121"/>
              <a:ext cx="15632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en-US" altLang="ko-KR" sz="10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  <a:r>
                <a:rPr lang="en-US" altLang="ko-KR" sz="10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oxp3</a:t>
              </a:r>
              <a:r>
                <a:rPr lang="en-US" altLang="ko-KR" sz="10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ells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TextBox 38"/>
          <p:cNvSpPr txBox="1"/>
          <p:nvPr/>
        </p:nvSpPr>
        <p:spPr>
          <a:xfrm>
            <a:off x="464666" y="256344"/>
            <a:ext cx="82800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04838" indent="-604838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Proportion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LNs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altLang="ko-KR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solated PLN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cells wer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ained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with antibodies against CD3, CD4, CD25, and Foxp3 and then analyzed by flow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ytometry. Data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represent the mean ± standard error. *</a:t>
            </a:r>
            <a:r>
              <a:rPr lang="en-US" altLang="ko-KR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&lt;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.05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vs. AD group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13639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개체 5"/>
          <p:cNvGraphicFramePr>
            <a:graphicFrameLocks noChangeAspect="1"/>
          </p:cNvGraphicFramePr>
          <p:nvPr>
            <p:extLst/>
          </p:nvPr>
        </p:nvGraphicFramePr>
        <p:xfrm>
          <a:off x="4675188" y="2838768"/>
          <a:ext cx="3001962" cy="2203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4" name="Prism 6" r:id="rId3" imgW="3001731" imgH="2203062" progId="Prism6.Document">
                  <p:embed/>
                </p:oleObj>
              </mc:Choice>
              <mc:Fallback>
                <p:oleObj name="Prism 6" r:id="rId3" imgW="3001731" imgH="220306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75188" y="2838768"/>
                        <a:ext cx="3001962" cy="2203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표 3"/>
          <p:cNvGraphicFramePr>
            <a:graphicFrameLocks noGrp="1"/>
          </p:cNvGraphicFramePr>
          <p:nvPr>
            <p:extLst/>
          </p:nvPr>
        </p:nvGraphicFramePr>
        <p:xfrm>
          <a:off x="6208672" y="3888549"/>
          <a:ext cx="1384251" cy="81343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84251"/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drogenoanaerobacterium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erofilu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gibacterium_f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tococcacea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thromitus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stridiacea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표 4"/>
          <p:cNvGraphicFramePr>
            <a:graphicFrameLocks noGrp="1"/>
          </p:cNvGraphicFramePr>
          <p:nvPr>
            <p:extLst/>
          </p:nvPr>
        </p:nvGraphicFramePr>
        <p:xfrm>
          <a:off x="5342105" y="3358717"/>
          <a:ext cx="797994" cy="4648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97994"/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minococcu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roiciproducen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ell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mella_f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7" name="개체 6"/>
          <p:cNvGraphicFramePr>
            <a:graphicFrameLocks noChangeAspect="1"/>
          </p:cNvGraphicFramePr>
          <p:nvPr>
            <p:extLst/>
          </p:nvPr>
        </p:nvGraphicFramePr>
        <p:xfrm>
          <a:off x="1647825" y="955040"/>
          <a:ext cx="3001963" cy="408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5" name="Prism 6" r:id="rId5" imgW="3001731" imgH="4083066" progId="Prism6.Document">
                  <p:embed/>
                </p:oleObj>
              </mc:Choice>
              <mc:Fallback>
                <p:oleObj name="Prism 6" r:id="rId5" imgW="3001731" imgH="408306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647825" y="955040"/>
                        <a:ext cx="3001963" cy="408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표 7"/>
          <p:cNvGraphicFramePr>
            <a:graphicFrameLocks noGrp="1"/>
          </p:cNvGraphicFramePr>
          <p:nvPr>
            <p:extLst/>
          </p:nvPr>
        </p:nvGraphicFramePr>
        <p:xfrm>
          <a:off x="2057400" y="2266037"/>
          <a:ext cx="1041400" cy="5810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41400"/>
              </a:tblGrid>
              <a:tr h="85751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acteroidete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85751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teroidi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85751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teroidale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85751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minococcu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85751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istensenellacea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9" name="표 8"/>
          <p:cNvGraphicFramePr>
            <a:graphicFrameLocks noGrp="1"/>
          </p:cNvGraphicFramePr>
          <p:nvPr>
            <p:extLst/>
          </p:nvPr>
        </p:nvGraphicFramePr>
        <p:xfrm>
          <a:off x="3173634" y="2928429"/>
          <a:ext cx="1205622" cy="17430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05622"/>
              </a:tblGrid>
              <a:tr h="59999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stoni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1784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drogenoanaerobacteriu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1784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robacter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1784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lercreutzi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1784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iobacteriacea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1784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iobacteriale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iobacterii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1784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obacteri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1784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stridiacea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1784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thromitu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rmicute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actobacillu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actobacillacea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actobacillale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459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acilli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3475138" y="196310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ïve</a:t>
            </a:r>
            <a:endParaRPr lang="ko-KR" altLang="en-US" sz="10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417795" y="1963109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NCB</a:t>
            </a:r>
            <a:endParaRPr lang="ko-KR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285045" y="2979808"/>
            <a:ext cx="886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NCB+W30</a:t>
            </a:r>
            <a:endParaRPr lang="ko-KR" alt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557902" y="2979808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NCB</a:t>
            </a:r>
            <a:endParaRPr lang="ko-KR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439318" y="4906461"/>
            <a:ext cx="1391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DA SCORE (log 10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509070" y="4906461"/>
            <a:ext cx="1391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DA SCORE (log 10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67058" y="256028"/>
            <a:ext cx="8280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. Linear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discriminant analysis (LDA) score of gut microbiota in each group by linear discriminant analysis effect size 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fSe</a:t>
            </a: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nalysis. </a:t>
            </a:r>
            <a:endParaRPr lang="en-US" altLang="ko-KR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604838" indent="-604838"/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higher the score was, the more important the role was. Only taxa meeting an LDA score threshold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&gt;1.7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were listed.</a:t>
            </a:r>
          </a:p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Blue =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aïve;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Red = AD; Green = AD + WIKIM30, n = 5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20768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9" name="차트 28"/>
          <p:cNvGraphicFramePr>
            <a:graphicFrameLocks/>
          </p:cNvGraphicFramePr>
          <p:nvPr>
            <p:extLst/>
          </p:nvPr>
        </p:nvGraphicFramePr>
        <p:xfrm>
          <a:off x="1034349" y="1296208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0" name="차트 29"/>
          <p:cNvGraphicFramePr>
            <a:graphicFrameLocks/>
          </p:cNvGraphicFramePr>
          <p:nvPr>
            <p:extLst/>
          </p:nvPr>
        </p:nvGraphicFramePr>
        <p:xfrm>
          <a:off x="2259974" y="1296208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1" name="차트 30"/>
          <p:cNvGraphicFramePr>
            <a:graphicFrameLocks/>
          </p:cNvGraphicFramePr>
          <p:nvPr>
            <p:extLst/>
          </p:nvPr>
        </p:nvGraphicFramePr>
        <p:xfrm>
          <a:off x="3485599" y="1296208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2" name="차트 31"/>
          <p:cNvGraphicFramePr>
            <a:graphicFrameLocks/>
          </p:cNvGraphicFramePr>
          <p:nvPr>
            <p:extLst/>
          </p:nvPr>
        </p:nvGraphicFramePr>
        <p:xfrm>
          <a:off x="4711224" y="1296208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3" name="차트 32"/>
          <p:cNvGraphicFramePr>
            <a:graphicFrameLocks/>
          </p:cNvGraphicFramePr>
          <p:nvPr>
            <p:extLst/>
          </p:nvPr>
        </p:nvGraphicFramePr>
        <p:xfrm>
          <a:off x="5936849" y="1296208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4" name="차트 33"/>
          <p:cNvGraphicFramePr>
            <a:graphicFrameLocks/>
          </p:cNvGraphicFramePr>
          <p:nvPr>
            <p:extLst/>
          </p:nvPr>
        </p:nvGraphicFramePr>
        <p:xfrm>
          <a:off x="7162474" y="1296208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5" name="차트 34"/>
          <p:cNvGraphicFramePr>
            <a:graphicFrameLocks/>
          </p:cNvGraphicFramePr>
          <p:nvPr>
            <p:extLst/>
          </p:nvPr>
        </p:nvGraphicFramePr>
        <p:xfrm>
          <a:off x="1034349" y="267324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6" name="차트 35"/>
          <p:cNvGraphicFramePr>
            <a:graphicFrameLocks/>
          </p:cNvGraphicFramePr>
          <p:nvPr>
            <p:extLst/>
          </p:nvPr>
        </p:nvGraphicFramePr>
        <p:xfrm>
          <a:off x="2259974" y="267324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7" name="차트 36"/>
          <p:cNvGraphicFramePr>
            <a:graphicFrameLocks/>
          </p:cNvGraphicFramePr>
          <p:nvPr>
            <p:extLst/>
          </p:nvPr>
        </p:nvGraphicFramePr>
        <p:xfrm>
          <a:off x="3485599" y="267324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8" name="차트 37"/>
          <p:cNvGraphicFramePr>
            <a:graphicFrameLocks/>
          </p:cNvGraphicFramePr>
          <p:nvPr>
            <p:extLst/>
          </p:nvPr>
        </p:nvGraphicFramePr>
        <p:xfrm>
          <a:off x="4711224" y="267324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39" name="차트 38"/>
          <p:cNvGraphicFramePr>
            <a:graphicFrameLocks/>
          </p:cNvGraphicFramePr>
          <p:nvPr>
            <p:extLst/>
          </p:nvPr>
        </p:nvGraphicFramePr>
        <p:xfrm>
          <a:off x="5936849" y="267324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40" name="차트 39"/>
          <p:cNvGraphicFramePr>
            <a:graphicFrameLocks/>
          </p:cNvGraphicFramePr>
          <p:nvPr>
            <p:extLst/>
          </p:nvPr>
        </p:nvGraphicFramePr>
        <p:xfrm>
          <a:off x="7162474" y="267324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41" name="차트 40"/>
          <p:cNvGraphicFramePr>
            <a:graphicFrameLocks/>
          </p:cNvGraphicFramePr>
          <p:nvPr>
            <p:extLst/>
          </p:nvPr>
        </p:nvGraphicFramePr>
        <p:xfrm>
          <a:off x="1034349" y="405028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42" name="차트 41"/>
          <p:cNvGraphicFramePr>
            <a:graphicFrameLocks/>
          </p:cNvGraphicFramePr>
          <p:nvPr>
            <p:extLst/>
          </p:nvPr>
        </p:nvGraphicFramePr>
        <p:xfrm>
          <a:off x="2259974" y="405028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43" name="차트 42"/>
          <p:cNvGraphicFramePr>
            <a:graphicFrameLocks/>
          </p:cNvGraphicFramePr>
          <p:nvPr>
            <p:extLst/>
          </p:nvPr>
        </p:nvGraphicFramePr>
        <p:xfrm>
          <a:off x="3485599" y="405028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44" name="차트 43"/>
          <p:cNvGraphicFramePr>
            <a:graphicFrameLocks/>
          </p:cNvGraphicFramePr>
          <p:nvPr>
            <p:extLst/>
          </p:nvPr>
        </p:nvGraphicFramePr>
        <p:xfrm>
          <a:off x="4711224" y="405028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45" name="차트 44"/>
          <p:cNvGraphicFramePr>
            <a:graphicFrameLocks/>
          </p:cNvGraphicFramePr>
          <p:nvPr>
            <p:extLst/>
          </p:nvPr>
        </p:nvGraphicFramePr>
        <p:xfrm>
          <a:off x="5936849" y="405028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46" name="차트 45"/>
          <p:cNvGraphicFramePr>
            <a:graphicFrameLocks/>
          </p:cNvGraphicFramePr>
          <p:nvPr>
            <p:extLst/>
          </p:nvPr>
        </p:nvGraphicFramePr>
        <p:xfrm>
          <a:off x="7162474" y="4050289"/>
          <a:ext cx="1368000" cy="13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51" name="TextBox 50"/>
          <p:cNvSpPr txBox="1"/>
          <p:nvPr/>
        </p:nvSpPr>
        <p:spPr>
          <a:xfrm>
            <a:off x="1260465" y="1245934"/>
            <a:ext cx="1130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ermatitis Scor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631182" y="1245934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rum </a:t>
            </a:r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005764" y="1245934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L-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170848" y="1245934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altLang="ko-KR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endParaRPr lang="ko-KR" altLang="en-US" sz="10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439895" y="1245934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7701813" y="1245934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L-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477589" y="1880563"/>
            <a:ext cx="10230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uminococcus</a:t>
            </a:r>
            <a:endParaRPr lang="ko-KR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 rot="16200000">
            <a:off x="569764" y="3143306"/>
            <a:ext cx="8386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thromitus</a:t>
            </a:r>
            <a:endParaRPr lang="ko-KR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 rot="16200000">
            <a:off x="630678" y="4518016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lstonia</a:t>
            </a:r>
            <a:endParaRPr lang="ko-KR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직사각형 65"/>
          <p:cNvSpPr/>
          <p:nvPr/>
        </p:nvSpPr>
        <p:spPr>
          <a:xfrm>
            <a:off x="1622845" y="2775386"/>
            <a:ext cx="73289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673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직사각형 66"/>
          <p:cNvSpPr/>
          <p:nvPr/>
        </p:nvSpPr>
        <p:spPr>
          <a:xfrm>
            <a:off x="1589181" y="1479599"/>
            <a:ext cx="76655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-0.653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직사각형 67"/>
          <p:cNvSpPr/>
          <p:nvPr/>
        </p:nvSpPr>
        <p:spPr>
          <a:xfrm>
            <a:off x="1622845" y="4180055"/>
            <a:ext cx="73289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696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직사각형 68"/>
          <p:cNvSpPr/>
          <p:nvPr/>
        </p:nvSpPr>
        <p:spPr>
          <a:xfrm>
            <a:off x="2795572" y="1479599"/>
            <a:ext cx="76655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-0.660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직사각형 69"/>
          <p:cNvSpPr/>
          <p:nvPr/>
        </p:nvSpPr>
        <p:spPr>
          <a:xfrm>
            <a:off x="2829236" y="2775386"/>
            <a:ext cx="73289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769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직사각형 70"/>
          <p:cNvSpPr/>
          <p:nvPr/>
        </p:nvSpPr>
        <p:spPr>
          <a:xfrm>
            <a:off x="2829236" y="4180055"/>
            <a:ext cx="73289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668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직사각형 71"/>
          <p:cNvSpPr/>
          <p:nvPr/>
        </p:nvSpPr>
        <p:spPr>
          <a:xfrm>
            <a:off x="4020625" y="1479599"/>
            <a:ext cx="76655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-</a:t>
            </a:r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99</a:t>
            </a:r>
            <a:r>
              <a:rPr lang="ko-KR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3" name="직사각형 72"/>
          <p:cNvSpPr/>
          <p:nvPr/>
        </p:nvSpPr>
        <p:spPr>
          <a:xfrm>
            <a:off x="4054289" y="2775386"/>
            <a:ext cx="73289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702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직사각형 73"/>
          <p:cNvSpPr/>
          <p:nvPr/>
        </p:nvSpPr>
        <p:spPr>
          <a:xfrm>
            <a:off x="4054289" y="4180055"/>
            <a:ext cx="73289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699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직사각형 74"/>
          <p:cNvSpPr/>
          <p:nvPr/>
        </p:nvSpPr>
        <p:spPr>
          <a:xfrm>
            <a:off x="5254723" y="1479599"/>
            <a:ext cx="73289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116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직사각형 75"/>
          <p:cNvSpPr/>
          <p:nvPr/>
        </p:nvSpPr>
        <p:spPr>
          <a:xfrm>
            <a:off x="5221059" y="2775386"/>
            <a:ext cx="76655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-</a:t>
            </a:r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354</a:t>
            </a:r>
            <a:r>
              <a:rPr lang="ko-KR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7" name="직사각형 76"/>
          <p:cNvSpPr/>
          <p:nvPr/>
        </p:nvSpPr>
        <p:spPr>
          <a:xfrm>
            <a:off x="5221059" y="4180055"/>
            <a:ext cx="76655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-</a:t>
            </a:r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588</a:t>
            </a:r>
            <a:r>
              <a:rPr lang="ko-KR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8" name="직사각형 77"/>
          <p:cNvSpPr/>
          <p:nvPr/>
        </p:nvSpPr>
        <p:spPr>
          <a:xfrm>
            <a:off x="6529805" y="1479599"/>
            <a:ext cx="73289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80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직사각형 78"/>
          <p:cNvSpPr/>
          <p:nvPr/>
        </p:nvSpPr>
        <p:spPr>
          <a:xfrm>
            <a:off x="6496141" y="2775386"/>
            <a:ext cx="76655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-</a:t>
            </a:r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78</a:t>
            </a:r>
            <a:r>
              <a:rPr lang="ko-KR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0" name="직사각형 79"/>
          <p:cNvSpPr/>
          <p:nvPr/>
        </p:nvSpPr>
        <p:spPr>
          <a:xfrm>
            <a:off x="6496141" y="4180055"/>
            <a:ext cx="76655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-</a:t>
            </a:r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7</a:t>
            </a:r>
            <a:r>
              <a:rPr lang="ko-KR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1" name="직사각형 80"/>
          <p:cNvSpPr/>
          <p:nvPr/>
        </p:nvSpPr>
        <p:spPr>
          <a:xfrm>
            <a:off x="7730240" y="1479599"/>
            <a:ext cx="73289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197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직사각형 81"/>
          <p:cNvSpPr/>
          <p:nvPr/>
        </p:nvSpPr>
        <p:spPr>
          <a:xfrm>
            <a:off x="7696576" y="2775386"/>
            <a:ext cx="76655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-</a:t>
            </a:r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93</a:t>
            </a:r>
            <a:r>
              <a:rPr lang="ko-KR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3" name="직사각형 82"/>
          <p:cNvSpPr/>
          <p:nvPr/>
        </p:nvSpPr>
        <p:spPr>
          <a:xfrm>
            <a:off x="7696576" y="4180055"/>
            <a:ext cx="76655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-</a:t>
            </a:r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18</a:t>
            </a:r>
            <a:r>
              <a:rPr lang="ko-KR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4" name="직사각형 83"/>
          <p:cNvSpPr/>
          <p:nvPr/>
        </p:nvSpPr>
        <p:spPr>
          <a:xfrm>
            <a:off x="1656407" y="1641330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426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직사각형 84"/>
          <p:cNvSpPr/>
          <p:nvPr/>
        </p:nvSpPr>
        <p:spPr>
          <a:xfrm>
            <a:off x="2844997" y="1641330"/>
            <a:ext cx="67358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436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직사각형 85"/>
          <p:cNvSpPr/>
          <p:nvPr/>
        </p:nvSpPr>
        <p:spPr>
          <a:xfrm>
            <a:off x="4079381" y="1641330"/>
            <a:ext cx="67358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48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직사각형 86"/>
          <p:cNvSpPr/>
          <p:nvPr/>
        </p:nvSpPr>
        <p:spPr>
          <a:xfrm>
            <a:off x="5288285" y="1641330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13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직사각형 87"/>
          <p:cNvSpPr/>
          <p:nvPr/>
        </p:nvSpPr>
        <p:spPr>
          <a:xfrm>
            <a:off x="6563367" y="1641330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06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직사각형 88"/>
          <p:cNvSpPr/>
          <p:nvPr/>
        </p:nvSpPr>
        <p:spPr>
          <a:xfrm>
            <a:off x="7763802" y="1641330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39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직사각형 89"/>
          <p:cNvSpPr/>
          <p:nvPr/>
        </p:nvSpPr>
        <p:spPr>
          <a:xfrm>
            <a:off x="1656408" y="2927786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453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직사각형 90"/>
          <p:cNvSpPr/>
          <p:nvPr/>
        </p:nvSpPr>
        <p:spPr>
          <a:xfrm>
            <a:off x="2862799" y="2927786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592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직사각형 91"/>
          <p:cNvSpPr/>
          <p:nvPr/>
        </p:nvSpPr>
        <p:spPr>
          <a:xfrm>
            <a:off x="4087852" y="2927786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492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직사각형 92"/>
          <p:cNvSpPr/>
          <p:nvPr/>
        </p:nvSpPr>
        <p:spPr>
          <a:xfrm>
            <a:off x="5279816" y="2927786"/>
            <a:ext cx="67358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12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직사각형 93"/>
          <p:cNvSpPr/>
          <p:nvPr/>
        </p:nvSpPr>
        <p:spPr>
          <a:xfrm>
            <a:off x="6563368" y="2927786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77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직사각형 94"/>
          <p:cNvSpPr/>
          <p:nvPr/>
        </p:nvSpPr>
        <p:spPr>
          <a:xfrm>
            <a:off x="7763803" y="2927786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86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직사각형 95"/>
          <p:cNvSpPr/>
          <p:nvPr/>
        </p:nvSpPr>
        <p:spPr>
          <a:xfrm>
            <a:off x="1656408" y="4332455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484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직사각형 96"/>
          <p:cNvSpPr/>
          <p:nvPr/>
        </p:nvSpPr>
        <p:spPr>
          <a:xfrm>
            <a:off x="2854329" y="4332455"/>
            <a:ext cx="67358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446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직사각형 97"/>
          <p:cNvSpPr/>
          <p:nvPr/>
        </p:nvSpPr>
        <p:spPr>
          <a:xfrm>
            <a:off x="4087852" y="4332455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489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직사각형 98"/>
          <p:cNvSpPr/>
          <p:nvPr/>
        </p:nvSpPr>
        <p:spPr>
          <a:xfrm>
            <a:off x="5288286" y="4332455"/>
            <a:ext cx="7024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345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직사각형 99"/>
          <p:cNvSpPr/>
          <p:nvPr/>
        </p:nvSpPr>
        <p:spPr>
          <a:xfrm>
            <a:off x="6621076" y="4332455"/>
            <a:ext cx="64472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0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직사각형 100"/>
          <p:cNvSpPr/>
          <p:nvPr/>
        </p:nvSpPr>
        <p:spPr>
          <a:xfrm>
            <a:off x="7821511" y="4332455"/>
            <a:ext cx="64472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8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8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0</a:t>
            </a:r>
            <a:r>
              <a:rPr lang="ko-KR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직사각형 101"/>
          <p:cNvSpPr/>
          <p:nvPr/>
        </p:nvSpPr>
        <p:spPr>
          <a:xfrm>
            <a:off x="5987616" y="5326849"/>
            <a:ext cx="2488182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2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</a:t>
            </a:r>
            <a:r>
              <a:rPr lang="en-US" altLang="ko-KR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Correlation matrix (Pearson)</a:t>
            </a:r>
          </a:p>
          <a:p>
            <a:pPr>
              <a:lnSpc>
                <a:spcPct val="200000"/>
              </a:lnSpc>
            </a:pPr>
            <a:r>
              <a:rPr lang="en-US" altLang="ko-KR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1200" baseline="30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Coefficients of determination</a:t>
            </a:r>
            <a:endParaRPr lang="ko-KR" altLang="en-US" sz="1200" baseline="30000" dirty="0"/>
          </a:p>
        </p:txBody>
      </p:sp>
      <p:sp>
        <p:nvSpPr>
          <p:cNvPr id="103" name="TextBox 102"/>
          <p:cNvSpPr txBox="1"/>
          <p:nvPr/>
        </p:nvSpPr>
        <p:spPr>
          <a:xfrm>
            <a:off x="467854" y="259390"/>
            <a:ext cx="64635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04838" indent="-604838"/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altLang="ko-KR" sz="11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relation </a:t>
            </a:r>
            <a:r>
              <a: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 the gut microbiota and key atopic dermatitis parameters. 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6219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54</TotalTime>
  <Words>760</Words>
  <Application>Microsoft Office PowerPoint</Application>
  <PresentationFormat>화면 슬라이드 쇼(4:3)</PresentationFormat>
  <Paragraphs>213</Paragraphs>
  <Slides>6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맑은 고딕</vt:lpstr>
      <vt:lpstr>Arial</vt:lpstr>
      <vt:lpstr>Calibri</vt:lpstr>
      <vt:lpstr>Calibri Light</vt:lpstr>
      <vt:lpstr>Symbol</vt:lpstr>
      <vt:lpstr>Office 테마</vt:lpstr>
      <vt:lpstr>Prism 6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soft 계정</dc:creator>
  <cp:lastModifiedBy>최학종</cp:lastModifiedBy>
  <cp:revision>57</cp:revision>
  <cp:lastPrinted>2018-07-19T00:27:10Z</cp:lastPrinted>
  <dcterms:created xsi:type="dcterms:W3CDTF">2018-05-30T02:22:19Z</dcterms:created>
  <dcterms:modified xsi:type="dcterms:W3CDTF">2018-08-06T01:36:45Z</dcterms:modified>
</cp:coreProperties>
</file>